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9" r:id="rId3"/>
    <p:sldId id="291" r:id="rId4"/>
    <p:sldId id="260" r:id="rId5"/>
    <p:sldId id="270" r:id="rId6"/>
    <p:sldId id="258" r:id="rId7"/>
    <p:sldId id="266" r:id="rId8"/>
    <p:sldId id="261" r:id="rId9"/>
    <p:sldId id="264" r:id="rId10"/>
    <p:sldId id="262" r:id="rId11"/>
    <p:sldId id="265" r:id="rId12"/>
    <p:sldId id="269" r:id="rId13"/>
    <p:sldId id="263" r:id="rId14"/>
    <p:sldId id="267" r:id="rId15"/>
    <p:sldId id="268" r:id="rId16"/>
    <p:sldId id="271" r:id="rId17"/>
    <p:sldId id="272" r:id="rId18"/>
    <p:sldId id="273" r:id="rId19"/>
    <p:sldId id="274" r:id="rId20"/>
    <p:sldId id="275" r:id="rId21"/>
    <p:sldId id="276" r:id="rId22"/>
    <p:sldId id="284" r:id="rId23"/>
    <p:sldId id="285" r:id="rId24"/>
    <p:sldId id="281" r:id="rId25"/>
    <p:sldId id="282" r:id="rId26"/>
    <p:sldId id="283" r:id="rId27"/>
    <p:sldId id="277" r:id="rId28"/>
    <p:sldId id="278" r:id="rId29"/>
    <p:sldId id="279" r:id="rId30"/>
    <p:sldId id="280" r:id="rId31"/>
    <p:sldId id="286" r:id="rId32"/>
    <p:sldId id="287" r:id="rId33"/>
    <p:sldId id="290" r:id="rId34"/>
    <p:sldId id="288" r:id="rId35"/>
    <p:sldId id="289" r:id="rId3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6AD00C61-63ED-46BA-9EE6-F3A8B3A29C68}">
          <p14:sldIdLst>
            <p14:sldId id="256"/>
          </p14:sldIdLst>
        </p14:section>
        <p14:section name="Terminology" id="{9E7EA143-ECE8-47E3-94DD-D934D2AFABD5}">
          <p14:sldIdLst>
            <p14:sldId id="259"/>
            <p14:sldId id="291"/>
            <p14:sldId id="260"/>
            <p14:sldId id="270"/>
            <p14:sldId id="258"/>
            <p14:sldId id="266"/>
            <p14:sldId id="261"/>
            <p14:sldId id="264"/>
            <p14:sldId id="262"/>
            <p14:sldId id="265"/>
            <p14:sldId id="269"/>
            <p14:sldId id="263"/>
            <p14:sldId id="267"/>
            <p14:sldId id="268"/>
            <p14:sldId id="271"/>
            <p14:sldId id="272"/>
            <p14:sldId id="273"/>
            <p14:sldId id="274"/>
            <p14:sldId id="275"/>
            <p14:sldId id="276"/>
            <p14:sldId id="284"/>
            <p14:sldId id="285"/>
            <p14:sldId id="281"/>
            <p14:sldId id="282"/>
            <p14:sldId id="283"/>
            <p14:sldId id="277"/>
            <p14:sldId id="278"/>
            <p14:sldId id="279"/>
            <p14:sldId id="280"/>
            <p14:sldId id="286"/>
            <p14:sldId id="287"/>
            <p14:sldId id="290"/>
            <p14:sldId id="288"/>
            <p14:sldId id="289"/>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9F7F9"/>
    <a:srgbClr val="FF9999"/>
    <a:srgbClr val="CC99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61B03EE-95FE-457B-869D-1BF7800899D4}" v="528" dt="2021-02-08T01:38:09.154"/>
    <p1510:client id="{1B024AE9-EA4C-C444-9EC2-2BA076A90798}" v="91" dt="2021-02-08T01:43:00.99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cSldViewPr>
  </p:slide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21" Type="http://schemas.openxmlformats.org/officeDocument/2006/relationships/slide" Target="slides/slide20.xml"/><Relationship Id="rId34" Type="http://schemas.openxmlformats.org/officeDocument/2006/relationships/slide" Target="slides/slide33.xml"/><Relationship Id="rId42" Type="http://schemas.microsoft.com/office/2015/10/relationships/revisionInfo" Target="revisionInfo.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ibson, Amanda" userId="907984a6-cd77-4b7d-b1f8-6dfd5dda5862" providerId="ADAL" clId="{1B024AE9-EA4C-C444-9EC2-2BA076A90798}"/>
    <pc:docChg chg="undo custSel addSld modSld">
      <pc:chgData name="Gibson, Amanda" userId="907984a6-cd77-4b7d-b1f8-6dfd5dda5862" providerId="ADAL" clId="{1B024AE9-EA4C-C444-9EC2-2BA076A90798}" dt="2021-02-08T01:43:00.999" v="87" actId="27636"/>
      <pc:docMkLst>
        <pc:docMk/>
      </pc:docMkLst>
      <pc:sldChg chg="modSp mod">
        <pc:chgData name="Gibson, Amanda" userId="907984a6-cd77-4b7d-b1f8-6dfd5dda5862" providerId="ADAL" clId="{1B024AE9-EA4C-C444-9EC2-2BA076A90798}" dt="2021-02-08T01:43:00.999" v="87" actId="27636"/>
        <pc:sldMkLst>
          <pc:docMk/>
          <pc:sldMk cId="3920724944" sldId="259"/>
        </pc:sldMkLst>
        <pc:spChg chg="mod">
          <ac:chgData name="Gibson, Amanda" userId="907984a6-cd77-4b7d-b1f8-6dfd5dda5862" providerId="ADAL" clId="{1B024AE9-EA4C-C444-9EC2-2BA076A90798}" dt="2021-02-08T01:43:00.999" v="87" actId="27636"/>
          <ac:spMkLst>
            <pc:docMk/>
            <pc:sldMk cId="3920724944" sldId="259"/>
            <ac:spMk id="4" creationId="{449EDA6B-C05C-4CBC-964D-959BAED3287F}"/>
          </ac:spMkLst>
        </pc:spChg>
      </pc:sldChg>
      <pc:sldChg chg="modSp add mod">
        <pc:chgData name="Gibson, Amanda" userId="907984a6-cd77-4b7d-b1f8-6dfd5dda5862" providerId="ADAL" clId="{1B024AE9-EA4C-C444-9EC2-2BA076A90798}" dt="2021-02-08T01:42:12.342" v="82" actId="20577"/>
        <pc:sldMkLst>
          <pc:docMk/>
          <pc:sldMk cId="1901113370" sldId="291"/>
        </pc:sldMkLst>
        <pc:spChg chg="mod">
          <ac:chgData name="Gibson, Amanda" userId="907984a6-cd77-4b7d-b1f8-6dfd5dda5862" providerId="ADAL" clId="{1B024AE9-EA4C-C444-9EC2-2BA076A90798}" dt="2021-02-08T01:41:59.128" v="55" actId="6549"/>
          <ac:spMkLst>
            <pc:docMk/>
            <pc:sldMk cId="1901113370" sldId="291"/>
            <ac:spMk id="2" creationId="{28C08DB6-BD44-4401-A786-2D06627D7C16}"/>
          </ac:spMkLst>
        </pc:spChg>
        <pc:spChg chg="mod">
          <ac:chgData name="Gibson, Amanda" userId="907984a6-cd77-4b7d-b1f8-6dfd5dda5862" providerId="ADAL" clId="{1B024AE9-EA4C-C444-9EC2-2BA076A90798}" dt="2021-02-08T01:42:12.342" v="82" actId="20577"/>
          <ac:spMkLst>
            <pc:docMk/>
            <pc:sldMk cId="1901113370" sldId="291"/>
            <ac:spMk id="49" creationId="{19AFFEFF-5E7C-45FD-AFFA-D5744EDE5B92}"/>
          </ac:spMkLst>
        </pc:spChg>
      </pc:sldChg>
    </pc:docChg>
  </pc:docChgLst>
  <pc:docChgLst>
    <pc:chgData name="Amanda Gibson" userId="907984a6-cd77-4b7d-b1f8-6dfd5dda5862" providerId="ADAL" clId="{161B03EE-95FE-457B-869D-1BF7800899D4}"/>
    <pc:docChg chg="undo redo custSel addSld delSld modSld sldOrd modSection">
      <pc:chgData name="Amanda Gibson" userId="907984a6-cd77-4b7d-b1f8-6dfd5dda5862" providerId="ADAL" clId="{161B03EE-95FE-457B-869D-1BF7800899D4}" dt="2021-02-08T01:38:02.004" v="5140" actId="3626"/>
      <pc:docMkLst>
        <pc:docMk/>
      </pc:docMkLst>
      <pc:sldChg chg="del">
        <pc:chgData name="Amanda Gibson" userId="907984a6-cd77-4b7d-b1f8-6dfd5dda5862" providerId="ADAL" clId="{161B03EE-95FE-457B-869D-1BF7800899D4}" dt="2021-02-08T00:53:42.435" v="4402" actId="47"/>
        <pc:sldMkLst>
          <pc:docMk/>
          <pc:sldMk cId="3775273095" sldId="257"/>
        </pc:sldMkLst>
      </pc:sldChg>
      <pc:sldChg chg="addSp delSp modSp mod modClrScheme chgLayout">
        <pc:chgData name="Amanda Gibson" userId="907984a6-cd77-4b7d-b1f8-6dfd5dda5862" providerId="ADAL" clId="{161B03EE-95FE-457B-869D-1BF7800899D4}" dt="2021-02-07T23:28:03.678" v="832" actId="478"/>
        <pc:sldMkLst>
          <pc:docMk/>
          <pc:sldMk cId="439454531" sldId="258"/>
        </pc:sldMkLst>
        <pc:spChg chg="add del mod ord">
          <ac:chgData name="Amanda Gibson" userId="907984a6-cd77-4b7d-b1f8-6dfd5dda5862" providerId="ADAL" clId="{161B03EE-95FE-457B-869D-1BF7800899D4}" dt="2021-02-07T23:28:03.058" v="831" actId="700"/>
          <ac:spMkLst>
            <pc:docMk/>
            <pc:sldMk cId="439454531" sldId="258"/>
            <ac:spMk id="10" creationId="{663CB840-8FE4-489E-ABA0-16C13D2E9042}"/>
          </ac:spMkLst>
        </pc:spChg>
        <pc:spChg chg="add del">
          <ac:chgData name="Amanda Gibson" userId="907984a6-cd77-4b7d-b1f8-6dfd5dda5862" providerId="ADAL" clId="{161B03EE-95FE-457B-869D-1BF7800899D4}" dt="2021-02-07T23:28:03.678" v="832" actId="478"/>
          <ac:spMkLst>
            <pc:docMk/>
            <pc:sldMk cId="439454531" sldId="258"/>
            <ac:spMk id="88" creationId="{BB4E3879-0FC6-44D6-9281-34F2B554E57F}"/>
          </ac:spMkLst>
        </pc:spChg>
      </pc:sldChg>
      <pc:sldChg chg="modSp mod">
        <pc:chgData name="Amanda Gibson" userId="907984a6-cd77-4b7d-b1f8-6dfd5dda5862" providerId="ADAL" clId="{161B03EE-95FE-457B-869D-1BF7800899D4}" dt="2021-02-08T01:38:02.004" v="5140" actId="3626"/>
        <pc:sldMkLst>
          <pc:docMk/>
          <pc:sldMk cId="3920724944" sldId="259"/>
        </pc:sldMkLst>
        <pc:spChg chg="mod">
          <ac:chgData name="Amanda Gibson" userId="907984a6-cd77-4b7d-b1f8-6dfd5dda5862" providerId="ADAL" clId="{161B03EE-95FE-457B-869D-1BF7800899D4}" dt="2021-02-08T01:28:00.188" v="5077" actId="1076"/>
          <ac:spMkLst>
            <pc:docMk/>
            <pc:sldMk cId="3920724944" sldId="259"/>
            <ac:spMk id="3" creationId="{EDBFCBC9-3F5A-4F93-8B85-A0A71E5A4DC3}"/>
          </ac:spMkLst>
        </pc:spChg>
        <pc:spChg chg="mod">
          <ac:chgData name="Amanda Gibson" userId="907984a6-cd77-4b7d-b1f8-6dfd5dda5862" providerId="ADAL" clId="{161B03EE-95FE-457B-869D-1BF7800899D4}" dt="2021-02-08T01:38:02.004" v="5140" actId="3626"/>
          <ac:spMkLst>
            <pc:docMk/>
            <pc:sldMk cId="3920724944" sldId="259"/>
            <ac:spMk id="4" creationId="{449EDA6B-C05C-4CBC-964D-959BAED3287F}"/>
          </ac:spMkLst>
        </pc:spChg>
      </pc:sldChg>
      <pc:sldChg chg="addSp delSp modSp mod">
        <pc:chgData name="Amanda Gibson" userId="907984a6-cd77-4b7d-b1f8-6dfd5dda5862" providerId="ADAL" clId="{161B03EE-95FE-457B-869D-1BF7800899D4}" dt="2021-02-07T23:31:26.843" v="876" actId="20577"/>
        <pc:sldMkLst>
          <pc:docMk/>
          <pc:sldMk cId="2720930455" sldId="260"/>
        </pc:sldMkLst>
        <pc:spChg chg="mod">
          <ac:chgData name="Amanda Gibson" userId="907984a6-cd77-4b7d-b1f8-6dfd5dda5862" providerId="ADAL" clId="{161B03EE-95FE-457B-869D-1BF7800899D4}" dt="2021-02-07T23:26:57.510" v="817" actId="20577"/>
          <ac:spMkLst>
            <pc:docMk/>
            <pc:sldMk cId="2720930455" sldId="260"/>
            <ac:spMk id="2" creationId="{28C08DB6-BD44-4401-A786-2D06627D7C16}"/>
          </ac:spMkLst>
        </pc:spChg>
        <pc:spChg chg="del">
          <ac:chgData name="Amanda Gibson" userId="907984a6-cd77-4b7d-b1f8-6dfd5dda5862" providerId="ADAL" clId="{161B03EE-95FE-457B-869D-1BF7800899D4}" dt="2021-02-07T23:27:01.648" v="818" actId="478"/>
          <ac:spMkLst>
            <pc:docMk/>
            <pc:sldMk cId="2720930455" sldId="260"/>
            <ac:spMk id="29" creationId="{460264DC-D798-4A2C-AFEE-E3EAC89381C0}"/>
          </ac:spMkLst>
        </pc:spChg>
        <pc:spChg chg="del">
          <ac:chgData name="Amanda Gibson" userId="907984a6-cd77-4b7d-b1f8-6dfd5dda5862" providerId="ADAL" clId="{161B03EE-95FE-457B-869D-1BF7800899D4}" dt="2021-02-07T23:27:01.648" v="818" actId="478"/>
          <ac:spMkLst>
            <pc:docMk/>
            <pc:sldMk cId="2720930455" sldId="260"/>
            <ac:spMk id="30" creationId="{5F69EB05-D6FB-49F7-9D4F-2321ED99160C}"/>
          </ac:spMkLst>
        </pc:spChg>
        <pc:spChg chg="del">
          <ac:chgData name="Amanda Gibson" userId="907984a6-cd77-4b7d-b1f8-6dfd5dda5862" providerId="ADAL" clId="{161B03EE-95FE-457B-869D-1BF7800899D4}" dt="2021-02-07T23:27:04.729" v="819" actId="478"/>
          <ac:spMkLst>
            <pc:docMk/>
            <pc:sldMk cId="2720930455" sldId="260"/>
            <ac:spMk id="31" creationId="{62926CC4-7085-4A05-A78E-4E92A3FEC177}"/>
          </ac:spMkLst>
        </pc:spChg>
        <pc:spChg chg="del">
          <ac:chgData name="Amanda Gibson" userId="907984a6-cd77-4b7d-b1f8-6dfd5dda5862" providerId="ADAL" clId="{161B03EE-95FE-457B-869D-1BF7800899D4}" dt="2021-02-07T23:27:04.729" v="819" actId="478"/>
          <ac:spMkLst>
            <pc:docMk/>
            <pc:sldMk cId="2720930455" sldId="260"/>
            <ac:spMk id="32" creationId="{6F6AAB42-47DD-4055-A07F-E14D264F1462}"/>
          </ac:spMkLst>
        </pc:spChg>
        <pc:spChg chg="del">
          <ac:chgData name="Amanda Gibson" userId="907984a6-cd77-4b7d-b1f8-6dfd5dda5862" providerId="ADAL" clId="{161B03EE-95FE-457B-869D-1BF7800899D4}" dt="2021-02-07T23:27:04.729" v="819" actId="478"/>
          <ac:spMkLst>
            <pc:docMk/>
            <pc:sldMk cId="2720930455" sldId="260"/>
            <ac:spMk id="33" creationId="{EC002835-4BE6-41E5-9F95-6A4615E6F746}"/>
          </ac:spMkLst>
        </pc:spChg>
        <pc:spChg chg="del">
          <ac:chgData name="Amanda Gibson" userId="907984a6-cd77-4b7d-b1f8-6dfd5dda5862" providerId="ADAL" clId="{161B03EE-95FE-457B-869D-1BF7800899D4}" dt="2021-02-07T23:27:01.648" v="818" actId="478"/>
          <ac:spMkLst>
            <pc:docMk/>
            <pc:sldMk cId="2720930455" sldId="260"/>
            <ac:spMk id="34" creationId="{85F64347-BE6B-4136-8D58-30B1BC5DCA5B}"/>
          </ac:spMkLst>
        </pc:spChg>
        <pc:spChg chg="del">
          <ac:chgData name="Amanda Gibson" userId="907984a6-cd77-4b7d-b1f8-6dfd5dda5862" providerId="ADAL" clId="{161B03EE-95FE-457B-869D-1BF7800899D4}" dt="2021-02-07T23:27:01.648" v="818" actId="478"/>
          <ac:spMkLst>
            <pc:docMk/>
            <pc:sldMk cId="2720930455" sldId="260"/>
            <ac:spMk id="35" creationId="{E102B067-510D-489C-B457-AB574C74135A}"/>
          </ac:spMkLst>
        </pc:spChg>
        <pc:spChg chg="add mod">
          <ac:chgData name="Amanda Gibson" userId="907984a6-cd77-4b7d-b1f8-6dfd5dda5862" providerId="ADAL" clId="{161B03EE-95FE-457B-869D-1BF7800899D4}" dt="2021-02-07T23:30:01.972" v="833"/>
          <ac:spMkLst>
            <pc:docMk/>
            <pc:sldMk cId="2720930455" sldId="260"/>
            <ac:spMk id="36" creationId="{BF02E7A9-F5EF-43CA-8B8D-C5D472815F16}"/>
          </ac:spMkLst>
        </pc:spChg>
        <pc:spChg chg="add mod">
          <ac:chgData name="Amanda Gibson" userId="907984a6-cd77-4b7d-b1f8-6dfd5dda5862" providerId="ADAL" clId="{161B03EE-95FE-457B-869D-1BF7800899D4}" dt="2021-02-07T23:30:01.972" v="833"/>
          <ac:spMkLst>
            <pc:docMk/>
            <pc:sldMk cId="2720930455" sldId="260"/>
            <ac:spMk id="38" creationId="{368D76A5-CAA3-4070-B6C2-875B32207197}"/>
          </ac:spMkLst>
        </pc:spChg>
        <pc:spChg chg="add mod">
          <ac:chgData name="Amanda Gibson" userId="907984a6-cd77-4b7d-b1f8-6dfd5dda5862" providerId="ADAL" clId="{161B03EE-95FE-457B-869D-1BF7800899D4}" dt="2021-02-07T23:30:15.238" v="835" actId="1076"/>
          <ac:spMkLst>
            <pc:docMk/>
            <pc:sldMk cId="2720930455" sldId="260"/>
            <ac:spMk id="40" creationId="{0FC3F339-EB43-4A7D-AE11-DDFC200AB678}"/>
          </ac:spMkLst>
        </pc:spChg>
        <pc:spChg chg="add mod">
          <ac:chgData name="Amanda Gibson" userId="907984a6-cd77-4b7d-b1f8-6dfd5dda5862" providerId="ADAL" clId="{161B03EE-95FE-457B-869D-1BF7800899D4}" dt="2021-02-07T23:30:41.247" v="840" actId="20577"/>
          <ac:spMkLst>
            <pc:docMk/>
            <pc:sldMk cId="2720930455" sldId="260"/>
            <ac:spMk id="42" creationId="{011BCC47-7C11-477D-A088-66AF1245ED95}"/>
          </ac:spMkLst>
        </pc:spChg>
        <pc:spChg chg="add mod">
          <ac:chgData name="Amanda Gibson" userId="907984a6-cd77-4b7d-b1f8-6dfd5dda5862" providerId="ADAL" clId="{161B03EE-95FE-457B-869D-1BF7800899D4}" dt="2021-02-07T23:30:51.605" v="841" actId="571"/>
          <ac:spMkLst>
            <pc:docMk/>
            <pc:sldMk cId="2720930455" sldId="260"/>
            <ac:spMk id="45" creationId="{3BE02717-75A8-467A-971C-F80368F4E2B1}"/>
          </ac:spMkLst>
        </pc:spChg>
        <pc:spChg chg="add mod">
          <ac:chgData name="Amanda Gibson" userId="907984a6-cd77-4b7d-b1f8-6dfd5dda5862" providerId="ADAL" clId="{161B03EE-95FE-457B-869D-1BF7800899D4}" dt="2021-02-07T23:30:54.620" v="842" actId="571"/>
          <ac:spMkLst>
            <pc:docMk/>
            <pc:sldMk cId="2720930455" sldId="260"/>
            <ac:spMk id="47" creationId="{E3DEFAEF-72D9-467E-AEF9-8F7D76A261D0}"/>
          </ac:spMkLst>
        </pc:spChg>
        <pc:spChg chg="add mod">
          <ac:chgData name="Amanda Gibson" userId="907984a6-cd77-4b7d-b1f8-6dfd5dda5862" providerId="ADAL" clId="{161B03EE-95FE-457B-869D-1BF7800899D4}" dt="2021-02-07T23:31:26.843" v="876" actId="20577"/>
          <ac:spMkLst>
            <pc:docMk/>
            <pc:sldMk cId="2720930455" sldId="260"/>
            <ac:spMk id="49" creationId="{19AFFEFF-5E7C-45FD-AFFA-D5744EDE5B92}"/>
          </ac:spMkLst>
        </pc:spChg>
        <pc:cxnChg chg="add mod">
          <ac:chgData name="Amanda Gibson" userId="907984a6-cd77-4b7d-b1f8-6dfd5dda5862" providerId="ADAL" clId="{161B03EE-95FE-457B-869D-1BF7800899D4}" dt="2021-02-07T23:30:01.972" v="833"/>
          <ac:cxnSpMkLst>
            <pc:docMk/>
            <pc:sldMk cId="2720930455" sldId="260"/>
            <ac:cxnSpMk id="37" creationId="{F88F0585-0883-4550-B46A-1A419C2238BE}"/>
          </ac:cxnSpMkLst>
        </pc:cxnChg>
        <pc:cxnChg chg="add mod">
          <ac:chgData name="Amanda Gibson" userId="907984a6-cd77-4b7d-b1f8-6dfd5dda5862" providerId="ADAL" clId="{161B03EE-95FE-457B-869D-1BF7800899D4}" dt="2021-02-07T23:30:01.972" v="833"/>
          <ac:cxnSpMkLst>
            <pc:docMk/>
            <pc:sldMk cId="2720930455" sldId="260"/>
            <ac:cxnSpMk id="39" creationId="{E04BD833-3EC8-4C6E-BBE6-EA5808D5B21E}"/>
          </ac:cxnSpMkLst>
        </pc:cxnChg>
        <pc:cxnChg chg="add mod">
          <ac:chgData name="Amanda Gibson" userId="907984a6-cd77-4b7d-b1f8-6dfd5dda5862" providerId="ADAL" clId="{161B03EE-95FE-457B-869D-1BF7800899D4}" dt="2021-02-07T23:30:15.238" v="835" actId="1076"/>
          <ac:cxnSpMkLst>
            <pc:docMk/>
            <pc:sldMk cId="2720930455" sldId="260"/>
            <ac:cxnSpMk id="41" creationId="{6D55FB04-5277-49B4-8ADF-CDED89F88B90}"/>
          </ac:cxnSpMkLst>
        </pc:cxnChg>
        <pc:cxnChg chg="add mod">
          <ac:chgData name="Amanda Gibson" userId="907984a6-cd77-4b7d-b1f8-6dfd5dda5862" providerId="ADAL" clId="{161B03EE-95FE-457B-869D-1BF7800899D4}" dt="2021-02-07T23:30:31.264" v="838" actId="14100"/>
          <ac:cxnSpMkLst>
            <pc:docMk/>
            <pc:sldMk cId="2720930455" sldId="260"/>
            <ac:cxnSpMk id="43" creationId="{4AFE4589-C802-4C9C-8429-111B9A2AD3CF}"/>
          </ac:cxnSpMkLst>
        </pc:cxnChg>
        <pc:cxnChg chg="add mod">
          <ac:chgData name="Amanda Gibson" userId="907984a6-cd77-4b7d-b1f8-6dfd5dda5862" providerId="ADAL" clId="{161B03EE-95FE-457B-869D-1BF7800899D4}" dt="2021-02-07T23:30:51.605" v="841" actId="571"/>
          <ac:cxnSpMkLst>
            <pc:docMk/>
            <pc:sldMk cId="2720930455" sldId="260"/>
            <ac:cxnSpMk id="46" creationId="{30FD6F98-E783-4192-95D6-23276F500B4C}"/>
          </ac:cxnSpMkLst>
        </pc:cxnChg>
        <pc:cxnChg chg="add mod">
          <ac:chgData name="Amanda Gibson" userId="907984a6-cd77-4b7d-b1f8-6dfd5dda5862" providerId="ADAL" clId="{161B03EE-95FE-457B-869D-1BF7800899D4}" dt="2021-02-07T23:30:54.620" v="842" actId="571"/>
          <ac:cxnSpMkLst>
            <pc:docMk/>
            <pc:sldMk cId="2720930455" sldId="260"/>
            <ac:cxnSpMk id="48" creationId="{8AEF4F75-BC9D-48AC-9DAC-C63AC7E1450B}"/>
          </ac:cxnSpMkLst>
        </pc:cxnChg>
      </pc:sldChg>
      <pc:sldChg chg="modSp">
        <pc:chgData name="Amanda Gibson" userId="907984a6-cd77-4b7d-b1f8-6dfd5dda5862" providerId="ADAL" clId="{161B03EE-95FE-457B-869D-1BF7800899D4}" dt="2021-02-07T23:50:40.735" v="2060" actId="20577"/>
        <pc:sldMkLst>
          <pc:docMk/>
          <pc:sldMk cId="3814277440" sldId="263"/>
        </pc:sldMkLst>
        <pc:spChg chg="mod">
          <ac:chgData name="Amanda Gibson" userId="907984a6-cd77-4b7d-b1f8-6dfd5dda5862" providerId="ADAL" clId="{161B03EE-95FE-457B-869D-1BF7800899D4}" dt="2021-02-07T23:50:40.735" v="2060" actId="20577"/>
          <ac:spMkLst>
            <pc:docMk/>
            <pc:sldMk cId="3814277440" sldId="263"/>
            <ac:spMk id="133" creationId="{FCBFF678-2D12-4089-BC17-3FF02D8C29CF}"/>
          </ac:spMkLst>
        </pc:spChg>
      </pc:sldChg>
      <pc:sldChg chg="modSp">
        <pc:chgData name="Amanda Gibson" userId="907984a6-cd77-4b7d-b1f8-6dfd5dda5862" providerId="ADAL" clId="{161B03EE-95FE-457B-869D-1BF7800899D4}" dt="2021-02-07T23:50:33.205" v="2059" actId="20577"/>
        <pc:sldMkLst>
          <pc:docMk/>
          <pc:sldMk cId="704896010" sldId="265"/>
        </pc:sldMkLst>
        <pc:spChg chg="mod">
          <ac:chgData name="Amanda Gibson" userId="907984a6-cd77-4b7d-b1f8-6dfd5dda5862" providerId="ADAL" clId="{161B03EE-95FE-457B-869D-1BF7800899D4}" dt="2021-02-07T23:50:33.205" v="2059" actId="20577"/>
          <ac:spMkLst>
            <pc:docMk/>
            <pc:sldMk cId="704896010" sldId="265"/>
            <ac:spMk id="133" creationId="{FCBFF678-2D12-4089-BC17-3FF02D8C29CF}"/>
          </ac:spMkLst>
        </pc:spChg>
      </pc:sldChg>
      <pc:sldChg chg="addSp delSp modSp mod ord">
        <pc:chgData name="Amanda Gibson" userId="907984a6-cd77-4b7d-b1f8-6dfd5dda5862" providerId="ADAL" clId="{161B03EE-95FE-457B-869D-1BF7800899D4}" dt="2021-02-07T23:22:54.238" v="494" actId="21"/>
        <pc:sldMkLst>
          <pc:docMk/>
          <pc:sldMk cId="3156922747" sldId="267"/>
        </pc:sldMkLst>
        <pc:spChg chg="add mod">
          <ac:chgData name="Amanda Gibson" userId="907984a6-cd77-4b7d-b1f8-6dfd5dda5862" providerId="ADAL" clId="{161B03EE-95FE-457B-869D-1BF7800899D4}" dt="2021-02-07T23:06:52.456" v="5" actId="208"/>
          <ac:spMkLst>
            <pc:docMk/>
            <pc:sldMk cId="3156922747" sldId="267"/>
            <ac:spMk id="3" creationId="{0DE33D1C-035D-4D28-A945-E49776245146}"/>
          </ac:spMkLst>
        </pc:spChg>
        <pc:spChg chg="mod">
          <ac:chgData name="Amanda Gibson" userId="907984a6-cd77-4b7d-b1f8-6dfd5dda5862" providerId="ADAL" clId="{161B03EE-95FE-457B-869D-1BF7800899D4}" dt="2021-02-07T23:07:10.069" v="8" actId="1076"/>
          <ac:spMkLst>
            <pc:docMk/>
            <pc:sldMk cId="3156922747" sldId="267"/>
            <ac:spMk id="42" creationId="{C1E07250-43D2-4775-A763-56A4085D57AD}"/>
          </ac:spMkLst>
        </pc:spChg>
        <pc:spChg chg="add del mod">
          <ac:chgData name="Amanda Gibson" userId="907984a6-cd77-4b7d-b1f8-6dfd5dda5862" providerId="ADAL" clId="{161B03EE-95FE-457B-869D-1BF7800899D4}" dt="2021-02-07T23:22:54.238" v="494" actId="21"/>
          <ac:spMkLst>
            <pc:docMk/>
            <pc:sldMk cId="3156922747" sldId="267"/>
            <ac:spMk id="43" creationId="{71CE151E-9C23-4513-9B00-B25A53F560E1}"/>
          </ac:spMkLst>
        </pc:spChg>
        <pc:spChg chg="add del mod">
          <ac:chgData name="Amanda Gibson" userId="907984a6-cd77-4b7d-b1f8-6dfd5dda5862" providerId="ADAL" clId="{161B03EE-95FE-457B-869D-1BF7800899D4}" dt="2021-02-07T23:22:54.238" v="494" actId="21"/>
          <ac:spMkLst>
            <pc:docMk/>
            <pc:sldMk cId="3156922747" sldId="267"/>
            <ac:spMk id="45" creationId="{7949AE68-6EB0-4D70-8AAC-CFB0A0B9DD0F}"/>
          </ac:spMkLst>
        </pc:spChg>
        <pc:spChg chg="add del mod">
          <ac:chgData name="Amanda Gibson" userId="907984a6-cd77-4b7d-b1f8-6dfd5dda5862" providerId="ADAL" clId="{161B03EE-95FE-457B-869D-1BF7800899D4}" dt="2021-02-07T23:22:54.238" v="494" actId="21"/>
          <ac:spMkLst>
            <pc:docMk/>
            <pc:sldMk cId="3156922747" sldId="267"/>
            <ac:spMk id="46" creationId="{BEEA6525-6EA6-4CB5-A216-B9AD4E5A6E84}"/>
          </ac:spMkLst>
        </pc:spChg>
        <pc:spChg chg="add del mod">
          <ac:chgData name="Amanda Gibson" userId="907984a6-cd77-4b7d-b1f8-6dfd5dda5862" providerId="ADAL" clId="{161B03EE-95FE-457B-869D-1BF7800899D4}" dt="2021-02-07T23:22:54.238" v="494" actId="21"/>
          <ac:spMkLst>
            <pc:docMk/>
            <pc:sldMk cId="3156922747" sldId="267"/>
            <ac:spMk id="48" creationId="{5C962EB9-9DF4-4F9B-BD85-BB94A84AFE34}"/>
          </ac:spMkLst>
        </pc:spChg>
        <pc:spChg chg="add del mod">
          <ac:chgData name="Amanda Gibson" userId="907984a6-cd77-4b7d-b1f8-6dfd5dda5862" providerId="ADAL" clId="{161B03EE-95FE-457B-869D-1BF7800899D4}" dt="2021-02-07T23:22:54.238" v="494" actId="21"/>
          <ac:spMkLst>
            <pc:docMk/>
            <pc:sldMk cId="3156922747" sldId="267"/>
            <ac:spMk id="50" creationId="{6BA4389C-77D2-4017-B273-1EDABF5BBADB}"/>
          </ac:spMkLst>
        </pc:spChg>
        <pc:cxnChg chg="add del mod">
          <ac:chgData name="Amanda Gibson" userId="907984a6-cd77-4b7d-b1f8-6dfd5dda5862" providerId="ADAL" clId="{161B03EE-95FE-457B-869D-1BF7800899D4}" dt="2021-02-07T23:22:54.238" v="494" actId="21"/>
          <ac:cxnSpMkLst>
            <pc:docMk/>
            <pc:sldMk cId="3156922747" sldId="267"/>
            <ac:cxnSpMk id="44" creationId="{5783EC3A-CF86-4665-817A-FE56F71B52E8}"/>
          </ac:cxnSpMkLst>
        </pc:cxnChg>
        <pc:cxnChg chg="add del mod">
          <ac:chgData name="Amanda Gibson" userId="907984a6-cd77-4b7d-b1f8-6dfd5dda5862" providerId="ADAL" clId="{161B03EE-95FE-457B-869D-1BF7800899D4}" dt="2021-02-07T23:22:54.238" v="494" actId="21"/>
          <ac:cxnSpMkLst>
            <pc:docMk/>
            <pc:sldMk cId="3156922747" sldId="267"/>
            <ac:cxnSpMk id="47" creationId="{B8AA1FBF-85A2-45F2-9507-C358469288CF}"/>
          </ac:cxnSpMkLst>
        </pc:cxnChg>
      </pc:sldChg>
      <pc:sldChg chg="addSp modSp add mod">
        <pc:chgData name="Amanda Gibson" userId="907984a6-cd77-4b7d-b1f8-6dfd5dda5862" providerId="ADAL" clId="{161B03EE-95FE-457B-869D-1BF7800899D4}" dt="2021-02-07T23:24:24.353" v="601" actId="20577"/>
        <pc:sldMkLst>
          <pc:docMk/>
          <pc:sldMk cId="303203322" sldId="268"/>
        </pc:sldMkLst>
        <pc:spChg chg="mod">
          <ac:chgData name="Amanda Gibson" userId="907984a6-cd77-4b7d-b1f8-6dfd5dda5862" providerId="ADAL" clId="{161B03EE-95FE-457B-869D-1BF7800899D4}" dt="2021-02-07T23:24:24.353" v="601" actId="20577"/>
          <ac:spMkLst>
            <pc:docMk/>
            <pc:sldMk cId="303203322" sldId="268"/>
            <ac:spMk id="2" creationId="{28C08DB6-BD44-4401-A786-2D06627D7C16}"/>
          </ac:spMkLst>
        </pc:spChg>
        <pc:spChg chg="add mod">
          <ac:chgData name="Amanda Gibson" userId="907984a6-cd77-4b7d-b1f8-6dfd5dda5862" providerId="ADAL" clId="{161B03EE-95FE-457B-869D-1BF7800899D4}" dt="2021-02-07T23:22:55.724" v="495"/>
          <ac:spMkLst>
            <pc:docMk/>
            <pc:sldMk cId="303203322" sldId="268"/>
            <ac:spMk id="31" creationId="{6DA930FB-AD67-4BF5-B2F1-40CB2B19AF1E}"/>
          </ac:spMkLst>
        </pc:spChg>
        <pc:spChg chg="add mod">
          <ac:chgData name="Amanda Gibson" userId="907984a6-cd77-4b7d-b1f8-6dfd5dda5862" providerId="ADAL" clId="{161B03EE-95FE-457B-869D-1BF7800899D4}" dt="2021-02-07T23:22:55.724" v="495"/>
          <ac:spMkLst>
            <pc:docMk/>
            <pc:sldMk cId="303203322" sldId="268"/>
            <ac:spMk id="33" creationId="{5006F60C-629F-43A4-B394-45D8960BA12C}"/>
          </ac:spMkLst>
        </pc:spChg>
        <pc:spChg chg="add mod">
          <ac:chgData name="Amanda Gibson" userId="907984a6-cd77-4b7d-b1f8-6dfd5dda5862" providerId="ADAL" clId="{161B03EE-95FE-457B-869D-1BF7800899D4}" dt="2021-02-07T23:22:55.724" v="495"/>
          <ac:spMkLst>
            <pc:docMk/>
            <pc:sldMk cId="303203322" sldId="268"/>
            <ac:spMk id="34" creationId="{877AB1D4-B093-428A-9236-823E7C76BEDE}"/>
          </ac:spMkLst>
        </pc:spChg>
        <pc:spChg chg="add mod">
          <ac:chgData name="Amanda Gibson" userId="907984a6-cd77-4b7d-b1f8-6dfd5dda5862" providerId="ADAL" clId="{161B03EE-95FE-457B-869D-1BF7800899D4}" dt="2021-02-07T23:22:55.724" v="495"/>
          <ac:spMkLst>
            <pc:docMk/>
            <pc:sldMk cId="303203322" sldId="268"/>
            <ac:spMk id="36" creationId="{FE50D528-7CEF-4ED2-9834-37A1A83283C3}"/>
          </ac:spMkLst>
        </pc:spChg>
        <pc:spChg chg="add mod">
          <ac:chgData name="Amanda Gibson" userId="907984a6-cd77-4b7d-b1f8-6dfd5dda5862" providerId="ADAL" clId="{161B03EE-95FE-457B-869D-1BF7800899D4}" dt="2021-02-07T23:22:55.724" v="495"/>
          <ac:spMkLst>
            <pc:docMk/>
            <pc:sldMk cId="303203322" sldId="268"/>
            <ac:spMk id="37" creationId="{11F4F17E-B198-4662-82B9-FD38C6AFD4A0}"/>
          </ac:spMkLst>
        </pc:spChg>
        <pc:cxnChg chg="add mod">
          <ac:chgData name="Amanda Gibson" userId="907984a6-cd77-4b7d-b1f8-6dfd5dda5862" providerId="ADAL" clId="{161B03EE-95FE-457B-869D-1BF7800899D4}" dt="2021-02-07T23:22:55.724" v="495"/>
          <ac:cxnSpMkLst>
            <pc:docMk/>
            <pc:sldMk cId="303203322" sldId="268"/>
            <ac:cxnSpMk id="32" creationId="{67223FFA-2893-4A49-B60F-60DCAA072D7F}"/>
          </ac:cxnSpMkLst>
        </pc:cxnChg>
        <pc:cxnChg chg="add mod">
          <ac:chgData name="Amanda Gibson" userId="907984a6-cd77-4b7d-b1f8-6dfd5dda5862" providerId="ADAL" clId="{161B03EE-95FE-457B-869D-1BF7800899D4}" dt="2021-02-07T23:22:55.724" v="495"/>
          <ac:cxnSpMkLst>
            <pc:docMk/>
            <pc:sldMk cId="303203322" sldId="268"/>
            <ac:cxnSpMk id="35" creationId="{EAA5785A-76FF-4E58-9AE8-0555230AEDD3}"/>
          </ac:cxnSpMkLst>
        </pc:cxnChg>
      </pc:sldChg>
      <pc:sldChg chg="addSp delSp modSp add mod ord">
        <pc:chgData name="Amanda Gibson" userId="907984a6-cd77-4b7d-b1f8-6dfd5dda5862" providerId="ADAL" clId="{161B03EE-95FE-457B-869D-1BF7800899D4}" dt="2021-02-07T23:20:42.512" v="442" actId="20577"/>
        <pc:sldMkLst>
          <pc:docMk/>
          <pc:sldMk cId="3619109974" sldId="269"/>
        </pc:sldMkLst>
        <pc:spChg chg="add mod">
          <ac:chgData name="Amanda Gibson" userId="907984a6-cd77-4b7d-b1f8-6dfd5dda5862" providerId="ADAL" clId="{161B03EE-95FE-457B-869D-1BF7800899D4}" dt="2021-02-07T23:15:04.508" v="406" actId="208"/>
          <ac:spMkLst>
            <pc:docMk/>
            <pc:sldMk cId="3619109974" sldId="269"/>
            <ac:spMk id="2" creationId="{F51A084A-20A1-4369-AFA8-8E790C2DC747}"/>
          </ac:spMkLst>
        </pc:spChg>
        <pc:spChg chg="del">
          <ac:chgData name="Amanda Gibson" userId="907984a6-cd77-4b7d-b1f8-6dfd5dda5862" providerId="ADAL" clId="{161B03EE-95FE-457B-869D-1BF7800899D4}" dt="2021-02-07T23:13:09.813" v="394" actId="478"/>
          <ac:spMkLst>
            <pc:docMk/>
            <pc:sldMk cId="3619109974" sldId="269"/>
            <ac:spMk id="37" creationId="{67CD279A-76E7-441F-8C14-4EADF2C21C00}"/>
          </ac:spMkLst>
        </pc:spChg>
        <pc:spChg chg="add mod">
          <ac:chgData name="Amanda Gibson" userId="907984a6-cd77-4b7d-b1f8-6dfd5dda5862" providerId="ADAL" clId="{161B03EE-95FE-457B-869D-1BF7800899D4}" dt="2021-02-07T23:15:04.508" v="406" actId="208"/>
          <ac:spMkLst>
            <pc:docMk/>
            <pc:sldMk cId="3619109974" sldId="269"/>
            <ac:spMk id="57" creationId="{54C203F2-07A3-4AD4-9025-FD00C21B27A1}"/>
          </ac:spMkLst>
        </pc:spChg>
        <pc:spChg chg="add mod">
          <ac:chgData name="Amanda Gibson" userId="907984a6-cd77-4b7d-b1f8-6dfd5dda5862" providerId="ADAL" clId="{161B03EE-95FE-457B-869D-1BF7800899D4}" dt="2021-02-07T23:15:04.508" v="406" actId="208"/>
          <ac:spMkLst>
            <pc:docMk/>
            <pc:sldMk cId="3619109974" sldId="269"/>
            <ac:spMk id="58" creationId="{896ABF27-2A53-46B7-8CC7-165ED60CFC35}"/>
          </ac:spMkLst>
        </pc:spChg>
        <pc:spChg chg="add mod">
          <ac:chgData name="Amanda Gibson" userId="907984a6-cd77-4b7d-b1f8-6dfd5dda5862" providerId="ADAL" clId="{161B03EE-95FE-457B-869D-1BF7800899D4}" dt="2021-02-07T23:15:04.508" v="406" actId="208"/>
          <ac:spMkLst>
            <pc:docMk/>
            <pc:sldMk cId="3619109974" sldId="269"/>
            <ac:spMk id="64" creationId="{A299D3DF-B465-4AB7-9385-48324F6802BE}"/>
          </ac:spMkLst>
        </pc:spChg>
        <pc:spChg chg="add mod">
          <ac:chgData name="Amanda Gibson" userId="907984a6-cd77-4b7d-b1f8-6dfd5dda5862" providerId="ADAL" clId="{161B03EE-95FE-457B-869D-1BF7800899D4}" dt="2021-02-07T23:15:04.508" v="406" actId="208"/>
          <ac:spMkLst>
            <pc:docMk/>
            <pc:sldMk cId="3619109974" sldId="269"/>
            <ac:spMk id="65" creationId="{D3B12C9D-EB89-4932-8C1D-1361ACA48444}"/>
          </ac:spMkLst>
        </pc:spChg>
        <pc:spChg chg="add mod">
          <ac:chgData name="Amanda Gibson" userId="907984a6-cd77-4b7d-b1f8-6dfd5dda5862" providerId="ADAL" clId="{161B03EE-95FE-457B-869D-1BF7800899D4}" dt="2021-02-07T23:20:42.512" v="442" actId="20577"/>
          <ac:spMkLst>
            <pc:docMk/>
            <pc:sldMk cId="3619109974" sldId="269"/>
            <ac:spMk id="66" creationId="{A5692AE5-B003-42A8-8E8E-9CA8E6587F98}"/>
          </ac:spMkLst>
        </pc:spChg>
        <pc:spChg chg="mod">
          <ac:chgData name="Amanda Gibson" userId="907984a6-cd77-4b7d-b1f8-6dfd5dda5862" providerId="ADAL" clId="{161B03EE-95FE-457B-869D-1BF7800899D4}" dt="2021-02-07T23:12:47.993" v="391" actId="20577"/>
          <ac:spMkLst>
            <pc:docMk/>
            <pc:sldMk cId="3619109974" sldId="269"/>
            <ac:spMk id="88" creationId="{BB4E3879-0FC6-44D6-9281-34F2B554E57F}"/>
          </ac:spMkLst>
        </pc:spChg>
        <pc:spChg chg="del">
          <ac:chgData name="Amanda Gibson" userId="907984a6-cd77-4b7d-b1f8-6dfd5dda5862" providerId="ADAL" clId="{161B03EE-95FE-457B-869D-1BF7800899D4}" dt="2021-02-07T23:13:04.777" v="392" actId="478"/>
          <ac:spMkLst>
            <pc:docMk/>
            <pc:sldMk cId="3619109974" sldId="269"/>
            <ac:spMk id="130" creationId="{E1961E32-E05C-4074-9202-D26E7C008F2F}"/>
          </ac:spMkLst>
        </pc:spChg>
        <pc:spChg chg="del">
          <ac:chgData name="Amanda Gibson" userId="907984a6-cd77-4b7d-b1f8-6dfd5dda5862" providerId="ADAL" clId="{161B03EE-95FE-457B-869D-1BF7800899D4}" dt="2021-02-07T23:13:06.979" v="393" actId="478"/>
          <ac:spMkLst>
            <pc:docMk/>
            <pc:sldMk cId="3619109974" sldId="269"/>
            <ac:spMk id="131" creationId="{92EE0D56-23EA-4DB3-ADC0-F17F7053200A}"/>
          </ac:spMkLst>
        </pc:spChg>
        <pc:spChg chg="del">
          <ac:chgData name="Amanda Gibson" userId="907984a6-cd77-4b7d-b1f8-6dfd5dda5862" providerId="ADAL" clId="{161B03EE-95FE-457B-869D-1BF7800899D4}" dt="2021-02-07T23:13:19.782" v="396" actId="478"/>
          <ac:spMkLst>
            <pc:docMk/>
            <pc:sldMk cId="3619109974" sldId="269"/>
            <ac:spMk id="132" creationId="{7056583F-8F74-4665-93C0-E9BE7FAB6F79}"/>
          </ac:spMkLst>
        </pc:spChg>
        <pc:spChg chg="del">
          <ac:chgData name="Amanda Gibson" userId="907984a6-cd77-4b7d-b1f8-6dfd5dda5862" providerId="ADAL" clId="{161B03EE-95FE-457B-869D-1BF7800899D4}" dt="2021-02-07T23:13:17.312" v="395" actId="478"/>
          <ac:spMkLst>
            <pc:docMk/>
            <pc:sldMk cId="3619109974" sldId="269"/>
            <ac:spMk id="133" creationId="{FCBFF678-2D12-4089-BC17-3FF02D8C29CF}"/>
          </ac:spMkLst>
        </pc:spChg>
      </pc:sldChg>
      <pc:sldChg chg="modSp add mod">
        <pc:chgData name="Amanda Gibson" userId="907984a6-cd77-4b7d-b1f8-6dfd5dda5862" providerId="ADAL" clId="{161B03EE-95FE-457B-869D-1BF7800899D4}" dt="2021-02-07T23:26:13.918" v="650" actId="20577"/>
        <pc:sldMkLst>
          <pc:docMk/>
          <pc:sldMk cId="3291021928" sldId="270"/>
        </pc:sldMkLst>
        <pc:spChg chg="mod">
          <ac:chgData name="Amanda Gibson" userId="907984a6-cd77-4b7d-b1f8-6dfd5dda5862" providerId="ADAL" clId="{161B03EE-95FE-457B-869D-1BF7800899D4}" dt="2021-02-07T23:26:13.918" v="650" actId="20577"/>
          <ac:spMkLst>
            <pc:docMk/>
            <pc:sldMk cId="3291021928" sldId="270"/>
            <ac:spMk id="2" creationId="{28C08DB6-BD44-4401-A786-2D06627D7C16}"/>
          </ac:spMkLst>
        </pc:spChg>
      </pc:sldChg>
      <pc:sldChg chg="add del">
        <pc:chgData name="Amanda Gibson" userId="907984a6-cd77-4b7d-b1f8-6dfd5dda5862" providerId="ADAL" clId="{161B03EE-95FE-457B-869D-1BF7800899D4}" dt="2021-02-07T23:22:51.912" v="492"/>
        <pc:sldMkLst>
          <pc:docMk/>
          <pc:sldMk cId="3628805714" sldId="270"/>
        </pc:sldMkLst>
      </pc:sldChg>
      <pc:sldChg chg="addSp delSp modSp add mod">
        <pc:chgData name="Amanda Gibson" userId="907984a6-cd77-4b7d-b1f8-6dfd5dda5862" providerId="ADAL" clId="{161B03EE-95FE-457B-869D-1BF7800899D4}" dt="2021-02-07T23:38:31.311" v="1056" actId="1076"/>
        <pc:sldMkLst>
          <pc:docMk/>
          <pc:sldMk cId="284535913" sldId="271"/>
        </pc:sldMkLst>
        <pc:spChg chg="mod">
          <ac:chgData name="Amanda Gibson" userId="907984a6-cd77-4b7d-b1f8-6dfd5dda5862" providerId="ADAL" clId="{161B03EE-95FE-457B-869D-1BF7800899D4}" dt="2021-02-07T23:38:15.307" v="1055" actId="20577"/>
          <ac:spMkLst>
            <pc:docMk/>
            <pc:sldMk cId="284535913" sldId="271"/>
            <ac:spMk id="2" creationId="{28C08DB6-BD44-4401-A786-2D06627D7C16}"/>
          </ac:spMkLst>
        </pc:spChg>
        <pc:spChg chg="del">
          <ac:chgData name="Amanda Gibson" userId="907984a6-cd77-4b7d-b1f8-6dfd5dda5862" providerId="ADAL" clId="{161B03EE-95FE-457B-869D-1BF7800899D4}" dt="2021-02-07T23:33:13.772" v="979" actId="478"/>
          <ac:spMkLst>
            <pc:docMk/>
            <pc:sldMk cId="284535913" sldId="271"/>
            <ac:spMk id="3" creationId="{0DE33D1C-035D-4D28-A945-E49776245146}"/>
          </ac:spMkLst>
        </pc:spChg>
        <pc:spChg chg="del">
          <ac:chgData name="Amanda Gibson" userId="907984a6-cd77-4b7d-b1f8-6dfd5dda5862" providerId="ADAL" clId="{161B03EE-95FE-457B-869D-1BF7800899D4}" dt="2021-02-07T23:33:13.772" v="979" actId="478"/>
          <ac:spMkLst>
            <pc:docMk/>
            <pc:sldMk cId="284535913" sldId="271"/>
            <ac:spMk id="13" creationId="{063F1761-4EAD-40E2-BD14-2EEF411621C9}"/>
          </ac:spMkLst>
        </pc:spChg>
        <pc:spChg chg="del">
          <ac:chgData name="Amanda Gibson" userId="907984a6-cd77-4b7d-b1f8-6dfd5dda5862" providerId="ADAL" clId="{161B03EE-95FE-457B-869D-1BF7800899D4}" dt="2021-02-07T23:33:13.772" v="979" actId="478"/>
          <ac:spMkLst>
            <pc:docMk/>
            <pc:sldMk cId="284535913" sldId="271"/>
            <ac:spMk id="14" creationId="{A5B98651-E29F-4D49-A6FB-A631BA5B4E18}"/>
          </ac:spMkLst>
        </pc:spChg>
        <pc:spChg chg="del">
          <ac:chgData name="Amanda Gibson" userId="907984a6-cd77-4b7d-b1f8-6dfd5dda5862" providerId="ADAL" clId="{161B03EE-95FE-457B-869D-1BF7800899D4}" dt="2021-02-07T23:33:13.772" v="979" actId="478"/>
          <ac:spMkLst>
            <pc:docMk/>
            <pc:sldMk cId="284535913" sldId="271"/>
            <ac:spMk id="15" creationId="{57DBFBDB-A607-41CD-A042-30EBF2F22D7C}"/>
          </ac:spMkLst>
        </pc:spChg>
        <pc:spChg chg="del">
          <ac:chgData name="Amanda Gibson" userId="907984a6-cd77-4b7d-b1f8-6dfd5dda5862" providerId="ADAL" clId="{161B03EE-95FE-457B-869D-1BF7800899D4}" dt="2021-02-07T23:33:13.772" v="979" actId="478"/>
          <ac:spMkLst>
            <pc:docMk/>
            <pc:sldMk cId="284535913" sldId="271"/>
            <ac:spMk id="16" creationId="{EAFA46F0-1EAD-492B-B17F-9B66C38F660F}"/>
          </ac:spMkLst>
        </pc:spChg>
        <pc:spChg chg="del">
          <ac:chgData name="Amanda Gibson" userId="907984a6-cd77-4b7d-b1f8-6dfd5dda5862" providerId="ADAL" clId="{161B03EE-95FE-457B-869D-1BF7800899D4}" dt="2021-02-07T23:33:13.772" v="979" actId="478"/>
          <ac:spMkLst>
            <pc:docMk/>
            <pc:sldMk cId="284535913" sldId="271"/>
            <ac:spMk id="17" creationId="{7F8CDF7A-FDF6-4DE7-B305-464F6C52B7B9}"/>
          </ac:spMkLst>
        </pc:spChg>
        <pc:spChg chg="del">
          <ac:chgData name="Amanda Gibson" userId="907984a6-cd77-4b7d-b1f8-6dfd5dda5862" providerId="ADAL" clId="{161B03EE-95FE-457B-869D-1BF7800899D4}" dt="2021-02-07T23:33:13.772" v="979" actId="478"/>
          <ac:spMkLst>
            <pc:docMk/>
            <pc:sldMk cId="284535913" sldId="271"/>
            <ac:spMk id="18" creationId="{9F1C46BE-7900-4262-90C3-0471B29061A4}"/>
          </ac:spMkLst>
        </pc:spChg>
        <pc:spChg chg="del">
          <ac:chgData name="Amanda Gibson" userId="907984a6-cd77-4b7d-b1f8-6dfd5dda5862" providerId="ADAL" clId="{161B03EE-95FE-457B-869D-1BF7800899D4}" dt="2021-02-07T23:33:13.772" v="979" actId="478"/>
          <ac:spMkLst>
            <pc:docMk/>
            <pc:sldMk cId="284535913" sldId="271"/>
            <ac:spMk id="20" creationId="{9F438B38-4B5B-42F2-BCB7-6941DD03CAFF}"/>
          </ac:spMkLst>
        </pc:spChg>
        <pc:spChg chg="del">
          <ac:chgData name="Amanda Gibson" userId="907984a6-cd77-4b7d-b1f8-6dfd5dda5862" providerId="ADAL" clId="{161B03EE-95FE-457B-869D-1BF7800899D4}" dt="2021-02-07T23:33:13.772" v="979" actId="478"/>
          <ac:spMkLst>
            <pc:docMk/>
            <pc:sldMk cId="284535913" sldId="271"/>
            <ac:spMk id="21" creationId="{71718F80-5BB8-4AEB-8504-9A2D9A1E5D77}"/>
          </ac:spMkLst>
        </pc:spChg>
        <pc:spChg chg="del">
          <ac:chgData name="Amanda Gibson" userId="907984a6-cd77-4b7d-b1f8-6dfd5dda5862" providerId="ADAL" clId="{161B03EE-95FE-457B-869D-1BF7800899D4}" dt="2021-02-07T23:33:13.772" v="979" actId="478"/>
          <ac:spMkLst>
            <pc:docMk/>
            <pc:sldMk cId="284535913" sldId="271"/>
            <ac:spMk id="22" creationId="{586FD3E3-E337-4357-B28A-016395D6231A}"/>
          </ac:spMkLst>
        </pc:spChg>
        <pc:spChg chg="del">
          <ac:chgData name="Amanda Gibson" userId="907984a6-cd77-4b7d-b1f8-6dfd5dda5862" providerId="ADAL" clId="{161B03EE-95FE-457B-869D-1BF7800899D4}" dt="2021-02-07T23:33:13.772" v="979" actId="478"/>
          <ac:spMkLst>
            <pc:docMk/>
            <pc:sldMk cId="284535913" sldId="271"/>
            <ac:spMk id="23" creationId="{68CC3645-D8F4-4A75-9408-E695E3B04050}"/>
          </ac:spMkLst>
        </pc:spChg>
        <pc:spChg chg="del">
          <ac:chgData name="Amanda Gibson" userId="907984a6-cd77-4b7d-b1f8-6dfd5dda5862" providerId="ADAL" clId="{161B03EE-95FE-457B-869D-1BF7800899D4}" dt="2021-02-07T23:33:13.772" v="979" actId="478"/>
          <ac:spMkLst>
            <pc:docMk/>
            <pc:sldMk cId="284535913" sldId="271"/>
            <ac:spMk id="24" creationId="{EE8F42A6-71D2-4541-9238-A6F22A7FC8B1}"/>
          </ac:spMkLst>
        </pc:spChg>
        <pc:spChg chg="del">
          <ac:chgData name="Amanda Gibson" userId="907984a6-cd77-4b7d-b1f8-6dfd5dda5862" providerId="ADAL" clId="{161B03EE-95FE-457B-869D-1BF7800899D4}" dt="2021-02-07T23:33:13.772" v="979" actId="478"/>
          <ac:spMkLst>
            <pc:docMk/>
            <pc:sldMk cId="284535913" sldId="271"/>
            <ac:spMk id="25" creationId="{F07C037D-791F-459D-B32F-24ECE9031F63}"/>
          </ac:spMkLst>
        </pc:spChg>
        <pc:spChg chg="del">
          <ac:chgData name="Amanda Gibson" userId="907984a6-cd77-4b7d-b1f8-6dfd5dda5862" providerId="ADAL" clId="{161B03EE-95FE-457B-869D-1BF7800899D4}" dt="2021-02-07T23:33:13.772" v="979" actId="478"/>
          <ac:spMkLst>
            <pc:docMk/>
            <pc:sldMk cId="284535913" sldId="271"/>
            <ac:spMk id="31" creationId="{6DA930FB-AD67-4BF5-B2F1-40CB2B19AF1E}"/>
          </ac:spMkLst>
        </pc:spChg>
        <pc:spChg chg="del">
          <ac:chgData name="Amanda Gibson" userId="907984a6-cd77-4b7d-b1f8-6dfd5dda5862" providerId="ADAL" clId="{161B03EE-95FE-457B-869D-1BF7800899D4}" dt="2021-02-07T23:33:13.772" v="979" actId="478"/>
          <ac:spMkLst>
            <pc:docMk/>
            <pc:sldMk cId="284535913" sldId="271"/>
            <ac:spMk id="33" creationId="{5006F60C-629F-43A4-B394-45D8960BA12C}"/>
          </ac:spMkLst>
        </pc:spChg>
        <pc:spChg chg="del">
          <ac:chgData name="Amanda Gibson" userId="907984a6-cd77-4b7d-b1f8-6dfd5dda5862" providerId="ADAL" clId="{161B03EE-95FE-457B-869D-1BF7800899D4}" dt="2021-02-07T23:33:13.772" v="979" actId="478"/>
          <ac:spMkLst>
            <pc:docMk/>
            <pc:sldMk cId="284535913" sldId="271"/>
            <ac:spMk id="34" creationId="{877AB1D4-B093-428A-9236-823E7C76BEDE}"/>
          </ac:spMkLst>
        </pc:spChg>
        <pc:spChg chg="del">
          <ac:chgData name="Amanda Gibson" userId="907984a6-cd77-4b7d-b1f8-6dfd5dda5862" providerId="ADAL" clId="{161B03EE-95FE-457B-869D-1BF7800899D4}" dt="2021-02-07T23:33:13.772" v="979" actId="478"/>
          <ac:spMkLst>
            <pc:docMk/>
            <pc:sldMk cId="284535913" sldId="271"/>
            <ac:spMk id="36" creationId="{FE50D528-7CEF-4ED2-9834-37A1A83283C3}"/>
          </ac:spMkLst>
        </pc:spChg>
        <pc:spChg chg="del">
          <ac:chgData name="Amanda Gibson" userId="907984a6-cd77-4b7d-b1f8-6dfd5dda5862" providerId="ADAL" clId="{161B03EE-95FE-457B-869D-1BF7800899D4}" dt="2021-02-07T23:33:21.606" v="983" actId="478"/>
          <ac:spMkLst>
            <pc:docMk/>
            <pc:sldMk cId="284535913" sldId="271"/>
            <ac:spMk id="37" creationId="{11F4F17E-B198-4662-82B9-FD38C6AFD4A0}"/>
          </ac:spMkLst>
        </pc:spChg>
        <pc:spChg chg="del">
          <ac:chgData name="Amanda Gibson" userId="907984a6-cd77-4b7d-b1f8-6dfd5dda5862" providerId="ADAL" clId="{161B03EE-95FE-457B-869D-1BF7800899D4}" dt="2021-02-07T23:33:13.772" v="979" actId="478"/>
          <ac:spMkLst>
            <pc:docMk/>
            <pc:sldMk cId="284535913" sldId="271"/>
            <ac:spMk id="38" creationId="{AE2451CF-3087-453B-AED6-0A342E20F705}"/>
          </ac:spMkLst>
        </pc:spChg>
        <pc:spChg chg="add mod">
          <ac:chgData name="Amanda Gibson" userId="907984a6-cd77-4b7d-b1f8-6dfd5dda5862" providerId="ADAL" clId="{161B03EE-95FE-457B-869D-1BF7800899D4}" dt="2021-02-07T23:37:49.668" v="1003" actId="1076"/>
          <ac:spMkLst>
            <pc:docMk/>
            <pc:sldMk cId="284535913" sldId="271"/>
            <ac:spMk id="39" creationId="{27D58888-A601-43D8-83DB-2A7A24D06105}"/>
          </ac:spMkLst>
        </pc:spChg>
        <pc:spChg chg="del">
          <ac:chgData name="Amanda Gibson" userId="907984a6-cd77-4b7d-b1f8-6dfd5dda5862" providerId="ADAL" clId="{161B03EE-95FE-457B-869D-1BF7800899D4}" dt="2021-02-07T23:33:19.470" v="982" actId="478"/>
          <ac:spMkLst>
            <pc:docMk/>
            <pc:sldMk cId="284535913" sldId="271"/>
            <ac:spMk id="41" creationId="{39999795-113F-4E9B-AA9E-39C14F92993D}"/>
          </ac:spMkLst>
        </pc:spChg>
        <pc:spChg chg="del">
          <ac:chgData name="Amanda Gibson" userId="907984a6-cd77-4b7d-b1f8-6dfd5dda5862" providerId="ADAL" clId="{161B03EE-95FE-457B-869D-1BF7800899D4}" dt="2021-02-07T23:33:13.772" v="979" actId="478"/>
          <ac:spMkLst>
            <pc:docMk/>
            <pc:sldMk cId="284535913" sldId="271"/>
            <ac:spMk id="42" creationId="{C1E07250-43D2-4775-A763-56A4085D57AD}"/>
          </ac:spMkLst>
        </pc:spChg>
        <pc:spChg chg="add mod">
          <ac:chgData name="Amanda Gibson" userId="907984a6-cd77-4b7d-b1f8-6dfd5dda5862" providerId="ADAL" clId="{161B03EE-95FE-457B-869D-1BF7800899D4}" dt="2021-02-07T23:35:42.558" v="985"/>
          <ac:spMkLst>
            <pc:docMk/>
            <pc:sldMk cId="284535913" sldId="271"/>
            <ac:spMk id="61" creationId="{E1FD9494-E437-48FB-88EE-289A911AB776}"/>
          </ac:spMkLst>
        </pc:spChg>
        <pc:spChg chg="add mod">
          <ac:chgData name="Amanda Gibson" userId="907984a6-cd77-4b7d-b1f8-6dfd5dda5862" providerId="ADAL" clId="{161B03EE-95FE-457B-869D-1BF7800899D4}" dt="2021-02-07T23:35:42.558" v="985"/>
          <ac:spMkLst>
            <pc:docMk/>
            <pc:sldMk cId="284535913" sldId="271"/>
            <ac:spMk id="62" creationId="{CF1DC525-A6C0-4390-AED8-CE86A5F0B56D}"/>
          </ac:spMkLst>
        </pc:spChg>
        <pc:spChg chg="add mod">
          <ac:chgData name="Amanda Gibson" userId="907984a6-cd77-4b7d-b1f8-6dfd5dda5862" providerId="ADAL" clId="{161B03EE-95FE-457B-869D-1BF7800899D4}" dt="2021-02-07T23:35:42.558" v="985"/>
          <ac:spMkLst>
            <pc:docMk/>
            <pc:sldMk cId="284535913" sldId="271"/>
            <ac:spMk id="63" creationId="{F4BCD483-BFD5-4012-9496-1651EB9CA4FF}"/>
          </ac:spMkLst>
        </pc:spChg>
        <pc:spChg chg="add mod">
          <ac:chgData name="Amanda Gibson" userId="907984a6-cd77-4b7d-b1f8-6dfd5dda5862" providerId="ADAL" clId="{161B03EE-95FE-457B-869D-1BF7800899D4}" dt="2021-02-07T23:35:42.558" v="985"/>
          <ac:spMkLst>
            <pc:docMk/>
            <pc:sldMk cId="284535913" sldId="271"/>
            <ac:spMk id="64" creationId="{CAD81215-1598-44A5-BCB5-6E1329FC06CB}"/>
          </ac:spMkLst>
        </pc:spChg>
        <pc:spChg chg="add mod">
          <ac:chgData name="Amanda Gibson" userId="907984a6-cd77-4b7d-b1f8-6dfd5dda5862" providerId="ADAL" clId="{161B03EE-95FE-457B-869D-1BF7800899D4}" dt="2021-02-07T23:35:42.558" v="985"/>
          <ac:spMkLst>
            <pc:docMk/>
            <pc:sldMk cId="284535913" sldId="271"/>
            <ac:spMk id="65" creationId="{D2FFD943-EDDD-401B-9C3B-E66DC286ECA5}"/>
          </ac:spMkLst>
        </pc:spChg>
        <pc:spChg chg="add mod">
          <ac:chgData name="Amanda Gibson" userId="907984a6-cd77-4b7d-b1f8-6dfd5dda5862" providerId="ADAL" clId="{161B03EE-95FE-457B-869D-1BF7800899D4}" dt="2021-02-07T23:35:42.558" v="985"/>
          <ac:spMkLst>
            <pc:docMk/>
            <pc:sldMk cId="284535913" sldId="271"/>
            <ac:spMk id="66" creationId="{304D18D9-1489-4BED-B9FB-54641824AD45}"/>
          </ac:spMkLst>
        </pc:spChg>
        <pc:spChg chg="add mod">
          <ac:chgData name="Amanda Gibson" userId="907984a6-cd77-4b7d-b1f8-6dfd5dda5862" providerId="ADAL" clId="{161B03EE-95FE-457B-869D-1BF7800899D4}" dt="2021-02-07T23:35:42.558" v="985"/>
          <ac:spMkLst>
            <pc:docMk/>
            <pc:sldMk cId="284535913" sldId="271"/>
            <ac:spMk id="67" creationId="{19C21360-5531-40AF-90D8-EA1E050B1624}"/>
          </ac:spMkLst>
        </pc:spChg>
        <pc:spChg chg="add mod">
          <ac:chgData name="Amanda Gibson" userId="907984a6-cd77-4b7d-b1f8-6dfd5dda5862" providerId="ADAL" clId="{161B03EE-95FE-457B-869D-1BF7800899D4}" dt="2021-02-07T23:35:42.558" v="985"/>
          <ac:spMkLst>
            <pc:docMk/>
            <pc:sldMk cId="284535913" sldId="271"/>
            <ac:spMk id="68" creationId="{C9FF9BF8-2DBF-49BB-BB74-CBBEB5494177}"/>
          </ac:spMkLst>
        </pc:spChg>
        <pc:spChg chg="add mod">
          <ac:chgData name="Amanda Gibson" userId="907984a6-cd77-4b7d-b1f8-6dfd5dda5862" providerId="ADAL" clId="{161B03EE-95FE-457B-869D-1BF7800899D4}" dt="2021-02-07T23:35:42.558" v="985"/>
          <ac:spMkLst>
            <pc:docMk/>
            <pc:sldMk cId="284535913" sldId="271"/>
            <ac:spMk id="69" creationId="{3DD35A0C-FB95-451D-9210-529BB8553657}"/>
          </ac:spMkLst>
        </pc:spChg>
        <pc:spChg chg="add mod">
          <ac:chgData name="Amanda Gibson" userId="907984a6-cd77-4b7d-b1f8-6dfd5dda5862" providerId="ADAL" clId="{161B03EE-95FE-457B-869D-1BF7800899D4}" dt="2021-02-07T23:35:42.558" v="985"/>
          <ac:spMkLst>
            <pc:docMk/>
            <pc:sldMk cId="284535913" sldId="271"/>
            <ac:spMk id="70" creationId="{794E1B52-0F46-4FB3-8B7F-EB53C8327154}"/>
          </ac:spMkLst>
        </pc:spChg>
        <pc:spChg chg="add mod">
          <ac:chgData name="Amanda Gibson" userId="907984a6-cd77-4b7d-b1f8-6dfd5dda5862" providerId="ADAL" clId="{161B03EE-95FE-457B-869D-1BF7800899D4}" dt="2021-02-07T23:35:42.558" v="985"/>
          <ac:spMkLst>
            <pc:docMk/>
            <pc:sldMk cId="284535913" sldId="271"/>
            <ac:spMk id="71" creationId="{130AA605-2900-4295-9FAA-F73DDF45F6CF}"/>
          </ac:spMkLst>
        </pc:spChg>
        <pc:spChg chg="add mod">
          <ac:chgData name="Amanda Gibson" userId="907984a6-cd77-4b7d-b1f8-6dfd5dda5862" providerId="ADAL" clId="{161B03EE-95FE-457B-869D-1BF7800899D4}" dt="2021-02-07T23:35:42.558" v="985"/>
          <ac:spMkLst>
            <pc:docMk/>
            <pc:sldMk cId="284535913" sldId="271"/>
            <ac:spMk id="72" creationId="{CD6429D6-BBB2-4B38-8293-0480D5799369}"/>
          </ac:spMkLst>
        </pc:spChg>
        <pc:spChg chg="add mod">
          <ac:chgData name="Amanda Gibson" userId="907984a6-cd77-4b7d-b1f8-6dfd5dda5862" providerId="ADAL" clId="{161B03EE-95FE-457B-869D-1BF7800899D4}" dt="2021-02-07T23:35:42.558" v="985"/>
          <ac:spMkLst>
            <pc:docMk/>
            <pc:sldMk cId="284535913" sldId="271"/>
            <ac:spMk id="73" creationId="{382734AC-1615-4858-818A-F8BE53B6C96D}"/>
          </ac:spMkLst>
        </pc:spChg>
        <pc:spChg chg="add mod">
          <ac:chgData name="Amanda Gibson" userId="907984a6-cd77-4b7d-b1f8-6dfd5dda5862" providerId="ADAL" clId="{161B03EE-95FE-457B-869D-1BF7800899D4}" dt="2021-02-07T23:35:42.558" v="985"/>
          <ac:spMkLst>
            <pc:docMk/>
            <pc:sldMk cId="284535913" sldId="271"/>
            <ac:spMk id="74" creationId="{11AADA4F-09DC-4B0C-B8CE-8E626421B549}"/>
          </ac:spMkLst>
        </pc:spChg>
        <pc:spChg chg="add mod">
          <ac:chgData name="Amanda Gibson" userId="907984a6-cd77-4b7d-b1f8-6dfd5dda5862" providerId="ADAL" clId="{161B03EE-95FE-457B-869D-1BF7800899D4}" dt="2021-02-07T23:35:42.558" v="985"/>
          <ac:spMkLst>
            <pc:docMk/>
            <pc:sldMk cId="284535913" sldId="271"/>
            <ac:spMk id="75" creationId="{F15B31C9-CBD7-4EE4-9CFD-DB390763665D}"/>
          </ac:spMkLst>
        </pc:spChg>
        <pc:spChg chg="add mod">
          <ac:chgData name="Amanda Gibson" userId="907984a6-cd77-4b7d-b1f8-6dfd5dda5862" providerId="ADAL" clId="{161B03EE-95FE-457B-869D-1BF7800899D4}" dt="2021-02-07T23:35:42.558" v="985"/>
          <ac:spMkLst>
            <pc:docMk/>
            <pc:sldMk cId="284535913" sldId="271"/>
            <ac:spMk id="76" creationId="{A41973E2-05AF-4384-A490-018477B607D4}"/>
          </ac:spMkLst>
        </pc:spChg>
        <pc:spChg chg="add mod">
          <ac:chgData name="Amanda Gibson" userId="907984a6-cd77-4b7d-b1f8-6dfd5dda5862" providerId="ADAL" clId="{161B03EE-95FE-457B-869D-1BF7800899D4}" dt="2021-02-07T23:35:42.558" v="985"/>
          <ac:spMkLst>
            <pc:docMk/>
            <pc:sldMk cId="284535913" sldId="271"/>
            <ac:spMk id="77" creationId="{5D11163C-B992-4353-9F3D-BB5DFBCE4FB1}"/>
          </ac:spMkLst>
        </pc:spChg>
        <pc:spChg chg="add mod">
          <ac:chgData name="Amanda Gibson" userId="907984a6-cd77-4b7d-b1f8-6dfd5dda5862" providerId="ADAL" clId="{161B03EE-95FE-457B-869D-1BF7800899D4}" dt="2021-02-07T23:35:42.558" v="985"/>
          <ac:spMkLst>
            <pc:docMk/>
            <pc:sldMk cId="284535913" sldId="271"/>
            <ac:spMk id="78" creationId="{B8CF1FF0-79B3-483F-9320-EF64775CB397}"/>
          </ac:spMkLst>
        </pc:spChg>
        <pc:spChg chg="add mod">
          <ac:chgData name="Amanda Gibson" userId="907984a6-cd77-4b7d-b1f8-6dfd5dda5862" providerId="ADAL" clId="{161B03EE-95FE-457B-869D-1BF7800899D4}" dt="2021-02-07T23:35:42.558" v="985"/>
          <ac:spMkLst>
            <pc:docMk/>
            <pc:sldMk cId="284535913" sldId="271"/>
            <ac:spMk id="79" creationId="{799A331B-6EBE-4CC3-A16F-0B092870A7C6}"/>
          </ac:spMkLst>
        </pc:spChg>
        <pc:spChg chg="add mod">
          <ac:chgData name="Amanda Gibson" userId="907984a6-cd77-4b7d-b1f8-6dfd5dda5862" providerId="ADAL" clId="{161B03EE-95FE-457B-869D-1BF7800899D4}" dt="2021-02-07T23:35:42.558" v="985"/>
          <ac:spMkLst>
            <pc:docMk/>
            <pc:sldMk cId="284535913" sldId="271"/>
            <ac:spMk id="80" creationId="{A2F037F8-2EB4-473A-9038-4B493E305455}"/>
          </ac:spMkLst>
        </pc:spChg>
        <pc:spChg chg="add mod">
          <ac:chgData name="Amanda Gibson" userId="907984a6-cd77-4b7d-b1f8-6dfd5dda5862" providerId="ADAL" clId="{161B03EE-95FE-457B-869D-1BF7800899D4}" dt="2021-02-07T23:35:42.558" v="985"/>
          <ac:spMkLst>
            <pc:docMk/>
            <pc:sldMk cId="284535913" sldId="271"/>
            <ac:spMk id="81" creationId="{77C95FF9-757E-4031-A501-4E78FD91A8E8}"/>
          </ac:spMkLst>
        </pc:spChg>
        <pc:spChg chg="add mod">
          <ac:chgData name="Amanda Gibson" userId="907984a6-cd77-4b7d-b1f8-6dfd5dda5862" providerId="ADAL" clId="{161B03EE-95FE-457B-869D-1BF7800899D4}" dt="2021-02-07T23:35:42.558" v="985"/>
          <ac:spMkLst>
            <pc:docMk/>
            <pc:sldMk cId="284535913" sldId="271"/>
            <ac:spMk id="82" creationId="{3EB1A2A9-F142-481B-BE30-E891504FF6E6}"/>
          </ac:spMkLst>
        </pc:spChg>
        <pc:spChg chg="add mod">
          <ac:chgData name="Amanda Gibson" userId="907984a6-cd77-4b7d-b1f8-6dfd5dda5862" providerId="ADAL" clId="{161B03EE-95FE-457B-869D-1BF7800899D4}" dt="2021-02-07T23:35:42.558" v="985"/>
          <ac:spMkLst>
            <pc:docMk/>
            <pc:sldMk cId="284535913" sldId="271"/>
            <ac:spMk id="83" creationId="{8BD4B837-7EC9-4D46-B106-CAD6EAC86DAF}"/>
          </ac:spMkLst>
        </pc:spChg>
        <pc:spChg chg="add mod">
          <ac:chgData name="Amanda Gibson" userId="907984a6-cd77-4b7d-b1f8-6dfd5dda5862" providerId="ADAL" clId="{161B03EE-95FE-457B-869D-1BF7800899D4}" dt="2021-02-07T23:35:42.558" v="985"/>
          <ac:spMkLst>
            <pc:docMk/>
            <pc:sldMk cId="284535913" sldId="271"/>
            <ac:spMk id="84" creationId="{E3215548-D849-49A7-9A83-98B26F95F25B}"/>
          </ac:spMkLst>
        </pc:spChg>
        <pc:spChg chg="add mod">
          <ac:chgData name="Amanda Gibson" userId="907984a6-cd77-4b7d-b1f8-6dfd5dda5862" providerId="ADAL" clId="{161B03EE-95FE-457B-869D-1BF7800899D4}" dt="2021-02-07T23:35:42.558" v="985"/>
          <ac:spMkLst>
            <pc:docMk/>
            <pc:sldMk cId="284535913" sldId="271"/>
            <ac:spMk id="85" creationId="{2F81B13E-D292-4D17-A9F6-5CA73777B940}"/>
          </ac:spMkLst>
        </pc:spChg>
        <pc:spChg chg="add mod">
          <ac:chgData name="Amanda Gibson" userId="907984a6-cd77-4b7d-b1f8-6dfd5dda5862" providerId="ADAL" clId="{161B03EE-95FE-457B-869D-1BF7800899D4}" dt="2021-02-07T23:35:42.558" v="985"/>
          <ac:spMkLst>
            <pc:docMk/>
            <pc:sldMk cId="284535913" sldId="271"/>
            <ac:spMk id="86" creationId="{2A5BE422-5CA5-4E45-A20A-A35C9E6E9B45}"/>
          </ac:spMkLst>
        </pc:spChg>
        <pc:spChg chg="add mod">
          <ac:chgData name="Amanda Gibson" userId="907984a6-cd77-4b7d-b1f8-6dfd5dda5862" providerId="ADAL" clId="{161B03EE-95FE-457B-869D-1BF7800899D4}" dt="2021-02-07T23:35:42.558" v="985"/>
          <ac:spMkLst>
            <pc:docMk/>
            <pc:sldMk cId="284535913" sldId="271"/>
            <ac:spMk id="87" creationId="{A408FB12-C23F-4899-AA5C-0C06257304A5}"/>
          </ac:spMkLst>
        </pc:spChg>
        <pc:spChg chg="add del mod">
          <ac:chgData name="Amanda Gibson" userId="907984a6-cd77-4b7d-b1f8-6dfd5dda5862" providerId="ADAL" clId="{161B03EE-95FE-457B-869D-1BF7800899D4}" dt="2021-02-07T23:36:45.662" v="996" actId="1076"/>
          <ac:spMkLst>
            <pc:docMk/>
            <pc:sldMk cId="284535913" sldId="271"/>
            <ac:spMk id="88" creationId="{E02AF79D-E5E8-4E83-9A47-DAA469C4CC81}"/>
          </ac:spMkLst>
        </pc:spChg>
        <pc:spChg chg="add del mod">
          <ac:chgData name="Amanda Gibson" userId="907984a6-cd77-4b7d-b1f8-6dfd5dda5862" providerId="ADAL" clId="{161B03EE-95FE-457B-869D-1BF7800899D4}" dt="2021-02-07T23:36:45.662" v="996" actId="1076"/>
          <ac:spMkLst>
            <pc:docMk/>
            <pc:sldMk cId="284535913" sldId="271"/>
            <ac:spMk id="89" creationId="{3A1C2354-CB97-4539-B2E6-1F48EB6681BC}"/>
          </ac:spMkLst>
        </pc:spChg>
        <pc:spChg chg="add mod">
          <ac:chgData name="Amanda Gibson" userId="907984a6-cd77-4b7d-b1f8-6dfd5dda5862" providerId="ADAL" clId="{161B03EE-95FE-457B-869D-1BF7800899D4}" dt="2021-02-07T23:36:45.662" v="996" actId="1076"/>
          <ac:spMkLst>
            <pc:docMk/>
            <pc:sldMk cId="284535913" sldId="271"/>
            <ac:spMk id="90" creationId="{C6BC3E5C-7AEC-478A-9C2F-4AE5B70715C9}"/>
          </ac:spMkLst>
        </pc:spChg>
        <pc:spChg chg="add mod">
          <ac:chgData name="Amanda Gibson" userId="907984a6-cd77-4b7d-b1f8-6dfd5dda5862" providerId="ADAL" clId="{161B03EE-95FE-457B-869D-1BF7800899D4}" dt="2021-02-07T23:36:45.662" v="996" actId="1076"/>
          <ac:spMkLst>
            <pc:docMk/>
            <pc:sldMk cId="284535913" sldId="271"/>
            <ac:spMk id="91" creationId="{69AFBEEB-9DA9-47C8-870A-4BF72E457C16}"/>
          </ac:spMkLst>
        </pc:spChg>
        <pc:spChg chg="add mod">
          <ac:chgData name="Amanda Gibson" userId="907984a6-cd77-4b7d-b1f8-6dfd5dda5862" providerId="ADAL" clId="{161B03EE-95FE-457B-869D-1BF7800899D4}" dt="2021-02-07T23:36:45.662" v="996" actId="1076"/>
          <ac:spMkLst>
            <pc:docMk/>
            <pc:sldMk cId="284535913" sldId="271"/>
            <ac:spMk id="92" creationId="{DCD63FD1-D848-4F9B-B53E-883996B4CB7A}"/>
          </ac:spMkLst>
        </pc:spChg>
        <pc:spChg chg="add mod">
          <ac:chgData name="Amanda Gibson" userId="907984a6-cd77-4b7d-b1f8-6dfd5dda5862" providerId="ADAL" clId="{161B03EE-95FE-457B-869D-1BF7800899D4}" dt="2021-02-07T23:36:45.662" v="996" actId="1076"/>
          <ac:spMkLst>
            <pc:docMk/>
            <pc:sldMk cId="284535913" sldId="271"/>
            <ac:spMk id="93" creationId="{A46A09FC-8F6E-4351-9439-21C5B0E6C1FE}"/>
          </ac:spMkLst>
        </pc:spChg>
        <pc:spChg chg="add mod">
          <ac:chgData name="Amanda Gibson" userId="907984a6-cd77-4b7d-b1f8-6dfd5dda5862" providerId="ADAL" clId="{161B03EE-95FE-457B-869D-1BF7800899D4}" dt="2021-02-07T23:36:45.662" v="996" actId="1076"/>
          <ac:spMkLst>
            <pc:docMk/>
            <pc:sldMk cId="284535913" sldId="271"/>
            <ac:spMk id="94" creationId="{45B413E9-B943-4FA7-8ED2-52FFF6A7BC3C}"/>
          </ac:spMkLst>
        </pc:spChg>
        <pc:spChg chg="add mod">
          <ac:chgData name="Amanda Gibson" userId="907984a6-cd77-4b7d-b1f8-6dfd5dda5862" providerId="ADAL" clId="{161B03EE-95FE-457B-869D-1BF7800899D4}" dt="2021-02-07T23:36:45.662" v="996" actId="1076"/>
          <ac:spMkLst>
            <pc:docMk/>
            <pc:sldMk cId="284535913" sldId="271"/>
            <ac:spMk id="95" creationId="{88DD6E14-873E-4FC1-8D29-4684985DF959}"/>
          </ac:spMkLst>
        </pc:spChg>
        <pc:spChg chg="add mod">
          <ac:chgData name="Amanda Gibson" userId="907984a6-cd77-4b7d-b1f8-6dfd5dda5862" providerId="ADAL" clId="{161B03EE-95FE-457B-869D-1BF7800899D4}" dt="2021-02-07T23:36:45.662" v="996" actId="1076"/>
          <ac:spMkLst>
            <pc:docMk/>
            <pc:sldMk cId="284535913" sldId="271"/>
            <ac:spMk id="96" creationId="{65B182B4-A532-4856-81B7-BEEE275F2508}"/>
          </ac:spMkLst>
        </pc:spChg>
        <pc:spChg chg="add del mod">
          <ac:chgData name="Amanda Gibson" userId="907984a6-cd77-4b7d-b1f8-6dfd5dda5862" providerId="ADAL" clId="{161B03EE-95FE-457B-869D-1BF7800899D4}" dt="2021-02-07T23:36:30.877" v="995" actId="478"/>
          <ac:spMkLst>
            <pc:docMk/>
            <pc:sldMk cId="284535913" sldId="271"/>
            <ac:spMk id="97" creationId="{5BECCAE3-8FFB-4F18-AD14-DDA66065487D}"/>
          </ac:spMkLst>
        </pc:spChg>
        <pc:spChg chg="add del mod">
          <ac:chgData name="Amanda Gibson" userId="907984a6-cd77-4b7d-b1f8-6dfd5dda5862" providerId="ADAL" clId="{161B03EE-95FE-457B-869D-1BF7800899D4}" dt="2021-02-07T23:36:26.888" v="994" actId="478"/>
          <ac:spMkLst>
            <pc:docMk/>
            <pc:sldMk cId="284535913" sldId="271"/>
            <ac:spMk id="98" creationId="{89AE17DA-D30C-42D8-9376-5E3216E4F799}"/>
          </ac:spMkLst>
        </pc:spChg>
        <pc:spChg chg="add mod">
          <ac:chgData name="Amanda Gibson" userId="907984a6-cd77-4b7d-b1f8-6dfd5dda5862" providerId="ADAL" clId="{161B03EE-95FE-457B-869D-1BF7800899D4}" dt="2021-02-07T23:38:31.311" v="1056" actId="1076"/>
          <ac:spMkLst>
            <pc:docMk/>
            <pc:sldMk cId="284535913" sldId="271"/>
            <ac:spMk id="99" creationId="{57A54BF0-E63B-4D90-8391-0278D839B39D}"/>
          </ac:spMkLst>
        </pc:spChg>
        <pc:cxnChg chg="del">
          <ac:chgData name="Amanda Gibson" userId="907984a6-cd77-4b7d-b1f8-6dfd5dda5862" providerId="ADAL" clId="{161B03EE-95FE-457B-869D-1BF7800899D4}" dt="2021-02-07T23:33:13.772" v="979" actId="478"/>
          <ac:cxnSpMkLst>
            <pc:docMk/>
            <pc:sldMk cId="284535913" sldId="271"/>
            <ac:cxnSpMk id="5" creationId="{5E6CC999-542D-450B-9072-1D8886BE890D}"/>
          </ac:cxnSpMkLst>
        </pc:cxnChg>
        <pc:cxnChg chg="del">
          <ac:chgData name="Amanda Gibson" userId="907984a6-cd77-4b7d-b1f8-6dfd5dda5862" providerId="ADAL" clId="{161B03EE-95FE-457B-869D-1BF7800899D4}" dt="2021-02-07T23:33:13.772" v="979" actId="478"/>
          <ac:cxnSpMkLst>
            <pc:docMk/>
            <pc:sldMk cId="284535913" sldId="271"/>
            <ac:cxnSpMk id="6" creationId="{08F7E712-5429-455C-9EFB-D74CDF210A04}"/>
          </ac:cxnSpMkLst>
        </pc:cxnChg>
        <pc:cxnChg chg="del">
          <ac:chgData name="Amanda Gibson" userId="907984a6-cd77-4b7d-b1f8-6dfd5dda5862" providerId="ADAL" clId="{161B03EE-95FE-457B-869D-1BF7800899D4}" dt="2021-02-07T23:33:13.772" v="979" actId="478"/>
          <ac:cxnSpMkLst>
            <pc:docMk/>
            <pc:sldMk cId="284535913" sldId="271"/>
            <ac:cxnSpMk id="7" creationId="{F9A5C009-1910-496B-A7C1-1822970F0A54}"/>
          </ac:cxnSpMkLst>
        </pc:cxnChg>
        <pc:cxnChg chg="del">
          <ac:chgData name="Amanda Gibson" userId="907984a6-cd77-4b7d-b1f8-6dfd5dda5862" providerId="ADAL" clId="{161B03EE-95FE-457B-869D-1BF7800899D4}" dt="2021-02-07T23:33:13.772" v="979" actId="478"/>
          <ac:cxnSpMkLst>
            <pc:docMk/>
            <pc:sldMk cId="284535913" sldId="271"/>
            <ac:cxnSpMk id="8" creationId="{B66BFC10-08DE-48B5-B23A-6F183F082A13}"/>
          </ac:cxnSpMkLst>
        </pc:cxnChg>
        <pc:cxnChg chg="del">
          <ac:chgData name="Amanda Gibson" userId="907984a6-cd77-4b7d-b1f8-6dfd5dda5862" providerId="ADAL" clId="{161B03EE-95FE-457B-869D-1BF7800899D4}" dt="2021-02-07T23:33:13.772" v="979" actId="478"/>
          <ac:cxnSpMkLst>
            <pc:docMk/>
            <pc:sldMk cId="284535913" sldId="271"/>
            <ac:cxnSpMk id="9" creationId="{743E1477-59EB-44BF-9DB3-3C6A7A8C082D}"/>
          </ac:cxnSpMkLst>
        </pc:cxnChg>
        <pc:cxnChg chg="del">
          <ac:chgData name="Amanda Gibson" userId="907984a6-cd77-4b7d-b1f8-6dfd5dda5862" providerId="ADAL" clId="{161B03EE-95FE-457B-869D-1BF7800899D4}" dt="2021-02-07T23:33:13.772" v="979" actId="478"/>
          <ac:cxnSpMkLst>
            <pc:docMk/>
            <pc:sldMk cId="284535913" sldId="271"/>
            <ac:cxnSpMk id="10" creationId="{11323809-9FDA-4F29-A82C-AA0FBACD5790}"/>
          </ac:cxnSpMkLst>
        </pc:cxnChg>
        <pc:cxnChg chg="del">
          <ac:chgData name="Amanda Gibson" userId="907984a6-cd77-4b7d-b1f8-6dfd5dda5862" providerId="ADAL" clId="{161B03EE-95FE-457B-869D-1BF7800899D4}" dt="2021-02-07T23:33:13.772" v="979" actId="478"/>
          <ac:cxnSpMkLst>
            <pc:docMk/>
            <pc:sldMk cId="284535913" sldId="271"/>
            <ac:cxnSpMk id="32" creationId="{67223FFA-2893-4A49-B60F-60DCAA072D7F}"/>
          </ac:cxnSpMkLst>
        </pc:cxnChg>
        <pc:cxnChg chg="del">
          <ac:chgData name="Amanda Gibson" userId="907984a6-cd77-4b7d-b1f8-6dfd5dda5862" providerId="ADAL" clId="{161B03EE-95FE-457B-869D-1BF7800899D4}" dt="2021-02-07T23:33:13.772" v="979" actId="478"/>
          <ac:cxnSpMkLst>
            <pc:docMk/>
            <pc:sldMk cId="284535913" sldId="271"/>
            <ac:cxnSpMk id="35" creationId="{EAA5785A-76FF-4E58-9AE8-0555230AEDD3}"/>
          </ac:cxnSpMkLst>
        </pc:cxnChg>
        <pc:cxnChg chg="add mod">
          <ac:chgData name="Amanda Gibson" userId="907984a6-cd77-4b7d-b1f8-6dfd5dda5862" providerId="ADAL" clId="{161B03EE-95FE-457B-869D-1BF7800899D4}" dt="2021-02-07T23:35:42.558" v="985"/>
          <ac:cxnSpMkLst>
            <pc:docMk/>
            <pc:sldMk cId="284535913" sldId="271"/>
            <ac:cxnSpMk id="40" creationId="{B0C75C54-9777-4355-8ED0-3AE4B6C24E65}"/>
          </ac:cxnSpMkLst>
        </pc:cxnChg>
        <pc:cxnChg chg="add mod">
          <ac:chgData name="Amanda Gibson" userId="907984a6-cd77-4b7d-b1f8-6dfd5dda5862" providerId="ADAL" clId="{161B03EE-95FE-457B-869D-1BF7800899D4}" dt="2021-02-07T23:35:42.558" v="985"/>
          <ac:cxnSpMkLst>
            <pc:docMk/>
            <pc:sldMk cId="284535913" sldId="271"/>
            <ac:cxnSpMk id="43" creationId="{C09FC3A6-B612-4A0E-A9AF-AE55C01646C0}"/>
          </ac:cxnSpMkLst>
        </pc:cxnChg>
        <pc:cxnChg chg="add mod">
          <ac:chgData name="Amanda Gibson" userId="907984a6-cd77-4b7d-b1f8-6dfd5dda5862" providerId="ADAL" clId="{161B03EE-95FE-457B-869D-1BF7800899D4}" dt="2021-02-07T23:35:42.558" v="985"/>
          <ac:cxnSpMkLst>
            <pc:docMk/>
            <pc:sldMk cId="284535913" sldId="271"/>
            <ac:cxnSpMk id="44" creationId="{EE6AF921-BF94-4F45-9936-D9522C3D3BA0}"/>
          </ac:cxnSpMkLst>
        </pc:cxnChg>
        <pc:cxnChg chg="add mod">
          <ac:chgData name="Amanda Gibson" userId="907984a6-cd77-4b7d-b1f8-6dfd5dda5862" providerId="ADAL" clId="{161B03EE-95FE-457B-869D-1BF7800899D4}" dt="2021-02-07T23:35:42.558" v="985"/>
          <ac:cxnSpMkLst>
            <pc:docMk/>
            <pc:sldMk cId="284535913" sldId="271"/>
            <ac:cxnSpMk id="45" creationId="{07A3D001-4343-440F-BC09-7E755AEADA54}"/>
          </ac:cxnSpMkLst>
        </pc:cxnChg>
        <pc:cxnChg chg="add mod">
          <ac:chgData name="Amanda Gibson" userId="907984a6-cd77-4b7d-b1f8-6dfd5dda5862" providerId="ADAL" clId="{161B03EE-95FE-457B-869D-1BF7800899D4}" dt="2021-02-07T23:35:42.558" v="985"/>
          <ac:cxnSpMkLst>
            <pc:docMk/>
            <pc:sldMk cId="284535913" sldId="271"/>
            <ac:cxnSpMk id="46" creationId="{E4215D8C-F389-47EB-B9CD-6386BFAD7F84}"/>
          </ac:cxnSpMkLst>
        </pc:cxnChg>
        <pc:cxnChg chg="add mod">
          <ac:chgData name="Amanda Gibson" userId="907984a6-cd77-4b7d-b1f8-6dfd5dda5862" providerId="ADAL" clId="{161B03EE-95FE-457B-869D-1BF7800899D4}" dt="2021-02-07T23:35:42.558" v="985"/>
          <ac:cxnSpMkLst>
            <pc:docMk/>
            <pc:sldMk cId="284535913" sldId="271"/>
            <ac:cxnSpMk id="47" creationId="{CEA95916-EA13-4C8E-9249-787B254E44A3}"/>
          </ac:cxnSpMkLst>
        </pc:cxnChg>
        <pc:cxnChg chg="add mod">
          <ac:chgData name="Amanda Gibson" userId="907984a6-cd77-4b7d-b1f8-6dfd5dda5862" providerId="ADAL" clId="{161B03EE-95FE-457B-869D-1BF7800899D4}" dt="2021-02-07T23:35:42.558" v="985"/>
          <ac:cxnSpMkLst>
            <pc:docMk/>
            <pc:sldMk cId="284535913" sldId="271"/>
            <ac:cxnSpMk id="48" creationId="{FF8104FF-B039-444B-941E-9D5A7ADE03D6}"/>
          </ac:cxnSpMkLst>
        </pc:cxnChg>
        <pc:cxnChg chg="add mod">
          <ac:chgData name="Amanda Gibson" userId="907984a6-cd77-4b7d-b1f8-6dfd5dda5862" providerId="ADAL" clId="{161B03EE-95FE-457B-869D-1BF7800899D4}" dt="2021-02-07T23:35:42.558" v="985"/>
          <ac:cxnSpMkLst>
            <pc:docMk/>
            <pc:sldMk cId="284535913" sldId="271"/>
            <ac:cxnSpMk id="49" creationId="{D5E5D010-18E1-4583-B741-EA7A7CBDAB0C}"/>
          </ac:cxnSpMkLst>
        </pc:cxnChg>
        <pc:cxnChg chg="add del mod">
          <ac:chgData name="Amanda Gibson" userId="907984a6-cd77-4b7d-b1f8-6dfd5dda5862" providerId="ADAL" clId="{161B03EE-95FE-457B-869D-1BF7800899D4}" dt="2021-02-07T23:37:23.077" v="1002" actId="1076"/>
          <ac:cxnSpMkLst>
            <pc:docMk/>
            <pc:sldMk cId="284535913" sldId="271"/>
            <ac:cxnSpMk id="50" creationId="{28FB31A9-BBFC-4E52-97CB-1ED0A23439F9}"/>
          </ac:cxnSpMkLst>
        </pc:cxnChg>
        <pc:cxnChg chg="add mod">
          <ac:chgData name="Amanda Gibson" userId="907984a6-cd77-4b7d-b1f8-6dfd5dda5862" providerId="ADAL" clId="{161B03EE-95FE-457B-869D-1BF7800899D4}" dt="2021-02-07T23:36:10.831" v="989" actId="208"/>
          <ac:cxnSpMkLst>
            <pc:docMk/>
            <pc:sldMk cId="284535913" sldId="271"/>
            <ac:cxnSpMk id="51" creationId="{A3500F1A-C26B-495A-8C89-6E3665DF2D08}"/>
          </ac:cxnSpMkLst>
        </pc:cxnChg>
        <pc:cxnChg chg="add mod">
          <ac:chgData name="Amanda Gibson" userId="907984a6-cd77-4b7d-b1f8-6dfd5dda5862" providerId="ADAL" clId="{161B03EE-95FE-457B-869D-1BF7800899D4}" dt="2021-02-07T23:35:42.558" v="985"/>
          <ac:cxnSpMkLst>
            <pc:docMk/>
            <pc:sldMk cId="284535913" sldId="271"/>
            <ac:cxnSpMk id="52" creationId="{1B4BD474-CA63-446C-8B42-6087BB84047C}"/>
          </ac:cxnSpMkLst>
        </pc:cxnChg>
        <pc:cxnChg chg="add mod">
          <ac:chgData name="Amanda Gibson" userId="907984a6-cd77-4b7d-b1f8-6dfd5dda5862" providerId="ADAL" clId="{161B03EE-95FE-457B-869D-1BF7800899D4}" dt="2021-02-07T23:35:42.558" v="985"/>
          <ac:cxnSpMkLst>
            <pc:docMk/>
            <pc:sldMk cId="284535913" sldId="271"/>
            <ac:cxnSpMk id="53" creationId="{68877F21-0715-4C2C-BD86-5FF8D6383C20}"/>
          </ac:cxnSpMkLst>
        </pc:cxnChg>
        <pc:cxnChg chg="add mod">
          <ac:chgData name="Amanda Gibson" userId="907984a6-cd77-4b7d-b1f8-6dfd5dda5862" providerId="ADAL" clId="{161B03EE-95FE-457B-869D-1BF7800899D4}" dt="2021-02-07T23:35:42.558" v="985"/>
          <ac:cxnSpMkLst>
            <pc:docMk/>
            <pc:sldMk cId="284535913" sldId="271"/>
            <ac:cxnSpMk id="54" creationId="{446F511D-2EE9-4CF1-B470-231B51AECD7A}"/>
          </ac:cxnSpMkLst>
        </pc:cxnChg>
        <pc:cxnChg chg="add mod">
          <ac:chgData name="Amanda Gibson" userId="907984a6-cd77-4b7d-b1f8-6dfd5dda5862" providerId="ADAL" clId="{161B03EE-95FE-457B-869D-1BF7800899D4}" dt="2021-02-07T23:35:42.558" v="985"/>
          <ac:cxnSpMkLst>
            <pc:docMk/>
            <pc:sldMk cId="284535913" sldId="271"/>
            <ac:cxnSpMk id="55" creationId="{1CCEBE3F-5D3F-4DE3-95CA-2B40DB4D4D47}"/>
          </ac:cxnSpMkLst>
        </pc:cxnChg>
        <pc:cxnChg chg="add mod">
          <ac:chgData name="Amanda Gibson" userId="907984a6-cd77-4b7d-b1f8-6dfd5dda5862" providerId="ADAL" clId="{161B03EE-95FE-457B-869D-1BF7800899D4}" dt="2021-02-07T23:35:42.558" v="985"/>
          <ac:cxnSpMkLst>
            <pc:docMk/>
            <pc:sldMk cId="284535913" sldId="271"/>
            <ac:cxnSpMk id="56" creationId="{3D182075-E6E1-4F41-8FEC-0D54A8C76EA3}"/>
          </ac:cxnSpMkLst>
        </pc:cxnChg>
        <pc:cxnChg chg="add mod">
          <ac:chgData name="Amanda Gibson" userId="907984a6-cd77-4b7d-b1f8-6dfd5dda5862" providerId="ADAL" clId="{161B03EE-95FE-457B-869D-1BF7800899D4}" dt="2021-02-07T23:35:42.558" v="985"/>
          <ac:cxnSpMkLst>
            <pc:docMk/>
            <pc:sldMk cId="284535913" sldId="271"/>
            <ac:cxnSpMk id="57" creationId="{FBCEDD3B-FD2C-4D58-BCD0-4BEA878C17AE}"/>
          </ac:cxnSpMkLst>
        </pc:cxnChg>
        <pc:cxnChg chg="add mod">
          <ac:chgData name="Amanda Gibson" userId="907984a6-cd77-4b7d-b1f8-6dfd5dda5862" providerId="ADAL" clId="{161B03EE-95FE-457B-869D-1BF7800899D4}" dt="2021-02-07T23:35:42.558" v="985"/>
          <ac:cxnSpMkLst>
            <pc:docMk/>
            <pc:sldMk cId="284535913" sldId="271"/>
            <ac:cxnSpMk id="58" creationId="{9E5FBB96-7F3B-46A5-9A11-F2F32AB146E8}"/>
          </ac:cxnSpMkLst>
        </pc:cxnChg>
        <pc:cxnChg chg="add mod">
          <ac:chgData name="Amanda Gibson" userId="907984a6-cd77-4b7d-b1f8-6dfd5dda5862" providerId="ADAL" clId="{161B03EE-95FE-457B-869D-1BF7800899D4}" dt="2021-02-07T23:35:42.558" v="985"/>
          <ac:cxnSpMkLst>
            <pc:docMk/>
            <pc:sldMk cId="284535913" sldId="271"/>
            <ac:cxnSpMk id="59" creationId="{2371B90C-54E3-4226-B6E2-0E4170CE025D}"/>
          </ac:cxnSpMkLst>
        </pc:cxnChg>
        <pc:cxnChg chg="add mod">
          <ac:chgData name="Amanda Gibson" userId="907984a6-cd77-4b7d-b1f8-6dfd5dda5862" providerId="ADAL" clId="{161B03EE-95FE-457B-869D-1BF7800899D4}" dt="2021-02-07T23:35:42.558" v="985"/>
          <ac:cxnSpMkLst>
            <pc:docMk/>
            <pc:sldMk cId="284535913" sldId="271"/>
            <ac:cxnSpMk id="60" creationId="{BFB0E42A-B467-43CF-BE2A-23BB4F099047}"/>
          </ac:cxnSpMkLst>
        </pc:cxnChg>
      </pc:sldChg>
      <pc:sldChg chg="addSp modSp add mod">
        <pc:chgData name="Amanda Gibson" userId="907984a6-cd77-4b7d-b1f8-6dfd5dda5862" providerId="ADAL" clId="{161B03EE-95FE-457B-869D-1BF7800899D4}" dt="2021-02-08T01:29:19.767" v="5101" actId="207"/>
        <pc:sldMkLst>
          <pc:docMk/>
          <pc:sldMk cId="1271623256" sldId="272"/>
        </pc:sldMkLst>
        <pc:spChg chg="mod">
          <ac:chgData name="Amanda Gibson" userId="907984a6-cd77-4b7d-b1f8-6dfd5dda5862" providerId="ADAL" clId="{161B03EE-95FE-457B-869D-1BF7800899D4}" dt="2021-02-07T23:39:20.775" v="1233" actId="20577"/>
          <ac:spMkLst>
            <pc:docMk/>
            <pc:sldMk cId="1271623256" sldId="272"/>
            <ac:spMk id="2" creationId="{28C08DB6-BD44-4401-A786-2D06627D7C16}"/>
          </ac:spMkLst>
        </pc:spChg>
        <pc:spChg chg="add mod">
          <ac:chgData name="Amanda Gibson" userId="907984a6-cd77-4b7d-b1f8-6dfd5dda5862" providerId="ADAL" clId="{161B03EE-95FE-457B-869D-1BF7800899D4}" dt="2021-02-08T01:29:19.767" v="5101" actId="207"/>
          <ac:spMkLst>
            <pc:docMk/>
            <pc:sldMk cId="1271623256" sldId="272"/>
            <ac:spMk id="97" creationId="{CEFFC746-337A-4770-A155-BC72A2353F84}"/>
          </ac:spMkLst>
        </pc:spChg>
      </pc:sldChg>
      <pc:sldChg chg="modSp add mod">
        <pc:chgData name="Amanda Gibson" userId="907984a6-cd77-4b7d-b1f8-6dfd5dda5862" providerId="ADAL" clId="{161B03EE-95FE-457B-869D-1BF7800899D4}" dt="2021-02-07T23:45:15.568" v="1785" actId="207"/>
        <pc:sldMkLst>
          <pc:docMk/>
          <pc:sldMk cId="964794674" sldId="273"/>
        </pc:sldMkLst>
        <pc:spChg chg="mod">
          <ac:chgData name="Amanda Gibson" userId="907984a6-cd77-4b7d-b1f8-6dfd5dda5862" providerId="ADAL" clId="{161B03EE-95FE-457B-869D-1BF7800899D4}" dt="2021-02-07T23:40:39.355" v="1465" actId="20577"/>
          <ac:spMkLst>
            <pc:docMk/>
            <pc:sldMk cId="964794674" sldId="273"/>
            <ac:spMk id="2" creationId="{28C08DB6-BD44-4401-A786-2D06627D7C16}"/>
          </ac:spMkLst>
        </pc:spChg>
        <pc:spChg chg="mod">
          <ac:chgData name="Amanda Gibson" userId="907984a6-cd77-4b7d-b1f8-6dfd5dda5862" providerId="ADAL" clId="{161B03EE-95FE-457B-869D-1BF7800899D4}" dt="2021-02-07T23:45:15.568" v="1785" actId="207"/>
          <ac:spMkLst>
            <pc:docMk/>
            <pc:sldMk cId="964794674" sldId="273"/>
            <ac:spMk id="97" creationId="{CEFFC746-337A-4770-A155-BC72A2353F84}"/>
          </ac:spMkLst>
        </pc:spChg>
      </pc:sldChg>
      <pc:sldChg chg="addSp delSp modSp add mod ord">
        <pc:chgData name="Amanda Gibson" userId="907984a6-cd77-4b7d-b1f8-6dfd5dda5862" providerId="ADAL" clId="{161B03EE-95FE-457B-869D-1BF7800899D4}" dt="2021-02-07T23:50:14.807" v="2057" actId="20577"/>
        <pc:sldMkLst>
          <pc:docMk/>
          <pc:sldMk cId="3406265641" sldId="274"/>
        </pc:sldMkLst>
        <pc:spChg chg="del">
          <ac:chgData name="Amanda Gibson" userId="907984a6-cd77-4b7d-b1f8-6dfd5dda5862" providerId="ADAL" clId="{161B03EE-95FE-457B-869D-1BF7800899D4}" dt="2021-02-07T23:43:11.145" v="1647" actId="478"/>
          <ac:spMkLst>
            <pc:docMk/>
            <pc:sldMk cId="3406265641" sldId="274"/>
            <ac:spMk id="37" creationId="{67CD279A-76E7-441F-8C14-4EADF2C21C00}"/>
          </ac:spMkLst>
        </pc:spChg>
        <pc:spChg chg="del mod">
          <ac:chgData name="Amanda Gibson" userId="907984a6-cd77-4b7d-b1f8-6dfd5dda5862" providerId="ADAL" clId="{161B03EE-95FE-457B-869D-1BF7800899D4}" dt="2021-02-07T23:43:18.465" v="1651"/>
          <ac:spMkLst>
            <pc:docMk/>
            <pc:sldMk cId="3406265641" sldId="274"/>
            <ac:spMk id="42" creationId="{804278AB-ADAA-4094-9AC0-41B605F71761}"/>
          </ac:spMkLst>
        </pc:spChg>
        <pc:spChg chg="del">
          <ac:chgData name="Amanda Gibson" userId="907984a6-cd77-4b7d-b1f8-6dfd5dda5862" providerId="ADAL" clId="{161B03EE-95FE-457B-869D-1BF7800899D4}" dt="2021-02-07T23:43:18.463" v="1649" actId="478"/>
          <ac:spMkLst>
            <pc:docMk/>
            <pc:sldMk cId="3406265641" sldId="274"/>
            <ac:spMk id="44" creationId="{F83A1E40-4E6D-4820-BCEB-8AA1205428FA}"/>
          </ac:spMkLst>
        </pc:spChg>
        <pc:spChg chg="del">
          <ac:chgData name="Amanda Gibson" userId="907984a6-cd77-4b7d-b1f8-6dfd5dda5862" providerId="ADAL" clId="{161B03EE-95FE-457B-869D-1BF7800899D4}" dt="2021-02-07T23:43:28.519" v="1652" actId="478"/>
          <ac:spMkLst>
            <pc:docMk/>
            <pc:sldMk cId="3406265641" sldId="274"/>
            <ac:spMk id="48" creationId="{D4C94EE9-8875-4F62-87AD-B68E516FFB8A}"/>
          </ac:spMkLst>
        </pc:spChg>
        <pc:spChg chg="del">
          <ac:chgData name="Amanda Gibson" userId="907984a6-cd77-4b7d-b1f8-6dfd5dda5862" providerId="ADAL" clId="{161B03EE-95FE-457B-869D-1BF7800899D4}" dt="2021-02-07T23:43:28.519" v="1652" actId="478"/>
          <ac:spMkLst>
            <pc:docMk/>
            <pc:sldMk cId="3406265641" sldId="274"/>
            <ac:spMk id="53" creationId="{CD3429B1-4AE3-4F50-98AC-4E8C6CA50AAE}"/>
          </ac:spMkLst>
        </pc:spChg>
        <pc:spChg chg="add mod">
          <ac:chgData name="Amanda Gibson" userId="907984a6-cd77-4b7d-b1f8-6dfd5dda5862" providerId="ADAL" clId="{161B03EE-95FE-457B-869D-1BF7800899D4}" dt="2021-02-07T23:42:51.054" v="1641"/>
          <ac:spMkLst>
            <pc:docMk/>
            <pc:sldMk cId="3406265641" sldId="274"/>
            <ac:spMk id="57" creationId="{5589FE37-94B4-4F25-A457-A6AB718CBBEB}"/>
          </ac:spMkLst>
        </pc:spChg>
        <pc:spChg chg="add mod">
          <ac:chgData name="Amanda Gibson" userId="907984a6-cd77-4b7d-b1f8-6dfd5dda5862" providerId="ADAL" clId="{161B03EE-95FE-457B-869D-1BF7800899D4}" dt="2021-02-07T23:42:51.054" v="1641"/>
          <ac:spMkLst>
            <pc:docMk/>
            <pc:sldMk cId="3406265641" sldId="274"/>
            <ac:spMk id="58" creationId="{3CAF49F3-D477-41C8-A4C9-A7725A461FE2}"/>
          </ac:spMkLst>
        </pc:spChg>
        <pc:spChg chg="del">
          <ac:chgData name="Amanda Gibson" userId="907984a6-cd77-4b7d-b1f8-6dfd5dda5862" providerId="ADAL" clId="{161B03EE-95FE-457B-869D-1BF7800899D4}" dt="2021-02-07T23:43:28.519" v="1652" actId="478"/>
          <ac:spMkLst>
            <pc:docMk/>
            <pc:sldMk cId="3406265641" sldId="274"/>
            <ac:spMk id="59" creationId="{3F539560-D257-4FDC-973B-29F18C2CDA04}"/>
          </ac:spMkLst>
        </pc:spChg>
        <pc:spChg chg="mod">
          <ac:chgData name="Amanda Gibson" userId="907984a6-cd77-4b7d-b1f8-6dfd5dda5862" providerId="ADAL" clId="{161B03EE-95FE-457B-869D-1BF7800899D4}" dt="2021-02-07T23:42:43.315" v="1640" actId="20577"/>
          <ac:spMkLst>
            <pc:docMk/>
            <pc:sldMk cId="3406265641" sldId="274"/>
            <ac:spMk id="88" creationId="{BB4E3879-0FC6-44D6-9281-34F2B554E57F}"/>
          </ac:spMkLst>
        </pc:spChg>
        <pc:spChg chg="del">
          <ac:chgData name="Amanda Gibson" userId="907984a6-cd77-4b7d-b1f8-6dfd5dda5862" providerId="ADAL" clId="{161B03EE-95FE-457B-869D-1BF7800899D4}" dt="2021-02-07T23:43:08.617" v="1646" actId="478"/>
          <ac:spMkLst>
            <pc:docMk/>
            <pc:sldMk cId="3406265641" sldId="274"/>
            <ac:spMk id="130" creationId="{E1961E32-E05C-4074-9202-D26E7C008F2F}"/>
          </ac:spMkLst>
        </pc:spChg>
        <pc:spChg chg="del">
          <ac:chgData name="Amanda Gibson" userId="907984a6-cd77-4b7d-b1f8-6dfd5dda5862" providerId="ADAL" clId="{161B03EE-95FE-457B-869D-1BF7800899D4}" dt="2021-02-07T23:43:08.617" v="1646" actId="478"/>
          <ac:spMkLst>
            <pc:docMk/>
            <pc:sldMk cId="3406265641" sldId="274"/>
            <ac:spMk id="131" creationId="{92EE0D56-23EA-4DB3-ADC0-F17F7053200A}"/>
          </ac:spMkLst>
        </pc:spChg>
        <pc:spChg chg="del">
          <ac:chgData name="Amanda Gibson" userId="907984a6-cd77-4b7d-b1f8-6dfd5dda5862" providerId="ADAL" clId="{161B03EE-95FE-457B-869D-1BF7800899D4}" dt="2021-02-07T23:43:08.617" v="1646" actId="478"/>
          <ac:spMkLst>
            <pc:docMk/>
            <pc:sldMk cId="3406265641" sldId="274"/>
            <ac:spMk id="132" creationId="{7056583F-8F74-4665-93C0-E9BE7FAB6F79}"/>
          </ac:spMkLst>
        </pc:spChg>
        <pc:spChg chg="mod">
          <ac:chgData name="Amanda Gibson" userId="907984a6-cd77-4b7d-b1f8-6dfd5dda5862" providerId="ADAL" clId="{161B03EE-95FE-457B-869D-1BF7800899D4}" dt="2021-02-07T23:50:14.807" v="2057" actId="20577"/>
          <ac:spMkLst>
            <pc:docMk/>
            <pc:sldMk cId="3406265641" sldId="274"/>
            <ac:spMk id="133" creationId="{FCBFF678-2D12-4089-BC17-3FF02D8C29CF}"/>
          </ac:spMkLst>
        </pc:spChg>
        <pc:cxnChg chg="del">
          <ac:chgData name="Amanda Gibson" userId="907984a6-cd77-4b7d-b1f8-6dfd5dda5862" providerId="ADAL" clId="{161B03EE-95FE-457B-869D-1BF7800899D4}" dt="2021-02-07T23:43:18.463" v="1649" actId="478"/>
          <ac:cxnSpMkLst>
            <pc:docMk/>
            <pc:sldMk cId="3406265641" sldId="274"/>
            <ac:cxnSpMk id="38" creationId="{DAFE289F-1C50-4872-AE7C-87ED291EF7BA}"/>
          </ac:cxnSpMkLst>
        </pc:cxnChg>
        <pc:cxnChg chg="del">
          <ac:chgData name="Amanda Gibson" userId="907984a6-cd77-4b7d-b1f8-6dfd5dda5862" providerId="ADAL" clId="{161B03EE-95FE-457B-869D-1BF7800899D4}" dt="2021-02-07T23:43:18.463" v="1649" actId="478"/>
          <ac:cxnSpMkLst>
            <pc:docMk/>
            <pc:sldMk cId="3406265641" sldId="274"/>
            <ac:cxnSpMk id="45" creationId="{D39932FB-9D8A-403B-AAAD-59EB3EEE70AD}"/>
          </ac:cxnSpMkLst>
        </pc:cxnChg>
        <pc:cxnChg chg="del">
          <ac:chgData name="Amanda Gibson" userId="907984a6-cd77-4b7d-b1f8-6dfd5dda5862" providerId="ADAL" clId="{161B03EE-95FE-457B-869D-1BF7800899D4}" dt="2021-02-07T23:43:28.519" v="1652" actId="478"/>
          <ac:cxnSpMkLst>
            <pc:docMk/>
            <pc:sldMk cId="3406265641" sldId="274"/>
            <ac:cxnSpMk id="49" creationId="{50E26952-EBEB-405B-9051-66196D06390A}"/>
          </ac:cxnSpMkLst>
        </pc:cxnChg>
        <pc:cxnChg chg="del">
          <ac:chgData name="Amanda Gibson" userId="907984a6-cd77-4b7d-b1f8-6dfd5dda5862" providerId="ADAL" clId="{161B03EE-95FE-457B-869D-1BF7800899D4}" dt="2021-02-07T23:43:28.519" v="1652" actId="478"/>
          <ac:cxnSpMkLst>
            <pc:docMk/>
            <pc:sldMk cId="3406265641" sldId="274"/>
            <ac:cxnSpMk id="54" creationId="{D9B1F86C-9611-4892-A6E2-60BC0F869D89}"/>
          </ac:cxnSpMkLst>
        </pc:cxnChg>
        <pc:cxnChg chg="del">
          <ac:chgData name="Amanda Gibson" userId="907984a6-cd77-4b7d-b1f8-6dfd5dda5862" providerId="ADAL" clId="{161B03EE-95FE-457B-869D-1BF7800899D4}" dt="2021-02-07T23:43:28.519" v="1652" actId="478"/>
          <ac:cxnSpMkLst>
            <pc:docMk/>
            <pc:sldMk cId="3406265641" sldId="274"/>
            <ac:cxnSpMk id="63" creationId="{325783C9-EA5F-4789-AD32-370C2EC353B8}"/>
          </ac:cxnSpMkLst>
        </pc:cxnChg>
      </pc:sldChg>
      <pc:sldChg chg="addSp delSp modSp add mod ord">
        <pc:chgData name="Amanda Gibson" userId="907984a6-cd77-4b7d-b1f8-6dfd5dda5862" providerId="ADAL" clId="{161B03EE-95FE-457B-869D-1BF7800899D4}" dt="2021-02-07T23:50:07.576" v="2056" actId="20577"/>
        <pc:sldMkLst>
          <pc:docMk/>
          <pc:sldMk cId="1960457448" sldId="275"/>
        </pc:sldMkLst>
        <pc:spChg chg="mod">
          <ac:chgData name="Amanda Gibson" userId="907984a6-cd77-4b7d-b1f8-6dfd5dda5862" providerId="ADAL" clId="{161B03EE-95FE-457B-869D-1BF7800899D4}" dt="2021-02-07T23:49:28.821" v="2040" actId="20577"/>
          <ac:spMkLst>
            <pc:docMk/>
            <pc:sldMk cId="1960457448" sldId="275"/>
            <ac:spMk id="2" creationId="{28C08DB6-BD44-4401-A786-2D06627D7C16}"/>
          </ac:spMkLst>
        </pc:spChg>
        <pc:spChg chg="del">
          <ac:chgData name="Amanda Gibson" userId="907984a6-cd77-4b7d-b1f8-6dfd5dda5862" providerId="ADAL" clId="{161B03EE-95FE-457B-869D-1BF7800899D4}" dt="2021-02-07T23:47:34.205" v="2006" actId="478"/>
          <ac:spMkLst>
            <pc:docMk/>
            <pc:sldMk cId="1960457448" sldId="275"/>
            <ac:spMk id="62" creationId="{CF1DC525-A6C0-4390-AED8-CE86A5F0B56D}"/>
          </ac:spMkLst>
        </pc:spChg>
        <pc:spChg chg="del">
          <ac:chgData name="Amanda Gibson" userId="907984a6-cd77-4b7d-b1f8-6dfd5dda5862" providerId="ADAL" clId="{161B03EE-95FE-457B-869D-1BF7800899D4}" dt="2021-02-07T23:47:34.205" v="2006" actId="478"/>
          <ac:spMkLst>
            <pc:docMk/>
            <pc:sldMk cId="1960457448" sldId="275"/>
            <ac:spMk id="63" creationId="{F4BCD483-BFD5-4012-9496-1651EB9CA4FF}"/>
          </ac:spMkLst>
        </pc:spChg>
        <pc:spChg chg="del">
          <ac:chgData name="Amanda Gibson" userId="907984a6-cd77-4b7d-b1f8-6dfd5dda5862" providerId="ADAL" clId="{161B03EE-95FE-457B-869D-1BF7800899D4}" dt="2021-02-07T23:47:38.743" v="2007" actId="478"/>
          <ac:spMkLst>
            <pc:docMk/>
            <pc:sldMk cId="1960457448" sldId="275"/>
            <ac:spMk id="65" creationId="{D2FFD943-EDDD-401B-9C3B-E66DC286ECA5}"/>
          </ac:spMkLst>
        </pc:spChg>
        <pc:spChg chg="del">
          <ac:chgData name="Amanda Gibson" userId="907984a6-cd77-4b7d-b1f8-6dfd5dda5862" providerId="ADAL" clId="{161B03EE-95FE-457B-869D-1BF7800899D4}" dt="2021-02-07T23:47:38.743" v="2007" actId="478"/>
          <ac:spMkLst>
            <pc:docMk/>
            <pc:sldMk cId="1960457448" sldId="275"/>
            <ac:spMk id="66" creationId="{304D18D9-1489-4BED-B9FB-54641824AD45}"/>
          </ac:spMkLst>
        </pc:spChg>
        <pc:spChg chg="del">
          <ac:chgData name="Amanda Gibson" userId="907984a6-cd77-4b7d-b1f8-6dfd5dda5862" providerId="ADAL" clId="{161B03EE-95FE-457B-869D-1BF7800899D4}" dt="2021-02-07T23:47:38.743" v="2007" actId="478"/>
          <ac:spMkLst>
            <pc:docMk/>
            <pc:sldMk cId="1960457448" sldId="275"/>
            <ac:spMk id="67" creationId="{19C21360-5531-40AF-90D8-EA1E050B1624}"/>
          </ac:spMkLst>
        </pc:spChg>
        <pc:spChg chg="del">
          <ac:chgData name="Amanda Gibson" userId="907984a6-cd77-4b7d-b1f8-6dfd5dda5862" providerId="ADAL" clId="{161B03EE-95FE-457B-869D-1BF7800899D4}" dt="2021-02-07T23:47:23.485" v="2003" actId="478"/>
          <ac:spMkLst>
            <pc:docMk/>
            <pc:sldMk cId="1960457448" sldId="275"/>
            <ac:spMk id="69" creationId="{3DD35A0C-FB95-451D-9210-529BB8553657}"/>
          </ac:spMkLst>
        </pc:spChg>
        <pc:spChg chg="del mod">
          <ac:chgData name="Amanda Gibson" userId="907984a6-cd77-4b7d-b1f8-6dfd5dda5862" providerId="ADAL" clId="{161B03EE-95FE-457B-869D-1BF7800899D4}" dt="2021-02-07T23:47:26.529" v="2005" actId="478"/>
          <ac:spMkLst>
            <pc:docMk/>
            <pc:sldMk cId="1960457448" sldId="275"/>
            <ac:spMk id="70" creationId="{794E1B52-0F46-4FB3-8B7F-EB53C8327154}"/>
          </ac:spMkLst>
        </pc:spChg>
        <pc:spChg chg="del">
          <ac:chgData name="Amanda Gibson" userId="907984a6-cd77-4b7d-b1f8-6dfd5dda5862" providerId="ADAL" clId="{161B03EE-95FE-457B-869D-1BF7800899D4}" dt="2021-02-07T23:47:52.180" v="2010" actId="478"/>
          <ac:spMkLst>
            <pc:docMk/>
            <pc:sldMk cId="1960457448" sldId="275"/>
            <ac:spMk id="71" creationId="{130AA605-2900-4295-9FAA-F73DDF45F6CF}"/>
          </ac:spMkLst>
        </pc:spChg>
        <pc:spChg chg="del">
          <ac:chgData name="Amanda Gibson" userId="907984a6-cd77-4b7d-b1f8-6dfd5dda5862" providerId="ADAL" clId="{161B03EE-95FE-457B-869D-1BF7800899D4}" dt="2021-02-07T23:47:46.606" v="2009" actId="478"/>
          <ac:spMkLst>
            <pc:docMk/>
            <pc:sldMk cId="1960457448" sldId="275"/>
            <ac:spMk id="72" creationId="{CD6429D6-BBB2-4B38-8293-0480D5799369}"/>
          </ac:spMkLst>
        </pc:spChg>
        <pc:spChg chg="del">
          <ac:chgData name="Amanda Gibson" userId="907984a6-cd77-4b7d-b1f8-6dfd5dda5862" providerId="ADAL" clId="{161B03EE-95FE-457B-869D-1BF7800899D4}" dt="2021-02-07T23:47:52.180" v="2010" actId="478"/>
          <ac:spMkLst>
            <pc:docMk/>
            <pc:sldMk cId="1960457448" sldId="275"/>
            <ac:spMk id="73" creationId="{382734AC-1615-4858-818A-F8BE53B6C96D}"/>
          </ac:spMkLst>
        </pc:spChg>
        <pc:spChg chg="del">
          <ac:chgData name="Amanda Gibson" userId="907984a6-cd77-4b7d-b1f8-6dfd5dda5862" providerId="ADAL" clId="{161B03EE-95FE-457B-869D-1BF7800899D4}" dt="2021-02-07T23:47:58.925" v="2011" actId="478"/>
          <ac:spMkLst>
            <pc:docMk/>
            <pc:sldMk cId="1960457448" sldId="275"/>
            <ac:spMk id="75" creationId="{F15B31C9-CBD7-4EE4-9CFD-DB390763665D}"/>
          </ac:spMkLst>
        </pc:spChg>
        <pc:spChg chg="del">
          <ac:chgData name="Amanda Gibson" userId="907984a6-cd77-4b7d-b1f8-6dfd5dda5862" providerId="ADAL" clId="{161B03EE-95FE-457B-869D-1BF7800899D4}" dt="2021-02-07T23:47:58.925" v="2011" actId="478"/>
          <ac:spMkLst>
            <pc:docMk/>
            <pc:sldMk cId="1960457448" sldId="275"/>
            <ac:spMk id="76" creationId="{A41973E2-05AF-4384-A490-018477B607D4}"/>
          </ac:spMkLst>
        </pc:spChg>
        <pc:spChg chg="del">
          <ac:chgData name="Amanda Gibson" userId="907984a6-cd77-4b7d-b1f8-6dfd5dda5862" providerId="ADAL" clId="{161B03EE-95FE-457B-869D-1BF7800899D4}" dt="2021-02-07T23:47:58.925" v="2011" actId="478"/>
          <ac:spMkLst>
            <pc:docMk/>
            <pc:sldMk cId="1960457448" sldId="275"/>
            <ac:spMk id="77" creationId="{5D11163C-B992-4353-9F3D-BB5DFBCE4FB1}"/>
          </ac:spMkLst>
        </pc:spChg>
        <pc:spChg chg="del">
          <ac:chgData name="Amanda Gibson" userId="907984a6-cd77-4b7d-b1f8-6dfd5dda5862" providerId="ADAL" clId="{161B03EE-95FE-457B-869D-1BF7800899D4}" dt="2021-02-07T23:48:03.352" v="2013" actId="478"/>
          <ac:spMkLst>
            <pc:docMk/>
            <pc:sldMk cId="1960457448" sldId="275"/>
            <ac:spMk id="79" creationId="{799A331B-6EBE-4CC3-A16F-0B092870A7C6}"/>
          </ac:spMkLst>
        </pc:spChg>
        <pc:spChg chg="mod">
          <ac:chgData name="Amanda Gibson" userId="907984a6-cd77-4b7d-b1f8-6dfd5dda5862" providerId="ADAL" clId="{161B03EE-95FE-457B-869D-1BF7800899D4}" dt="2021-02-07T23:48:27.352" v="2017" actId="1076"/>
          <ac:spMkLst>
            <pc:docMk/>
            <pc:sldMk cId="1960457448" sldId="275"/>
            <ac:spMk id="81" creationId="{77C95FF9-757E-4031-A501-4E78FD91A8E8}"/>
          </ac:spMkLst>
        </pc:spChg>
        <pc:spChg chg="mod">
          <ac:chgData name="Amanda Gibson" userId="907984a6-cd77-4b7d-b1f8-6dfd5dda5862" providerId="ADAL" clId="{161B03EE-95FE-457B-869D-1BF7800899D4}" dt="2021-02-07T23:48:34.461" v="2018" actId="1076"/>
          <ac:spMkLst>
            <pc:docMk/>
            <pc:sldMk cId="1960457448" sldId="275"/>
            <ac:spMk id="82" creationId="{3EB1A2A9-F142-481B-BE30-E891504FF6E6}"/>
          </ac:spMkLst>
        </pc:spChg>
        <pc:spChg chg="mod">
          <ac:chgData name="Amanda Gibson" userId="907984a6-cd77-4b7d-b1f8-6dfd5dda5862" providerId="ADAL" clId="{161B03EE-95FE-457B-869D-1BF7800899D4}" dt="2021-02-07T23:48:44.387" v="2019" actId="1076"/>
          <ac:spMkLst>
            <pc:docMk/>
            <pc:sldMk cId="1960457448" sldId="275"/>
            <ac:spMk id="83" creationId="{8BD4B837-7EC9-4D46-B106-CAD6EAC86DAF}"/>
          </ac:spMkLst>
        </pc:spChg>
        <pc:spChg chg="mod">
          <ac:chgData name="Amanda Gibson" userId="907984a6-cd77-4b7d-b1f8-6dfd5dda5862" providerId="ADAL" clId="{161B03EE-95FE-457B-869D-1BF7800899D4}" dt="2021-02-07T23:48:55.134" v="2020" actId="1076"/>
          <ac:spMkLst>
            <pc:docMk/>
            <pc:sldMk cId="1960457448" sldId="275"/>
            <ac:spMk id="84" creationId="{E3215548-D849-49A7-9A83-98B26F95F25B}"/>
          </ac:spMkLst>
        </pc:spChg>
        <pc:spChg chg="del mod">
          <ac:chgData name="Amanda Gibson" userId="907984a6-cd77-4b7d-b1f8-6dfd5dda5862" providerId="ADAL" clId="{161B03EE-95FE-457B-869D-1BF7800899D4}" dt="2021-02-07T23:48:57.412" v="2021" actId="478"/>
          <ac:spMkLst>
            <pc:docMk/>
            <pc:sldMk cId="1960457448" sldId="275"/>
            <ac:spMk id="85" creationId="{2F81B13E-D292-4D17-A9F6-5CA73777B940}"/>
          </ac:spMkLst>
        </pc:spChg>
        <pc:spChg chg="del mod">
          <ac:chgData name="Amanda Gibson" userId="907984a6-cd77-4b7d-b1f8-6dfd5dda5862" providerId="ADAL" clId="{161B03EE-95FE-457B-869D-1BF7800899D4}" dt="2021-02-07T23:48:57.412" v="2021" actId="478"/>
          <ac:spMkLst>
            <pc:docMk/>
            <pc:sldMk cId="1960457448" sldId="275"/>
            <ac:spMk id="86" creationId="{2A5BE422-5CA5-4E45-A20A-A35C9E6E9B45}"/>
          </ac:spMkLst>
        </pc:spChg>
        <pc:spChg chg="del mod">
          <ac:chgData name="Amanda Gibson" userId="907984a6-cd77-4b7d-b1f8-6dfd5dda5862" providerId="ADAL" clId="{161B03EE-95FE-457B-869D-1BF7800899D4}" dt="2021-02-07T23:48:57.412" v="2021" actId="478"/>
          <ac:spMkLst>
            <pc:docMk/>
            <pc:sldMk cId="1960457448" sldId="275"/>
            <ac:spMk id="87" creationId="{A408FB12-C23F-4899-AA5C-0C06257304A5}"/>
          </ac:spMkLst>
        </pc:spChg>
        <pc:spChg chg="del mod">
          <ac:chgData name="Amanda Gibson" userId="907984a6-cd77-4b7d-b1f8-6dfd5dda5862" providerId="ADAL" clId="{161B03EE-95FE-457B-869D-1BF7800899D4}" dt="2021-02-07T23:48:57.412" v="2021" actId="478"/>
          <ac:spMkLst>
            <pc:docMk/>
            <pc:sldMk cId="1960457448" sldId="275"/>
            <ac:spMk id="88" creationId="{E02AF79D-E5E8-4E83-9A47-DAA469C4CC81}"/>
          </ac:spMkLst>
        </pc:spChg>
        <pc:spChg chg="del mod">
          <ac:chgData name="Amanda Gibson" userId="907984a6-cd77-4b7d-b1f8-6dfd5dda5862" providerId="ADAL" clId="{161B03EE-95FE-457B-869D-1BF7800899D4}" dt="2021-02-07T23:48:57.412" v="2021" actId="478"/>
          <ac:spMkLst>
            <pc:docMk/>
            <pc:sldMk cId="1960457448" sldId="275"/>
            <ac:spMk id="89" creationId="{3A1C2354-CB97-4539-B2E6-1F48EB6681BC}"/>
          </ac:spMkLst>
        </pc:spChg>
        <pc:spChg chg="del mod">
          <ac:chgData name="Amanda Gibson" userId="907984a6-cd77-4b7d-b1f8-6dfd5dda5862" providerId="ADAL" clId="{161B03EE-95FE-457B-869D-1BF7800899D4}" dt="2021-02-07T23:48:57.412" v="2021" actId="478"/>
          <ac:spMkLst>
            <pc:docMk/>
            <pc:sldMk cId="1960457448" sldId="275"/>
            <ac:spMk id="90" creationId="{C6BC3E5C-7AEC-478A-9C2F-4AE5B70715C9}"/>
          </ac:spMkLst>
        </pc:spChg>
        <pc:spChg chg="del mod">
          <ac:chgData name="Amanda Gibson" userId="907984a6-cd77-4b7d-b1f8-6dfd5dda5862" providerId="ADAL" clId="{161B03EE-95FE-457B-869D-1BF7800899D4}" dt="2021-02-07T23:48:57.412" v="2021" actId="478"/>
          <ac:spMkLst>
            <pc:docMk/>
            <pc:sldMk cId="1960457448" sldId="275"/>
            <ac:spMk id="91" creationId="{69AFBEEB-9DA9-47C8-870A-4BF72E457C16}"/>
          </ac:spMkLst>
        </pc:spChg>
        <pc:spChg chg="del mod">
          <ac:chgData name="Amanda Gibson" userId="907984a6-cd77-4b7d-b1f8-6dfd5dda5862" providerId="ADAL" clId="{161B03EE-95FE-457B-869D-1BF7800899D4}" dt="2021-02-07T23:48:57.412" v="2021" actId="478"/>
          <ac:spMkLst>
            <pc:docMk/>
            <pc:sldMk cId="1960457448" sldId="275"/>
            <ac:spMk id="92" creationId="{DCD63FD1-D848-4F9B-B53E-883996B4CB7A}"/>
          </ac:spMkLst>
        </pc:spChg>
        <pc:spChg chg="del mod">
          <ac:chgData name="Amanda Gibson" userId="907984a6-cd77-4b7d-b1f8-6dfd5dda5862" providerId="ADAL" clId="{161B03EE-95FE-457B-869D-1BF7800899D4}" dt="2021-02-07T23:48:57.412" v="2021" actId="478"/>
          <ac:spMkLst>
            <pc:docMk/>
            <pc:sldMk cId="1960457448" sldId="275"/>
            <ac:spMk id="93" creationId="{A46A09FC-8F6E-4351-9439-21C5B0E6C1FE}"/>
          </ac:spMkLst>
        </pc:spChg>
        <pc:spChg chg="del mod">
          <ac:chgData name="Amanda Gibson" userId="907984a6-cd77-4b7d-b1f8-6dfd5dda5862" providerId="ADAL" clId="{161B03EE-95FE-457B-869D-1BF7800899D4}" dt="2021-02-07T23:48:57.412" v="2021" actId="478"/>
          <ac:spMkLst>
            <pc:docMk/>
            <pc:sldMk cId="1960457448" sldId="275"/>
            <ac:spMk id="94" creationId="{45B413E9-B943-4FA7-8ED2-52FFF6A7BC3C}"/>
          </ac:spMkLst>
        </pc:spChg>
        <pc:spChg chg="del mod">
          <ac:chgData name="Amanda Gibson" userId="907984a6-cd77-4b7d-b1f8-6dfd5dda5862" providerId="ADAL" clId="{161B03EE-95FE-457B-869D-1BF7800899D4}" dt="2021-02-07T23:48:57.412" v="2021" actId="478"/>
          <ac:spMkLst>
            <pc:docMk/>
            <pc:sldMk cId="1960457448" sldId="275"/>
            <ac:spMk id="95" creationId="{88DD6E14-873E-4FC1-8D29-4684985DF959}"/>
          </ac:spMkLst>
        </pc:spChg>
        <pc:spChg chg="del mod">
          <ac:chgData name="Amanda Gibson" userId="907984a6-cd77-4b7d-b1f8-6dfd5dda5862" providerId="ADAL" clId="{161B03EE-95FE-457B-869D-1BF7800899D4}" dt="2021-02-07T23:48:57.412" v="2021" actId="478"/>
          <ac:spMkLst>
            <pc:docMk/>
            <pc:sldMk cId="1960457448" sldId="275"/>
            <ac:spMk id="96" creationId="{65B182B4-A532-4856-81B7-BEEE275F2508}"/>
          </ac:spMkLst>
        </pc:spChg>
        <pc:spChg chg="del">
          <ac:chgData name="Amanda Gibson" userId="907984a6-cd77-4b7d-b1f8-6dfd5dda5862" providerId="ADAL" clId="{161B03EE-95FE-457B-869D-1BF7800899D4}" dt="2021-02-07T23:49:16.907" v="2022" actId="478"/>
          <ac:spMkLst>
            <pc:docMk/>
            <pc:sldMk cId="1960457448" sldId="275"/>
            <ac:spMk id="97" creationId="{CEFFC746-337A-4770-A155-BC72A2353F84}"/>
          </ac:spMkLst>
        </pc:spChg>
        <pc:spChg chg="add mod">
          <ac:chgData name="Amanda Gibson" userId="907984a6-cd77-4b7d-b1f8-6dfd5dda5862" providerId="ADAL" clId="{161B03EE-95FE-457B-869D-1BF7800899D4}" dt="2021-02-07T23:50:07.576" v="2056" actId="20577"/>
          <ac:spMkLst>
            <pc:docMk/>
            <pc:sldMk cId="1960457448" sldId="275"/>
            <ac:spMk id="98" creationId="{00D45527-E47C-4639-B2B4-62FA826EA551}"/>
          </ac:spMkLst>
        </pc:spChg>
        <pc:cxnChg chg="del">
          <ac:chgData name="Amanda Gibson" userId="907984a6-cd77-4b7d-b1f8-6dfd5dda5862" providerId="ADAL" clId="{161B03EE-95FE-457B-869D-1BF7800899D4}" dt="2021-02-07T23:47:34.205" v="2006" actId="478"/>
          <ac:cxnSpMkLst>
            <pc:docMk/>
            <pc:sldMk cId="1960457448" sldId="275"/>
            <ac:cxnSpMk id="43" creationId="{C09FC3A6-B612-4A0E-A9AF-AE55C01646C0}"/>
          </ac:cxnSpMkLst>
        </pc:cxnChg>
        <pc:cxnChg chg="del">
          <ac:chgData name="Amanda Gibson" userId="907984a6-cd77-4b7d-b1f8-6dfd5dda5862" providerId="ADAL" clId="{161B03EE-95FE-457B-869D-1BF7800899D4}" dt="2021-02-07T23:47:34.205" v="2006" actId="478"/>
          <ac:cxnSpMkLst>
            <pc:docMk/>
            <pc:sldMk cId="1960457448" sldId="275"/>
            <ac:cxnSpMk id="44" creationId="{EE6AF921-BF94-4F45-9936-D9522C3D3BA0}"/>
          </ac:cxnSpMkLst>
        </pc:cxnChg>
        <pc:cxnChg chg="del">
          <ac:chgData name="Amanda Gibson" userId="907984a6-cd77-4b7d-b1f8-6dfd5dda5862" providerId="ADAL" clId="{161B03EE-95FE-457B-869D-1BF7800899D4}" dt="2021-02-07T23:47:38.743" v="2007" actId="478"/>
          <ac:cxnSpMkLst>
            <pc:docMk/>
            <pc:sldMk cId="1960457448" sldId="275"/>
            <ac:cxnSpMk id="46" creationId="{E4215D8C-F389-47EB-B9CD-6386BFAD7F84}"/>
          </ac:cxnSpMkLst>
        </pc:cxnChg>
        <pc:cxnChg chg="del">
          <ac:chgData name="Amanda Gibson" userId="907984a6-cd77-4b7d-b1f8-6dfd5dda5862" providerId="ADAL" clId="{161B03EE-95FE-457B-869D-1BF7800899D4}" dt="2021-02-07T23:47:38.743" v="2007" actId="478"/>
          <ac:cxnSpMkLst>
            <pc:docMk/>
            <pc:sldMk cId="1960457448" sldId="275"/>
            <ac:cxnSpMk id="47" creationId="{CEA95916-EA13-4C8E-9249-787B254E44A3}"/>
          </ac:cxnSpMkLst>
        </pc:cxnChg>
        <pc:cxnChg chg="del">
          <ac:chgData name="Amanda Gibson" userId="907984a6-cd77-4b7d-b1f8-6dfd5dda5862" providerId="ADAL" clId="{161B03EE-95FE-457B-869D-1BF7800899D4}" dt="2021-02-07T23:47:38.743" v="2007" actId="478"/>
          <ac:cxnSpMkLst>
            <pc:docMk/>
            <pc:sldMk cId="1960457448" sldId="275"/>
            <ac:cxnSpMk id="48" creationId="{FF8104FF-B039-444B-941E-9D5A7ADE03D6}"/>
          </ac:cxnSpMkLst>
        </pc:cxnChg>
        <pc:cxnChg chg="del">
          <ac:chgData name="Amanda Gibson" userId="907984a6-cd77-4b7d-b1f8-6dfd5dda5862" providerId="ADAL" clId="{161B03EE-95FE-457B-869D-1BF7800899D4}" dt="2021-02-07T23:47:19.974" v="2001" actId="478"/>
          <ac:cxnSpMkLst>
            <pc:docMk/>
            <pc:sldMk cId="1960457448" sldId="275"/>
            <ac:cxnSpMk id="50" creationId="{28FB31A9-BBFC-4E52-97CB-1ED0A23439F9}"/>
          </ac:cxnSpMkLst>
        </pc:cxnChg>
        <pc:cxnChg chg="del">
          <ac:chgData name="Amanda Gibson" userId="907984a6-cd77-4b7d-b1f8-6dfd5dda5862" providerId="ADAL" clId="{161B03EE-95FE-457B-869D-1BF7800899D4}" dt="2021-02-07T23:47:21.612" v="2002" actId="478"/>
          <ac:cxnSpMkLst>
            <pc:docMk/>
            <pc:sldMk cId="1960457448" sldId="275"/>
            <ac:cxnSpMk id="51" creationId="{A3500F1A-C26B-495A-8C89-6E3665DF2D08}"/>
          </ac:cxnSpMkLst>
        </pc:cxnChg>
        <pc:cxnChg chg="del">
          <ac:chgData name="Amanda Gibson" userId="907984a6-cd77-4b7d-b1f8-6dfd5dda5862" providerId="ADAL" clId="{161B03EE-95FE-457B-869D-1BF7800899D4}" dt="2021-02-07T23:47:43.440" v="2008" actId="478"/>
          <ac:cxnSpMkLst>
            <pc:docMk/>
            <pc:sldMk cId="1960457448" sldId="275"/>
            <ac:cxnSpMk id="52" creationId="{1B4BD474-CA63-446C-8B42-6087BB84047C}"/>
          </ac:cxnSpMkLst>
        </pc:cxnChg>
        <pc:cxnChg chg="del">
          <ac:chgData name="Amanda Gibson" userId="907984a6-cd77-4b7d-b1f8-6dfd5dda5862" providerId="ADAL" clId="{161B03EE-95FE-457B-869D-1BF7800899D4}" dt="2021-02-07T23:47:43.440" v="2008" actId="478"/>
          <ac:cxnSpMkLst>
            <pc:docMk/>
            <pc:sldMk cId="1960457448" sldId="275"/>
            <ac:cxnSpMk id="53" creationId="{68877F21-0715-4C2C-BD86-5FF8D6383C20}"/>
          </ac:cxnSpMkLst>
        </pc:cxnChg>
        <pc:cxnChg chg="del">
          <ac:chgData name="Amanda Gibson" userId="907984a6-cd77-4b7d-b1f8-6dfd5dda5862" providerId="ADAL" clId="{161B03EE-95FE-457B-869D-1BF7800899D4}" dt="2021-02-07T23:47:43.440" v="2008" actId="478"/>
          <ac:cxnSpMkLst>
            <pc:docMk/>
            <pc:sldMk cId="1960457448" sldId="275"/>
            <ac:cxnSpMk id="54" creationId="{446F511D-2EE9-4CF1-B470-231B51AECD7A}"/>
          </ac:cxnSpMkLst>
        </pc:cxnChg>
        <pc:cxnChg chg="del">
          <ac:chgData name="Amanda Gibson" userId="907984a6-cd77-4b7d-b1f8-6dfd5dda5862" providerId="ADAL" clId="{161B03EE-95FE-457B-869D-1BF7800899D4}" dt="2021-02-07T23:47:58.925" v="2011" actId="478"/>
          <ac:cxnSpMkLst>
            <pc:docMk/>
            <pc:sldMk cId="1960457448" sldId="275"/>
            <ac:cxnSpMk id="56" creationId="{3D182075-E6E1-4F41-8FEC-0D54A8C76EA3}"/>
          </ac:cxnSpMkLst>
        </pc:cxnChg>
        <pc:cxnChg chg="del">
          <ac:chgData name="Amanda Gibson" userId="907984a6-cd77-4b7d-b1f8-6dfd5dda5862" providerId="ADAL" clId="{161B03EE-95FE-457B-869D-1BF7800899D4}" dt="2021-02-07T23:47:58.925" v="2011" actId="478"/>
          <ac:cxnSpMkLst>
            <pc:docMk/>
            <pc:sldMk cId="1960457448" sldId="275"/>
            <ac:cxnSpMk id="57" creationId="{FBCEDD3B-FD2C-4D58-BCD0-4BEA878C17AE}"/>
          </ac:cxnSpMkLst>
        </pc:cxnChg>
        <pc:cxnChg chg="del">
          <ac:chgData name="Amanda Gibson" userId="907984a6-cd77-4b7d-b1f8-6dfd5dda5862" providerId="ADAL" clId="{161B03EE-95FE-457B-869D-1BF7800899D4}" dt="2021-02-07T23:47:58.925" v="2011" actId="478"/>
          <ac:cxnSpMkLst>
            <pc:docMk/>
            <pc:sldMk cId="1960457448" sldId="275"/>
            <ac:cxnSpMk id="58" creationId="{9E5FBB96-7F3B-46A5-9A11-F2F32AB146E8}"/>
          </ac:cxnSpMkLst>
        </pc:cxnChg>
        <pc:cxnChg chg="del">
          <ac:chgData name="Amanda Gibson" userId="907984a6-cd77-4b7d-b1f8-6dfd5dda5862" providerId="ADAL" clId="{161B03EE-95FE-457B-869D-1BF7800899D4}" dt="2021-02-07T23:48:01.655" v="2012" actId="478"/>
          <ac:cxnSpMkLst>
            <pc:docMk/>
            <pc:sldMk cId="1960457448" sldId="275"/>
            <ac:cxnSpMk id="60" creationId="{BFB0E42A-B467-43CF-BE2A-23BB4F099047}"/>
          </ac:cxnSpMkLst>
        </pc:cxnChg>
      </pc:sldChg>
      <pc:sldChg chg="addSp delSp modSp add mod ord">
        <pc:chgData name="Amanda Gibson" userId="907984a6-cd77-4b7d-b1f8-6dfd5dda5862" providerId="ADAL" clId="{161B03EE-95FE-457B-869D-1BF7800899D4}" dt="2021-02-07T23:52:47.576" v="2121" actId="20577"/>
        <pc:sldMkLst>
          <pc:docMk/>
          <pc:sldMk cId="318286620" sldId="276"/>
        </pc:sldMkLst>
        <pc:spChg chg="mod">
          <ac:chgData name="Amanda Gibson" userId="907984a6-cd77-4b7d-b1f8-6dfd5dda5862" providerId="ADAL" clId="{161B03EE-95FE-457B-869D-1BF7800899D4}" dt="2021-02-07T23:52:03.762" v="2086" actId="20577"/>
          <ac:spMkLst>
            <pc:docMk/>
            <pc:sldMk cId="318286620" sldId="276"/>
            <ac:spMk id="2" creationId="{28C08DB6-BD44-4401-A786-2D06627D7C16}"/>
          </ac:spMkLst>
        </pc:spChg>
        <pc:spChg chg="del">
          <ac:chgData name="Amanda Gibson" userId="907984a6-cd77-4b7d-b1f8-6dfd5dda5862" providerId="ADAL" clId="{161B03EE-95FE-457B-869D-1BF7800899D4}" dt="2021-02-07T23:52:11.694" v="2087" actId="478"/>
          <ac:spMkLst>
            <pc:docMk/>
            <pc:sldMk cId="318286620" sldId="276"/>
            <ac:spMk id="3" creationId="{0DE33D1C-035D-4D28-A945-E49776245146}"/>
          </ac:spMkLst>
        </pc:spChg>
        <pc:spChg chg="add mod">
          <ac:chgData name="Amanda Gibson" userId="907984a6-cd77-4b7d-b1f8-6dfd5dda5862" providerId="ADAL" clId="{161B03EE-95FE-457B-869D-1BF7800899D4}" dt="2021-02-07T23:52:47.576" v="2121" actId="20577"/>
          <ac:spMkLst>
            <pc:docMk/>
            <pc:sldMk cId="318286620" sldId="276"/>
            <ac:spMk id="31" creationId="{FE4E92DC-8895-4359-A47E-77E4E2C689FB}"/>
          </ac:spMkLst>
        </pc:spChg>
        <pc:spChg chg="del">
          <ac:chgData name="Amanda Gibson" userId="907984a6-cd77-4b7d-b1f8-6dfd5dda5862" providerId="ADAL" clId="{161B03EE-95FE-457B-869D-1BF7800899D4}" dt="2021-02-07T23:52:11.694" v="2087" actId="478"/>
          <ac:spMkLst>
            <pc:docMk/>
            <pc:sldMk cId="318286620" sldId="276"/>
            <ac:spMk id="38" creationId="{AE2451CF-3087-453B-AED6-0A342E20F705}"/>
          </ac:spMkLst>
        </pc:spChg>
        <pc:spChg chg="del">
          <ac:chgData name="Amanda Gibson" userId="907984a6-cd77-4b7d-b1f8-6dfd5dda5862" providerId="ADAL" clId="{161B03EE-95FE-457B-869D-1BF7800899D4}" dt="2021-02-07T23:52:11.694" v="2087" actId="478"/>
          <ac:spMkLst>
            <pc:docMk/>
            <pc:sldMk cId="318286620" sldId="276"/>
            <ac:spMk id="41" creationId="{39999795-113F-4E9B-AA9E-39C14F92993D}"/>
          </ac:spMkLst>
        </pc:spChg>
        <pc:spChg chg="del">
          <ac:chgData name="Amanda Gibson" userId="907984a6-cd77-4b7d-b1f8-6dfd5dda5862" providerId="ADAL" clId="{161B03EE-95FE-457B-869D-1BF7800899D4}" dt="2021-02-07T23:52:11.694" v="2087" actId="478"/>
          <ac:spMkLst>
            <pc:docMk/>
            <pc:sldMk cId="318286620" sldId="276"/>
            <ac:spMk id="42" creationId="{C1E07250-43D2-4775-A763-56A4085D57AD}"/>
          </ac:spMkLst>
        </pc:spChg>
      </pc:sldChg>
      <pc:sldChg chg="addSp delSp modSp add mod ord">
        <pc:chgData name="Amanda Gibson" userId="907984a6-cd77-4b7d-b1f8-6dfd5dda5862" providerId="ADAL" clId="{161B03EE-95FE-457B-869D-1BF7800899D4}" dt="2021-02-08T00:04:34.195" v="2436" actId="20577"/>
        <pc:sldMkLst>
          <pc:docMk/>
          <pc:sldMk cId="295893259" sldId="277"/>
        </pc:sldMkLst>
        <pc:spChg chg="mod">
          <ac:chgData name="Amanda Gibson" userId="907984a6-cd77-4b7d-b1f8-6dfd5dda5862" providerId="ADAL" clId="{161B03EE-95FE-457B-869D-1BF7800899D4}" dt="2021-02-07T23:54:35.152" v="2226" actId="20577"/>
          <ac:spMkLst>
            <pc:docMk/>
            <pc:sldMk cId="295893259" sldId="277"/>
            <ac:spMk id="2" creationId="{28C08DB6-BD44-4401-A786-2D06627D7C16}"/>
          </ac:spMkLst>
        </pc:spChg>
        <pc:spChg chg="del">
          <ac:chgData name="Amanda Gibson" userId="907984a6-cd77-4b7d-b1f8-6dfd5dda5862" providerId="ADAL" clId="{161B03EE-95FE-457B-869D-1BF7800899D4}" dt="2021-02-07T23:55:19.668" v="2233" actId="478"/>
          <ac:spMkLst>
            <pc:docMk/>
            <pc:sldMk cId="295893259" sldId="277"/>
            <ac:spMk id="3" creationId="{0DE33D1C-035D-4D28-A945-E49776245146}"/>
          </ac:spMkLst>
        </pc:spChg>
        <pc:spChg chg="del">
          <ac:chgData name="Amanda Gibson" userId="907984a6-cd77-4b7d-b1f8-6dfd5dda5862" providerId="ADAL" clId="{161B03EE-95FE-457B-869D-1BF7800899D4}" dt="2021-02-07T23:55:35.652" v="2234" actId="478"/>
          <ac:spMkLst>
            <pc:docMk/>
            <pc:sldMk cId="295893259" sldId="277"/>
            <ac:spMk id="15" creationId="{57DBFBDB-A607-41CD-A042-30EBF2F22D7C}"/>
          </ac:spMkLst>
        </pc:spChg>
        <pc:spChg chg="del">
          <ac:chgData name="Amanda Gibson" userId="907984a6-cd77-4b7d-b1f8-6dfd5dda5862" providerId="ADAL" clId="{161B03EE-95FE-457B-869D-1BF7800899D4}" dt="2021-02-07T23:55:35.652" v="2234" actId="478"/>
          <ac:spMkLst>
            <pc:docMk/>
            <pc:sldMk cId="295893259" sldId="277"/>
            <ac:spMk id="16" creationId="{EAFA46F0-1EAD-492B-B17F-9B66C38F660F}"/>
          </ac:spMkLst>
        </pc:spChg>
        <pc:spChg chg="del">
          <ac:chgData name="Amanda Gibson" userId="907984a6-cd77-4b7d-b1f8-6dfd5dda5862" providerId="ADAL" clId="{161B03EE-95FE-457B-869D-1BF7800899D4}" dt="2021-02-07T23:55:35.652" v="2234" actId="478"/>
          <ac:spMkLst>
            <pc:docMk/>
            <pc:sldMk cId="295893259" sldId="277"/>
            <ac:spMk id="22" creationId="{586FD3E3-E337-4357-B28A-016395D6231A}"/>
          </ac:spMkLst>
        </pc:spChg>
        <pc:spChg chg="del">
          <ac:chgData name="Amanda Gibson" userId="907984a6-cd77-4b7d-b1f8-6dfd5dda5862" providerId="ADAL" clId="{161B03EE-95FE-457B-869D-1BF7800899D4}" dt="2021-02-07T23:55:35.652" v="2234" actId="478"/>
          <ac:spMkLst>
            <pc:docMk/>
            <pc:sldMk cId="295893259" sldId="277"/>
            <ac:spMk id="23" creationId="{68CC3645-D8F4-4A75-9408-E695E3B04050}"/>
          </ac:spMkLst>
        </pc:spChg>
        <pc:spChg chg="mod">
          <ac:chgData name="Amanda Gibson" userId="907984a6-cd77-4b7d-b1f8-6dfd5dda5862" providerId="ADAL" clId="{161B03EE-95FE-457B-869D-1BF7800899D4}" dt="2021-02-07T23:55:39.203" v="2237" actId="20577"/>
          <ac:spMkLst>
            <pc:docMk/>
            <pc:sldMk cId="295893259" sldId="277"/>
            <ac:spMk id="24" creationId="{EE8F42A6-71D2-4541-9238-A6F22A7FC8B1}"/>
          </ac:spMkLst>
        </pc:spChg>
        <pc:spChg chg="mod">
          <ac:chgData name="Amanda Gibson" userId="907984a6-cd77-4b7d-b1f8-6dfd5dda5862" providerId="ADAL" clId="{161B03EE-95FE-457B-869D-1BF7800899D4}" dt="2021-02-07T23:55:41.399" v="2238" actId="20577"/>
          <ac:spMkLst>
            <pc:docMk/>
            <pc:sldMk cId="295893259" sldId="277"/>
            <ac:spMk id="25" creationId="{F07C037D-791F-459D-B32F-24ECE9031F63}"/>
          </ac:spMkLst>
        </pc:spChg>
        <pc:spChg chg="add mod">
          <ac:chgData name="Amanda Gibson" userId="907984a6-cd77-4b7d-b1f8-6dfd5dda5862" providerId="ADAL" clId="{161B03EE-95FE-457B-869D-1BF7800899D4}" dt="2021-02-07T23:57:07.113" v="2251" actId="207"/>
          <ac:spMkLst>
            <pc:docMk/>
            <pc:sldMk cId="295893259" sldId="277"/>
            <ac:spMk id="30" creationId="{A4382A67-DA2E-44AB-A549-32451C6CCEB7}"/>
          </ac:spMkLst>
        </pc:spChg>
        <pc:spChg chg="mod ord">
          <ac:chgData name="Amanda Gibson" userId="907984a6-cd77-4b7d-b1f8-6dfd5dda5862" providerId="ADAL" clId="{161B03EE-95FE-457B-869D-1BF7800899D4}" dt="2021-02-07T23:56:56.038" v="2249" actId="166"/>
          <ac:spMkLst>
            <pc:docMk/>
            <pc:sldMk cId="295893259" sldId="277"/>
            <ac:spMk id="31" creationId="{6DA930FB-AD67-4BF5-B2F1-40CB2B19AF1E}"/>
          </ac:spMkLst>
        </pc:spChg>
        <pc:spChg chg="del">
          <ac:chgData name="Amanda Gibson" userId="907984a6-cd77-4b7d-b1f8-6dfd5dda5862" providerId="ADAL" clId="{161B03EE-95FE-457B-869D-1BF7800899D4}" dt="2021-02-07T23:55:12.400" v="2231" actId="478"/>
          <ac:spMkLst>
            <pc:docMk/>
            <pc:sldMk cId="295893259" sldId="277"/>
            <ac:spMk id="33" creationId="{5006F60C-629F-43A4-B394-45D8960BA12C}"/>
          </ac:spMkLst>
        </pc:spChg>
        <pc:spChg chg="mod">
          <ac:chgData name="Amanda Gibson" userId="907984a6-cd77-4b7d-b1f8-6dfd5dda5862" providerId="ADAL" clId="{161B03EE-95FE-457B-869D-1BF7800899D4}" dt="2021-02-07T23:55:47.359" v="2239" actId="14100"/>
          <ac:spMkLst>
            <pc:docMk/>
            <pc:sldMk cId="295893259" sldId="277"/>
            <ac:spMk id="34" creationId="{877AB1D4-B093-428A-9236-823E7C76BEDE}"/>
          </ac:spMkLst>
        </pc:spChg>
        <pc:spChg chg="mod">
          <ac:chgData name="Amanda Gibson" userId="907984a6-cd77-4b7d-b1f8-6dfd5dda5862" providerId="ADAL" clId="{161B03EE-95FE-457B-869D-1BF7800899D4}" dt="2021-02-07T23:55:47.359" v="2239" actId="14100"/>
          <ac:spMkLst>
            <pc:docMk/>
            <pc:sldMk cId="295893259" sldId="277"/>
            <ac:spMk id="36" creationId="{FE50D528-7CEF-4ED2-9834-37A1A83283C3}"/>
          </ac:spMkLst>
        </pc:spChg>
        <pc:spChg chg="mod">
          <ac:chgData name="Amanda Gibson" userId="907984a6-cd77-4b7d-b1f8-6dfd5dda5862" providerId="ADAL" clId="{161B03EE-95FE-457B-869D-1BF7800899D4}" dt="2021-02-07T23:57:19.714" v="2253" actId="1076"/>
          <ac:spMkLst>
            <pc:docMk/>
            <pc:sldMk cId="295893259" sldId="277"/>
            <ac:spMk id="37" creationId="{11F4F17E-B198-4662-82B9-FD38C6AFD4A0}"/>
          </ac:spMkLst>
        </pc:spChg>
        <pc:spChg chg="del">
          <ac:chgData name="Amanda Gibson" userId="907984a6-cd77-4b7d-b1f8-6dfd5dda5862" providerId="ADAL" clId="{161B03EE-95FE-457B-869D-1BF7800899D4}" dt="2021-02-07T23:55:16.908" v="2232" actId="478"/>
          <ac:spMkLst>
            <pc:docMk/>
            <pc:sldMk cId="295893259" sldId="277"/>
            <ac:spMk id="38" creationId="{AE2451CF-3087-453B-AED6-0A342E20F705}"/>
          </ac:spMkLst>
        </pc:spChg>
        <pc:spChg chg="add mod ord">
          <ac:chgData name="Amanda Gibson" userId="907984a6-cd77-4b7d-b1f8-6dfd5dda5862" providerId="ADAL" clId="{161B03EE-95FE-457B-869D-1BF7800899D4}" dt="2021-02-07T23:55:02.560" v="2229" actId="167"/>
          <ac:spMkLst>
            <pc:docMk/>
            <pc:sldMk cId="295893259" sldId="277"/>
            <ac:spMk id="39" creationId="{E7F1EF72-DAFB-4736-98C7-915A42B2CB95}"/>
          </ac:spMkLst>
        </pc:spChg>
        <pc:spChg chg="add mod ord">
          <ac:chgData name="Amanda Gibson" userId="907984a6-cd77-4b7d-b1f8-6dfd5dda5862" providerId="ADAL" clId="{161B03EE-95FE-457B-869D-1BF7800899D4}" dt="2021-02-07T23:55:02.560" v="2229" actId="167"/>
          <ac:spMkLst>
            <pc:docMk/>
            <pc:sldMk cId="295893259" sldId="277"/>
            <ac:spMk id="40" creationId="{D6BFA371-49D0-4E84-B80E-7BB03447B796}"/>
          </ac:spMkLst>
        </pc:spChg>
        <pc:spChg chg="del">
          <ac:chgData name="Amanda Gibson" userId="907984a6-cd77-4b7d-b1f8-6dfd5dda5862" providerId="ADAL" clId="{161B03EE-95FE-457B-869D-1BF7800899D4}" dt="2021-02-07T23:55:16.908" v="2232" actId="478"/>
          <ac:spMkLst>
            <pc:docMk/>
            <pc:sldMk cId="295893259" sldId="277"/>
            <ac:spMk id="41" creationId="{39999795-113F-4E9B-AA9E-39C14F92993D}"/>
          </ac:spMkLst>
        </pc:spChg>
        <pc:spChg chg="del">
          <ac:chgData name="Amanda Gibson" userId="907984a6-cd77-4b7d-b1f8-6dfd5dda5862" providerId="ADAL" clId="{161B03EE-95FE-457B-869D-1BF7800899D4}" dt="2021-02-07T23:55:19.668" v="2233" actId="478"/>
          <ac:spMkLst>
            <pc:docMk/>
            <pc:sldMk cId="295893259" sldId="277"/>
            <ac:spMk id="42" creationId="{C1E07250-43D2-4775-A763-56A4085D57AD}"/>
          </ac:spMkLst>
        </pc:spChg>
        <pc:spChg chg="add mod">
          <ac:chgData name="Amanda Gibson" userId="907984a6-cd77-4b7d-b1f8-6dfd5dda5862" providerId="ADAL" clId="{161B03EE-95FE-457B-869D-1BF7800899D4}" dt="2021-02-07T23:56:12.699" v="2243" actId="20577"/>
          <ac:spMkLst>
            <pc:docMk/>
            <pc:sldMk cId="295893259" sldId="277"/>
            <ac:spMk id="43" creationId="{D8A5192F-AD11-4EE7-9768-886477640848}"/>
          </ac:spMkLst>
        </pc:spChg>
        <pc:spChg chg="add mod">
          <ac:chgData name="Amanda Gibson" userId="907984a6-cd77-4b7d-b1f8-6dfd5dda5862" providerId="ADAL" clId="{161B03EE-95FE-457B-869D-1BF7800899D4}" dt="2021-02-07T23:55:56.856" v="2240" actId="571"/>
          <ac:spMkLst>
            <pc:docMk/>
            <pc:sldMk cId="295893259" sldId="277"/>
            <ac:spMk id="45" creationId="{8F839C2A-6B20-4896-9318-12A9F8AC6806}"/>
          </ac:spMkLst>
        </pc:spChg>
        <pc:spChg chg="add mod">
          <ac:chgData name="Amanda Gibson" userId="907984a6-cd77-4b7d-b1f8-6dfd5dda5862" providerId="ADAL" clId="{161B03EE-95FE-457B-869D-1BF7800899D4}" dt="2021-02-08T00:04:34.195" v="2436" actId="20577"/>
          <ac:spMkLst>
            <pc:docMk/>
            <pc:sldMk cId="295893259" sldId="277"/>
            <ac:spMk id="46" creationId="{B3FCEA8F-D89A-459A-8EE5-ADB9402A18C5}"/>
          </ac:spMkLst>
        </pc:spChg>
        <pc:cxnChg chg="del">
          <ac:chgData name="Amanda Gibson" userId="907984a6-cd77-4b7d-b1f8-6dfd5dda5862" providerId="ADAL" clId="{161B03EE-95FE-457B-869D-1BF7800899D4}" dt="2021-02-07T23:55:35.652" v="2234" actId="478"/>
          <ac:cxnSpMkLst>
            <pc:docMk/>
            <pc:sldMk cId="295893259" sldId="277"/>
            <ac:cxnSpMk id="7" creationId="{F9A5C009-1910-496B-A7C1-1822970F0A54}"/>
          </ac:cxnSpMkLst>
        </pc:cxnChg>
        <pc:cxnChg chg="del">
          <ac:chgData name="Amanda Gibson" userId="907984a6-cd77-4b7d-b1f8-6dfd5dda5862" providerId="ADAL" clId="{161B03EE-95FE-457B-869D-1BF7800899D4}" dt="2021-02-07T23:55:35.652" v="2234" actId="478"/>
          <ac:cxnSpMkLst>
            <pc:docMk/>
            <pc:sldMk cId="295893259" sldId="277"/>
            <ac:cxnSpMk id="8" creationId="{B66BFC10-08DE-48B5-B23A-6F183F082A13}"/>
          </ac:cxnSpMkLst>
        </pc:cxnChg>
        <pc:cxnChg chg="mod">
          <ac:chgData name="Amanda Gibson" userId="907984a6-cd77-4b7d-b1f8-6dfd5dda5862" providerId="ADAL" clId="{161B03EE-95FE-457B-869D-1BF7800899D4}" dt="2021-02-07T23:55:47.359" v="2239" actId="14100"/>
          <ac:cxnSpMkLst>
            <pc:docMk/>
            <pc:sldMk cId="295893259" sldId="277"/>
            <ac:cxnSpMk id="35" creationId="{EAA5785A-76FF-4E58-9AE8-0555230AEDD3}"/>
          </ac:cxnSpMkLst>
        </pc:cxnChg>
        <pc:cxnChg chg="add mod">
          <ac:chgData name="Amanda Gibson" userId="907984a6-cd77-4b7d-b1f8-6dfd5dda5862" providerId="ADAL" clId="{161B03EE-95FE-457B-869D-1BF7800899D4}" dt="2021-02-07T23:56:06.659" v="2242" actId="14100"/>
          <ac:cxnSpMkLst>
            <pc:docMk/>
            <pc:sldMk cId="295893259" sldId="277"/>
            <ac:cxnSpMk id="44" creationId="{49F12F1F-A365-4928-97C5-D4B1636F3611}"/>
          </ac:cxnSpMkLst>
        </pc:cxnChg>
      </pc:sldChg>
      <pc:sldChg chg="addSp delSp modSp add mod">
        <pc:chgData name="Amanda Gibson" userId="907984a6-cd77-4b7d-b1f8-6dfd5dda5862" providerId="ADAL" clId="{161B03EE-95FE-457B-869D-1BF7800899D4}" dt="2021-02-08T00:12:19.356" v="2853" actId="478"/>
        <pc:sldMkLst>
          <pc:docMk/>
          <pc:sldMk cId="3786362050" sldId="278"/>
        </pc:sldMkLst>
        <pc:spChg chg="mod">
          <ac:chgData name="Amanda Gibson" userId="907984a6-cd77-4b7d-b1f8-6dfd5dda5862" providerId="ADAL" clId="{161B03EE-95FE-457B-869D-1BF7800899D4}" dt="2021-02-07T23:59:27.374" v="2335" actId="20577"/>
          <ac:spMkLst>
            <pc:docMk/>
            <pc:sldMk cId="3786362050" sldId="278"/>
            <ac:spMk id="2" creationId="{28C08DB6-BD44-4401-A786-2D06627D7C16}"/>
          </ac:spMkLst>
        </pc:spChg>
        <pc:spChg chg="del">
          <ac:chgData name="Amanda Gibson" userId="907984a6-cd77-4b7d-b1f8-6dfd5dda5862" providerId="ADAL" clId="{161B03EE-95FE-457B-869D-1BF7800899D4}" dt="2021-02-07T23:59:35.337" v="2336" actId="478"/>
          <ac:spMkLst>
            <pc:docMk/>
            <pc:sldMk cId="3786362050" sldId="278"/>
            <ac:spMk id="13" creationId="{063F1761-4EAD-40E2-BD14-2EEF411621C9}"/>
          </ac:spMkLst>
        </pc:spChg>
        <pc:spChg chg="del">
          <ac:chgData name="Amanda Gibson" userId="907984a6-cd77-4b7d-b1f8-6dfd5dda5862" providerId="ADAL" clId="{161B03EE-95FE-457B-869D-1BF7800899D4}" dt="2021-02-07T23:59:35.337" v="2336" actId="478"/>
          <ac:spMkLst>
            <pc:docMk/>
            <pc:sldMk cId="3786362050" sldId="278"/>
            <ac:spMk id="14" creationId="{A5B98651-E29F-4D49-A6FB-A631BA5B4E18}"/>
          </ac:spMkLst>
        </pc:spChg>
        <pc:spChg chg="del">
          <ac:chgData name="Amanda Gibson" userId="907984a6-cd77-4b7d-b1f8-6dfd5dda5862" providerId="ADAL" clId="{161B03EE-95FE-457B-869D-1BF7800899D4}" dt="2021-02-07T23:59:35.337" v="2336" actId="478"/>
          <ac:spMkLst>
            <pc:docMk/>
            <pc:sldMk cId="3786362050" sldId="278"/>
            <ac:spMk id="17" creationId="{7F8CDF7A-FDF6-4DE7-B305-464F6C52B7B9}"/>
          </ac:spMkLst>
        </pc:spChg>
        <pc:spChg chg="del">
          <ac:chgData name="Amanda Gibson" userId="907984a6-cd77-4b7d-b1f8-6dfd5dda5862" providerId="ADAL" clId="{161B03EE-95FE-457B-869D-1BF7800899D4}" dt="2021-02-07T23:59:35.337" v="2336" actId="478"/>
          <ac:spMkLst>
            <pc:docMk/>
            <pc:sldMk cId="3786362050" sldId="278"/>
            <ac:spMk id="18" creationId="{9F1C46BE-7900-4262-90C3-0471B29061A4}"/>
          </ac:spMkLst>
        </pc:spChg>
        <pc:spChg chg="del">
          <ac:chgData name="Amanda Gibson" userId="907984a6-cd77-4b7d-b1f8-6dfd5dda5862" providerId="ADAL" clId="{161B03EE-95FE-457B-869D-1BF7800899D4}" dt="2021-02-07T23:59:35.337" v="2336" actId="478"/>
          <ac:spMkLst>
            <pc:docMk/>
            <pc:sldMk cId="3786362050" sldId="278"/>
            <ac:spMk id="20" creationId="{9F438B38-4B5B-42F2-BCB7-6941DD03CAFF}"/>
          </ac:spMkLst>
        </pc:spChg>
        <pc:spChg chg="del">
          <ac:chgData name="Amanda Gibson" userId="907984a6-cd77-4b7d-b1f8-6dfd5dda5862" providerId="ADAL" clId="{161B03EE-95FE-457B-869D-1BF7800899D4}" dt="2021-02-07T23:59:35.337" v="2336" actId="478"/>
          <ac:spMkLst>
            <pc:docMk/>
            <pc:sldMk cId="3786362050" sldId="278"/>
            <ac:spMk id="21" creationId="{71718F80-5BB8-4AEB-8504-9A2D9A1E5D77}"/>
          </ac:spMkLst>
        </pc:spChg>
        <pc:spChg chg="del">
          <ac:chgData name="Amanda Gibson" userId="907984a6-cd77-4b7d-b1f8-6dfd5dda5862" providerId="ADAL" clId="{161B03EE-95FE-457B-869D-1BF7800899D4}" dt="2021-02-07T23:59:35.337" v="2336" actId="478"/>
          <ac:spMkLst>
            <pc:docMk/>
            <pc:sldMk cId="3786362050" sldId="278"/>
            <ac:spMk id="24" creationId="{EE8F42A6-71D2-4541-9238-A6F22A7FC8B1}"/>
          </ac:spMkLst>
        </pc:spChg>
        <pc:spChg chg="del">
          <ac:chgData name="Amanda Gibson" userId="907984a6-cd77-4b7d-b1f8-6dfd5dda5862" providerId="ADAL" clId="{161B03EE-95FE-457B-869D-1BF7800899D4}" dt="2021-02-07T23:59:35.337" v="2336" actId="478"/>
          <ac:spMkLst>
            <pc:docMk/>
            <pc:sldMk cId="3786362050" sldId="278"/>
            <ac:spMk id="25" creationId="{F07C037D-791F-459D-B32F-24ECE9031F63}"/>
          </ac:spMkLst>
        </pc:spChg>
        <pc:spChg chg="del">
          <ac:chgData name="Amanda Gibson" userId="907984a6-cd77-4b7d-b1f8-6dfd5dda5862" providerId="ADAL" clId="{161B03EE-95FE-457B-869D-1BF7800899D4}" dt="2021-02-07T23:59:35.337" v="2336" actId="478"/>
          <ac:spMkLst>
            <pc:docMk/>
            <pc:sldMk cId="3786362050" sldId="278"/>
            <ac:spMk id="30" creationId="{A4382A67-DA2E-44AB-A549-32451C6CCEB7}"/>
          </ac:spMkLst>
        </pc:spChg>
        <pc:spChg chg="del">
          <ac:chgData name="Amanda Gibson" userId="907984a6-cd77-4b7d-b1f8-6dfd5dda5862" providerId="ADAL" clId="{161B03EE-95FE-457B-869D-1BF7800899D4}" dt="2021-02-07T23:59:35.337" v="2336" actId="478"/>
          <ac:spMkLst>
            <pc:docMk/>
            <pc:sldMk cId="3786362050" sldId="278"/>
            <ac:spMk id="31" creationId="{6DA930FB-AD67-4BF5-B2F1-40CB2B19AF1E}"/>
          </ac:spMkLst>
        </pc:spChg>
        <pc:spChg chg="del">
          <ac:chgData name="Amanda Gibson" userId="907984a6-cd77-4b7d-b1f8-6dfd5dda5862" providerId="ADAL" clId="{161B03EE-95FE-457B-869D-1BF7800899D4}" dt="2021-02-07T23:59:35.337" v="2336" actId="478"/>
          <ac:spMkLst>
            <pc:docMk/>
            <pc:sldMk cId="3786362050" sldId="278"/>
            <ac:spMk id="34" creationId="{877AB1D4-B093-428A-9236-823E7C76BEDE}"/>
          </ac:spMkLst>
        </pc:spChg>
        <pc:spChg chg="del">
          <ac:chgData name="Amanda Gibson" userId="907984a6-cd77-4b7d-b1f8-6dfd5dda5862" providerId="ADAL" clId="{161B03EE-95FE-457B-869D-1BF7800899D4}" dt="2021-02-07T23:59:35.337" v="2336" actId="478"/>
          <ac:spMkLst>
            <pc:docMk/>
            <pc:sldMk cId="3786362050" sldId="278"/>
            <ac:spMk id="36" creationId="{FE50D528-7CEF-4ED2-9834-37A1A83283C3}"/>
          </ac:spMkLst>
        </pc:spChg>
        <pc:spChg chg="mod">
          <ac:chgData name="Amanda Gibson" userId="907984a6-cd77-4b7d-b1f8-6dfd5dda5862" providerId="ADAL" clId="{161B03EE-95FE-457B-869D-1BF7800899D4}" dt="2021-02-08T00:02:15.382" v="2379" actId="20577"/>
          <ac:spMkLst>
            <pc:docMk/>
            <pc:sldMk cId="3786362050" sldId="278"/>
            <ac:spMk id="37" creationId="{11F4F17E-B198-4662-82B9-FD38C6AFD4A0}"/>
          </ac:spMkLst>
        </pc:spChg>
        <pc:spChg chg="del">
          <ac:chgData name="Amanda Gibson" userId="907984a6-cd77-4b7d-b1f8-6dfd5dda5862" providerId="ADAL" clId="{161B03EE-95FE-457B-869D-1BF7800899D4}" dt="2021-02-07T23:59:35.337" v="2336" actId="478"/>
          <ac:spMkLst>
            <pc:docMk/>
            <pc:sldMk cId="3786362050" sldId="278"/>
            <ac:spMk id="39" creationId="{E7F1EF72-DAFB-4736-98C7-915A42B2CB95}"/>
          </ac:spMkLst>
        </pc:spChg>
        <pc:spChg chg="del">
          <ac:chgData name="Amanda Gibson" userId="907984a6-cd77-4b7d-b1f8-6dfd5dda5862" providerId="ADAL" clId="{161B03EE-95FE-457B-869D-1BF7800899D4}" dt="2021-02-07T23:59:35.337" v="2336" actId="478"/>
          <ac:spMkLst>
            <pc:docMk/>
            <pc:sldMk cId="3786362050" sldId="278"/>
            <ac:spMk id="40" creationId="{D6BFA371-49D0-4E84-B80E-7BB03447B796}"/>
          </ac:spMkLst>
        </pc:spChg>
        <pc:spChg chg="del">
          <ac:chgData name="Amanda Gibson" userId="907984a6-cd77-4b7d-b1f8-6dfd5dda5862" providerId="ADAL" clId="{161B03EE-95FE-457B-869D-1BF7800899D4}" dt="2021-02-07T23:59:35.337" v="2336" actId="478"/>
          <ac:spMkLst>
            <pc:docMk/>
            <pc:sldMk cId="3786362050" sldId="278"/>
            <ac:spMk id="43" creationId="{D8A5192F-AD11-4EE7-9768-886477640848}"/>
          </ac:spMkLst>
        </pc:spChg>
        <pc:spChg chg="del">
          <ac:chgData name="Amanda Gibson" userId="907984a6-cd77-4b7d-b1f8-6dfd5dda5862" providerId="ADAL" clId="{161B03EE-95FE-457B-869D-1BF7800899D4}" dt="2021-02-07T23:59:35.337" v="2336" actId="478"/>
          <ac:spMkLst>
            <pc:docMk/>
            <pc:sldMk cId="3786362050" sldId="278"/>
            <ac:spMk id="45" creationId="{8F839C2A-6B20-4896-9318-12A9F8AC6806}"/>
          </ac:spMkLst>
        </pc:spChg>
        <pc:spChg chg="mod">
          <ac:chgData name="Amanda Gibson" userId="907984a6-cd77-4b7d-b1f8-6dfd5dda5862" providerId="ADAL" clId="{161B03EE-95FE-457B-869D-1BF7800899D4}" dt="2021-02-08T00:04:28.889" v="2433" actId="20577"/>
          <ac:spMkLst>
            <pc:docMk/>
            <pc:sldMk cId="3786362050" sldId="278"/>
            <ac:spMk id="46" creationId="{B3FCEA8F-D89A-459A-8EE5-ADB9402A18C5}"/>
          </ac:spMkLst>
        </pc:spChg>
        <pc:spChg chg="add mod">
          <ac:chgData name="Amanda Gibson" userId="907984a6-cd77-4b7d-b1f8-6dfd5dda5862" providerId="ADAL" clId="{161B03EE-95FE-457B-869D-1BF7800899D4}" dt="2021-02-07T23:59:53.180" v="2337"/>
          <ac:spMkLst>
            <pc:docMk/>
            <pc:sldMk cId="3786362050" sldId="278"/>
            <ac:spMk id="52" creationId="{FAD7A4B2-A1E3-415D-A665-453154FAB86C}"/>
          </ac:spMkLst>
        </pc:spChg>
        <pc:spChg chg="add del mod">
          <ac:chgData name="Amanda Gibson" userId="907984a6-cd77-4b7d-b1f8-6dfd5dda5862" providerId="ADAL" clId="{161B03EE-95FE-457B-869D-1BF7800899D4}" dt="2021-02-08T00:00:32.702" v="2344" actId="478"/>
          <ac:spMkLst>
            <pc:docMk/>
            <pc:sldMk cId="3786362050" sldId="278"/>
            <ac:spMk id="53" creationId="{CF7C5840-C743-431C-86C1-6D9670AAF190}"/>
          </ac:spMkLst>
        </pc:spChg>
        <pc:spChg chg="add mod">
          <ac:chgData name="Amanda Gibson" userId="907984a6-cd77-4b7d-b1f8-6dfd5dda5862" providerId="ADAL" clId="{161B03EE-95FE-457B-869D-1BF7800899D4}" dt="2021-02-07T23:59:53.180" v="2337"/>
          <ac:spMkLst>
            <pc:docMk/>
            <pc:sldMk cId="3786362050" sldId="278"/>
            <ac:spMk id="54" creationId="{7381E3C5-ED8A-4469-BED7-2F5B2886C88D}"/>
          </ac:spMkLst>
        </pc:spChg>
        <pc:spChg chg="add mod">
          <ac:chgData name="Amanda Gibson" userId="907984a6-cd77-4b7d-b1f8-6dfd5dda5862" providerId="ADAL" clId="{161B03EE-95FE-457B-869D-1BF7800899D4}" dt="2021-02-07T23:59:53.180" v="2337"/>
          <ac:spMkLst>
            <pc:docMk/>
            <pc:sldMk cId="3786362050" sldId="278"/>
            <ac:spMk id="55" creationId="{9B8ED585-3C99-48EE-B49C-05996436BA14}"/>
          </ac:spMkLst>
        </pc:spChg>
        <pc:spChg chg="add del mod">
          <ac:chgData name="Amanda Gibson" userId="907984a6-cd77-4b7d-b1f8-6dfd5dda5862" providerId="ADAL" clId="{161B03EE-95FE-457B-869D-1BF7800899D4}" dt="2021-02-08T00:01:11.873" v="2354" actId="478"/>
          <ac:spMkLst>
            <pc:docMk/>
            <pc:sldMk cId="3786362050" sldId="278"/>
            <ac:spMk id="56" creationId="{24AAEB08-CD14-46BA-A91E-7142C665B3D5}"/>
          </ac:spMkLst>
        </pc:spChg>
        <pc:spChg chg="add mod">
          <ac:chgData name="Amanda Gibson" userId="907984a6-cd77-4b7d-b1f8-6dfd5dda5862" providerId="ADAL" clId="{161B03EE-95FE-457B-869D-1BF7800899D4}" dt="2021-02-07T23:59:53.180" v="2337"/>
          <ac:spMkLst>
            <pc:docMk/>
            <pc:sldMk cId="3786362050" sldId="278"/>
            <ac:spMk id="57" creationId="{4D469F44-E72E-45EA-91AC-AC07FD3DE9F3}"/>
          </ac:spMkLst>
        </pc:spChg>
        <pc:spChg chg="add mod">
          <ac:chgData name="Amanda Gibson" userId="907984a6-cd77-4b7d-b1f8-6dfd5dda5862" providerId="ADAL" clId="{161B03EE-95FE-457B-869D-1BF7800899D4}" dt="2021-02-07T23:59:53.180" v="2337"/>
          <ac:spMkLst>
            <pc:docMk/>
            <pc:sldMk cId="3786362050" sldId="278"/>
            <ac:spMk id="58" creationId="{4F2BDE49-EE55-4350-8BF0-F9CE734E60EB}"/>
          </ac:spMkLst>
        </pc:spChg>
        <pc:spChg chg="add mod">
          <ac:chgData name="Amanda Gibson" userId="907984a6-cd77-4b7d-b1f8-6dfd5dda5862" providerId="ADAL" clId="{161B03EE-95FE-457B-869D-1BF7800899D4}" dt="2021-02-07T23:59:53.180" v="2337"/>
          <ac:spMkLst>
            <pc:docMk/>
            <pc:sldMk cId="3786362050" sldId="278"/>
            <ac:spMk id="59" creationId="{75D68392-A52D-4E97-9277-3D76539B1091}"/>
          </ac:spMkLst>
        </pc:spChg>
        <pc:spChg chg="add mod">
          <ac:chgData name="Amanda Gibson" userId="907984a6-cd77-4b7d-b1f8-6dfd5dda5862" providerId="ADAL" clId="{161B03EE-95FE-457B-869D-1BF7800899D4}" dt="2021-02-07T23:59:53.180" v="2337"/>
          <ac:spMkLst>
            <pc:docMk/>
            <pc:sldMk cId="3786362050" sldId="278"/>
            <ac:spMk id="60" creationId="{802B3785-D750-479B-B35D-E8BDF822272B}"/>
          </ac:spMkLst>
        </pc:spChg>
        <pc:spChg chg="add del mod">
          <ac:chgData name="Amanda Gibson" userId="907984a6-cd77-4b7d-b1f8-6dfd5dda5862" providerId="ADAL" clId="{161B03EE-95FE-457B-869D-1BF7800899D4}" dt="2021-02-08T00:00:35.105" v="2345" actId="478"/>
          <ac:spMkLst>
            <pc:docMk/>
            <pc:sldMk cId="3786362050" sldId="278"/>
            <ac:spMk id="61" creationId="{AF24D0CB-5231-4E38-A86A-E8E4F6DFA0BD}"/>
          </ac:spMkLst>
        </pc:spChg>
        <pc:spChg chg="add mod">
          <ac:chgData name="Amanda Gibson" userId="907984a6-cd77-4b7d-b1f8-6dfd5dda5862" providerId="ADAL" clId="{161B03EE-95FE-457B-869D-1BF7800899D4}" dt="2021-02-07T23:59:53.180" v="2337"/>
          <ac:spMkLst>
            <pc:docMk/>
            <pc:sldMk cId="3786362050" sldId="278"/>
            <ac:spMk id="62" creationId="{C4B33B01-2ECE-46FF-ADF3-90FB961B320D}"/>
          </ac:spMkLst>
        </pc:spChg>
        <pc:spChg chg="add mod">
          <ac:chgData name="Amanda Gibson" userId="907984a6-cd77-4b7d-b1f8-6dfd5dda5862" providerId="ADAL" clId="{161B03EE-95FE-457B-869D-1BF7800899D4}" dt="2021-02-07T23:59:53.180" v="2337"/>
          <ac:spMkLst>
            <pc:docMk/>
            <pc:sldMk cId="3786362050" sldId="278"/>
            <ac:spMk id="63" creationId="{9E01BDAD-702C-4C2F-88A7-3F34BD58A52B}"/>
          </ac:spMkLst>
        </pc:spChg>
        <pc:spChg chg="add del mod">
          <ac:chgData name="Amanda Gibson" userId="907984a6-cd77-4b7d-b1f8-6dfd5dda5862" providerId="ADAL" clId="{161B03EE-95FE-457B-869D-1BF7800899D4}" dt="2021-02-08T00:01:11.873" v="2354" actId="478"/>
          <ac:spMkLst>
            <pc:docMk/>
            <pc:sldMk cId="3786362050" sldId="278"/>
            <ac:spMk id="64" creationId="{9B2105E3-87FC-41C1-B46E-F08195954736}"/>
          </ac:spMkLst>
        </pc:spChg>
        <pc:spChg chg="add mod">
          <ac:chgData name="Amanda Gibson" userId="907984a6-cd77-4b7d-b1f8-6dfd5dda5862" providerId="ADAL" clId="{161B03EE-95FE-457B-869D-1BF7800899D4}" dt="2021-02-07T23:59:53.180" v="2337"/>
          <ac:spMkLst>
            <pc:docMk/>
            <pc:sldMk cId="3786362050" sldId="278"/>
            <ac:spMk id="65" creationId="{A457C328-3FC8-4F8A-9772-3211116F0778}"/>
          </ac:spMkLst>
        </pc:spChg>
        <pc:spChg chg="add mod">
          <ac:chgData name="Amanda Gibson" userId="907984a6-cd77-4b7d-b1f8-6dfd5dda5862" providerId="ADAL" clId="{161B03EE-95FE-457B-869D-1BF7800899D4}" dt="2021-02-07T23:59:53.180" v="2337"/>
          <ac:spMkLst>
            <pc:docMk/>
            <pc:sldMk cId="3786362050" sldId="278"/>
            <ac:spMk id="66" creationId="{DAFF608D-E1CA-41C9-B58D-5F736CFE46FE}"/>
          </ac:spMkLst>
        </pc:spChg>
        <pc:spChg chg="add mod">
          <ac:chgData name="Amanda Gibson" userId="907984a6-cd77-4b7d-b1f8-6dfd5dda5862" providerId="ADAL" clId="{161B03EE-95FE-457B-869D-1BF7800899D4}" dt="2021-02-07T23:59:53.180" v="2337"/>
          <ac:spMkLst>
            <pc:docMk/>
            <pc:sldMk cId="3786362050" sldId="278"/>
            <ac:spMk id="67" creationId="{6E00364D-EB2F-4B86-B713-DE620F3D9B6E}"/>
          </ac:spMkLst>
        </pc:spChg>
        <pc:spChg chg="add del mod">
          <ac:chgData name="Amanda Gibson" userId="907984a6-cd77-4b7d-b1f8-6dfd5dda5862" providerId="ADAL" clId="{161B03EE-95FE-457B-869D-1BF7800899D4}" dt="2021-02-07T23:59:59.284" v="2338" actId="478"/>
          <ac:spMkLst>
            <pc:docMk/>
            <pc:sldMk cId="3786362050" sldId="278"/>
            <ac:spMk id="68" creationId="{BAB1C626-9C6F-49AB-A5E5-1D35A913C809}"/>
          </ac:spMkLst>
        </pc:spChg>
        <pc:spChg chg="add del mod">
          <ac:chgData name="Amanda Gibson" userId="907984a6-cd77-4b7d-b1f8-6dfd5dda5862" providerId="ADAL" clId="{161B03EE-95FE-457B-869D-1BF7800899D4}" dt="2021-02-07T23:59:59.284" v="2338" actId="478"/>
          <ac:spMkLst>
            <pc:docMk/>
            <pc:sldMk cId="3786362050" sldId="278"/>
            <ac:spMk id="69" creationId="{674282B9-1BD2-4E72-89C8-03BEFE46B6D8}"/>
          </ac:spMkLst>
        </pc:spChg>
        <pc:spChg chg="add del mod">
          <ac:chgData name="Amanda Gibson" userId="907984a6-cd77-4b7d-b1f8-6dfd5dda5862" providerId="ADAL" clId="{161B03EE-95FE-457B-869D-1BF7800899D4}" dt="2021-02-07T23:59:59.284" v="2338" actId="478"/>
          <ac:spMkLst>
            <pc:docMk/>
            <pc:sldMk cId="3786362050" sldId="278"/>
            <ac:spMk id="70" creationId="{275BA786-3D8C-4833-A82F-F8C8C4BF3BEF}"/>
          </ac:spMkLst>
        </pc:spChg>
        <pc:spChg chg="add mod">
          <ac:chgData name="Amanda Gibson" userId="907984a6-cd77-4b7d-b1f8-6dfd5dda5862" providerId="ADAL" clId="{161B03EE-95FE-457B-869D-1BF7800899D4}" dt="2021-02-08T00:00:12.174" v="2340" actId="571"/>
          <ac:spMkLst>
            <pc:docMk/>
            <pc:sldMk cId="3786362050" sldId="278"/>
            <ac:spMk id="72" creationId="{30239FE8-D38F-429C-93C8-B1FF4293FBCB}"/>
          </ac:spMkLst>
        </pc:spChg>
        <pc:spChg chg="add mod">
          <ac:chgData name="Amanda Gibson" userId="907984a6-cd77-4b7d-b1f8-6dfd5dda5862" providerId="ADAL" clId="{161B03EE-95FE-457B-869D-1BF7800899D4}" dt="2021-02-08T00:12:12.447" v="2851" actId="1076"/>
          <ac:spMkLst>
            <pc:docMk/>
            <pc:sldMk cId="3786362050" sldId="278"/>
            <ac:spMk id="74" creationId="{DD2A9F8B-7937-4D05-936D-132C6E47FA03}"/>
          </ac:spMkLst>
        </pc:spChg>
        <pc:spChg chg="add mod">
          <ac:chgData name="Amanda Gibson" userId="907984a6-cd77-4b7d-b1f8-6dfd5dda5862" providerId="ADAL" clId="{161B03EE-95FE-457B-869D-1BF7800899D4}" dt="2021-02-08T00:00:22.808" v="2341" actId="571"/>
          <ac:spMkLst>
            <pc:docMk/>
            <pc:sldMk cId="3786362050" sldId="278"/>
            <ac:spMk id="75" creationId="{73393428-69D2-43D2-9DF6-FC52BC91236B}"/>
          </ac:spMkLst>
        </pc:spChg>
        <pc:spChg chg="add mod">
          <ac:chgData name="Amanda Gibson" userId="907984a6-cd77-4b7d-b1f8-6dfd5dda5862" providerId="ADAL" clId="{161B03EE-95FE-457B-869D-1BF7800899D4}" dt="2021-02-08T00:01:18.178" v="2355" actId="1076"/>
          <ac:spMkLst>
            <pc:docMk/>
            <pc:sldMk cId="3786362050" sldId="278"/>
            <ac:spMk id="77" creationId="{F2097A6F-43AA-40BB-B20E-B225DC0625E7}"/>
          </ac:spMkLst>
        </pc:spChg>
        <pc:spChg chg="add mod">
          <ac:chgData name="Amanda Gibson" userId="907984a6-cd77-4b7d-b1f8-6dfd5dda5862" providerId="ADAL" clId="{161B03EE-95FE-457B-869D-1BF7800899D4}" dt="2021-02-08T00:00:59.409" v="2350" actId="571"/>
          <ac:spMkLst>
            <pc:docMk/>
            <pc:sldMk cId="3786362050" sldId="278"/>
            <ac:spMk id="78" creationId="{447876AA-2991-4C82-A13A-048EE46D073F}"/>
          </ac:spMkLst>
        </pc:spChg>
        <pc:spChg chg="add mod">
          <ac:chgData name="Amanda Gibson" userId="907984a6-cd77-4b7d-b1f8-6dfd5dda5862" providerId="ADAL" clId="{161B03EE-95FE-457B-869D-1BF7800899D4}" dt="2021-02-08T00:01:40.885" v="2358" actId="14100"/>
          <ac:spMkLst>
            <pc:docMk/>
            <pc:sldMk cId="3786362050" sldId="278"/>
            <ac:spMk id="79" creationId="{1280C149-EE31-4510-941F-CD758B67EBC6}"/>
          </ac:spMkLst>
        </pc:spChg>
        <pc:spChg chg="add mod">
          <ac:chgData name="Amanda Gibson" userId="907984a6-cd77-4b7d-b1f8-6dfd5dda5862" providerId="ADAL" clId="{161B03EE-95FE-457B-869D-1BF7800899D4}" dt="2021-02-08T00:01:53.379" v="2360" actId="1076"/>
          <ac:spMkLst>
            <pc:docMk/>
            <pc:sldMk cId="3786362050" sldId="278"/>
            <ac:spMk id="80" creationId="{166392F5-BFC8-43E9-8432-1CE92035C799}"/>
          </ac:spMkLst>
        </pc:spChg>
        <pc:spChg chg="add del mod">
          <ac:chgData name="Amanda Gibson" userId="907984a6-cd77-4b7d-b1f8-6dfd5dda5862" providerId="ADAL" clId="{161B03EE-95FE-457B-869D-1BF7800899D4}" dt="2021-02-08T00:02:50.308" v="2387" actId="1076"/>
          <ac:spMkLst>
            <pc:docMk/>
            <pc:sldMk cId="3786362050" sldId="278"/>
            <ac:spMk id="81" creationId="{768D9834-C797-40B0-B5C3-A8A753C2EBA4}"/>
          </ac:spMkLst>
        </pc:spChg>
        <pc:spChg chg="add del mod">
          <ac:chgData name="Amanda Gibson" userId="907984a6-cd77-4b7d-b1f8-6dfd5dda5862" providerId="ADAL" clId="{161B03EE-95FE-457B-869D-1BF7800899D4}" dt="2021-02-08T00:02:41.252" v="2385" actId="478"/>
          <ac:spMkLst>
            <pc:docMk/>
            <pc:sldMk cId="3786362050" sldId="278"/>
            <ac:spMk id="82" creationId="{CFA7C288-F034-4A5D-814A-C45B23E6580D}"/>
          </ac:spMkLst>
        </pc:spChg>
        <pc:spChg chg="add del mod">
          <ac:chgData name="Amanda Gibson" userId="907984a6-cd77-4b7d-b1f8-6dfd5dda5862" providerId="ADAL" clId="{161B03EE-95FE-457B-869D-1BF7800899D4}" dt="2021-02-08T00:12:19.356" v="2853" actId="478"/>
          <ac:spMkLst>
            <pc:docMk/>
            <pc:sldMk cId="3786362050" sldId="278"/>
            <ac:spMk id="83" creationId="{7054B56C-3B22-4401-A41B-D0D28467C0A1}"/>
          </ac:spMkLst>
        </pc:spChg>
        <pc:cxnChg chg="del">
          <ac:chgData name="Amanda Gibson" userId="907984a6-cd77-4b7d-b1f8-6dfd5dda5862" providerId="ADAL" clId="{161B03EE-95FE-457B-869D-1BF7800899D4}" dt="2021-02-07T23:59:35.337" v="2336" actId="478"/>
          <ac:cxnSpMkLst>
            <pc:docMk/>
            <pc:sldMk cId="3786362050" sldId="278"/>
            <ac:cxnSpMk id="5" creationId="{5E6CC999-542D-450B-9072-1D8886BE890D}"/>
          </ac:cxnSpMkLst>
        </pc:cxnChg>
        <pc:cxnChg chg="del">
          <ac:chgData name="Amanda Gibson" userId="907984a6-cd77-4b7d-b1f8-6dfd5dda5862" providerId="ADAL" clId="{161B03EE-95FE-457B-869D-1BF7800899D4}" dt="2021-02-07T23:59:35.337" v="2336" actId="478"/>
          <ac:cxnSpMkLst>
            <pc:docMk/>
            <pc:sldMk cId="3786362050" sldId="278"/>
            <ac:cxnSpMk id="6" creationId="{08F7E712-5429-455C-9EFB-D74CDF210A04}"/>
          </ac:cxnSpMkLst>
        </pc:cxnChg>
        <pc:cxnChg chg="del">
          <ac:chgData name="Amanda Gibson" userId="907984a6-cd77-4b7d-b1f8-6dfd5dda5862" providerId="ADAL" clId="{161B03EE-95FE-457B-869D-1BF7800899D4}" dt="2021-02-07T23:59:35.337" v="2336" actId="478"/>
          <ac:cxnSpMkLst>
            <pc:docMk/>
            <pc:sldMk cId="3786362050" sldId="278"/>
            <ac:cxnSpMk id="9" creationId="{743E1477-59EB-44BF-9DB3-3C6A7A8C082D}"/>
          </ac:cxnSpMkLst>
        </pc:cxnChg>
        <pc:cxnChg chg="del">
          <ac:chgData name="Amanda Gibson" userId="907984a6-cd77-4b7d-b1f8-6dfd5dda5862" providerId="ADAL" clId="{161B03EE-95FE-457B-869D-1BF7800899D4}" dt="2021-02-07T23:59:35.337" v="2336" actId="478"/>
          <ac:cxnSpMkLst>
            <pc:docMk/>
            <pc:sldMk cId="3786362050" sldId="278"/>
            <ac:cxnSpMk id="10" creationId="{11323809-9FDA-4F29-A82C-AA0FBACD5790}"/>
          </ac:cxnSpMkLst>
        </pc:cxnChg>
        <pc:cxnChg chg="del">
          <ac:chgData name="Amanda Gibson" userId="907984a6-cd77-4b7d-b1f8-6dfd5dda5862" providerId="ADAL" clId="{161B03EE-95FE-457B-869D-1BF7800899D4}" dt="2021-02-07T23:59:35.337" v="2336" actId="478"/>
          <ac:cxnSpMkLst>
            <pc:docMk/>
            <pc:sldMk cId="3786362050" sldId="278"/>
            <ac:cxnSpMk id="32" creationId="{67223FFA-2893-4A49-B60F-60DCAA072D7F}"/>
          </ac:cxnSpMkLst>
        </pc:cxnChg>
        <pc:cxnChg chg="del">
          <ac:chgData name="Amanda Gibson" userId="907984a6-cd77-4b7d-b1f8-6dfd5dda5862" providerId="ADAL" clId="{161B03EE-95FE-457B-869D-1BF7800899D4}" dt="2021-02-07T23:59:35.337" v="2336" actId="478"/>
          <ac:cxnSpMkLst>
            <pc:docMk/>
            <pc:sldMk cId="3786362050" sldId="278"/>
            <ac:cxnSpMk id="35" creationId="{EAA5785A-76FF-4E58-9AE8-0555230AEDD3}"/>
          </ac:cxnSpMkLst>
        </pc:cxnChg>
        <pc:cxnChg chg="add mod">
          <ac:chgData name="Amanda Gibson" userId="907984a6-cd77-4b7d-b1f8-6dfd5dda5862" providerId="ADAL" clId="{161B03EE-95FE-457B-869D-1BF7800899D4}" dt="2021-02-07T23:59:53.180" v="2337"/>
          <ac:cxnSpMkLst>
            <pc:docMk/>
            <pc:sldMk cId="3786362050" sldId="278"/>
            <ac:cxnSpMk id="38" creationId="{679A1E74-D06F-421B-A2DF-AF555FE4108A}"/>
          </ac:cxnSpMkLst>
        </pc:cxnChg>
        <pc:cxnChg chg="add del mod">
          <ac:chgData name="Amanda Gibson" userId="907984a6-cd77-4b7d-b1f8-6dfd5dda5862" providerId="ADAL" clId="{161B03EE-95FE-457B-869D-1BF7800899D4}" dt="2021-02-08T00:00:27.804" v="2342" actId="478"/>
          <ac:cxnSpMkLst>
            <pc:docMk/>
            <pc:sldMk cId="3786362050" sldId="278"/>
            <ac:cxnSpMk id="41" creationId="{4021BF5F-7999-49CC-ABF6-EE53E89F8345}"/>
          </ac:cxnSpMkLst>
        </pc:cxnChg>
        <pc:cxnChg chg="add mod">
          <ac:chgData name="Amanda Gibson" userId="907984a6-cd77-4b7d-b1f8-6dfd5dda5862" providerId="ADAL" clId="{161B03EE-95FE-457B-869D-1BF7800899D4}" dt="2021-02-07T23:59:53.180" v="2337"/>
          <ac:cxnSpMkLst>
            <pc:docMk/>
            <pc:sldMk cId="3786362050" sldId="278"/>
            <ac:cxnSpMk id="42" creationId="{1CEED8F7-68A8-4964-8C07-3A90094E793E}"/>
          </ac:cxnSpMkLst>
        </pc:cxnChg>
        <pc:cxnChg chg="del">
          <ac:chgData name="Amanda Gibson" userId="907984a6-cd77-4b7d-b1f8-6dfd5dda5862" providerId="ADAL" clId="{161B03EE-95FE-457B-869D-1BF7800899D4}" dt="2021-02-07T23:59:35.337" v="2336" actId="478"/>
          <ac:cxnSpMkLst>
            <pc:docMk/>
            <pc:sldMk cId="3786362050" sldId="278"/>
            <ac:cxnSpMk id="44" creationId="{49F12F1F-A365-4928-97C5-D4B1636F3611}"/>
          </ac:cxnSpMkLst>
        </pc:cxnChg>
        <pc:cxnChg chg="add mod">
          <ac:chgData name="Amanda Gibson" userId="907984a6-cd77-4b7d-b1f8-6dfd5dda5862" providerId="ADAL" clId="{161B03EE-95FE-457B-869D-1BF7800899D4}" dt="2021-02-07T23:59:53.180" v="2337"/>
          <ac:cxnSpMkLst>
            <pc:docMk/>
            <pc:sldMk cId="3786362050" sldId="278"/>
            <ac:cxnSpMk id="47" creationId="{C247D9B3-60F4-49FC-91F7-BB43C135E37B}"/>
          </ac:cxnSpMkLst>
        </pc:cxnChg>
        <pc:cxnChg chg="add del mod">
          <ac:chgData name="Amanda Gibson" userId="907984a6-cd77-4b7d-b1f8-6dfd5dda5862" providerId="ADAL" clId="{161B03EE-95FE-457B-869D-1BF7800899D4}" dt="2021-02-08T00:01:11.873" v="2354" actId="478"/>
          <ac:cxnSpMkLst>
            <pc:docMk/>
            <pc:sldMk cId="3786362050" sldId="278"/>
            <ac:cxnSpMk id="48" creationId="{321F76A4-71A9-4172-8348-742D1E2E76CE}"/>
          </ac:cxnSpMkLst>
        </pc:cxnChg>
        <pc:cxnChg chg="add mod">
          <ac:chgData name="Amanda Gibson" userId="907984a6-cd77-4b7d-b1f8-6dfd5dda5862" providerId="ADAL" clId="{161B03EE-95FE-457B-869D-1BF7800899D4}" dt="2021-02-07T23:59:53.180" v="2337"/>
          <ac:cxnSpMkLst>
            <pc:docMk/>
            <pc:sldMk cId="3786362050" sldId="278"/>
            <ac:cxnSpMk id="49" creationId="{5335414E-2F04-4013-AF6D-EF915881D0A5}"/>
          </ac:cxnSpMkLst>
        </pc:cxnChg>
        <pc:cxnChg chg="add mod">
          <ac:chgData name="Amanda Gibson" userId="907984a6-cd77-4b7d-b1f8-6dfd5dda5862" providerId="ADAL" clId="{161B03EE-95FE-457B-869D-1BF7800899D4}" dt="2021-02-07T23:59:53.180" v="2337"/>
          <ac:cxnSpMkLst>
            <pc:docMk/>
            <pc:sldMk cId="3786362050" sldId="278"/>
            <ac:cxnSpMk id="50" creationId="{6CABE885-F2EE-4C73-ADB7-F08500CC216A}"/>
          </ac:cxnSpMkLst>
        </pc:cxnChg>
        <pc:cxnChg chg="add mod">
          <ac:chgData name="Amanda Gibson" userId="907984a6-cd77-4b7d-b1f8-6dfd5dda5862" providerId="ADAL" clId="{161B03EE-95FE-457B-869D-1BF7800899D4}" dt="2021-02-07T23:59:53.180" v="2337"/>
          <ac:cxnSpMkLst>
            <pc:docMk/>
            <pc:sldMk cId="3786362050" sldId="278"/>
            <ac:cxnSpMk id="51" creationId="{B1738F0B-4B49-43CA-A172-DBE1B5809737}"/>
          </ac:cxnSpMkLst>
        </pc:cxnChg>
        <pc:cxnChg chg="add mod">
          <ac:chgData name="Amanda Gibson" userId="907984a6-cd77-4b7d-b1f8-6dfd5dda5862" providerId="ADAL" clId="{161B03EE-95FE-457B-869D-1BF7800899D4}" dt="2021-02-08T00:00:12.174" v="2340" actId="571"/>
          <ac:cxnSpMkLst>
            <pc:docMk/>
            <pc:sldMk cId="3786362050" sldId="278"/>
            <ac:cxnSpMk id="71" creationId="{C77114B2-373F-46FF-A207-7F7F42CF740F}"/>
          </ac:cxnSpMkLst>
        </pc:cxnChg>
        <pc:cxnChg chg="add mod">
          <ac:chgData name="Amanda Gibson" userId="907984a6-cd77-4b7d-b1f8-6dfd5dda5862" providerId="ADAL" clId="{161B03EE-95FE-457B-869D-1BF7800899D4}" dt="2021-02-08T00:00:22.808" v="2341" actId="571"/>
          <ac:cxnSpMkLst>
            <pc:docMk/>
            <pc:sldMk cId="3786362050" sldId="278"/>
            <ac:cxnSpMk id="73" creationId="{4FB2743C-BA85-45B8-8E7D-CAD53164FA1B}"/>
          </ac:cxnSpMkLst>
        </pc:cxnChg>
        <pc:cxnChg chg="add mod">
          <ac:chgData name="Amanda Gibson" userId="907984a6-cd77-4b7d-b1f8-6dfd5dda5862" providerId="ADAL" clId="{161B03EE-95FE-457B-869D-1BF7800899D4}" dt="2021-02-08T00:00:59.409" v="2350" actId="571"/>
          <ac:cxnSpMkLst>
            <pc:docMk/>
            <pc:sldMk cId="3786362050" sldId="278"/>
            <ac:cxnSpMk id="76" creationId="{506F30E3-7638-4C2B-9E3A-1A4209EE9562}"/>
          </ac:cxnSpMkLst>
        </pc:cxnChg>
      </pc:sldChg>
      <pc:sldChg chg="addSp delSp modSp add mod ord">
        <pc:chgData name="Amanda Gibson" userId="907984a6-cd77-4b7d-b1f8-6dfd5dda5862" providerId="ADAL" clId="{161B03EE-95FE-457B-869D-1BF7800899D4}" dt="2021-02-08T01:30:49.356" v="5109" actId="20577"/>
        <pc:sldMkLst>
          <pc:docMk/>
          <pc:sldMk cId="568423308" sldId="279"/>
        </pc:sldMkLst>
        <pc:spChg chg="mod">
          <ac:chgData name="Amanda Gibson" userId="907984a6-cd77-4b7d-b1f8-6dfd5dda5862" providerId="ADAL" clId="{161B03EE-95FE-457B-869D-1BF7800899D4}" dt="2021-02-08T01:30:49.356" v="5109" actId="20577"/>
          <ac:spMkLst>
            <pc:docMk/>
            <pc:sldMk cId="568423308" sldId="279"/>
            <ac:spMk id="2" creationId="{28C08DB6-BD44-4401-A786-2D06627D7C16}"/>
          </ac:spMkLst>
        </pc:spChg>
        <pc:spChg chg="mod">
          <ac:chgData name="Amanda Gibson" userId="907984a6-cd77-4b7d-b1f8-6dfd5dda5862" providerId="ADAL" clId="{161B03EE-95FE-457B-869D-1BF7800899D4}" dt="2021-02-08T00:18:01.289" v="3012" actId="20577"/>
          <ac:spMkLst>
            <pc:docMk/>
            <pc:sldMk cId="568423308" sldId="279"/>
            <ac:spMk id="37" creationId="{11F4F17E-B198-4662-82B9-FD38C6AFD4A0}"/>
          </ac:spMkLst>
        </pc:spChg>
        <pc:spChg chg="add del mod">
          <ac:chgData name="Amanda Gibson" userId="907984a6-cd77-4b7d-b1f8-6dfd5dda5862" providerId="ADAL" clId="{161B03EE-95FE-457B-869D-1BF7800899D4}" dt="2021-02-08T00:17:02.091" v="2988" actId="478"/>
          <ac:spMkLst>
            <pc:docMk/>
            <pc:sldMk cId="568423308" sldId="279"/>
            <ac:spMk id="39" creationId="{C4DA35AA-78AE-47E4-8AD1-4398A0069D5E}"/>
          </ac:spMkLst>
        </pc:spChg>
        <pc:spChg chg="add del mod">
          <ac:chgData name="Amanda Gibson" userId="907984a6-cd77-4b7d-b1f8-6dfd5dda5862" providerId="ADAL" clId="{161B03EE-95FE-457B-869D-1BF7800899D4}" dt="2021-02-08T00:17:02.091" v="2988" actId="478"/>
          <ac:spMkLst>
            <pc:docMk/>
            <pc:sldMk cId="568423308" sldId="279"/>
            <ac:spMk id="40" creationId="{494346B1-47CD-47D4-8366-709308B2A4F8}"/>
          </ac:spMkLst>
        </pc:spChg>
        <pc:spChg chg="add del mod">
          <ac:chgData name="Amanda Gibson" userId="907984a6-cd77-4b7d-b1f8-6dfd5dda5862" providerId="ADAL" clId="{161B03EE-95FE-457B-869D-1BF7800899D4}" dt="2021-02-08T00:17:02.091" v="2988" actId="478"/>
          <ac:spMkLst>
            <pc:docMk/>
            <pc:sldMk cId="568423308" sldId="279"/>
            <ac:spMk id="43" creationId="{8E0CDEA3-7B1D-45D9-8043-3922FBC5850F}"/>
          </ac:spMkLst>
        </pc:spChg>
        <pc:spChg chg="add mod ord">
          <ac:chgData name="Amanda Gibson" userId="907984a6-cd77-4b7d-b1f8-6dfd5dda5862" providerId="ADAL" clId="{161B03EE-95FE-457B-869D-1BF7800899D4}" dt="2021-02-08T00:17:26.277" v="2992" actId="166"/>
          <ac:spMkLst>
            <pc:docMk/>
            <pc:sldMk cId="568423308" sldId="279"/>
            <ac:spMk id="44" creationId="{FF677707-C4CE-4641-8CB6-0D9D16BB2DCA}"/>
          </ac:spMkLst>
        </pc:spChg>
        <pc:spChg chg="add mod">
          <ac:chgData name="Amanda Gibson" userId="907984a6-cd77-4b7d-b1f8-6dfd5dda5862" providerId="ADAL" clId="{161B03EE-95FE-457B-869D-1BF7800899D4}" dt="2021-02-08T00:16:14.951" v="2981" actId="20577"/>
          <ac:spMkLst>
            <pc:docMk/>
            <pc:sldMk cId="568423308" sldId="279"/>
            <ac:spMk id="45" creationId="{7FCB340D-76E7-447C-8D26-E4CC509A5A63}"/>
          </ac:spMkLst>
        </pc:spChg>
        <pc:spChg chg="mod">
          <ac:chgData name="Amanda Gibson" userId="907984a6-cd77-4b7d-b1f8-6dfd5dda5862" providerId="ADAL" clId="{161B03EE-95FE-457B-869D-1BF7800899D4}" dt="2021-02-08T00:18:13.856" v="3022" actId="20577"/>
          <ac:spMkLst>
            <pc:docMk/>
            <pc:sldMk cId="568423308" sldId="279"/>
            <ac:spMk id="46" creationId="{B3FCEA8F-D89A-459A-8EE5-ADB9402A18C5}"/>
          </ac:spMkLst>
        </pc:spChg>
        <pc:spChg chg="add mod">
          <ac:chgData name="Amanda Gibson" userId="907984a6-cd77-4b7d-b1f8-6dfd5dda5862" providerId="ADAL" clId="{161B03EE-95FE-457B-869D-1BF7800899D4}" dt="2021-02-08T00:17:31.250" v="2995" actId="1076"/>
          <ac:spMkLst>
            <pc:docMk/>
            <pc:sldMk cId="568423308" sldId="279"/>
            <ac:spMk id="48" creationId="{5BDDB4A8-E648-450E-B96E-F8D4DD553D1E}"/>
          </ac:spMkLst>
        </pc:spChg>
        <pc:spChg chg="del">
          <ac:chgData name="Amanda Gibson" userId="907984a6-cd77-4b7d-b1f8-6dfd5dda5862" providerId="ADAL" clId="{161B03EE-95FE-457B-869D-1BF7800899D4}" dt="2021-02-08T00:17:02.091" v="2988" actId="478"/>
          <ac:spMkLst>
            <pc:docMk/>
            <pc:sldMk cId="568423308" sldId="279"/>
            <ac:spMk id="52" creationId="{FAD7A4B2-A1E3-415D-A665-453154FAB86C}"/>
          </ac:spMkLst>
        </pc:spChg>
        <pc:spChg chg="del">
          <ac:chgData name="Amanda Gibson" userId="907984a6-cd77-4b7d-b1f8-6dfd5dda5862" providerId="ADAL" clId="{161B03EE-95FE-457B-869D-1BF7800899D4}" dt="2021-02-08T00:17:02.091" v="2988" actId="478"/>
          <ac:spMkLst>
            <pc:docMk/>
            <pc:sldMk cId="568423308" sldId="279"/>
            <ac:spMk id="54" creationId="{7381E3C5-ED8A-4469-BED7-2F5B2886C88D}"/>
          </ac:spMkLst>
        </pc:spChg>
        <pc:spChg chg="del">
          <ac:chgData name="Amanda Gibson" userId="907984a6-cd77-4b7d-b1f8-6dfd5dda5862" providerId="ADAL" clId="{161B03EE-95FE-457B-869D-1BF7800899D4}" dt="2021-02-08T00:17:02.091" v="2988" actId="478"/>
          <ac:spMkLst>
            <pc:docMk/>
            <pc:sldMk cId="568423308" sldId="279"/>
            <ac:spMk id="55" creationId="{9B8ED585-3C99-48EE-B49C-05996436BA14}"/>
          </ac:spMkLst>
        </pc:spChg>
        <pc:spChg chg="del">
          <ac:chgData name="Amanda Gibson" userId="907984a6-cd77-4b7d-b1f8-6dfd5dda5862" providerId="ADAL" clId="{161B03EE-95FE-457B-869D-1BF7800899D4}" dt="2021-02-08T00:17:02.091" v="2988" actId="478"/>
          <ac:spMkLst>
            <pc:docMk/>
            <pc:sldMk cId="568423308" sldId="279"/>
            <ac:spMk id="57" creationId="{4D469F44-E72E-45EA-91AC-AC07FD3DE9F3}"/>
          </ac:spMkLst>
        </pc:spChg>
        <pc:spChg chg="del">
          <ac:chgData name="Amanda Gibson" userId="907984a6-cd77-4b7d-b1f8-6dfd5dda5862" providerId="ADAL" clId="{161B03EE-95FE-457B-869D-1BF7800899D4}" dt="2021-02-08T00:17:02.091" v="2988" actId="478"/>
          <ac:spMkLst>
            <pc:docMk/>
            <pc:sldMk cId="568423308" sldId="279"/>
            <ac:spMk id="58" creationId="{4F2BDE49-EE55-4350-8BF0-F9CE734E60EB}"/>
          </ac:spMkLst>
        </pc:spChg>
        <pc:spChg chg="del">
          <ac:chgData name="Amanda Gibson" userId="907984a6-cd77-4b7d-b1f8-6dfd5dda5862" providerId="ADAL" clId="{161B03EE-95FE-457B-869D-1BF7800899D4}" dt="2021-02-08T00:17:05.605" v="2989" actId="478"/>
          <ac:spMkLst>
            <pc:docMk/>
            <pc:sldMk cId="568423308" sldId="279"/>
            <ac:spMk id="59" creationId="{75D68392-A52D-4E97-9277-3D76539B1091}"/>
          </ac:spMkLst>
        </pc:spChg>
        <pc:spChg chg="del">
          <ac:chgData name="Amanda Gibson" userId="907984a6-cd77-4b7d-b1f8-6dfd5dda5862" providerId="ADAL" clId="{161B03EE-95FE-457B-869D-1BF7800899D4}" dt="2021-02-08T00:17:02.091" v="2988" actId="478"/>
          <ac:spMkLst>
            <pc:docMk/>
            <pc:sldMk cId="568423308" sldId="279"/>
            <ac:spMk id="60" creationId="{802B3785-D750-479B-B35D-E8BDF822272B}"/>
          </ac:spMkLst>
        </pc:spChg>
        <pc:spChg chg="del">
          <ac:chgData name="Amanda Gibson" userId="907984a6-cd77-4b7d-b1f8-6dfd5dda5862" providerId="ADAL" clId="{161B03EE-95FE-457B-869D-1BF7800899D4}" dt="2021-02-08T00:17:02.091" v="2988" actId="478"/>
          <ac:spMkLst>
            <pc:docMk/>
            <pc:sldMk cId="568423308" sldId="279"/>
            <ac:spMk id="62" creationId="{C4B33B01-2ECE-46FF-ADF3-90FB961B320D}"/>
          </ac:spMkLst>
        </pc:spChg>
        <pc:spChg chg="del">
          <ac:chgData name="Amanda Gibson" userId="907984a6-cd77-4b7d-b1f8-6dfd5dda5862" providerId="ADAL" clId="{161B03EE-95FE-457B-869D-1BF7800899D4}" dt="2021-02-08T00:17:02.091" v="2988" actId="478"/>
          <ac:spMkLst>
            <pc:docMk/>
            <pc:sldMk cId="568423308" sldId="279"/>
            <ac:spMk id="63" creationId="{9E01BDAD-702C-4C2F-88A7-3F34BD58A52B}"/>
          </ac:spMkLst>
        </pc:spChg>
        <pc:spChg chg="del">
          <ac:chgData name="Amanda Gibson" userId="907984a6-cd77-4b7d-b1f8-6dfd5dda5862" providerId="ADAL" clId="{161B03EE-95FE-457B-869D-1BF7800899D4}" dt="2021-02-08T00:17:02.091" v="2988" actId="478"/>
          <ac:spMkLst>
            <pc:docMk/>
            <pc:sldMk cId="568423308" sldId="279"/>
            <ac:spMk id="65" creationId="{A457C328-3FC8-4F8A-9772-3211116F0778}"/>
          </ac:spMkLst>
        </pc:spChg>
        <pc:spChg chg="del">
          <ac:chgData name="Amanda Gibson" userId="907984a6-cd77-4b7d-b1f8-6dfd5dda5862" providerId="ADAL" clId="{161B03EE-95FE-457B-869D-1BF7800899D4}" dt="2021-02-08T00:17:02.091" v="2988" actId="478"/>
          <ac:spMkLst>
            <pc:docMk/>
            <pc:sldMk cId="568423308" sldId="279"/>
            <ac:spMk id="66" creationId="{DAFF608D-E1CA-41C9-B58D-5F736CFE46FE}"/>
          </ac:spMkLst>
        </pc:spChg>
        <pc:spChg chg="del">
          <ac:chgData name="Amanda Gibson" userId="907984a6-cd77-4b7d-b1f8-6dfd5dda5862" providerId="ADAL" clId="{161B03EE-95FE-457B-869D-1BF7800899D4}" dt="2021-02-08T00:17:02.091" v="2988" actId="478"/>
          <ac:spMkLst>
            <pc:docMk/>
            <pc:sldMk cId="568423308" sldId="279"/>
            <ac:spMk id="67" creationId="{6E00364D-EB2F-4B86-B713-DE620F3D9B6E}"/>
          </ac:spMkLst>
        </pc:spChg>
        <pc:spChg chg="add mod">
          <ac:chgData name="Amanda Gibson" userId="907984a6-cd77-4b7d-b1f8-6dfd5dda5862" providerId="ADAL" clId="{161B03EE-95FE-457B-869D-1BF7800899D4}" dt="2021-02-08T00:17:06.213" v="2990"/>
          <ac:spMkLst>
            <pc:docMk/>
            <pc:sldMk cId="568423308" sldId="279"/>
            <ac:spMk id="69" creationId="{9CB26AC9-A803-4139-B999-2F74AEC0D716}"/>
          </ac:spMkLst>
        </pc:spChg>
        <pc:spChg chg="add mod">
          <ac:chgData name="Amanda Gibson" userId="907984a6-cd77-4b7d-b1f8-6dfd5dda5862" providerId="ADAL" clId="{161B03EE-95FE-457B-869D-1BF7800899D4}" dt="2021-02-08T00:17:06.213" v="2990"/>
          <ac:spMkLst>
            <pc:docMk/>
            <pc:sldMk cId="568423308" sldId="279"/>
            <ac:spMk id="70" creationId="{B35F54B4-3BF5-4648-BA5F-839B8217BC62}"/>
          </ac:spMkLst>
        </pc:spChg>
        <pc:spChg chg="add mod">
          <ac:chgData name="Amanda Gibson" userId="907984a6-cd77-4b7d-b1f8-6dfd5dda5862" providerId="ADAL" clId="{161B03EE-95FE-457B-869D-1BF7800899D4}" dt="2021-02-08T00:17:06.213" v="2990"/>
          <ac:spMkLst>
            <pc:docMk/>
            <pc:sldMk cId="568423308" sldId="279"/>
            <ac:spMk id="71" creationId="{089B2115-724F-40EB-9552-97D19D3C03E3}"/>
          </ac:spMkLst>
        </pc:spChg>
        <pc:spChg chg="add mod">
          <ac:chgData name="Amanda Gibson" userId="907984a6-cd77-4b7d-b1f8-6dfd5dda5862" providerId="ADAL" clId="{161B03EE-95FE-457B-869D-1BF7800899D4}" dt="2021-02-08T00:17:06.213" v="2990"/>
          <ac:spMkLst>
            <pc:docMk/>
            <pc:sldMk cId="568423308" sldId="279"/>
            <ac:spMk id="72" creationId="{CF8821E0-4EEE-465E-8798-BFB4F5C8DC2D}"/>
          </ac:spMkLst>
        </pc:spChg>
        <pc:spChg chg="del">
          <ac:chgData name="Amanda Gibson" userId="907984a6-cd77-4b7d-b1f8-6dfd5dda5862" providerId="ADAL" clId="{161B03EE-95FE-457B-869D-1BF7800899D4}" dt="2021-02-08T00:17:02.091" v="2988" actId="478"/>
          <ac:spMkLst>
            <pc:docMk/>
            <pc:sldMk cId="568423308" sldId="279"/>
            <ac:spMk id="74" creationId="{DD2A9F8B-7937-4D05-936D-132C6E47FA03}"/>
          </ac:spMkLst>
        </pc:spChg>
        <pc:spChg chg="del">
          <ac:chgData name="Amanda Gibson" userId="907984a6-cd77-4b7d-b1f8-6dfd5dda5862" providerId="ADAL" clId="{161B03EE-95FE-457B-869D-1BF7800899D4}" dt="2021-02-08T00:17:02.091" v="2988" actId="478"/>
          <ac:spMkLst>
            <pc:docMk/>
            <pc:sldMk cId="568423308" sldId="279"/>
            <ac:spMk id="75" creationId="{73393428-69D2-43D2-9DF6-FC52BC91236B}"/>
          </ac:spMkLst>
        </pc:spChg>
        <pc:spChg chg="del">
          <ac:chgData name="Amanda Gibson" userId="907984a6-cd77-4b7d-b1f8-6dfd5dda5862" providerId="ADAL" clId="{161B03EE-95FE-457B-869D-1BF7800899D4}" dt="2021-02-08T00:17:02.091" v="2988" actId="478"/>
          <ac:spMkLst>
            <pc:docMk/>
            <pc:sldMk cId="568423308" sldId="279"/>
            <ac:spMk id="77" creationId="{F2097A6F-43AA-40BB-B20E-B225DC0625E7}"/>
          </ac:spMkLst>
        </pc:spChg>
        <pc:spChg chg="del">
          <ac:chgData name="Amanda Gibson" userId="907984a6-cd77-4b7d-b1f8-6dfd5dda5862" providerId="ADAL" clId="{161B03EE-95FE-457B-869D-1BF7800899D4}" dt="2021-02-08T00:17:02.091" v="2988" actId="478"/>
          <ac:spMkLst>
            <pc:docMk/>
            <pc:sldMk cId="568423308" sldId="279"/>
            <ac:spMk id="78" creationId="{447876AA-2991-4C82-A13A-048EE46D073F}"/>
          </ac:spMkLst>
        </pc:spChg>
        <pc:spChg chg="del">
          <ac:chgData name="Amanda Gibson" userId="907984a6-cd77-4b7d-b1f8-6dfd5dda5862" providerId="ADAL" clId="{161B03EE-95FE-457B-869D-1BF7800899D4}" dt="2021-02-08T00:17:02.091" v="2988" actId="478"/>
          <ac:spMkLst>
            <pc:docMk/>
            <pc:sldMk cId="568423308" sldId="279"/>
            <ac:spMk id="79" creationId="{1280C149-EE31-4510-941F-CD758B67EBC6}"/>
          </ac:spMkLst>
        </pc:spChg>
        <pc:spChg chg="del">
          <ac:chgData name="Amanda Gibson" userId="907984a6-cd77-4b7d-b1f8-6dfd5dda5862" providerId="ADAL" clId="{161B03EE-95FE-457B-869D-1BF7800899D4}" dt="2021-02-08T00:17:02.091" v="2988" actId="478"/>
          <ac:spMkLst>
            <pc:docMk/>
            <pc:sldMk cId="568423308" sldId="279"/>
            <ac:spMk id="80" creationId="{166392F5-BFC8-43E9-8432-1CE92035C799}"/>
          </ac:spMkLst>
        </pc:spChg>
        <pc:spChg chg="del">
          <ac:chgData name="Amanda Gibson" userId="907984a6-cd77-4b7d-b1f8-6dfd5dda5862" providerId="ADAL" clId="{161B03EE-95FE-457B-869D-1BF7800899D4}" dt="2021-02-08T00:11:59.606" v="2848" actId="478"/>
          <ac:spMkLst>
            <pc:docMk/>
            <pc:sldMk cId="568423308" sldId="279"/>
            <ac:spMk id="81" creationId="{768D9834-C797-40B0-B5C3-A8A753C2EBA4}"/>
          </ac:spMkLst>
        </pc:spChg>
        <pc:spChg chg="add mod">
          <ac:chgData name="Amanda Gibson" userId="907984a6-cd77-4b7d-b1f8-6dfd5dda5862" providerId="ADAL" clId="{161B03EE-95FE-457B-869D-1BF7800899D4}" dt="2021-02-08T00:17:06.213" v="2990"/>
          <ac:spMkLst>
            <pc:docMk/>
            <pc:sldMk cId="568423308" sldId="279"/>
            <ac:spMk id="82" creationId="{71266F89-E78D-4096-930C-0FE7CCFEE445}"/>
          </ac:spMkLst>
        </pc:spChg>
        <pc:spChg chg="add mod">
          <ac:chgData name="Amanda Gibson" userId="907984a6-cd77-4b7d-b1f8-6dfd5dda5862" providerId="ADAL" clId="{161B03EE-95FE-457B-869D-1BF7800899D4}" dt="2021-02-08T00:17:06.213" v="2990"/>
          <ac:spMkLst>
            <pc:docMk/>
            <pc:sldMk cId="568423308" sldId="279"/>
            <ac:spMk id="83" creationId="{1944A02E-85F4-4174-BA79-16515F18AE10}"/>
          </ac:spMkLst>
        </pc:spChg>
        <pc:spChg chg="add mod">
          <ac:chgData name="Amanda Gibson" userId="907984a6-cd77-4b7d-b1f8-6dfd5dda5862" providerId="ADAL" clId="{161B03EE-95FE-457B-869D-1BF7800899D4}" dt="2021-02-08T00:17:06.213" v="2990"/>
          <ac:spMkLst>
            <pc:docMk/>
            <pc:sldMk cId="568423308" sldId="279"/>
            <ac:spMk id="84" creationId="{22D67E9D-5062-4A87-A030-A820008E3850}"/>
          </ac:spMkLst>
        </pc:spChg>
        <pc:spChg chg="add mod">
          <ac:chgData name="Amanda Gibson" userId="907984a6-cd77-4b7d-b1f8-6dfd5dda5862" providerId="ADAL" clId="{161B03EE-95FE-457B-869D-1BF7800899D4}" dt="2021-02-08T00:17:06.213" v="2990"/>
          <ac:spMkLst>
            <pc:docMk/>
            <pc:sldMk cId="568423308" sldId="279"/>
            <ac:spMk id="85" creationId="{359C128B-6D73-42B9-933D-679813012B6B}"/>
          </ac:spMkLst>
        </pc:spChg>
        <pc:spChg chg="add mod">
          <ac:chgData name="Amanda Gibson" userId="907984a6-cd77-4b7d-b1f8-6dfd5dda5862" providerId="ADAL" clId="{161B03EE-95FE-457B-869D-1BF7800899D4}" dt="2021-02-08T00:17:06.213" v="2990"/>
          <ac:spMkLst>
            <pc:docMk/>
            <pc:sldMk cId="568423308" sldId="279"/>
            <ac:spMk id="86" creationId="{742A3144-C6B4-46BE-93AE-D1A8B320876D}"/>
          </ac:spMkLst>
        </pc:spChg>
        <pc:spChg chg="add mod">
          <ac:chgData name="Amanda Gibson" userId="907984a6-cd77-4b7d-b1f8-6dfd5dda5862" providerId="ADAL" clId="{161B03EE-95FE-457B-869D-1BF7800899D4}" dt="2021-02-08T00:17:06.213" v="2990"/>
          <ac:spMkLst>
            <pc:docMk/>
            <pc:sldMk cId="568423308" sldId="279"/>
            <ac:spMk id="87" creationId="{AF44DBA4-9024-49AF-8F00-134BE9E470C0}"/>
          </ac:spMkLst>
        </pc:spChg>
        <pc:spChg chg="add mod">
          <ac:chgData name="Amanda Gibson" userId="907984a6-cd77-4b7d-b1f8-6dfd5dda5862" providerId="ADAL" clId="{161B03EE-95FE-457B-869D-1BF7800899D4}" dt="2021-02-08T00:17:06.213" v="2990"/>
          <ac:spMkLst>
            <pc:docMk/>
            <pc:sldMk cId="568423308" sldId="279"/>
            <ac:spMk id="88" creationId="{3CCD7D92-4DAA-40EA-97F9-DF5BF51CCACC}"/>
          </ac:spMkLst>
        </pc:spChg>
        <pc:spChg chg="add del mod">
          <ac:chgData name="Amanda Gibson" userId="907984a6-cd77-4b7d-b1f8-6dfd5dda5862" providerId="ADAL" clId="{161B03EE-95FE-457B-869D-1BF7800899D4}" dt="2021-02-08T00:17:43.518" v="2998" actId="478"/>
          <ac:spMkLst>
            <pc:docMk/>
            <pc:sldMk cId="568423308" sldId="279"/>
            <ac:spMk id="89" creationId="{D646DDD7-4310-4182-8499-169DAB42DF80}"/>
          </ac:spMkLst>
        </pc:spChg>
        <pc:spChg chg="add mod">
          <ac:chgData name="Amanda Gibson" userId="907984a6-cd77-4b7d-b1f8-6dfd5dda5862" providerId="ADAL" clId="{161B03EE-95FE-457B-869D-1BF7800899D4}" dt="2021-02-08T00:17:49.137" v="2999" actId="571"/>
          <ac:spMkLst>
            <pc:docMk/>
            <pc:sldMk cId="568423308" sldId="279"/>
            <ac:spMk id="90" creationId="{B6CCA7B9-30AC-4C8A-8D36-B18E51D847FA}"/>
          </ac:spMkLst>
        </pc:spChg>
        <pc:cxnChg chg="del">
          <ac:chgData name="Amanda Gibson" userId="907984a6-cd77-4b7d-b1f8-6dfd5dda5862" providerId="ADAL" clId="{161B03EE-95FE-457B-869D-1BF7800899D4}" dt="2021-02-08T00:17:02.091" v="2988" actId="478"/>
          <ac:cxnSpMkLst>
            <pc:docMk/>
            <pc:sldMk cId="568423308" sldId="279"/>
            <ac:cxnSpMk id="38" creationId="{679A1E74-D06F-421B-A2DF-AF555FE4108A}"/>
          </ac:cxnSpMkLst>
        </pc:cxnChg>
        <pc:cxnChg chg="add del mod ord">
          <ac:chgData name="Amanda Gibson" userId="907984a6-cd77-4b7d-b1f8-6dfd5dda5862" providerId="ADAL" clId="{161B03EE-95FE-457B-869D-1BF7800899D4}" dt="2021-02-08T00:17:02.091" v="2988" actId="478"/>
          <ac:cxnSpMkLst>
            <pc:docMk/>
            <pc:sldMk cId="568423308" sldId="279"/>
            <ac:cxnSpMk id="41" creationId="{E739EEF8-DBD4-4E97-BE73-0792D78350B2}"/>
          </ac:cxnSpMkLst>
        </pc:cxnChg>
        <pc:cxnChg chg="del">
          <ac:chgData name="Amanda Gibson" userId="907984a6-cd77-4b7d-b1f8-6dfd5dda5862" providerId="ADAL" clId="{161B03EE-95FE-457B-869D-1BF7800899D4}" dt="2021-02-08T00:17:02.091" v="2988" actId="478"/>
          <ac:cxnSpMkLst>
            <pc:docMk/>
            <pc:sldMk cId="568423308" sldId="279"/>
            <ac:cxnSpMk id="42" creationId="{1CEED8F7-68A8-4964-8C07-3A90094E793E}"/>
          </ac:cxnSpMkLst>
        </pc:cxnChg>
        <pc:cxnChg chg="del">
          <ac:chgData name="Amanda Gibson" userId="907984a6-cd77-4b7d-b1f8-6dfd5dda5862" providerId="ADAL" clId="{161B03EE-95FE-457B-869D-1BF7800899D4}" dt="2021-02-08T00:17:02.091" v="2988" actId="478"/>
          <ac:cxnSpMkLst>
            <pc:docMk/>
            <pc:sldMk cId="568423308" sldId="279"/>
            <ac:cxnSpMk id="47" creationId="{C247D9B3-60F4-49FC-91F7-BB43C135E37B}"/>
          </ac:cxnSpMkLst>
        </pc:cxnChg>
        <pc:cxnChg chg="del">
          <ac:chgData name="Amanda Gibson" userId="907984a6-cd77-4b7d-b1f8-6dfd5dda5862" providerId="ADAL" clId="{161B03EE-95FE-457B-869D-1BF7800899D4}" dt="2021-02-08T00:17:02.091" v="2988" actId="478"/>
          <ac:cxnSpMkLst>
            <pc:docMk/>
            <pc:sldMk cId="568423308" sldId="279"/>
            <ac:cxnSpMk id="49" creationId="{5335414E-2F04-4013-AF6D-EF915881D0A5}"/>
          </ac:cxnSpMkLst>
        </pc:cxnChg>
        <pc:cxnChg chg="del">
          <ac:chgData name="Amanda Gibson" userId="907984a6-cd77-4b7d-b1f8-6dfd5dda5862" providerId="ADAL" clId="{161B03EE-95FE-457B-869D-1BF7800899D4}" dt="2021-02-08T00:17:02.091" v="2988" actId="478"/>
          <ac:cxnSpMkLst>
            <pc:docMk/>
            <pc:sldMk cId="568423308" sldId="279"/>
            <ac:cxnSpMk id="50" creationId="{6CABE885-F2EE-4C73-ADB7-F08500CC216A}"/>
          </ac:cxnSpMkLst>
        </pc:cxnChg>
        <pc:cxnChg chg="del">
          <ac:chgData name="Amanda Gibson" userId="907984a6-cd77-4b7d-b1f8-6dfd5dda5862" providerId="ADAL" clId="{161B03EE-95FE-457B-869D-1BF7800899D4}" dt="2021-02-08T00:17:02.091" v="2988" actId="478"/>
          <ac:cxnSpMkLst>
            <pc:docMk/>
            <pc:sldMk cId="568423308" sldId="279"/>
            <ac:cxnSpMk id="51" creationId="{B1738F0B-4B49-43CA-A172-DBE1B5809737}"/>
          </ac:cxnSpMkLst>
        </pc:cxnChg>
        <pc:cxnChg chg="add mod">
          <ac:chgData name="Amanda Gibson" userId="907984a6-cd77-4b7d-b1f8-6dfd5dda5862" providerId="ADAL" clId="{161B03EE-95FE-457B-869D-1BF7800899D4}" dt="2021-02-08T00:17:06.213" v="2990"/>
          <ac:cxnSpMkLst>
            <pc:docMk/>
            <pc:sldMk cId="568423308" sldId="279"/>
            <ac:cxnSpMk id="53" creationId="{DA4046F3-1FF5-4AF0-89FB-2C774766A340}"/>
          </ac:cxnSpMkLst>
        </pc:cxnChg>
        <pc:cxnChg chg="add mod">
          <ac:chgData name="Amanda Gibson" userId="907984a6-cd77-4b7d-b1f8-6dfd5dda5862" providerId="ADAL" clId="{161B03EE-95FE-457B-869D-1BF7800899D4}" dt="2021-02-08T00:17:06.213" v="2990"/>
          <ac:cxnSpMkLst>
            <pc:docMk/>
            <pc:sldMk cId="568423308" sldId="279"/>
            <ac:cxnSpMk id="56" creationId="{4E2FA796-806A-4296-8581-DFC3A22ECA86}"/>
          </ac:cxnSpMkLst>
        </pc:cxnChg>
        <pc:cxnChg chg="add mod">
          <ac:chgData name="Amanda Gibson" userId="907984a6-cd77-4b7d-b1f8-6dfd5dda5862" providerId="ADAL" clId="{161B03EE-95FE-457B-869D-1BF7800899D4}" dt="2021-02-08T00:17:06.213" v="2990"/>
          <ac:cxnSpMkLst>
            <pc:docMk/>
            <pc:sldMk cId="568423308" sldId="279"/>
            <ac:cxnSpMk id="61" creationId="{498CE6F1-5676-4D21-911C-31707F403203}"/>
          </ac:cxnSpMkLst>
        </pc:cxnChg>
        <pc:cxnChg chg="add mod">
          <ac:chgData name="Amanda Gibson" userId="907984a6-cd77-4b7d-b1f8-6dfd5dda5862" providerId="ADAL" clId="{161B03EE-95FE-457B-869D-1BF7800899D4}" dt="2021-02-08T00:17:06.213" v="2990"/>
          <ac:cxnSpMkLst>
            <pc:docMk/>
            <pc:sldMk cId="568423308" sldId="279"/>
            <ac:cxnSpMk id="64" creationId="{70430FA3-15C3-4ACC-B736-B019C8C1BE3F}"/>
          </ac:cxnSpMkLst>
        </pc:cxnChg>
        <pc:cxnChg chg="add mod">
          <ac:chgData name="Amanda Gibson" userId="907984a6-cd77-4b7d-b1f8-6dfd5dda5862" providerId="ADAL" clId="{161B03EE-95FE-457B-869D-1BF7800899D4}" dt="2021-02-08T00:17:06.213" v="2990"/>
          <ac:cxnSpMkLst>
            <pc:docMk/>
            <pc:sldMk cId="568423308" sldId="279"/>
            <ac:cxnSpMk id="68" creationId="{568B8FAB-BB61-40DA-8202-6E34571A5B57}"/>
          </ac:cxnSpMkLst>
        </pc:cxnChg>
        <pc:cxnChg chg="del">
          <ac:chgData name="Amanda Gibson" userId="907984a6-cd77-4b7d-b1f8-6dfd5dda5862" providerId="ADAL" clId="{161B03EE-95FE-457B-869D-1BF7800899D4}" dt="2021-02-08T00:17:02.091" v="2988" actId="478"/>
          <ac:cxnSpMkLst>
            <pc:docMk/>
            <pc:sldMk cId="568423308" sldId="279"/>
            <ac:cxnSpMk id="73" creationId="{4FB2743C-BA85-45B8-8E7D-CAD53164FA1B}"/>
          </ac:cxnSpMkLst>
        </pc:cxnChg>
        <pc:cxnChg chg="del">
          <ac:chgData name="Amanda Gibson" userId="907984a6-cd77-4b7d-b1f8-6dfd5dda5862" providerId="ADAL" clId="{161B03EE-95FE-457B-869D-1BF7800899D4}" dt="2021-02-08T00:17:02.091" v="2988" actId="478"/>
          <ac:cxnSpMkLst>
            <pc:docMk/>
            <pc:sldMk cId="568423308" sldId="279"/>
            <ac:cxnSpMk id="76" creationId="{506F30E3-7638-4C2B-9E3A-1A4209EE9562}"/>
          </ac:cxnSpMkLst>
        </pc:cxnChg>
      </pc:sldChg>
      <pc:sldChg chg="modSp add mod ord">
        <pc:chgData name="Amanda Gibson" userId="907984a6-cd77-4b7d-b1f8-6dfd5dda5862" providerId="ADAL" clId="{161B03EE-95FE-457B-869D-1BF7800899D4}" dt="2021-02-08T01:30:55.274" v="5118" actId="20577"/>
        <pc:sldMkLst>
          <pc:docMk/>
          <pc:sldMk cId="4067617883" sldId="280"/>
        </pc:sldMkLst>
        <pc:spChg chg="mod">
          <ac:chgData name="Amanda Gibson" userId="907984a6-cd77-4b7d-b1f8-6dfd5dda5862" providerId="ADAL" clId="{161B03EE-95FE-457B-869D-1BF7800899D4}" dt="2021-02-08T01:30:55.274" v="5118" actId="20577"/>
          <ac:spMkLst>
            <pc:docMk/>
            <pc:sldMk cId="4067617883" sldId="280"/>
            <ac:spMk id="2" creationId="{28C08DB6-BD44-4401-A786-2D06627D7C16}"/>
          </ac:spMkLst>
        </pc:spChg>
      </pc:sldChg>
      <pc:sldChg chg="add del">
        <pc:chgData name="Amanda Gibson" userId="907984a6-cd77-4b7d-b1f8-6dfd5dda5862" providerId="ADAL" clId="{161B03EE-95FE-457B-869D-1BF7800899D4}" dt="2021-02-08T00:23:34.317" v="3157" actId="2890"/>
        <pc:sldMkLst>
          <pc:docMk/>
          <pc:sldMk cId="816545368" sldId="281"/>
        </pc:sldMkLst>
      </pc:sldChg>
      <pc:sldChg chg="new del">
        <pc:chgData name="Amanda Gibson" userId="907984a6-cd77-4b7d-b1f8-6dfd5dda5862" providerId="ADAL" clId="{161B03EE-95FE-457B-869D-1BF7800899D4}" dt="2021-02-08T00:23:29.823" v="3155" actId="680"/>
        <pc:sldMkLst>
          <pc:docMk/>
          <pc:sldMk cId="1107219453" sldId="281"/>
        </pc:sldMkLst>
      </pc:sldChg>
      <pc:sldChg chg="addSp delSp modSp add mod ord">
        <pc:chgData name="Amanda Gibson" userId="907984a6-cd77-4b7d-b1f8-6dfd5dda5862" providerId="ADAL" clId="{161B03EE-95FE-457B-869D-1BF7800899D4}" dt="2021-02-08T01:30:22.390" v="5103"/>
        <pc:sldMkLst>
          <pc:docMk/>
          <pc:sldMk cId="1378134600" sldId="281"/>
        </pc:sldMkLst>
        <pc:spChg chg="mod">
          <ac:chgData name="Amanda Gibson" userId="907984a6-cd77-4b7d-b1f8-6dfd5dda5862" providerId="ADAL" clId="{161B03EE-95FE-457B-869D-1BF7800899D4}" dt="2021-02-08T00:37:45.409" v="3722" actId="20577"/>
          <ac:spMkLst>
            <pc:docMk/>
            <pc:sldMk cId="1378134600" sldId="281"/>
            <ac:spMk id="2" creationId="{28C08DB6-BD44-4401-A786-2D06627D7C16}"/>
          </ac:spMkLst>
        </pc:spChg>
        <pc:spChg chg="mod">
          <ac:chgData name="Amanda Gibson" userId="907984a6-cd77-4b7d-b1f8-6dfd5dda5862" providerId="ADAL" clId="{161B03EE-95FE-457B-869D-1BF7800899D4}" dt="2021-02-08T00:37:12.498" v="3655" actId="20577"/>
          <ac:spMkLst>
            <pc:docMk/>
            <pc:sldMk cId="1378134600" sldId="281"/>
            <ac:spMk id="37" creationId="{11F4F17E-B198-4662-82B9-FD38C6AFD4A0}"/>
          </ac:spMkLst>
        </pc:spChg>
        <pc:spChg chg="del">
          <ac:chgData name="Amanda Gibson" userId="907984a6-cd77-4b7d-b1f8-6dfd5dda5862" providerId="ADAL" clId="{161B03EE-95FE-457B-869D-1BF7800899D4}" dt="2021-02-08T00:25:26.792" v="3347" actId="478"/>
          <ac:spMkLst>
            <pc:docMk/>
            <pc:sldMk cId="1378134600" sldId="281"/>
            <ac:spMk id="44" creationId="{FF677707-C4CE-4641-8CB6-0D9D16BB2DCA}"/>
          </ac:spMkLst>
        </pc:spChg>
        <pc:spChg chg="del">
          <ac:chgData name="Amanda Gibson" userId="907984a6-cd77-4b7d-b1f8-6dfd5dda5862" providerId="ADAL" clId="{161B03EE-95FE-457B-869D-1BF7800899D4}" dt="2021-02-08T00:25:34.859" v="3349" actId="478"/>
          <ac:spMkLst>
            <pc:docMk/>
            <pc:sldMk cId="1378134600" sldId="281"/>
            <ac:spMk id="45" creationId="{7FCB340D-76E7-447C-8D26-E4CC509A5A63}"/>
          </ac:spMkLst>
        </pc:spChg>
        <pc:spChg chg="del mod">
          <ac:chgData name="Amanda Gibson" userId="907984a6-cd77-4b7d-b1f8-6dfd5dda5862" providerId="ADAL" clId="{161B03EE-95FE-457B-869D-1BF7800899D4}" dt="2021-02-08T00:30:26.147" v="3524" actId="478"/>
          <ac:spMkLst>
            <pc:docMk/>
            <pc:sldMk cId="1378134600" sldId="281"/>
            <ac:spMk id="46" creationId="{B3FCEA8F-D89A-459A-8EE5-ADB9402A18C5}"/>
          </ac:spMkLst>
        </pc:spChg>
        <pc:spChg chg="add mod">
          <ac:chgData name="Amanda Gibson" userId="907984a6-cd77-4b7d-b1f8-6dfd5dda5862" providerId="ADAL" clId="{161B03EE-95FE-457B-869D-1BF7800899D4}" dt="2021-02-08T00:30:55.796" v="3527" actId="207"/>
          <ac:spMkLst>
            <pc:docMk/>
            <pc:sldMk cId="1378134600" sldId="281"/>
            <ac:spMk id="47" creationId="{F720D460-AE7D-43B2-8729-4BBC48C288C6}"/>
          </ac:spMkLst>
        </pc:spChg>
        <pc:spChg chg="mod">
          <ac:chgData name="Amanda Gibson" userId="907984a6-cd77-4b7d-b1f8-6dfd5dda5862" providerId="ADAL" clId="{161B03EE-95FE-457B-869D-1BF7800899D4}" dt="2021-02-08T00:25:22.302" v="3345" actId="1076"/>
          <ac:spMkLst>
            <pc:docMk/>
            <pc:sldMk cId="1378134600" sldId="281"/>
            <ac:spMk id="48" creationId="{5BDDB4A8-E648-450E-B96E-F8D4DD553D1E}"/>
          </ac:spMkLst>
        </pc:spChg>
        <pc:spChg chg="add mod">
          <ac:chgData name="Amanda Gibson" userId="907984a6-cd77-4b7d-b1f8-6dfd5dda5862" providerId="ADAL" clId="{161B03EE-95FE-457B-869D-1BF7800899D4}" dt="2021-02-08T00:29:24.741" v="3500" actId="1076"/>
          <ac:spMkLst>
            <pc:docMk/>
            <pc:sldMk cId="1378134600" sldId="281"/>
            <ac:spMk id="49" creationId="{8B6BD669-7569-4BD9-9205-25FEA5B77759}"/>
          </ac:spMkLst>
        </pc:spChg>
        <pc:spChg chg="add mod">
          <ac:chgData name="Amanda Gibson" userId="907984a6-cd77-4b7d-b1f8-6dfd5dda5862" providerId="ADAL" clId="{161B03EE-95FE-457B-869D-1BF7800899D4}" dt="2021-02-08T00:28:59.282" v="3497" actId="20577"/>
          <ac:spMkLst>
            <pc:docMk/>
            <pc:sldMk cId="1378134600" sldId="281"/>
            <ac:spMk id="50" creationId="{ECB5972F-3304-4595-A223-398DC9AA3367}"/>
          </ac:spMkLst>
        </pc:spChg>
        <pc:spChg chg="add mod">
          <ac:chgData name="Amanda Gibson" userId="907984a6-cd77-4b7d-b1f8-6dfd5dda5862" providerId="ADAL" clId="{161B03EE-95FE-457B-869D-1BF7800899D4}" dt="2021-02-08T00:29:13.922" v="3499" actId="20577"/>
          <ac:spMkLst>
            <pc:docMk/>
            <pc:sldMk cId="1378134600" sldId="281"/>
            <ac:spMk id="51" creationId="{03906754-AEBA-47DB-9CE3-4D36DCC2BE59}"/>
          </ac:spMkLst>
        </pc:spChg>
        <pc:spChg chg="add mod">
          <ac:chgData name="Amanda Gibson" userId="907984a6-cd77-4b7d-b1f8-6dfd5dda5862" providerId="ADAL" clId="{161B03EE-95FE-457B-869D-1BF7800899D4}" dt="2021-02-08T00:29:34.311" v="3502" actId="20577"/>
          <ac:spMkLst>
            <pc:docMk/>
            <pc:sldMk cId="1378134600" sldId="281"/>
            <ac:spMk id="52" creationId="{0E7759F6-05FA-4506-AD28-84C2C94859BB}"/>
          </ac:spMkLst>
        </pc:spChg>
        <pc:spChg chg="add mod">
          <ac:chgData name="Amanda Gibson" userId="907984a6-cd77-4b7d-b1f8-6dfd5dda5862" providerId="ADAL" clId="{161B03EE-95FE-457B-869D-1BF7800899D4}" dt="2021-02-08T00:29:57.841" v="3505" actId="20577"/>
          <ac:spMkLst>
            <pc:docMk/>
            <pc:sldMk cId="1378134600" sldId="281"/>
            <ac:spMk id="54" creationId="{16DF88A2-65C8-4A9A-95A3-20EF4B345899}"/>
          </ac:spMkLst>
        </pc:spChg>
        <pc:spChg chg="add mod">
          <ac:chgData name="Amanda Gibson" userId="907984a6-cd77-4b7d-b1f8-6dfd5dda5862" providerId="ADAL" clId="{161B03EE-95FE-457B-869D-1BF7800899D4}" dt="2021-02-08T00:30:52.580" v="3526" actId="1076"/>
          <ac:spMkLst>
            <pc:docMk/>
            <pc:sldMk cId="1378134600" sldId="281"/>
            <ac:spMk id="55" creationId="{767BBC8B-2E0C-441B-8794-1A194F2E8D8C}"/>
          </ac:spMkLst>
        </pc:spChg>
        <pc:spChg chg="mod">
          <ac:chgData name="Amanda Gibson" userId="907984a6-cd77-4b7d-b1f8-6dfd5dda5862" providerId="ADAL" clId="{161B03EE-95FE-457B-869D-1BF7800899D4}" dt="2021-02-08T00:25:22.302" v="3345" actId="1076"/>
          <ac:spMkLst>
            <pc:docMk/>
            <pc:sldMk cId="1378134600" sldId="281"/>
            <ac:spMk id="88" creationId="{3CCD7D92-4DAA-40EA-97F9-DF5BF51CCACC}"/>
          </ac:spMkLst>
        </pc:spChg>
        <pc:spChg chg="del">
          <ac:chgData name="Amanda Gibson" userId="907984a6-cd77-4b7d-b1f8-6dfd5dda5862" providerId="ADAL" clId="{161B03EE-95FE-457B-869D-1BF7800899D4}" dt="2021-02-08T00:25:28.407" v="3348" actId="478"/>
          <ac:spMkLst>
            <pc:docMk/>
            <pc:sldMk cId="1378134600" sldId="281"/>
            <ac:spMk id="90" creationId="{B6CCA7B9-30AC-4C8A-8D36-B18E51D847FA}"/>
          </ac:spMkLst>
        </pc:spChg>
        <pc:cxnChg chg="add del mod">
          <ac:chgData name="Amanda Gibson" userId="907984a6-cd77-4b7d-b1f8-6dfd5dda5862" providerId="ADAL" clId="{161B03EE-95FE-457B-869D-1BF7800899D4}" dt="2021-02-08T00:25:25.059" v="3346" actId="478"/>
          <ac:cxnSpMkLst>
            <pc:docMk/>
            <pc:sldMk cId="1378134600" sldId="281"/>
            <ac:cxnSpMk id="31" creationId="{2102ED70-6AF6-400A-9EB8-CFE2FF837169}"/>
          </ac:cxnSpMkLst>
        </pc:cxnChg>
        <pc:cxnChg chg="add mod">
          <ac:chgData name="Amanda Gibson" userId="907984a6-cd77-4b7d-b1f8-6dfd5dda5862" providerId="ADAL" clId="{161B03EE-95FE-457B-869D-1BF7800899D4}" dt="2021-02-08T00:27:00.154" v="3472" actId="14100"/>
          <ac:cxnSpMkLst>
            <pc:docMk/>
            <pc:sldMk cId="1378134600" sldId="281"/>
            <ac:cxnSpMk id="32" creationId="{9615E0FF-C953-446C-AB32-AB262B8CDFF7}"/>
          </ac:cxnSpMkLst>
        </pc:cxnChg>
        <pc:cxnChg chg="add mod">
          <ac:chgData name="Amanda Gibson" userId="907984a6-cd77-4b7d-b1f8-6dfd5dda5862" providerId="ADAL" clId="{161B03EE-95FE-457B-869D-1BF7800899D4}" dt="2021-02-08T00:27:33.890" v="3479" actId="465"/>
          <ac:cxnSpMkLst>
            <pc:docMk/>
            <pc:sldMk cId="1378134600" sldId="281"/>
            <ac:cxnSpMk id="34" creationId="{85073BB6-ABAF-4902-AAA3-55A0094E4DD4}"/>
          </ac:cxnSpMkLst>
        </pc:cxnChg>
        <pc:cxnChg chg="add mod">
          <ac:chgData name="Amanda Gibson" userId="907984a6-cd77-4b7d-b1f8-6dfd5dda5862" providerId="ADAL" clId="{161B03EE-95FE-457B-869D-1BF7800899D4}" dt="2021-02-08T00:27:22.611" v="3478" actId="14100"/>
          <ac:cxnSpMkLst>
            <pc:docMk/>
            <pc:sldMk cId="1378134600" sldId="281"/>
            <ac:cxnSpMk id="36" creationId="{90C87663-491B-4516-AA66-0E82ACAC0ABF}"/>
          </ac:cxnSpMkLst>
        </pc:cxnChg>
        <pc:cxnChg chg="add del mod">
          <ac:chgData name="Amanda Gibson" userId="907984a6-cd77-4b7d-b1f8-6dfd5dda5862" providerId="ADAL" clId="{161B03EE-95FE-457B-869D-1BF7800899D4}" dt="2021-02-08T00:27:47.719" v="3482" actId="478"/>
          <ac:cxnSpMkLst>
            <pc:docMk/>
            <pc:sldMk cId="1378134600" sldId="281"/>
            <ac:cxnSpMk id="38" creationId="{A15402A1-CBD1-46F5-8C07-BD2E7FB72D10}"/>
          </ac:cxnSpMkLst>
        </pc:cxnChg>
        <pc:cxnChg chg="add del mod">
          <ac:chgData name="Amanda Gibson" userId="907984a6-cd77-4b7d-b1f8-6dfd5dda5862" providerId="ADAL" clId="{161B03EE-95FE-457B-869D-1BF7800899D4}" dt="2021-02-08T00:27:47.719" v="3482" actId="478"/>
          <ac:cxnSpMkLst>
            <pc:docMk/>
            <pc:sldMk cId="1378134600" sldId="281"/>
            <ac:cxnSpMk id="39" creationId="{74B06B26-0436-4C55-9AF9-EA0FC67759C9}"/>
          </ac:cxnSpMkLst>
        </pc:cxnChg>
        <pc:cxnChg chg="add del mod">
          <ac:chgData name="Amanda Gibson" userId="907984a6-cd77-4b7d-b1f8-6dfd5dda5862" providerId="ADAL" clId="{161B03EE-95FE-457B-869D-1BF7800899D4}" dt="2021-02-08T00:27:47.719" v="3482" actId="478"/>
          <ac:cxnSpMkLst>
            <pc:docMk/>
            <pc:sldMk cId="1378134600" sldId="281"/>
            <ac:cxnSpMk id="40" creationId="{2C176B75-A955-4D29-B2D6-E1D4DEAE1011}"/>
          </ac:cxnSpMkLst>
        </pc:cxnChg>
        <pc:cxnChg chg="add mod">
          <ac:chgData name="Amanda Gibson" userId="907984a6-cd77-4b7d-b1f8-6dfd5dda5862" providerId="ADAL" clId="{161B03EE-95FE-457B-869D-1BF7800899D4}" dt="2021-02-08T00:28:06.090" v="3485" actId="14100"/>
          <ac:cxnSpMkLst>
            <pc:docMk/>
            <pc:sldMk cId="1378134600" sldId="281"/>
            <ac:cxnSpMk id="41" creationId="{DAD3936B-4228-46A3-A38B-5BA45E6C367E}"/>
          </ac:cxnSpMkLst>
        </pc:cxnChg>
        <pc:cxnChg chg="add mod">
          <ac:chgData name="Amanda Gibson" userId="907984a6-cd77-4b7d-b1f8-6dfd5dda5862" providerId="ADAL" clId="{161B03EE-95FE-457B-869D-1BF7800899D4}" dt="2021-02-08T00:28:02.079" v="3484" actId="14100"/>
          <ac:cxnSpMkLst>
            <pc:docMk/>
            <pc:sldMk cId="1378134600" sldId="281"/>
            <ac:cxnSpMk id="42" creationId="{E36C1C09-DD66-466D-8A58-6FE600D21C8E}"/>
          </ac:cxnSpMkLst>
        </pc:cxnChg>
      </pc:sldChg>
      <pc:sldChg chg="addSp delSp modSp add mod ord">
        <pc:chgData name="Amanda Gibson" userId="907984a6-cd77-4b7d-b1f8-6dfd5dda5862" providerId="ADAL" clId="{161B03EE-95FE-457B-869D-1BF7800899D4}" dt="2021-02-08T01:30:22.390" v="5103"/>
        <pc:sldMkLst>
          <pc:docMk/>
          <pc:sldMk cId="2979487962" sldId="282"/>
        </pc:sldMkLst>
        <pc:spChg chg="mod">
          <ac:chgData name="Amanda Gibson" userId="907984a6-cd77-4b7d-b1f8-6dfd5dda5862" providerId="ADAL" clId="{161B03EE-95FE-457B-869D-1BF7800899D4}" dt="2021-02-08T00:37:52.264" v="3725"/>
          <ac:spMkLst>
            <pc:docMk/>
            <pc:sldMk cId="2979487962" sldId="282"/>
            <ac:spMk id="2" creationId="{28C08DB6-BD44-4401-A786-2D06627D7C16}"/>
          </ac:spMkLst>
        </pc:spChg>
        <pc:spChg chg="mod">
          <ac:chgData name="Amanda Gibson" userId="907984a6-cd77-4b7d-b1f8-6dfd5dda5862" providerId="ADAL" clId="{161B03EE-95FE-457B-869D-1BF7800899D4}" dt="2021-02-08T00:38:10.973" v="3732" actId="20577"/>
          <ac:spMkLst>
            <pc:docMk/>
            <pc:sldMk cId="2979487962" sldId="282"/>
            <ac:spMk id="37" creationId="{11F4F17E-B198-4662-82B9-FD38C6AFD4A0}"/>
          </ac:spMkLst>
        </pc:spChg>
        <pc:spChg chg="add mod">
          <ac:chgData name="Amanda Gibson" userId="907984a6-cd77-4b7d-b1f8-6dfd5dda5862" providerId="ADAL" clId="{161B03EE-95FE-457B-869D-1BF7800899D4}" dt="2021-02-08T00:32:55.336" v="3601" actId="1076"/>
          <ac:spMkLst>
            <pc:docMk/>
            <pc:sldMk cId="2979487962" sldId="282"/>
            <ac:spMk id="40" creationId="{48240F80-D536-4D67-B0E3-0E01F8975809}"/>
          </ac:spMkLst>
        </pc:spChg>
        <pc:spChg chg="add del mod">
          <ac:chgData name="Amanda Gibson" userId="907984a6-cd77-4b7d-b1f8-6dfd5dda5862" providerId="ADAL" clId="{161B03EE-95FE-457B-869D-1BF7800899D4}" dt="2021-02-08T00:34:41.725" v="3622" actId="478"/>
          <ac:spMkLst>
            <pc:docMk/>
            <pc:sldMk cId="2979487962" sldId="282"/>
            <ac:spMk id="44" creationId="{3A1A5B34-BE10-498E-8805-5D948FBB5BB6}"/>
          </ac:spMkLst>
        </pc:spChg>
        <pc:spChg chg="add mod">
          <ac:chgData name="Amanda Gibson" userId="907984a6-cd77-4b7d-b1f8-6dfd5dda5862" providerId="ADAL" clId="{161B03EE-95FE-457B-869D-1BF7800899D4}" dt="2021-02-08T00:34:51.231" v="3624" actId="20577"/>
          <ac:spMkLst>
            <pc:docMk/>
            <pc:sldMk cId="2979487962" sldId="282"/>
            <ac:spMk id="46" creationId="{78403348-608E-4F87-9FF7-90BB016A23C5}"/>
          </ac:spMkLst>
        </pc:spChg>
        <pc:spChg chg="del mod">
          <ac:chgData name="Amanda Gibson" userId="907984a6-cd77-4b7d-b1f8-6dfd5dda5862" providerId="ADAL" clId="{161B03EE-95FE-457B-869D-1BF7800899D4}" dt="2021-02-08T00:35:04.195" v="3627" actId="478"/>
          <ac:spMkLst>
            <pc:docMk/>
            <pc:sldMk cId="2979487962" sldId="282"/>
            <ac:spMk id="47" creationId="{F720D460-AE7D-43B2-8729-4BBC48C288C6}"/>
          </ac:spMkLst>
        </pc:spChg>
        <pc:spChg chg="mod">
          <ac:chgData name="Amanda Gibson" userId="907984a6-cd77-4b7d-b1f8-6dfd5dda5862" providerId="ADAL" clId="{161B03EE-95FE-457B-869D-1BF7800899D4}" dt="2021-02-08T00:33:28.613" v="3617" actId="1035"/>
          <ac:spMkLst>
            <pc:docMk/>
            <pc:sldMk cId="2979487962" sldId="282"/>
            <ac:spMk id="49" creationId="{8B6BD669-7569-4BD9-9205-25FEA5B77759}"/>
          </ac:spMkLst>
        </pc:spChg>
        <pc:spChg chg="del">
          <ac:chgData name="Amanda Gibson" userId="907984a6-cd77-4b7d-b1f8-6dfd5dda5862" providerId="ADAL" clId="{161B03EE-95FE-457B-869D-1BF7800899D4}" dt="2021-02-08T00:32:59.625" v="3602" actId="478"/>
          <ac:spMkLst>
            <pc:docMk/>
            <pc:sldMk cId="2979487962" sldId="282"/>
            <ac:spMk id="50" creationId="{ECB5972F-3304-4595-A223-398DC9AA3367}"/>
          </ac:spMkLst>
        </pc:spChg>
        <pc:spChg chg="mod">
          <ac:chgData name="Amanda Gibson" userId="907984a6-cd77-4b7d-b1f8-6dfd5dda5862" providerId="ADAL" clId="{161B03EE-95FE-457B-869D-1BF7800899D4}" dt="2021-02-08T00:36:46.456" v="3647" actId="20577"/>
          <ac:spMkLst>
            <pc:docMk/>
            <pc:sldMk cId="2979487962" sldId="282"/>
            <ac:spMk id="51" creationId="{03906754-AEBA-47DB-9CE3-4D36DCC2BE59}"/>
          </ac:spMkLst>
        </pc:spChg>
        <pc:spChg chg="mod">
          <ac:chgData name="Amanda Gibson" userId="907984a6-cd77-4b7d-b1f8-6dfd5dda5862" providerId="ADAL" clId="{161B03EE-95FE-457B-869D-1BF7800899D4}" dt="2021-02-08T00:37:04.881" v="3651" actId="20577"/>
          <ac:spMkLst>
            <pc:docMk/>
            <pc:sldMk cId="2979487962" sldId="282"/>
            <ac:spMk id="52" creationId="{0E7759F6-05FA-4506-AD28-84C2C94859BB}"/>
          </ac:spMkLst>
        </pc:spChg>
        <pc:spChg chg="mod">
          <ac:chgData name="Amanda Gibson" userId="907984a6-cd77-4b7d-b1f8-6dfd5dda5862" providerId="ADAL" clId="{161B03EE-95FE-457B-869D-1BF7800899D4}" dt="2021-02-08T00:35:36.381" v="3634" actId="3064"/>
          <ac:spMkLst>
            <pc:docMk/>
            <pc:sldMk cId="2979487962" sldId="282"/>
            <ac:spMk id="55" creationId="{767BBC8B-2E0C-441B-8794-1A194F2E8D8C}"/>
          </ac:spMkLst>
        </pc:spChg>
        <pc:cxnChg chg="del mod">
          <ac:chgData name="Amanda Gibson" userId="907984a6-cd77-4b7d-b1f8-6dfd5dda5862" providerId="ADAL" clId="{161B03EE-95FE-457B-869D-1BF7800899D4}" dt="2021-02-08T00:35:05.540" v="3628" actId="478"/>
          <ac:cxnSpMkLst>
            <pc:docMk/>
            <pc:sldMk cId="2979487962" sldId="282"/>
            <ac:cxnSpMk id="32" creationId="{9615E0FF-C953-446C-AB32-AB262B8CDFF7}"/>
          </ac:cxnSpMkLst>
        </pc:cxnChg>
        <pc:cxnChg chg="mod">
          <ac:chgData name="Amanda Gibson" userId="907984a6-cd77-4b7d-b1f8-6dfd5dda5862" providerId="ADAL" clId="{161B03EE-95FE-457B-869D-1BF7800899D4}" dt="2021-02-08T00:33:14.500" v="3604" actId="14100"/>
          <ac:cxnSpMkLst>
            <pc:docMk/>
            <pc:sldMk cId="2979487962" sldId="282"/>
            <ac:cxnSpMk id="34" creationId="{85073BB6-ABAF-4902-AAA3-55A0094E4DD4}"/>
          </ac:cxnSpMkLst>
        </pc:cxnChg>
        <pc:cxnChg chg="del">
          <ac:chgData name="Amanda Gibson" userId="907984a6-cd77-4b7d-b1f8-6dfd5dda5862" providerId="ADAL" clId="{161B03EE-95FE-457B-869D-1BF7800899D4}" dt="2021-02-08T00:32:59.625" v="3602" actId="478"/>
          <ac:cxnSpMkLst>
            <pc:docMk/>
            <pc:sldMk cId="2979487962" sldId="282"/>
            <ac:cxnSpMk id="36" creationId="{90C87663-491B-4516-AA66-0E82ACAC0ABF}"/>
          </ac:cxnSpMkLst>
        </pc:cxnChg>
        <pc:cxnChg chg="add mod">
          <ac:chgData name="Amanda Gibson" userId="907984a6-cd77-4b7d-b1f8-6dfd5dda5862" providerId="ADAL" clId="{161B03EE-95FE-457B-869D-1BF7800899D4}" dt="2021-02-08T00:32:55.336" v="3601" actId="1076"/>
          <ac:cxnSpMkLst>
            <pc:docMk/>
            <pc:sldMk cId="2979487962" sldId="282"/>
            <ac:cxnSpMk id="39" creationId="{4F8200E0-1631-42A9-955E-94D7CD170D71}"/>
          </ac:cxnSpMkLst>
        </pc:cxnChg>
        <pc:cxnChg chg="mod">
          <ac:chgData name="Amanda Gibson" userId="907984a6-cd77-4b7d-b1f8-6dfd5dda5862" providerId="ADAL" clId="{161B03EE-95FE-457B-869D-1BF7800899D4}" dt="2021-02-08T00:36:38.945" v="3645" actId="14100"/>
          <ac:cxnSpMkLst>
            <pc:docMk/>
            <pc:sldMk cId="2979487962" sldId="282"/>
            <ac:cxnSpMk id="41" creationId="{DAD3936B-4228-46A3-A38B-5BA45E6C367E}"/>
          </ac:cxnSpMkLst>
        </pc:cxnChg>
        <pc:cxnChg chg="mod">
          <ac:chgData name="Amanda Gibson" userId="907984a6-cd77-4b7d-b1f8-6dfd5dda5862" providerId="ADAL" clId="{161B03EE-95FE-457B-869D-1BF7800899D4}" dt="2021-02-08T00:36:57.840" v="3649" actId="14100"/>
          <ac:cxnSpMkLst>
            <pc:docMk/>
            <pc:sldMk cId="2979487962" sldId="282"/>
            <ac:cxnSpMk id="42" creationId="{E36C1C09-DD66-466D-8A58-6FE600D21C8E}"/>
          </ac:cxnSpMkLst>
        </pc:cxnChg>
        <pc:cxnChg chg="add mod">
          <ac:chgData name="Amanda Gibson" userId="907984a6-cd77-4b7d-b1f8-6dfd5dda5862" providerId="ADAL" clId="{161B03EE-95FE-457B-869D-1BF7800899D4}" dt="2021-02-08T00:34:31.952" v="3619" actId="14100"/>
          <ac:cxnSpMkLst>
            <pc:docMk/>
            <pc:sldMk cId="2979487962" sldId="282"/>
            <ac:cxnSpMk id="43" creationId="{AF3FF410-EA7D-42D6-BCE5-583BC6BAAB31}"/>
          </ac:cxnSpMkLst>
        </pc:cxnChg>
        <pc:cxnChg chg="add del mod">
          <ac:chgData name="Amanda Gibson" userId="907984a6-cd77-4b7d-b1f8-6dfd5dda5862" providerId="ADAL" clId="{161B03EE-95FE-457B-869D-1BF7800899D4}" dt="2021-02-08T00:35:01.401" v="3626" actId="478"/>
          <ac:cxnSpMkLst>
            <pc:docMk/>
            <pc:sldMk cId="2979487962" sldId="282"/>
            <ac:cxnSpMk id="45" creationId="{645B1ACC-EBE3-4A33-8A60-9BFA7FF5268B}"/>
          </ac:cxnSpMkLst>
        </pc:cxnChg>
      </pc:sldChg>
      <pc:sldChg chg="addSp delSp modSp add mod ord">
        <pc:chgData name="Amanda Gibson" userId="907984a6-cd77-4b7d-b1f8-6dfd5dda5862" providerId="ADAL" clId="{161B03EE-95FE-457B-869D-1BF7800899D4}" dt="2021-02-08T01:30:22.390" v="5103"/>
        <pc:sldMkLst>
          <pc:docMk/>
          <pc:sldMk cId="367900502" sldId="283"/>
        </pc:sldMkLst>
        <pc:spChg chg="mod">
          <ac:chgData name="Amanda Gibson" userId="907984a6-cd77-4b7d-b1f8-6dfd5dda5862" providerId="ADAL" clId="{161B03EE-95FE-457B-869D-1BF7800899D4}" dt="2021-02-08T00:43:54.998" v="4011" actId="20577"/>
          <ac:spMkLst>
            <pc:docMk/>
            <pc:sldMk cId="367900502" sldId="283"/>
            <ac:spMk id="2" creationId="{28C08DB6-BD44-4401-A786-2D06627D7C16}"/>
          </ac:spMkLst>
        </pc:spChg>
        <pc:spChg chg="mod">
          <ac:chgData name="Amanda Gibson" userId="907984a6-cd77-4b7d-b1f8-6dfd5dda5862" providerId="ADAL" clId="{161B03EE-95FE-457B-869D-1BF7800899D4}" dt="2021-02-08T00:46:15.112" v="4074" actId="207"/>
          <ac:spMkLst>
            <pc:docMk/>
            <pc:sldMk cId="367900502" sldId="283"/>
            <ac:spMk id="37" creationId="{11F4F17E-B198-4662-82B9-FD38C6AFD4A0}"/>
          </ac:spMkLst>
        </pc:spChg>
        <pc:spChg chg="del">
          <ac:chgData name="Amanda Gibson" userId="907984a6-cd77-4b7d-b1f8-6dfd5dda5862" providerId="ADAL" clId="{161B03EE-95FE-457B-869D-1BF7800899D4}" dt="2021-02-08T00:39:10.864" v="3817" actId="478"/>
          <ac:spMkLst>
            <pc:docMk/>
            <pc:sldMk cId="367900502" sldId="283"/>
            <ac:spMk id="40" creationId="{48240F80-D536-4D67-B0E3-0E01F8975809}"/>
          </ac:spMkLst>
        </pc:spChg>
        <pc:spChg chg="add mod">
          <ac:chgData name="Amanda Gibson" userId="907984a6-cd77-4b7d-b1f8-6dfd5dda5862" providerId="ADAL" clId="{161B03EE-95FE-457B-869D-1BF7800899D4}" dt="2021-02-08T00:44:40.979" v="4055" actId="1076"/>
          <ac:spMkLst>
            <pc:docMk/>
            <pc:sldMk cId="367900502" sldId="283"/>
            <ac:spMk id="44" creationId="{78CD0FC1-06AB-42FD-9785-625F60BB71A2}"/>
          </ac:spMkLst>
        </pc:spChg>
        <pc:spChg chg="add mod">
          <ac:chgData name="Amanda Gibson" userId="907984a6-cd77-4b7d-b1f8-6dfd5dda5862" providerId="ADAL" clId="{161B03EE-95FE-457B-869D-1BF7800899D4}" dt="2021-02-08T00:44:46.332" v="4057" actId="1076"/>
          <ac:spMkLst>
            <pc:docMk/>
            <pc:sldMk cId="367900502" sldId="283"/>
            <ac:spMk id="45" creationId="{92234871-3244-4FF0-805D-EF8D613833C0}"/>
          </ac:spMkLst>
        </pc:spChg>
        <pc:spChg chg="del">
          <ac:chgData name="Amanda Gibson" userId="907984a6-cd77-4b7d-b1f8-6dfd5dda5862" providerId="ADAL" clId="{161B03EE-95FE-457B-869D-1BF7800899D4}" dt="2021-02-08T00:39:08.631" v="3816" actId="478"/>
          <ac:spMkLst>
            <pc:docMk/>
            <pc:sldMk cId="367900502" sldId="283"/>
            <ac:spMk id="46" creationId="{78403348-608E-4F87-9FF7-90BB016A23C5}"/>
          </ac:spMkLst>
        </pc:spChg>
        <pc:spChg chg="add mod">
          <ac:chgData name="Amanda Gibson" userId="907984a6-cd77-4b7d-b1f8-6dfd5dda5862" providerId="ADAL" clId="{161B03EE-95FE-457B-869D-1BF7800899D4}" dt="2021-02-08T00:44:56.603" v="4058" actId="571"/>
          <ac:spMkLst>
            <pc:docMk/>
            <pc:sldMk cId="367900502" sldId="283"/>
            <ac:spMk id="47" creationId="{4A851316-A2EF-4C7F-B7F8-CC58BD1D8F2D}"/>
          </ac:spMkLst>
        </pc:spChg>
        <pc:spChg chg="del">
          <ac:chgData name="Amanda Gibson" userId="907984a6-cd77-4b7d-b1f8-6dfd5dda5862" providerId="ADAL" clId="{161B03EE-95FE-457B-869D-1BF7800899D4}" dt="2021-02-08T00:39:08.631" v="3816" actId="478"/>
          <ac:spMkLst>
            <pc:docMk/>
            <pc:sldMk cId="367900502" sldId="283"/>
            <ac:spMk id="49" creationId="{8B6BD669-7569-4BD9-9205-25FEA5B77759}"/>
          </ac:spMkLst>
        </pc:spChg>
        <pc:spChg chg="add mod">
          <ac:chgData name="Amanda Gibson" userId="907984a6-cd77-4b7d-b1f8-6dfd5dda5862" providerId="ADAL" clId="{161B03EE-95FE-457B-869D-1BF7800899D4}" dt="2021-02-08T00:44:59.485" v="4059" actId="571"/>
          <ac:spMkLst>
            <pc:docMk/>
            <pc:sldMk cId="367900502" sldId="283"/>
            <ac:spMk id="50" creationId="{9EBD8EA2-9E07-4A71-B743-9C88F0A86A5B}"/>
          </ac:spMkLst>
        </pc:spChg>
        <pc:spChg chg="del">
          <ac:chgData name="Amanda Gibson" userId="907984a6-cd77-4b7d-b1f8-6dfd5dda5862" providerId="ADAL" clId="{161B03EE-95FE-457B-869D-1BF7800899D4}" dt="2021-02-08T00:44:09.601" v="4013" actId="478"/>
          <ac:spMkLst>
            <pc:docMk/>
            <pc:sldMk cId="367900502" sldId="283"/>
            <ac:spMk id="51" creationId="{03906754-AEBA-47DB-9CE3-4D36DCC2BE59}"/>
          </ac:spMkLst>
        </pc:spChg>
        <pc:spChg chg="del">
          <ac:chgData name="Amanda Gibson" userId="907984a6-cd77-4b7d-b1f8-6dfd5dda5862" providerId="ADAL" clId="{161B03EE-95FE-457B-869D-1BF7800899D4}" dt="2021-02-08T00:44:09.601" v="4013" actId="478"/>
          <ac:spMkLst>
            <pc:docMk/>
            <pc:sldMk cId="367900502" sldId="283"/>
            <ac:spMk id="52" creationId="{0E7759F6-05FA-4506-AD28-84C2C94859BB}"/>
          </ac:spMkLst>
        </pc:spChg>
        <pc:spChg chg="del">
          <ac:chgData name="Amanda Gibson" userId="907984a6-cd77-4b7d-b1f8-6dfd5dda5862" providerId="ADAL" clId="{161B03EE-95FE-457B-869D-1BF7800899D4}" dt="2021-02-08T00:44:04.216" v="4012" actId="478"/>
          <ac:spMkLst>
            <pc:docMk/>
            <pc:sldMk cId="367900502" sldId="283"/>
            <ac:spMk id="55" creationId="{767BBC8B-2E0C-441B-8794-1A194F2E8D8C}"/>
          </ac:spMkLst>
        </pc:spChg>
        <pc:spChg chg="add del mod">
          <ac:chgData name="Amanda Gibson" userId="907984a6-cd77-4b7d-b1f8-6dfd5dda5862" providerId="ADAL" clId="{161B03EE-95FE-457B-869D-1BF7800899D4}" dt="2021-02-08T00:45:13.693" v="4061" actId="478"/>
          <ac:spMkLst>
            <pc:docMk/>
            <pc:sldMk cId="367900502" sldId="283"/>
            <ac:spMk id="57" creationId="{4B254017-30EC-4561-B458-068CC80BC208}"/>
          </ac:spMkLst>
        </pc:spChg>
        <pc:spChg chg="add mod">
          <ac:chgData name="Amanda Gibson" userId="907984a6-cd77-4b7d-b1f8-6dfd5dda5862" providerId="ADAL" clId="{161B03EE-95FE-457B-869D-1BF7800899D4}" dt="2021-02-08T00:45:56.534" v="4063" actId="20577"/>
          <ac:spMkLst>
            <pc:docMk/>
            <pc:sldMk cId="367900502" sldId="283"/>
            <ac:spMk id="58" creationId="{638D959D-6F48-45FD-8320-E292F549EC90}"/>
          </ac:spMkLst>
        </pc:spChg>
        <pc:spChg chg="add mod">
          <ac:chgData name="Amanda Gibson" userId="907984a6-cd77-4b7d-b1f8-6dfd5dda5862" providerId="ADAL" clId="{161B03EE-95FE-457B-869D-1BF7800899D4}" dt="2021-02-08T00:46:42.428" v="4077" actId="1076"/>
          <ac:spMkLst>
            <pc:docMk/>
            <pc:sldMk cId="367900502" sldId="283"/>
            <ac:spMk id="59" creationId="{48ADFD6A-FC11-440E-92B4-44B416C62A0B}"/>
          </ac:spMkLst>
        </pc:spChg>
        <pc:cxnChg chg="del">
          <ac:chgData name="Amanda Gibson" userId="907984a6-cd77-4b7d-b1f8-6dfd5dda5862" providerId="ADAL" clId="{161B03EE-95FE-457B-869D-1BF7800899D4}" dt="2021-02-08T00:39:08.631" v="3816" actId="478"/>
          <ac:cxnSpMkLst>
            <pc:docMk/>
            <pc:sldMk cId="367900502" sldId="283"/>
            <ac:cxnSpMk id="34" creationId="{85073BB6-ABAF-4902-AAA3-55A0094E4DD4}"/>
          </ac:cxnSpMkLst>
        </pc:cxnChg>
        <pc:cxnChg chg="del">
          <ac:chgData name="Amanda Gibson" userId="907984a6-cd77-4b7d-b1f8-6dfd5dda5862" providerId="ADAL" clId="{161B03EE-95FE-457B-869D-1BF7800899D4}" dt="2021-02-08T00:39:12.370" v="3818" actId="478"/>
          <ac:cxnSpMkLst>
            <pc:docMk/>
            <pc:sldMk cId="367900502" sldId="283"/>
            <ac:cxnSpMk id="39" creationId="{4F8200E0-1631-42A9-955E-94D7CD170D71}"/>
          </ac:cxnSpMkLst>
        </pc:cxnChg>
        <pc:cxnChg chg="del">
          <ac:chgData name="Amanda Gibson" userId="907984a6-cd77-4b7d-b1f8-6dfd5dda5862" providerId="ADAL" clId="{161B03EE-95FE-457B-869D-1BF7800899D4}" dt="2021-02-08T00:44:09.601" v="4013" actId="478"/>
          <ac:cxnSpMkLst>
            <pc:docMk/>
            <pc:sldMk cId="367900502" sldId="283"/>
            <ac:cxnSpMk id="41" creationId="{DAD3936B-4228-46A3-A38B-5BA45E6C367E}"/>
          </ac:cxnSpMkLst>
        </pc:cxnChg>
        <pc:cxnChg chg="del">
          <ac:chgData name="Amanda Gibson" userId="907984a6-cd77-4b7d-b1f8-6dfd5dda5862" providerId="ADAL" clId="{161B03EE-95FE-457B-869D-1BF7800899D4}" dt="2021-02-08T00:44:09.601" v="4013" actId="478"/>
          <ac:cxnSpMkLst>
            <pc:docMk/>
            <pc:sldMk cId="367900502" sldId="283"/>
            <ac:cxnSpMk id="42" creationId="{E36C1C09-DD66-466D-8A58-6FE600D21C8E}"/>
          </ac:cxnSpMkLst>
        </pc:cxnChg>
        <pc:cxnChg chg="del">
          <ac:chgData name="Amanda Gibson" userId="907984a6-cd77-4b7d-b1f8-6dfd5dda5862" providerId="ADAL" clId="{161B03EE-95FE-457B-869D-1BF7800899D4}" dt="2021-02-08T00:39:08.631" v="3816" actId="478"/>
          <ac:cxnSpMkLst>
            <pc:docMk/>
            <pc:sldMk cId="367900502" sldId="283"/>
            <ac:cxnSpMk id="43" creationId="{AF3FF410-EA7D-42D6-BCE5-583BC6BAAB31}"/>
          </ac:cxnSpMkLst>
        </pc:cxnChg>
      </pc:sldChg>
      <pc:sldChg chg="addSp delSp modSp add mod ord">
        <pc:chgData name="Amanda Gibson" userId="907984a6-cd77-4b7d-b1f8-6dfd5dda5862" providerId="ADAL" clId="{161B03EE-95FE-457B-869D-1BF7800899D4}" dt="2021-02-08T01:30:22.390" v="5103"/>
        <pc:sldMkLst>
          <pc:docMk/>
          <pc:sldMk cId="1687639029" sldId="284"/>
        </pc:sldMkLst>
        <pc:spChg chg="mod">
          <ac:chgData name="Amanda Gibson" userId="907984a6-cd77-4b7d-b1f8-6dfd5dda5862" providerId="ADAL" clId="{161B03EE-95FE-457B-869D-1BF7800899D4}" dt="2021-02-08T00:50:43.204" v="4216" actId="1076"/>
          <ac:spMkLst>
            <pc:docMk/>
            <pc:sldMk cId="1687639029" sldId="284"/>
            <ac:spMk id="2" creationId="{28C08DB6-BD44-4401-A786-2D06627D7C16}"/>
          </ac:spMkLst>
        </pc:spChg>
        <pc:spChg chg="mod">
          <ac:chgData name="Amanda Gibson" userId="907984a6-cd77-4b7d-b1f8-6dfd5dda5862" providerId="ADAL" clId="{161B03EE-95FE-457B-869D-1BF7800899D4}" dt="2021-02-08T00:51:23.436" v="4270" actId="20577"/>
          <ac:spMkLst>
            <pc:docMk/>
            <pc:sldMk cId="1687639029" sldId="284"/>
            <ac:spMk id="37" creationId="{11F4F17E-B198-4662-82B9-FD38C6AFD4A0}"/>
          </ac:spMkLst>
        </pc:spChg>
        <pc:spChg chg="del">
          <ac:chgData name="Amanda Gibson" userId="907984a6-cd77-4b7d-b1f8-6dfd5dda5862" providerId="ADAL" clId="{161B03EE-95FE-457B-869D-1BF7800899D4}" dt="2021-02-08T00:48:37.899" v="4194" actId="478"/>
          <ac:spMkLst>
            <pc:docMk/>
            <pc:sldMk cId="1687639029" sldId="284"/>
            <ac:spMk id="47" creationId="{F720D460-AE7D-43B2-8729-4BBC48C288C6}"/>
          </ac:spMkLst>
        </pc:spChg>
        <pc:spChg chg="del">
          <ac:chgData name="Amanda Gibson" userId="907984a6-cd77-4b7d-b1f8-6dfd5dda5862" providerId="ADAL" clId="{161B03EE-95FE-457B-869D-1BF7800899D4}" dt="2021-02-08T00:48:31.777" v="4192" actId="478"/>
          <ac:spMkLst>
            <pc:docMk/>
            <pc:sldMk cId="1687639029" sldId="284"/>
            <ac:spMk id="48" creationId="{5BDDB4A8-E648-450E-B96E-F8D4DD553D1E}"/>
          </ac:spMkLst>
        </pc:spChg>
        <pc:spChg chg="del">
          <ac:chgData name="Amanda Gibson" userId="907984a6-cd77-4b7d-b1f8-6dfd5dda5862" providerId="ADAL" clId="{161B03EE-95FE-457B-869D-1BF7800899D4}" dt="2021-02-08T00:48:31.777" v="4192" actId="478"/>
          <ac:spMkLst>
            <pc:docMk/>
            <pc:sldMk cId="1687639029" sldId="284"/>
            <ac:spMk id="49" creationId="{8B6BD669-7569-4BD9-9205-25FEA5B77759}"/>
          </ac:spMkLst>
        </pc:spChg>
        <pc:spChg chg="del">
          <ac:chgData name="Amanda Gibson" userId="907984a6-cd77-4b7d-b1f8-6dfd5dda5862" providerId="ADAL" clId="{161B03EE-95FE-457B-869D-1BF7800899D4}" dt="2021-02-08T00:48:31.777" v="4192" actId="478"/>
          <ac:spMkLst>
            <pc:docMk/>
            <pc:sldMk cId="1687639029" sldId="284"/>
            <ac:spMk id="50" creationId="{ECB5972F-3304-4595-A223-398DC9AA3367}"/>
          </ac:spMkLst>
        </pc:spChg>
        <pc:spChg chg="del">
          <ac:chgData name="Amanda Gibson" userId="907984a6-cd77-4b7d-b1f8-6dfd5dda5862" providerId="ADAL" clId="{161B03EE-95FE-457B-869D-1BF7800899D4}" dt="2021-02-08T00:48:31.777" v="4192" actId="478"/>
          <ac:spMkLst>
            <pc:docMk/>
            <pc:sldMk cId="1687639029" sldId="284"/>
            <ac:spMk id="51" creationId="{03906754-AEBA-47DB-9CE3-4D36DCC2BE59}"/>
          </ac:spMkLst>
        </pc:spChg>
        <pc:spChg chg="del">
          <ac:chgData name="Amanda Gibson" userId="907984a6-cd77-4b7d-b1f8-6dfd5dda5862" providerId="ADAL" clId="{161B03EE-95FE-457B-869D-1BF7800899D4}" dt="2021-02-08T00:48:31.777" v="4192" actId="478"/>
          <ac:spMkLst>
            <pc:docMk/>
            <pc:sldMk cId="1687639029" sldId="284"/>
            <ac:spMk id="52" creationId="{0E7759F6-05FA-4506-AD28-84C2C94859BB}"/>
          </ac:spMkLst>
        </pc:spChg>
        <pc:spChg chg="del">
          <ac:chgData name="Amanda Gibson" userId="907984a6-cd77-4b7d-b1f8-6dfd5dda5862" providerId="ADAL" clId="{161B03EE-95FE-457B-869D-1BF7800899D4}" dt="2021-02-08T00:48:31.777" v="4192" actId="478"/>
          <ac:spMkLst>
            <pc:docMk/>
            <pc:sldMk cId="1687639029" sldId="284"/>
            <ac:spMk id="54" creationId="{16DF88A2-65C8-4A9A-95A3-20EF4B345899}"/>
          </ac:spMkLst>
        </pc:spChg>
        <pc:spChg chg="del">
          <ac:chgData name="Amanda Gibson" userId="907984a6-cd77-4b7d-b1f8-6dfd5dda5862" providerId="ADAL" clId="{161B03EE-95FE-457B-869D-1BF7800899D4}" dt="2021-02-08T00:48:31.777" v="4192" actId="478"/>
          <ac:spMkLst>
            <pc:docMk/>
            <pc:sldMk cId="1687639029" sldId="284"/>
            <ac:spMk id="55" creationId="{767BBC8B-2E0C-441B-8794-1A194F2E8D8C}"/>
          </ac:spMkLst>
        </pc:spChg>
        <pc:spChg chg="del">
          <ac:chgData name="Amanda Gibson" userId="907984a6-cd77-4b7d-b1f8-6dfd5dda5862" providerId="ADAL" clId="{161B03EE-95FE-457B-869D-1BF7800899D4}" dt="2021-02-08T00:48:31.777" v="4192" actId="478"/>
          <ac:spMkLst>
            <pc:docMk/>
            <pc:sldMk cId="1687639029" sldId="284"/>
            <ac:spMk id="69" creationId="{9CB26AC9-A803-4139-B999-2F74AEC0D716}"/>
          </ac:spMkLst>
        </pc:spChg>
        <pc:spChg chg="del">
          <ac:chgData name="Amanda Gibson" userId="907984a6-cd77-4b7d-b1f8-6dfd5dda5862" providerId="ADAL" clId="{161B03EE-95FE-457B-869D-1BF7800899D4}" dt="2021-02-08T00:48:31.777" v="4192" actId="478"/>
          <ac:spMkLst>
            <pc:docMk/>
            <pc:sldMk cId="1687639029" sldId="284"/>
            <ac:spMk id="70" creationId="{B35F54B4-3BF5-4648-BA5F-839B8217BC62}"/>
          </ac:spMkLst>
        </pc:spChg>
        <pc:spChg chg="del">
          <ac:chgData name="Amanda Gibson" userId="907984a6-cd77-4b7d-b1f8-6dfd5dda5862" providerId="ADAL" clId="{161B03EE-95FE-457B-869D-1BF7800899D4}" dt="2021-02-08T00:48:31.777" v="4192" actId="478"/>
          <ac:spMkLst>
            <pc:docMk/>
            <pc:sldMk cId="1687639029" sldId="284"/>
            <ac:spMk id="71" creationId="{089B2115-724F-40EB-9552-97D19D3C03E3}"/>
          </ac:spMkLst>
        </pc:spChg>
        <pc:spChg chg="del">
          <ac:chgData name="Amanda Gibson" userId="907984a6-cd77-4b7d-b1f8-6dfd5dda5862" providerId="ADAL" clId="{161B03EE-95FE-457B-869D-1BF7800899D4}" dt="2021-02-08T00:48:31.777" v="4192" actId="478"/>
          <ac:spMkLst>
            <pc:docMk/>
            <pc:sldMk cId="1687639029" sldId="284"/>
            <ac:spMk id="72" creationId="{CF8821E0-4EEE-465E-8798-BFB4F5C8DC2D}"/>
          </ac:spMkLst>
        </pc:spChg>
        <pc:spChg chg="add del mod">
          <ac:chgData name="Amanda Gibson" userId="907984a6-cd77-4b7d-b1f8-6dfd5dda5862" providerId="ADAL" clId="{161B03EE-95FE-457B-869D-1BF7800899D4}" dt="2021-02-08T00:50:29.595" v="4211" actId="478"/>
          <ac:spMkLst>
            <pc:docMk/>
            <pc:sldMk cId="1687639029" sldId="284"/>
            <ac:spMk id="77" creationId="{5DF3B91C-E240-4100-BA7F-AA458AAAF7E7}"/>
          </ac:spMkLst>
        </pc:spChg>
        <pc:spChg chg="add mod">
          <ac:chgData name="Amanda Gibson" userId="907984a6-cd77-4b7d-b1f8-6dfd5dda5862" providerId="ADAL" clId="{161B03EE-95FE-457B-869D-1BF7800899D4}" dt="2021-02-08T00:48:51.392" v="4195"/>
          <ac:spMkLst>
            <pc:docMk/>
            <pc:sldMk cId="1687639029" sldId="284"/>
            <ac:spMk id="78" creationId="{0E8A473B-7FA7-41EA-AA50-EEA7AE38B320}"/>
          </ac:spMkLst>
        </pc:spChg>
        <pc:spChg chg="add del mod">
          <ac:chgData name="Amanda Gibson" userId="907984a6-cd77-4b7d-b1f8-6dfd5dda5862" providerId="ADAL" clId="{161B03EE-95FE-457B-869D-1BF7800899D4}" dt="2021-02-08T00:50:29.595" v="4211" actId="478"/>
          <ac:spMkLst>
            <pc:docMk/>
            <pc:sldMk cId="1687639029" sldId="284"/>
            <ac:spMk id="79" creationId="{4B2C4B47-2998-41A4-BA99-F5B1023400F4}"/>
          </ac:spMkLst>
        </pc:spChg>
        <pc:spChg chg="add mod">
          <ac:chgData name="Amanda Gibson" userId="907984a6-cd77-4b7d-b1f8-6dfd5dda5862" providerId="ADAL" clId="{161B03EE-95FE-457B-869D-1BF7800899D4}" dt="2021-02-08T00:48:51.392" v="4195"/>
          <ac:spMkLst>
            <pc:docMk/>
            <pc:sldMk cId="1687639029" sldId="284"/>
            <ac:spMk id="80" creationId="{D72A0772-79B8-43B2-8FED-CAFDF2A93F8E}"/>
          </ac:spMkLst>
        </pc:spChg>
        <pc:spChg chg="add del mod">
          <ac:chgData name="Amanda Gibson" userId="907984a6-cd77-4b7d-b1f8-6dfd5dda5862" providerId="ADAL" clId="{161B03EE-95FE-457B-869D-1BF7800899D4}" dt="2021-02-08T00:50:38.738" v="4213" actId="478"/>
          <ac:spMkLst>
            <pc:docMk/>
            <pc:sldMk cId="1687639029" sldId="284"/>
            <ac:spMk id="81" creationId="{3C5E1DD6-62BF-4AAF-AC42-AA8B9E79E589}"/>
          </ac:spMkLst>
        </pc:spChg>
        <pc:spChg chg="del">
          <ac:chgData name="Amanda Gibson" userId="907984a6-cd77-4b7d-b1f8-6dfd5dda5862" providerId="ADAL" clId="{161B03EE-95FE-457B-869D-1BF7800899D4}" dt="2021-02-08T00:48:31.777" v="4192" actId="478"/>
          <ac:spMkLst>
            <pc:docMk/>
            <pc:sldMk cId="1687639029" sldId="284"/>
            <ac:spMk id="82" creationId="{71266F89-E78D-4096-930C-0FE7CCFEE445}"/>
          </ac:spMkLst>
        </pc:spChg>
        <pc:spChg chg="del">
          <ac:chgData name="Amanda Gibson" userId="907984a6-cd77-4b7d-b1f8-6dfd5dda5862" providerId="ADAL" clId="{161B03EE-95FE-457B-869D-1BF7800899D4}" dt="2021-02-08T00:48:31.777" v="4192" actId="478"/>
          <ac:spMkLst>
            <pc:docMk/>
            <pc:sldMk cId="1687639029" sldId="284"/>
            <ac:spMk id="83" creationId="{1944A02E-85F4-4174-BA79-16515F18AE10}"/>
          </ac:spMkLst>
        </pc:spChg>
        <pc:spChg chg="del">
          <ac:chgData name="Amanda Gibson" userId="907984a6-cd77-4b7d-b1f8-6dfd5dda5862" providerId="ADAL" clId="{161B03EE-95FE-457B-869D-1BF7800899D4}" dt="2021-02-08T00:48:31.777" v="4192" actId="478"/>
          <ac:spMkLst>
            <pc:docMk/>
            <pc:sldMk cId="1687639029" sldId="284"/>
            <ac:spMk id="84" creationId="{22D67E9D-5062-4A87-A030-A820008E3850}"/>
          </ac:spMkLst>
        </pc:spChg>
        <pc:spChg chg="del">
          <ac:chgData name="Amanda Gibson" userId="907984a6-cd77-4b7d-b1f8-6dfd5dda5862" providerId="ADAL" clId="{161B03EE-95FE-457B-869D-1BF7800899D4}" dt="2021-02-08T00:48:31.777" v="4192" actId="478"/>
          <ac:spMkLst>
            <pc:docMk/>
            <pc:sldMk cId="1687639029" sldId="284"/>
            <ac:spMk id="85" creationId="{359C128B-6D73-42B9-933D-679813012B6B}"/>
          </ac:spMkLst>
        </pc:spChg>
        <pc:spChg chg="del">
          <ac:chgData name="Amanda Gibson" userId="907984a6-cd77-4b7d-b1f8-6dfd5dda5862" providerId="ADAL" clId="{161B03EE-95FE-457B-869D-1BF7800899D4}" dt="2021-02-08T00:48:31.777" v="4192" actId="478"/>
          <ac:spMkLst>
            <pc:docMk/>
            <pc:sldMk cId="1687639029" sldId="284"/>
            <ac:spMk id="86" creationId="{742A3144-C6B4-46BE-93AE-D1A8B320876D}"/>
          </ac:spMkLst>
        </pc:spChg>
        <pc:spChg chg="del">
          <ac:chgData name="Amanda Gibson" userId="907984a6-cd77-4b7d-b1f8-6dfd5dda5862" providerId="ADAL" clId="{161B03EE-95FE-457B-869D-1BF7800899D4}" dt="2021-02-08T00:48:31.777" v="4192" actId="478"/>
          <ac:spMkLst>
            <pc:docMk/>
            <pc:sldMk cId="1687639029" sldId="284"/>
            <ac:spMk id="87" creationId="{AF44DBA4-9024-49AF-8F00-134BE9E470C0}"/>
          </ac:spMkLst>
        </pc:spChg>
        <pc:spChg chg="del">
          <ac:chgData name="Amanda Gibson" userId="907984a6-cd77-4b7d-b1f8-6dfd5dda5862" providerId="ADAL" clId="{161B03EE-95FE-457B-869D-1BF7800899D4}" dt="2021-02-08T00:48:31.777" v="4192" actId="478"/>
          <ac:spMkLst>
            <pc:docMk/>
            <pc:sldMk cId="1687639029" sldId="284"/>
            <ac:spMk id="88" creationId="{3CCD7D92-4DAA-40EA-97F9-DF5BF51CCACC}"/>
          </ac:spMkLst>
        </pc:spChg>
        <pc:spChg chg="add del mod">
          <ac:chgData name="Amanda Gibson" userId="907984a6-cd77-4b7d-b1f8-6dfd5dda5862" providerId="ADAL" clId="{161B03EE-95FE-457B-869D-1BF7800899D4}" dt="2021-02-08T00:50:34.330" v="4212" actId="478"/>
          <ac:spMkLst>
            <pc:docMk/>
            <pc:sldMk cId="1687639029" sldId="284"/>
            <ac:spMk id="89" creationId="{2C06F59D-32B7-4EE4-83F7-FEAD51B4AE3B}"/>
          </ac:spMkLst>
        </pc:spChg>
        <pc:spChg chg="add del mod">
          <ac:chgData name="Amanda Gibson" userId="907984a6-cd77-4b7d-b1f8-6dfd5dda5862" providerId="ADAL" clId="{161B03EE-95FE-457B-869D-1BF7800899D4}" dt="2021-02-08T00:50:34.330" v="4212" actId="478"/>
          <ac:spMkLst>
            <pc:docMk/>
            <pc:sldMk cId="1687639029" sldId="284"/>
            <ac:spMk id="90" creationId="{FD6BB131-907D-4B47-B2D0-F5B5BE928107}"/>
          </ac:spMkLst>
        </pc:spChg>
        <pc:spChg chg="add del mod">
          <ac:chgData name="Amanda Gibson" userId="907984a6-cd77-4b7d-b1f8-6dfd5dda5862" providerId="ADAL" clId="{161B03EE-95FE-457B-869D-1BF7800899D4}" dt="2021-02-08T00:50:34.330" v="4212" actId="478"/>
          <ac:spMkLst>
            <pc:docMk/>
            <pc:sldMk cId="1687639029" sldId="284"/>
            <ac:spMk id="91" creationId="{40304DA5-1BC9-4559-9466-8C58E78B4581}"/>
          </ac:spMkLst>
        </pc:spChg>
        <pc:spChg chg="add mod">
          <ac:chgData name="Amanda Gibson" userId="907984a6-cd77-4b7d-b1f8-6dfd5dda5862" providerId="ADAL" clId="{161B03EE-95FE-457B-869D-1BF7800899D4}" dt="2021-02-08T00:48:51.392" v="4195"/>
          <ac:spMkLst>
            <pc:docMk/>
            <pc:sldMk cId="1687639029" sldId="284"/>
            <ac:spMk id="92" creationId="{BEDD4B03-A226-4C42-85D7-72498DE81B2B}"/>
          </ac:spMkLst>
        </pc:spChg>
        <pc:spChg chg="add del mod">
          <ac:chgData name="Amanda Gibson" userId="907984a6-cd77-4b7d-b1f8-6dfd5dda5862" providerId="ADAL" clId="{161B03EE-95FE-457B-869D-1BF7800899D4}" dt="2021-02-08T00:50:29.595" v="4211" actId="478"/>
          <ac:spMkLst>
            <pc:docMk/>
            <pc:sldMk cId="1687639029" sldId="284"/>
            <ac:spMk id="93" creationId="{B6FE48B9-2CD4-4F8D-92F0-47AA9FFFE6E3}"/>
          </ac:spMkLst>
        </pc:spChg>
        <pc:spChg chg="add mod">
          <ac:chgData name="Amanda Gibson" userId="907984a6-cd77-4b7d-b1f8-6dfd5dda5862" providerId="ADAL" clId="{161B03EE-95FE-457B-869D-1BF7800899D4}" dt="2021-02-08T00:48:51.392" v="4195"/>
          <ac:spMkLst>
            <pc:docMk/>
            <pc:sldMk cId="1687639029" sldId="284"/>
            <ac:spMk id="94" creationId="{34D1A363-E768-43A3-95F2-693699E568D9}"/>
          </ac:spMkLst>
        </pc:spChg>
        <pc:spChg chg="add del mod">
          <ac:chgData name="Amanda Gibson" userId="907984a6-cd77-4b7d-b1f8-6dfd5dda5862" providerId="ADAL" clId="{161B03EE-95FE-457B-869D-1BF7800899D4}" dt="2021-02-08T00:50:45.775" v="4217" actId="478"/>
          <ac:spMkLst>
            <pc:docMk/>
            <pc:sldMk cId="1687639029" sldId="284"/>
            <ac:spMk id="95" creationId="{0814DEB3-43AA-4EC0-B4A8-FFB26FF3F73D}"/>
          </ac:spMkLst>
        </pc:spChg>
        <pc:spChg chg="add del mod">
          <ac:chgData name="Amanda Gibson" userId="907984a6-cd77-4b7d-b1f8-6dfd5dda5862" providerId="ADAL" clId="{161B03EE-95FE-457B-869D-1BF7800899D4}" dt="2021-02-08T00:50:41.267" v="4214" actId="478"/>
          <ac:spMkLst>
            <pc:docMk/>
            <pc:sldMk cId="1687639029" sldId="284"/>
            <ac:spMk id="96" creationId="{4229B05F-0484-4DC8-A924-DCBBFBB9BB08}"/>
          </ac:spMkLst>
        </pc:spChg>
        <pc:spChg chg="add del mod">
          <ac:chgData name="Amanda Gibson" userId="907984a6-cd77-4b7d-b1f8-6dfd5dda5862" providerId="ADAL" clId="{161B03EE-95FE-457B-869D-1BF7800899D4}" dt="2021-02-08T00:50:52.283" v="4218" actId="478"/>
          <ac:spMkLst>
            <pc:docMk/>
            <pc:sldMk cId="1687639029" sldId="284"/>
            <ac:spMk id="97" creationId="{D89D1E4B-3251-4EB3-ABD4-3C2416DED1E1}"/>
          </ac:spMkLst>
        </pc:spChg>
        <pc:spChg chg="add mod">
          <ac:chgData name="Amanda Gibson" userId="907984a6-cd77-4b7d-b1f8-6dfd5dda5862" providerId="ADAL" clId="{161B03EE-95FE-457B-869D-1BF7800899D4}" dt="2021-02-08T00:48:51.392" v="4195"/>
          <ac:spMkLst>
            <pc:docMk/>
            <pc:sldMk cId="1687639029" sldId="284"/>
            <ac:spMk id="98" creationId="{F062F86A-765C-40A4-8D50-37C65FD1C748}"/>
          </ac:spMkLst>
        </pc:spChg>
        <pc:spChg chg="add del mod">
          <ac:chgData name="Amanda Gibson" userId="907984a6-cd77-4b7d-b1f8-6dfd5dda5862" providerId="ADAL" clId="{161B03EE-95FE-457B-869D-1BF7800899D4}" dt="2021-02-08T00:50:29.595" v="4211" actId="478"/>
          <ac:spMkLst>
            <pc:docMk/>
            <pc:sldMk cId="1687639029" sldId="284"/>
            <ac:spMk id="99" creationId="{24310EE3-B881-49FF-B807-1D900CD73108}"/>
          </ac:spMkLst>
        </pc:spChg>
        <pc:spChg chg="add mod">
          <ac:chgData name="Amanda Gibson" userId="907984a6-cd77-4b7d-b1f8-6dfd5dda5862" providerId="ADAL" clId="{161B03EE-95FE-457B-869D-1BF7800899D4}" dt="2021-02-08T00:48:51.392" v="4195"/>
          <ac:spMkLst>
            <pc:docMk/>
            <pc:sldMk cId="1687639029" sldId="284"/>
            <ac:spMk id="100" creationId="{A6489FAD-13A8-4BD6-86F3-22737223A8BF}"/>
          </ac:spMkLst>
        </pc:spChg>
        <pc:spChg chg="add del mod">
          <ac:chgData name="Amanda Gibson" userId="907984a6-cd77-4b7d-b1f8-6dfd5dda5862" providerId="ADAL" clId="{161B03EE-95FE-457B-869D-1BF7800899D4}" dt="2021-02-08T00:50:52.283" v="4218" actId="478"/>
          <ac:spMkLst>
            <pc:docMk/>
            <pc:sldMk cId="1687639029" sldId="284"/>
            <ac:spMk id="101" creationId="{D4E7D7E7-35BF-4A98-A18E-014D321C1968}"/>
          </ac:spMkLst>
        </pc:spChg>
        <pc:spChg chg="add del mod">
          <ac:chgData name="Amanda Gibson" userId="907984a6-cd77-4b7d-b1f8-6dfd5dda5862" providerId="ADAL" clId="{161B03EE-95FE-457B-869D-1BF7800899D4}" dt="2021-02-08T00:50:52.283" v="4218" actId="478"/>
          <ac:spMkLst>
            <pc:docMk/>
            <pc:sldMk cId="1687639029" sldId="284"/>
            <ac:spMk id="102" creationId="{8F6870F1-3BB6-4422-A80D-613C60E82CFB}"/>
          </ac:spMkLst>
        </pc:spChg>
        <pc:spChg chg="add mod">
          <ac:chgData name="Amanda Gibson" userId="907984a6-cd77-4b7d-b1f8-6dfd5dda5862" providerId="ADAL" clId="{161B03EE-95FE-457B-869D-1BF7800899D4}" dt="2021-02-08T00:49:01.372" v="4196"/>
          <ac:spMkLst>
            <pc:docMk/>
            <pc:sldMk cId="1687639029" sldId="284"/>
            <ac:spMk id="103" creationId="{D0A17C3F-26E9-4AC4-9957-CCE77D81134C}"/>
          </ac:spMkLst>
        </pc:spChg>
        <pc:spChg chg="add mod">
          <ac:chgData name="Amanda Gibson" userId="907984a6-cd77-4b7d-b1f8-6dfd5dda5862" providerId="ADAL" clId="{161B03EE-95FE-457B-869D-1BF7800899D4}" dt="2021-02-08T00:49:48.036" v="4204" actId="1076"/>
          <ac:spMkLst>
            <pc:docMk/>
            <pc:sldMk cId="1687639029" sldId="284"/>
            <ac:spMk id="104" creationId="{99E6E7B1-C41A-474E-A32C-5C2B168B28FB}"/>
          </ac:spMkLst>
        </pc:spChg>
        <pc:spChg chg="add mod">
          <ac:chgData name="Amanda Gibson" userId="907984a6-cd77-4b7d-b1f8-6dfd5dda5862" providerId="ADAL" clId="{161B03EE-95FE-457B-869D-1BF7800899D4}" dt="2021-02-08T00:50:08.826" v="4209" actId="1076"/>
          <ac:spMkLst>
            <pc:docMk/>
            <pc:sldMk cId="1687639029" sldId="284"/>
            <ac:spMk id="105" creationId="{ACB24AA2-4FE3-4FEA-AED5-53B5530494F6}"/>
          </ac:spMkLst>
        </pc:spChg>
        <pc:spChg chg="add mod">
          <ac:chgData name="Amanda Gibson" userId="907984a6-cd77-4b7d-b1f8-6dfd5dda5862" providerId="ADAL" clId="{161B03EE-95FE-457B-869D-1BF7800899D4}" dt="2021-02-08T00:50:00.743" v="4207" actId="571"/>
          <ac:spMkLst>
            <pc:docMk/>
            <pc:sldMk cId="1687639029" sldId="284"/>
            <ac:spMk id="125" creationId="{1263F12C-66A6-4E1F-ABD6-2137749FBEDC}"/>
          </ac:spMkLst>
        </pc:spChg>
        <pc:spChg chg="add mod">
          <ac:chgData name="Amanda Gibson" userId="907984a6-cd77-4b7d-b1f8-6dfd5dda5862" providerId="ADAL" clId="{161B03EE-95FE-457B-869D-1BF7800899D4}" dt="2021-02-08T00:50:00.743" v="4207" actId="571"/>
          <ac:spMkLst>
            <pc:docMk/>
            <pc:sldMk cId="1687639029" sldId="284"/>
            <ac:spMk id="126" creationId="{7E4DF9A6-5A34-4EC6-9CA1-C958539A6D02}"/>
          </ac:spMkLst>
        </pc:spChg>
        <pc:spChg chg="add mod">
          <ac:chgData name="Amanda Gibson" userId="907984a6-cd77-4b7d-b1f8-6dfd5dda5862" providerId="ADAL" clId="{161B03EE-95FE-457B-869D-1BF7800899D4}" dt="2021-02-08T00:50:00.743" v="4207" actId="571"/>
          <ac:spMkLst>
            <pc:docMk/>
            <pc:sldMk cId="1687639029" sldId="284"/>
            <ac:spMk id="127" creationId="{D4E7A91F-26D1-4ABA-91CA-7C1B2484DE36}"/>
          </ac:spMkLst>
        </pc:spChg>
        <pc:cxnChg chg="del">
          <ac:chgData name="Amanda Gibson" userId="907984a6-cd77-4b7d-b1f8-6dfd5dda5862" providerId="ADAL" clId="{161B03EE-95FE-457B-869D-1BF7800899D4}" dt="2021-02-08T00:48:35.659" v="4193" actId="478"/>
          <ac:cxnSpMkLst>
            <pc:docMk/>
            <pc:sldMk cId="1687639029" sldId="284"/>
            <ac:cxnSpMk id="32" creationId="{9615E0FF-C953-446C-AB32-AB262B8CDFF7}"/>
          </ac:cxnSpMkLst>
        </pc:cxnChg>
        <pc:cxnChg chg="del">
          <ac:chgData name="Amanda Gibson" userId="907984a6-cd77-4b7d-b1f8-6dfd5dda5862" providerId="ADAL" clId="{161B03EE-95FE-457B-869D-1BF7800899D4}" dt="2021-02-08T00:48:35.659" v="4193" actId="478"/>
          <ac:cxnSpMkLst>
            <pc:docMk/>
            <pc:sldMk cId="1687639029" sldId="284"/>
            <ac:cxnSpMk id="34" creationId="{85073BB6-ABAF-4902-AAA3-55A0094E4DD4}"/>
          </ac:cxnSpMkLst>
        </pc:cxnChg>
        <pc:cxnChg chg="del">
          <ac:chgData name="Amanda Gibson" userId="907984a6-cd77-4b7d-b1f8-6dfd5dda5862" providerId="ADAL" clId="{161B03EE-95FE-457B-869D-1BF7800899D4}" dt="2021-02-08T00:48:35.659" v="4193" actId="478"/>
          <ac:cxnSpMkLst>
            <pc:docMk/>
            <pc:sldMk cId="1687639029" sldId="284"/>
            <ac:cxnSpMk id="36" creationId="{90C87663-491B-4516-AA66-0E82ACAC0ABF}"/>
          </ac:cxnSpMkLst>
        </pc:cxnChg>
        <pc:cxnChg chg="add del mod">
          <ac:chgData name="Amanda Gibson" userId="907984a6-cd77-4b7d-b1f8-6dfd5dda5862" providerId="ADAL" clId="{161B03EE-95FE-457B-869D-1BF7800899D4}" dt="2021-02-08T00:50:20.691" v="4210" actId="478"/>
          <ac:cxnSpMkLst>
            <pc:docMk/>
            <pc:sldMk cId="1687639029" sldId="284"/>
            <ac:cxnSpMk id="39" creationId="{F84152DF-9261-4CDC-BCC4-3788D79A8A25}"/>
          </ac:cxnSpMkLst>
        </pc:cxnChg>
        <pc:cxnChg chg="add del mod">
          <ac:chgData name="Amanda Gibson" userId="907984a6-cd77-4b7d-b1f8-6dfd5dda5862" providerId="ADAL" clId="{161B03EE-95FE-457B-869D-1BF7800899D4}" dt="2021-02-08T00:50:20.691" v="4210" actId="478"/>
          <ac:cxnSpMkLst>
            <pc:docMk/>
            <pc:sldMk cId="1687639029" sldId="284"/>
            <ac:cxnSpMk id="40" creationId="{B94B7753-05E8-40A6-9CC9-578A6BEEB7F6}"/>
          </ac:cxnSpMkLst>
        </pc:cxnChg>
        <pc:cxnChg chg="del">
          <ac:chgData name="Amanda Gibson" userId="907984a6-cd77-4b7d-b1f8-6dfd5dda5862" providerId="ADAL" clId="{161B03EE-95FE-457B-869D-1BF7800899D4}" dt="2021-02-08T00:48:31.777" v="4192" actId="478"/>
          <ac:cxnSpMkLst>
            <pc:docMk/>
            <pc:sldMk cId="1687639029" sldId="284"/>
            <ac:cxnSpMk id="41" creationId="{DAD3936B-4228-46A3-A38B-5BA45E6C367E}"/>
          </ac:cxnSpMkLst>
        </pc:cxnChg>
        <pc:cxnChg chg="del">
          <ac:chgData name="Amanda Gibson" userId="907984a6-cd77-4b7d-b1f8-6dfd5dda5862" providerId="ADAL" clId="{161B03EE-95FE-457B-869D-1BF7800899D4}" dt="2021-02-08T00:48:31.777" v="4192" actId="478"/>
          <ac:cxnSpMkLst>
            <pc:docMk/>
            <pc:sldMk cId="1687639029" sldId="284"/>
            <ac:cxnSpMk id="42" creationId="{E36C1C09-DD66-466D-8A58-6FE600D21C8E}"/>
          </ac:cxnSpMkLst>
        </pc:cxnChg>
        <pc:cxnChg chg="add del mod">
          <ac:chgData name="Amanda Gibson" userId="907984a6-cd77-4b7d-b1f8-6dfd5dda5862" providerId="ADAL" clId="{161B03EE-95FE-457B-869D-1BF7800899D4}" dt="2021-02-08T00:50:20.691" v="4210" actId="478"/>
          <ac:cxnSpMkLst>
            <pc:docMk/>
            <pc:sldMk cId="1687639029" sldId="284"/>
            <ac:cxnSpMk id="43" creationId="{260BD297-F70E-4617-9B73-66BE9C26B1E2}"/>
          </ac:cxnSpMkLst>
        </pc:cxnChg>
        <pc:cxnChg chg="add del mod">
          <ac:chgData name="Amanda Gibson" userId="907984a6-cd77-4b7d-b1f8-6dfd5dda5862" providerId="ADAL" clId="{161B03EE-95FE-457B-869D-1BF7800899D4}" dt="2021-02-08T00:50:20.691" v="4210" actId="478"/>
          <ac:cxnSpMkLst>
            <pc:docMk/>
            <pc:sldMk cId="1687639029" sldId="284"/>
            <ac:cxnSpMk id="44" creationId="{19D85D5A-2142-42B3-906E-D6297C6A5132}"/>
          </ac:cxnSpMkLst>
        </pc:cxnChg>
        <pc:cxnChg chg="add del mod">
          <ac:chgData name="Amanda Gibson" userId="907984a6-cd77-4b7d-b1f8-6dfd5dda5862" providerId="ADAL" clId="{161B03EE-95FE-457B-869D-1BF7800899D4}" dt="2021-02-08T00:50:20.691" v="4210" actId="478"/>
          <ac:cxnSpMkLst>
            <pc:docMk/>
            <pc:sldMk cId="1687639029" sldId="284"/>
            <ac:cxnSpMk id="45" creationId="{F5F8394D-7477-4DFD-BE3F-4B6F7F2FDB94}"/>
          </ac:cxnSpMkLst>
        </pc:cxnChg>
        <pc:cxnChg chg="add del mod">
          <ac:chgData name="Amanda Gibson" userId="907984a6-cd77-4b7d-b1f8-6dfd5dda5862" providerId="ADAL" clId="{161B03EE-95FE-457B-869D-1BF7800899D4}" dt="2021-02-08T00:50:20.691" v="4210" actId="478"/>
          <ac:cxnSpMkLst>
            <pc:docMk/>
            <pc:sldMk cId="1687639029" sldId="284"/>
            <ac:cxnSpMk id="46" creationId="{CEF809ED-E91B-431C-8FF4-B3FCD5FC5AED}"/>
          </ac:cxnSpMkLst>
        </pc:cxnChg>
        <pc:cxnChg chg="del">
          <ac:chgData name="Amanda Gibson" userId="907984a6-cd77-4b7d-b1f8-6dfd5dda5862" providerId="ADAL" clId="{161B03EE-95FE-457B-869D-1BF7800899D4}" dt="2021-02-08T00:48:31.777" v="4192" actId="478"/>
          <ac:cxnSpMkLst>
            <pc:docMk/>
            <pc:sldMk cId="1687639029" sldId="284"/>
            <ac:cxnSpMk id="53" creationId="{DA4046F3-1FF5-4AF0-89FB-2C774766A340}"/>
          </ac:cxnSpMkLst>
        </pc:cxnChg>
        <pc:cxnChg chg="del">
          <ac:chgData name="Amanda Gibson" userId="907984a6-cd77-4b7d-b1f8-6dfd5dda5862" providerId="ADAL" clId="{161B03EE-95FE-457B-869D-1BF7800899D4}" dt="2021-02-08T00:48:31.777" v="4192" actId="478"/>
          <ac:cxnSpMkLst>
            <pc:docMk/>
            <pc:sldMk cId="1687639029" sldId="284"/>
            <ac:cxnSpMk id="56" creationId="{4E2FA796-806A-4296-8581-DFC3A22ECA86}"/>
          </ac:cxnSpMkLst>
        </pc:cxnChg>
        <pc:cxnChg chg="add del mod">
          <ac:chgData name="Amanda Gibson" userId="907984a6-cd77-4b7d-b1f8-6dfd5dda5862" providerId="ADAL" clId="{161B03EE-95FE-457B-869D-1BF7800899D4}" dt="2021-02-08T00:50:20.691" v="4210" actId="478"/>
          <ac:cxnSpMkLst>
            <pc:docMk/>
            <pc:sldMk cId="1687639029" sldId="284"/>
            <ac:cxnSpMk id="57" creationId="{BDDA7564-BECA-42F0-9D0D-E778217CBD37}"/>
          </ac:cxnSpMkLst>
        </pc:cxnChg>
        <pc:cxnChg chg="add del mod">
          <ac:chgData name="Amanda Gibson" userId="907984a6-cd77-4b7d-b1f8-6dfd5dda5862" providerId="ADAL" clId="{161B03EE-95FE-457B-869D-1BF7800899D4}" dt="2021-02-08T00:50:20.691" v="4210" actId="478"/>
          <ac:cxnSpMkLst>
            <pc:docMk/>
            <pc:sldMk cId="1687639029" sldId="284"/>
            <ac:cxnSpMk id="58" creationId="{4F3F9AE7-A643-4055-82FB-FABEA4132503}"/>
          </ac:cxnSpMkLst>
        </pc:cxnChg>
        <pc:cxnChg chg="add del mod">
          <ac:chgData name="Amanda Gibson" userId="907984a6-cd77-4b7d-b1f8-6dfd5dda5862" providerId="ADAL" clId="{161B03EE-95FE-457B-869D-1BF7800899D4}" dt="2021-02-08T00:50:20.691" v="4210" actId="478"/>
          <ac:cxnSpMkLst>
            <pc:docMk/>
            <pc:sldMk cId="1687639029" sldId="284"/>
            <ac:cxnSpMk id="59" creationId="{54202A2E-30D0-41F6-B9CF-0E31B9692A3C}"/>
          </ac:cxnSpMkLst>
        </pc:cxnChg>
        <pc:cxnChg chg="add del mod">
          <ac:chgData name="Amanda Gibson" userId="907984a6-cd77-4b7d-b1f8-6dfd5dda5862" providerId="ADAL" clId="{161B03EE-95FE-457B-869D-1BF7800899D4}" dt="2021-02-08T00:50:20.691" v="4210" actId="478"/>
          <ac:cxnSpMkLst>
            <pc:docMk/>
            <pc:sldMk cId="1687639029" sldId="284"/>
            <ac:cxnSpMk id="60" creationId="{11D4878C-C31C-4966-B2C0-EE5EC7C12400}"/>
          </ac:cxnSpMkLst>
        </pc:cxnChg>
        <pc:cxnChg chg="del">
          <ac:chgData name="Amanda Gibson" userId="907984a6-cd77-4b7d-b1f8-6dfd5dda5862" providerId="ADAL" clId="{161B03EE-95FE-457B-869D-1BF7800899D4}" dt="2021-02-08T00:48:31.777" v="4192" actId="478"/>
          <ac:cxnSpMkLst>
            <pc:docMk/>
            <pc:sldMk cId="1687639029" sldId="284"/>
            <ac:cxnSpMk id="61" creationId="{498CE6F1-5676-4D21-911C-31707F403203}"/>
          </ac:cxnSpMkLst>
        </pc:cxnChg>
        <pc:cxnChg chg="add del mod">
          <ac:chgData name="Amanda Gibson" userId="907984a6-cd77-4b7d-b1f8-6dfd5dda5862" providerId="ADAL" clId="{161B03EE-95FE-457B-869D-1BF7800899D4}" dt="2021-02-08T00:50:20.691" v="4210" actId="478"/>
          <ac:cxnSpMkLst>
            <pc:docMk/>
            <pc:sldMk cId="1687639029" sldId="284"/>
            <ac:cxnSpMk id="62" creationId="{CF9DD923-B015-4CE3-88FD-B3CEA68AB081}"/>
          </ac:cxnSpMkLst>
        </pc:cxnChg>
        <pc:cxnChg chg="add del mod">
          <ac:chgData name="Amanda Gibson" userId="907984a6-cd77-4b7d-b1f8-6dfd5dda5862" providerId="ADAL" clId="{161B03EE-95FE-457B-869D-1BF7800899D4}" dt="2021-02-08T00:50:20.691" v="4210" actId="478"/>
          <ac:cxnSpMkLst>
            <pc:docMk/>
            <pc:sldMk cId="1687639029" sldId="284"/>
            <ac:cxnSpMk id="63" creationId="{7FD15E16-3D80-43DB-B725-4FE7114BA504}"/>
          </ac:cxnSpMkLst>
        </pc:cxnChg>
        <pc:cxnChg chg="del">
          <ac:chgData name="Amanda Gibson" userId="907984a6-cd77-4b7d-b1f8-6dfd5dda5862" providerId="ADAL" clId="{161B03EE-95FE-457B-869D-1BF7800899D4}" dt="2021-02-08T00:48:31.777" v="4192" actId="478"/>
          <ac:cxnSpMkLst>
            <pc:docMk/>
            <pc:sldMk cId="1687639029" sldId="284"/>
            <ac:cxnSpMk id="64" creationId="{70430FA3-15C3-4ACC-B736-B019C8C1BE3F}"/>
          </ac:cxnSpMkLst>
        </pc:cxnChg>
        <pc:cxnChg chg="add del mod">
          <ac:chgData name="Amanda Gibson" userId="907984a6-cd77-4b7d-b1f8-6dfd5dda5862" providerId="ADAL" clId="{161B03EE-95FE-457B-869D-1BF7800899D4}" dt="2021-02-08T00:50:20.691" v="4210" actId="478"/>
          <ac:cxnSpMkLst>
            <pc:docMk/>
            <pc:sldMk cId="1687639029" sldId="284"/>
            <ac:cxnSpMk id="65" creationId="{90A0EFFE-9788-4744-A24C-3A893BBD0E33}"/>
          </ac:cxnSpMkLst>
        </pc:cxnChg>
        <pc:cxnChg chg="add del mod">
          <ac:chgData name="Amanda Gibson" userId="907984a6-cd77-4b7d-b1f8-6dfd5dda5862" providerId="ADAL" clId="{161B03EE-95FE-457B-869D-1BF7800899D4}" dt="2021-02-08T00:50:20.691" v="4210" actId="478"/>
          <ac:cxnSpMkLst>
            <pc:docMk/>
            <pc:sldMk cId="1687639029" sldId="284"/>
            <ac:cxnSpMk id="66" creationId="{AC01FD25-D902-42E1-9A25-F2577B805323}"/>
          </ac:cxnSpMkLst>
        </pc:cxnChg>
        <pc:cxnChg chg="add del mod">
          <ac:chgData name="Amanda Gibson" userId="907984a6-cd77-4b7d-b1f8-6dfd5dda5862" providerId="ADAL" clId="{161B03EE-95FE-457B-869D-1BF7800899D4}" dt="2021-02-08T00:50:20.691" v="4210" actId="478"/>
          <ac:cxnSpMkLst>
            <pc:docMk/>
            <pc:sldMk cId="1687639029" sldId="284"/>
            <ac:cxnSpMk id="67" creationId="{73A1DF4C-0EEA-430A-8CFF-1C9D4F763AE3}"/>
          </ac:cxnSpMkLst>
        </pc:cxnChg>
        <pc:cxnChg chg="del">
          <ac:chgData name="Amanda Gibson" userId="907984a6-cd77-4b7d-b1f8-6dfd5dda5862" providerId="ADAL" clId="{161B03EE-95FE-457B-869D-1BF7800899D4}" dt="2021-02-08T00:48:31.777" v="4192" actId="478"/>
          <ac:cxnSpMkLst>
            <pc:docMk/>
            <pc:sldMk cId="1687639029" sldId="284"/>
            <ac:cxnSpMk id="68" creationId="{568B8FAB-BB61-40DA-8202-6E34571A5B57}"/>
          </ac:cxnSpMkLst>
        </pc:cxnChg>
        <pc:cxnChg chg="add del mod">
          <ac:chgData name="Amanda Gibson" userId="907984a6-cd77-4b7d-b1f8-6dfd5dda5862" providerId="ADAL" clId="{161B03EE-95FE-457B-869D-1BF7800899D4}" dt="2021-02-08T00:50:20.691" v="4210" actId="478"/>
          <ac:cxnSpMkLst>
            <pc:docMk/>
            <pc:sldMk cId="1687639029" sldId="284"/>
            <ac:cxnSpMk id="73" creationId="{2FB99715-97BF-464D-B1B8-60570531DFDA}"/>
          </ac:cxnSpMkLst>
        </pc:cxnChg>
        <pc:cxnChg chg="add del mod">
          <ac:chgData name="Amanda Gibson" userId="907984a6-cd77-4b7d-b1f8-6dfd5dda5862" providerId="ADAL" clId="{161B03EE-95FE-457B-869D-1BF7800899D4}" dt="2021-02-08T00:50:20.691" v="4210" actId="478"/>
          <ac:cxnSpMkLst>
            <pc:docMk/>
            <pc:sldMk cId="1687639029" sldId="284"/>
            <ac:cxnSpMk id="74" creationId="{7C547178-4562-404A-AE28-AADAAE7D7F85}"/>
          </ac:cxnSpMkLst>
        </pc:cxnChg>
        <pc:cxnChg chg="add del mod">
          <ac:chgData name="Amanda Gibson" userId="907984a6-cd77-4b7d-b1f8-6dfd5dda5862" providerId="ADAL" clId="{161B03EE-95FE-457B-869D-1BF7800899D4}" dt="2021-02-08T00:50:20.691" v="4210" actId="478"/>
          <ac:cxnSpMkLst>
            <pc:docMk/>
            <pc:sldMk cId="1687639029" sldId="284"/>
            <ac:cxnSpMk id="75" creationId="{CC2714D3-F61F-40E0-9330-04BFDDDA246C}"/>
          </ac:cxnSpMkLst>
        </pc:cxnChg>
        <pc:cxnChg chg="add del mod">
          <ac:chgData name="Amanda Gibson" userId="907984a6-cd77-4b7d-b1f8-6dfd5dda5862" providerId="ADAL" clId="{161B03EE-95FE-457B-869D-1BF7800899D4}" dt="2021-02-08T00:50:20.691" v="4210" actId="478"/>
          <ac:cxnSpMkLst>
            <pc:docMk/>
            <pc:sldMk cId="1687639029" sldId="284"/>
            <ac:cxnSpMk id="76" creationId="{7449BACC-DA17-48F1-8A68-55DD106D8BDD}"/>
          </ac:cxnSpMkLst>
        </pc:cxnChg>
        <pc:cxnChg chg="add mod">
          <ac:chgData name="Amanda Gibson" userId="907984a6-cd77-4b7d-b1f8-6dfd5dda5862" providerId="ADAL" clId="{161B03EE-95FE-457B-869D-1BF7800899D4}" dt="2021-02-08T00:50:00.743" v="4207" actId="571"/>
          <ac:cxnSpMkLst>
            <pc:docMk/>
            <pc:sldMk cId="1687639029" sldId="284"/>
            <ac:cxnSpMk id="106" creationId="{2435ABFC-CC00-4B93-AE41-D22FC9ACA608}"/>
          </ac:cxnSpMkLst>
        </pc:cxnChg>
        <pc:cxnChg chg="add mod">
          <ac:chgData name="Amanda Gibson" userId="907984a6-cd77-4b7d-b1f8-6dfd5dda5862" providerId="ADAL" clId="{161B03EE-95FE-457B-869D-1BF7800899D4}" dt="2021-02-08T00:50:00.743" v="4207" actId="571"/>
          <ac:cxnSpMkLst>
            <pc:docMk/>
            <pc:sldMk cId="1687639029" sldId="284"/>
            <ac:cxnSpMk id="107" creationId="{8F9FC56A-733A-4565-BAE4-0964CD94F7BF}"/>
          </ac:cxnSpMkLst>
        </pc:cxnChg>
        <pc:cxnChg chg="add mod">
          <ac:chgData name="Amanda Gibson" userId="907984a6-cd77-4b7d-b1f8-6dfd5dda5862" providerId="ADAL" clId="{161B03EE-95FE-457B-869D-1BF7800899D4}" dt="2021-02-08T00:50:00.743" v="4207" actId="571"/>
          <ac:cxnSpMkLst>
            <pc:docMk/>
            <pc:sldMk cId="1687639029" sldId="284"/>
            <ac:cxnSpMk id="108" creationId="{FB9D103D-F269-4E52-A46A-7FBC1AF27D98}"/>
          </ac:cxnSpMkLst>
        </pc:cxnChg>
        <pc:cxnChg chg="add mod">
          <ac:chgData name="Amanda Gibson" userId="907984a6-cd77-4b7d-b1f8-6dfd5dda5862" providerId="ADAL" clId="{161B03EE-95FE-457B-869D-1BF7800899D4}" dt="2021-02-08T00:50:00.743" v="4207" actId="571"/>
          <ac:cxnSpMkLst>
            <pc:docMk/>
            <pc:sldMk cId="1687639029" sldId="284"/>
            <ac:cxnSpMk id="109" creationId="{045C7C0F-E77A-439E-9A50-AC4C6057B8F1}"/>
          </ac:cxnSpMkLst>
        </pc:cxnChg>
        <pc:cxnChg chg="add mod">
          <ac:chgData name="Amanda Gibson" userId="907984a6-cd77-4b7d-b1f8-6dfd5dda5862" providerId="ADAL" clId="{161B03EE-95FE-457B-869D-1BF7800899D4}" dt="2021-02-08T00:50:00.743" v="4207" actId="571"/>
          <ac:cxnSpMkLst>
            <pc:docMk/>
            <pc:sldMk cId="1687639029" sldId="284"/>
            <ac:cxnSpMk id="110" creationId="{D455C1AD-6A17-4AF9-8981-B455F11F27B0}"/>
          </ac:cxnSpMkLst>
        </pc:cxnChg>
        <pc:cxnChg chg="add mod">
          <ac:chgData name="Amanda Gibson" userId="907984a6-cd77-4b7d-b1f8-6dfd5dda5862" providerId="ADAL" clId="{161B03EE-95FE-457B-869D-1BF7800899D4}" dt="2021-02-08T00:50:00.743" v="4207" actId="571"/>
          <ac:cxnSpMkLst>
            <pc:docMk/>
            <pc:sldMk cId="1687639029" sldId="284"/>
            <ac:cxnSpMk id="111" creationId="{33407F2A-4651-4B37-974A-77E0D372112D}"/>
          </ac:cxnSpMkLst>
        </pc:cxnChg>
        <pc:cxnChg chg="add mod">
          <ac:chgData name="Amanda Gibson" userId="907984a6-cd77-4b7d-b1f8-6dfd5dda5862" providerId="ADAL" clId="{161B03EE-95FE-457B-869D-1BF7800899D4}" dt="2021-02-08T00:50:00.743" v="4207" actId="571"/>
          <ac:cxnSpMkLst>
            <pc:docMk/>
            <pc:sldMk cId="1687639029" sldId="284"/>
            <ac:cxnSpMk id="112" creationId="{9F042ECB-F4F6-4CE1-A418-1A965D93CE1E}"/>
          </ac:cxnSpMkLst>
        </pc:cxnChg>
        <pc:cxnChg chg="add mod">
          <ac:chgData name="Amanda Gibson" userId="907984a6-cd77-4b7d-b1f8-6dfd5dda5862" providerId="ADAL" clId="{161B03EE-95FE-457B-869D-1BF7800899D4}" dt="2021-02-08T00:50:00.743" v="4207" actId="571"/>
          <ac:cxnSpMkLst>
            <pc:docMk/>
            <pc:sldMk cId="1687639029" sldId="284"/>
            <ac:cxnSpMk id="113" creationId="{574042FF-F774-4766-BE5A-2754CFF484F0}"/>
          </ac:cxnSpMkLst>
        </pc:cxnChg>
        <pc:cxnChg chg="add mod">
          <ac:chgData name="Amanda Gibson" userId="907984a6-cd77-4b7d-b1f8-6dfd5dda5862" providerId="ADAL" clId="{161B03EE-95FE-457B-869D-1BF7800899D4}" dt="2021-02-08T00:50:00.743" v="4207" actId="571"/>
          <ac:cxnSpMkLst>
            <pc:docMk/>
            <pc:sldMk cId="1687639029" sldId="284"/>
            <ac:cxnSpMk id="114" creationId="{39A6F5B5-8998-4298-8C18-4880AE9D29C0}"/>
          </ac:cxnSpMkLst>
        </pc:cxnChg>
        <pc:cxnChg chg="add mod">
          <ac:chgData name="Amanda Gibson" userId="907984a6-cd77-4b7d-b1f8-6dfd5dda5862" providerId="ADAL" clId="{161B03EE-95FE-457B-869D-1BF7800899D4}" dt="2021-02-08T00:50:00.743" v="4207" actId="571"/>
          <ac:cxnSpMkLst>
            <pc:docMk/>
            <pc:sldMk cId="1687639029" sldId="284"/>
            <ac:cxnSpMk id="115" creationId="{256AE36F-66FB-4125-B767-269F4DA6DBC4}"/>
          </ac:cxnSpMkLst>
        </pc:cxnChg>
        <pc:cxnChg chg="add mod">
          <ac:chgData name="Amanda Gibson" userId="907984a6-cd77-4b7d-b1f8-6dfd5dda5862" providerId="ADAL" clId="{161B03EE-95FE-457B-869D-1BF7800899D4}" dt="2021-02-08T00:50:00.743" v="4207" actId="571"/>
          <ac:cxnSpMkLst>
            <pc:docMk/>
            <pc:sldMk cId="1687639029" sldId="284"/>
            <ac:cxnSpMk id="116" creationId="{53F2A60E-0A41-43F9-8FFC-8931164319BC}"/>
          </ac:cxnSpMkLst>
        </pc:cxnChg>
        <pc:cxnChg chg="add mod">
          <ac:chgData name="Amanda Gibson" userId="907984a6-cd77-4b7d-b1f8-6dfd5dda5862" providerId="ADAL" clId="{161B03EE-95FE-457B-869D-1BF7800899D4}" dt="2021-02-08T00:50:00.743" v="4207" actId="571"/>
          <ac:cxnSpMkLst>
            <pc:docMk/>
            <pc:sldMk cId="1687639029" sldId="284"/>
            <ac:cxnSpMk id="117" creationId="{7BF92DFE-9387-4877-B02F-F712B0921C47}"/>
          </ac:cxnSpMkLst>
        </pc:cxnChg>
        <pc:cxnChg chg="add mod">
          <ac:chgData name="Amanda Gibson" userId="907984a6-cd77-4b7d-b1f8-6dfd5dda5862" providerId="ADAL" clId="{161B03EE-95FE-457B-869D-1BF7800899D4}" dt="2021-02-08T00:50:00.743" v="4207" actId="571"/>
          <ac:cxnSpMkLst>
            <pc:docMk/>
            <pc:sldMk cId="1687639029" sldId="284"/>
            <ac:cxnSpMk id="118" creationId="{4555E0C9-8A88-4E12-910F-1D34942D165A}"/>
          </ac:cxnSpMkLst>
        </pc:cxnChg>
        <pc:cxnChg chg="add mod">
          <ac:chgData name="Amanda Gibson" userId="907984a6-cd77-4b7d-b1f8-6dfd5dda5862" providerId="ADAL" clId="{161B03EE-95FE-457B-869D-1BF7800899D4}" dt="2021-02-08T00:50:00.743" v="4207" actId="571"/>
          <ac:cxnSpMkLst>
            <pc:docMk/>
            <pc:sldMk cId="1687639029" sldId="284"/>
            <ac:cxnSpMk id="119" creationId="{39B9ADA0-2631-415C-AC2D-F64F30826D35}"/>
          </ac:cxnSpMkLst>
        </pc:cxnChg>
        <pc:cxnChg chg="add mod">
          <ac:chgData name="Amanda Gibson" userId="907984a6-cd77-4b7d-b1f8-6dfd5dda5862" providerId="ADAL" clId="{161B03EE-95FE-457B-869D-1BF7800899D4}" dt="2021-02-08T00:50:00.743" v="4207" actId="571"/>
          <ac:cxnSpMkLst>
            <pc:docMk/>
            <pc:sldMk cId="1687639029" sldId="284"/>
            <ac:cxnSpMk id="120" creationId="{EBD0EFF8-69B0-41C1-A63B-AF9D548C2C40}"/>
          </ac:cxnSpMkLst>
        </pc:cxnChg>
        <pc:cxnChg chg="add mod">
          <ac:chgData name="Amanda Gibson" userId="907984a6-cd77-4b7d-b1f8-6dfd5dda5862" providerId="ADAL" clId="{161B03EE-95FE-457B-869D-1BF7800899D4}" dt="2021-02-08T00:50:00.743" v="4207" actId="571"/>
          <ac:cxnSpMkLst>
            <pc:docMk/>
            <pc:sldMk cId="1687639029" sldId="284"/>
            <ac:cxnSpMk id="121" creationId="{05F6D7B0-20B8-461B-839D-9252D2ED2CE6}"/>
          </ac:cxnSpMkLst>
        </pc:cxnChg>
        <pc:cxnChg chg="add mod">
          <ac:chgData name="Amanda Gibson" userId="907984a6-cd77-4b7d-b1f8-6dfd5dda5862" providerId="ADAL" clId="{161B03EE-95FE-457B-869D-1BF7800899D4}" dt="2021-02-08T00:50:00.743" v="4207" actId="571"/>
          <ac:cxnSpMkLst>
            <pc:docMk/>
            <pc:sldMk cId="1687639029" sldId="284"/>
            <ac:cxnSpMk id="122" creationId="{0A4BC8E3-BAB1-47B0-A45D-35B2798EF291}"/>
          </ac:cxnSpMkLst>
        </pc:cxnChg>
        <pc:cxnChg chg="add mod">
          <ac:chgData name="Amanda Gibson" userId="907984a6-cd77-4b7d-b1f8-6dfd5dda5862" providerId="ADAL" clId="{161B03EE-95FE-457B-869D-1BF7800899D4}" dt="2021-02-08T00:50:00.743" v="4207" actId="571"/>
          <ac:cxnSpMkLst>
            <pc:docMk/>
            <pc:sldMk cId="1687639029" sldId="284"/>
            <ac:cxnSpMk id="123" creationId="{67BDCC88-2E3C-428B-90DC-30112F1D3560}"/>
          </ac:cxnSpMkLst>
        </pc:cxnChg>
        <pc:cxnChg chg="add mod">
          <ac:chgData name="Amanda Gibson" userId="907984a6-cd77-4b7d-b1f8-6dfd5dda5862" providerId="ADAL" clId="{161B03EE-95FE-457B-869D-1BF7800899D4}" dt="2021-02-08T00:50:00.743" v="4207" actId="571"/>
          <ac:cxnSpMkLst>
            <pc:docMk/>
            <pc:sldMk cId="1687639029" sldId="284"/>
            <ac:cxnSpMk id="124" creationId="{7DC4B73F-AE0A-4730-8413-34FB40D172D9}"/>
          </ac:cxnSpMkLst>
        </pc:cxnChg>
      </pc:sldChg>
      <pc:sldChg chg="modSp add mod ord">
        <pc:chgData name="Amanda Gibson" userId="907984a6-cd77-4b7d-b1f8-6dfd5dda5862" providerId="ADAL" clId="{161B03EE-95FE-457B-869D-1BF7800899D4}" dt="2021-02-08T01:30:22.390" v="5103"/>
        <pc:sldMkLst>
          <pc:docMk/>
          <pc:sldMk cId="1172058924" sldId="285"/>
        </pc:sldMkLst>
        <pc:spChg chg="mod">
          <ac:chgData name="Amanda Gibson" userId="907984a6-cd77-4b7d-b1f8-6dfd5dda5862" providerId="ADAL" clId="{161B03EE-95FE-457B-869D-1BF7800899D4}" dt="2021-02-08T00:52:42.693" v="4378" actId="20577"/>
          <ac:spMkLst>
            <pc:docMk/>
            <pc:sldMk cId="1172058924" sldId="285"/>
            <ac:spMk id="2" creationId="{28C08DB6-BD44-4401-A786-2D06627D7C16}"/>
          </ac:spMkLst>
        </pc:spChg>
        <pc:spChg chg="mod">
          <ac:chgData name="Amanda Gibson" userId="907984a6-cd77-4b7d-b1f8-6dfd5dda5862" providerId="ADAL" clId="{161B03EE-95FE-457B-869D-1BF7800899D4}" dt="2021-02-08T00:52:56.263" v="4401" actId="20577"/>
          <ac:spMkLst>
            <pc:docMk/>
            <pc:sldMk cId="1172058924" sldId="285"/>
            <ac:spMk id="37" creationId="{11F4F17E-B198-4662-82B9-FD38C6AFD4A0}"/>
          </ac:spMkLst>
        </pc:spChg>
      </pc:sldChg>
      <pc:sldChg chg="addSp delSp modSp add mod">
        <pc:chgData name="Amanda Gibson" userId="907984a6-cd77-4b7d-b1f8-6dfd5dda5862" providerId="ADAL" clId="{161B03EE-95FE-457B-869D-1BF7800899D4}" dt="2021-02-08T01:22:04.614" v="4738" actId="20577"/>
        <pc:sldMkLst>
          <pc:docMk/>
          <pc:sldMk cId="2341376025" sldId="286"/>
        </pc:sldMkLst>
        <pc:spChg chg="mod">
          <ac:chgData name="Amanda Gibson" userId="907984a6-cd77-4b7d-b1f8-6dfd5dda5862" providerId="ADAL" clId="{161B03EE-95FE-457B-869D-1BF7800899D4}" dt="2021-02-08T01:14:49.265" v="4534" actId="20577"/>
          <ac:spMkLst>
            <pc:docMk/>
            <pc:sldMk cId="2341376025" sldId="286"/>
            <ac:spMk id="2" creationId="{28C08DB6-BD44-4401-A786-2D06627D7C16}"/>
          </ac:spMkLst>
        </pc:spChg>
        <pc:spChg chg="del">
          <ac:chgData name="Amanda Gibson" userId="907984a6-cd77-4b7d-b1f8-6dfd5dda5862" providerId="ADAL" clId="{161B03EE-95FE-457B-869D-1BF7800899D4}" dt="2021-02-08T01:14:01.185" v="4404" actId="478"/>
          <ac:spMkLst>
            <pc:docMk/>
            <pc:sldMk cId="2341376025" sldId="286"/>
            <ac:spMk id="12" creationId="{73C8D4CF-6D74-4517-B89F-A634F8F06F8C}"/>
          </ac:spMkLst>
        </pc:spChg>
        <pc:spChg chg="del">
          <ac:chgData name="Amanda Gibson" userId="907984a6-cd77-4b7d-b1f8-6dfd5dda5862" providerId="ADAL" clId="{161B03EE-95FE-457B-869D-1BF7800899D4}" dt="2021-02-08T01:14:01.185" v="4404" actId="478"/>
          <ac:spMkLst>
            <pc:docMk/>
            <pc:sldMk cId="2341376025" sldId="286"/>
            <ac:spMk id="19" creationId="{B99D2179-B280-439D-A35B-B12D4C34FF11}"/>
          </ac:spMkLst>
        </pc:spChg>
        <pc:spChg chg="del">
          <ac:chgData name="Amanda Gibson" userId="907984a6-cd77-4b7d-b1f8-6dfd5dda5862" providerId="ADAL" clId="{161B03EE-95FE-457B-869D-1BF7800899D4}" dt="2021-02-08T01:14:01.185" v="4404" actId="478"/>
          <ac:spMkLst>
            <pc:docMk/>
            <pc:sldMk cId="2341376025" sldId="286"/>
            <ac:spMk id="26" creationId="{3BA4ED5A-514F-48A9-9EF8-6AA68AF802A4}"/>
          </ac:spMkLst>
        </pc:spChg>
        <pc:spChg chg="del">
          <ac:chgData name="Amanda Gibson" userId="907984a6-cd77-4b7d-b1f8-6dfd5dda5862" providerId="ADAL" clId="{161B03EE-95FE-457B-869D-1BF7800899D4}" dt="2021-02-08T01:14:01.185" v="4404" actId="478"/>
          <ac:spMkLst>
            <pc:docMk/>
            <pc:sldMk cId="2341376025" sldId="286"/>
            <ac:spMk id="27" creationId="{F8458700-1DEE-45E7-8814-E563D7CB3D9A}"/>
          </ac:spMkLst>
        </pc:spChg>
        <pc:spChg chg="del">
          <ac:chgData name="Amanda Gibson" userId="907984a6-cd77-4b7d-b1f8-6dfd5dda5862" providerId="ADAL" clId="{161B03EE-95FE-457B-869D-1BF7800899D4}" dt="2021-02-08T01:14:01.185" v="4404" actId="478"/>
          <ac:spMkLst>
            <pc:docMk/>
            <pc:sldMk cId="2341376025" sldId="286"/>
            <ac:spMk id="37" creationId="{11F4F17E-B198-4662-82B9-FD38C6AFD4A0}"/>
          </ac:spMkLst>
        </pc:spChg>
        <pc:spChg chg="del">
          <ac:chgData name="Amanda Gibson" userId="907984a6-cd77-4b7d-b1f8-6dfd5dda5862" providerId="ADAL" clId="{161B03EE-95FE-457B-869D-1BF7800899D4}" dt="2021-02-08T01:14:01.185" v="4404" actId="478"/>
          <ac:spMkLst>
            <pc:docMk/>
            <pc:sldMk cId="2341376025" sldId="286"/>
            <ac:spMk id="44" creationId="{78CD0FC1-06AB-42FD-9785-625F60BB71A2}"/>
          </ac:spMkLst>
        </pc:spChg>
        <pc:spChg chg="del">
          <ac:chgData name="Amanda Gibson" userId="907984a6-cd77-4b7d-b1f8-6dfd5dda5862" providerId="ADAL" clId="{161B03EE-95FE-457B-869D-1BF7800899D4}" dt="2021-02-08T01:14:01.185" v="4404" actId="478"/>
          <ac:spMkLst>
            <pc:docMk/>
            <pc:sldMk cId="2341376025" sldId="286"/>
            <ac:spMk id="45" creationId="{92234871-3244-4FF0-805D-EF8D613833C0}"/>
          </ac:spMkLst>
        </pc:spChg>
        <pc:spChg chg="del">
          <ac:chgData name="Amanda Gibson" userId="907984a6-cd77-4b7d-b1f8-6dfd5dda5862" providerId="ADAL" clId="{161B03EE-95FE-457B-869D-1BF7800899D4}" dt="2021-02-08T01:14:01.185" v="4404" actId="478"/>
          <ac:spMkLst>
            <pc:docMk/>
            <pc:sldMk cId="2341376025" sldId="286"/>
            <ac:spMk id="47" creationId="{4A851316-A2EF-4C7F-B7F8-CC58BD1D8F2D}"/>
          </ac:spMkLst>
        </pc:spChg>
        <pc:spChg chg="del">
          <ac:chgData name="Amanda Gibson" userId="907984a6-cd77-4b7d-b1f8-6dfd5dda5862" providerId="ADAL" clId="{161B03EE-95FE-457B-869D-1BF7800899D4}" dt="2021-02-08T01:14:01.185" v="4404" actId="478"/>
          <ac:spMkLst>
            <pc:docMk/>
            <pc:sldMk cId="2341376025" sldId="286"/>
            <ac:spMk id="48" creationId="{5BDDB4A8-E648-450E-B96E-F8D4DD553D1E}"/>
          </ac:spMkLst>
        </pc:spChg>
        <pc:spChg chg="del">
          <ac:chgData name="Amanda Gibson" userId="907984a6-cd77-4b7d-b1f8-6dfd5dda5862" providerId="ADAL" clId="{161B03EE-95FE-457B-869D-1BF7800899D4}" dt="2021-02-08T01:14:01.185" v="4404" actId="478"/>
          <ac:spMkLst>
            <pc:docMk/>
            <pc:sldMk cId="2341376025" sldId="286"/>
            <ac:spMk id="50" creationId="{9EBD8EA2-9E07-4A71-B743-9C88F0A86A5B}"/>
          </ac:spMkLst>
        </pc:spChg>
        <pc:spChg chg="del">
          <ac:chgData name="Amanda Gibson" userId="907984a6-cd77-4b7d-b1f8-6dfd5dda5862" providerId="ADAL" clId="{161B03EE-95FE-457B-869D-1BF7800899D4}" dt="2021-02-08T01:14:01.185" v="4404" actId="478"/>
          <ac:spMkLst>
            <pc:docMk/>
            <pc:sldMk cId="2341376025" sldId="286"/>
            <ac:spMk id="54" creationId="{16DF88A2-65C8-4A9A-95A3-20EF4B345899}"/>
          </ac:spMkLst>
        </pc:spChg>
        <pc:spChg chg="del">
          <ac:chgData name="Amanda Gibson" userId="907984a6-cd77-4b7d-b1f8-6dfd5dda5862" providerId="ADAL" clId="{161B03EE-95FE-457B-869D-1BF7800899D4}" dt="2021-02-08T01:14:01.185" v="4404" actId="478"/>
          <ac:spMkLst>
            <pc:docMk/>
            <pc:sldMk cId="2341376025" sldId="286"/>
            <ac:spMk id="58" creationId="{638D959D-6F48-45FD-8320-E292F549EC90}"/>
          </ac:spMkLst>
        </pc:spChg>
        <pc:spChg chg="del">
          <ac:chgData name="Amanda Gibson" userId="907984a6-cd77-4b7d-b1f8-6dfd5dda5862" providerId="ADAL" clId="{161B03EE-95FE-457B-869D-1BF7800899D4}" dt="2021-02-08T01:14:01.185" v="4404" actId="478"/>
          <ac:spMkLst>
            <pc:docMk/>
            <pc:sldMk cId="2341376025" sldId="286"/>
            <ac:spMk id="59" creationId="{48ADFD6A-FC11-440E-92B4-44B416C62A0B}"/>
          </ac:spMkLst>
        </pc:spChg>
        <pc:spChg chg="del">
          <ac:chgData name="Amanda Gibson" userId="907984a6-cd77-4b7d-b1f8-6dfd5dda5862" providerId="ADAL" clId="{161B03EE-95FE-457B-869D-1BF7800899D4}" dt="2021-02-08T01:14:01.185" v="4404" actId="478"/>
          <ac:spMkLst>
            <pc:docMk/>
            <pc:sldMk cId="2341376025" sldId="286"/>
            <ac:spMk id="69" creationId="{9CB26AC9-A803-4139-B999-2F74AEC0D716}"/>
          </ac:spMkLst>
        </pc:spChg>
        <pc:spChg chg="del">
          <ac:chgData name="Amanda Gibson" userId="907984a6-cd77-4b7d-b1f8-6dfd5dda5862" providerId="ADAL" clId="{161B03EE-95FE-457B-869D-1BF7800899D4}" dt="2021-02-08T01:14:01.185" v="4404" actId="478"/>
          <ac:spMkLst>
            <pc:docMk/>
            <pc:sldMk cId="2341376025" sldId="286"/>
            <ac:spMk id="70" creationId="{B35F54B4-3BF5-4648-BA5F-839B8217BC62}"/>
          </ac:spMkLst>
        </pc:spChg>
        <pc:spChg chg="del">
          <ac:chgData name="Amanda Gibson" userId="907984a6-cd77-4b7d-b1f8-6dfd5dda5862" providerId="ADAL" clId="{161B03EE-95FE-457B-869D-1BF7800899D4}" dt="2021-02-08T01:14:01.185" v="4404" actId="478"/>
          <ac:spMkLst>
            <pc:docMk/>
            <pc:sldMk cId="2341376025" sldId="286"/>
            <ac:spMk id="71" creationId="{089B2115-724F-40EB-9552-97D19D3C03E3}"/>
          </ac:spMkLst>
        </pc:spChg>
        <pc:spChg chg="del">
          <ac:chgData name="Amanda Gibson" userId="907984a6-cd77-4b7d-b1f8-6dfd5dda5862" providerId="ADAL" clId="{161B03EE-95FE-457B-869D-1BF7800899D4}" dt="2021-02-08T01:14:01.185" v="4404" actId="478"/>
          <ac:spMkLst>
            <pc:docMk/>
            <pc:sldMk cId="2341376025" sldId="286"/>
            <ac:spMk id="72" creationId="{CF8821E0-4EEE-465E-8798-BFB4F5C8DC2D}"/>
          </ac:spMkLst>
        </pc:spChg>
        <pc:spChg chg="add mod">
          <ac:chgData name="Amanda Gibson" userId="907984a6-cd77-4b7d-b1f8-6dfd5dda5862" providerId="ADAL" clId="{161B03EE-95FE-457B-869D-1BF7800899D4}" dt="2021-02-08T01:14:02.297" v="4405"/>
          <ac:spMkLst>
            <pc:docMk/>
            <pc:sldMk cId="2341376025" sldId="286"/>
            <ac:spMk id="73" creationId="{9574B2BE-913E-4105-B3FD-0D9ABB3860A6}"/>
          </ac:spMkLst>
        </pc:spChg>
        <pc:spChg chg="add del mod">
          <ac:chgData name="Amanda Gibson" userId="907984a6-cd77-4b7d-b1f8-6dfd5dda5862" providerId="ADAL" clId="{161B03EE-95FE-457B-869D-1BF7800899D4}" dt="2021-02-08T01:15:42.492" v="4539" actId="478"/>
          <ac:spMkLst>
            <pc:docMk/>
            <pc:sldMk cId="2341376025" sldId="286"/>
            <ac:spMk id="74" creationId="{F4FF2F6F-7910-411D-B1C8-8FAD6A3082C8}"/>
          </ac:spMkLst>
        </pc:spChg>
        <pc:spChg chg="add del mod">
          <ac:chgData name="Amanda Gibson" userId="907984a6-cd77-4b7d-b1f8-6dfd5dda5862" providerId="ADAL" clId="{161B03EE-95FE-457B-869D-1BF7800899D4}" dt="2021-02-08T01:15:42.492" v="4539" actId="478"/>
          <ac:spMkLst>
            <pc:docMk/>
            <pc:sldMk cId="2341376025" sldId="286"/>
            <ac:spMk id="75" creationId="{72AD2895-D053-4608-90D1-4A8AF157EAEB}"/>
          </ac:spMkLst>
        </pc:spChg>
        <pc:spChg chg="add del mod">
          <ac:chgData name="Amanda Gibson" userId="907984a6-cd77-4b7d-b1f8-6dfd5dda5862" providerId="ADAL" clId="{161B03EE-95FE-457B-869D-1BF7800899D4}" dt="2021-02-08T01:15:26.192" v="4537" actId="478"/>
          <ac:spMkLst>
            <pc:docMk/>
            <pc:sldMk cId="2341376025" sldId="286"/>
            <ac:spMk id="76" creationId="{982E6383-71FA-477B-BF9A-AD6A3B55EBB3}"/>
          </ac:spMkLst>
        </pc:spChg>
        <pc:spChg chg="add del mod">
          <ac:chgData name="Amanda Gibson" userId="907984a6-cd77-4b7d-b1f8-6dfd5dda5862" providerId="ADAL" clId="{161B03EE-95FE-457B-869D-1BF7800899D4}" dt="2021-02-08T01:15:26.992" v="4538" actId="478"/>
          <ac:spMkLst>
            <pc:docMk/>
            <pc:sldMk cId="2341376025" sldId="286"/>
            <ac:spMk id="77" creationId="{D5045A1D-4042-45DA-8CEF-F7DDBEB918AA}"/>
          </ac:spMkLst>
        </pc:spChg>
        <pc:spChg chg="add del mod">
          <ac:chgData name="Amanda Gibson" userId="907984a6-cd77-4b7d-b1f8-6dfd5dda5862" providerId="ADAL" clId="{161B03EE-95FE-457B-869D-1BF7800899D4}" dt="2021-02-08T01:15:47.417" v="4540" actId="478"/>
          <ac:spMkLst>
            <pc:docMk/>
            <pc:sldMk cId="2341376025" sldId="286"/>
            <ac:spMk id="78" creationId="{3F5C8308-B465-4EEF-AA11-68DEB2CA2DFD}"/>
          </ac:spMkLst>
        </pc:spChg>
        <pc:spChg chg="add del mod">
          <ac:chgData name="Amanda Gibson" userId="907984a6-cd77-4b7d-b1f8-6dfd5dda5862" providerId="ADAL" clId="{161B03EE-95FE-457B-869D-1BF7800899D4}" dt="2021-02-08T01:15:47.417" v="4540" actId="478"/>
          <ac:spMkLst>
            <pc:docMk/>
            <pc:sldMk cId="2341376025" sldId="286"/>
            <ac:spMk id="79" creationId="{63006E06-B6C7-488E-AE32-A69DCF52D39A}"/>
          </ac:spMkLst>
        </pc:spChg>
        <pc:spChg chg="add del mod">
          <ac:chgData name="Amanda Gibson" userId="907984a6-cd77-4b7d-b1f8-6dfd5dda5862" providerId="ADAL" clId="{161B03EE-95FE-457B-869D-1BF7800899D4}" dt="2021-02-08T01:15:47.417" v="4540" actId="478"/>
          <ac:spMkLst>
            <pc:docMk/>
            <pc:sldMk cId="2341376025" sldId="286"/>
            <ac:spMk id="80" creationId="{34DD7226-50EB-4839-BCFB-5F41BBC977AD}"/>
          </ac:spMkLst>
        </pc:spChg>
        <pc:spChg chg="add del mod">
          <ac:chgData name="Amanda Gibson" userId="907984a6-cd77-4b7d-b1f8-6dfd5dda5862" providerId="ADAL" clId="{161B03EE-95FE-457B-869D-1BF7800899D4}" dt="2021-02-08T01:15:47.417" v="4540" actId="478"/>
          <ac:spMkLst>
            <pc:docMk/>
            <pc:sldMk cId="2341376025" sldId="286"/>
            <ac:spMk id="81" creationId="{B226E726-90D5-48CB-B9C6-FA4766F66CAE}"/>
          </ac:spMkLst>
        </pc:spChg>
        <pc:spChg chg="del">
          <ac:chgData name="Amanda Gibson" userId="907984a6-cd77-4b7d-b1f8-6dfd5dda5862" providerId="ADAL" clId="{161B03EE-95FE-457B-869D-1BF7800899D4}" dt="2021-02-08T01:14:01.185" v="4404" actId="478"/>
          <ac:spMkLst>
            <pc:docMk/>
            <pc:sldMk cId="2341376025" sldId="286"/>
            <ac:spMk id="82" creationId="{71266F89-E78D-4096-930C-0FE7CCFEE445}"/>
          </ac:spMkLst>
        </pc:spChg>
        <pc:spChg chg="del">
          <ac:chgData name="Amanda Gibson" userId="907984a6-cd77-4b7d-b1f8-6dfd5dda5862" providerId="ADAL" clId="{161B03EE-95FE-457B-869D-1BF7800899D4}" dt="2021-02-08T01:14:01.185" v="4404" actId="478"/>
          <ac:spMkLst>
            <pc:docMk/>
            <pc:sldMk cId="2341376025" sldId="286"/>
            <ac:spMk id="83" creationId="{1944A02E-85F4-4174-BA79-16515F18AE10}"/>
          </ac:spMkLst>
        </pc:spChg>
        <pc:spChg chg="del">
          <ac:chgData name="Amanda Gibson" userId="907984a6-cd77-4b7d-b1f8-6dfd5dda5862" providerId="ADAL" clId="{161B03EE-95FE-457B-869D-1BF7800899D4}" dt="2021-02-08T01:14:01.185" v="4404" actId="478"/>
          <ac:spMkLst>
            <pc:docMk/>
            <pc:sldMk cId="2341376025" sldId="286"/>
            <ac:spMk id="84" creationId="{22D67E9D-5062-4A87-A030-A820008E3850}"/>
          </ac:spMkLst>
        </pc:spChg>
        <pc:spChg chg="del">
          <ac:chgData name="Amanda Gibson" userId="907984a6-cd77-4b7d-b1f8-6dfd5dda5862" providerId="ADAL" clId="{161B03EE-95FE-457B-869D-1BF7800899D4}" dt="2021-02-08T01:14:01.185" v="4404" actId="478"/>
          <ac:spMkLst>
            <pc:docMk/>
            <pc:sldMk cId="2341376025" sldId="286"/>
            <ac:spMk id="85" creationId="{359C128B-6D73-42B9-933D-679813012B6B}"/>
          </ac:spMkLst>
        </pc:spChg>
        <pc:spChg chg="del">
          <ac:chgData name="Amanda Gibson" userId="907984a6-cd77-4b7d-b1f8-6dfd5dda5862" providerId="ADAL" clId="{161B03EE-95FE-457B-869D-1BF7800899D4}" dt="2021-02-08T01:14:01.185" v="4404" actId="478"/>
          <ac:spMkLst>
            <pc:docMk/>
            <pc:sldMk cId="2341376025" sldId="286"/>
            <ac:spMk id="86" creationId="{742A3144-C6B4-46BE-93AE-D1A8B320876D}"/>
          </ac:spMkLst>
        </pc:spChg>
        <pc:spChg chg="del">
          <ac:chgData name="Amanda Gibson" userId="907984a6-cd77-4b7d-b1f8-6dfd5dda5862" providerId="ADAL" clId="{161B03EE-95FE-457B-869D-1BF7800899D4}" dt="2021-02-08T01:14:01.185" v="4404" actId="478"/>
          <ac:spMkLst>
            <pc:docMk/>
            <pc:sldMk cId="2341376025" sldId="286"/>
            <ac:spMk id="87" creationId="{AF44DBA4-9024-49AF-8F00-134BE9E470C0}"/>
          </ac:spMkLst>
        </pc:spChg>
        <pc:spChg chg="del">
          <ac:chgData name="Amanda Gibson" userId="907984a6-cd77-4b7d-b1f8-6dfd5dda5862" providerId="ADAL" clId="{161B03EE-95FE-457B-869D-1BF7800899D4}" dt="2021-02-08T01:14:01.185" v="4404" actId="478"/>
          <ac:spMkLst>
            <pc:docMk/>
            <pc:sldMk cId="2341376025" sldId="286"/>
            <ac:spMk id="88" creationId="{3CCD7D92-4DAA-40EA-97F9-DF5BF51CCACC}"/>
          </ac:spMkLst>
        </pc:spChg>
        <pc:spChg chg="add mod">
          <ac:chgData name="Amanda Gibson" userId="907984a6-cd77-4b7d-b1f8-6dfd5dda5862" providerId="ADAL" clId="{161B03EE-95FE-457B-869D-1BF7800899D4}" dt="2021-02-08T01:14:02.297" v="4405"/>
          <ac:spMkLst>
            <pc:docMk/>
            <pc:sldMk cId="2341376025" sldId="286"/>
            <ac:spMk id="89" creationId="{F6B6002F-5E81-4BA1-B6D0-ABC65AFFB17D}"/>
          </ac:spMkLst>
        </pc:spChg>
        <pc:spChg chg="add mod">
          <ac:chgData name="Amanda Gibson" userId="907984a6-cd77-4b7d-b1f8-6dfd5dda5862" providerId="ADAL" clId="{161B03EE-95FE-457B-869D-1BF7800899D4}" dt="2021-02-08T01:14:02.297" v="4405"/>
          <ac:spMkLst>
            <pc:docMk/>
            <pc:sldMk cId="2341376025" sldId="286"/>
            <ac:spMk id="90" creationId="{5588F674-1BDB-4F23-A205-1952182558C6}"/>
          </ac:spMkLst>
        </pc:spChg>
        <pc:spChg chg="add mod">
          <ac:chgData name="Amanda Gibson" userId="907984a6-cd77-4b7d-b1f8-6dfd5dda5862" providerId="ADAL" clId="{161B03EE-95FE-457B-869D-1BF7800899D4}" dt="2021-02-08T01:14:02.297" v="4405"/>
          <ac:spMkLst>
            <pc:docMk/>
            <pc:sldMk cId="2341376025" sldId="286"/>
            <ac:spMk id="91" creationId="{FB666959-732B-4ED7-89D8-08DADF665B83}"/>
          </ac:spMkLst>
        </pc:spChg>
        <pc:spChg chg="add del mod">
          <ac:chgData name="Amanda Gibson" userId="907984a6-cd77-4b7d-b1f8-6dfd5dda5862" providerId="ADAL" clId="{161B03EE-95FE-457B-869D-1BF7800899D4}" dt="2021-02-08T01:15:59.016" v="4543" actId="478"/>
          <ac:spMkLst>
            <pc:docMk/>
            <pc:sldMk cId="2341376025" sldId="286"/>
            <ac:spMk id="92" creationId="{AFCDF31F-FAD1-44BD-B673-5334FC65ECF1}"/>
          </ac:spMkLst>
        </pc:spChg>
        <pc:spChg chg="add del mod">
          <ac:chgData name="Amanda Gibson" userId="907984a6-cd77-4b7d-b1f8-6dfd5dda5862" providerId="ADAL" clId="{161B03EE-95FE-457B-869D-1BF7800899D4}" dt="2021-02-08T01:15:50.372" v="4541" actId="478"/>
          <ac:spMkLst>
            <pc:docMk/>
            <pc:sldMk cId="2341376025" sldId="286"/>
            <ac:spMk id="93" creationId="{CD1A5280-AB07-4310-9912-09C98827E766}"/>
          </ac:spMkLst>
        </pc:spChg>
        <pc:spChg chg="add del mod">
          <ac:chgData name="Amanda Gibson" userId="907984a6-cd77-4b7d-b1f8-6dfd5dda5862" providerId="ADAL" clId="{161B03EE-95FE-457B-869D-1BF7800899D4}" dt="2021-02-08T01:15:56.671" v="4542" actId="478"/>
          <ac:spMkLst>
            <pc:docMk/>
            <pc:sldMk cId="2341376025" sldId="286"/>
            <ac:spMk id="94" creationId="{673C3D82-582B-4592-8150-794119D18207}"/>
          </ac:spMkLst>
        </pc:spChg>
        <pc:spChg chg="add mod">
          <ac:chgData name="Amanda Gibson" userId="907984a6-cd77-4b7d-b1f8-6dfd5dda5862" providerId="ADAL" clId="{161B03EE-95FE-457B-869D-1BF7800899D4}" dt="2021-02-08T01:14:02.297" v="4405"/>
          <ac:spMkLst>
            <pc:docMk/>
            <pc:sldMk cId="2341376025" sldId="286"/>
            <ac:spMk id="95" creationId="{57842CB3-7F18-4588-957D-89858DA0664B}"/>
          </ac:spMkLst>
        </pc:spChg>
        <pc:spChg chg="add del mod">
          <ac:chgData name="Amanda Gibson" userId="907984a6-cd77-4b7d-b1f8-6dfd5dda5862" providerId="ADAL" clId="{161B03EE-95FE-457B-869D-1BF7800899D4}" dt="2021-02-08T01:16:05.902" v="4544" actId="478"/>
          <ac:spMkLst>
            <pc:docMk/>
            <pc:sldMk cId="2341376025" sldId="286"/>
            <ac:spMk id="96" creationId="{93E47917-C498-47D4-A0FF-F31686BBC923}"/>
          </ac:spMkLst>
        </pc:spChg>
        <pc:spChg chg="add del mod">
          <ac:chgData name="Amanda Gibson" userId="907984a6-cd77-4b7d-b1f8-6dfd5dda5862" providerId="ADAL" clId="{161B03EE-95FE-457B-869D-1BF7800899D4}" dt="2021-02-08T01:16:05.902" v="4544" actId="478"/>
          <ac:spMkLst>
            <pc:docMk/>
            <pc:sldMk cId="2341376025" sldId="286"/>
            <ac:spMk id="97" creationId="{7811F29A-BF0B-4FD5-A671-1E35110B744C}"/>
          </ac:spMkLst>
        </pc:spChg>
        <pc:spChg chg="add del mod">
          <ac:chgData name="Amanda Gibson" userId="907984a6-cd77-4b7d-b1f8-6dfd5dda5862" providerId="ADAL" clId="{161B03EE-95FE-457B-869D-1BF7800899D4}" dt="2021-02-08T01:16:05.902" v="4544" actId="478"/>
          <ac:spMkLst>
            <pc:docMk/>
            <pc:sldMk cId="2341376025" sldId="286"/>
            <ac:spMk id="98" creationId="{C56595AC-5081-46C0-A978-1ED39490CBEC}"/>
          </ac:spMkLst>
        </pc:spChg>
        <pc:spChg chg="add mod">
          <ac:chgData name="Amanda Gibson" userId="907984a6-cd77-4b7d-b1f8-6dfd5dda5862" providerId="ADAL" clId="{161B03EE-95FE-457B-869D-1BF7800899D4}" dt="2021-02-08T01:14:02.297" v="4405"/>
          <ac:spMkLst>
            <pc:docMk/>
            <pc:sldMk cId="2341376025" sldId="286"/>
            <ac:spMk id="99" creationId="{14463CAA-B4D5-4220-A29B-B54081169A57}"/>
          </ac:spMkLst>
        </pc:spChg>
        <pc:spChg chg="add mod">
          <ac:chgData name="Amanda Gibson" userId="907984a6-cd77-4b7d-b1f8-6dfd5dda5862" providerId="ADAL" clId="{161B03EE-95FE-457B-869D-1BF7800899D4}" dt="2021-02-08T01:14:02.297" v="4405"/>
          <ac:spMkLst>
            <pc:docMk/>
            <pc:sldMk cId="2341376025" sldId="286"/>
            <ac:spMk id="100" creationId="{470AB2E8-03D9-4071-8329-8063DB46FD0A}"/>
          </ac:spMkLst>
        </pc:spChg>
        <pc:spChg chg="add del mod">
          <ac:chgData name="Amanda Gibson" userId="907984a6-cd77-4b7d-b1f8-6dfd5dda5862" providerId="ADAL" clId="{161B03EE-95FE-457B-869D-1BF7800899D4}" dt="2021-02-08T01:15:42.492" v="4539" actId="478"/>
          <ac:spMkLst>
            <pc:docMk/>
            <pc:sldMk cId="2341376025" sldId="286"/>
            <ac:spMk id="101" creationId="{75F69B35-23C1-4992-A19E-830B335AE9AD}"/>
          </ac:spMkLst>
        </pc:spChg>
        <pc:spChg chg="add del mod">
          <ac:chgData name="Amanda Gibson" userId="907984a6-cd77-4b7d-b1f8-6dfd5dda5862" providerId="ADAL" clId="{161B03EE-95FE-457B-869D-1BF7800899D4}" dt="2021-02-08T01:15:42.492" v="4539" actId="478"/>
          <ac:spMkLst>
            <pc:docMk/>
            <pc:sldMk cId="2341376025" sldId="286"/>
            <ac:spMk id="102" creationId="{C6D6EEB4-B9ED-441D-8B0A-535FCE1C0431}"/>
          </ac:spMkLst>
        </pc:spChg>
        <pc:spChg chg="add del mod">
          <ac:chgData name="Amanda Gibson" userId="907984a6-cd77-4b7d-b1f8-6dfd5dda5862" providerId="ADAL" clId="{161B03EE-95FE-457B-869D-1BF7800899D4}" dt="2021-02-08T01:21:49.524" v="4732" actId="20577"/>
          <ac:spMkLst>
            <pc:docMk/>
            <pc:sldMk cId="2341376025" sldId="286"/>
            <ac:spMk id="103" creationId="{F30E38B6-500B-40D2-A227-03FDB888FBA8}"/>
          </ac:spMkLst>
        </pc:spChg>
        <pc:spChg chg="add del mod">
          <ac:chgData name="Amanda Gibson" userId="907984a6-cd77-4b7d-b1f8-6dfd5dda5862" providerId="ADAL" clId="{161B03EE-95FE-457B-869D-1BF7800899D4}" dt="2021-02-08T01:21:51.773" v="4733" actId="20577"/>
          <ac:spMkLst>
            <pc:docMk/>
            <pc:sldMk cId="2341376025" sldId="286"/>
            <ac:spMk id="104" creationId="{299F0864-5921-4133-BC22-E152B0427FB1}"/>
          </ac:spMkLst>
        </pc:spChg>
        <pc:spChg chg="add del mod">
          <ac:chgData name="Amanda Gibson" userId="907984a6-cd77-4b7d-b1f8-6dfd5dda5862" providerId="ADAL" clId="{161B03EE-95FE-457B-869D-1BF7800899D4}" dt="2021-02-08T01:15:47.417" v="4540" actId="478"/>
          <ac:spMkLst>
            <pc:docMk/>
            <pc:sldMk cId="2341376025" sldId="286"/>
            <ac:spMk id="105" creationId="{3F180F75-ED36-418E-B989-B900CE0380EB}"/>
          </ac:spMkLst>
        </pc:spChg>
        <pc:spChg chg="add del mod">
          <ac:chgData name="Amanda Gibson" userId="907984a6-cd77-4b7d-b1f8-6dfd5dda5862" providerId="ADAL" clId="{161B03EE-95FE-457B-869D-1BF7800899D4}" dt="2021-02-08T01:15:47.417" v="4540" actId="478"/>
          <ac:spMkLst>
            <pc:docMk/>
            <pc:sldMk cId="2341376025" sldId="286"/>
            <ac:spMk id="106" creationId="{25EFD942-60D2-4AC2-8439-7FFC97752B70}"/>
          </ac:spMkLst>
        </pc:spChg>
        <pc:spChg chg="add del mod">
          <ac:chgData name="Amanda Gibson" userId="907984a6-cd77-4b7d-b1f8-6dfd5dda5862" providerId="ADAL" clId="{161B03EE-95FE-457B-869D-1BF7800899D4}" dt="2021-02-08T01:15:47.417" v="4540" actId="478"/>
          <ac:spMkLst>
            <pc:docMk/>
            <pc:sldMk cId="2341376025" sldId="286"/>
            <ac:spMk id="107" creationId="{A10CA7A5-E3FD-4907-93CD-CD5E7D7D0002}"/>
          </ac:spMkLst>
        </pc:spChg>
        <pc:spChg chg="add del mod">
          <ac:chgData name="Amanda Gibson" userId="907984a6-cd77-4b7d-b1f8-6dfd5dda5862" providerId="ADAL" clId="{161B03EE-95FE-457B-869D-1BF7800899D4}" dt="2021-02-08T01:15:47.417" v="4540" actId="478"/>
          <ac:spMkLst>
            <pc:docMk/>
            <pc:sldMk cId="2341376025" sldId="286"/>
            <ac:spMk id="108" creationId="{6E1490AB-FBA7-4E8C-A59C-06E457F313CF}"/>
          </ac:spMkLst>
        </pc:spChg>
        <pc:spChg chg="add mod">
          <ac:chgData name="Amanda Gibson" userId="907984a6-cd77-4b7d-b1f8-6dfd5dda5862" providerId="ADAL" clId="{161B03EE-95FE-457B-869D-1BF7800899D4}" dt="2021-02-08T01:21:54.046" v="4734" actId="20577"/>
          <ac:spMkLst>
            <pc:docMk/>
            <pc:sldMk cId="2341376025" sldId="286"/>
            <ac:spMk id="109" creationId="{6060DD13-5E8E-40AC-B9F6-ACA988540C0A}"/>
          </ac:spMkLst>
        </pc:spChg>
        <pc:spChg chg="add mod">
          <ac:chgData name="Amanda Gibson" userId="907984a6-cd77-4b7d-b1f8-6dfd5dda5862" providerId="ADAL" clId="{161B03EE-95FE-457B-869D-1BF7800899D4}" dt="2021-02-08T01:21:56.298" v="4735" actId="20577"/>
          <ac:spMkLst>
            <pc:docMk/>
            <pc:sldMk cId="2341376025" sldId="286"/>
            <ac:spMk id="110" creationId="{69B87198-A706-428C-9718-ABFDA3B733F5}"/>
          </ac:spMkLst>
        </pc:spChg>
        <pc:spChg chg="add mod">
          <ac:chgData name="Amanda Gibson" userId="907984a6-cd77-4b7d-b1f8-6dfd5dda5862" providerId="ADAL" clId="{161B03EE-95FE-457B-869D-1BF7800899D4}" dt="2021-02-08T01:21:58.392" v="4736" actId="20577"/>
          <ac:spMkLst>
            <pc:docMk/>
            <pc:sldMk cId="2341376025" sldId="286"/>
            <ac:spMk id="111" creationId="{AAC1C26B-0EF3-409D-98E3-2AD7928E6068}"/>
          </ac:spMkLst>
        </pc:spChg>
        <pc:spChg chg="add del mod">
          <ac:chgData name="Amanda Gibson" userId="907984a6-cd77-4b7d-b1f8-6dfd5dda5862" providerId="ADAL" clId="{161B03EE-95FE-457B-869D-1BF7800899D4}" dt="2021-02-08T01:15:59.016" v="4543" actId="478"/>
          <ac:spMkLst>
            <pc:docMk/>
            <pc:sldMk cId="2341376025" sldId="286"/>
            <ac:spMk id="112" creationId="{B3204279-039B-4C3D-92B8-6B8F31BA31E0}"/>
          </ac:spMkLst>
        </pc:spChg>
        <pc:spChg chg="add del mod">
          <ac:chgData name="Amanda Gibson" userId="907984a6-cd77-4b7d-b1f8-6dfd5dda5862" providerId="ADAL" clId="{161B03EE-95FE-457B-869D-1BF7800899D4}" dt="2021-02-08T01:15:50.372" v="4541" actId="478"/>
          <ac:spMkLst>
            <pc:docMk/>
            <pc:sldMk cId="2341376025" sldId="286"/>
            <ac:spMk id="113" creationId="{9F625BB9-0081-4E65-AFBA-8D800337432F}"/>
          </ac:spMkLst>
        </pc:spChg>
        <pc:spChg chg="add del mod">
          <ac:chgData name="Amanda Gibson" userId="907984a6-cd77-4b7d-b1f8-6dfd5dda5862" providerId="ADAL" clId="{161B03EE-95FE-457B-869D-1BF7800899D4}" dt="2021-02-08T01:15:56.671" v="4542" actId="478"/>
          <ac:spMkLst>
            <pc:docMk/>
            <pc:sldMk cId="2341376025" sldId="286"/>
            <ac:spMk id="114" creationId="{44A83298-E708-451D-9D82-48546556B779}"/>
          </ac:spMkLst>
        </pc:spChg>
        <pc:spChg chg="add mod">
          <ac:chgData name="Amanda Gibson" userId="907984a6-cd77-4b7d-b1f8-6dfd5dda5862" providerId="ADAL" clId="{161B03EE-95FE-457B-869D-1BF7800899D4}" dt="2021-02-08T01:22:01.613" v="4737" actId="20577"/>
          <ac:spMkLst>
            <pc:docMk/>
            <pc:sldMk cId="2341376025" sldId="286"/>
            <ac:spMk id="115" creationId="{8589A5DF-11B7-45C0-A72C-CAE47CFADF09}"/>
          </ac:spMkLst>
        </pc:spChg>
        <pc:spChg chg="add del mod">
          <ac:chgData name="Amanda Gibson" userId="907984a6-cd77-4b7d-b1f8-6dfd5dda5862" providerId="ADAL" clId="{161B03EE-95FE-457B-869D-1BF7800899D4}" dt="2021-02-08T01:16:05.902" v="4544" actId="478"/>
          <ac:spMkLst>
            <pc:docMk/>
            <pc:sldMk cId="2341376025" sldId="286"/>
            <ac:spMk id="116" creationId="{E72096DB-F5EB-4B1F-9F89-2242A89F1B41}"/>
          </ac:spMkLst>
        </pc:spChg>
        <pc:spChg chg="add del mod">
          <ac:chgData name="Amanda Gibson" userId="907984a6-cd77-4b7d-b1f8-6dfd5dda5862" providerId="ADAL" clId="{161B03EE-95FE-457B-869D-1BF7800899D4}" dt="2021-02-08T01:16:05.902" v="4544" actId="478"/>
          <ac:spMkLst>
            <pc:docMk/>
            <pc:sldMk cId="2341376025" sldId="286"/>
            <ac:spMk id="117" creationId="{11EF380E-16AC-4201-8CDF-3BEE3F46D9C9}"/>
          </ac:spMkLst>
        </pc:spChg>
        <pc:spChg chg="add del mod">
          <ac:chgData name="Amanda Gibson" userId="907984a6-cd77-4b7d-b1f8-6dfd5dda5862" providerId="ADAL" clId="{161B03EE-95FE-457B-869D-1BF7800899D4}" dt="2021-02-08T01:16:05.902" v="4544" actId="478"/>
          <ac:spMkLst>
            <pc:docMk/>
            <pc:sldMk cId="2341376025" sldId="286"/>
            <ac:spMk id="118" creationId="{7A32D1E3-E041-45D1-816A-F9F4E068C609}"/>
          </ac:spMkLst>
        </pc:spChg>
        <pc:spChg chg="add mod">
          <ac:chgData name="Amanda Gibson" userId="907984a6-cd77-4b7d-b1f8-6dfd5dda5862" providerId="ADAL" clId="{161B03EE-95FE-457B-869D-1BF7800899D4}" dt="2021-02-08T01:22:04.614" v="4738" actId="20577"/>
          <ac:spMkLst>
            <pc:docMk/>
            <pc:sldMk cId="2341376025" sldId="286"/>
            <ac:spMk id="119" creationId="{CC2922FC-7BB8-4805-BE54-88F9BDD672D1}"/>
          </ac:spMkLst>
        </pc:spChg>
        <pc:spChg chg="add mod">
          <ac:chgData name="Amanda Gibson" userId="907984a6-cd77-4b7d-b1f8-6dfd5dda5862" providerId="ADAL" clId="{161B03EE-95FE-457B-869D-1BF7800899D4}" dt="2021-02-08T01:14:02.297" v="4405"/>
          <ac:spMkLst>
            <pc:docMk/>
            <pc:sldMk cId="2341376025" sldId="286"/>
            <ac:spMk id="120" creationId="{096F04EA-A040-44A9-AFDB-5F60F01F0B87}"/>
          </ac:spMkLst>
        </pc:spChg>
        <pc:spChg chg="add mod">
          <ac:chgData name="Amanda Gibson" userId="907984a6-cd77-4b7d-b1f8-6dfd5dda5862" providerId="ADAL" clId="{161B03EE-95FE-457B-869D-1BF7800899D4}" dt="2021-02-08T01:14:02.297" v="4405"/>
          <ac:spMkLst>
            <pc:docMk/>
            <pc:sldMk cId="2341376025" sldId="286"/>
            <ac:spMk id="121" creationId="{37041C17-0262-46E7-9A6F-CD6F73B5A23B}"/>
          </ac:spMkLst>
        </pc:spChg>
        <pc:spChg chg="add mod ord">
          <ac:chgData name="Amanda Gibson" userId="907984a6-cd77-4b7d-b1f8-6dfd5dda5862" providerId="ADAL" clId="{161B03EE-95FE-457B-869D-1BF7800899D4}" dt="2021-02-08T01:19:14.421" v="4599" actId="20577"/>
          <ac:spMkLst>
            <pc:docMk/>
            <pc:sldMk cId="2341376025" sldId="286"/>
            <ac:spMk id="122" creationId="{D1D1982A-B4D6-41F2-B28B-2532BD1E25C7}"/>
          </ac:spMkLst>
        </pc:spChg>
        <pc:spChg chg="add mod ord">
          <ac:chgData name="Amanda Gibson" userId="907984a6-cd77-4b7d-b1f8-6dfd5dda5862" providerId="ADAL" clId="{161B03EE-95FE-457B-869D-1BF7800899D4}" dt="2021-02-08T01:19:28.834" v="4611" actId="20577"/>
          <ac:spMkLst>
            <pc:docMk/>
            <pc:sldMk cId="2341376025" sldId="286"/>
            <ac:spMk id="123" creationId="{500CF3E1-13F2-4B40-96AB-FB4E24757961}"/>
          </ac:spMkLst>
        </pc:spChg>
        <pc:spChg chg="add mod ord">
          <ac:chgData name="Amanda Gibson" userId="907984a6-cd77-4b7d-b1f8-6dfd5dda5862" providerId="ADAL" clId="{161B03EE-95FE-457B-869D-1BF7800899D4}" dt="2021-02-08T01:19:36.258" v="4619" actId="20577"/>
          <ac:spMkLst>
            <pc:docMk/>
            <pc:sldMk cId="2341376025" sldId="286"/>
            <ac:spMk id="124" creationId="{BBC82ADC-8DD9-44AF-8692-D301AC7E9A70}"/>
          </ac:spMkLst>
        </pc:spChg>
        <pc:spChg chg="add mod ord">
          <ac:chgData name="Amanda Gibson" userId="907984a6-cd77-4b7d-b1f8-6dfd5dda5862" providerId="ADAL" clId="{161B03EE-95FE-457B-869D-1BF7800899D4}" dt="2021-02-08T01:19:43.257" v="4625" actId="20577"/>
          <ac:spMkLst>
            <pc:docMk/>
            <pc:sldMk cId="2341376025" sldId="286"/>
            <ac:spMk id="125" creationId="{CE7534F3-0D54-4E2B-9C0D-EEEE055E6B47}"/>
          </ac:spMkLst>
        </pc:spChg>
        <pc:cxnChg chg="del">
          <ac:chgData name="Amanda Gibson" userId="907984a6-cd77-4b7d-b1f8-6dfd5dda5862" providerId="ADAL" clId="{161B03EE-95FE-457B-869D-1BF7800899D4}" dt="2021-02-08T01:14:01.185" v="4404" actId="478"/>
          <ac:cxnSpMkLst>
            <pc:docMk/>
            <pc:sldMk cId="2341376025" sldId="286"/>
            <ac:cxnSpMk id="4" creationId="{BBA85397-CC20-4B9B-9F65-005390E6F737}"/>
          </ac:cxnSpMkLst>
        </pc:cxnChg>
        <pc:cxnChg chg="del">
          <ac:chgData name="Amanda Gibson" userId="907984a6-cd77-4b7d-b1f8-6dfd5dda5862" providerId="ADAL" clId="{161B03EE-95FE-457B-869D-1BF7800899D4}" dt="2021-02-08T01:14:01.185" v="4404" actId="478"/>
          <ac:cxnSpMkLst>
            <pc:docMk/>
            <pc:sldMk cId="2341376025" sldId="286"/>
            <ac:cxnSpMk id="11" creationId="{D5399204-A56F-4E35-BB37-F8A94BFDACEF}"/>
          </ac:cxnSpMkLst>
        </pc:cxnChg>
        <pc:cxnChg chg="add mod">
          <ac:chgData name="Amanda Gibson" userId="907984a6-cd77-4b7d-b1f8-6dfd5dda5862" providerId="ADAL" clId="{161B03EE-95FE-457B-869D-1BF7800899D4}" dt="2021-02-08T01:14:02.297" v="4405"/>
          <ac:cxnSpMkLst>
            <pc:docMk/>
            <pc:sldMk cId="2341376025" sldId="286"/>
            <ac:cxnSpMk id="34" creationId="{F2A917D8-AA09-4F22-81C1-C259D4B57583}"/>
          </ac:cxnSpMkLst>
        </pc:cxnChg>
        <pc:cxnChg chg="add del mod">
          <ac:chgData name="Amanda Gibson" userId="907984a6-cd77-4b7d-b1f8-6dfd5dda5862" providerId="ADAL" clId="{161B03EE-95FE-457B-869D-1BF7800899D4}" dt="2021-02-08T01:15:42.492" v="4539" actId="478"/>
          <ac:cxnSpMkLst>
            <pc:docMk/>
            <pc:sldMk cId="2341376025" sldId="286"/>
            <ac:cxnSpMk id="35" creationId="{1236BE40-8A7B-4DB3-981F-6D63C03D901A}"/>
          </ac:cxnSpMkLst>
        </pc:cxnChg>
        <pc:cxnChg chg="add del mod">
          <ac:chgData name="Amanda Gibson" userId="907984a6-cd77-4b7d-b1f8-6dfd5dda5862" providerId="ADAL" clId="{161B03EE-95FE-457B-869D-1BF7800899D4}" dt="2021-02-08T01:15:42.492" v="4539" actId="478"/>
          <ac:cxnSpMkLst>
            <pc:docMk/>
            <pc:sldMk cId="2341376025" sldId="286"/>
            <ac:cxnSpMk id="36" creationId="{1A13D86A-C8A1-4D62-9B95-0B3E0E71FF54}"/>
          </ac:cxnSpMkLst>
        </pc:cxnChg>
        <pc:cxnChg chg="add del mod">
          <ac:chgData name="Amanda Gibson" userId="907984a6-cd77-4b7d-b1f8-6dfd5dda5862" providerId="ADAL" clId="{161B03EE-95FE-457B-869D-1BF7800899D4}" dt="2021-02-08T01:15:26.992" v="4538" actId="478"/>
          <ac:cxnSpMkLst>
            <pc:docMk/>
            <pc:sldMk cId="2341376025" sldId="286"/>
            <ac:cxnSpMk id="38" creationId="{09B2289E-F02B-428E-B511-DEAB1B34F0F3}"/>
          </ac:cxnSpMkLst>
        </pc:cxnChg>
        <pc:cxnChg chg="add del mod">
          <ac:chgData name="Amanda Gibson" userId="907984a6-cd77-4b7d-b1f8-6dfd5dda5862" providerId="ADAL" clId="{161B03EE-95FE-457B-869D-1BF7800899D4}" dt="2021-02-08T01:15:26.992" v="4538" actId="478"/>
          <ac:cxnSpMkLst>
            <pc:docMk/>
            <pc:sldMk cId="2341376025" sldId="286"/>
            <ac:cxnSpMk id="39" creationId="{4B7B9466-5977-4660-8DCA-2BFCB21B5A29}"/>
          </ac:cxnSpMkLst>
        </pc:cxnChg>
        <pc:cxnChg chg="add del mod">
          <ac:chgData name="Amanda Gibson" userId="907984a6-cd77-4b7d-b1f8-6dfd5dda5862" providerId="ADAL" clId="{161B03EE-95FE-457B-869D-1BF7800899D4}" dt="2021-02-08T01:15:47.417" v="4540" actId="478"/>
          <ac:cxnSpMkLst>
            <pc:docMk/>
            <pc:sldMk cId="2341376025" sldId="286"/>
            <ac:cxnSpMk id="40" creationId="{3A168C01-C8D7-42A9-B95F-150F3E47F5CB}"/>
          </ac:cxnSpMkLst>
        </pc:cxnChg>
        <pc:cxnChg chg="add del mod">
          <ac:chgData name="Amanda Gibson" userId="907984a6-cd77-4b7d-b1f8-6dfd5dda5862" providerId="ADAL" clId="{161B03EE-95FE-457B-869D-1BF7800899D4}" dt="2021-02-08T01:15:47.417" v="4540" actId="478"/>
          <ac:cxnSpMkLst>
            <pc:docMk/>
            <pc:sldMk cId="2341376025" sldId="286"/>
            <ac:cxnSpMk id="41" creationId="{62700230-DC5B-4023-9DDD-C3FD29513974}"/>
          </ac:cxnSpMkLst>
        </pc:cxnChg>
        <pc:cxnChg chg="add del mod">
          <ac:chgData name="Amanda Gibson" userId="907984a6-cd77-4b7d-b1f8-6dfd5dda5862" providerId="ADAL" clId="{161B03EE-95FE-457B-869D-1BF7800899D4}" dt="2021-02-08T01:15:47.417" v="4540" actId="478"/>
          <ac:cxnSpMkLst>
            <pc:docMk/>
            <pc:sldMk cId="2341376025" sldId="286"/>
            <ac:cxnSpMk id="42" creationId="{12EA5E85-3C1F-41AF-B7CA-4AAAE14D0DB8}"/>
          </ac:cxnSpMkLst>
        </pc:cxnChg>
        <pc:cxnChg chg="add del mod">
          <ac:chgData name="Amanda Gibson" userId="907984a6-cd77-4b7d-b1f8-6dfd5dda5862" providerId="ADAL" clId="{161B03EE-95FE-457B-869D-1BF7800899D4}" dt="2021-02-08T01:15:47.417" v="4540" actId="478"/>
          <ac:cxnSpMkLst>
            <pc:docMk/>
            <pc:sldMk cId="2341376025" sldId="286"/>
            <ac:cxnSpMk id="43" creationId="{20BF1209-D7CD-422A-8AFA-0FE6F117FE66}"/>
          </ac:cxnSpMkLst>
        </pc:cxnChg>
        <pc:cxnChg chg="add mod">
          <ac:chgData name="Amanda Gibson" userId="907984a6-cd77-4b7d-b1f8-6dfd5dda5862" providerId="ADAL" clId="{161B03EE-95FE-457B-869D-1BF7800899D4}" dt="2021-02-08T01:14:02.297" v="4405"/>
          <ac:cxnSpMkLst>
            <pc:docMk/>
            <pc:sldMk cId="2341376025" sldId="286"/>
            <ac:cxnSpMk id="46" creationId="{5CB3EE82-0234-4F81-90D0-D87F923EE4AA}"/>
          </ac:cxnSpMkLst>
        </pc:cxnChg>
        <pc:cxnChg chg="add mod">
          <ac:chgData name="Amanda Gibson" userId="907984a6-cd77-4b7d-b1f8-6dfd5dda5862" providerId="ADAL" clId="{161B03EE-95FE-457B-869D-1BF7800899D4}" dt="2021-02-08T01:14:02.297" v="4405"/>
          <ac:cxnSpMkLst>
            <pc:docMk/>
            <pc:sldMk cId="2341376025" sldId="286"/>
            <ac:cxnSpMk id="49" creationId="{B5E8C635-4938-42A2-BD75-A83BAB84AB40}"/>
          </ac:cxnSpMkLst>
        </pc:cxnChg>
        <pc:cxnChg chg="add mod">
          <ac:chgData name="Amanda Gibson" userId="907984a6-cd77-4b7d-b1f8-6dfd5dda5862" providerId="ADAL" clId="{161B03EE-95FE-457B-869D-1BF7800899D4}" dt="2021-02-08T01:14:02.297" v="4405"/>
          <ac:cxnSpMkLst>
            <pc:docMk/>
            <pc:sldMk cId="2341376025" sldId="286"/>
            <ac:cxnSpMk id="51" creationId="{ABC37F7C-8905-4810-844A-32C81344656D}"/>
          </ac:cxnSpMkLst>
        </pc:cxnChg>
        <pc:cxnChg chg="add del mod">
          <ac:chgData name="Amanda Gibson" userId="907984a6-cd77-4b7d-b1f8-6dfd5dda5862" providerId="ADAL" clId="{161B03EE-95FE-457B-869D-1BF7800899D4}" dt="2021-02-08T01:15:50.372" v="4541" actId="478"/>
          <ac:cxnSpMkLst>
            <pc:docMk/>
            <pc:sldMk cId="2341376025" sldId="286"/>
            <ac:cxnSpMk id="52" creationId="{3DB15548-B75A-4C74-A7CF-DB0994626C76}"/>
          </ac:cxnSpMkLst>
        </pc:cxnChg>
        <pc:cxnChg chg="del">
          <ac:chgData name="Amanda Gibson" userId="907984a6-cd77-4b7d-b1f8-6dfd5dda5862" providerId="ADAL" clId="{161B03EE-95FE-457B-869D-1BF7800899D4}" dt="2021-02-08T01:14:01.185" v="4404" actId="478"/>
          <ac:cxnSpMkLst>
            <pc:docMk/>
            <pc:sldMk cId="2341376025" sldId="286"/>
            <ac:cxnSpMk id="53" creationId="{DA4046F3-1FF5-4AF0-89FB-2C774766A340}"/>
          </ac:cxnSpMkLst>
        </pc:cxnChg>
        <pc:cxnChg chg="add del mod">
          <ac:chgData name="Amanda Gibson" userId="907984a6-cd77-4b7d-b1f8-6dfd5dda5862" providerId="ADAL" clId="{161B03EE-95FE-457B-869D-1BF7800899D4}" dt="2021-02-08T01:15:50.372" v="4541" actId="478"/>
          <ac:cxnSpMkLst>
            <pc:docMk/>
            <pc:sldMk cId="2341376025" sldId="286"/>
            <ac:cxnSpMk id="55" creationId="{95AAFE59-3BDB-4E06-A74E-F767F2FD8FDD}"/>
          </ac:cxnSpMkLst>
        </pc:cxnChg>
        <pc:cxnChg chg="del">
          <ac:chgData name="Amanda Gibson" userId="907984a6-cd77-4b7d-b1f8-6dfd5dda5862" providerId="ADAL" clId="{161B03EE-95FE-457B-869D-1BF7800899D4}" dt="2021-02-08T01:14:01.185" v="4404" actId="478"/>
          <ac:cxnSpMkLst>
            <pc:docMk/>
            <pc:sldMk cId="2341376025" sldId="286"/>
            <ac:cxnSpMk id="56" creationId="{4E2FA796-806A-4296-8581-DFC3A22ECA86}"/>
          </ac:cxnSpMkLst>
        </pc:cxnChg>
        <pc:cxnChg chg="add del mod">
          <ac:chgData name="Amanda Gibson" userId="907984a6-cd77-4b7d-b1f8-6dfd5dda5862" providerId="ADAL" clId="{161B03EE-95FE-457B-869D-1BF7800899D4}" dt="2021-02-08T01:15:50.372" v="4541" actId="478"/>
          <ac:cxnSpMkLst>
            <pc:docMk/>
            <pc:sldMk cId="2341376025" sldId="286"/>
            <ac:cxnSpMk id="57" creationId="{EFD483B6-7299-4CBD-B9EB-E3D2E481526A}"/>
          </ac:cxnSpMkLst>
        </pc:cxnChg>
        <pc:cxnChg chg="add mod">
          <ac:chgData name="Amanda Gibson" userId="907984a6-cd77-4b7d-b1f8-6dfd5dda5862" providerId="ADAL" clId="{161B03EE-95FE-457B-869D-1BF7800899D4}" dt="2021-02-08T01:14:02.297" v="4405"/>
          <ac:cxnSpMkLst>
            <pc:docMk/>
            <pc:sldMk cId="2341376025" sldId="286"/>
            <ac:cxnSpMk id="60" creationId="{E632A8B1-3649-49A7-B57B-C6D10F953DD8}"/>
          </ac:cxnSpMkLst>
        </pc:cxnChg>
        <pc:cxnChg chg="del">
          <ac:chgData name="Amanda Gibson" userId="907984a6-cd77-4b7d-b1f8-6dfd5dda5862" providerId="ADAL" clId="{161B03EE-95FE-457B-869D-1BF7800899D4}" dt="2021-02-08T01:14:01.185" v="4404" actId="478"/>
          <ac:cxnSpMkLst>
            <pc:docMk/>
            <pc:sldMk cId="2341376025" sldId="286"/>
            <ac:cxnSpMk id="61" creationId="{498CE6F1-5676-4D21-911C-31707F403203}"/>
          </ac:cxnSpMkLst>
        </pc:cxnChg>
        <pc:cxnChg chg="add del mod">
          <ac:chgData name="Amanda Gibson" userId="907984a6-cd77-4b7d-b1f8-6dfd5dda5862" providerId="ADAL" clId="{161B03EE-95FE-457B-869D-1BF7800899D4}" dt="2021-02-08T01:16:05.902" v="4544" actId="478"/>
          <ac:cxnSpMkLst>
            <pc:docMk/>
            <pc:sldMk cId="2341376025" sldId="286"/>
            <ac:cxnSpMk id="62" creationId="{351709A0-9586-4C87-8BC8-7E7842403E72}"/>
          </ac:cxnSpMkLst>
        </pc:cxnChg>
        <pc:cxnChg chg="add del mod">
          <ac:chgData name="Amanda Gibson" userId="907984a6-cd77-4b7d-b1f8-6dfd5dda5862" providerId="ADAL" clId="{161B03EE-95FE-457B-869D-1BF7800899D4}" dt="2021-02-08T01:16:05.902" v="4544" actId="478"/>
          <ac:cxnSpMkLst>
            <pc:docMk/>
            <pc:sldMk cId="2341376025" sldId="286"/>
            <ac:cxnSpMk id="63" creationId="{93E65585-A200-4AC9-BEE9-CEA23830A7DA}"/>
          </ac:cxnSpMkLst>
        </pc:cxnChg>
        <pc:cxnChg chg="del">
          <ac:chgData name="Amanda Gibson" userId="907984a6-cd77-4b7d-b1f8-6dfd5dda5862" providerId="ADAL" clId="{161B03EE-95FE-457B-869D-1BF7800899D4}" dt="2021-02-08T01:14:01.185" v="4404" actId="478"/>
          <ac:cxnSpMkLst>
            <pc:docMk/>
            <pc:sldMk cId="2341376025" sldId="286"/>
            <ac:cxnSpMk id="64" creationId="{70430FA3-15C3-4ACC-B736-B019C8C1BE3F}"/>
          </ac:cxnSpMkLst>
        </pc:cxnChg>
        <pc:cxnChg chg="add del mod">
          <ac:chgData name="Amanda Gibson" userId="907984a6-cd77-4b7d-b1f8-6dfd5dda5862" providerId="ADAL" clId="{161B03EE-95FE-457B-869D-1BF7800899D4}" dt="2021-02-08T01:16:05.902" v="4544" actId="478"/>
          <ac:cxnSpMkLst>
            <pc:docMk/>
            <pc:sldMk cId="2341376025" sldId="286"/>
            <ac:cxnSpMk id="65" creationId="{39EF2FCF-BA72-460F-8293-AC158E9050EA}"/>
          </ac:cxnSpMkLst>
        </pc:cxnChg>
        <pc:cxnChg chg="add mod">
          <ac:chgData name="Amanda Gibson" userId="907984a6-cd77-4b7d-b1f8-6dfd5dda5862" providerId="ADAL" clId="{161B03EE-95FE-457B-869D-1BF7800899D4}" dt="2021-02-08T01:14:02.297" v="4405"/>
          <ac:cxnSpMkLst>
            <pc:docMk/>
            <pc:sldMk cId="2341376025" sldId="286"/>
            <ac:cxnSpMk id="66" creationId="{A0325E31-CC59-44F7-94FD-3404F8F56D35}"/>
          </ac:cxnSpMkLst>
        </pc:cxnChg>
        <pc:cxnChg chg="add mod">
          <ac:chgData name="Amanda Gibson" userId="907984a6-cd77-4b7d-b1f8-6dfd5dda5862" providerId="ADAL" clId="{161B03EE-95FE-457B-869D-1BF7800899D4}" dt="2021-02-08T01:14:02.297" v="4405"/>
          <ac:cxnSpMkLst>
            <pc:docMk/>
            <pc:sldMk cId="2341376025" sldId="286"/>
            <ac:cxnSpMk id="67" creationId="{5714644C-2281-4F4F-92A9-147BE6F41E09}"/>
          </ac:cxnSpMkLst>
        </pc:cxnChg>
        <pc:cxnChg chg="del">
          <ac:chgData name="Amanda Gibson" userId="907984a6-cd77-4b7d-b1f8-6dfd5dda5862" providerId="ADAL" clId="{161B03EE-95FE-457B-869D-1BF7800899D4}" dt="2021-02-08T01:14:01.185" v="4404" actId="478"/>
          <ac:cxnSpMkLst>
            <pc:docMk/>
            <pc:sldMk cId="2341376025" sldId="286"/>
            <ac:cxnSpMk id="68" creationId="{568B8FAB-BB61-40DA-8202-6E34571A5B57}"/>
          </ac:cxnSpMkLst>
        </pc:cxnChg>
        <pc:cxnChg chg="add del mod">
          <ac:chgData name="Amanda Gibson" userId="907984a6-cd77-4b7d-b1f8-6dfd5dda5862" providerId="ADAL" clId="{161B03EE-95FE-457B-869D-1BF7800899D4}" dt="2021-02-08T01:21:27.703" v="4722"/>
          <ac:cxnSpMkLst>
            <pc:docMk/>
            <pc:sldMk cId="2341376025" sldId="286"/>
            <ac:cxnSpMk id="126" creationId="{FC5F82EF-0440-4CB5-93BE-CE62791BE719}"/>
          </ac:cxnSpMkLst>
        </pc:cxnChg>
      </pc:sldChg>
      <pc:sldChg chg="addSp delSp modSp add mod">
        <pc:chgData name="Amanda Gibson" userId="907984a6-cd77-4b7d-b1f8-6dfd5dda5862" providerId="ADAL" clId="{161B03EE-95FE-457B-869D-1BF7800899D4}" dt="2021-02-08T01:27:13.062" v="4989" actId="208"/>
        <pc:sldMkLst>
          <pc:docMk/>
          <pc:sldMk cId="1792043383" sldId="287"/>
        </pc:sldMkLst>
        <pc:spChg chg="mod">
          <ac:chgData name="Amanda Gibson" userId="907984a6-cd77-4b7d-b1f8-6dfd5dda5862" providerId="ADAL" clId="{161B03EE-95FE-457B-869D-1BF7800899D4}" dt="2021-02-08T01:20:18.977" v="4711" actId="1076"/>
          <ac:spMkLst>
            <pc:docMk/>
            <pc:sldMk cId="1792043383" sldId="287"/>
            <ac:spMk id="2" creationId="{28C08DB6-BD44-4401-A786-2D06627D7C16}"/>
          </ac:spMkLst>
        </pc:spChg>
        <pc:spChg chg="add mod">
          <ac:chgData name="Amanda Gibson" userId="907984a6-cd77-4b7d-b1f8-6dfd5dda5862" providerId="ADAL" clId="{161B03EE-95FE-457B-869D-1BF7800899D4}" dt="2021-02-08T01:23:54.860" v="4751" actId="571"/>
          <ac:spMkLst>
            <pc:docMk/>
            <pc:sldMk cId="1792043383" sldId="287"/>
            <ac:spMk id="37" creationId="{F7977A75-1678-42B8-BB1B-FE96AB5B75A7}"/>
          </ac:spMkLst>
        </pc:spChg>
        <pc:spChg chg="add mod">
          <ac:chgData name="Amanda Gibson" userId="907984a6-cd77-4b7d-b1f8-6dfd5dda5862" providerId="ADAL" clId="{161B03EE-95FE-457B-869D-1BF7800899D4}" dt="2021-02-08T01:23:54.860" v="4751" actId="571"/>
          <ac:spMkLst>
            <pc:docMk/>
            <pc:sldMk cId="1792043383" sldId="287"/>
            <ac:spMk id="40" creationId="{96A89F5F-6703-4462-9F46-EDFFE99EF633}"/>
          </ac:spMkLst>
        </pc:spChg>
        <pc:spChg chg="add mod">
          <ac:chgData name="Amanda Gibson" userId="907984a6-cd77-4b7d-b1f8-6dfd5dda5862" providerId="ADAL" clId="{161B03EE-95FE-457B-869D-1BF7800899D4}" dt="2021-02-08T01:23:54.860" v="4751" actId="571"/>
          <ac:spMkLst>
            <pc:docMk/>
            <pc:sldMk cId="1792043383" sldId="287"/>
            <ac:spMk id="41" creationId="{C4C365F6-0C57-49E2-AE6F-8C4E87DE112B}"/>
          </ac:spMkLst>
        </pc:spChg>
        <pc:spChg chg="mod">
          <ac:chgData name="Amanda Gibson" userId="907984a6-cd77-4b7d-b1f8-6dfd5dda5862" providerId="ADAL" clId="{161B03EE-95FE-457B-869D-1BF7800899D4}" dt="2021-02-08T01:20:57.223" v="4717" actId="1076"/>
          <ac:spMkLst>
            <pc:docMk/>
            <pc:sldMk cId="1792043383" sldId="287"/>
            <ac:spMk id="89" creationId="{F6B6002F-5E81-4BA1-B6D0-ABC65AFFB17D}"/>
          </ac:spMkLst>
        </pc:spChg>
        <pc:spChg chg="mod">
          <ac:chgData name="Amanda Gibson" userId="907984a6-cd77-4b7d-b1f8-6dfd5dda5862" providerId="ADAL" clId="{161B03EE-95FE-457B-869D-1BF7800899D4}" dt="2021-02-08T01:20:57.223" v="4717" actId="1076"/>
          <ac:spMkLst>
            <pc:docMk/>
            <pc:sldMk cId="1792043383" sldId="287"/>
            <ac:spMk id="90" creationId="{5588F674-1BDB-4F23-A205-1952182558C6}"/>
          </ac:spMkLst>
        </pc:spChg>
        <pc:spChg chg="mod">
          <ac:chgData name="Amanda Gibson" userId="907984a6-cd77-4b7d-b1f8-6dfd5dda5862" providerId="ADAL" clId="{161B03EE-95FE-457B-869D-1BF7800899D4}" dt="2021-02-08T01:21:09.146" v="4718" actId="1076"/>
          <ac:spMkLst>
            <pc:docMk/>
            <pc:sldMk cId="1792043383" sldId="287"/>
            <ac:spMk id="99" creationId="{14463CAA-B4D5-4220-A29B-B54081169A57}"/>
          </ac:spMkLst>
        </pc:spChg>
        <pc:spChg chg="del">
          <ac:chgData name="Amanda Gibson" userId="907984a6-cd77-4b7d-b1f8-6dfd5dda5862" providerId="ADAL" clId="{161B03EE-95FE-457B-869D-1BF7800899D4}" dt="2021-02-08T01:23:57.431" v="4752" actId="478"/>
          <ac:spMkLst>
            <pc:docMk/>
            <pc:sldMk cId="1792043383" sldId="287"/>
            <ac:spMk id="100" creationId="{470AB2E8-03D9-4071-8329-8063DB46FD0A}"/>
          </ac:spMkLst>
        </pc:spChg>
        <pc:spChg chg="mod">
          <ac:chgData name="Amanda Gibson" userId="907984a6-cd77-4b7d-b1f8-6dfd5dda5862" providerId="ADAL" clId="{161B03EE-95FE-457B-869D-1BF7800899D4}" dt="2021-02-08T01:22:33.226" v="4739" actId="20577"/>
          <ac:spMkLst>
            <pc:docMk/>
            <pc:sldMk cId="1792043383" sldId="287"/>
            <ac:spMk id="103" creationId="{F30E38B6-500B-40D2-A227-03FDB888FBA8}"/>
          </ac:spMkLst>
        </pc:spChg>
        <pc:spChg chg="mod">
          <ac:chgData name="Amanda Gibson" userId="907984a6-cd77-4b7d-b1f8-6dfd5dda5862" providerId="ADAL" clId="{161B03EE-95FE-457B-869D-1BF7800899D4}" dt="2021-02-08T01:22:35.502" v="4740" actId="20577"/>
          <ac:spMkLst>
            <pc:docMk/>
            <pc:sldMk cId="1792043383" sldId="287"/>
            <ac:spMk id="104" creationId="{299F0864-5921-4133-BC22-E152B0427FB1}"/>
          </ac:spMkLst>
        </pc:spChg>
        <pc:spChg chg="mod">
          <ac:chgData name="Amanda Gibson" userId="907984a6-cd77-4b7d-b1f8-6dfd5dda5862" providerId="ADAL" clId="{161B03EE-95FE-457B-869D-1BF7800899D4}" dt="2021-02-08T01:24:34.844" v="4762" actId="20577"/>
          <ac:spMkLst>
            <pc:docMk/>
            <pc:sldMk cId="1792043383" sldId="287"/>
            <ac:spMk id="109" creationId="{6060DD13-5E8E-40AC-B9F6-ACA988540C0A}"/>
          </ac:spMkLst>
        </pc:spChg>
        <pc:spChg chg="mod">
          <ac:chgData name="Amanda Gibson" userId="907984a6-cd77-4b7d-b1f8-6dfd5dda5862" providerId="ADAL" clId="{161B03EE-95FE-457B-869D-1BF7800899D4}" dt="2021-02-08T01:24:37.530" v="4763" actId="20577"/>
          <ac:spMkLst>
            <pc:docMk/>
            <pc:sldMk cId="1792043383" sldId="287"/>
            <ac:spMk id="110" creationId="{69B87198-A706-428C-9718-ABFDA3B733F5}"/>
          </ac:spMkLst>
        </pc:spChg>
        <pc:spChg chg="mod">
          <ac:chgData name="Amanda Gibson" userId="907984a6-cd77-4b7d-b1f8-6dfd5dda5862" providerId="ADAL" clId="{161B03EE-95FE-457B-869D-1BF7800899D4}" dt="2021-02-08T01:24:39.791" v="4764" actId="20577"/>
          <ac:spMkLst>
            <pc:docMk/>
            <pc:sldMk cId="1792043383" sldId="287"/>
            <ac:spMk id="111" creationId="{AAC1C26B-0EF3-409D-98E3-2AD7928E6068}"/>
          </ac:spMkLst>
        </pc:spChg>
        <pc:spChg chg="mod">
          <ac:chgData name="Amanda Gibson" userId="907984a6-cd77-4b7d-b1f8-6dfd5dda5862" providerId="ADAL" clId="{161B03EE-95FE-457B-869D-1BF7800899D4}" dt="2021-02-08T01:24:42.849" v="4765" actId="20577"/>
          <ac:spMkLst>
            <pc:docMk/>
            <pc:sldMk cId="1792043383" sldId="287"/>
            <ac:spMk id="115" creationId="{8589A5DF-11B7-45C0-A72C-CAE47CFADF09}"/>
          </ac:spMkLst>
        </pc:spChg>
        <pc:spChg chg="mod">
          <ac:chgData name="Amanda Gibson" userId="907984a6-cd77-4b7d-b1f8-6dfd5dda5862" providerId="ADAL" clId="{161B03EE-95FE-457B-869D-1BF7800899D4}" dt="2021-02-08T01:24:45.488" v="4766" actId="20577"/>
          <ac:spMkLst>
            <pc:docMk/>
            <pc:sldMk cId="1792043383" sldId="287"/>
            <ac:spMk id="119" creationId="{CC2922FC-7BB8-4805-BE54-88F9BDD672D1}"/>
          </ac:spMkLst>
        </pc:spChg>
        <pc:spChg chg="mod">
          <ac:chgData name="Amanda Gibson" userId="907984a6-cd77-4b7d-b1f8-6dfd5dda5862" providerId="ADAL" clId="{161B03EE-95FE-457B-869D-1BF7800899D4}" dt="2021-02-08T01:20:57.223" v="4717" actId="1076"/>
          <ac:spMkLst>
            <pc:docMk/>
            <pc:sldMk cId="1792043383" sldId="287"/>
            <ac:spMk id="123" creationId="{500CF3E1-13F2-4B40-96AB-FB4E24757961}"/>
          </ac:spMkLst>
        </pc:spChg>
        <pc:spChg chg="mod">
          <ac:chgData name="Amanda Gibson" userId="907984a6-cd77-4b7d-b1f8-6dfd5dda5862" providerId="ADAL" clId="{161B03EE-95FE-457B-869D-1BF7800899D4}" dt="2021-02-08T01:21:09.146" v="4718" actId="1076"/>
          <ac:spMkLst>
            <pc:docMk/>
            <pc:sldMk cId="1792043383" sldId="287"/>
            <ac:spMk id="125" creationId="{CE7534F3-0D54-4E2B-9C0D-EEEE055E6B47}"/>
          </ac:spMkLst>
        </pc:spChg>
        <pc:cxnChg chg="add del mod">
          <ac:chgData name="Amanda Gibson" userId="907984a6-cd77-4b7d-b1f8-6dfd5dda5862" providerId="ADAL" clId="{161B03EE-95FE-457B-869D-1BF7800899D4}" dt="2021-02-08T01:20:33.767" v="4715"/>
          <ac:cxnSpMkLst>
            <pc:docMk/>
            <pc:sldMk cId="1792043383" sldId="287"/>
            <ac:cxnSpMk id="35" creationId="{ABFCD969-173A-439B-A5F8-FF85F74698F3}"/>
          </ac:cxnSpMkLst>
        </pc:cxnChg>
        <pc:cxnChg chg="add mod">
          <ac:chgData name="Amanda Gibson" userId="907984a6-cd77-4b7d-b1f8-6dfd5dda5862" providerId="ADAL" clId="{161B03EE-95FE-457B-869D-1BF7800899D4}" dt="2021-02-08T01:20:39.379" v="4716" actId="571"/>
          <ac:cxnSpMkLst>
            <pc:docMk/>
            <pc:sldMk cId="1792043383" sldId="287"/>
            <ac:cxnSpMk id="36" creationId="{4194EDD0-3CE6-46FA-96E6-86A0B52070A5}"/>
          </ac:cxnSpMkLst>
        </pc:cxnChg>
        <pc:cxnChg chg="mod">
          <ac:chgData name="Amanda Gibson" userId="907984a6-cd77-4b7d-b1f8-6dfd5dda5862" providerId="ADAL" clId="{161B03EE-95FE-457B-869D-1BF7800899D4}" dt="2021-02-08T01:27:13.062" v="4989" actId="208"/>
          <ac:cxnSpMkLst>
            <pc:docMk/>
            <pc:sldMk cId="1792043383" sldId="287"/>
            <ac:cxnSpMk id="38" creationId="{09B2289E-F02B-428E-B511-DEAB1B34F0F3}"/>
          </ac:cxnSpMkLst>
        </pc:cxnChg>
        <pc:cxnChg chg="mod">
          <ac:chgData name="Amanda Gibson" userId="907984a6-cd77-4b7d-b1f8-6dfd5dda5862" providerId="ADAL" clId="{161B03EE-95FE-457B-869D-1BF7800899D4}" dt="2021-02-08T01:27:13.062" v="4989" actId="208"/>
          <ac:cxnSpMkLst>
            <pc:docMk/>
            <pc:sldMk cId="1792043383" sldId="287"/>
            <ac:cxnSpMk id="39" creationId="{4B7B9466-5977-4660-8DCA-2BFCB21B5A29}"/>
          </ac:cxnSpMkLst>
        </pc:cxnChg>
        <pc:cxnChg chg="add mod">
          <ac:chgData name="Amanda Gibson" userId="907984a6-cd77-4b7d-b1f8-6dfd5dda5862" providerId="ADAL" clId="{161B03EE-95FE-457B-869D-1BF7800899D4}" dt="2021-02-08T01:24:06.599" v="4755" actId="571"/>
          <ac:cxnSpMkLst>
            <pc:docMk/>
            <pc:sldMk cId="1792043383" sldId="287"/>
            <ac:cxnSpMk id="42" creationId="{D6915FFD-AB24-4C23-AF2E-0141B4FC1F2C}"/>
          </ac:cxnSpMkLst>
        </pc:cxnChg>
        <pc:cxnChg chg="add mod">
          <ac:chgData name="Amanda Gibson" userId="907984a6-cd77-4b7d-b1f8-6dfd5dda5862" providerId="ADAL" clId="{161B03EE-95FE-457B-869D-1BF7800899D4}" dt="2021-02-08T01:24:08.690" v="4756" actId="571"/>
          <ac:cxnSpMkLst>
            <pc:docMk/>
            <pc:sldMk cId="1792043383" sldId="287"/>
            <ac:cxnSpMk id="43" creationId="{281CB8DA-C9F2-4F12-87F8-87ABB7DF0E21}"/>
          </ac:cxnSpMkLst>
        </pc:cxnChg>
        <pc:cxnChg chg="add mod">
          <ac:chgData name="Amanda Gibson" userId="907984a6-cd77-4b7d-b1f8-6dfd5dda5862" providerId="ADAL" clId="{161B03EE-95FE-457B-869D-1BF7800899D4}" dt="2021-02-08T01:24:14.334" v="4759" actId="1076"/>
          <ac:cxnSpMkLst>
            <pc:docMk/>
            <pc:sldMk cId="1792043383" sldId="287"/>
            <ac:cxnSpMk id="44" creationId="{FB326302-4F96-40FC-BB1D-63037D61E7A2}"/>
          </ac:cxnSpMkLst>
        </pc:cxnChg>
        <pc:cxnChg chg="add mod">
          <ac:chgData name="Amanda Gibson" userId="907984a6-cd77-4b7d-b1f8-6dfd5dda5862" providerId="ADAL" clId="{161B03EE-95FE-457B-869D-1BF7800899D4}" dt="2021-02-08T01:24:18.734" v="4760" actId="571"/>
          <ac:cxnSpMkLst>
            <pc:docMk/>
            <pc:sldMk cId="1792043383" sldId="287"/>
            <ac:cxnSpMk id="45" creationId="{9E33AA6D-C126-4EB5-A693-9408FF0193EC}"/>
          </ac:cxnSpMkLst>
        </pc:cxnChg>
        <pc:cxnChg chg="mod">
          <ac:chgData name="Amanda Gibson" userId="907984a6-cd77-4b7d-b1f8-6dfd5dda5862" providerId="ADAL" clId="{161B03EE-95FE-457B-869D-1BF7800899D4}" dt="2021-02-08T01:27:13.062" v="4989" actId="208"/>
          <ac:cxnSpMkLst>
            <pc:docMk/>
            <pc:sldMk cId="1792043383" sldId="287"/>
            <ac:cxnSpMk id="46" creationId="{5CB3EE82-0234-4F81-90D0-D87F923EE4AA}"/>
          </ac:cxnSpMkLst>
        </pc:cxnChg>
        <pc:cxnChg chg="add mod">
          <ac:chgData name="Amanda Gibson" userId="907984a6-cd77-4b7d-b1f8-6dfd5dda5862" providerId="ADAL" clId="{161B03EE-95FE-457B-869D-1BF7800899D4}" dt="2021-02-08T01:24:21.286" v="4761" actId="571"/>
          <ac:cxnSpMkLst>
            <pc:docMk/>
            <pc:sldMk cId="1792043383" sldId="287"/>
            <ac:cxnSpMk id="47" creationId="{821F7EE7-3427-4E19-8918-B40DEE561B54}"/>
          </ac:cxnSpMkLst>
        </pc:cxnChg>
        <pc:cxnChg chg="mod">
          <ac:chgData name="Amanda Gibson" userId="907984a6-cd77-4b7d-b1f8-6dfd5dda5862" providerId="ADAL" clId="{161B03EE-95FE-457B-869D-1BF7800899D4}" dt="2021-02-08T01:27:13.062" v="4989" actId="208"/>
          <ac:cxnSpMkLst>
            <pc:docMk/>
            <pc:sldMk cId="1792043383" sldId="287"/>
            <ac:cxnSpMk id="49" creationId="{B5E8C635-4938-42A2-BD75-A83BAB84AB40}"/>
          </ac:cxnSpMkLst>
        </pc:cxnChg>
        <pc:cxnChg chg="mod">
          <ac:chgData name="Amanda Gibson" userId="907984a6-cd77-4b7d-b1f8-6dfd5dda5862" providerId="ADAL" clId="{161B03EE-95FE-457B-869D-1BF7800899D4}" dt="2021-02-08T01:27:13.062" v="4989" actId="208"/>
          <ac:cxnSpMkLst>
            <pc:docMk/>
            <pc:sldMk cId="1792043383" sldId="287"/>
            <ac:cxnSpMk id="51" creationId="{ABC37F7C-8905-4810-844A-32C81344656D}"/>
          </ac:cxnSpMkLst>
        </pc:cxnChg>
        <pc:cxnChg chg="mod">
          <ac:chgData name="Amanda Gibson" userId="907984a6-cd77-4b7d-b1f8-6dfd5dda5862" providerId="ADAL" clId="{161B03EE-95FE-457B-869D-1BF7800899D4}" dt="2021-02-08T01:27:13.062" v="4989" actId="208"/>
          <ac:cxnSpMkLst>
            <pc:docMk/>
            <pc:sldMk cId="1792043383" sldId="287"/>
            <ac:cxnSpMk id="60" creationId="{E632A8B1-3649-49A7-B57B-C6D10F953DD8}"/>
          </ac:cxnSpMkLst>
        </pc:cxnChg>
        <pc:cxnChg chg="mod">
          <ac:chgData name="Amanda Gibson" userId="907984a6-cd77-4b7d-b1f8-6dfd5dda5862" providerId="ADAL" clId="{161B03EE-95FE-457B-869D-1BF7800899D4}" dt="2021-02-08T01:27:13.062" v="4989" actId="208"/>
          <ac:cxnSpMkLst>
            <pc:docMk/>
            <pc:sldMk cId="1792043383" sldId="287"/>
            <ac:cxnSpMk id="66" creationId="{A0325E31-CC59-44F7-94FD-3404F8F56D35}"/>
          </ac:cxnSpMkLst>
        </pc:cxnChg>
        <pc:cxnChg chg="mod">
          <ac:chgData name="Amanda Gibson" userId="907984a6-cd77-4b7d-b1f8-6dfd5dda5862" providerId="ADAL" clId="{161B03EE-95FE-457B-869D-1BF7800899D4}" dt="2021-02-08T01:24:04.108" v="4754" actId="1076"/>
          <ac:cxnSpMkLst>
            <pc:docMk/>
            <pc:sldMk cId="1792043383" sldId="287"/>
            <ac:cxnSpMk id="67" creationId="{5714644C-2281-4F4F-92A9-147BE6F41E09}"/>
          </ac:cxnSpMkLst>
        </pc:cxnChg>
      </pc:sldChg>
      <pc:sldChg chg="delSp modSp add mod ord">
        <pc:chgData name="Amanda Gibson" userId="907984a6-cd77-4b7d-b1f8-6dfd5dda5862" providerId="ADAL" clId="{161B03EE-95FE-457B-869D-1BF7800899D4}" dt="2021-02-08T01:26:40.829" v="4987" actId="478"/>
        <pc:sldMkLst>
          <pc:docMk/>
          <pc:sldMk cId="1737122098" sldId="288"/>
        </pc:sldMkLst>
        <pc:spChg chg="mod">
          <ac:chgData name="Amanda Gibson" userId="907984a6-cd77-4b7d-b1f8-6dfd5dda5862" providerId="ADAL" clId="{161B03EE-95FE-457B-869D-1BF7800899D4}" dt="2021-02-08T01:25:47.888" v="4982" actId="20577"/>
          <ac:spMkLst>
            <pc:docMk/>
            <pc:sldMk cId="1737122098" sldId="288"/>
            <ac:spMk id="2" creationId="{28C08DB6-BD44-4401-A786-2D06627D7C16}"/>
          </ac:spMkLst>
        </pc:spChg>
        <pc:spChg chg="del">
          <ac:chgData name="Amanda Gibson" userId="907984a6-cd77-4b7d-b1f8-6dfd5dda5862" providerId="ADAL" clId="{161B03EE-95FE-457B-869D-1BF7800899D4}" dt="2021-02-08T01:26:40.829" v="4987" actId="478"/>
          <ac:spMkLst>
            <pc:docMk/>
            <pc:sldMk cId="1737122098" sldId="288"/>
            <ac:spMk id="122" creationId="{D1D1982A-B4D6-41F2-B28B-2532BD1E25C7}"/>
          </ac:spMkLst>
        </pc:spChg>
        <pc:spChg chg="del">
          <ac:chgData name="Amanda Gibson" userId="907984a6-cd77-4b7d-b1f8-6dfd5dda5862" providerId="ADAL" clId="{161B03EE-95FE-457B-869D-1BF7800899D4}" dt="2021-02-08T01:26:40.829" v="4987" actId="478"/>
          <ac:spMkLst>
            <pc:docMk/>
            <pc:sldMk cId="1737122098" sldId="288"/>
            <ac:spMk id="123" creationId="{500CF3E1-13F2-4B40-96AB-FB4E24757961}"/>
          </ac:spMkLst>
        </pc:spChg>
        <pc:spChg chg="del">
          <ac:chgData name="Amanda Gibson" userId="907984a6-cd77-4b7d-b1f8-6dfd5dda5862" providerId="ADAL" clId="{161B03EE-95FE-457B-869D-1BF7800899D4}" dt="2021-02-08T01:26:40.829" v="4987" actId="478"/>
          <ac:spMkLst>
            <pc:docMk/>
            <pc:sldMk cId="1737122098" sldId="288"/>
            <ac:spMk id="124" creationId="{BBC82ADC-8DD9-44AF-8692-D301AC7E9A70}"/>
          </ac:spMkLst>
        </pc:spChg>
        <pc:spChg chg="del">
          <ac:chgData name="Amanda Gibson" userId="907984a6-cd77-4b7d-b1f8-6dfd5dda5862" providerId="ADAL" clId="{161B03EE-95FE-457B-869D-1BF7800899D4}" dt="2021-02-08T01:26:40.829" v="4987" actId="478"/>
          <ac:spMkLst>
            <pc:docMk/>
            <pc:sldMk cId="1737122098" sldId="288"/>
            <ac:spMk id="125" creationId="{CE7534F3-0D54-4E2B-9C0D-EEEE055E6B47}"/>
          </ac:spMkLst>
        </pc:spChg>
        <pc:cxnChg chg="mod">
          <ac:chgData name="Amanda Gibson" userId="907984a6-cd77-4b7d-b1f8-6dfd5dda5862" providerId="ADAL" clId="{161B03EE-95FE-457B-869D-1BF7800899D4}" dt="2021-02-08T01:26:18.467" v="4985" actId="208"/>
          <ac:cxnSpMkLst>
            <pc:docMk/>
            <pc:sldMk cId="1737122098" sldId="288"/>
            <ac:cxnSpMk id="38" creationId="{09B2289E-F02B-428E-B511-DEAB1B34F0F3}"/>
          </ac:cxnSpMkLst>
        </pc:cxnChg>
        <pc:cxnChg chg="mod">
          <ac:chgData name="Amanda Gibson" userId="907984a6-cd77-4b7d-b1f8-6dfd5dda5862" providerId="ADAL" clId="{161B03EE-95FE-457B-869D-1BF7800899D4}" dt="2021-02-08T01:26:18.467" v="4985" actId="208"/>
          <ac:cxnSpMkLst>
            <pc:docMk/>
            <pc:sldMk cId="1737122098" sldId="288"/>
            <ac:cxnSpMk id="39" creationId="{4B7B9466-5977-4660-8DCA-2BFCB21B5A29}"/>
          </ac:cxnSpMkLst>
        </pc:cxnChg>
        <pc:cxnChg chg="mod">
          <ac:chgData name="Amanda Gibson" userId="907984a6-cd77-4b7d-b1f8-6dfd5dda5862" providerId="ADAL" clId="{161B03EE-95FE-457B-869D-1BF7800899D4}" dt="2021-02-08T01:26:00.175" v="4983" actId="208"/>
          <ac:cxnSpMkLst>
            <pc:docMk/>
            <pc:sldMk cId="1737122098" sldId="288"/>
            <ac:cxnSpMk id="46" creationId="{5CB3EE82-0234-4F81-90D0-D87F923EE4AA}"/>
          </ac:cxnSpMkLst>
        </pc:cxnChg>
        <pc:cxnChg chg="mod">
          <ac:chgData name="Amanda Gibson" userId="907984a6-cd77-4b7d-b1f8-6dfd5dda5862" providerId="ADAL" clId="{161B03EE-95FE-457B-869D-1BF7800899D4}" dt="2021-02-08T01:26:00.175" v="4983" actId="208"/>
          <ac:cxnSpMkLst>
            <pc:docMk/>
            <pc:sldMk cId="1737122098" sldId="288"/>
            <ac:cxnSpMk id="49" creationId="{B5E8C635-4938-42A2-BD75-A83BAB84AB40}"/>
          </ac:cxnSpMkLst>
        </pc:cxnChg>
        <pc:cxnChg chg="mod">
          <ac:chgData name="Amanda Gibson" userId="907984a6-cd77-4b7d-b1f8-6dfd5dda5862" providerId="ADAL" clId="{161B03EE-95FE-457B-869D-1BF7800899D4}" dt="2021-02-08T01:26:00.175" v="4983" actId="208"/>
          <ac:cxnSpMkLst>
            <pc:docMk/>
            <pc:sldMk cId="1737122098" sldId="288"/>
            <ac:cxnSpMk id="51" creationId="{ABC37F7C-8905-4810-844A-32C81344656D}"/>
          </ac:cxnSpMkLst>
        </pc:cxnChg>
        <pc:cxnChg chg="mod">
          <ac:chgData name="Amanda Gibson" userId="907984a6-cd77-4b7d-b1f8-6dfd5dda5862" providerId="ADAL" clId="{161B03EE-95FE-457B-869D-1BF7800899D4}" dt="2021-02-08T01:26:06.210" v="4984" actId="208"/>
          <ac:cxnSpMkLst>
            <pc:docMk/>
            <pc:sldMk cId="1737122098" sldId="288"/>
            <ac:cxnSpMk id="66" creationId="{A0325E31-CC59-44F7-94FD-3404F8F56D35}"/>
          </ac:cxnSpMkLst>
        </pc:cxnChg>
      </pc:sldChg>
      <pc:sldChg chg="add">
        <pc:chgData name="Amanda Gibson" userId="907984a6-cd77-4b7d-b1f8-6dfd5dda5862" providerId="ADAL" clId="{161B03EE-95FE-457B-869D-1BF7800899D4}" dt="2021-02-08T01:26:34.155" v="4986" actId="2890"/>
        <pc:sldMkLst>
          <pc:docMk/>
          <pc:sldMk cId="2698803788" sldId="289"/>
        </pc:sldMkLst>
      </pc:sldChg>
      <pc:sldChg chg="add">
        <pc:chgData name="Amanda Gibson" userId="907984a6-cd77-4b7d-b1f8-6dfd5dda5862" providerId="ADAL" clId="{161B03EE-95FE-457B-869D-1BF7800899D4}" dt="2021-02-08T01:26:57.994" v="4988" actId="2890"/>
        <pc:sldMkLst>
          <pc:docMk/>
          <pc:sldMk cId="3268507636" sldId="290"/>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479040-2939-4B45-B18B-4689EBD576D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2CDA3BF-3BC4-41CC-8DBD-7D7D7D75FE6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7E4BD8E-AF7E-4214-9F33-5380FA2D4BF0}"/>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5" name="Footer Placeholder 4">
            <a:extLst>
              <a:ext uri="{FF2B5EF4-FFF2-40B4-BE49-F238E27FC236}">
                <a16:creationId xmlns:a16="http://schemas.microsoft.com/office/drawing/2014/main" id="{8436B23D-90E2-4CF9-A286-565C7F20ADB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CB0730D-86CC-4B6A-9D57-5D7CD02965B8}"/>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19607023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74FBD1-2BEC-4E2A-83BF-5F9BC8A5C88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25D69E1-C3ED-43BE-855B-CB97DFCC214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300AE8F-E366-49A8-8CEF-341825B7D846}"/>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5" name="Footer Placeholder 4">
            <a:extLst>
              <a:ext uri="{FF2B5EF4-FFF2-40B4-BE49-F238E27FC236}">
                <a16:creationId xmlns:a16="http://schemas.microsoft.com/office/drawing/2014/main" id="{45383319-0DFB-41D7-B6C6-3D7556217AB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929179-97A2-40F6-9EC3-66737CF2B25E}"/>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28101178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9F3DB55-67BE-4F7F-A4F9-9C4347C2DA1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B81485A-6FF9-4BAC-8AAD-C63AA9F0C11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5A45959-4853-4A52-98F0-E5421471BC59}"/>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5" name="Footer Placeholder 4">
            <a:extLst>
              <a:ext uri="{FF2B5EF4-FFF2-40B4-BE49-F238E27FC236}">
                <a16:creationId xmlns:a16="http://schemas.microsoft.com/office/drawing/2014/main" id="{6F1CF7DB-BBF0-42B7-BBCF-13C7207D76A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BAED78-A004-459F-95D0-BB8E16A81A6A}"/>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12453425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EF2B9E-D4B5-4A9F-B460-35DA63C551EF}"/>
              </a:ext>
            </a:extLst>
          </p:cNvPr>
          <p:cNvSpPr>
            <a:spLocks noGrp="1"/>
          </p:cNvSpPr>
          <p:nvPr>
            <p:ph type="title"/>
          </p:nvPr>
        </p:nvSpPr>
        <p:spPr/>
        <p:txBody>
          <a:bodyPr/>
          <a:lstStyle>
            <a:lvl1pPr>
              <a:defRPr>
                <a:latin typeface="Arial" panose="020B0604020202020204" pitchFamily="34" charset="0"/>
                <a:cs typeface="Arial" panose="020B0604020202020204" pitchFamily="34" charset="0"/>
              </a:defRPr>
            </a:lvl1pPr>
          </a:lstStyle>
          <a:p>
            <a:r>
              <a:rPr lang="en-US"/>
              <a:t>Click to edit Master title style</a:t>
            </a:r>
          </a:p>
        </p:txBody>
      </p:sp>
      <p:sp>
        <p:nvSpPr>
          <p:cNvPr id="3" name="Content Placeholder 2">
            <a:extLst>
              <a:ext uri="{FF2B5EF4-FFF2-40B4-BE49-F238E27FC236}">
                <a16:creationId xmlns:a16="http://schemas.microsoft.com/office/drawing/2014/main" id="{4E5B4421-355C-4505-9B63-DBC9014C5437}"/>
              </a:ext>
            </a:extLst>
          </p:cNvPr>
          <p:cNvSpPr>
            <a:spLocks noGrp="1"/>
          </p:cNvSpPr>
          <p:nvPr>
            <p:ph idx="1"/>
          </p:nvPr>
        </p:nvSpPr>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077BE7-62C5-43E4-A6B6-84DA70DDD13B}"/>
              </a:ext>
            </a:extLst>
          </p:cNvPr>
          <p:cNvSpPr>
            <a:spLocks noGrp="1"/>
          </p:cNvSpPr>
          <p:nvPr>
            <p:ph type="dt" sz="half" idx="10"/>
          </p:nvPr>
        </p:nvSpPr>
        <p:spPr/>
        <p:txBody>
          <a:bodyPr/>
          <a:lstStyle>
            <a:lvl1pPr>
              <a:defRPr>
                <a:latin typeface="Arial" panose="020B0604020202020204" pitchFamily="34" charset="0"/>
                <a:cs typeface="Arial" panose="020B0604020202020204" pitchFamily="34" charset="0"/>
              </a:defRPr>
            </a:lvl1pPr>
          </a:lstStyle>
          <a:p>
            <a:fld id="{EBF42146-D36B-456C-ACC2-97B2367A8047}" type="datetimeFigureOut">
              <a:rPr lang="en-US" smtClean="0"/>
              <a:pPr/>
              <a:t>2/7/2021</a:t>
            </a:fld>
            <a:endParaRPr lang="en-US"/>
          </a:p>
        </p:txBody>
      </p:sp>
      <p:sp>
        <p:nvSpPr>
          <p:cNvPr id="5" name="Footer Placeholder 4">
            <a:extLst>
              <a:ext uri="{FF2B5EF4-FFF2-40B4-BE49-F238E27FC236}">
                <a16:creationId xmlns:a16="http://schemas.microsoft.com/office/drawing/2014/main" id="{E5C0999E-3796-413C-98D7-03C359D6663B}"/>
              </a:ext>
            </a:extLst>
          </p:cNvPr>
          <p:cNvSpPr>
            <a:spLocks noGrp="1"/>
          </p:cNvSpPr>
          <p:nvPr>
            <p:ph type="ftr" sz="quarter" idx="11"/>
          </p:nvPr>
        </p:nvSpPr>
        <p:spPr/>
        <p:txBody>
          <a:bodyPr/>
          <a:lstStyle>
            <a:lvl1pPr>
              <a:defRPr>
                <a:latin typeface="Arial" panose="020B0604020202020204" pitchFamily="34" charset="0"/>
                <a:cs typeface="Arial" panose="020B0604020202020204" pitchFamily="34" charset="0"/>
              </a:defRPr>
            </a:lvl1pPr>
          </a:lstStyle>
          <a:p>
            <a:endParaRPr lang="en-US"/>
          </a:p>
        </p:txBody>
      </p:sp>
      <p:sp>
        <p:nvSpPr>
          <p:cNvPr id="6" name="Slide Number Placeholder 5">
            <a:extLst>
              <a:ext uri="{FF2B5EF4-FFF2-40B4-BE49-F238E27FC236}">
                <a16:creationId xmlns:a16="http://schemas.microsoft.com/office/drawing/2014/main" id="{1A015672-2D3F-4808-8FA4-D64A4D8414E9}"/>
              </a:ext>
            </a:extLst>
          </p:cNvPr>
          <p:cNvSpPr>
            <a:spLocks noGrp="1"/>
          </p:cNvSpPr>
          <p:nvPr>
            <p:ph type="sldNum" sz="quarter" idx="12"/>
          </p:nvPr>
        </p:nvSpPr>
        <p:spPr/>
        <p:txBody>
          <a:bodyPr/>
          <a:lstStyle>
            <a:lvl1pPr>
              <a:defRPr>
                <a:latin typeface="Arial" panose="020B0604020202020204" pitchFamily="34" charset="0"/>
                <a:cs typeface="Arial" panose="020B0604020202020204" pitchFamily="34" charset="0"/>
              </a:defRPr>
            </a:lvl1pPr>
          </a:lstStyle>
          <a:p>
            <a:fld id="{F1037952-43E3-4323-978C-4746DA390542}" type="slidenum">
              <a:rPr lang="en-US" smtClean="0"/>
              <a:pPr/>
              <a:t>‹#›</a:t>
            </a:fld>
            <a:endParaRPr lang="en-US"/>
          </a:p>
        </p:txBody>
      </p:sp>
    </p:spTree>
    <p:extLst>
      <p:ext uri="{BB962C8B-B14F-4D97-AF65-F5344CB8AC3E}">
        <p14:creationId xmlns:p14="http://schemas.microsoft.com/office/powerpoint/2010/main" val="14980914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88C9E7-972B-4E92-99F8-E95E7CCA42B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6782644-A5A6-4216-BBD7-A4A0F643356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F3025F1-966C-4292-B1DE-E46927960FF4}"/>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5" name="Footer Placeholder 4">
            <a:extLst>
              <a:ext uri="{FF2B5EF4-FFF2-40B4-BE49-F238E27FC236}">
                <a16:creationId xmlns:a16="http://schemas.microsoft.com/office/drawing/2014/main" id="{4DABFAB8-6E8E-4121-9B46-B488058D3B3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EC71A1-0DBC-4B08-B84F-6CDF41917FAF}"/>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28527056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45A928-D6A3-4975-B9B8-299837AE7CA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A36AB85-B689-4E42-AD15-5AEAFC55BBF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E0DE358-315C-4BBC-AFD0-ED47817AFF5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DC15BC0-E9AA-4674-A26E-1E7649946333}"/>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6" name="Footer Placeholder 5">
            <a:extLst>
              <a:ext uri="{FF2B5EF4-FFF2-40B4-BE49-F238E27FC236}">
                <a16:creationId xmlns:a16="http://schemas.microsoft.com/office/drawing/2014/main" id="{0A55D7DE-D0AE-4FED-8155-00451147519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1D05F74-4484-49F2-B3BE-AFA043D77653}"/>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36307857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3E961E-6BB6-4726-8F47-8B9B4AD0C63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03597BC-2AC1-488E-83C3-0D9D55B0DF1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2E1B3FF-5471-4F9B-9F81-5DAA894FC16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45511B3-0F18-4DC3-B844-A5BF472A8BB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E0E59AF-DC40-4D5E-8D17-259D167CBF2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594FC8D-1045-450C-AAEB-D192219F1CB1}"/>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8" name="Footer Placeholder 7">
            <a:extLst>
              <a:ext uri="{FF2B5EF4-FFF2-40B4-BE49-F238E27FC236}">
                <a16:creationId xmlns:a16="http://schemas.microsoft.com/office/drawing/2014/main" id="{F4E3679F-399F-49E6-913F-0B5BF98FFEC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3DE6CB8-677F-4530-86AB-35EC10BB864B}"/>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38379602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B83174-AD35-4B07-963A-BE9FC5FF204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F65626C-1E13-4C89-ABF4-69BE0139ECEC}"/>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4" name="Footer Placeholder 3">
            <a:extLst>
              <a:ext uri="{FF2B5EF4-FFF2-40B4-BE49-F238E27FC236}">
                <a16:creationId xmlns:a16="http://schemas.microsoft.com/office/drawing/2014/main" id="{7CBC9AA6-BF22-45FA-8935-364430467CC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50EE6A4-3982-42F0-B035-0A5160A3ECB3}"/>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7716918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9465CDC-40A4-44AD-ACE7-438B67364FB6}"/>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3" name="Footer Placeholder 2">
            <a:extLst>
              <a:ext uri="{FF2B5EF4-FFF2-40B4-BE49-F238E27FC236}">
                <a16:creationId xmlns:a16="http://schemas.microsoft.com/office/drawing/2014/main" id="{F2EB2689-0C08-4DB9-98F3-B55371E8CC1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21677EF-C6C3-45D0-BE2C-58DAC29B26F2}"/>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16485812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6571C9-70A3-45E0-8333-66BCB24EA35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9B07AA9-D6FA-48A0-B036-F54D51EF9A5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0F4C951-06CA-4085-A97C-FD17B27A10D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108C8B9-6CF4-4C55-B3E6-69F6E85D7592}"/>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6" name="Footer Placeholder 5">
            <a:extLst>
              <a:ext uri="{FF2B5EF4-FFF2-40B4-BE49-F238E27FC236}">
                <a16:creationId xmlns:a16="http://schemas.microsoft.com/office/drawing/2014/main" id="{F20EA963-E526-4604-BED8-790CF7D8BBB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5D63317-69CF-4644-A717-D913F89327AD}"/>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36568132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0158FD-C898-4F31-8A8B-B1F5ABDD3B0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2142552-14E8-48E3-B7B1-308030F4A32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B51F5C3-1014-41B0-B867-5CB05EFF62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BF7A02B-1DDD-4778-ADC3-5C5835D67547}"/>
              </a:ext>
            </a:extLst>
          </p:cNvPr>
          <p:cNvSpPr>
            <a:spLocks noGrp="1"/>
          </p:cNvSpPr>
          <p:nvPr>
            <p:ph type="dt" sz="half" idx="10"/>
          </p:nvPr>
        </p:nvSpPr>
        <p:spPr/>
        <p:txBody>
          <a:bodyPr/>
          <a:lstStyle/>
          <a:p>
            <a:fld id="{EBF42146-D36B-456C-ACC2-97B2367A8047}" type="datetimeFigureOut">
              <a:rPr lang="en-US" smtClean="0"/>
              <a:t>2/7/2021</a:t>
            </a:fld>
            <a:endParaRPr lang="en-US"/>
          </a:p>
        </p:txBody>
      </p:sp>
      <p:sp>
        <p:nvSpPr>
          <p:cNvPr id="6" name="Footer Placeholder 5">
            <a:extLst>
              <a:ext uri="{FF2B5EF4-FFF2-40B4-BE49-F238E27FC236}">
                <a16:creationId xmlns:a16="http://schemas.microsoft.com/office/drawing/2014/main" id="{60F0B17A-1395-4933-ACA9-250E21BBCC1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31FD87B-FCD9-4EE3-BCBA-AFB5628BAC69}"/>
              </a:ext>
            </a:extLst>
          </p:cNvPr>
          <p:cNvSpPr>
            <a:spLocks noGrp="1"/>
          </p:cNvSpPr>
          <p:nvPr>
            <p:ph type="sldNum" sz="quarter" idx="12"/>
          </p:nvPr>
        </p:nvSpPr>
        <p:spPr/>
        <p:txBody>
          <a:bodyPr/>
          <a:lstStyle/>
          <a:p>
            <a:fld id="{F1037952-43E3-4323-978C-4746DA390542}" type="slidenum">
              <a:rPr lang="en-US" smtClean="0"/>
              <a:t>‹#›</a:t>
            </a:fld>
            <a:endParaRPr lang="en-US"/>
          </a:p>
        </p:txBody>
      </p:sp>
    </p:spTree>
    <p:extLst>
      <p:ext uri="{BB962C8B-B14F-4D97-AF65-F5344CB8AC3E}">
        <p14:creationId xmlns:p14="http://schemas.microsoft.com/office/powerpoint/2010/main" val="31333453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47EE8C2-2829-4725-86E6-C72BBAC4A2C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37212C5-550C-46DF-A292-EB0C3A496F0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C951CA8-95CC-4B91-948D-FD478099F88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BF42146-D36B-456C-ACC2-97B2367A8047}" type="datetimeFigureOut">
              <a:rPr lang="en-US" smtClean="0"/>
              <a:t>2/7/2021</a:t>
            </a:fld>
            <a:endParaRPr lang="en-US"/>
          </a:p>
        </p:txBody>
      </p:sp>
      <p:sp>
        <p:nvSpPr>
          <p:cNvPr id="5" name="Footer Placeholder 4">
            <a:extLst>
              <a:ext uri="{FF2B5EF4-FFF2-40B4-BE49-F238E27FC236}">
                <a16:creationId xmlns:a16="http://schemas.microsoft.com/office/drawing/2014/main" id="{F60B026D-171F-41A3-BC07-87FB82E00FD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64AD321-450F-4F5B-9E6B-AC0C4520D51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1037952-43E3-4323-978C-4746DA390542}" type="slidenum">
              <a:rPr lang="en-US" smtClean="0"/>
              <a:t>‹#›</a:t>
            </a:fld>
            <a:endParaRPr lang="en-US"/>
          </a:p>
        </p:txBody>
      </p:sp>
    </p:spTree>
    <p:extLst>
      <p:ext uri="{BB962C8B-B14F-4D97-AF65-F5344CB8AC3E}">
        <p14:creationId xmlns:p14="http://schemas.microsoft.com/office/powerpoint/2010/main" val="33326669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slide" Target="slide9.xml"/><Relationship Id="rId13" Type="http://schemas.openxmlformats.org/officeDocument/2006/relationships/slide" Target="slide14.xml"/><Relationship Id="rId18" Type="http://schemas.openxmlformats.org/officeDocument/2006/relationships/slide" Target="slide19.xml"/><Relationship Id="rId26" Type="http://schemas.openxmlformats.org/officeDocument/2006/relationships/slide" Target="slide27.xml"/><Relationship Id="rId3" Type="http://schemas.openxmlformats.org/officeDocument/2006/relationships/slide" Target="slide4.xml"/><Relationship Id="rId21" Type="http://schemas.openxmlformats.org/officeDocument/2006/relationships/slide" Target="slide22.xml"/><Relationship Id="rId7" Type="http://schemas.openxmlformats.org/officeDocument/2006/relationships/slide" Target="slide8.xml"/><Relationship Id="rId12" Type="http://schemas.openxmlformats.org/officeDocument/2006/relationships/slide" Target="slide13.xml"/><Relationship Id="rId17" Type="http://schemas.openxmlformats.org/officeDocument/2006/relationships/slide" Target="slide18.xml"/><Relationship Id="rId25" Type="http://schemas.openxmlformats.org/officeDocument/2006/relationships/slide" Target="slide26.xml"/><Relationship Id="rId2" Type="http://schemas.openxmlformats.org/officeDocument/2006/relationships/slide" Target="slide3.xml"/><Relationship Id="rId16" Type="http://schemas.openxmlformats.org/officeDocument/2006/relationships/slide" Target="slide17.xml"/><Relationship Id="rId20" Type="http://schemas.openxmlformats.org/officeDocument/2006/relationships/slide" Target="slide21.xml"/><Relationship Id="rId29" Type="http://schemas.openxmlformats.org/officeDocument/2006/relationships/slide" Target="slide30.xml"/><Relationship Id="rId1" Type="http://schemas.openxmlformats.org/officeDocument/2006/relationships/slideLayout" Target="../slideLayouts/slideLayout2.xml"/><Relationship Id="rId6" Type="http://schemas.openxmlformats.org/officeDocument/2006/relationships/slide" Target="slide7.xml"/><Relationship Id="rId11" Type="http://schemas.openxmlformats.org/officeDocument/2006/relationships/slide" Target="slide12.xml"/><Relationship Id="rId24" Type="http://schemas.openxmlformats.org/officeDocument/2006/relationships/slide" Target="slide25.xml"/><Relationship Id="rId32" Type="http://schemas.openxmlformats.org/officeDocument/2006/relationships/slide" Target="slide34.xml"/><Relationship Id="rId5" Type="http://schemas.openxmlformats.org/officeDocument/2006/relationships/slide" Target="slide6.xml"/><Relationship Id="rId15" Type="http://schemas.openxmlformats.org/officeDocument/2006/relationships/slide" Target="slide16.xml"/><Relationship Id="rId23" Type="http://schemas.openxmlformats.org/officeDocument/2006/relationships/slide" Target="slide24.xml"/><Relationship Id="rId28" Type="http://schemas.openxmlformats.org/officeDocument/2006/relationships/slide" Target="slide29.xml"/><Relationship Id="rId10" Type="http://schemas.openxmlformats.org/officeDocument/2006/relationships/slide" Target="slide11.xml"/><Relationship Id="rId19" Type="http://schemas.openxmlformats.org/officeDocument/2006/relationships/slide" Target="slide20.xml"/><Relationship Id="rId31" Type="http://schemas.openxmlformats.org/officeDocument/2006/relationships/slide" Target="slide32.xml"/><Relationship Id="rId4" Type="http://schemas.openxmlformats.org/officeDocument/2006/relationships/slide" Target="slide5.xml"/><Relationship Id="rId9" Type="http://schemas.openxmlformats.org/officeDocument/2006/relationships/slide" Target="slide10.xml"/><Relationship Id="rId14" Type="http://schemas.openxmlformats.org/officeDocument/2006/relationships/slide" Target="slide15.xml"/><Relationship Id="rId22" Type="http://schemas.openxmlformats.org/officeDocument/2006/relationships/slide" Target="slide23.xml"/><Relationship Id="rId27" Type="http://schemas.openxmlformats.org/officeDocument/2006/relationships/slide" Target="slide28.xml"/><Relationship Id="rId30" Type="http://schemas.openxmlformats.org/officeDocument/2006/relationships/slide" Target="slide31.xml"/></Relationships>
</file>

<file path=ppt/slides/_rels/slide20.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42F51F-1A84-4DF1-9EDD-7FF7BD35ADF0}"/>
              </a:ext>
            </a:extLst>
          </p:cNvPr>
          <p:cNvSpPr>
            <a:spLocks noGrp="1"/>
          </p:cNvSpPr>
          <p:nvPr>
            <p:ph type="ctrTitle"/>
          </p:nvPr>
        </p:nvSpPr>
        <p:spPr/>
        <p:txBody>
          <a:bodyPr/>
          <a:lstStyle/>
          <a:p>
            <a:r>
              <a:rPr lang="en-US"/>
              <a:t>Vary Burst Window Analysis</a:t>
            </a:r>
          </a:p>
        </p:txBody>
      </p:sp>
      <p:sp>
        <p:nvSpPr>
          <p:cNvPr id="3" name="Subtitle 2">
            <a:extLst>
              <a:ext uri="{FF2B5EF4-FFF2-40B4-BE49-F238E27FC236}">
                <a16:creationId xmlns:a16="http://schemas.microsoft.com/office/drawing/2014/main" id="{F4A1DA4A-E0EC-4158-AD20-FED6DDF5F6D0}"/>
              </a:ext>
            </a:extLst>
          </p:cNvPr>
          <p:cNvSpPr>
            <a:spLocks noGrp="1"/>
          </p:cNvSpPr>
          <p:nvPr>
            <p:ph type="subTitle" idx="1"/>
          </p:nvPr>
        </p:nvSpPr>
        <p:spPr/>
        <p:txBody>
          <a:bodyPr/>
          <a:lstStyle/>
          <a:p>
            <a:r>
              <a:rPr lang="en-US"/>
              <a:t>Feb 2021</a:t>
            </a:r>
          </a:p>
        </p:txBody>
      </p:sp>
    </p:spTree>
    <p:extLst>
      <p:ext uri="{BB962C8B-B14F-4D97-AF65-F5344CB8AC3E}">
        <p14:creationId xmlns:p14="http://schemas.microsoft.com/office/powerpoint/2010/main" val="34940474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 name="Title 1">
            <a:extLst>
              <a:ext uri="{FF2B5EF4-FFF2-40B4-BE49-F238E27FC236}">
                <a16:creationId xmlns:a16="http://schemas.microsoft.com/office/drawing/2014/main" id="{BB4E3879-0FC6-44D6-9281-34F2B554E57F}"/>
              </a:ext>
            </a:extLst>
          </p:cNvPr>
          <p:cNvSpPr txBox="1">
            <a:spLocks/>
          </p:cNvSpPr>
          <p:nvPr/>
        </p:nvSpPr>
        <p:spPr>
          <a:xfrm>
            <a:off x="838200" y="1"/>
            <a:ext cx="10515600" cy="203092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Arial" panose="020B0604020202020204" pitchFamily="34" charset="0"/>
                <a:ea typeface="+mj-ea"/>
                <a:cs typeface="Arial" panose="020B0604020202020204" pitchFamily="34" charset="0"/>
              </a:defRPr>
            </a:lvl1pPr>
          </a:lstStyle>
          <a:p>
            <a:r>
              <a:rPr lang="en-US" sz="3600" b="1">
                <a:solidFill>
                  <a:srgbClr val="7030A0"/>
                </a:solidFill>
              </a:rPr>
              <a:t>Burst start time: </a:t>
            </a:r>
            <a:r>
              <a:rPr lang="en-US" sz="3600"/>
              <a:t>The time of the first spike in a burst</a:t>
            </a:r>
          </a:p>
        </p:txBody>
      </p:sp>
      <p:cxnSp>
        <p:nvCxnSpPr>
          <p:cNvPr id="35" name="Straight Connector 34">
            <a:extLst>
              <a:ext uri="{FF2B5EF4-FFF2-40B4-BE49-F238E27FC236}">
                <a16:creationId xmlns:a16="http://schemas.microsoft.com/office/drawing/2014/main" id="{2814F8E3-4AEA-4BA4-A3D8-EB9F55DB1F02}"/>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748586B8-9830-440E-91B0-F430C21E1AAE}"/>
              </a:ext>
            </a:extLst>
          </p:cNvPr>
          <p:cNvCxnSpPr>
            <a:cxnSpLocks/>
          </p:cNvCxnSpPr>
          <p:nvPr/>
        </p:nvCxnSpPr>
        <p:spPr>
          <a:xfrm>
            <a:off x="3026378" y="2693433"/>
            <a:ext cx="0" cy="1928326"/>
          </a:xfrm>
          <a:prstGeom prst="line">
            <a:avLst/>
          </a:prstGeom>
          <a:ln w="3810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C45B121B-A3D2-4BC8-AE2A-F676503D0272}"/>
              </a:ext>
            </a:extLst>
          </p:cNvPr>
          <p:cNvCxnSpPr>
            <a:cxnSpLocks/>
          </p:cNvCxnSpPr>
          <p:nvPr/>
        </p:nvCxnSpPr>
        <p:spPr>
          <a:xfrm>
            <a:off x="352949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622BF435-EBBA-4218-96BF-4AFCE9AB182D}"/>
              </a:ext>
            </a:extLst>
          </p:cNvPr>
          <p:cNvCxnSpPr>
            <a:cxnSpLocks/>
          </p:cNvCxnSpPr>
          <p:nvPr/>
        </p:nvCxnSpPr>
        <p:spPr>
          <a:xfrm>
            <a:off x="403260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5F8121D-EAA0-4330-999A-E18CB41CBE16}"/>
              </a:ext>
            </a:extLst>
          </p:cNvPr>
          <p:cNvCxnSpPr>
            <a:cxnSpLocks/>
          </p:cNvCxnSpPr>
          <p:nvPr/>
        </p:nvCxnSpPr>
        <p:spPr>
          <a:xfrm>
            <a:off x="6548169" y="2693433"/>
            <a:ext cx="0" cy="1928326"/>
          </a:xfrm>
          <a:prstGeom prst="line">
            <a:avLst/>
          </a:prstGeom>
          <a:ln w="3810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4EEB74AE-83EB-4C75-BDF1-FF349CDAE14A}"/>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55BC6AA-6EBD-42D9-B053-D4DCDC89E349}"/>
              </a:ext>
            </a:extLst>
          </p:cNvPr>
          <p:cNvCxnSpPr>
            <a:cxnSpLocks/>
          </p:cNvCxnSpPr>
          <p:nvPr/>
        </p:nvCxnSpPr>
        <p:spPr>
          <a:xfrm>
            <a:off x="8560621" y="2693433"/>
            <a:ext cx="0" cy="1928326"/>
          </a:xfrm>
          <a:prstGeom prst="line">
            <a:avLst/>
          </a:prstGeom>
          <a:ln w="3810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55A4474-74EF-48A7-81BB-0D5B373EA381}"/>
              </a:ext>
            </a:extLst>
          </p:cNvPr>
          <p:cNvCxnSpPr>
            <a:cxnSpLocks/>
          </p:cNvCxnSpPr>
          <p:nvPr/>
        </p:nvCxnSpPr>
        <p:spPr>
          <a:xfrm>
            <a:off x="906373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6865C555-B0A1-4DC7-BFB3-159291064D3E}"/>
              </a:ext>
            </a:extLst>
          </p:cNvPr>
          <p:cNvCxnSpPr>
            <a:cxnSpLocks/>
          </p:cNvCxnSpPr>
          <p:nvPr/>
        </p:nvCxnSpPr>
        <p:spPr>
          <a:xfrm>
            <a:off x="9566847"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EAC61716-623A-447C-954B-8DD898D75C07}"/>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56" name="TextBox 55">
            <a:extLst>
              <a:ext uri="{FF2B5EF4-FFF2-40B4-BE49-F238E27FC236}">
                <a16:creationId xmlns:a16="http://schemas.microsoft.com/office/drawing/2014/main" id="{506BA941-9ED2-45B9-AC3F-C8C0B0E5C028}"/>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60" name="TextBox 59">
            <a:extLst>
              <a:ext uri="{FF2B5EF4-FFF2-40B4-BE49-F238E27FC236}">
                <a16:creationId xmlns:a16="http://schemas.microsoft.com/office/drawing/2014/main" id="{D5578323-22C5-48E1-ADEE-17A44D65AA3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1" name="TextBox 60">
            <a:extLst>
              <a:ext uri="{FF2B5EF4-FFF2-40B4-BE49-F238E27FC236}">
                <a16:creationId xmlns:a16="http://schemas.microsoft.com/office/drawing/2014/main" id="{1FFB11D9-B26C-434D-9740-8725EB830EE4}"/>
              </a:ext>
            </a:extLst>
          </p:cNvPr>
          <p:cNvSpPr txBox="1"/>
          <p:nvPr/>
        </p:nvSpPr>
        <p:spPr>
          <a:xfrm>
            <a:off x="3373038"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a:t>
            </a:r>
          </a:p>
        </p:txBody>
      </p:sp>
      <p:sp>
        <p:nvSpPr>
          <p:cNvPr id="62" name="TextBox 61">
            <a:extLst>
              <a:ext uri="{FF2B5EF4-FFF2-40B4-BE49-F238E27FC236}">
                <a16:creationId xmlns:a16="http://schemas.microsoft.com/office/drawing/2014/main" id="{83114AA9-4B59-41B6-ADFE-6C4F2491E6E7}"/>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CA7BFD84-ABBA-4A9A-B2F8-6FC0089400F0}"/>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68" name="TextBox 67">
            <a:extLst>
              <a:ext uri="{FF2B5EF4-FFF2-40B4-BE49-F238E27FC236}">
                <a16:creationId xmlns:a16="http://schemas.microsoft.com/office/drawing/2014/main" id="{CB981839-37F6-4368-8E3F-DF8754634807}"/>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71" name="TextBox 70">
            <a:extLst>
              <a:ext uri="{FF2B5EF4-FFF2-40B4-BE49-F238E27FC236}">
                <a16:creationId xmlns:a16="http://schemas.microsoft.com/office/drawing/2014/main" id="{D45BBE2E-DF92-4219-BC3A-1AF1A2792BF9}"/>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72" name="TextBox 71">
            <a:extLst>
              <a:ext uri="{FF2B5EF4-FFF2-40B4-BE49-F238E27FC236}">
                <a16:creationId xmlns:a16="http://schemas.microsoft.com/office/drawing/2014/main" id="{BD8B3B41-1FE1-4CCC-9168-42A24303DFDC}"/>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73" name="TextBox 72">
            <a:extLst>
              <a:ext uri="{FF2B5EF4-FFF2-40B4-BE49-F238E27FC236}">
                <a16:creationId xmlns:a16="http://schemas.microsoft.com/office/drawing/2014/main" id="{D2BC4F3C-EDCE-490E-ADBC-F65B227FA8F9}"/>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76" name="TextBox 75">
            <a:extLst>
              <a:ext uri="{FF2B5EF4-FFF2-40B4-BE49-F238E27FC236}">
                <a16:creationId xmlns:a16="http://schemas.microsoft.com/office/drawing/2014/main" id="{5FC86196-7C2D-42D7-BE6A-1D096E132698}"/>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80" name="TextBox 79">
            <a:extLst>
              <a:ext uri="{FF2B5EF4-FFF2-40B4-BE49-F238E27FC236}">
                <a16:creationId xmlns:a16="http://schemas.microsoft.com/office/drawing/2014/main" id="{0C900B59-4201-4F1B-B8E7-7340816C4316}"/>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5A66A2F2-34E3-4247-8534-59192890CC22}"/>
              </a:ext>
            </a:extLst>
          </p:cNvPr>
          <p:cNvSpPr txBox="1"/>
          <p:nvPr/>
        </p:nvSpPr>
        <p:spPr>
          <a:xfrm>
            <a:off x="337303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17974CD7-4EB3-4ABE-9BD7-E18031C0821C}"/>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7" name="TextBox 86">
            <a:extLst>
              <a:ext uri="{FF2B5EF4-FFF2-40B4-BE49-F238E27FC236}">
                <a16:creationId xmlns:a16="http://schemas.microsoft.com/office/drawing/2014/main" id="{95024911-2DE9-4D0B-A4B3-4BD19777884F}"/>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90" name="TextBox 89">
            <a:extLst>
              <a:ext uri="{FF2B5EF4-FFF2-40B4-BE49-F238E27FC236}">
                <a16:creationId xmlns:a16="http://schemas.microsoft.com/office/drawing/2014/main" id="{062B7B16-42E2-4076-A421-365223EFD43C}"/>
              </a:ext>
            </a:extLst>
          </p:cNvPr>
          <p:cNvSpPr txBox="1"/>
          <p:nvPr/>
        </p:nvSpPr>
        <p:spPr>
          <a:xfrm>
            <a:off x="6894829"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23" name="TextBox 122">
            <a:extLst>
              <a:ext uri="{FF2B5EF4-FFF2-40B4-BE49-F238E27FC236}">
                <a16:creationId xmlns:a16="http://schemas.microsoft.com/office/drawing/2014/main" id="{F07E911A-EF55-4077-B0DF-D9984A42F982}"/>
              </a:ext>
            </a:extLst>
          </p:cNvPr>
          <p:cNvSpPr txBox="1"/>
          <p:nvPr/>
        </p:nvSpPr>
        <p:spPr>
          <a:xfrm>
            <a:off x="8404168"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24" name="TextBox 123">
            <a:extLst>
              <a:ext uri="{FF2B5EF4-FFF2-40B4-BE49-F238E27FC236}">
                <a16:creationId xmlns:a16="http://schemas.microsoft.com/office/drawing/2014/main" id="{E4DDCEBE-F36D-42F0-91A2-FD89D2A6C8CA}"/>
              </a:ext>
            </a:extLst>
          </p:cNvPr>
          <p:cNvSpPr txBox="1"/>
          <p:nvPr/>
        </p:nvSpPr>
        <p:spPr>
          <a:xfrm>
            <a:off x="8907281"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125" name="TextBox 124">
            <a:extLst>
              <a:ext uri="{FF2B5EF4-FFF2-40B4-BE49-F238E27FC236}">
                <a16:creationId xmlns:a16="http://schemas.microsoft.com/office/drawing/2014/main" id="{51749985-D96F-4694-BCC7-0CCD556B9E04}"/>
              </a:ext>
            </a:extLst>
          </p:cNvPr>
          <p:cNvSpPr txBox="1"/>
          <p:nvPr/>
        </p:nvSpPr>
        <p:spPr>
          <a:xfrm>
            <a:off x="9410394"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sp>
        <p:nvSpPr>
          <p:cNvPr id="128" name="TextBox 127">
            <a:extLst>
              <a:ext uri="{FF2B5EF4-FFF2-40B4-BE49-F238E27FC236}">
                <a16:creationId xmlns:a16="http://schemas.microsoft.com/office/drawing/2014/main" id="{8B5F1059-0ECA-4AA6-AA71-49F6194AB602}"/>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9" name="TextBox 128">
            <a:extLst>
              <a:ext uri="{FF2B5EF4-FFF2-40B4-BE49-F238E27FC236}">
                <a16:creationId xmlns:a16="http://schemas.microsoft.com/office/drawing/2014/main" id="{17105D4D-3475-4F62-8B53-E8A9D9E8CB2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130" name="TextBox 129">
            <a:extLst>
              <a:ext uri="{FF2B5EF4-FFF2-40B4-BE49-F238E27FC236}">
                <a16:creationId xmlns:a16="http://schemas.microsoft.com/office/drawing/2014/main" id="{E1961E32-E05C-4074-9202-D26E7C008F2F}"/>
              </a:ext>
            </a:extLst>
          </p:cNvPr>
          <p:cNvSpPr txBox="1"/>
          <p:nvPr/>
        </p:nvSpPr>
        <p:spPr>
          <a:xfrm>
            <a:off x="2869925" y="4667925"/>
            <a:ext cx="1287533" cy="646331"/>
          </a:xfrm>
          <a:prstGeom prst="rect">
            <a:avLst/>
          </a:prstGeom>
          <a:noFill/>
        </p:spPr>
        <p:txBody>
          <a:bodyPr wrap="none" rtlCol="0">
            <a:spAutoFit/>
          </a:bodyPr>
          <a:lstStyle/>
          <a:p>
            <a:r>
              <a:rPr lang="en-US" sz="3600">
                <a:solidFill>
                  <a:schemeClr val="accent1"/>
                </a:solidFill>
                <a:latin typeface="Arial" panose="020B0604020202020204" pitchFamily="34" charset="0"/>
              </a:rPr>
              <a:t>4 sec</a:t>
            </a:r>
            <a:endParaRPr lang="en-US" sz="3600">
              <a:solidFill>
                <a:schemeClr val="accent1"/>
              </a:solidFill>
            </a:endParaRPr>
          </a:p>
        </p:txBody>
      </p:sp>
      <p:sp>
        <p:nvSpPr>
          <p:cNvPr id="131" name="TextBox 130">
            <a:extLst>
              <a:ext uri="{FF2B5EF4-FFF2-40B4-BE49-F238E27FC236}">
                <a16:creationId xmlns:a16="http://schemas.microsoft.com/office/drawing/2014/main" id="{92EE0D56-23EA-4DB3-ADC0-F17F7053200A}"/>
              </a:ext>
            </a:extLst>
          </p:cNvPr>
          <p:cNvSpPr txBox="1"/>
          <p:nvPr/>
        </p:nvSpPr>
        <p:spPr>
          <a:xfrm>
            <a:off x="6369160" y="4662730"/>
            <a:ext cx="1509772" cy="646331"/>
          </a:xfrm>
          <a:prstGeom prst="rect">
            <a:avLst/>
          </a:prstGeom>
          <a:noFill/>
        </p:spPr>
        <p:txBody>
          <a:bodyPr wrap="none" rtlCol="0">
            <a:spAutoFit/>
          </a:bodyPr>
          <a:lstStyle/>
          <a:p>
            <a:r>
              <a:rPr lang="en-US" sz="3600">
                <a:solidFill>
                  <a:schemeClr val="accent1"/>
                </a:solidFill>
                <a:latin typeface="Arial" panose="020B0604020202020204" pitchFamily="34" charset="0"/>
              </a:rPr>
              <a:t>11 sec</a:t>
            </a:r>
            <a:endParaRPr lang="en-US" sz="3600">
              <a:solidFill>
                <a:schemeClr val="accent1"/>
              </a:solidFill>
            </a:endParaRPr>
          </a:p>
        </p:txBody>
      </p:sp>
      <p:sp>
        <p:nvSpPr>
          <p:cNvPr id="132" name="TextBox 131">
            <a:extLst>
              <a:ext uri="{FF2B5EF4-FFF2-40B4-BE49-F238E27FC236}">
                <a16:creationId xmlns:a16="http://schemas.microsoft.com/office/drawing/2014/main" id="{7056583F-8F74-4665-93C0-E9BE7FAB6F79}"/>
              </a:ext>
            </a:extLst>
          </p:cNvPr>
          <p:cNvSpPr txBox="1"/>
          <p:nvPr/>
        </p:nvSpPr>
        <p:spPr>
          <a:xfrm>
            <a:off x="8340048" y="4664068"/>
            <a:ext cx="1544012" cy="646331"/>
          </a:xfrm>
          <a:prstGeom prst="rect">
            <a:avLst/>
          </a:prstGeom>
          <a:noFill/>
        </p:spPr>
        <p:txBody>
          <a:bodyPr wrap="none" rtlCol="0">
            <a:spAutoFit/>
          </a:bodyPr>
          <a:lstStyle/>
          <a:p>
            <a:r>
              <a:rPr lang="en-US" sz="3600">
                <a:solidFill>
                  <a:schemeClr val="accent1"/>
                </a:solidFill>
                <a:latin typeface="Arial" panose="020B0604020202020204" pitchFamily="34" charset="0"/>
              </a:rPr>
              <a:t>15 sec</a:t>
            </a:r>
            <a:endParaRPr lang="en-US" sz="3600">
              <a:solidFill>
                <a:schemeClr val="accent1"/>
              </a:solidFill>
            </a:endParaRPr>
          </a:p>
        </p:txBody>
      </p:sp>
      <p:sp>
        <p:nvSpPr>
          <p:cNvPr id="134" name="TextBox 133">
            <a:extLst>
              <a:ext uri="{FF2B5EF4-FFF2-40B4-BE49-F238E27FC236}">
                <a16:creationId xmlns:a16="http://schemas.microsoft.com/office/drawing/2014/main" id="{4F52454D-2976-4067-8ED1-20866AC8B786}"/>
              </a:ext>
            </a:extLst>
          </p:cNvPr>
          <p:cNvSpPr txBox="1"/>
          <p:nvPr/>
        </p:nvSpPr>
        <p:spPr>
          <a:xfrm>
            <a:off x="3040392" y="5356565"/>
            <a:ext cx="6071662" cy="1077218"/>
          </a:xfrm>
          <a:prstGeom prst="rect">
            <a:avLst/>
          </a:prstGeom>
          <a:noFill/>
        </p:spPr>
        <p:txBody>
          <a:bodyPr wrap="none" rtlCol="0">
            <a:spAutoFit/>
          </a:bodyPr>
          <a:lstStyle/>
          <a:p>
            <a:pPr algn="ctr"/>
            <a:r>
              <a:rPr lang="en-US" sz="3200" err="1">
                <a:solidFill>
                  <a:srgbClr val="00B050"/>
                </a:solidFill>
              </a:rPr>
              <a:t>burstStartTimes</a:t>
            </a:r>
            <a:r>
              <a:rPr lang="en-US" sz="3200">
                <a:solidFill>
                  <a:srgbClr val="00B050"/>
                </a:solidFill>
              </a:rPr>
              <a:t> = [4, 11, 15] sec</a:t>
            </a:r>
          </a:p>
          <a:p>
            <a:pPr algn="ctr"/>
            <a:r>
              <a:rPr lang="en-US" sz="3200" err="1">
                <a:solidFill>
                  <a:srgbClr val="00B050"/>
                </a:solidFill>
              </a:rPr>
              <a:t>burstStartPoints</a:t>
            </a:r>
            <a:r>
              <a:rPr lang="en-US" sz="3200">
                <a:solidFill>
                  <a:srgbClr val="00B050"/>
                </a:solidFill>
              </a:rPr>
              <a:t> = [0, 3, 5]</a:t>
            </a:r>
          </a:p>
        </p:txBody>
      </p:sp>
    </p:spTree>
    <p:extLst>
      <p:ext uri="{BB962C8B-B14F-4D97-AF65-F5344CB8AC3E}">
        <p14:creationId xmlns:p14="http://schemas.microsoft.com/office/powerpoint/2010/main" val="317287041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 name="Title 1">
            <a:extLst>
              <a:ext uri="{FF2B5EF4-FFF2-40B4-BE49-F238E27FC236}">
                <a16:creationId xmlns:a16="http://schemas.microsoft.com/office/drawing/2014/main" id="{BB4E3879-0FC6-44D6-9281-34F2B554E57F}"/>
              </a:ext>
            </a:extLst>
          </p:cNvPr>
          <p:cNvSpPr txBox="1">
            <a:spLocks/>
          </p:cNvSpPr>
          <p:nvPr/>
        </p:nvSpPr>
        <p:spPr>
          <a:xfrm>
            <a:off x="838200" y="1"/>
            <a:ext cx="10515600" cy="203092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Arial" panose="020B0604020202020204" pitchFamily="34" charset="0"/>
                <a:ea typeface="+mj-ea"/>
                <a:cs typeface="Arial" panose="020B0604020202020204" pitchFamily="34" charset="0"/>
              </a:defRPr>
            </a:lvl1pPr>
          </a:lstStyle>
          <a:p>
            <a:r>
              <a:rPr lang="en-US" sz="3600" b="1">
                <a:solidFill>
                  <a:srgbClr val="7030A0"/>
                </a:solidFill>
              </a:rPr>
              <a:t>Spikes per burst: </a:t>
            </a:r>
            <a:r>
              <a:rPr lang="en-US" sz="3600"/>
              <a:t>The number of spikes that occur in a burst. For the output, this is averaged across all bursts</a:t>
            </a:r>
          </a:p>
        </p:txBody>
      </p:sp>
      <p:cxnSp>
        <p:nvCxnSpPr>
          <p:cNvPr id="35" name="Straight Connector 34">
            <a:extLst>
              <a:ext uri="{FF2B5EF4-FFF2-40B4-BE49-F238E27FC236}">
                <a16:creationId xmlns:a16="http://schemas.microsoft.com/office/drawing/2014/main" id="{2814F8E3-4AEA-4BA4-A3D8-EB9F55DB1F02}"/>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748586B8-9830-440E-91B0-F430C21E1AAE}"/>
              </a:ext>
            </a:extLst>
          </p:cNvPr>
          <p:cNvCxnSpPr>
            <a:cxnSpLocks/>
          </p:cNvCxnSpPr>
          <p:nvPr/>
        </p:nvCxnSpPr>
        <p:spPr>
          <a:xfrm>
            <a:off x="3026378"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C45B121B-A3D2-4BC8-AE2A-F676503D0272}"/>
              </a:ext>
            </a:extLst>
          </p:cNvPr>
          <p:cNvCxnSpPr>
            <a:cxnSpLocks/>
          </p:cNvCxnSpPr>
          <p:nvPr/>
        </p:nvCxnSpPr>
        <p:spPr>
          <a:xfrm>
            <a:off x="352949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622BF435-EBBA-4218-96BF-4AFCE9AB182D}"/>
              </a:ext>
            </a:extLst>
          </p:cNvPr>
          <p:cNvCxnSpPr>
            <a:cxnSpLocks/>
          </p:cNvCxnSpPr>
          <p:nvPr/>
        </p:nvCxnSpPr>
        <p:spPr>
          <a:xfrm>
            <a:off x="403260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5F8121D-EAA0-4330-999A-E18CB41CBE16}"/>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4EEB74AE-83EB-4C75-BDF1-FF349CDAE14A}"/>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55BC6AA-6EBD-42D9-B053-D4DCDC89E349}"/>
              </a:ext>
            </a:extLst>
          </p:cNvPr>
          <p:cNvCxnSpPr>
            <a:cxnSpLocks/>
          </p:cNvCxnSpPr>
          <p:nvPr/>
        </p:nvCxnSpPr>
        <p:spPr>
          <a:xfrm>
            <a:off x="856062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55A4474-74EF-48A7-81BB-0D5B373EA381}"/>
              </a:ext>
            </a:extLst>
          </p:cNvPr>
          <p:cNvCxnSpPr>
            <a:cxnSpLocks/>
          </p:cNvCxnSpPr>
          <p:nvPr/>
        </p:nvCxnSpPr>
        <p:spPr>
          <a:xfrm>
            <a:off x="906373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6865C555-B0A1-4DC7-BFB3-159291064D3E}"/>
              </a:ext>
            </a:extLst>
          </p:cNvPr>
          <p:cNvCxnSpPr>
            <a:cxnSpLocks/>
          </p:cNvCxnSpPr>
          <p:nvPr/>
        </p:nvCxnSpPr>
        <p:spPr>
          <a:xfrm>
            <a:off x="9566847"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EAC61716-623A-447C-954B-8DD898D75C07}"/>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56" name="TextBox 55">
            <a:extLst>
              <a:ext uri="{FF2B5EF4-FFF2-40B4-BE49-F238E27FC236}">
                <a16:creationId xmlns:a16="http://schemas.microsoft.com/office/drawing/2014/main" id="{506BA941-9ED2-45B9-AC3F-C8C0B0E5C028}"/>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60" name="TextBox 59">
            <a:extLst>
              <a:ext uri="{FF2B5EF4-FFF2-40B4-BE49-F238E27FC236}">
                <a16:creationId xmlns:a16="http://schemas.microsoft.com/office/drawing/2014/main" id="{D5578323-22C5-48E1-ADEE-17A44D65AA3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1" name="TextBox 60">
            <a:extLst>
              <a:ext uri="{FF2B5EF4-FFF2-40B4-BE49-F238E27FC236}">
                <a16:creationId xmlns:a16="http://schemas.microsoft.com/office/drawing/2014/main" id="{1FFB11D9-B26C-434D-9740-8725EB830EE4}"/>
              </a:ext>
            </a:extLst>
          </p:cNvPr>
          <p:cNvSpPr txBox="1"/>
          <p:nvPr/>
        </p:nvSpPr>
        <p:spPr>
          <a:xfrm>
            <a:off x="3373038"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a:t>
            </a:r>
          </a:p>
        </p:txBody>
      </p:sp>
      <p:sp>
        <p:nvSpPr>
          <p:cNvPr id="62" name="TextBox 61">
            <a:extLst>
              <a:ext uri="{FF2B5EF4-FFF2-40B4-BE49-F238E27FC236}">
                <a16:creationId xmlns:a16="http://schemas.microsoft.com/office/drawing/2014/main" id="{83114AA9-4B59-41B6-ADFE-6C4F2491E6E7}"/>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CA7BFD84-ABBA-4A9A-B2F8-6FC0089400F0}"/>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68" name="TextBox 67">
            <a:extLst>
              <a:ext uri="{FF2B5EF4-FFF2-40B4-BE49-F238E27FC236}">
                <a16:creationId xmlns:a16="http://schemas.microsoft.com/office/drawing/2014/main" id="{CB981839-37F6-4368-8E3F-DF8754634807}"/>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71" name="TextBox 70">
            <a:extLst>
              <a:ext uri="{FF2B5EF4-FFF2-40B4-BE49-F238E27FC236}">
                <a16:creationId xmlns:a16="http://schemas.microsoft.com/office/drawing/2014/main" id="{D45BBE2E-DF92-4219-BC3A-1AF1A2792BF9}"/>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72" name="TextBox 71">
            <a:extLst>
              <a:ext uri="{FF2B5EF4-FFF2-40B4-BE49-F238E27FC236}">
                <a16:creationId xmlns:a16="http://schemas.microsoft.com/office/drawing/2014/main" id="{BD8B3B41-1FE1-4CCC-9168-42A24303DFDC}"/>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73" name="TextBox 72">
            <a:extLst>
              <a:ext uri="{FF2B5EF4-FFF2-40B4-BE49-F238E27FC236}">
                <a16:creationId xmlns:a16="http://schemas.microsoft.com/office/drawing/2014/main" id="{D2BC4F3C-EDCE-490E-ADBC-F65B227FA8F9}"/>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76" name="TextBox 75">
            <a:extLst>
              <a:ext uri="{FF2B5EF4-FFF2-40B4-BE49-F238E27FC236}">
                <a16:creationId xmlns:a16="http://schemas.microsoft.com/office/drawing/2014/main" id="{5FC86196-7C2D-42D7-BE6A-1D096E132698}"/>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80" name="TextBox 79">
            <a:extLst>
              <a:ext uri="{FF2B5EF4-FFF2-40B4-BE49-F238E27FC236}">
                <a16:creationId xmlns:a16="http://schemas.microsoft.com/office/drawing/2014/main" id="{0C900B59-4201-4F1B-B8E7-7340816C4316}"/>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5A66A2F2-34E3-4247-8534-59192890CC22}"/>
              </a:ext>
            </a:extLst>
          </p:cNvPr>
          <p:cNvSpPr txBox="1"/>
          <p:nvPr/>
        </p:nvSpPr>
        <p:spPr>
          <a:xfrm>
            <a:off x="337303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17974CD7-4EB3-4ABE-9BD7-E18031C0821C}"/>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7" name="TextBox 86">
            <a:extLst>
              <a:ext uri="{FF2B5EF4-FFF2-40B4-BE49-F238E27FC236}">
                <a16:creationId xmlns:a16="http://schemas.microsoft.com/office/drawing/2014/main" id="{95024911-2DE9-4D0B-A4B3-4BD19777884F}"/>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90" name="TextBox 89">
            <a:extLst>
              <a:ext uri="{FF2B5EF4-FFF2-40B4-BE49-F238E27FC236}">
                <a16:creationId xmlns:a16="http://schemas.microsoft.com/office/drawing/2014/main" id="{062B7B16-42E2-4076-A421-365223EFD43C}"/>
              </a:ext>
            </a:extLst>
          </p:cNvPr>
          <p:cNvSpPr txBox="1"/>
          <p:nvPr/>
        </p:nvSpPr>
        <p:spPr>
          <a:xfrm>
            <a:off x="6894829"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23" name="TextBox 122">
            <a:extLst>
              <a:ext uri="{FF2B5EF4-FFF2-40B4-BE49-F238E27FC236}">
                <a16:creationId xmlns:a16="http://schemas.microsoft.com/office/drawing/2014/main" id="{F07E911A-EF55-4077-B0DF-D9984A42F982}"/>
              </a:ext>
            </a:extLst>
          </p:cNvPr>
          <p:cNvSpPr txBox="1"/>
          <p:nvPr/>
        </p:nvSpPr>
        <p:spPr>
          <a:xfrm>
            <a:off x="8404168"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24" name="TextBox 123">
            <a:extLst>
              <a:ext uri="{FF2B5EF4-FFF2-40B4-BE49-F238E27FC236}">
                <a16:creationId xmlns:a16="http://schemas.microsoft.com/office/drawing/2014/main" id="{E4DDCEBE-F36D-42F0-91A2-FD89D2A6C8CA}"/>
              </a:ext>
            </a:extLst>
          </p:cNvPr>
          <p:cNvSpPr txBox="1"/>
          <p:nvPr/>
        </p:nvSpPr>
        <p:spPr>
          <a:xfrm>
            <a:off x="8907281"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125" name="TextBox 124">
            <a:extLst>
              <a:ext uri="{FF2B5EF4-FFF2-40B4-BE49-F238E27FC236}">
                <a16:creationId xmlns:a16="http://schemas.microsoft.com/office/drawing/2014/main" id="{51749985-D96F-4694-BCC7-0CCD556B9E04}"/>
              </a:ext>
            </a:extLst>
          </p:cNvPr>
          <p:cNvSpPr txBox="1"/>
          <p:nvPr/>
        </p:nvSpPr>
        <p:spPr>
          <a:xfrm>
            <a:off x="9410394"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sp>
        <p:nvSpPr>
          <p:cNvPr id="128" name="TextBox 127">
            <a:extLst>
              <a:ext uri="{FF2B5EF4-FFF2-40B4-BE49-F238E27FC236}">
                <a16:creationId xmlns:a16="http://schemas.microsoft.com/office/drawing/2014/main" id="{8B5F1059-0ECA-4AA6-AA71-49F6194AB602}"/>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9" name="TextBox 128">
            <a:extLst>
              <a:ext uri="{FF2B5EF4-FFF2-40B4-BE49-F238E27FC236}">
                <a16:creationId xmlns:a16="http://schemas.microsoft.com/office/drawing/2014/main" id="{17105D4D-3475-4F62-8B53-E8A9D9E8CB2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130" name="TextBox 129">
            <a:extLst>
              <a:ext uri="{FF2B5EF4-FFF2-40B4-BE49-F238E27FC236}">
                <a16:creationId xmlns:a16="http://schemas.microsoft.com/office/drawing/2014/main" id="{E1961E32-E05C-4074-9202-D26E7C008F2F}"/>
              </a:ext>
            </a:extLst>
          </p:cNvPr>
          <p:cNvSpPr txBox="1"/>
          <p:nvPr/>
        </p:nvSpPr>
        <p:spPr>
          <a:xfrm>
            <a:off x="2590774" y="4667925"/>
            <a:ext cx="1877438" cy="64633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3 spikes</a:t>
            </a:r>
            <a:endParaRPr lang="en-US" sz="3600">
              <a:solidFill>
                <a:schemeClr val="accent1"/>
              </a:solidFill>
            </a:endParaRPr>
          </a:p>
        </p:txBody>
      </p:sp>
      <p:sp>
        <p:nvSpPr>
          <p:cNvPr id="131" name="TextBox 130">
            <a:extLst>
              <a:ext uri="{FF2B5EF4-FFF2-40B4-BE49-F238E27FC236}">
                <a16:creationId xmlns:a16="http://schemas.microsoft.com/office/drawing/2014/main" id="{92EE0D56-23EA-4DB3-ADC0-F17F7053200A}"/>
              </a:ext>
            </a:extLst>
          </p:cNvPr>
          <p:cNvSpPr txBox="1"/>
          <p:nvPr/>
        </p:nvSpPr>
        <p:spPr>
          <a:xfrm>
            <a:off x="5891990" y="4667925"/>
            <a:ext cx="1877438" cy="64633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2 spikes</a:t>
            </a:r>
            <a:endParaRPr lang="en-US" sz="3600">
              <a:solidFill>
                <a:schemeClr val="accent1"/>
              </a:solidFill>
            </a:endParaRPr>
          </a:p>
        </p:txBody>
      </p:sp>
      <p:sp>
        <p:nvSpPr>
          <p:cNvPr id="132" name="TextBox 131">
            <a:extLst>
              <a:ext uri="{FF2B5EF4-FFF2-40B4-BE49-F238E27FC236}">
                <a16:creationId xmlns:a16="http://schemas.microsoft.com/office/drawing/2014/main" id="{7056583F-8F74-4665-93C0-E9BE7FAB6F79}"/>
              </a:ext>
            </a:extLst>
          </p:cNvPr>
          <p:cNvSpPr txBox="1"/>
          <p:nvPr/>
        </p:nvSpPr>
        <p:spPr>
          <a:xfrm>
            <a:off x="8125015" y="4667925"/>
            <a:ext cx="1877438" cy="64633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3 spikes</a:t>
            </a:r>
            <a:endParaRPr lang="en-US" sz="3600">
              <a:solidFill>
                <a:schemeClr val="accent1"/>
              </a:solidFill>
            </a:endParaRPr>
          </a:p>
        </p:txBody>
      </p:sp>
      <mc:AlternateContent xmlns:mc="http://schemas.openxmlformats.org/markup-compatibility/2006">
        <mc:Choice xmlns:a14="http://schemas.microsoft.com/office/drawing/2010/main" Requires="a14">
          <p:sp>
            <p:nvSpPr>
              <p:cNvPr id="133" name="TextBox 132">
                <a:extLst>
                  <a:ext uri="{FF2B5EF4-FFF2-40B4-BE49-F238E27FC236}">
                    <a16:creationId xmlns:a16="http://schemas.microsoft.com/office/drawing/2014/main" id="{FCBFF678-2D12-4089-BC17-3FF02D8C29CF}"/>
                  </a:ext>
                </a:extLst>
              </p:cNvPr>
              <p:cNvSpPr txBox="1"/>
              <p:nvPr/>
            </p:nvSpPr>
            <p:spPr>
              <a:xfrm>
                <a:off x="226251" y="5892094"/>
                <a:ext cx="11739497" cy="965905"/>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Spikes per burst = </a:t>
                </a:r>
                <a14:m>
                  <m:oMath xmlns:m="http://schemas.openxmlformats.org/officeDocument/2006/math">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𝑠𝑢𝑚</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𝑠𝑝𝑖𝑘𝑒𝑠</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𝑝𝑒𝑟</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𝑏𝑢𝑟𝑠𝑡</m:t>
                        </m:r>
                        <m:r>
                          <a:rPr lang="en-US" sz="3600" b="0" i="1" smtClean="0">
                            <a:solidFill>
                              <a:schemeClr val="accent1"/>
                            </a:solidFill>
                            <a:latin typeface="Cambria Math" panose="02040503050406030204" pitchFamily="18" charset="0"/>
                          </a:rPr>
                          <m:t>)</m:t>
                        </m:r>
                      </m:num>
                      <m:den>
                        <m:r>
                          <a:rPr lang="en-US" sz="3600" b="0" i="1" smtClean="0">
                            <a:solidFill>
                              <a:schemeClr val="accent1"/>
                            </a:solidFill>
                            <a:latin typeface="Cambria Math" panose="02040503050406030204" pitchFamily="18" charset="0"/>
                          </a:rPr>
                          <m:t>𝑛𝑢𝑚𝑏𝑒𝑟</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𝑜𝑓</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𝑏𝑢𝑟𝑠𝑡𝑠</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3+2+3</m:t>
                        </m:r>
                      </m:num>
                      <m:den>
                        <m:r>
                          <a:rPr lang="en-US" sz="3600" b="0" i="1" smtClean="0">
                            <a:solidFill>
                              <a:schemeClr val="accent1"/>
                            </a:solidFill>
                            <a:latin typeface="Cambria Math" panose="02040503050406030204" pitchFamily="18" charset="0"/>
                          </a:rPr>
                          <m:t>3</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8</m:t>
                        </m:r>
                      </m:num>
                      <m:den>
                        <m:r>
                          <a:rPr lang="en-US" sz="3600" b="0" i="1" smtClean="0">
                            <a:solidFill>
                              <a:schemeClr val="accent1"/>
                            </a:solidFill>
                            <a:latin typeface="Cambria Math" panose="02040503050406030204" pitchFamily="18" charset="0"/>
                          </a:rPr>
                          <m:t>3</m:t>
                        </m:r>
                      </m:den>
                    </m:f>
                    <m:r>
                      <a:rPr lang="en-US" sz="3600" b="0" i="1" smtClean="0">
                        <a:solidFill>
                          <a:schemeClr val="accent1"/>
                        </a:solidFill>
                        <a:latin typeface="Cambria Math" panose="02040503050406030204" pitchFamily="18" charset="0"/>
                      </a:rPr>
                      <m:t>=2.67</m:t>
                    </m:r>
                  </m:oMath>
                </a14:m>
                <a:endParaRPr lang="en-US" sz="3600">
                  <a:solidFill>
                    <a:schemeClr val="accent1"/>
                  </a:solidFill>
                </a:endParaRPr>
              </a:p>
            </p:txBody>
          </p:sp>
        </mc:Choice>
        <mc:Fallback>
          <p:sp>
            <p:nvSpPr>
              <p:cNvPr id="133" name="TextBox 132">
                <a:extLst>
                  <a:ext uri="{FF2B5EF4-FFF2-40B4-BE49-F238E27FC236}">
                    <a16:creationId xmlns:a16="http://schemas.microsoft.com/office/drawing/2014/main" id="{FCBFF678-2D12-4089-BC17-3FF02D8C29CF}"/>
                  </a:ext>
                </a:extLst>
              </p:cNvPr>
              <p:cNvSpPr txBox="1">
                <a:spLocks noRot="1" noChangeAspect="1" noMove="1" noResize="1" noEditPoints="1" noAdjustHandles="1" noChangeArrowheads="1" noChangeShapeType="1" noTextEdit="1"/>
              </p:cNvSpPr>
              <p:nvPr/>
            </p:nvSpPr>
            <p:spPr>
              <a:xfrm>
                <a:off x="226251" y="5892094"/>
                <a:ext cx="11739497" cy="965905"/>
              </a:xfrm>
              <a:prstGeom prst="rect">
                <a:avLst/>
              </a:prstGeom>
              <a:blipFill>
                <a:blip r:embed="rId2"/>
                <a:stretch>
                  <a:fillRect l="-1090" b="-3797"/>
                </a:stretch>
              </a:blipFill>
            </p:spPr>
            <p:txBody>
              <a:bodyPr/>
              <a:lstStyle/>
              <a:p>
                <a:r>
                  <a:rPr lang="en-US">
                    <a:noFill/>
                  </a:rPr>
                  <a:t> </a:t>
                </a:r>
              </a:p>
            </p:txBody>
          </p:sp>
        </mc:Fallback>
      </mc:AlternateContent>
      <p:sp>
        <p:nvSpPr>
          <p:cNvPr id="134" name="TextBox 133">
            <a:extLst>
              <a:ext uri="{FF2B5EF4-FFF2-40B4-BE49-F238E27FC236}">
                <a16:creationId xmlns:a16="http://schemas.microsoft.com/office/drawing/2014/main" id="{4F52454D-2976-4067-8ED1-20866AC8B786}"/>
              </a:ext>
            </a:extLst>
          </p:cNvPr>
          <p:cNvSpPr txBox="1"/>
          <p:nvPr/>
        </p:nvSpPr>
        <p:spPr>
          <a:xfrm>
            <a:off x="4015942" y="5229584"/>
            <a:ext cx="4160114" cy="584775"/>
          </a:xfrm>
          <a:prstGeom prst="rect">
            <a:avLst/>
          </a:prstGeom>
          <a:noFill/>
        </p:spPr>
        <p:txBody>
          <a:bodyPr wrap="none" rtlCol="0">
            <a:spAutoFit/>
          </a:bodyPr>
          <a:lstStyle/>
          <a:p>
            <a:pPr algn="ctr"/>
            <a:r>
              <a:rPr lang="en-US" sz="3200" err="1">
                <a:solidFill>
                  <a:srgbClr val="00B050"/>
                </a:solidFill>
              </a:rPr>
              <a:t>burstSpikes</a:t>
            </a:r>
            <a:r>
              <a:rPr lang="en-US" sz="3200">
                <a:solidFill>
                  <a:srgbClr val="00B050"/>
                </a:solidFill>
              </a:rPr>
              <a:t> = [3, 2, 3]</a:t>
            </a:r>
          </a:p>
        </p:txBody>
      </p:sp>
    </p:spTree>
    <p:extLst>
      <p:ext uri="{BB962C8B-B14F-4D97-AF65-F5344CB8AC3E}">
        <p14:creationId xmlns:p14="http://schemas.microsoft.com/office/powerpoint/2010/main" val="7048960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TextBox 41">
            <a:extLst>
              <a:ext uri="{FF2B5EF4-FFF2-40B4-BE49-F238E27FC236}">
                <a16:creationId xmlns:a16="http://schemas.microsoft.com/office/drawing/2014/main" id="{804278AB-ADAA-4094-9AC0-41B605F71761}"/>
              </a:ext>
            </a:extLst>
          </p:cNvPr>
          <p:cNvSpPr txBox="1"/>
          <p:nvPr/>
        </p:nvSpPr>
        <p:spPr>
          <a:xfrm>
            <a:off x="3117519" y="3244334"/>
            <a:ext cx="301686" cy="369332"/>
          </a:xfrm>
          <a:prstGeom prst="rect">
            <a:avLst/>
          </a:prstGeom>
          <a:noFill/>
        </p:spPr>
        <p:txBody>
          <a:bodyPr wrap="square" rtlCol="0">
            <a:spAutoFit/>
          </a:bodyPr>
          <a:lstStyle/>
          <a:p>
            <a:pPr algn="ctr"/>
            <a:r>
              <a:rPr lang="en-US"/>
              <a:t>1</a:t>
            </a:r>
          </a:p>
        </p:txBody>
      </p:sp>
      <p:sp>
        <p:nvSpPr>
          <p:cNvPr id="88" name="Title 1">
            <a:extLst>
              <a:ext uri="{FF2B5EF4-FFF2-40B4-BE49-F238E27FC236}">
                <a16:creationId xmlns:a16="http://schemas.microsoft.com/office/drawing/2014/main" id="{BB4E3879-0FC6-44D6-9281-34F2B554E57F}"/>
              </a:ext>
            </a:extLst>
          </p:cNvPr>
          <p:cNvSpPr txBox="1">
            <a:spLocks/>
          </p:cNvSpPr>
          <p:nvPr/>
        </p:nvSpPr>
        <p:spPr>
          <a:xfrm>
            <a:off x="838200" y="1"/>
            <a:ext cx="10515600" cy="203092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Arial" panose="020B0604020202020204" pitchFamily="34" charset="0"/>
                <a:ea typeface="+mj-ea"/>
                <a:cs typeface="Arial" panose="020B0604020202020204" pitchFamily="34" charset="0"/>
              </a:defRPr>
            </a:lvl1pPr>
          </a:lstStyle>
          <a:p>
            <a:r>
              <a:rPr lang="en-US" sz="3600" b="1">
                <a:solidFill>
                  <a:srgbClr val="7030A0"/>
                </a:solidFill>
              </a:rPr>
              <a:t>Intra-burst interval: </a:t>
            </a:r>
            <a:r>
              <a:rPr lang="en-US" sz="3600"/>
              <a:t>The time between two spikes within a burst. By definition, and interval less than the burst window</a:t>
            </a:r>
          </a:p>
        </p:txBody>
      </p:sp>
      <p:cxnSp>
        <p:nvCxnSpPr>
          <p:cNvPr id="35" name="Straight Connector 34">
            <a:extLst>
              <a:ext uri="{FF2B5EF4-FFF2-40B4-BE49-F238E27FC236}">
                <a16:creationId xmlns:a16="http://schemas.microsoft.com/office/drawing/2014/main" id="{2814F8E3-4AEA-4BA4-A3D8-EB9F55DB1F02}"/>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748586B8-9830-440E-91B0-F430C21E1AAE}"/>
              </a:ext>
            </a:extLst>
          </p:cNvPr>
          <p:cNvCxnSpPr>
            <a:cxnSpLocks/>
          </p:cNvCxnSpPr>
          <p:nvPr/>
        </p:nvCxnSpPr>
        <p:spPr>
          <a:xfrm>
            <a:off x="3026378"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C45B121B-A3D2-4BC8-AE2A-F676503D0272}"/>
              </a:ext>
            </a:extLst>
          </p:cNvPr>
          <p:cNvCxnSpPr>
            <a:cxnSpLocks/>
          </p:cNvCxnSpPr>
          <p:nvPr/>
        </p:nvCxnSpPr>
        <p:spPr>
          <a:xfrm>
            <a:off x="352949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622BF435-EBBA-4218-96BF-4AFCE9AB182D}"/>
              </a:ext>
            </a:extLst>
          </p:cNvPr>
          <p:cNvCxnSpPr>
            <a:cxnSpLocks/>
          </p:cNvCxnSpPr>
          <p:nvPr/>
        </p:nvCxnSpPr>
        <p:spPr>
          <a:xfrm>
            <a:off x="403260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5F8121D-EAA0-4330-999A-E18CB41CBE16}"/>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4EEB74AE-83EB-4C75-BDF1-FF349CDAE14A}"/>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55BC6AA-6EBD-42D9-B053-D4DCDC89E349}"/>
              </a:ext>
            </a:extLst>
          </p:cNvPr>
          <p:cNvCxnSpPr>
            <a:cxnSpLocks/>
          </p:cNvCxnSpPr>
          <p:nvPr/>
        </p:nvCxnSpPr>
        <p:spPr>
          <a:xfrm>
            <a:off x="856062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55A4474-74EF-48A7-81BB-0D5B373EA381}"/>
              </a:ext>
            </a:extLst>
          </p:cNvPr>
          <p:cNvCxnSpPr>
            <a:cxnSpLocks/>
          </p:cNvCxnSpPr>
          <p:nvPr/>
        </p:nvCxnSpPr>
        <p:spPr>
          <a:xfrm>
            <a:off x="906373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6865C555-B0A1-4DC7-BFB3-159291064D3E}"/>
              </a:ext>
            </a:extLst>
          </p:cNvPr>
          <p:cNvCxnSpPr>
            <a:cxnSpLocks/>
          </p:cNvCxnSpPr>
          <p:nvPr/>
        </p:nvCxnSpPr>
        <p:spPr>
          <a:xfrm>
            <a:off x="9566847"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EAC61716-623A-447C-954B-8DD898D75C07}"/>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56" name="TextBox 55">
            <a:extLst>
              <a:ext uri="{FF2B5EF4-FFF2-40B4-BE49-F238E27FC236}">
                <a16:creationId xmlns:a16="http://schemas.microsoft.com/office/drawing/2014/main" id="{506BA941-9ED2-45B9-AC3F-C8C0B0E5C028}"/>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60" name="TextBox 59">
            <a:extLst>
              <a:ext uri="{FF2B5EF4-FFF2-40B4-BE49-F238E27FC236}">
                <a16:creationId xmlns:a16="http://schemas.microsoft.com/office/drawing/2014/main" id="{D5578323-22C5-48E1-ADEE-17A44D65AA3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1" name="TextBox 60">
            <a:extLst>
              <a:ext uri="{FF2B5EF4-FFF2-40B4-BE49-F238E27FC236}">
                <a16:creationId xmlns:a16="http://schemas.microsoft.com/office/drawing/2014/main" id="{1FFB11D9-B26C-434D-9740-8725EB830EE4}"/>
              </a:ext>
            </a:extLst>
          </p:cNvPr>
          <p:cNvSpPr txBox="1"/>
          <p:nvPr/>
        </p:nvSpPr>
        <p:spPr>
          <a:xfrm>
            <a:off x="3373038"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a:t>
            </a:r>
          </a:p>
        </p:txBody>
      </p:sp>
      <p:sp>
        <p:nvSpPr>
          <p:cNvPr id="62" name="TextBox 61">
            <a:extLst>
              <a:ext uri="{FF2B5EF4-FFF2-40B4-BE49-F238E27FC236}">
                <a16:creationId xmlns:a16="http://schemas.microsoft.com/office/drawing/2014/main" id="{83114AA9-4B59-41B6-ADFE-6C4F2491E6E7}"/>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CA7BFD84-ABBA-4A9A-B2F8-6FC0089400F0}"/>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68" name="TextBox 67">
            <a:extLst>
              <a:ext uri="{FF2B5EF4-FFF2-40B4-BE49-F238E27FC236}">
                <a16:creationId xmlns:a16="http://schemas.microsoft.com/office/drawing/2014/main" id="{CB981839-37F6-4368-8E3F-DF8754634807}"/>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71" name="TextBox 70">
            <a:extLst>
              <a:ext uri="{FF2B5EF4-FFF2-40B4-BE49-F238E27FC236}">
                <a16:creationId xmlns:a16="http://schemas.microsoft.com/office/drawing/2014/main" id="{D45BBE2E-DF92-4219-BC3A-1AF1A2792BF9}"/>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72" name="TextBox 71">
            <a:extLst>
              <a:ext uri="{FF2B5EF4-FFF2-40B4-BE49-F238E27FC236}">
                <a16:creationId xmlns:a16="http://schemas.microsoft.com/office/drawing/2014/main" id="{BD8B3B41-1FE1-4CCC-9168-42A24303DFDC}"/>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73" name="TextBox 72">
            <a:extLst>
              <a:ext uri="{FF2B5EF4-FFF2-40B4-BE49-F238E27FC236}">
                <a16:creationId xmlns:a16="http://schemas.microsoft.com/office/drawing/2014/main" id="{D2BC4F3C-EDCE-490E-ADBC-F65B227FA8F9}"/>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76" name="TextBox 75">
            <a:extLst>
              <a:ext uri="{FF2B5EF4-FFF2-40B4-BE49-F238E27FC236}">
                <a16:creationId xmlns:a16="http://schemas.microsoft.com/office/drawing/2014/main" id="{5FC86196-7C2D-42D7-BE6A-1D096E132698}"/>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80" name="TextBox 79">
            <a:extLst>
              <a:ext uri="{FF2B5EF4-FFF2-40B4-BE49-F238E27FC236}">
                <a16:creationId xmlns:a16="http://schemas.microsoft.com/office/drawing/2014/main" id="{0C900B59-4201-4F1B-B8E7-7340816C4316}"/>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5A66A2F2-34E3-4247-8534-59192890CC22}"/>
              </a:ext>
            </a:extLst>
          </p:cNvPr>
          <p:cNvSpPr txBox="1"/>
          <p:nvPr/>
        </p:nvSpPr>
        <p:spPr>
          <a:xfrm>
            <a:off x="337303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17974CD7-4EB3-4ABE-9BD7-E18031C0821C}"/>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7" name="TextBox 86">
            <a:extLst>
              <a:ext uri="{FF2B5EF4-FFF2-40B4-BE49-F238E27FC236}">
                <a16:creationId xmlns:a16="http://schemas.microsoft.com/office/drawing/2014/main" id="{95024911-2DE9-4D0B-A4B3-4BD19777884F}"/>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90" name="TextBox 89">
            <a:extLst>
              <a:ext uri="{FF2B5EF4-FFF2-40B4-BE49-F238E27FC236}">
                <a16:creationId xmlns:a16="http://schemas.microsoft.com/office/drawing/2014/main" id="{062B7B16-42E2-4076-A421-365223EFD43C}"/>
              </a:ext>
            </a:extLst>
          </p:cNvPr>
          <p:cNvSpPr txBox="1"/>
          <p:nvPr/>
        </p:nvSpPr>
        <p:spPr>
          <a:xfrm>
            <a:off x="6894829"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23" name="TextBox 122">
            <a:extLst>
              <a:ext uri="{FF2B5EF4-FFF2-40B4-BE49-F238E27FC236}">
                <a16:creationId xmlns:a16="http://schemas.microsoft.com/office/drawing/2014/main" id="{F07E911A-EF55-4077-B0DF-D9984A42F982}"/>
              </a:ext>
            </a:extLst>
          </p:cNvPr>
          <p:cNvSpPr txBox="1"/>
          <p:nvPr/>
        </p:nvSpPr>
        <p:spPr>
          <a:xfrm>
            <a:off x="8404168"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24" name="TextBox 123">
            <a:extLst>
              <a:ext uri="{FF2B5EF4-FFF2-40B4-BE49-F238E27FC236}">
                <a16:creationId xmlns:a16="http://schemas.microsoft.com/office/drawing/2014/main" id="{E4DDCEBE-F36D-42F0-91A2-FD89D2A6C8CA}"/>
              </a:ext>
            </a:extLst>
          </p:cNvPr>
          <p:cNvSpPr txBox="1"/>
          <p:nvPr/>
        </p:nvSpPr>
        <p:spPr>
          <a:xfrm>
            <a:off x="8907281"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125" name="TextBox 124">
            <a:extLst>
              <a:ext uri="{FF2B5EF4-FFF2-40B4-BE49-F238E27FC236}">
                <a16:creationId xmlns:a16="http://schemas.microsoft.com/office/drawing/2014/main" id="{51749985-D96F-4694-BCC7-0CCD556B9E04}"/>
              </a:ext>
            </a:extLst>
          </p:cNvPr>
          <p:cNvSpPr txBox="1"/>
          <p:nvPr/>
        </p:nvSpPr>
        <p:spPr>
          <a:xfrm>
            <a:off x="9410394"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sp>
        <p:nvSpPr>
          <p:cNvPr id="128" name="TextBox 127">
            <a:extLst>
              <a:ext uri="{FF2B5EF4-FFF2-40B4-BE49-F238E27FC236}">
                <a16:creationId xmlns:a16="http://schemas.microsoft.com/office/drawing/2014/main" id="{8B5F1059-0ECA-4AA6-AA71-49F6194AB602}"/>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9" name="TextBox 128">
            <a:extLst>
              <a:ext uri="{FF2B5EF4-FFF2-40B4-BE49-F238E27FC236}">
                <a16:creationId xmlns:a16="http://schemas.microsoft.com/office/drawing/2014/main" id="{17105D4D-3475-4F62-8B53-E8A9D9E8CB2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cxnSp>
        <p:nvCxnSpPr>
          <p:cNvPr id="38" name="Straight Connector 37">
            <a:extLst>
              <a:ext uri="{FF2B5EF4-FFF2-40B4-BE49-F238E27FC236}">
                <a16:creationId xmlns:a16="http://schemas.microsoft.com/office/drawing/2014/main" id="{DAFE289F-1C50-4872-AE7C-87ED291EF7BA}"/>
              </a:ext>
            </a:extLst>
          </p:cNvPr>
          <p:cNvCxnSpPr>
            <a:cxnSpLocks/>
          </p:cNvCxnSpPr>
          <p:nvPr/>
        </p:nvCxnSpPr>
        <p:spPr>
          <a:xfrm>
            <a:off x="3026378"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a16="http://schemas.microsoft.com/office/drawing/2014/main" id="{F83A1E40-4E6D-4820-BCEB-8AA1205428FA}"/>
              </a:ext>
            </a:extLst>
          </p:cNvPr>
          <p:cNvSpPr txBox="1"/>
          <p:nvPr/>
        </p:nvSpPr>
        <p:spPr>
          <a:xfrm>
            <a:off x="3621856" y="3244334"/>
            <a:ext cx="301686" cy="369332"/>
          </a:xfrm>
          <a:prstGeom prst="rect">
            <a:avLst/>
          </a:prstGeom>
          <a:noFill/>
        </p:spPr>
        <p:txBody>
          <a:bodyPr wrap="square" rtlCol="0">
            <a:spAutoFit/>
          </a:bodyPr>
          <a:lstStyle/>
          <a:p>
            <a:pPr algn="ctr"/>
            <a:r>
              <a:rPr lang="en-US"/>
              <a:t>1</a:t>
            </a:r>
          </a:p>
        </p:txBody>
      </p:sp>
      <p:cxnSp>
        <p:nvCxnSpPr>
          <p:cNvPr id="45" name="Straight Connector 44">
            <a:extLst>
              <a:ext uri="{FF2B5EF4-FFF2-40B4-BE49-F238E27FC236}">
                <a16:creationId xmlns:a16="http://schemas.microsoft.com/office/drawing/2014/main" id="{D39932FB-9D8A-403B-AAAD-59EB3EEE70AD}"/>
              </a:ext>
            </a:extLst>
          </p:cNvPr>
          <p:cNvCxnSpPr>
            <a:cxnSpLocks/>
          </p:cNvCxnSpPr>
          <p:nvPr/>
        </p:nvCxnSpPr>
        <p:spPr>
          <a:xfrm>
            <a:off x="3530715"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D4C94EE9-8875-4F62-87AD-B68E516FFB8A}"/>
              </a:ext>
            </a:extLst>
          </p:cNvPr>
          <p:cNvSpPr txBox="1"/>
          <p:nvPr/>
        </p:nvSpPr>
        <p:spPr>
          <a:xfrm>
            <a:off x="6639310" y="3244334"/>
            <a:ext cx="301686" cy="369332"/>
          </a:xfrm>
          <a:prstGeom prst="rect">
            <a:avLst/>
          </a:prstGeom>
          <a:noFill/>
        </p:spPr>
        <p:txBody>
          <a:bodyPr wrap="square" rtlCol="0">
            <a:spAutoFit/>
          </a:bodyPr>
          <a:lstStyle/>
          <a:p>
            <a:pPr algn="ctr"/>
            <a:r>
              <a:rPr lang="en-US"/>
              <a:t>1</a:t>
            </a:r>
          </a:p>
        </p:txBody>
      </p:sp>
      <p:cxnSp>
        <p:nvCxnSpPr>
          <p:cNvPr id="49" name="Straight Connector 48">
            <a:extLst>
              <a:ext uri="{FF2B5EF4-FFF2-40B4-BE49-F238E27FC236}">
                <a16:creationId xmlns:a16="http://schemas.microsoft.com/office/drawing/2014/main" id="{50E26952-EBEB-405B-9051-66196D06390A}"/>
              </a:ext>
            </a:extLst>
          </p:cNvPr>
          <p:cNvCxnSpPr>
            <a:cxnSpLocks/>
          </p:cNvCxnSpPr>
          <p:nvPr/>
        </p:nvCxnSpPr>
        <p:spPr>
          <a:xfrm>
            <a:off x="6548169"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53" name="TextBox 52">
            <a:extLst>
              <a:ext uri="{FF2B5EF4-FFF2-40B4-BE49-F238E27FC236}">
                <a16:creationId xmlns:a16="http://schemas.microsoft.com/office/drawing/2014/main" id="{CD3429B1-4AE3-4F50-98AC-4E8C6CA50AAE}"/>
              </a:ext>
            </a:extLst>
          </p:cNvPr>
          <p:cNvSpPr txBox="1"/>
          <p:nvPr/>
        </p:nvSpPr>
        <p:spPr>
          <a:xfrm>
            <a:off x="8650539" y="3244334"/>
            <a:ext cx="301686" cy="369332"/>
          </a:xfrm>
          <a:prstGeom prst="rect">
            <a:avLst/>
          </a:prstGeom>
          <a:noFill/>
        </p:spPr>
        <p:txBody>
          <a:bodyPr wrap="square" rtlCol="0">
            <a:spAutoFit/>
          </a:bodyPr>
          <a:lstStyle/>
          <a:p>
            <a:pPr algn="ctr"/>
            <a:r>
              <a:rPr lang="en-US"/>
              <a:t>1</a:t>
            </a:r>
          </a:p>
        </p:txBody>
      </p:sp>
      <p:cxnSp>
        <p:nvCxnSpPr>
          <p:cNvPr id="54" name="Straight Connector 53">
            <a:extLst>
              <a:ext uri="{FF2B5EF4-FFF2-40B4-BE49-F238E27FC236}">
                <a16:creationId xmlns:a16="http://schemas.microsoft.com/office/drawing/2014/main" id="{D9B1F86C-9611-4892-A6E2-60BC0F869D89}"/>
              </a:ext>
            </a:extLst>
          </p:cNvPr>
          <p:cNvCxnSpPr>
            <a:cxnSpLocks/>
          </p:cNvCxnSpPr>
          <p:nvPr/>
        </p:nvCxnSpPr>
        <p:spPr>
          <a:xfrm>
            <a:off x="8559398"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59" name="TextBox 58">
            <a:extLst>
              <a:ext uri="{FF2B5EF4-FFF2-40B4-BE49-F238E27FC236}">
                <a16:creationId xmlns:a16="http://schemas.microsoft.com/office/drawing/2014/main" id="{3F539560-D257-4FDC-973B-29F18C2CDA04}"/>
              </a:ext>
            </a:extLst>
          </p:cNvPr>
          <p:cNvSpPr txBox="1"/>
          <p:nvPr/>
        </p:nvSpPr>
        <p:spPr>
          <a:xfrm>
            <a:off x="9144078" y="3244334"/>
            <a:ext cx="301686" cy="369332"/>
          </a:xfrm>
          <a:prstGeom prst="rect">
            <a:avLst/>
          </a:prstGeom>
          <a:noFill/>
        </p:spPr>
        <p:txBody>
          <a:bodyPr wrap="square" rtlCol="0">
            <a:spAutoFit/>
          </a:bodyPr>
          <a:lstStyle/>
          <a:p>
            <a:pPr algn="ctr"/>
            <a:r>
              <a:rPr lang="en-US"/>
              <a:t>1</a:t>
            </a:r>
          </a:p>
        </p:txBody>
      </p:sp>
      <p:cxnSp>
        <p:nvCxnSpPr>
          <p:cNvPr id="63" name="Straight Connector 62">
            <a:extLst>
              <a:ext uri="{FF2B5EF4-FFF2-40B4-BE49-F238E27FC236}">
                <a16:creationId xmlns:a16="http://schemas.microsoft.com/office/drawing/2014/main" id="{325783C9-EA5F-4789-AD32-370C2EC353B8}"/>
              </a:ext>
            </a:extLst>
          </p:cNvPr>
          <p:cNvCxnSpPr>
            <a:cxnSpLocks/>
          </p:cNvCxnSpPr>
          <p:nvPr/>
        </p:nvCxnSpPr>
        <p:spPr>
          <a:xfrm>
            <a:off x="9052937"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2" name="Arrow: Down 1">
            <a:extLst>
              <a:ext uri="{FF2B5EF4-FFF2-40B4-BE49-F238E27FC236}">
                <a16:creationId xmlns:a16="http://schemas.microsoft.com/office/drawing/2014/main" id="{F51A084A-20A1-4369-AFA8-8E790C2DC747}"/>
              </a:ext>
            </a:extLst>
          </p:cNvPr>
          <p:cNvSpPr/>
          <p:nvPr/>
        </p:nvSpPr>
        <p:spPr>
          <a:xfrm rot="10800000">
            <a:off x="3037176" y="3622550"/>
            <a:ext cx="476772" cy="568587"/>
          </a:xfrm>
          <a:prstGeom prst="downArrow">
            <a:avLst/>
          </a:prstGeom>
          <a:solidFill>
            <a:srgbClr val="CC99FF"/>
          </a:solidFill>
          <a:ln>
            <a:solidFill>
              <a:srgbClr val="CC99FF"/>
            </a:solidFill>
          </a:ln>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a:p>
        </p:txBody>
      </p:sp>
      <p:sp>
        <p:nvSpPr>
          <p:cNvPr id="57" name="Arrow: Down 56">
            <a:extLst>
              <a:ext uri="{FF2B5EF4-FFF2-40B4-BE49-F238E27FC236}">
                <a16:creationId xmlns:a16="http://schemas.microsoft.com/office/drawing/2014/main" id="{54C203F2-07A3-4AD4-9025-FD00C21B27A1}"/>
              </a:ext>
            </a:extLst>
          </p:cNvPr>
          <p:cNvSpPr/>
          <p:nvPr/>
        </p:nvSpPr>
        <p:spPr>
          <a:xfrm rot="10800000">
            <a:off x="3543885" y="3622550"/>
            <a:ext cx="476772" cy="568587"/>
          </a:xfrm>
          <a:prstGeom prst="downArrow">
            <a:avLst/>
          </a:prstGeom>
          <a:solidFill>
            <a:srgbClr val="CC99FF"/>
          </a:solidFill>
          <a:ln>
            <a:solidFill>
              <a:srgbClr val="CC99FF"/>
            </a:solidFill>
          </a:ln>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a:p>
        </p:txBody>
      </p:sp>
      <p:sp>
        <p:nvSpPr>
          <p:cNvPr id="58" name="Arrow: Down 57">
            <a:extLst>
              <a:ext uri="{FF2B5EF4-FFF2-40B4-BE49-F238E27FC236}">
                <a16:creationId xmlns:a16="http://schemas.microsoft.com/office/drawing/2014/main" id="{896ABF27-2A53-46B7-8CC7-165ED60CFC35}"/>
              </a:ext>
            </a:extLst>
          </p:cNvPr>
          <p:cNvSpPr/>
          <p:nvPr/>
        </p:nvSpPr>
        <p:spPr>
          <a:xfrm rot="10800000">
            <a:off x="6561339" y="3622550"/>
            <a:ext cx="476772" cy="568587"/>
          </a:xfrm>
          <a:prstGeom prst="downArrow">
            <a:avLst/>
          </a:prstGeom>
          <a:solidFill>
            <a:srgbClr val="CC99FF"/>
          </a:solidFill>
          <a:ln>
            <a:solidFill>
              <a:srgbClr val="CC99FF"/>
            </a:solidFill>
          </a:ln>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a:p>
        </p:txBody>
      </p:sp>
      <p:sp>
        <p:nvSpPr>
          <p:cNvPr id="64" name="Arrow: Down 63">
            <a:extLst>
              <a:ext uri="{FF2B5EF4-FFF2-40B4-BE49-F238E27FC236}">
                <a16:creationId xmlns:a16="http://schemas.microsoft.com/office/drawing/2014/main" id="{A299D3DF-B465-4AB7-9385-48324F6802BE}"/>
              </a:ext>
            </a:extLst>
          </p:cNvPr>
          <p:cNvSpPr/>
          <p:nvPr/>
        </p:nvSpPr>
        <p:spPr>
          <a:xfrm rot="10800000">
            <a:off x="8572568" y="3622550"/>
            <a:ext cx="476772" cy="568587"/>
          </a:xfrm>
          <a:prstGeom prst="downArrow">
            <a:avLst/>
          </a:prstGeom>
          <a:solidFill>
            <a:srgbClr val="CC99FF"/>
          </a:solidFill>
          <a:ln>
            <a:solidFill>
              <a:srgbClr val="CC99FF"/>
            </a:solidFill>
          </a:ln>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a:p>
        </p:txBody>
      </p:sp>
      <p:sp>
        <p:nvSpPr>
          <p:cNvPr id="65" name="Arrow: Down 64">
            <a:extLst>
              <a:ext uri="{FF2B5EF4-FFF2-40B4-BE49-F238E27FC236}">
                <a16:creationId xmlns:a16="http://schemas.microsoft.com/office/drawing/2014/main" id="{D3B12C9D-EB89-4932-8C1D-1361ACA48444}"/>
              </a:ext>
            </a:extLst>
          </p:cNvPr>
          <p:cNvSpPr/>
          <p:nvPr/>
        </p:nvSpPr>
        <p:spPr>
          <a:xfrm rot="10800000">
            <a:off x="9077680" y="3622550"/>
            <a:ext cx="476772" cy="568587"/>
          </a:xfrm>
          <a:prstGeom prst="downArrow">
            <a:avLst/>
          </a:prstGeom>
          <a:solidFill>
            <a:srgbClr val="CC99FF"/>
          </a:solidFill>
          <a:ln>
            <a:solidFill>
              <a:srgbClr val="CC99FF"/>
            </a:solidFill>
          </a:ln>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a:p>
        </p:txBody>
      </p:sp>
      <p:sp>
        <p:nvSpPr>
          <p:cNvPr id="66" name="TextBox 65">
            <a:extLst>
              <a:ext uri="{FF2B5EF4-FFF2-40B4-BE49-F238E27FC236}">
                <a16:creationId xmlns:a16="http://schemas.microsoft.com/office/drawing/2014/main" id="{A5692AE5-B003-42A8-8E8E-9CA8E6587F98}"/>
              </a:ext>
            </a:extLst>
          </p:cNvPr>
          <p:cNvSpPr txBox="1"/>
          <p:nvPr/>
        </p:nvSpPr>
        <p:spPr>
          <a:xfrm>
            <a:off x="2957968" y="5229584"/>
            <a:ext cx="6276077" cy="584775"/>
          </a:xfrm>
          <a:prstGeom prst="rect">
            <a:avLst/>
          </a:prstGeom>
          <a:noFill/>
        </p:spPr>
        <p:txBody>
          <a:bodyPr wrap="none" rtlCol="0">
            <a:spAutoFit/>
          </a:bodyPr>
          <a:lstStyle/>
          <a:p>
            <a:pPr algn="ctr"/>
            <a:r>
              <a:rPr lang="en-US" sz="3200" err="1">
                <a:solidFill>
                  <a:srgbClr val="00B050"/>
                </a:solidFill>
              </a:rPr>
              <a:t>Intra_Intervals</a:t>
            </a:r>
            <a:r>
              <a:rPr lang="en-US" sz="3200">
                <a:solidFill>
                  <a:srgbClr val="00B050"/>
                </a:solidFill>
              </a:rPr>
              <a:t> = [1, 1, 1, 1, 1] sec</a:t>
            </a:r>
          </a:p>
        </p:txBody>
      </p:sp>
    </p:spTree>
    <p:extLst>
      <p:ext uri="{BB962C8B-B14F-4D97-AF65-F5344CB8AC3E}">
        <p14:creationId xmlns:p14="http://schemas.microsoft.com/office/powerpoint/2010/main" val="361910997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TextBox 41">
            <a:extLst>
              <a:ext uri="{FF2B5EF4-FFF2-40B4-BE49-F238E27FC236}">
                <a16:creationId xmlns:a16="http://schemas.microsoft.com/office/drawing/2014/main" id="{804278AB-ADAA-4094-9AC0-41B605F71761}"/>
              </a:ext>
            </a:extLst>
          </p:cNvPr>
          <p:cNvSpPr txBox="1"/>
          <p:nvPr/>
        </p:nvSpPr>
        <p:spPr>
          <a:xfrm>
            <a:off x="3117519" y="3244334"/>
            <a:ext cx="301686" cy="369332"/>
          </a:xfrm>
          <a:prstGeom prst="rect">
            <a:avLst/>
          </a:prstGeom>
          <a:noFill/>
        </p:spPr>
        <p:txBody>
          <a:bodyPr wrap="square" rtlCol="0">
            <a:spAutoFit/>
          </a:bodyPr>
          <a:lstStyle/>
          <a:p>
            <a:pPr algn="ctr"/>
            <a:r>
              <a:rPr lang="en-US"/>
              <a:t>1</a:t>
            </a:r>
          </a:p>
        </p:txBody>
      </p:sp>
      <p:sp>
        <p:nvSpPr>
          <p:cNvPr id="88" name="Title 1">
            <a:extLst>
              <a:ext uri="{FF2B5EF4-FFF2-40B4-BE49-F238E27FC236}">
                <a16:creationId xmlns:a16="http://schemas.microsoft.com/office/drawing/2014/main" id="{BB4E3879-0FC6-44D6-9281-34F2B554E57F}"/>
              </a:ext>
            </a:extLst>
          </p:cNvPr>
          <p:cNvSpPr txBox="1">
            <a:spLocks/>
          </p:cNvSpPr>
          <p:nvPr/>
        </p:nvSpPr>
        <p:spPr>
          <a:xfrm>
            <a:off x="838200" y="1"/>
            <a:ext cx="10515600" cy="203092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Arial" panose="020B0604020202020204" pitchFamily="34" charset="0"/>
                <a:ea typeface="+mj-ea"/>
                <a:cs typeface="Arial" panose="020B0604020202020204" pitchFamily="34" charset="0"/>
              </a:defRPr>
            </a:lvl1pPr>
          </a:lstStyle>
          <a:p>
            <a:r>
              <a:rPr lang="en-US" sz="3600" b="1">
                <a:solidFill>
                  <a:srgbClr val="7030A0"/>
                </a:solidFill>
              </a:rPr>
              <a:t>Burst Duration and Mean Burst Duration (</a:t>
            </a:r>
            <a:r>
              <a:rPr lang="en-US" sz="3600" b="1" err="1">
                <a:solidFill>
                  <a:srgbClr val="7030A0"/>
                </a:solidFill>
              </a:rPr>
              <a:t>mbd</a:t>
            </a:r>
            <a:r>
              <a:rPr lang="en-US" sz="3600" b="1">
                <a:solidFill>
                  <a:srgbClr val="7030A0"/>
                </a:solidFill>
              </a:rPr>
              <a:t>): </a:t>
            </a:r>
            <a:r>
              <a:rPr lang="en-US" sz="3600"/>
              <a:t>The time from the first spike in a burst to the last spike in a burst. </a:t>
            </a:r>
            <a:r>
              <a:rPr lang="en-US" sz="2800"/>
              <a:t>Calculated by sum of </a:t>
            </a:r>
            <a:r>
              <a:rPr lang="en-US" sz="2800" err="1"/>
              <a:t>intraburst</a:t>
            </a:r>
            <a:r>
              <a:rPr lang="en-US" sz="2800"/>
              <a:t> intervals. </a:t>
            </a:r>
            <a:r>
              <a:rPr lang="en-US" sz="3600"/>
              <a:t>MBD is the average duration across all bursts</a:t>
            </a:r>
          </a:p>
        </p:txBody>
      </p:sp>
      <p:cxnSp>
        <p:nvCxnSpPr>
          <p:cNvPr id="35" name="Straight Connector 34">
            <a:extLst>
              <a:ext uri="{FF2B5EF4-FFF2-40B4-BE49-F238E27FC236}">
                <a16:creationId xmlns:a16="http://schemas.microsoft.com/office/drawing/2014/main" id="{2814F8E3-4AEA-4BA4-A3D8-EB9F55DB1F02}"/>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748586B8-9830-440E-91B0-F430C21E1AAE}"/>
              </a:ext>
            </a:extLst>
          </p:cNvPr>
          <p:cNvCxnSpPr>
            <a:cxnSpLocks/>
          </p:cNvCxnSpPr>
          <p:nvPr/>
        </p:nvCxnSpPr>
        <p:spPr>
          <a:xfrm>
            <a:off x="3026378"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C45B121B-A3D2-4BC8-AE2A-F676503D0272}"/>
              </a:ext>
            </a:extLst>
          </p:cNvPr>
          <p:cNvCxnSpPr>
            <a:cxnSpLocks/>
          </p:cNvCxnSpPr>
          <p:nvPr/>
        </p:nvCxnSpPr>
        <p:spPr>
          <a:xfrm>
            <a:off x="352949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622BF435-EBBA-4218-96BF-4AFCE9AB182D}"/>
              </a:ext>
            </a:extLst>
          </p:cNvPr>
          <p:cNvCxnSpPr>
            <a:cxnSpLocks/>
          </p:cNvCxnSpPr>
          <p:nvPr/>
        </p:nvCxnSpPr>
        <p:spPr>
          <a:xfrm>
            <a:off x="403260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5F8121D-EAA0-4330-999A-E18CB41CBE16}"/>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4EEB74AE-83EB-4C75-BDF1-FF349CDAE14A}"/>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55BC6AA-6EBD-42D9-B053-D4DCDC89E349}"/>
              </a:ext>
            </a:extLst>
          </p:cNvPr>
          <p:cNvCxnSpPr>
            <a:cxnSpLocks/>
          </p:cNvCxnSpPr>
          <p:nvPr/>
        </p:nvCxnSpPr>
        <p:spPr>
          <a:xfrm>
            <a:off x="856062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55A4474-74EF-48A7-81BB-0D5B373EA381}"/>
              </a:ext>
            </a:extLst>
          </p:cNvPr>
          <p:cNvCxnSpPr>
            <a:cxnSpLocks/>
          </p:cNvCxnSpPr>
          <p:nvPr/>
        </p:nvCxnSpPr>
        <p:spPr>
          <a:xfrm>
            <a:off x="906373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6865C555-B0A1-4DC7-BFB3-159291064D3E}"/>
              </a:ext>
            </a:extLst>
          </p:cNvPr>
          <p:cNvCxnSpPr>
            <a:cxnSpLocks/>
          </p:cNvCxnSpPr>
          <p:nvPr/>
        </p:nvCxnSpPr>
        <p:spPr>
          <a:xfrm>
            <a:off x="9566847"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EAC61716-623A-447C-954B-8DD898D75C07}"/>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56" name="TextBox 55">
            <a:extLst>
              <a:ext uri="{FF2B5EF4-FFF2-40B4-BE49-F238E27FC236}">
                <a16:creationId xmlns:a16="http://schemas.microsoft.com/office/drawing/2014/main" id="{506BA941-9ED2-45B9-AC3F-C8C0B0E5C028}"/>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60" name="TextBox 59">
            <a:extLst>
              <a:ext uri="{FF2B5EF4-FFF2-40B4-BE49-F238E27FC236}">
                <a16:creationId xmlns:a16="http://schemas.microsoft.com/office/drawing/2014/main" id="{D5578323-22C5-48E1-ADEE-17A44D65AA3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1" name="TextBox 60">
            <a:extLst>
              <a:ext uri="{FF2B5EF4-FFF2-40B4-BE49-F238E27FC236}">
                <a16:creationId xmlns:a16="http://schemas.microsoft.com/office/drawing/2014/main" id="{1FFB11D9-B26C-434D-9740-8725EB830EE4}"/>
              </a:ext>
            </a:extLst>
          </p:cNvPr>
          <p:cNvSpPr txBox="1"/>
          <p:nvPr/>
        </p:nvSpPr>
        <p:spPr>
          <a:xfrm>
            <a:off x="3373038"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a:t>
            </a:r>
          </a:p>
        </p:txBody>
      </p:sp>
      <p:sp>
        <p:nvSpPr>
          <p:cNvPr id="62" name="TextBox 61">
            <a:extLst>
              <a:ext uri="{FF2B5EF4-FFF2-40B4-BE49-F238E27FC236}">
                <a16:creationId xmlns:a16="http://schemas.microsoft.com/office/drawing/2014/main" id="{83114AA9-4B59-41B6-ADFE-6C4F2491E6E7}"/>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CA7BFD84-ABBA-4A9A-B2F8-6FC0089400F0}"/>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68" name="TextBox 67">
            <a:extLst>
              <a:ext uri="{FF2B5EF4-FFF2-40B4-BE49-F238E27FC236}">
                <a16:creationId xmlns:a16="http://schemas.microsoft.com/office/drawing/2014/main" id="{CB981839-37F6-4368-8E3F-DF8754634807}"/>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71" name="TextBox 70">
            <a:extLst>
              <a:ext uri="{FF2B5EF4-FFF2-40B4-BE49-F238E27FC236}">
                <a16:creationId xmlns:a16="http://schemas.microsoft.com/office/drawing/2014/main" id="{D45BBE2E-DF92-4219-BC3A-1AF1A2792BF9}"/>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72" name="TextBox 71">
            <a:extLst>
              <a:ext uri="{FF2B5EF4-FFF2-40B4-BE49-F238E27FC236}">
                <a16:creationId xmlns:a16="http://schemas.microsoft.com/office/drawing/2014/main" id="{BD8B3B41-1FE1-4CCC-9168-42A24303DFDC}"/>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73" name="TextBox 72">
            <a:extLst>
              <a:ext uri="{FF2B5EF4-FFF2-40B4-BE49-F238E27FC236}">
                <a16:creationId xmlns:a16="http://schemas.microsoft.com/office/drawing/2014/main" id="{D2BC4F3C-EDCE-490E-ADBC-F65B227FA8F9}"/>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76" name="TextBox 75">
            <a:extLst>
              <a:ext uri="{FF2B5EF4-FFF2-40B4-BE49-F238E27FC236}">
                <a16:creationId xmlns:a16="http://schemas.microsoft.com/office/drawing/2014/main" id="{5FC86196-7C2D-42D7-BE6A-1D096E132698}"/>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80" name="TextBox 79">
            <a:extLst>
              <a:ext uri="{FF2B5EF4-FFF2-40B4-BE49-F238E27FC236}">
                <a16:creationId xmlns:a16="http://schemas.microsoft.com/office/drawing/2014/main" id="{0C900B59-4201-4F1B-B8E7-7340816C4316}"/>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5A66A2F2-34E3-4247-8534-59192890CC22}"/>
              </a:ext>
            </a:extLst>
          </p:cNvPr>
          <p:cNvSpPr txBox="1"/>
          <p:nvPr/>
        </p:nvSpPr>
        <p:spPr>
          <a:xfrm>
            <a:off x="337303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17974CD7-4EB3-4ABE-9BD7-E18031C0821C}"/>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7" name="TextBox 86">
            <a:extLst>
              <a:ext uri="{FF2B5EF4-FFF2-40B4-BE49-F238E27FC236}">
                <a16:creationId xmlns:a16="http://schemas.microsoft.com/office/drawing/2014/main" id="{95024911-2DE9-4D0B-A4B3-4BD19777884F}"/>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90" name="TextBox 89">
            <a:extLst>
              <a:ext uri="{FF2B5EF4-FFF2-40B4-BE49-F238E27FC236}">
                <a16:creationId xmlns:a16="http://schemas.microsoft.com/office/drawing/2014/main" id="{062B7B16-42E2-4076-A421-365223EFD43C}"/>
              </a:ext>
            </a:extLst>
          </p:cNvPr>
          <p:cNvSpPr txBox="1"/>
          <p:nvPr/>
        </p:nvSpPr>
        <p:spPr>
          <a:xfrm>
            <a:off x="6894829"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23" name="TextBox 122">
            <a:extLst>
              <a:ext uri="{FF2B5EF4-FFF2-40B4-BE49-F238E27FC236}">
                <a16:creationId xmlns:a16="http://schemas.microsoft.com/office/drawing/2014/main" id="{F07E911A-EF55-4077-B0DF-D9984A42F982}"/>
              </a:ext>
            </a:extLst>
          </p:cNvPr>
          <p:cNvSpPr txBox="1"/>
          <p:nvPr/>
        </p:nvSpPr>
        <p:spPr>
          <a:xfrm>
            <a:off x="8404168"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24" name="TextBox 123">
            <a:extLst>
              <a:ext uri="{FF2B5EF4-FFF2-40B4-BE49-F238E27FC236}">
                <a16:creationId xmlns:a16="http://schemas.microsoft.com/office/drawing/2014/main" id="{E4DDCEBE-F36D-42F0-91A2-FD89D2A6C8CA}"/>
              </a:ext>
            </a:extLst>
          </p:cNvPr>
          <p:cNvSpPr txBox="1"/>
          <p:nvPr/>
        </p:nvSpPr>
        <p:spPr>
          <a:xfrm>
            <a:off x="8907281"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125" name="TextBox 124">
            <a:extLst>
              <a:ext uri="{FF2B5EF4-FFF2-40B4-BE49-F238E27FC236}">
                <a16:creationId xmlns:a16="http://schemas.microsoft.com/office/drawing/2014/main" id="{51749985-D96F-4694-BCC7-0CCD556B9E04}"/>
              </a:ext>
            </a:extLst>
          </p:cNvPr>
          <p:cNvSpPr txBox="1"/>
          <p:nvPr/>
        </p:nvSpPr>
        <p:spPr>
          <a:xfrm>
            <a:off x="9410394"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sp>
        <p:nvSpPr>
          <p:cNvPr id="128" name="TextBox 127">
            <a:extLst>
              <a:ext uri="{FF2B5EF4-FFF2-40B4-BE49-F238E27FC236}">
                <a16:creationId xmlns:a16="http://schemas.microsoft.com/office/drawing/2014/main" id="{8B5F1059-0ECA-4AA6-AA71-49F6194AB602}"/>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9" name="TextBox 128">
            <a:extLst>
              <a:ext uri="{FF2B5EF4-FFF2-40B4-BE49-F238E27FC236}">
                <a16:creationId xmlns:a16="http://schemas.microsoft.com/office/drawing/2014/main" id="{17105D4D-3475-4F62-8B53-E8A9D9E8CB2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130" name="TextBox 129">
            <a:extLst>
              <a:ext uri="{FF2B5EF4-FFF2-40B4-BE49-F238E27FC236}">
                <a16:creationId xmlns:a16="http://schemas.microsoft.com/office/drawing/2014/main" id="{E1961E32-E05C-4074-9202-D26E7C008F2F}"/>
              </a:ext>
            </a:extLst>
          </p:cNvPr>
          <p:cNvSpPr txBox="1"/>
          <p:nvPr/>
        </p:nvSpPr>
        <p:spPr>
          <a:xfrm>
            <a:off x="2885728" y="4667925"/>
            <a:ext cx="1287533" cy="64633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2 sec</a:t>
            </a:r>
            <a:endParaRPr lang="en-US" sz="3600">
              <a:solidFill>
                <a:schemeClr val="accent1"/>
              </a:solidFill>
            </a:endParaRPr>
          </a:p>
        </p:txBody>
      </p:sp>
      <p:sp>
        <p:nvSpPr>
          <p:cNvPr id="131" name="TextBox 130">
            <a:extLst>
              <a:ext uri="{FF2B5EF4-FFF2-40B4-BE49-F238E27FC236}">
                <a16:creationId xmlns:a16="http://schemas.microsoft.com/office/drawing/2014/main" id="{92EE0D56-23EA-4DB3-ADC0-F17F7053200A}"/>
              </a:ext>
            </a:extLst>
          </p:cNvPr>
          <p:cNvSpPr txBox="1"/>
          <p:nvPr/>
        </p:nvSpPr>
        <p:spPr>
          <a:xfrm>
            <a:off x="6186944" y="4667925"/>
            <a:ext cx="1287533" cy="64633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1 sec</a:t>
            </a:r>
            <a:endParaRPr lang="en-US" sz="3600">
              <a:solidFill>
                <a:schemeClr val="accent1"/>
              </a:solidFill>
            </a:endParaRPr>
          </a:p>
        </p:txBody>
      </p:sp>
      <p:sp>
        <p:nvSpPr>
          <p:cNvPr id="132" name="TextBox 131">
            <a:extLst>
              <a:ext uri="{FF2B5EF4-FFF2-40B4-BE49-F238E27FC236}">
                <a16:creationId xmlns:a16="http://schemas.microsoft.com/office/drawing/2014/main" id="{7056583F-8F74-4665-93C0-E9BE7FAB6F79}"/>
              </a:ext>
            </a:extLst>
          </p:cNvPr>
          <p:cNvSpPr txBox="1"/>
          <p:nvPr/>
        </p:nvSpPr>
        <p:spPr>
          <a:xfrm>
            <a:off x="8419969" y="4667925"/>
            <a:ext cx="1287533" cy="64633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2 sec</a:t>
            </a:r>
            <a:endParaRPr lang="en-US" sz="3600">
              <a:solidFill>
                <a:schemeClr val="accent1"/>
              </a:solidFill>
            </a:endParaRPr>
          </a:p>
        </p:txBody>
      </p:sp>
      <mc:AlternateContent xmlns:mc="http://schemas.openxmlformats.org/markup-compatibility/2006">
        <mc:Choice xmlns:a14="http://schemas.microsoft.com/office/drawing/2010/main" Requires="a14">
          <p:sp>
            <p:nvSpPr>
              <p:cNvPr id="133" name="TextBox 132">
                <a:extLst>
                  <a:ext uri="{FF2B5EF4-FFF2-40B4-BE49-F238E27FC236}">
                    <a16:creationId xmlns:a16="http://schemas.microsoft.com/office/drawing/2014/main" id="{FCBFF678-2D12-4089-BC17-3FF02D8C29CF}"/>
                  </a:ext>
                </a:extLst>
              </p:cNvPr>
              <p:cNvSpPr txBox="1"/>
              <p:nvPr/>
            </p:nvSpPr>
            <p:spPr>
              <a:xfrm>
                <a:off x="1009738" y="5892094"/>
                <a:ext cx="10172528" cy="965905"/>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MBD = </a:t>
                </a:r>
                <a14:m>
                  <m:oMath xmlns:m="http://schemas.openxmlformats.org/officeDocument/2006/math">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𝑠𝑢𝑚</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𝑏𝑢𝑟𝑠𝑡</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𝑑𝑢𝑟𝑎𝑡𝑖𝑜𝑛𝑠</m:t>
                        </m:r>
                        <m:r>
                          <a:rPr lang="en-US" sz="3600" b="0" i="1" smtClean="0">
                            <a:solidFill>
                              <a:schemeClr val="accent1"/>
                            </a:solidFill>
                            <a:latin typeface="Cambria Math" panose="02040503050406030204" pitchFamily="18" charset="0"/>
                          </a:rPr>
                          <m:t>)</m:t>
                        </m:r>
                      </m:num>
                      <m:den>
                        <m:r>
                          <a:rPr lang="en-US" sz="3600" b="0" i="1" smtClean="0">
                            <a:solidFill>
                              <a:schemeClr val="accent1"/>
                            </a:solidFill>
                            <a:latin typeface="Cambria Math" panose="02040503050406030204" pitchFamily="18" charset="0"/>
                          </a:rPr>
                          <m:t>𝑛𝑢𝑚𝑏𝑒𝑟</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𝑜𝑓</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𝑏𝑢𝑟𝑠𝑡𝑠</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2+1+2</m:t>
                        </m:r>
                      </m:num>
                      <m:den>
                        <m:r>
                          <a:rPr lang="en-US" sz="3600" b="0" i="1" smtClean="0">
                            <a:solidFill>
                              <a:schemeClr val="accent1"/>
                            </a:solidFill>
                            <a:latin typeface="Cambria Math" panose="02040503050406030204" pitchFamily="18" charset="0"/>
                          </a:rPr>
                          <m:t>3</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5</m:t>
                        </m:r>
                      </m:num>
                      <m:den>
                        <m:r>
                          <a:rPr lang="en-US" sz="3600" b="0" i="1" smtClean="0">
                            <a:solidFill>
                              <a:schemeClr val="accent1"/>
                            </a:solidFill>
                            <a:latin typeface="Cambria Math" panose="02040503050406030204" pitchFamily="18" charset="0"/>
                          </a:rPr>
                          <m:t>3</m:t>
                        </m:r>
                      </m:den>
                    </m:f>
                    <m:r>
                      <a:rPr lang="en-US" sz="3600" b="0" i="1" smtClean="0">
                        <a:solidFill>
                          <a:schemeClr val="accent1"/>
                        </a:solidFill>
                        <a:latin typeface="Cambria Math" panose="02040503050406030204" pitchFamily="18" charset="0"/>
                      </a:rPr>
                      <m:t>=1.67 </m:t>
                    </m:r>
                    <m:r>
                      <a:rPr lang="en-US" sz="3600" b="0" i="1" smtClean="0">
                        <a:solidFill>
                          <a:schemeClr val="accent1"/>
                        </a:solidFill>
                        <a:latin typeface="Cambria Math" panose="02040503050406030204" pitchFamily="18" charset="0"/>
                      </a:rPr>
                      <m:t>𝑠𝑒𝑐</m:t>
                    </m:r>
                  </m:oMath>
                </a14:m>
                <a:endParaRPr lang="en-US" sz="3600">
                  <a:solidFill>
                    <a:schemeClr val="accent1"/>
                  </a:solidFill>
                </a:endParaRPr>
              </a:p>
            </p:txBody>
          </p:sp>
        </mc:Choice>
        <mc:Fallback>
          <p:sp>
            <p:nvSpPr>
              <p:cNvPr id="133" name="TextBox 132">
                <a:extLst>
                  <a:ext uri="{FF2B5EF4-FFF2-40B4-BE49-F238E27FC236}">
                    <a16:creationId xmlns:a16="http://schemas.microsoft.com/office/drawing/2014/main" id="{FCBFF678-2D12-4089-BC17-3FF02D8C29CF}"/>
                  </a:ext>
                </a:extLst>
              </p:cNvPr>
              <p:cNvSpPr txBox="1">
                <a:spLocks noRot="1" noChangeAspect="1" noMove="1" noResize="1" noEditPoints="1" noAdjustHandles="1" noChangeArrowheads="1" noChangeShapeType="1" noTextEdit="1"/>
              </p:cNvSpPr>
              <p:nvPr/>
            </p:nvSpPr>
            <p:spPr>
              <a:xfrm>
                <a:off x="1009738" y="5892094"/>
                <a:ext cx="10172528" cy="965905"/>
              </a:xfrm>
              <a:prstGeom prst="rect">
                <a:avLst/>
              </a:prstGeom>
              <a:blipFill>
                <a:blip r:embed="rId2"/>
                <a:stretch>
                  <a:fillRect l="-1379" b="-3797"/>
                </a:stretch>
              </a:blipFill>
            </p:spPr>
            <p:txBody>
              <a:bodyPr/>
              <a:lstStyle/>
              <a:p>
                <a:r>
                  <a:rPr lang="en-US">
                    <a:noFill/>
                  </a:rPr>
                  <a:t> </a:t>
                </a:r>
              </a:p>
            </p:txBody>
          </p:sp>
        </mc:Fallback>
      </mc:AlternateContent>
      <p:sp>
        <p:nvSpPr>
          <p:cNvPr id="37" name="TextBox 36">
            <a:extLst>
              <a:ext uri="{FF2B5EF4-FFF2-40B4-BE49-F238E27FC236}">
                <a16:creationId xmlns:a16="http://schemas.microsoft.com/office/drawing/2014/main" id="{67CD279A-76E7-441F-8C14-4EADF2C21C00}"/>
              </a:ext>
            </a:extLst>
          </p:cNvPr>
          <p:cNvSpPr txBox="1"/>
          <p:nvPr/>
        </p:nvSpPr>
        <p:spPr>
          <a:xfrm>
            <a:off x="3378752" y="5229584"/>
            <a:ext cx="5434501" cy="584775"/>
          </a:xfrm>
          <a:prstGeom prst="rect">
            <a:avLst/>
          </a:prstGeom>
          <a:noFill/>
        </p:spPr>
        <p:txBody>
          <a:bodyPr wrap="none" rtlCol="0">
            <a:spAutoFit/>
          </a:bodyPr>
          <a:lstStyle/>
          <a:p>
            <a:pPr algn="ctr"/>
            <a:r>
              <a:rPr lang="en-US" sz="3200" err="1">
                <a:solidFill>
                  <a:srgbClr val="00B050"/>
                </a:solidFill>
              </a:rPr>
              <a:t>burstDurations</a:t>
            </a:r>
            <a:r>
              <a:rPr lang="en-US" sz="3200">
                <a:solidFill>
                  <a:srgbClr val="00B050"/>
                </a:solidFill>
              </a:rPr>
              <a:t> = [2, 1, 2] sec</a:t>
            </a:r>
          </a:p>
        </p:txBody>
      </p:sp>
      <p:cxnSp>
        <p:nvCxnSpPr>
          <p:cNvPr id="38" name="Straight Connector 37">
            <a:extLst>
              <a:ext uri="{FF2B5EF4-FFF2-40B4-BE49-F238E27FC236}">
                <a16:creationId xmlns:a16="http://schemas.microsoft.com/office/drawing/2014/main" id="{DAFE289F-1C50-4872-AE7C-87ED291EF7BA}"/>
              </a:ext>
            </a:extLst>
          </p:cNvPr>
          <p:cNvCxnSpPr>
            <a:cxnSpLocks/>
          </p:cNvCxnSpPr>
          <p:nvPr/>
        </p:nvCxnSpPr>
        <p:spPr>
          <a:xfrm>
            <a:off x="3026378"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a16="http://schemas.microsoft.com/office/drawing/2014/main" id="{F83A1E40-4E6D-4820-BCEB-8AA1205428FA}"/>
              </a:ext>
            </a:extLst>
          </p:cNvPr>
          <p:cNvSpPr txBox="1"/>
          <p:nvPr/>
        </p:nvSpPr>
        <p:spPr>
          <a:xfrm>
            <a:off x="3621856" y="3244334"/>
            <a:ext cx="301686" cy="369332"/>
          </a:xfrm>
          <a:prstGeom prst="rect">
            <a:avLst/>
          </a:prstGeom>
          <a:noFill/>
        </p:spPr>
        <p:txBody>
          <a:bodyPr wrap="square" rtlCol="0">
            <a:spAutoFit/>
          </a:bodyPr>
          <a:lstStyle/>
          <a:p>
            <a:pPr algn="ctr"/>
            <a:r>
              <a:rPr lang="en-US"/>
              <a:t>1</a:t>
            </a:r>
          </a:p>
        </p:txBody>
      </p:sp>
      <p:cxnSp>
        <p:nvCxnSpPr>
          <p:cNvPr id="45" name="Straight Connector 44">
            <a:extLst>
              <a:ext uri="{FF2B5EF4-FFF2-40B4-BE49-F238E27FC236}">
                <a16:creationId xmlns:a16="http://schemas.microsoft.com/office/drawing/2014/main" id="{D39932FB-9D8A-403B-AAAD-59EB3EEE70AD}"/>
              </a:ext>
            </a:extLst>
          </p:cNvPr>
          <p:cNvCxnSpPr>
            <a:cxnSpLocks/>
          </p:cNvCxnSpPr>
          <p:nvPr/>
        </p:nvCxnSpPr>
        <p:spPr>
          <a:xfrm>
            <a:off x="3530715"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D4C94EE9-8875-4F62-87AD-B68E516FFB8A}"/>
              </a:ext>
            </a:extLst>
          </p:cNvPr>
          <p:cNvSpPr txBox="1"/>
          <p:nvPr/>
        </p:nvSpPr>
        <p:spPr>
          <a:xfrm>
            <a:off x="6639310" y="3244334"/>
            <a:ext cx="301686" cy="369332"/>
          </a:xfrm>
          <a:prstGeom prst="rect">
            <a:avLst/>
          </a:prstGeom>
          <a:noFill/>
        </p:spPr>
        <p:txBody>
          <a:bodyPr wrap="square" rtlCol="0">
            <a:spAutoFit/>
          </a:bodyPr>
          <a:lstStyle/>
          <a:p>
            <a:pPr algn="ctr"/>
            <a:r>
              <a:rPr lang="en-US"/>
              <a:t>1</a:t>
            </a:r>
          </a:p>
        </p:txBody>
      </p:sp>
      <p:cxnSp>
        <p:nvCxnSpPr>
          <p:cNvPr id="49" name="Straight Connector 48">
            <a:extLst>
              <a:ext uri="{FF2B5EF4-FFF2-40B4-BE49-F238E27FC236}">
                <a16:creationId xmlns:a16="http://schemas.microsoft.com/office/drawing/2014/main" id="{50E26952-EBEB-405B-9051-66196D06390A}"/>
              </a:ext>
            </a:extLst>
          </p:cNvPr>
          <p:cNvCxnSpPr>
            <a:cxnSpLocks/>
          </p:cNvCxnSpPr>
          <p:nvPr/>
        </p:nvCxnSpPr>
        <p:spPr>
          <a:xfrm>
            <a:off x="6548169"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53" name="TextBox 52">
            <a:extLst>
              <a:ext uri="{FF2B5EF4-FFF2-40B4-BE49-F238E27FC236}">
                <a16:creationId xmlns:a16="http://schemas.microsoft.com/office/drawing/2014/main" id="{CD3429B1-4AE3-4F50-98AC-4E8C6CA50AAE}"/>
              </a:ext>
            </a:extLst>
          </p:cNvPr>
          <p:cNvSpPr txBox="1"/>
          <p:nvPr/>
        </p:nvSpPr>
        <p:spPr>
          <a:xfrm>
            <a:off x="8650539" y="3244334"/>
            <a:ext cx="301686" cy="369332"/>
          </a:xfrm>
          <a:prstGeom prst="rect">
            <a:avLst/>
          </a:prstGeom>
          <a:noFill/>
        </p:spPr>
        <p:txBody>
          <a:bodyPr wrap="square" rtlCol="0">
            <a:spAutoFit/>
          </a:bodyPr>
          <a:lstStyle/>
          <a:p>
            <a:pPr algn="ctr"/>
            <a:r>
              <a:rPr lang="en-US"/>
              <a:t>1</a:t>
            </a:r>
          </a:p>
        </p:txBody>
      </p:sp>
      <p:cxnSp>
        <p:nvCxnSpPr>
          <p:cNvPr id="54" name="Straight Connector 53">
            <a:extLst>
              <a:ext uri="{FF2B5EF4-FFF2-40B4-BE49-F238E27FC236}">
                <a16:creationId xmlns:a16="http://schemas.microsoft.com/office/drawing/2014/main" id="{D9B1F86C-9611-4892-A6E2-60BC0F869D89}"/>
              </a:ext>
            </a:extLst>
          </p:cNvPr>
          <p:cNvCxnSpPr>
            <a:cxnSpLocks/>
          </p:cNvCxnSpPr>
          <p:nvPr/>
        </p:nvCxnSpPr>
        <p:spPr>
          <a:xfrm>
            <a:off x="8559398"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59" name="TextBox 58">
            <a:extLst>
              <a:ext uri="{FF2B5EF4-FFF2-40B4-BE49-F238E27FC236}">
                <a16:creationId xmlns:a16="http://schemas.microsoft.com/office/drawing/2014/main" id="{3F539560-D257-4FDC-973B-29F18C2CDA04}"/>
              </a:ext>
            </a:extLst>
          </p:cNvPr>
          <p:cNvSpPr txBox="1"/>
          <p:nvPr/>
        </p:nvSpPr>
        <p:spPr>
          <a:xfrm>
            <a:off x="9144078" y="3244334"/>
            <a:ext cx="301686" cy="369332"/>
          </a:xfrm>
          <a:prstGeom prst="rect">
            <a:avLst/>
          </a:prstGeom>
          <a:noFill/>
        </p:spPr>
        <p:txBody>
          <a:bodyPr wrap="square" rtlCol="0">
            <a:spAutoFit/>
          </a:bodyPr>
          <a:lstStyle/>
          <a:p>
            <a:pPr algn="ctr"/>
            <a:r>
              <a:rPr lang="en-US"/>
              <a:t>1</a:t>
            </a:r>
          </a:p>
        </p:txBody>
      </p:sp>
      <p:cxnSp>
        <p:nvCxnSpPr>
          <p:cNvPr id="63" name="Straight Connector 62">
            <a:extLst>
              <a:ext uri="{FF2B5EF4-FFF2-40B4-BE49-F238E27FC236}">
                <a16:creationId xmlns:a16="http://schemas.microsoft.com/office/drawing/2014/main" id="{325783C9-EA5F-4789-AD32-370C2EC353B8}"/>
              </a:ext>
            </a:extLst>
          </p:cNvPr>
          <p:cNvCxnSpPr>
            <a:cxnSpLocks/>
          </p:cNvCxnSpPr>
          <p:nvPr/>
        </p:nvCxnSpPr>
        <p:spPr>
          <a:xfrm>
            <a:off x="9052937" y="3557734"/>
            <a:ext cx="503113" cy="0"/>
          </a:xfrm>
          <a:prstGeom prst="line">
            <a:avLst/>
          </a:prstGeom>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1427744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Event: </a:t>
            </a:r>
            <a:r>
              <a:rPr lang="en-US" sz="3600"/>
              <a:t>Either a single spike or a burst. All of the spikes in one burst are part of one “event”</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5E6CC999-542D-450B-9072-1D8886BE890D}"/>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08F7E712-5429-455C-9EFB-D74CDF210A04}"/>
              </a:ext>
            </a:extLst>
          </p:cNvPr>
          <p:cNvCxnSpPr>
            <a:cxnSpLocks/>
          </p:cNvCxnSpPr>
          <p:nvPr/>
        </p:nvCxnSpPr>
        <p:spPr>
          <a:xfrm>
            <a:off x="5541943"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F9A5C009-1910-496B-A7C1-1822970F0A54}"/>
              </a:ext>
            </a:extLst>
          </p:cNvPr>
          <p:cNvCxnSpPr>
            <a:cxnSpLocks/>
          </p:cNvCxnSpPr>
          <p:nvPr/>
        </p:nvCxnSpPr>
        <p:spPr>
          <a:xfrm>
            <a:off x="6045056"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B66BFC10-08DE-48B5-B23A-6F183F082A13}"/>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743E1477-59EB-44BF-9DB3-3C6A7A8C082D}"/>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11323809-9FDA-4F29-A82C-AA0FBACD5790}"/>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3" name="TextBox 12">
            <a:extLst>
              <a:ext uri="{FF2B5EF4-FFF2-40B4-BE49-F238E27FC236}">
                <a16:creationId xmlns:a16="http://schemas.microsoft.com/office/drawing/2014/main" id="{063F1761-4EAD-40E2-BD14-2EEF411621C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4" name="TextBox 13">
            <a:extLst>
              <a:ext uri="{FF2B5EF4-FFF2-40B4-BE49-F238E27FC236}">
                <a16:creationId xmlns:a16="http://schemas.microsoft.com/office/drawing/2014/main" id="{A5B98651-E29F-4D49-A6FB-A631BA5B4E18}"/>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5" name="TextBox 14">
            <a:extLst>
              <a:ext uri="{FF2B5EF4-FFF2-40B4-BE49-F238E27FC236}">
                <a16:creationId xmlns:a16="http://schemas.microsoft.com/office/drawing/2014/main" id="{57DBFBDB-A607-41CD-A042-30EBF2F22D7C}"/>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16" name="TextBox 15">
            <a:extLst>
              <a:ext uri="{FF2B5EF4-FFF2-40B4-BE49-F238E27FC236}">
                <a16:creationId xmlns:a16="http://schemas.microsoft.com/office/drawing/2014/main" id="{EAFA46F0-1EAD-492B-B17F-9B66C38F660F}"/>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17" name="TextBox 16">
            <a:extLst>
              <a:ext uri="{FF2B5EF4-FFF2-40B4-BE49-F238E27FC236}">
                <a16:creationId xmlns:a16="http://schemas.microsoft.com/office/drawing/2014/main" id="{7F8CDF7A-FDF6-4DE7-B305-464F6C52B7B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8" name="TextBox 17">
            <a:extLst>
              <a:ext uri="{FF2B5EF4-FFF2-40B4-BE49-F238E27FC236}">
                <a16:creationId xmlns:a16="http://schemas.microsoft.com/office/drawing/2014/main" id="{9F1C46BE-7900-4262-90C3-0471B29061A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0" name="TextBox 19">
            <a:extLst>
              <a:ext uri="{FF2B5EF4-FFF2-40B4-BE49-F238E27FC236}">
                <a16:creationId xmlns:a16="http://schemas.microsoft.com/office/drawing/2014/main" id="{9F438B38-4B5B-42F2-BCB7-6941DD03CAF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21" name="TextBox 20">
            <a:extLst>
              <a:ext uri="{FF2B5EF4-FFF2-40B4-BE49-F238E27FC236}">
                <a16:creationId xmlns:a16="http://schemas.microsoft.com/office/drawing/2014/main" id="{71718F80-5BB8-4AEB-8504-9A2D9A1E5D77}"/>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22" name="TextBox 21">
            <a:extLst>
              <a:ext uri="{FF2B5EF4-FFF2-40B4-BE49-F238E27FC236}">
                <a16:creationId xmlns:a16="http://schemas.microsoft.com/office/drawing/2014/main" id="{586FD3E3-E337-4357-B28A-016395D6231A}"/>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23" name="TextBox 22">
            <a:extLst>
              <a:ext uri="{FF2B5EF4-FFF2-40B4-BE49-F238E27FC236}">
                <a16:creationId xmlns:a16="http://schemas.microsoft.com/office/drawing/2014/main" id="{68CC3645-D8F4-4A75-9408-E695E3B04050}"/>
              </a:ext>
            </a:extLst>
          </p:cNvPr>
          <p:cNvSpPr txBox="1"/>
          <p:nvPr/>
        </p:nvSpPr>
        <p:spPr>
          <a:xfrm>
            <a:off x="639171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24" name="TextBox 23">
            <a:extLst>
              <a:ext uri="{FF2B5EF4-FFF2-40B4-BE49-F238E27FC236}">
                <a16:creationId xmlns:a16="http://schemas.microsoft.com/office/drawing/2014/main" id="{EE8F42A6-71D2-4541-9238-A6F22A7FC8B1}"/>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25" name="TextBox 24">
            <a:extLst>
              <a:ext uri="{FF2B5EF4-FFF2-40B4-BE49-F238E27FC236}">
                <a16:creationId xmlns:a16="http://schemas.microsoft.com/office/drawing/2014/main" id="{F07C037D-791F-459D-B32F-24ECE9031F63}"/>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8" name="Arrow: Down 37">
            <a:extLst>
              <a:ext uri="{FF2B5EF4-FFF2-40B4-BE49-F238E27FC236}">
                <a16:creationId xmlns:a16="http://schemas.microsoft.com/office/drawing/2014/main" id="{AE2451CF-3087-453B-AED6-0A342E20F705}"/>
              </a:ext>
            </a:extLst>
          </p:cNvPr>
          <p:cNvSpPr/>
          <p:nvPr/>
        </p:nvSpPr>
        <p:spPr>
          <a:xfrm rot="2877750">
            <a:off x="3284535" y="2084952"/>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270" rtlCol="0" anchor="ctr"/>
          <a:lstStyle/>
          <a:p>
            <a:pPr algn="ctr"/>
            <a:r>
              <a:rPr lang="en-US"/>
              <a:t>event</a:t>
            </a:r>
          </a:p>
        </p:txBody>
      </p:sp>
      <p:sp>
        <p:nvSpPr>
          <p:cNvPr id="41" name="Arrow: Down 40">
            <a:extLst>
              <a:ext uri="{FF2B5EF4-FFF2-40B4-BE49-F238E27FC236}">
                <a16:creationId xmlns:a16="http://schemas.microsoft.com/office/drawing/2014/main" id="{39999795-113F-4E9B-AA9E-39C14F92993D}"/>
              </a:ext>
            </a:extLst>
          </p:cNvPr>
          <p:cNvSpPr/>
          <p:nvPr/>
        </p:nvSpPr>
        <p:spPr>
          <a:xfrm rot="2877750">
            <a:off x="9397356" y="2084952"/>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270" rtlCol="0" anchor="ctr"/>
          <a:lstStyle/>
          <a:p>
            <a:pPr algn="ctr"/>
            <a:r>
              <a:rPr lang="en-US"/>
              <a:t>event</a:t>
            </a:r>
          </a:p>
        </p:txBody>
      </p:sp>
      <p:sp>
        <p:nvSpPr>
          <p:cNvPr id="42" name="TextBox 41">
            <a:extLst>
              <a:ext uri="{FF2B5EF4-FFF2-40B4-BE49-F238E27FC236}">
                <a16:creationId xmlns:a16="http://schemas.microsoft.com/office/drawing/2014/main" id="{C1E07250-43D2-4775-A763-56A4085D57AD}"/>
              </a:ext>
            </a:extLst>
          </p:cNvPr>
          <p:cNvSpPr txBox="1"/>
          <p:nvPr/>
        </p:nvSpPr>
        <p:spPr>
          <a:xfrm>
            <a:off x="5427017" y="5148033"/>
            <a:ext cx="1723549" cy="646331"/>
          </a:xfrm>
          <a:prstGeom prst="rect">
            <a:avLst/>
          </a:prstGeom>
          <a:noFill/>
        </p:spPr>
        <p:txBody>
          <a:bodyPr wrap="none" rtlCol="0">
            <a:spAutoFit/>
          </a:bodyPr>
          <a:lstStyle/>
          <a:p>
            <a:pPr algn="ctr"/>
            <a:r>
              <a:rPr lang="en-US" sz="3600">
                <a:latin typeface="Arial" panose="020B0604020202020204" pitchFamily="34" charset="0"/>
              </a:rPr>
              <a:t>EVENT</a:t>
            </a:r>
            <a:endParaRPr lang="en-US" sz="3600"/>
          </a:p>
        </p:txBody>
      </p:sp>
      <p:sp>
        <p:nvSpPr>
          <p:cNvPr id="3" name="Left Brace 2">
            <a:extLst>
              <a:ext uri="{FF2B5EF4-FFF2-40B4-BE49-F238E27FC236}">
                <a16:creationId xmlns:a16="http://schemas.microsoft.com/office/drawing/2014/main" id="{0DE33D1C-035D-4D28-A945-E49776245146}"/>
              </a:ext>
            </a:extLst>
          </p:cNvPr>
          <p:cNvSpPr/>
          <p:nvPr/>
        </p:nvSpPr>
        <p:spPr>
          <a:xfrm rot="16200000">
            <a:off x="6125507" y="4179496"/>
            <a:ext cx="326571" cy="1524982"/>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315692274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Inter-event interval: </a:t>
            </a:r>
            <a:r>
              <a:rPr lang="en-US" sz="3600"/>
              <a:t>The interval of time between events. By definition, an interval greater than burst window. Could be time between two single spikes, two bursts, or a single spike and a burst. </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5E6CC999-542D-450B-9072-1D8886BE890D}"/>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08F7E712-5429-455C-9EFB-D74CDF210A04}"/>
              </a:ext>
            </a:extLst>
          </p:cNvPr>
          <p:cNvCxnSpPr>
            <a:cxnSpLocks/>
          </p:cNvCxnSpPr>
          <p:nvPr/>
        </p:nvCxnSpPr>
        <p:spPr>
          <a:xfrm>
            <a:off x="5541943"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F9A5C009-1910-496B-A7C1-1822970F0A54}"/>
              </a:ext>
            </a:extLst>
          </p:cNvPr>
          <p:cNvCxnSpPr>
            <a:cxnSpLocks/>
          </p:cNvCxnSpPr>
          <p:nvPr/>
        </p:nvCxnSpPr>
        <p:spPr>
          <a:xfrm>
            <a:off x="6045056"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B66BFC10-08DE-48B5-B23A-6F183F082A13}"/>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743E1477-59EB-44BF-9DB3-3C6A7A8C082D}"/>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11323809-9FDA-4F29-A82C-AA0FBACD5790}"/>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3" name="TextBox 12">
            <a:extLst>
              <a:ext uri="{FF2B5EF4-FFF2-40B4-BE49-F238E27FC236}">
                <a16:creationId xmlns:a16="http://schemas.microsoft.com/office/drawing/2014/main" id="{063F1761-4EAD-40E2-BD14-2EEF411621C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4" name="TextBox 13">
            <a:extLst>
              <a:ext uri="{FF2B5EF4-FFF2-40B4-BE49-F238E27FC236}">
                <a16:creationId xmlns:a16="http://schemas.microsoft.com/office/drawing/2014/main" id="{A5B98651-E29F-4D49-A6FB-A631BA5B4E18}"/>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5" name="TextBox 14">
            <a:extLst>
              <a:ext uri="{FF2B5EF4-FFF2-40B4-BE49-F238E27FC236}">
                <a16:creationId xmlns:a16="http://schemas.microsoft.com/office/drawing/2014/main" id="{57DBFBDB-A607-41CD-A042-30EBF2F22D7C}"/>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16" name="TextBox 15">
            <a:extLst>
              <a:ext uri="{FF2B5EF4-FFF2-40B4-BE49-F238E27FC236}">
                <a16:creationId xmlns:a16="http://schemas.microsoft.com/office/drawing/2014/main" id="{EAFA46F0-1EAD-492B-B17F-9B66C38F660F}"/>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17" name="TextBox 16">
            <a:extLst>
              <a:ext uri="{FF2B5EF4-FFF2-40B4-BE49-F238E27FC236}">
                <a16:creationId xmlns:a16="http://schemas.microsoft.com/office/drawing/2014/main" id="{7F8CDF7A-FDF6-4DE7-B305-464F6C52B7B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8" name="TextBox 17">
            <a:extLst>
              <a:ext uri="{FF2B5EF4-FFF2-40B4-BE49-F238E27FC236}">
                <a16:creationId xmlns:a16="http://schemas.microsoft.com/office/drawing/2014/main" id="{9F1C46BE-7900-4262-90C3-0471B29061A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0" name="TextBox 19">
            <a:extLst>
              <a:ext uri="{FF2B5EF4-FFF2-40B4-BE49-F238E27FC236}">
                <a16:creationId xmlns:a16="http://schemas.microsoft.com/office/drawing/2014/main" id="{9F438B38-4B5B-42F2-BCB7-6941DD03CAF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21" name="TextBox 20">
            <a:extLst>
              <a:ext uri="{FF2B5EF4-FFF2-40B4-BE49-F238E27FC236}">
                <a16:creationId xmlns:a16="http://schemas.microsoft.com/office/drawing/2014/main" id="{71718F80-5BB8-4AEB-8504-9A2D9A1E5D77}"/>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22" name="TextBox 21">
            <a:extLst>
              <a:ext uri="{FF2B5EF4-FFF2-40B4-BE49-F238E27FC236}">
                <a16:creationId xmlns:a16="http://schemas.microsoft.com/office/drawing/2014/main" id="{586FD3E3-E337-4357-B28A-016395D6231A}"/>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23" name="TextBox 22">
            <a:extLst>
              <a:ext uri="{FF2B5EF4-FFF2-40B4-BE49-F238E27FC236}">
                <a16:creationId xmlns:a16="http://schemas.microsoft.com/office/drawing/2014/main" id="{68CC3645-D8F4-4A75-9408-E695E3B04050}"/>
              </a:ext>
            </a:extLst>
          </p:cNvPr>
          <p:cNvSpPr txBox="1"/>
          <p:nvPr/>
        </p:nvSpPr>
        <p:spPr>
          <a:xfrm>
            <a:off x="639171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24" name="TextBox 23">
            <a:extLst>
              <a:ext uri="{FF2B5EF4-FFF2-40B4-BE49-F238E27FC236}">
                <a16:creationId xmlns:a16="http://schemas.microsoft.com/office/drawing/2014/main" id="{EE8F42A6-71D2-4541-9238-A6F22A7FC8B1}"/>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25" name="TextBox 24">
            <a:extLst>
              <a:ext uri="{FF2B5EF4-FFF2-40B4-BE49-F238E27FC236}">
                <a16:creationId xmlns:a16="http://schemas.microsoft.com/office/drawing/2014/main" id="{F07C037D-791F-459D-B32F-24ECE9031F63}"/>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8" name="Arrow: Down 37">
            <a:extLst>
              <a:ext uri="{FF2B5EF4-FFF2-40B4-BE49-F238E27FC236}">
                <a16:creationId xmlns:a16="http://schemas.microsoft.com/office/drawing/2014/main" id="{AE2451CF-3087-453B-AED6-0A342E20F705}"/>
              </a:ext>
            </a:extLst>
          </p:cNvPr>
          <p:cNvSpPr/>
          <p:nvPr/>
        </p:nvSpPr>
        <p:spPr>
          <a:xfrm rot="2877750">
            <a:off x="3284535" y="2084952"/>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270" rtlCol="0" anchor="ctr"/>
          <a:lstStyle/>
          <a:p>
            <a:pPr algn="ctr"/>
            <a:r>
              <a:rPr lang="en-US"/>
              <a:t>event</a:t>
            </a:r>
          </a:p>
        </p:txBody>
      </p:sp>
      <p:sp>
        <p:nvSpPr>
          <p:cNvPr id="41" name="Arrow: Down 40">
            <a:extLst>
              <a:ext uri="{FF2B5EF4-FFF2-40B4-BE49-F238E27FC236}">
                <a16:creationId xmlns:a16="http://schemas.microsoft.com/office/drawing/2014/main" id="{39999795-113F-4E9B-AA9E-39C14F92993D}"/>
              </a:ext>
            </a:extLst>
          </p:cNvPr>
          <p:cNvSpPr/>
          <p:nvPr/>
        </p:nvSpPr>
        <p:spPr>
          <a:xfrm rot="2877750">
            <a:off x="9397356" y="2084952"/>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270" rtlCol="0" anchor="ctr"/>
          <a:lstStyle/>
          <a:p>
            <a:pPr algn="ctr"/>
            <a:r>
              <a:rPr lang="en-US"/>
              <a:t>event</a:t>
            </a:r>
          </a:p>
        </p:txBody>
      </p:sp>
      <p:sp>
        <p:nvSpPr>
          <p:cNvPr id="42" name="TextBox 41">
            <a:extLst>
              <a:ext uri="{FF2B5EF4-FFF2-40B4-BE49-F238E27FC236}">
                <a16:creationId xmlns:a16="http://schemas.microsoft.com/office/drawing/2014/main" id="{C1E07250-43D2-4775-A763-56A4085D57AD}"/>
              </a:ext>
            </a:extLst>
          </p:cNvPr>
          <p:cNvSpPr txBox="1"/>
          <p:nvPr/>
        </p:nvSpPr>
        <p:spPr>
          <a:xfrm>
            <a:off x="5427017" y="5148033"/>
            <a:ext cx="1723549" cy="646331"/>
          </a:xfrm>
          <a:prstGeom prst="rect">
            <a:avLst/>
          </a:prstGeom>
          <a:noFill/>
        </p:spPr>
        <p:txBody>
          <a:bodyPr wrap="none" rtlCol="0">
            <a:spAutoFit/>
          </a:bodyPr>
          <a:lstStyle/>
          <a:p>
            <a:pPr algn="ctr"/>
            <a:r>
              <a:rPr lang="en-US" sz="3600">
                <a:latin typeface="Arial" panose="020B0604020202020204" pitchFamily="34" charset="0"/>
              </a:rPr>
              <a:t>EVENT</a:t>
            </a:r>
            <a:endParaRPr lang="en-US" sz="3600"/>
          </a:p>
        </p:txBody>
      </p:sp>
      <p:sp>
        <p:nvSpPr>
          <p:cNvPr id="3" name="Left Brace 2">
            <a:extLst>
              <a:ext uri="{FF2B5EF4-FFF2-40B4-BE49-F238E27FC236}">
                <a16:creationId xmlns:a16="http://schemas.microsoft.com/office/drawing/2014/main" id="{0DE33D1C-035D-4D28-A945-E49776245146}"/>
              </a:ext>
            </a:extLst>
          </p:cNvPr>
          <p:cNvSpPr/>
          <p:nvPr/>
        </p:nvSpPr>
        <p:spPr>
          <a:xfrm rot="16200000">
            <a:off x="6125507" y="4179496"/>
            <a:ext cx="326571" cy="1524982"/>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1" name="TextBox 30">
            <a:extLst>
              <a:ext uri="{FF2B5EF4-FFF2-40B4-BE49-F238E27FC236}">
                <a16:creationId xmlns:a16="http://schemas.microsoft.com/office/drawing/2014/main" id="{6DA930FB-AD67-4BF5-B2F1-40CB2B19AF1E}"/>
              </a:ext>
            </a:extLst>
          </p:cNvPr>
          <p:cNvSpPr txBox="1"/>
          <p:nvPr/>
        </p:nvSpPr>
        <p:spPr>
          <a:xfrm>
            <a:off x="4125496" y="3214713"/>
            <a:ext cx="301686" cy="369332"/>
          </a:xfrm>
          <a:prstGeom prst="rect">
            <a:avLst/>
          </a:prstGeom>
          <a:noFill/>
        </p:spPr>
        <p:txBody>
          <a:bodyPr wrap="square" rtlCol="0">
            <a:spAutoFit/>
          </a:bodyPr>
          <a:lstStyle/>
          <a:p>
            <a:pPr algn="ctr"/>
            <a:r>
              <a:rPr lang="en-US"/>
              <a:t>5</a:t>
            </a:r>
          </a:p>
        </p:txBody>
      </p:sp>
      <p:cxnSp>
        <p:nvCxnSpPr>
          <p:cNvPr id="32" name="Straight Connector 31">
            <a:extLst>
              <a:ext uri="{FF2B5EF4-FFF2-40B4-BE49-F238E27FC236}">
                <a16:creationId xmlns:a16="http://schemas.microsoft.com/office/drawing/2014/main" id="{67223FFA-2893-4A49-B60F-60DCAA072D7F}"/>
              </a:ext>
            </a:extLst>
          </p:cNvPr>
          <p:cNvCxnSpPr>
            <a:cxnSpLocks/>
          </p:cNvCxnSpPr>
          <p:nvPr/>
        </p:nvCxnSpPr>
        <p:spPr>
          <a:xfrm>
            <a:off x="3026378" y="3557734"/>
            <a:ext cx="2499923" cy="0"/>
          </a:xfrm>
          <a:prstGeom prst="line">
            <a:avLst/>
          </a:prstGeom>
        </p:spPr>
        <p:style>
          <a:lnRef idx="1">
            <a:schemeClr val="accent1"/>
          </a:lnRef>
          <a:fillRef idx="0">
            <a:schemeClr val="accent1"/>
          </a:fillRef>
          <a:effectRef idx="0">
            <a:schemeClr val="accent1"/>
          </a:effectRef>
          <a:fontRef idx="minor">
            <a:schemeClr val="tx1"/>
          </a:fontRef>
        </p:style>
      </p:cxnSp>
      <p:sp>
        <p:nvSpPr>
          <p:cNvPr id="33" name="Arrow: Down 32">
            <a:extLst>
              <a:ext uri="{FF2B5EF4-FFF2-40B4-BE49-F238E27FC236}">
                <a16:creationId xmlns:a16="http://schemas.microsoft.com/office/drawing/2014/main" id="{5006F60C-629F-43A4-B394-45D8960BA12C}"/>
              </a:ext>
            </a:extLst>
          </p:cNvPr>
          <p:cNvSpPr/>
          <p:nvPr/>
        </p:nvSpPr>
        <p:spPr>
          <a:xfrm rot="10800000">
            <a:off x="4037953" y="3625940"/>
            <a:ext cx="476772" cy="568587"/>
          </a:xfrm>
          <a:prstGeom prst="downArrow">
            <a:avLst/>
          </a:prstGeom>
          <a:solidFill>
            <a:srgbClr val="CC99FF"/>
          </a:solidFill>
          <a:ln>
            <a:solidFill>
              <a:srgbClr val="CC99FF"/>
            </a:solidFill>
          </a:ln>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a:p>
        </p:txBody>
      </p:sp>
      <p:sp>
        <p:nvSpPr>
          <p:cNvPr id="34" name="TextBox 33">
            <a:extLst>
              <a:ext uri="{FF2B5EF4-FFF2-40B4-BE49-F238E27FC236}">
                <a16:creationId xmlns:a16="http://schemas.microsoft.com/office/drawing/2014/main" id="{877AB1D4-B093-428A-9236-823E7C76BEDE}"/>
              </a:ext>
            </a:extLst>
          </p:cNvPr>
          <p:cNvSpPr txBox="1"/>
          <p:nvPr/>
        </p:nvSpPr>
        <p:spPr>
          <a:xfrm>
            <a:off x="7906665" y="3214713"/>
            <a:ext cx="301686" cy="369332"/>
          </a:xfrm>
          <a:prstGeom prst="rect">
            <a:avLst/>
          </a:prstGeom>
          <a:noFill/>
        </p:spPr>
        <p:txBody>
          <a:bodyPr wrap="square" rtlCol="0">
            <a:spAutoFit/>
          </a:bodyPr>
          <a:lstStyle/>
          <a:p>
            <a:pPr algn="ctr"/>
            <a:r>
              <a:rPr lang="en-US"/>
              <a:t>4</a:t>
            </a:r>
          </a:p>
        </p:txBody>
      </p:sp>
      <p:cxnSp>
        <p:nvCxnSpPr>
          <p:cNvPr id="35" name="Straight Connector 34">
            <a:extLst>
              <a:ext uri="{FF2B5EF4-FFF2-40B4-BE49-F238E27FC236}">
                <a16:creationId xmlns:a16="http://schemas.microsoft.com/office/drawing/2014/main" id="{EAA5785A-76FF-4E58-9AE8-0555230AEDD3}"/>
              </a:ext>
            </a:extLst>
          </p:cNvPr>
          <p:cNvCxnSpPr>
            <a:cxnSpLocks/>
          </p:cNvCxnSpPr>
          <p:nvPr/>
        </p:nvCxnSpPr>
        <p:spPr>
          <a:xfrm>
            <a:off x="7048373" y="3557734"/>
            <a:ext cx="2015361" cy="0"/>
          </a:xfrm>
          <a:prstGeom prst="line">
            <a:avLst/>
          </a:prstGeom>
        </p:spPr>
        <p:style>
          <a:lnRef idx="1">
            <a:schemeClr val="accent1"/>
          </a:lnRef>
          <a:fillRef idx="0">
            <a:schemeClr val="accent1"/>
          </a:fillRef>
          <a:effectRef idx="0">
            <a:schemeClr val="accent1"/>
          </a:effectRef>
          <a:fontRef idx="minor">
            <a:schemeClr val="tx1"/>
          </a:fontRef>
        </p:style>
      </p:cxnSp>
      <p:sp>
        <p:nvSpPr>
          <p:cNvPr id="36" name="Arrow: Down 35">
            <a:extLst>
              <a:ext uri="{FF2B5EF4-FFF2-40B4-BE49-F238E27FC236}">
                <a16:creationId xmlns:a16="http://schemas.microsoft.com/office/drawing/2014/main" id="{FE50D528-7CEF-4ED2-9834-37A1A83283C3}"/>
              </a:ext>
            </a:extLst>
          </p:cNvPr>
          <p:cNvSpPr/>
          <p:nvPr/>
        </p:nvSpPr>
        <p:spPr>
          <a:xfrm rot="10800000">
            <a:off x="7817667" y="3625940"/>
            <a:ext cx="476772" cy="568587"/>
          </a:xfrm>
          <a:prstGeom prst="downArrow">
            <a:avLst/>
          </a:prstGeom>
          <a:solidFill>
            <a:srgbClr val="CC99FF"/>
          </a:solidFill>
          <a:ln>
            <a:solidFill>
              <a:srgbClr val="CC99FF"/>
            </a:solidFill>
          </a:ln>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a:p>
        </p:txBody>
      </p:sp>
      <p:sp>
        <p:nvSpPr>
          <p:cNvPr id="37" name="TextBox 36">
            <a:extLst>
              <a:ext uri="{FF2B5EF4-FFF2-40B4-BE49-F238E27FC236}">
                <a16:creationId xmlns:a16="http://schemas.microsoft.com/office/drawing/2014/main" id="{11F4F17E-B198-4662-82B9-FD38C6AFD4A0}"/>
              </a:ext>
            </a:extLst>
          </p:cNvPr>
          <p:cNvSpPr txBox="1"/>
          <p:nvPr/>
        </p:nvSpPr>
        <p:spPr>
          <a:xfrm>
            <a:off x="3640847" y="5941508"/>
            <a:ext cx="4910320" cy="584775"/>
          </a:xfrm>
          <a:prstGeom prst="rect">
            <a:avLst/>
          </a:prstGeom>
          <a:noFill/>
        </p:spPr>
        <p:txBody>
          <a:bodyPr wrap="none" rtlCol="0">
            <a:spAutoFit/>
          </a:bodyPr>
          <a:lstStyle/>
          <a:p>
            <a:pPr algn="ctr"/>
            <a:r>
              <a:rPr lang="en-US" sz="3200" err="1">
                <a:solidFill>
                  <a:srgbClr val="00B050"/>
                </a:solidFill>
              </a:rPr>
              <a:t>Inter_Intervals</a:t>
            </a:r>
            <a:r>
              <a:rPr lang="en-US" sz="3200">
                <a:solidFill>
                  <a:srgbClr val="00B050"/>
                </a:solidFill>
              </a:rPr>
              <a:t> = [5, 4] sec</a:t>
            </a:r>
          </a:p>
        </p:txBody>
      </p:sp>
    </p:spTree>
    <p:extLst>
      <p:ext uri="{BB962C8B-B14F-4D97-AF65-F5344CB8AC3E}">
        <p14:creationId xmlns:p14="http://schemas.microsoft.com/office/powerpoint/2010/main" val="30320332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Gap: </a:t>
            </a:r>
            <a:r>
              <a:rPr lang="en-US" sz="3600"/>
              <a:t>A break in the recording. No data exists during this time period. For extracellular recordings, this is typically between series</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9" name="Rectangle 38">
            <a:extLst>
              <a:ext uri="{FF2B5EF4-FFF2-40B4-BE49-F238E27FC236}">
                <a16:creationId xmlns:a16="http://schemas.microsoft.com/office/drawing/2014/main" id="{27D58888-A601-43D8-83DB-2A7A24D06105}"/>
              </a:ext>
            </a:extLst>
          </p:cNvPr>
          <p:cNvSpPr/>
          <p:nvPr/>
        </p:nvSpPr>
        <p:spPr>
          <a:xfrm>
            <a:off x="5288353"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0" name="Straight Connector 39">
            <a:extLst>
              <a:ext uri="{FF2B5EF4-FFF2-40B4-BE49-F238E27FC236}">
                <a16:creationId xmlns:a16="http://schemas.microsoft.com/office/drawing/2014/main" id="{B0C75C54-9777-4355-8ED0-3AE4B6C24E65}"/>
              </a:ext>
            </a:extLst>
          </p:cNvPr>
          <p:cNvCxnSpPr>
            <a:cxnSpLocks/>
          </p:cNvCxnSpPr>
          <p:nvPr/>
        </p:nvCxnSpPr>
        <p:spPr>
          <a:xfrm>
            <a:off x="151703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C09FC3A6-B612-4A0E-A9AF-AE55C01646C0}"/>
              </a:ext>
            </a:extLst>
          </p:cNvPr>
          <p:cNvCxnSpPr>
            <a:cxnSpLocks/>
          </p:cNvCxnSpPr>
          <p:nvPr/>
        </p:nvCxnSpPr>
        <p:spPr>
          <a:xfrm>
            <a:off x="2020152"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EE6AF921-BF94-4F45-9936-D9522C3D3BA0}"/>
              </a:ext>
            </a:extLst>
          </p:cNvPr>
          <p:cNvCxnSpPr>
            <a:cxnSpLocks/>
          </p:cNvCxnSpPr>
          <p:nvPr/>
        </p:nvCxnSpPr>
        <p:spPr>
          <a:xfrm>
            <a:off x="2523265"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07A3D001-4343-440F-BC09-7E755AEADA54}"/>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4215D8C-F389-47EB-B9CD-6386BFAD7F84}"/>
              </a:ext>
            </a:extLst>
          </p:cNvPr>
          <p:cNvCxnSpPr>
            <a:cxnSpLocks/>
          </p:cNvCxnSpPr>
          <p:nvPr/>
        </p:nvCxnSpPr>
        <p:spPr>
          <a:xfrm>
            <a:off x="352949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CEA95916-EA13-4C8E-9249-787B254E44A3}"/>
              </a:ext>
            </a:extLst>
          </p:cNvPr>
          <p:cNvCxnSpPr>
            <a:cxnSpLocks/>
          </p:cNvCxnSpPr>
          <p:nvPr/>
        </p:nvCxnSpPr>
        <p:spPr>
          <a:xfrm>
            <a:off x="403260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FF8104FF-B039-444B-941E-9D5A7ADE03D6}"/>
              </a:ext>
            </a:extLst>
          </p:cNvPr>
          <p:cNvCxnSpPr>
            <a:cxnSpLocks/>
          </p:cNvCxnSpPr>
          <p:nvPr/>
        </p:nvCxnSpPr>
        <p:spPr>
          <a:xfrm>
            <a:off x="4535717"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D5E5D010-18E1-4583-B741-EA7A7CBDAB0C}"/>
              </a:ext>
            </a:extLst>
          </p:cNvPr>
          <p:cNvCxnSpPr>
            <a:cxnSpLocks/>
          </p:cNvCxnSpPr>
          <p:nvPr/>
        </p:nvCxnSpPr>
        <p:spPr>
          <a:xfrm>
            <a:off x="503883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28FB31A9-BBFC-4E52-97CB-1ED0A23439F9}"/>
              </a:ext>
            </a:extLst>
          </p:cNvPr>
          <p:cNvCxnSpPr>
            <a:cxnSpLocks/>
          </p:cNvCxnSpPr>
          <p:nvPr/>
        </p:nvCxnSpPr>
        <p:spPr>
          <a:xfrm>
            <a:off x="5541943" y="2693433"/>
            <a:ext cx="0" cy="1928326"/>
          </a:xfrm>
          <a:prstGeom prst="line">
            <a:avLst/>
          </a:prstGeom>
          <a:ln w="1905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3500F1A-C26B-495A-8C89-6E3665DF2D08}"/>
              </a:ext>
            </a:extLst>
          </p:cNvPr>
          <p:cNvCxnSpPr>
            <a:cxnSpLocks/>
          </p:cNvCxnSpPr>
          <p:nvPr/>
        </p:nvCxnSpPr>
        <p:spPr>
          <a:xfrm>
            <a:off x="6045056" y="2693433"/>
            <a:ext cx="0" cy="1928326"/>
          </a:xfrm>
          <a:prstGeom prst="line">
            <a:avLst/>
          </a:prstGeom>
          <a:ln w="1905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1B4BD474-CA63-446C-8B42-6087BB84047C}"/>
              </a:ext>
            </a:extLst>
          </p:cNvPr>
          <p:cNvCxnSpPr>
            <a:cxnSpLocks/>
          </p:cNvCxnSpPr>
          <p:nvPr/>
        </p:nvCxnSpPr>
        <p:spPr>
          <a:xfrm>
            <a:off x="654816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68877F21-0715-4C2C-BD86-5FF8D6383C20}"/>
              </a:ext>
            </a:extLst>
          </p:cNvPr>
          <p:cNvCxnSpPr>
            <a:cxnSpLocks/>
          </p:cNvCxnSpPr>
          <p:nvPr/>
        </p:nvCxnSpPr>
        <p:spPr>
          <a:xfrm>
            <a:off x="7051282"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a16="http://schemas.microsoft.com/office/drawing/2014/main" id="{446F511D-2EE9-4CF1-B470-231B51AECD7A}"/>
              </a:ext>
            </a:extLst>
          </p:cNvPr>
          <p:cNvCxnSpPr>
            <a:cxnSpLocks/>
          </p:cNvCxnSpPr>
          <p:nvPr/>
        </p:nvCxnSpPr>
        <p:spPr>
          <a:xfrm>
            <a:off x="7554395"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1CCEBE3F-5D3F-4DE3-95CA-2B40DB4D4D47}"/>
              </a:ext>
            </a:extLst>
          </p:cNvPr>
          <p:cNvCxnSpPr>
            <a:cxnSpLocks/>
          </p:cNvCxnSpPr>
          <p:nvPr/>
        </p:nvCxnSpPr>
        <p:spPr>
          <a:xfrm>
            <a:off x="805750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3D182075-E6E1-4F41-8FEC-0D54A8C76EA3}"/>
              </a:ext>
            </a:extLst>
          </p:cNvPr>
          <p:cNvCxnSpPr>
            <a:cxnSpLocks/>
          </p:cNvCxnSpPr>
          <p:nvPr/>
        </p:nvCxnSpPr>
        <p:spPr>
          <a:xfrm>
            <a:off x="856062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FBCEDD3B-FD2C-4D58-BCD0-4BEA878C17AE}"/>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9E5FBB96-7F3B-46A5-9A11-F2F32AB146E8}"/>
              </a:ext>
            </a:extLst>
          </p:cNvPr>
          <p:cNvCxnSpPr>
            <a:cxnSpLocks/>
          </p:cNvCxnSpPr>
          <p:nvPr/>
        </p:nvCxnSpPr>
        <p:spPr>
          <a:xfrm>
            <a:off x="9566847"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2371B90C-54E3-4226-B6E2-0E4170CE025D}"/>
              </a:ext>
            </a:extLst>
          </p:cNvPr>
          <p:cNvCxnSpPr>
            <a:cxnSpLocks/>
          </p:cNvCxnSpPr>
          <p:nvPr/>
        </p:nvCxnSpPr>
        <p:spPr>
          <a:xfrm>
            <a:off x="1006996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BFB0E42A-B467-43CF-BE2A-23BB4F099047}"/>
              </a:ext>
            </a:extLst>
          </p:cNvPr>
          <p:cNvCxnSpPr>
            <a:cxnSpLocks/>
          </p:cNvCxnSpPr>
          <p:nvPr/>
        </p:nvCxnSpPr>
        <p:spPr>
          <a:xfrm>
            <a:off x="10573073"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TextBox 60">
            <a:extLst>
              <a:ext uri="{FF2B5EF4-FFF2-40B4-BE49-F238E27FC236}">
                <a16:creationId xmlns:a16="http://schemas.microsoft.com/office/drawing/2014/main" id="{E1FD9494-E437-48FB-88EE-289A911AB776}"/>
              </a:ext>
            </a:extLst>
          </p:cNvPr>
          <p:cNvSpPr txBox="1"/>
          <p:nvPr/>
        </p:nvSpPr>
        <p:spPr>
          <a:xfrm>
            <a:off x="1360586"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a:t>
            </a:r>
          </a:p>
        </p:txBody>
      </p:sp>
      <p:sp>
        <p:nvSpPr>
          <p:cNvPr id="62" name="TextBox 61">
            <a:extLst>
              <a:ext uri="{FF2B5EF4-FFF2-40B4-BE49-F238E27FC236}">
                <a16:creationId xmlns:a16="http://schemas.microsoft.com/office/drawing/2014/main" id="{CF1DC525-A6C0-4390-AED8-CE86A5F0B56D}"/>
              </a:ext>
            </a:extLst>
          </p:cNvPr>
          <p:cNvSpPr txBox="1"/>
          <p:nvPr/>
        </p:nvSpPr>
        <p:spPr>
          <a:xfrm>
            <a:off x="1863699"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a:t>
            </a:r>
          </a:p>
        </p:txBody>
      </p:sp>
      <p:sp>
        <p:nvSpPr>
          <p:cNvPr id="63" name="TextBox 62">
            <a:extLst>
              <a:ext uri="{FF2B5EF4-FFF2-40B4-BE49-F238E27FC236}">
                <a16:creationId xmlns:a16="http://schemas.microsoft.com/office/drawing/2014/main" id="{F4BCD483-BFD5-4012-9496-1651EB9CA4FF}"/>
              </a:ext>
            </a:extLst>
          </p:cNvPr>
          <p:cNvSpPr txBox="1"/>
          <p:nvPr/>
        </p:nvSpPr>
        <p:spPr>
          <a:xfrm>
            <a:off x="2366812"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3</a:t>
            </a:r>
          </a:p>
        </p:txBody>
      </p:sp>
      <p:sp>
        <p:nvSpPr>
          <p:cNvPr id="64" name="TextBox 63">
            <a:extLst>
              <a:ext uri="{FF2B5EF4-FFF2-40B4-BE49-F238E27FC236}">
                <a16:creationId xmlns:a16="http://schemas.microsoft.com/office/drawing/2014/main" id="{CAD81215-1598-44A5-BCB5-6E1329FC06CB}"/>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5" name="TextBox 64">
            <a:extLst>
              <a:ext uri="{FF2B5EF4-FFF2-40B4-BE49-F238E27FC236}">
                <a16:creationId xmlns:a16="http://schemas.microsoft.com/office/drawing/2014/main" id="{D2FFD943-EDDD-401B-9C3B-E66DC286ECA5}"/>
              </a:ext>
            </a:extLst>
          </p:cNvPr>
          <p:cNvSpPr txBox="1"/>
          <p:nvPr/>
        </p:nvSpPr>
        <p:spPr>
          <a:xfrm>
            <a:off x="3373038"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a:t>
            </a:r>
          </a:p>
        </p:txBody>
      </p:sp>
      <p:sp>
        <p:nvSpPr>
          <p:cNvPr id="66" name="TextBox 65">
            <a:extLst>
              <a:ext uri="{FF2B5EF4-FFF2-40B4-BE49-F238E27FC236}">
                <a16:creationId xmlns:a16="http://schemas.microsoft.com/office/drawing/2014/main" id="{304D18D9-1489-4BED-B9FB-54641824AD45}"/>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19C21360-5531-40AF-90D8-EA1E050B1624}"/>
              </a:ext>
            </a:extLst>
          </p:cNvPr>
          <p:cNvSpPr txBox="1"/>
          <p:nvPr/>
        </p:nvSpPr>
        <p:spPr>
          <a:xfrm>
            <a:off x="4379264"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7</a:t>
            </a:r>
          </a:p>
        </p:txBody>
      </p:sp>
      <p:sp>
        <p:nvSpPr>
          <p:cNvPr id="68" name="TextBox 67">
            <a:extLst>
              <a:ext uri="{FF2B5EF4-FFF2-40B4-BE49-F238E27FC236}">
                <a16:creationId xmlns:a16="http://schemas.microsoft.com/office/drawing/2014/main" id="{C9FF9BF8-2DBF-49BB-BB74-CBBEB5494177}"/>
              </a:ext>
            </a:extLst>
          </p:cNvPr>
          <p:cNvSpPr txBox="1"/>
          <p:nvPr/>
        </p:nvSpPr>
        <p:spPr>
          <a:xfrm>
            <a:off x="488237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8</a:t>
            </a:r>
          </a:p>
        </p:txBody>
      </p:sp>
      <p:sp>
        <p:nvSpPr>
          <p:cNvPr id="69" name="TextBox 68">
            <a:extLst>
              <a:ext uri="{FF2B5EF4-FFF2-40B4-BE49-F238E27FC236}">
                <a16:creationId xmlns:a16="http://schemas.microsoft.com/office/drawing/2014/main" id="{3DD35A0C-FB95-451D-9210-529BB8553657}"/>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70" name="TextBox 69">
            <a:extLst>
              <a:ext uri="{FF2B5EF4-FFF2-40B4-BE49-F238E27FC236}">
                <a16:creationId xmlns:a16="http://schemas.microsoft.com/office/drawing/2014/main" id="{794E1B52-0F46-4FB3-8B7F-EB53C8327154}"/>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71" name="TextBox 70">
            <a:extLst>
              <a:ext uri="{FF2B5EF4-FFF2-40B4-BE49-F238E27FC236}">
                <a16:creationId xmlns:a16="http://schemas.microsoft.com/office/drawing/2014/main" id="{130AA605-2900-4295-9FAA-F73DDF45F6CF}"/>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72" name="TextBox 71">
            <a:extLst>
              <a:ext uri="{FF2B5EF4-FFF2-40B4-BE49-F238E27FC236}">
                <a16:creationId xmlns:a16="http://schemas.microsoft.com/office/drawing/2014/main" id="{CD6429D6-BBB2-4B38-8293-0480D579936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73" name="TextBox 72">
            <a:extLst>
              <a:ext uri="{FF2B5EF4-FFF2-40B4-BE49-F238E27FC236}">
                <a16:creationId xmlns:a16="http://schemas.microsoft.com/office/drawing/2014/main" id="{382734AC-1615-4858-818A-F8BE53B6C96D}"/>
              </a:ext>
            </a:extLst>
          </p:cNvPr>
          <p:cNvSpPr txBox="1"/>
          <p:nvPr/>
        </p:nvSpPr>
        <p:spPr>
          <a:xfrm>
            <a:off x="7333822"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3</a:t>
            </a:r>
          </a:p>
        </p:txBody>
      </p:sp>
      <p:sp>
        <p:nvSpPr>
          <p:cNvPr id="74" name="TextBox 73">
            <a:extLst>
              <a:ext uri="{FF2B5EF4-FFF2-40B4-BE49-F238E27FC236}">
                <a16:creationId xmlns:a16="http://schemas.microsoft.com/office/drawing/2014/main" id="{11AADA4F-09DC-4B0C-B8CE-8E626421B549}"/>
              </a:ext>
            </a:extLst>
          </p:cNvPr>
          <p:cNvSpPr txBox="1"/>
          <p:nvPr/>
        </p:nvSpPr>
        <p:spPr>
          <a:xfrm>
            <a:off x="7836935"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4</a:t>
            </a:r>
          </a:p>
        </p:txBody>
      </p:sp>
      <p:sp>
        <p:nvSpPr>
          <p:cNvPr id="75" name="TextBox 74">
            <a:extLst>
              <a:ext uri="{FF2B5EF4-FFF2-40B4-BE49-F238E27FC236}">
                <a16:creationId xmlns:a16="http://schemas.microsoft.com/office/drawing/2014/main" id="{F15B31C9-CBD7-4EE4-9CFD-DB390763665D}"/>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76" name="TextBox 75">
            <a:extLst>
              <a:ext uri="{FF2B5EF4-FFF2-40B4-BE49-F238E27FC236}">
                <a16:creationId xmlns:a16="http://schemas.microsoft.com/office/drawing/2014/main" id="{A41973E2-05AF-4384-A490-018477B607D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77" name="TextBox 76">
            <a:extLst>
              <a:ext uri="{FF2B5EF4-FFF2-40B4-BE49-F238E27FC236}">
                <a16:creationId xmlns:a16="http://schemas.microsoft.com/office/drawing/2014/main" id="{5D11163C-B992-4353-9F3D-BB5DFBCE4FB1}"/>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78" name="TextBox 77">
            <a:extLst>
              <a:ext uri="{FF2B5EF4-FFF2-40B4-BE49-F238E27FC236}">
                <a16:creationId xmlns:a16="http://schemas.microsoft.com/office/drawing/2014/main" id="{B8CF1FF0-79B3-483F-9320-EF64775CB397}"/>
              </a:ext>
            </a:extLst>
          </p:cNvPr>
          <p:cNvSpPr txBox="1"/>
          <p:nvPr/>
        </p:nvSpPr>
        <p:spPr>
          <a:xfrm>
            <a:off x="9849387"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8</a:t>
            </a:r>
          </a:p>
        </p:txBody>
      </p:sp>
      <p:sp>
        <p:nvSpPr>
          <p:cNvPr id="79" name="TextBox 78">
            <a:extLst>
              <a:ext uri="{FF2B5EF4-FFF2-40B4-BE49-F238E27FC236}">
                <a16:creationId xmlns:a16="http://schemas.microsoft.com/office/drawing/2014/main" id="{799A331B-6EBE-4CC3-A16F-0B092870A7C6}"/>
              </a:ext>
            </a:extLst>
          </p:cNvPr>
          <p:cNvSpPr txBox="1"/>
          <p:nvPr/>
        </p:nvSpPr>
        <p:spPr>
          <a:xfrm>
            <a:off x="10352500"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9</a:t>
            </a:r>
          </a:p>
        </p:txBody>
      </p:sp>
      <p:sp>
        <p:nvSpPr>
          <p:cNvPr id="80" name="TextBox 79">
            <a:extLst>
              <a:ext uri="{FF2B5EF4-FFF2-40B4-BE49-F238E27FC236}">
                <a16:creationId xmlns:a16="http://schemas.microsoft.com/office/drawing/2014/main" id="{A2F037F8-2EB4-473A-9038-4B493E305455}"/>
              </a:ext>
            </a:extLst>
          </p:cNvPr>
          <p:cNvSpPr txBox="1"/>
          <p:nvPr/>
        </p:nvSpPr>
        <p:spPr>
          <a:xfrm>
            <a:off x="136058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77C95FF9-757E-4031-A501-4E78FD91A8E8}"/>
              </a:ext>
            </a:extLst>
          </p:cNvPr>
          <p:cNvSpPr txBox="1"/>
          <p:nvPr/>
        </p:nvSpPr>
        <p:spPr>
          <a:xfrm>
            <a:off x="1863699"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3EB1A2A9-F142-481B-BE30-E891504FF6E6}"/>
              </a:ext>
            </a:extLst>
          </p:cNvPr>
          <p:cNvSpPr txBox="1"/>
          <p:nvPr/>
        </p:nvSpPr>
        <p:spPr>
          <a:xfrm>
            <a:off x="2366812"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3" name="TextBox 82">
            <a:extLst>
              <a:ext uri="{FF2B5EF4-FFF2-40B4-BE49-F238E27FC236}">
                <a16:creationId xmlns:a16="http://schemas.microsoft.com/office/drawing/2014/main" id="{8BD4B837-7EC9-4D46-B106-CAD6EAC86DA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84" name="TextBox 83">
            <a:extLst>
              <a:ext uri="{FF2B5EF4-FFF2-40B4-BE49-F238E27FC236}">
                <a16:creationId xmlns:a16="http://schemas.microsoft.com/office/drawing/2014/main" id="{E3215548-D849-49A7-9A83-98B26F95F25B}"/>
              </a:ext>
            </a:extLst>
          </p:cNvPr>
          <p:cNvSpPr txBox="1"/>
          <p:nvPr/>
        </p:nvSpPr>
        <p:spPr>
          <a:xfrm>
            <a:off x="337303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85" name="TextBox 84">
            <a:extLst>
              <a:ext uri="{FF2B5EF4-FFF2-40B4-BE49-F238E27FC236}">
                <a16:creationId xmlns:a16="http://schemas.microsoft.com/office/drawing/2014/main" id="{2F81B13E-D292-4D17-A9F6-5CA73777B940}"/>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86" name="TextBox 85">
            <a:extLst>
              <a:ext uri="{FF2B5EF4-FFF2-40B4-BE49-F238E27FC236}">
                <a16:creationId xmlns:a16="http://schemas.microsoft.com/office/drawing/2014/main" id="{2A5BE422-5CA5-4E45-A20A-A35C9E6E9B45}"/>
              </a:ext>
            </a:extLst>
          </p:cNvPr>
          <p:cNvSpPr txBox="1"/>
          <p:nvPr/>
        </p:nvSpPr>
        <p:spPr>
          <a:xfrm>
            <a:off x="437926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87" name="TextBox 86">
            <a:extLst>
              <a:ext uri="{FF2B5EF4-FFF2-40B4-BE49-F238E27FC236}">
                <a16:creationId xmlns:a16="http://schemas.microsoft.com/office/drawing/2014/main" id="{A408FB12-C23F-4899-AA5C-0C06257304A5}"/>
              </a:ext>
            </a:extLst>
          </p:cNvPr>
          <p:cNvSpPr txBox="1"/>
          <p:nvPr/>
        </p:nvSpPr>
        <p:spPr>
          <a:xfrm>
            <a:off x="4882377"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sp>
        <p:nvSpPr>
          <p:cNvPr id="88" name="TextBox 87">
            <a:extLst>
              <a:ext uri="{FF2B5EF4-FFF2-40B4-BE49-F238E27FC236}">
                <a16:creationId xmlns:a16="http://schemas.microsoft.com/office/drawing/2014/main" id="{E02AF79D-E5E8-4E83-9A47-DAA469C4CC81}"/>
              </a:ext>
            </a:extLst>
          </p:cNvPr>
          <p:cNvSpPr txBox="1"/>
          <p:nvPr/>
        </p:nvSpPr>
        <p:spPr>
          <a:xfrm>
            <a:off x="639171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8</a:t>
            </a:r>
          </a:p>
        </p:txBody>
      </p:sp>
      <p:sp>
        <p:nvSpPr>
          <p:cNvPr id="89" name="TextBox 88">
            <a:extLst>
              <a:ext uri="{FF2B5EF4-FFF2-40B4-BE49-F238E27FC236}">
                <a16:creationId xmlns:a16="http://schemas.microsoft.com/office/drawing/2014/main" id="{3A1C2354-CB97-4539-B2E6-1F48EB6681BC}"/>
              </a:ext>
            </a:extLst>
          </p:cNvPr>
          <p:cNvSpPr txBox="1"/>
          <p:nvPr/>
        </p:nvSpPr>
        <p:spPr>
          <a:xfrm>
            <a:off x="6894829"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C6BC3E5C-7AEC-478A-9C2F-4AE5B70715C9}"/>
              </a:ext>
            </a:extLst>
          </p:cNvPr>
          <p:cNvSpPr txBox="1"/>
          <p:nvPr/>
        </p:nvSpPr>
        <p:spPr>
          <a:xfrm>
            <a:off x="7333822"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0</a:t>
            </a:r>
          </a:p>
        </p:txBody>
      </p:sp>
      <p:sp>
        <p:nvSpPr>
          <p:cNvPr id="91" name="TextBox 90">
            <a:extLst>
              <a:ext uri="{FF2B5EF4-FFF2-40B4-BE49-F238E27FC236}">
                <a16:creationId xmlns:a16="http://schemas.microsoft.com/office/drawing/2014/main" id="{69AFBEEB-9DA9-47C8-870A-4BF72E457C16}"/>
              </a:ext>
            </a:extLst>
          </p:cNvPr>
          <p:cNvSpPr txBox="1"/>
          <p:nvPr/>
        </p:nvSpPr>
        <p:spPr>
          <a:xfrm>
            <a:off x="7845495" y="1954769"/>
            <a:ext cx="42402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1</a:t>
            </a:r>
          </a:p>
        </p:txBody>
      </p:sp>
      <p:sp>
        <p:nvSpPr>
          <p:cNvPr id="92" name="TextBox 91">
            <a:extLst>
              <a:ext uri="{FF2B5EF4-FFF2-40B4-BE49-F238E27FC236}">
                <a16:creationId xmlns:a16="http://schemas.microsoft.com/office/drawing/2014/main" id="{DCD63FD1-D848-4F9B-B53E-883996B4CB7A}"/>
              </a:ext>
            </a:extLst>
          </p:cNvPr>
          <p:cNvSpPr txBox="1"/>
          <p:nvPr/>
        </p:nvSpPr>
        <p:spPr>
          <a:xfrm>
            <a:off x="8340048"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2</a:t>
            </a:r>
          </a:p>
        </p:txBody>
      </p:sp>
      <p:sp>
        <p:nvSpPr>
          <p:cNvPr id="93" name="TextBox 92">
            <a:extLst>
              <a:ext uri="{FF2B5EF4-FFF2-40B4-BE49-F238E27FC236}">
                <a16:creationId xmlns:a16="http://schemas.microsoft.com/office/drawing/2014/main" id="{A46A09FC-8F6E-4351-9439-21C5B0E6C1FE}"/>
              </a:ext>
            </a:extLst>
          </p:cNvPr>
          <p:cNvSpPr txBox="1"/>
          <p:nvPr/>
        </p:nvSpPr>
        <p:spPr>
          <a:xfrm>
            <a:off x="8843161"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3</a:t>
            </a:r>
          </a:p>
        </p:txBody>
      </p:sp>
      <p:sp>
        <p:nvSpPr>
          <p:cNvPr id="94" name="TextBox 93">
            <a:extLst>
              <a:ext uri="{FF2B5EF4-FFF2-40B4-BE49-F238E27FC236}">
                <a16:creationId xmlns:a16="http://schemas.microsoft.com/office/drawing/2014/main" id="{45B413E9-B943-4FA7-8ED2-52FFF6A7BC3C}"/>
              </a:ext>
            </a:extLst>
          </p:cNvPr>
          <p:cNvSpPr txBox="1"/>
          <p:nvPr/>
        </p:nvSpPr>
        <p:spPr>
          <a:xfrm>
            <a:off x="9346274"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4</a:t>
            </a:r>
          </a:p>
        </p:txBody>
      </p:sp>
      <p:sp>
        <p:nvSpPr>
          <p:cNvPr id="95" name="TextBox 94">
            <a:extLst>
              <a:ext uri="{FF2B5EF4-FFF2-40B4-BE49-F238E27FC236}">
                <a16:creationId xmlns:a16="http://schemas.microsoft.com/office/drawing/2014/main" id="{88DD6E14-873E-4FC1-8D29-4684985DF959}"/>
              </a:ext>
            </a:extLst>
          </p:cNvPr>
          <p:cNvSpPr txBox="1"/>
          <p:nvPr/>
        </p:nvSpPr>
        <p:spPr>
          <a:xfrm>
            <a:off x="9849387"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5</a:t>
            </a:r>
          </a:p>
        </p:txBody>
      </p:sp>
      <p:sp>
        <p:nvSpPr>
          <p:cNvPr id="96" name="TextBox 95">
            <a:extLst>
              <a:ext uri="{FF2B5EF4-FFF2-40B4-BE49-F238E27FC236}">
                <a16:creationId xmlns:a16="http://schemas.microsoft.com/office/drawing/2014/main" id="{65B182B4-A532-4856-81B7-BEEE275F2508}"/>
              </a:ext>
            </a:extLst>
          </p:cNvPr>
          <p:cNvSpPr txBox="1"/>
          <p:nvPr/>
        </p:nvSpPr>
        <p:spPr>
          <a:xfrm>
            <a:off x="10352500"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6</a:t>
            </a:r>
          </a:p>
        </p:txBody>
      </p:sp>
      <p:sp>
        <p:nvSpPr>
          <p:cNvPr id="99" name="TextBox 98">
            <a:extLst>
              <a:ext uri="{FF2B5EF4-FFF2-40B4-BE49-F238E27FC236}">
                <a16:creationId xmlns:a16="http://schemas.microsoft.com/office/drawing/2014/main" id="{57A54BF0-E63B-4D90-8391-0278D839B39D}"/>
              </a:ext>
            </a:extLst>
          </p:cNvPr>
          <p:cNvSpPr txBox="1"/>
          <p:nvPr/>
        </p:nvSpPr>
        <p:spPr>
          <a:xfrm>
            <a:off x="5427696" y="3334430"/>
            <a:ext cx="736099" cy="646331"/>
          </a:xfrm>
          <a:prstGeom prst="rect">
            <a:avLst/>
          </a:prstGeom>
          <a:noFill/>
        </p:spPr>
        <p:txBody>
          <a:bodyPr wrap="none" rtlCol="0">
            <a:spAutoFit/>
          </a:bodyPr>
          <a:lstStyle/>
          <a:p>
            <a:pPr algn="ctr"/>
            <a:r>
              <a:rPr lang="en-US"/>
              <a:t>GAP</a:t>
            </a:r>
          </a:p>
          <a:p>
            <a:pPr algn="ctr"/>
            <a:r>
              <a:rPr lang="en-US"/>
              <a:t>2 sec</a:t>
            </a:r>
          </a:p>
        </p:txBody>
      </p:sp>
    </p:spTree>
    <p:extLst>
      <p:ext uri="{BB962C8B-B14F-4D97-AF65-F5344CB8AC3E}">
        <p14:creationId xmlns:p14="http://schemas.microsoft.com/office/powerpoint/2010/main" val="28453591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Total Duration: </a:t>
            </a:r>
            <a:r>
              <a:rPr lang="en-US" sz="3600"/>
              <a:t>The absolute length of time (“clock time”) from the start of the recording to the end of the recording. This includes any gaps</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9" name="Rectangle 38">
            <a:extLst>
              <a:ext uri="{FF2B5EF4-FFF2-40B4-BE49-F238E27FC236}">
                <a16:creationId xmlns:a16="http://schemas.microsoft.com/office/drawing/2014/main" id="{27D58888-A601-43D8-83DB-2A7A24D06105}"/>
              </a:ext>
            </a:extLst>
          </p:cNvPr>
          <p:cNvSpPr/>
          <p:nvPr/>
        </p:nvSpPr>
        <p:spPr>
          <a:xfrm>
            <a:off x="5288353"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0" name="Straight Connector 39">
            <a:extLst>
              <a:ext uri="{FF2B5EF4-FFF2-40B4-BE49-F238E27FC236}">
                <a16:creationId xmlns:a16="http://schemas.microsoft.com/office/drawing/2014/main" id="{B0C75C54-9777-4355-8ED0-3AE4B6C24E65}"/>
              </a:ext>
            </a:extLst>
          </p:cNvPr>
          <p:cNvCxnSpPr>
            <a:cxnSpLocks/>
          </p:cNvCxnSpPr>
          <p:nvPr/>
        </p:nvCxnSpPr>
        <p:spPr>
          <a:xfrm>
            <a:off x="151703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C09FC3A6-B612-4A0E-A9AF-AE55C01646C0}"/>
              </a:ext>
            </a:extLst>
          </p:cNvPr>
          <p:cNvCxnSpPr>
            <a:cxnSpLocks/>
          </p:cNvCxnSpPr>
          <p:nvPr/>
        </p:nvCxnSpPr>
        <p:spPr>
          <a:xfrm>
            <a:off x="2020152"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EE6AF921-BF94-4F45-9936-D9522C3D3BA0}"/>
              </a:ext>
            </a:extLst>
          </p:cNvPr>
          <p:cNvCxnSpPr>
            <a:cxnSpLocks/>
          </p:cNvCxnSpPr>
          <p:nvPr/>
        </p:nvCxnSpPr>
        <p:spPr>
          <a:xfrm>
            <a:off x="2523265"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07A3D001-4343-440F-BC09-7E755AEADA54}"/>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4215D8C-F389-47EB-B9CD-6386BFAD7F84}"/>
              </a:ext>
            </a:extLst>
          </p:cNvPr>
          <p:cNvCxnSpPr>
            <a:cxnSpLocks/>
          </p:cNvCxnSpPr>
          <p:nvPr/>
        </p:nvCxnSpPr>
        <p:spPr>
          <a:xfrm>
            <a:off x="352949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CEA95916-EA13-4C8E-9249-787B254E44A3}"/>
              </a:ext>
            </a:extLst>
          </p:cNvPr>
          <p:cNvCxnSpPr>
            <a:cxnSpLocks/>
          </p:cNvCxnSpPr>
          <p:nvPr/>
        </p:nvCxnSpPr>
        <p:spPr>
          <a:xfrm>
            <a:off x="403260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FF8104FF-B039-444B-941E-9D5A7ADE03D6}"/>
              </a:ext>
            </a:extLst>
          </p:cNvPr>
          <p:cNvCxnSpPr>
            <a:cxnSpLocks/>
          </p:cNvCxnSpPr>
          <p:nvPr/>
        </p:nvCxnSpPr>
        <p:spPr>
          <a:xfrm>
            <a:off x="4535717"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D5E5D010-18E1-4583-B741-EA7A7CBDAB0C}"/>
              </a:ext>
            </a:extLst>
          </p:cNvPr>
          <p:cNvCxnSpPr>
            <a:cxnSpLocks/>
          </p:cNvCxnSpPr>
          <p:nvPr/>
        </p:nvCxnSpPr>
        <p:spPr>
          <a:xfrm>
            <a:off x="503883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28FB31A9-BBFC-4E52-97CB-1ED0A23439F9}"/>
              </a:ext>
            </a:extLst>
          </p:cNvPr>
          <p:cNvCxnSpPr>
            <a:cxnSpLocks/>
          </p:cNvCxnSpPr>
          <p:nvPr/>
        </p:nvCxnSpPr>
        <p:spPr>
          <a:xfrm>
            <a:off x="5541943" y="2693433"/>
            <a:ext cx="0" cy="1928326"/>
          </a:xfrm>
          <a:prstGeom prst="line">
            <a:avLst/>
          </a:prstGeom>
          <a:ln w="1905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3500F1A-C26B-495A-8C89-6E3665DF2D08}"/>
              </a:ext>
            </a:extLst>
          </p:cNvPr>
          <p:cNvCxnSpPr>
            <a:cxnSpLocks/>
          </p:cNvCxnSpPr>
          <p:nvPr/>
        </p:nvCxnSpPr>
        <p:spPr>
          <a:xfrm>
            <a:off x="6045056" y="2693433"/>
            <a:ext cx="0" cy="1928326"/>
          </a:xfrm>
          <a:prstGeom prst="line">
            <a:avLst/>
          </a:prstGeom>
          <a:ln w="1905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1B4BD474-CA63-446C-8B42-6087BB84047C}"/>
              </a:ext>
            </a:extLst>
          </p:cNvPr>
          <p:cNvCxnSpPr>
            <a:cxnSpLocks/>
          </p:cNvCxnSpPr>
          <p:nvPr/>
        </p:nvCxnSpPr>
        <p:spPr>
          <a:xfrm>
            <a:off x="654816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68877F21-0715-4C2C-BD86-5FF8D6383C20}"/>
              </a:ext>
            </a:extLst>
          </p:cNvPr>
          <p:cNvCxnSpPr>
            <a:cxnSpLocks/>
          </p:cNvCxnSpPr>
          <p:nvPr/>
        </p:nvCxnSpPr>
        <p:spPr>
          <a:xfrm>
            <a:off x="7051282"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a16="http://schemas.microsoft.com/office/drawing/2014/main" id="{446F511D-2EE9-4CF1-B470-231B51AECD7A}"/>
              </a:ext>
            </a:extLst>
          </p:cNvPr>
          <p:cNvCxnSpPr>
            <a:cxnSpLocks/>
          </p:cNvCxnSpPr>
          <p:nvPr/>
        </p:nvCxnSpPr>
        <p:spPr>
          <a:xfrm>
            <a:off x="7554395"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1CCEBE3F-5D3F-4DE3-95CA-2B40DB4D4D47}"/>
              </a:ext>
            </a:extLst>
          </p:cNvPr>
          <p:cNvCxnSpPr>
            <a:cxnSpLocks/>
          </p:cNvCxnSpPr>
          <p:nvPr/>
        </p:nvCxnSpPr>
        <p:spPr>
          <a:xfrm>
            <a:off x="805750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3D182075-E6E1-4F41-8FEC-0D54A8C76EA3}"/>
              </a:ext>
            </a:extLst>
          </p:cNvPr>
          <p:cNvCxnSpPr>
            <a:cxnSpLocks/>
          </p:cNvCxnSpPr>
          <p:nvPr/>
        </p:nvCxnSpPr>
        <p:spPr>
          <a:xfrm>
            <a:off x="856062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FBCEDD3B-FD2C-4D58-BCD0-4BEA878C17AE}"/>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9E5FBB96-7F3B-46A5-9A11-F2F32AB146E8}"/>
              </a:ext>
            </a:extLst>
          </p:cNvPr>
          <p:cNvCxnSpPr>
            <a:cxnSpLocks/>
          </p:cNvCxnSpPr>
          <p:nvPr/>
        </p:nvCxnSpPr>
        <p:spPr>
          <a:xfrm>
            <a:off x="9566847"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2371B90C-54E3-4226-B6E2-0E4170CE025D}"/>
              </a:ext>
            </a:extLst>
          </p:cNvPr>
          <p:cNvCxnSpPr>
            <a:cxnSpLocks/>
          </p:cNvCxnSpPr>
          <p:nvPr/>
        </p:nvCxnSpPr>
        <p:spPr>
          <a:xfrm>
            <a:off x="1006996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BFB0E42A-B467-43CF-BE2A-23BB4F099047}"/>
              </a:ext>
            </a:extLst>
          </p:cNvPr>
          <p:cNvCxnSpPr>
            <a:cxnSpLocks/>
          </p:cNvCxnSpPr>
          <p:nvPr/>
        </p:nvCxnSpPr>
        <p:spPr>
          <a:xfrm>
            <a:off x="10573073"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TextBox 60">
            <a:extLst>
              <a:ext uri="{FF2B5EF4-FFF2-40B4-BE49-F238E27FC236}">
                <a16:creationId xmlns:a16="http://schemas.microsoft.com/office/drawing/2014/main" id="{E1FD9494-E437-48FB-88EE-289A911AB776}"/>
              </a:ext>
            </a:extLst>
          </p:cNvPr>
          <p:cNvSpPr txBox="1"/>
          <p:nvPr/>
        </p:nvSpPr>
        <p:spPr>
          <a:xfrm>
            <a:off x="1360586"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a:t>
            </a:r>
          </a:p>
        </p:txBody>
      </p:sp>
      <p:sp>
        <p:nvSpPr>
          <p:cNvPr id="62" name="TextBox 61">
            <a:extLst>
              <a:ext uri="{FF2B5EF4-FFF2-40B4-BE49-F238E27FC236}">
                <a16:creationId xmlns:a16="http://schemas.microsoft.com/office/drawing/2014/main" id="{CF1DC525-A6C0-4390-AED8-CE86A5F0B56D}"/>
              </a:ext>
            </a:extLst>
          </p:cNvPr>
          <p:cNvSpPr txBox="1"/>
          <p:nvPr/>
        </p:nvSpPr>
        <p:spPr>
          <a:xfrm>
            <a:off x="1863699"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a:t>
            </a:r>
          </a:p>
        </p:txBody>
      </p:sp>
      <p:sp>
        <p:nvSpPr>
          <p:cNvPr id="63" name="TextBox 62">
            <a:extLst>
              <a:ext uri="{FF2B5EF4-FFF2-40B4-BE49-F238E27FC236}">
                <a16:creationId xmlns:a16="http://schemas.microsoft.com/office/drawing/2014/main" id="{F4BCD483-BFD5-4012-9496-1651EB9CA4FF}"/>
              </a:ext>
            </a:extLst>
          </p:cNvPr>
          <p:cNvSpPr txBox="1"/>
          <p:nvPr/>
        </p:nvSpPr>
        <p:spPr>
          <a:xfrm>
            <a:off x="2366812"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3</a:t>
            </a:r>
          </a:p>
        </p:txBody>
      </p:sp>
      <p:sp>
        <p:nvSpPr>
          <p:cNvPr id="64" name="TextBox 63">
            <a:extLst>
              <a:ext uri="{FF2B5EF4-FFF2-40B4-BE49-F238E27FC236}">
                <a16:creationId xmlns:a16="http://schemas.microsoft.com/office/drawing/2014/main" id="{CAD81215-1598-44A5-BCB5-6E1329FC06CB}"/>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5" name="TextBox 64">
            <a:extLst>
              <a:ext uri="{FF2B5EF4-FFF2-40B4-BE49-F238E27FC236}">
                <a16:creationId xmlns:a16="http://schemas.microsoft.com/office/drawing/2014/main" id="{D2FFD943-EDDD-401B-9C3B-E66DC286ECA5}"/>
              </a:ext>
            </a:extLst>
          </p:cNvPr>
          <p:cNvSpPr txBox="1"/>
          <p:nvPr/>
        </p:nvSpPr>
        <p:spPr>
          <a:xfrm>
            <a:off x="3373038"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a:t>
            </a:r>
          </a:p>
        </p:txBody>
      </p:sp>
      <p:sp>
        <p:nvSpPr>
          <p:cNvPr id="66" name="TextBox 65">
            <a:extLst>
              <a:ext uri="{FF2B5EF4-FFF2-40B4-BE49-F238E27FC236}">
                <a16:creationId xmlns:a16="http://schemas.microsoft.com/office/drawing/2014/main" id="{304D18D9-1489-4BED-B9FB-54641824AD45}"/>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19C21360-5531-40AF-90D8-EA1E050B1624}"/>
              </a:ext>
            </a:extLst>
          </p:cNvPr>
          <p:cNvSpPr txBox="1"/>
          <p:nvPr/>
        </p:nvSpPr>
        <p:spPr>
          <a:xfrm>
            <a:off x="4379264"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7</a:t>
            </a:r>
          </a:p>
        </p:txBody>
      </p:sp>
      <p:sp>
        <p:nvSpPr>
          <p:cNvPr id="68" name="TextBox 67">
            <a:extLst>
              <a:ext uri="{FF2B5EF4-FFF2-40B4-BE49-F238E27FC236}">
                <a16:creationId xmlns:a16="http://schemas.microsoft.com/office/drawing/2014/main" id="{C9FF9BF8-2DBF-49BB-BB74-CBBEB5494177}"/>
              </a:ext>
            </a:extLst>
          </p:cNvPr>
          <p:cNvSpPr txBox="1"/>
          <p:nvPr/>
        </p:nvSpPr>
        <p:spPr>
          <a:xfrm>
            <a:off x="488237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8</a:t>
            </a:r>
          </a:p>
        </p:txBody>
      </p:sp>
      <p:sp>
        <p:nvSpPr>
          <p:cNvPr id="69" name="TextBox 68">
            <a:extLst>
              <a:ext uri="{FF2B5EF4-FFF2-40B4-BE49-F238E27FC236}">
                <a16:creationId xmlns:a16="http://schemas.microsoft.com/office/drawing/2014/main" id="{3DD35A0C-FB95-451D-9210-529BB8553657}"/>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70" name="TextBox 69">
            <a:extLst>
              <a:ext uri="{FF2B5EF4-FFF2-40B4-BE49-F238E27FC236}">
                <a16:creationId xmlns:a16="http://schemas.microsoft.com/office/drawing/2014/main" id="{794E1B52-0F46-4FB3-8B7F-EB53C8327154}"/>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71" name="TextBox 70">
            <a:extLst>
              <a:ext uri="{FF2B5EF4-FFF2-40B4-BE49-F238E27FC236}">
                <a16:creationId xmlns:a16="http://schemas.microsoft.com/office/drawing/2014/main" id="{130AA605-2900-4295-9FAA-F73DDF45F6CF}"/>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72" name="TextBox 71">
            <a:extLst>
              <a:ext uri="{FF2B5EF4-FFF2-40B4-BE49-F238E27FC236}">
                <a16:creationId xmlns:a16="http://schemas.microsoft.com/office/drawing/2014/main" id="{CD6429D6-BBB2-4B38-8293-0480D579936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73" name="TextBox 72">
            <a:extLst>
              <a:ext uri="{FF2B5EF4-FFF2-40B4-BE49-F238E27FC236}">
                <a16:creationId xmlns:a16="http://schemas.microsoft.com/office/drawing/2014/main" id="{382734AC-1615-4858-818A-F8BE53B6C96D}"/>
              </a:ext>
            </a:extLst>
          </p:cNvPr>
          <p:cNvSpPr txBox="1"/>
          <p:nvPr/>
        </p:nvSpPr>
        <p:spPr>
          <a:xfrm>
            <a:off x="7333822"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3</a:t>
            </a:r>
          </a:p>
        </p:txBody>
      </p:sp>
      <p:sp>
        <p:nvSpPr>
          <p:cNvPr id="74" name="TextBox 73">
            <a:extLst>
              <a:ext uri="{FF2B5EF4-FFF2-40B4-BE49-F238E27FC236}">
                <a16:creationId xmlns:a16="http://schemas.microsoft.com/office/drawing/2014/main" id="{11AADA4F-09DC-4B0C-B8CE-8E626421B549}"/>
              </a:ext>
            </a:extLst>
          </p:cNvPr>
          <p:cNvSpPr txBox="1"/>
          <p:nvPr/>
        </p:nvSpPr>
        <p:spPr>
          <a:xfrm>
            <a:off x="7836935"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4</a:t>
            </a:r>
          </a:p>
        </p:txBody>
      </p:sp>
      <p:sp>
        <p:nvSpPr>
          <p:cNvPr id="75" name="TextBox 74">
            <a:extLst>
              <a:ext uri="{FF2B5EF4-FFF2-40B4-BE49-F238E27FC236}">
                <a16:creationId xmlns:a16="http://schemas.microsoft.com/office/drawing/2014/main" id="{F15B31C9-CBD7-4EE4-9CFD-DB390763665D}"/>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76" name="TextBox 75">
            <a:extLst>
              <a:ext uri="{FF2B5EF4-FFF2-40B4-BE49-F238E27FC236}">
                <a16:creationId xmlns:a16="http://schemas.microsoft.com/office/drawing/2014/main" id="{A41973E2-05AF-4384-A490-018477B607D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77" name="TextBox 76">
            <a:extLst>
              <a:ext uri="{FF2B5EF4-FFF2-40B4-BE49-F238E27FC236}">
                <a16:creationId xmlns:a16="http://schemas.microsoft.com/office/drawing/2014/main" id="{5D11163C-B992-4353-9F3D-BB5DFBCE4FB1}"/>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78" name="TextBox 77">
            <a:extLst>
              <a:ext uri="{FF2B5EF4-FFF2-40B4-BE49-F238E27FC236}">
                <a16:creationId xmlns:a16="http://schemas.microsoft.com/office/drawing/2014/main" id="{B8CF1FF0-79B3-483F-9320-EF64775CB397}"/>
              </a:ext>
            </a:extLst>
          </p:cNvPr>
          <p:cNvSpPr txBox="1"/>
          <p:nvPr/>
        </p:nvSpPr>
        <p:spPr>
          <a:xfrm>
            <a:off x="9849387"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8</a:t>
            </a:r>
          </a:p>
        </p:txBody>
      </p:sp>
      <p:sp>
        <p:nvSpPr>
          <p:cNvPr id="79" name="TextBox 78">
            <a:extLst>
              <a:ext uri="{FF2B5EF4-FFF2-40B4-BE49-F238E27FC236}">
                <a16:creationId xmlns:a16="http://schemas.microsoft.com/office/drawing/2014/main" id="{799A331B-6EBE-4CC3-A16F-0B092870A7C6}"/>
              </a:ext>
            </a:extLst>
          </p:cNvPr>
          <p:cNvSpPr txBox="1"/>
          <p:nvPr/>
        </p:nvSpPr>
        <p:spPr>
          <a:xfrm>
            <a:off x="10352500"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9</a:t>
            </a:r>
          </a:p>
        </p:txBody>
      </p:sp>
      <p:sp>
        <p:nvSpPr>
          <p:cNvPr id="80" name="TextBox 79">
            <a:extLst>
              <a:ext uri="{FF2B5EF4-FFF2-40B4-BE49-F238E27FC236}">
                <a16:creationId xmlns:a16="http://schemas.microsoft.com/office/drawing/2014/main" id="{A2F037F8-2EB4-473A-9038-4B493E305455}"/>
              </a:ext>
            </a:extLst>
          </p:cNvPr>
          <p:cNvSpPr txBox="1"/>
          <p:nvPr/>
        </p:nvSpPr>
        <p:spPr>
          <a:xfrm>
            <a:off x="136058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77C95FF9-757E-4031-A501-4E78FD91A8E8}"/>
              </a:ext>
            </a:extLst>
          </p:cNvPr>
          <p:cNvSpPr txBox="1"/>
          <p:nvPr/>
        </p:nvSpPr>
        <p:spPr>
          <a:xfrm>
            <a:off x="1863699"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3EB1A2A9-F142-481B-BE30-E891504FF6E6}"/>
              </a:ext>
            </a:extLst>
          </p:cNvPr>
          <p:cNvSpPr txBox="1"/>
          <p:nvPr/>
        </p:nvSpPr>
        <p:spPr>
          <a:xfrm>
            <a:off x="2366812"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3" name="TextBox 82">
            <a:extLst>
              <a:ext uri="{FF2B5EF4-FFF2-40B4-BE49-F238E27FC236}">
                <a16:creationId xmlns:a16="http://schemas.microsoft.com/office/drawing/2014/main" id="{8BD4B837-7EC9-4D46-B106-CAD6EAC86DA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84" name="TextBox 83">
            <a:extLst>
              <a:ext uri="{FF2B5EF4-FFF2-40B4-BE49-F238E27FC236}">
                <a16:creationId xmlns:a16="http://schemas.microsoft.com/office/drawing/2014/main" id="{E3215548-D849-49A7-9A83-98B26F95F25B}"/>
              </a:ext>
            </a:extLst>
          </p:cNvPr>
          <p:cNvSpPr txBox="1"/>
          <p:nvPr/>
        </p:nvSpPr>
        <p:spPr>
          <a:xfrm>
            <a:off x="337303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85" name="TextBox 84">
            <a:extLst>
              <a:ext uri="{FF2B5EF4-FFF2-40B4-BE49-F238E27FC236}">
                <a16:creationId xmlns:a16="http://schemas.microsoft.com/office/drawing/2014/main" id="{2F81B13E-D292-4D17-A9F6-5CA73777B940}"/>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86" name="TextBox 85">
            <a:extLst>
              <a:ext uri="{FF2B5EF4-FFF2-40B4-BE49-F238E27FC236}">
                <a16:creationId xmlns:a16="http://schemas.microsoft.com/office/drawing/2014/main" id="{2A5BE422-5CA5-4E45-A20A-A35C9E6E9B45}"/>
              </a:ext>
            </a:extLst>
          </p:cNvPr>
          <p:cNvSpPr txBox="1"/>
          <p:nvPr/>
        </p:nvSpPr>
        <p:spPr>
          <a:xfrm>
            <a:off x="437926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87" name="TextBox 86">
            <a:extLst>
              <a:ext uri="{FF2B5EF4-FFF2-40B4-BE49-F238E27FC236}">
                <a16:creationId xmlns:a16="http://schemas.microsoft.com/office/drawing/2014/main" id="{A408FB12-C23F-4899-AA5C-0C06257304A5}"/>
              </a:ext>
            </a:extLst>
          </p:cNvPr>
          <p:cNvSpPr txBox="1"/>
          <p:nvPr/>
        </p:nvSpPr>
        <p:spPr>
          <a:xfrm>
            <a:off x="4882377"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sp>
        <p:nvSpPr>
          <p:cNvPr id="88" name="TextBox 87">
            <a:extLst>
              <a:ext uri="{FF2B5EF4-FFF2-40B4-BE49-F238E27FC236}">
                <a16:creationId xmlns:a16="http://schemas.microsoft.com/office/drawing/2014/main" id="{E02AF79D-E5E8-4E83-9A47-DAA469C4CC81}"/>
              </a:ext>
            </a:extLst>
          </p:cNvPr>
          <p:cNvSpPr txBox="1"/>
          <p:nvPr/>
        </p:nvSpPr>
        <p:spPr>
          <a:xfrm>
            <a:off x="639171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8</a:t>
            </a:r>
          </a:p>
        </p:txBody>
      </p:sp>
      <p:sp>
        <p:nvSpPr>
          <p:cNvPr id="89" name="TextBox 88">
            <a:extLst>
              <a:ext uri="{FF2B5EF4-FFF2-40B4-BE49-F238E27FC236}">
                <a16:creationId xmlns:a16="http://schemas.microsoft.com/office/drawing/2014/main" id="{3A1C2354-CB97-4539-B2E6-1F48EB6681BC}"/>
              </a:ext>
            </a:extLst>
          </p:cNvPr>
          <p:cNvSpPr txBox="1"/>
          <p:nvPr/>
        </p:nvSpPr>
        <p:spPr>
          <a:xfrm>
            <a:off x="6894829"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C6BC3E5C-7AEC-478A-9C2F-4AE5B70715C9}"/>
              </a:ext>
            </a:extLst>
          </p:cNvPr>
          <p:cNvSpPr txBox="1"/>
          <p:nvPr/>
        </p:nvSpPr>
        <p:spPr>
          <a:xfrm>
            <a:off x="7333822"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0</a:t>
            </a:r>
          </a:p>
        </p:txBody>
      </p:sp>
      <p:sp>
        <p:nvSpPr>
          <p:cNvPr id="91" name="TextBox 90">
            <a:extLst>
              <a:ext uri="{FF2B5EF4-FFF2-40B4-BE49-F238E27FC236}">
                <a16:creationId xmlns:a16="http://schemas.microsoft.com/office/drawing/2014/main" id="{69AFBEEB-9DA9-47C8-870A-4BF72E457C16}"/>
              </a:ext>
            </a:extLst>
          </p:cNvPr>
          <p:cNvSpPr txBox="1"/>
          <p:nvPr/>
        </p:nvSpPr>
        <p:spPr>
          <a:xfrm>
            <a:off x="7845495" y="1954769"/>
            <a:ext cx="42402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1</a:t>
            </a:r>
          </a:p>
        </p:txBody>
      </p:sp>
      <p:sp>
        <p:nvSpPr>
          <p:cNvPr id="92" name="TextBox 91">
            <a:extLst>
              <a:ext uri="{FF2B5EF4-FFF2-40B4-BE49-F238E27FC236}">
                <a16:creationId xmlns:a16="http://schemas.microsoft.com/office/drawing/2014/main" id="{DCD63FD1-D848-4F9B-B53E-883996B4CB7A}"/>
              </a:ext>
            </a:extLst>
          </p:cNvPr>
          <p:cNvSpPr txBox="1"/>
          <p:nvPr/>
        </p:nvSpPr>
        <p:spPr>
          <a:xfrm>
            <a:off x="8340048"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2</a:t>
            </a:r>
          </a:p>
        </p:txBody>
      </p:sp>
      <p:sp>
        <p:nvSpPr>
          <p:cNvPr id="93" name="TextBox 92">
            <a:extLst>
              <a:ext uri="{FF2B5EF4-FFF2-40B4-BE49-F238E27FC236}">
                <a16:creationId xmlns:a16="http://schemas.microsoft.com/office/drawing/2014/main" id="{A46A09FC-8F6E-4351-9439-21C5B0E6C1FE}"/>
              </a:ext>
            </a:extLst>
          </p:cNvPr>
          <p:cNvSpPr txBox="1"/>
          <p:nvPr/>
        </p:nvSpPr>
        <p:spPr>
          <a:xfrm>
            <a:off x="8843161"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3</a:t>
            </a:r>
          </a:p>
        </p:txBody>
      </p:sp>
      <p:sp>
        <p:nvSpPr>
          <p:cNvPr id="94" name="TextBox 93">
            <a:extLst>
              <a:ext uri="{FF2B5EF4-FFF2-40B4-BE49-F238E27FC236}">
                <a16:creationId xmlns:a16="http://schemas.microsoft.com/office/drawing/2014/main" id="{45B413E9-B943-4FA7-8ED2-52FFF6A7BC3C}"/>
              </a:ext>
            </a:extLst>
          </p:cNvPr>
          <p:cNvSpPr txBox="1"/>
          <p:nvPr/>
        </p:nvSpPr>
        <p:spPr>
          <a:xfrm>
            <a:off x="9346274"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4</a:t>
            </a:r>
          </a:p>
        </p:txBody>
      </p:sp>
      <p:sp>
        <p:nvSpPr>
          <p:cNvPr id="95" name="TextBox 94">
            <a:extLst>
              <a:ext uri="{FF2B5EF4-FFF2-40B4-BE49-F238E27FC236}">
                <a16:creationId xmlns:a16="http://schemas.microsoft.com/office/drawing/2014/main" id="{88DD6E14-873E-4FC1-8D29-4684985DF959}"/>
              </a:ext>
            </a:extLst>
          </p:cNvPr>
          <p:cNvSpPr txBox="1"/>
          <p:nvPr/>
        </p:nvSpPr>
        <p:spPr>
          <a:xfrm>
            <a:off x="9849387"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5</a:t>
            </a:r>
          </a:p>
        </p:txBody>
      </p:sp>
      <p:sp>
        <p:nvSpPr>
          <p:cNvPr id="96" name="TextBox 95">
            <a:extLst>
              <a:ext uri="{FF2B5EF4-FFF2-40B4-BE49-F238E27FC236}">
                <a16:creationId xmlns:a16="http://schemas.microsoft.com/office/drawing/2014/main" id="{65B182B4-A532-4856-81B7-BEEE275F2508}"/>
              </a:ext>
            </a:extLst>
          </p:cNvPr>
          <p:cNvSpPr txBox="1"/>
          <p:nvPr/>
        </p:nvSpPr>
        <p:spPr>
          <a:xfrm>
            <a:off x="10352500"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6</a:t>
            </a:r>
          </a:p>
        </p:txBody>
      </p:sp>
      <p:sp>
        <p:nvSpPr>
          <p:cNvPr id="99" name="TextBox 98">
            <a:extLst>
              <a:ext uri="{FF2B5EF4-FFF2-40B4-BE49-F238E27FC236}">
                <a16:creationId xmlns:a16="http://schemas.microsoft.com/office/drawing/2014/main" id="{57A54BF0-E63B-4D90-8391-0278D839B39D}"/>
              </a:ext>
            </a:extLst>
          </p:cNvPr>
          <p:cNvSpPr txBox="1"/>
          <p:nvPr/>
        </p:nvSpPr>
        <p:spPr>
          <a:xfrm>
            <a:off x="5427696" y="3334430"/>
            <a:ext cx="736099" cy="646331"/>
          </a:xfrm>
          <a:prstGeom prst="rect">
            <a:avLst/>
          </a:prstGeom>
          <a:noFill/>
        </p:spPr>
        <p:txBody>
          <a:bodyPr wrap="none" rtlCol="0">
            <a:spAutoFit/>
          </a:bodyPr>
          <a:lstStyle/>
          <a:p>
            <a:pPr algn="ctr"/>
            <a:r>
              <a:rPr lang="en-US"/>
              <a:t>GAP</a:t>
            </a:r>
          </a:p>
          <a:p>
            <a:pPr algn="ctr"/>
            <a:r>
              <a:rPr lang="en-US"/>
              <a:t>2 sec</a:t>
            </a:r>
          </a:p>
        </p:txBody>
      </p:sp>
      <p:sp>
        <p:nvSpPr>
          <p:cNvPr id="97" name="TextBox 96">
            <a:extLst>
              <a:ext uri="{FF2B5EF4-FFF2-40B4-BE49-F238E27FC236}">
                <a16:creationId xmlns:a16="http://schemas.microsoft.com/office/drawing/2014/main" id="{CEFFC746-337A-4770-A155-BC72A2353F84}"/>
              </a:ext>
            </a:extLst>
          </p:cNvPr>
          <p:cNvSpPr txBox="1"/>
          <p:nvPr/>
        </p:nvSpPr>
        <p:spPr>
          <a:xfrm>
            <a:off x="4391856" y="5941508"/>
            <a:ext cx="3408305" cy="584775"/>
          </a:xfrm>
          <a:prstGeom prst="rect">
            <a:avLst/>
          </a:prstGeom>
          <a:noFill/>
        </p:spPr>
        <p:txBody>
          <a:bodyPr wrap="none" rtlCol="0">
            <a:spAutoFit/>
          </a:bodyPr>
          <a:lstStyle/>
          <a:p>
            <a:pPr algn="ctr"/>
            <a:r>
              <a:rPr lang="en-US" sz="3200">
                <a:solidFill>
                  <a:schemeClr val="accent1"/>
                </a:solidFill>
              </a:rPr>
              <a:t>Duration = 20 sec</a:t>
            </a:r>
          </a:p>
        </p:txBody>
      </p:sp>
    </p:spTree>
    <p:extLst>
      <p:ext uri="{BB962C8B-B14F-4D97-AF65-F5344CB8AC3E}">
        <p14:creationId xmlns:p14="http://schemas.microsoft.com/office/powerpoint/2010/main" val="127162325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Recording Duration: </a:t>
            </a:r>
            <a:r>
              <a:rPr lang="en-US" sz="3600"/>
              <a:t>The length of time during which data collection/recording occurred. This is the total duration minus any gaps.</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9" name="Rectangle 38">
            <a:extLst>
              <a:ext uri="{FF2B5EF4-FFF2-40B4-BE49-F238E27FC236}">
                <a16:creationId xmlns:a16="http://schemas.microsoft.com/office/drawing/2014/main" id="{27D58888-A601-43D8-83DB-2A7A24D06105}"/>
              </a:ext>
            </a:extLst>
          </p:cNvPr>
          <p:cNvSpPr/>
          <p:nvPr/>
        </p:nvSpPr>
        <p:spPr>
          <a:xfrm>
            <a:off x="5288353"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0" name="Straight Connector 39">
            <a:extLst>
              <a:ext uri="{FF2B5EF4-FFF2-40B4-BE49-F238E27FC236}">
                <a16:creationId xmlns:a16="http://schemas.microsoft.com/office/drawing/2014/main" id="{B0C75C54-9777-4355-8ED0-3AE4B6C24E65}"/>
              </a:ext>
            </a:extLst>
          </p:cNvPr>
          <p:cNvCxnSpPr>
            <a:cxnSpLocks/>
          </p:cNvCxnSpPr>
          <p:nvPr/>
        </p:nvCxnSpPr>
        <p:spPr>
          <a:xfrm>
            <a:off x="151703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C09FC3A6-B612-4A0E-A9AF-AE55C01646C0}"/>
              </a:ext>
            </a:extLst>
          </p:cNvPr>
          <p:cNvCxnSpPr>
            <a:cxnSpLocks/>
          </p:cNvCxnSpPr>
          <p:nvPr/>
        </p:nvCxnSpPr>
        <p:spPr>
          <a:xfrm>
            <a:off x="2020152"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EE6AF921-BF94-4F45-9936-D9522C3D3BA0}"/>
              </a:ext>
            </a:extLst>
          </p:cNvPr>
          <p:cNvCxnSpPr>
            <a:cxnSpLocks/>
          </p:cNvCxnSpPr>
          <p:nvPr/>
        </p:nvCxnSpPr>
        <p:spPr>
          <a:xfrm>
            <a:off x="2523265"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07A3D001-4343-440F-BC09-7E755AEADA54}"/>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4215D8C-F389-47EB-B9CD-6386BFAD7F84}"/>
              </a:ext>
            </a:extLst>
          </p:cNvPr>
          <p:cNvCxnSpPr>
            <a:cxnSpLocks/>
          </p:cNvCxnSpPr>
          <p:nvPr/>
        </p:nvCxnSpPr>
        <p:spPr>
          <a:xfrm>
            <a:off x="352949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CEA95916-EA13-4C8E-9249-787B254E44A3}"/>
              </a:ext>
            </a:extLst>
          </p:cNvPr>
          <p:cNvCxnSpPr>
            <a:cxnSpLocks/>
          </p:cNvCxnSpPr>
          <p:nvPr/>
        </p:nvCxnSpPr>
        <p:spPr>
          <a:xfrm>
            <a:off x="403260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FF8104FF-B039-444B-941E-9D5A7ADE03D6}"/>
              </a:ext>
            </a:extLst>
          </p:cNvPr>
          <p:cNvCxnSpPr>
            <a:cxnSpLocks/>
          </p:cNvCxnSpPr>
          <p:nvPr/>
        </p:nvCxnSpPr>
        <p:spPr>
          <a:xfrm>
            <a:off x="4535717"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D5E5D010-18E1-4583-B741-EA7A7CBDAB0C}"/>
              </a:ext>
            </a:extLst>
          </p:cNvPr>
          <p:cNvCxnSpPr>
            <a:cxnSpLocks/>
          </p:cNvCxnSpPr>
          <p:nvPr/>
        </p:nvCxnSpPr>
        <p:spPr>
          <a:xfrm>
            <a:off x="503883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28FB31A9-BBFC-4E52-97CB-1ED0A23439F9}"/>
              </a:ext>
            </a:extLst>
          </p:cNvPr>
          <p:cNvCxnSpPr>
            <a:cxnSpLocks/>
          </p:cNvCxnSpPr>
          <p:nvPr/>
        </p:nvCxnSpPr>
        <p:spPr>
          <a:xfrm>
            <a:off x="5541943" y="2693433"/>
            <a:ext cx="0" cy="1928326"/>
          </a:xfrm>
          <a:prstGeom prst="line">
            <a:avLst/>
          </a:prstGeom>
          <a:ln w="1905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3500F1A-C26B-495A-8C89-6E3665DF2D08}"/>
              </a:ext>
            </a:extLst>
          </p:cNvPr>
          <p:cNvCxnSpPr>
            <a:cxnSpLocks/>
          </p:cNvCxnSpPr>
          <p:nvPr/>
        </p:nvCxnSpPr>
        <p:spPr>
          <a:xfrm>
            <a:off x="6045056" y="2693433"/>
            <a:ext cx="0" cy="1928326"/>
          </a:xfrm>
          <a:prstGeom prst="line">
            <a:avLst/>
          </a:prstGeom>
          <a:ln w="19050">
            <a:solidFill>
              <a:schemeClr val="bg2">
                <a:lumMod val="90000"/>
              </a:schemeClr>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1B4BD474-CA63-446C-8B42-6087BB84047C}"/>
              </a:ext>
            </a:extLst>
          </p:cNvPr>
          <p:cNvCxnSpPr>
            <a:cxnSpLocks/>
          </p:cNvCxnSpPr>
          <p:nvPr/>
        </p:nvCxnSpPr>
        <p:spPr>
          <a:xfrm>
            <a:off x="654816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68877F21-0715-4C2C-BD86-5FF8D6383C20}"/>
              </a:ext>
            </a:extLst>
          </p:cNvPr>
          <p:cNvCxnSpPr>
            <a:cxnSpLocks/>
          </p:cNvCxnSpPr>
          <p:nvPr/>
        </p:nvCxnSpPr>
        <p:spPr>
          <a:xfrm>
            <a:off x="7051282"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a16="http://schemas.microsoft.com/office/drawing/2014/main" id="{446F511D-2EE9-4CF1-B470-231B51AECD7A}"/>
              </a:ext>
            </a:extLst>
          </p:cNvPr>
          <p:cNvCxnSpPr>
            <a:cxnSpLocks/>
          </p:cNvCxnSpPr>
          <p:nvPr/>
        </p:nvCxnSpPr>
        <p:spPr>
          <a:xfrm>
            <a:off x="7554395"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1CCEBE3F-5D3F-4DE3-95CA-2B40DB4D4D47}"/>
              </a:ext>
            </a:extLst>
          </p:cNvPr>
          <p:cNvCxnSpPr>
            <a:cxnSpLocks/>
          </p:cNvCxnSpPr>
          <p:nvPr/>
        </p:nvCxnSpPr>
        <p:spPr>
          <a:xfrm>
            <a:off x="805750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3D182075-E6E1-4F41-8FEC-0D54A8C76EA3}"/>
              </a:ext>
            </a:extLst>
          </p:cNvPr>
          <p:cNvCxnSpPr>
            <a:cxnSpLocks/>
          </p:cNvCxnSpPr>
          <p:nvPr/>
        </p:nvCxnSpPr>
        <p:spPr>
          <a:xfrm>
            <a:off x="856062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FBCEDD3B-FD2C-4D58-BCD0-4BEA878C17AE}"/>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9E5FBB96-7F3B-46A5-9A11-F2F32AB146E8}"/>
              </a:ext>
            </a:extLst>
          </p:cNvPr>
          <p:cNvCxnSpPr>
            <a:cxnSpLocks/>
          </p:cNvCxnSpPr>
          <p:nvPr/>
        </p:nvCxnSpPr>
        <p:spPr>
          <a:xfrm>
            <a:off x="9566847"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2371B90C-54E3-4226-B6E2-0E4170CE025D}"/>
              </a:ext>
            </a:extLst>
          </p:cNvPr>
          <p:cNvCxnSpPr>
            <a:cxnSpLocks/>
          </p:cNvCxnSpPr>
          <p:nvPr/>
        </p:nvCxnSpPr>
        <p:spPr>
          <a:xfrm>
            <a:off x="1006996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BFB0E42A-B467-43CF-BE2A-23BB4F099047}"/>
              </a:ext>
            </a:extLst>
          </p:cNvPr>
          <p:cNvCxnSpPr>
            <a:cxnSpLocks/>
          </p:cNvCxnSpPr>
          <p:nvPr/>
        </p:nvCxnSpPr>
        <p:spPr>
          <a:xfrm>
            <a:off x="10573073"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TextBox 60">
            <a:extLst>
              <a:ext uri="{FF2B5EF4-FFF2-40B4-BE49-F238E27FC236}">
                <a16:creationId xmlns:a16="http://schemas.microsoft.com/office/drawing/2014/main" id="{E1FD9494-E437-48FB-88EE-289A911AB776}"/>
              </a:ext>
            </a:extLst>
          </p:cNvPr>
          <p:cNvSpPr txBox="1"/>
          <p:nvPr/>
        </p:nvSpPr>
        <p:spPr>
          <a:xfrm>
            <a:off x="1360586"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a:t>
            </a:r>
          </a:p>
        </p:txBody>
      </p:sp>
      <p:sp>
        <p:nvSpPr>
          <p:cNvPr id="62" name="TextBox 61">
            <a:extLst>
              <a:ext uri="{FF2B5EF4-FFF2-40B4-BE49-F238E27FC236}">
                <a16:creationId xmlns:a16="http://schemas.microsoft.com/office/drawing/2014/main" id="{CF1DC525-A6C0-4390-AED8-CE86A5F0B56D}"/>
              </a:ext>
            </a:extLst>
          </p:cNvPr>
          <p:cNvSpPr txBox="1"/>
          <p:nvPr/>
        </p:nvSpPr>
        <p:spPr>
          <a:xfrm>
            <a:off x="1863699"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a:t>
            </a:r>
          </a:p>
        </p:txBody>
      </p:sp>
      <p:sp>
        <p:nvSpPr>
          <p:cNvPr id="63" name="TextBox 62">
            <a:extLst>
              <a:ext uri="{FF2B5EF4-FFF2-40B4-BE49-F238E27FC236}">
                <a16:creationId xmlns:a16="http://schemas.microsoft.com/office/drawing/2014/main" id="{F4BCD483-BFD5-4012-9496-1651EB9CA4FF}"/>
              </a:ext>
            </a:extLst>
          </p:cNvPr>
          <p:cNvSpPr txBox="1"/>
          <p:nvPr/>
        </p:nvSpPr>
        <p:spPr>
          <a:xfrm>
            <a:off x="2366812"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3</a:t>
            </a:r>
          </a:p>
        </p:txBody>
      </p:sp>
      <p:sp>
        <p:nvSpPr>
          <p:cNvPr id="64" name="TextBox 63">
            <a:extLst>
              <a:ext uri="{FF2B5EF4-FFF2-40B4-BE49-F238E27FC236}">
                <a16:creationId xmlns:a16="http://schemas.microsoft.com/office/drawing/2014/main" id="{CAD81215-1598-44A5-BCB5-6E1329FC06CB}"/>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5" name="TextBox 64">
            <a:extLst>
              <a:ext uri="{FF2B5EF4-FFF2-40B4-BE49-F238E27FC236}">
                <a16:creationId xmlns:a16="http://schemas.microsoft.com/office/drawing/2014/main" id="{D2FFD943-EDDD-401B-9C3B-E66DC286ECA5}"/>
              </a:ext>
            </a:extLst>
          </p:cNvPr>
          <p:cNvSpPr txBox="1"/>
          <p:nvPr/>
        </p:nvSpPr>
        <p:spPr>
          <a:xfrm>
            <a:off x="3373038"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a:t>
            </a:r>
          </a:p>
        </p:txBody>
      </p:sp>
      <p:sp>
        <p:nvSpPr>
          <p:cNvPr id="66" name="TextBox 65">
            <a:extLst>
              <a:ext uri="{FF2B5EF4-FFF2-40B4-BE49-F238E27FC236}">
                <a16:creationId xmlns:a16="http://schemas.microsoft.com/office/drawing/2014/main" id="{304D18D9-1489-4BED-B9FB-54641824AD45}"/>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19C21360-5531-40AF-90D8-EA1E050B1624}"/>
              </a:ext>
            </a:extLst>
          </p:cNvPr>
          <p:cNvSpPr txBox="1"/>
          <p:nvPr/>
        </p:nvSpPr>
        <p:spPr>
          <a:xfrm>
            <a:off x="4379264"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7</a:t>
            </a:r>
          </a:p>
        </p:txBody>
      </p:sp>
      <p:sp>
        <p:nvSpPr>
          <p:cNvPr id="68" name="TextBox 67">
            <a:extLst>
              <a:ext uri="{FF2B5EF4-FFF2-40B4-BE49-F238E27FC236}">
                <a16:creationId xmlns:a16="http://schemas.microsoft.com/office/drawing/2014/main" id="{C9FF9BF8-2DBF-49BB-BB74-CBBEB5494177}"/>
              </a:ext>
            </a:extLst>
          </p:cNvPr>
          <p:cNvSpPr txBox="1"/>
          <p:nvPr/>
        </p:nvSpPr>
        <p:spPr>
          <a:xfrm>
            <a:off x="488237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8</a:t>
            </a:r>
          </a:p>
        </p:txBody>
      </p:sp>
      <p:sp>
        <p:nvSpPr>
          <p:cNvPr id="69" name="TextBox 68">
            <a:extLst>
              <a:ext uri="{FF2B5EF4-FFF2-40B4-BE49-F238E27FC236}">
                <a16:creationId xmlns:a16="http://schemas.microsoft.com/office/drawing/2014/main" id="{3DD35A0C-FB95-451D-9210-529BB8553657}"/>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70" name="TextBox 69">
            <a:extLst>
              <a:ext uri="{FF2B5EF4-FFF2-40B4-BE49-F238E27FC236}">
                <a16:creationId xmlns:a16="http://schemas.microsoft.com/office/drawing/2014/main" id="{794E1B52-0F46-4FB3-8B7F-EB53C8327154}"/>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71" name="TextBox 70">
            <a:extLst>
              <a:ext uri="{FF2B5EF4-FFF2-40B4-BE49-F238E27FC236}">
                <a16:creationId xmlns:a16="http://schemas.microsoft.com/office/drawing/2014/main" id="{130AA605-2900-4295-9FAA-F73DDF45F6CF}"/>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72" name="TextBox 71">
            <a:extLst>
              <a:ext uri="{FF2B5EF4-FFF2-40B4-BE49-F238E27FC236}">
                <a16:creationId xmlns:a16="http://schemas.microsoft.com/office/drawing/2014/main" id="{CD6429D6-BBB2-4B38-8293-0480D579936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73" name="TextBox 72">
            <a:extLst>
              <a:ext uri="{FF2B5EF4-FFF2-40B4-BE49-F238E27FC236}">
                <a16:creationId xmlns:a16="http://schemas.microsoft.com/office/drawing/2014/main" id="{382734AC-1615-4858-818A-F8BE53B6C96D}"/>
              </a:ext>
            </a:extLst>
          </p:cNvPr>
          <p:cNvSpPr txBox="1"/>
          <p:nvPr/>
        </p:nvSpPr>
        <p:spPr>
          <a:xfrm>
            <a:off x="7333822"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3</a:t>
            </a:r>
          </a:p>
        </p:txBody>
      </p:sp>
      <p:sp>
        <p:nvSpPr>
          <p:cNvPr id="74" name="TextBox 73">
            <a:extLst>
              <a:ext uri="{FF2B5EF4-FFF2-40B4-BE49-F238E27FC236}">
                <a16:creationId xmlns:a16="http://schemas.microsoft.com/office/drawing/2014/main" id="{11AADA4F-09DC-4B0C-B8CE-8E626421B549}"/>
              </a:ext>
            </a:extLst>
          </p:cNvPr>
          <p:cNvSpPr txBox="1"/>
          <p:nvPr/>
        </p:nvSpPr>
        <p:spPr>
          <a:xfrm>
            <a:off x="7836935"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4</a:t>
            </a:r>
          </a:p>
        </p:txBody>
      </p:sp>
      <p:sp>
        <p:nvSpPr>
          <p:cNvPr id="75" name="TextBox 74">
            <a:extLst>
              <a:ext uri="{FF2B5EF4-FFF2-40B4-BE49-F238E27FC236}">
                <a16:creationId xmlns:a16="http://schemas.microsoft.com/office/drawing/2014/main" id="{F15B31C9-CBD7-4EE4-9CFD-DB390763665D}"/>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76" name="TextBox 75">
            <a:extLst>
              <a:ext uri="{FF2B5EF4-FFF2-40B4-BE49-F238E27FC236}">
                <a16:creationId xmlns:a16="http://schemas.microsoft.com/office/drawing/2014/main" id="{A41973E2-05AF-4384-A490-018477B607D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77" name="TextBox 76">
            <a:extLst>
              <a:ext uri="{FF2B5EF4-FFF2-40B4-BE49-F238E27FC236}">
                <a16:creationId xmlns:a16="http://schemas.microsoft.com/office/drawing/2014/main" id="{5D11163C-B992-4353-9F3D-BB5DFBCE4FB1}"/>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78" name="TextBox 77">
            <a:extLst>
              <a:ext uri="{FF2B5EF4-FFF2-40B4-BE49-F238E27FC236}">
                <a16:creationId xmlns:a16="http://schemas.microsoft.com/office/drawing/2014/main" id="{B8CF1FF0-79B3-483F-9320-EF64775CB397}"/>
              </a:ext>
            </a:extLst>
          </p:cNvPr>
          <p:cNvSpPr txBox="1"/>
          <p:nvPr/>
        </p:nvSpPr>
        <p:spPr>
          <a:xfrm>
            <a:off x="9849387"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8</a:t>
            </a:r>
          </a:p>
        </p:txBody>
      </p:sp>
      <p:sp>
        <p:nvSpPr>
          <p:cNvPr id="79" name="TextBox 78">
            <a:extLst>
              <a:ext uri="{FF2B5EF4-FFF2-40B4-BE49-F238E27FC236}">
                <a16:creationId xmlns:a16="http://schemas.microsoft.com/office/drawing/2014/main" id="{799A331B-6EBE-4CC3-A16F-0B092870A7C6}"/>
              </a:ext>
            </a:extLst>
          </p:cNvPr>
          <p:cNvSpPr txBox="1"/>
          <p:nvPr/>
        </p:nvSpPr>
        <p:spPr>
          <a:xfrm>
            <a:off x="10352500"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9</a:t>
            </a:r>
          </a:p>
        </p:txBody>
      </p:sp>
      <p:sp>
        <p:nvSpPr>
          <p:cNvPr id="80" name="TextBox 79">
            <a:extLst>
              <a:ext uri="{FF2B5EF4-FFF2-40B4-BE49-F238E27FC236}">
                <a16:creationId xmlns:a16="http://schemas.microsoft.com/office/drawing/2014/main" id="{A2F037F8-2EB4-473A-9038-4B493E305455}"/>
              </a:ext>
            </a:extLst>
          </p:cNvPr>
          <p:cNvSpPr txBox="1"/>
          <p:nvPr/>
        </p:nvSpPr>
        <p:spPr>
          <a:xfrm>
            <a:off x="136058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77C95FF9-757E-4031-A501-4E78FD91A8E8}"/>
              </a:ext>
            </a:extLst>
          </p:cNvPr>
          <p:cNvSpPr txBox="1"/>
          <p:nvPr/>
        </p:nvSpPr>
        <p:spPr>
          <a:xfrm>
            <a:off x="1863699"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3EB1A2A9-F142-481B-BE30-E891504FF6E6}"/>
              </a:ext>
            </a:extLst>
          </p:cNvPr>
          <p:cNvSpPr txBox="1"/>
          <p:nvPr/>
        </p:nvSpPr>
        <p:spPr>
          <a:xfrm>
            <a:off x="2366812"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3" name="TextBox 82">
            <a:extLst>
              <a:ext uri="{FF2B5EF4-FFF2-40B4-BE49-F238E27FC236}">
                <a16:creationId xmlns:a16="http://schemas.microsoft.com/office/drawing/2014/main" id="{8BD4B837-7EC9-4D46-B106-CAD6EAC86DA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84" name="TextBox 83">
            <a:extLst>
              <a:ext uri="{FF2B5EF4-FFF2-40B4-BE49-F238E27FC236}">
                <a16:creationId xmlns:a16="http://schemas.microsoft.com/office/drawing/2014/main" id="{E3215548-D849-49A7-9A83-98B26F95F25B}"/>
              </a:ext>
            </a:extLst>
          </p:cNvPr>
          <p:cNvSpPr txBox="1"/>
          <p:nvPr/>
        </p:nvSpPr>
        <p:spPr>
          <a:xfrm>
            <a:off x="337303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85" name="TextBox 84">
            <a:extLst>
              <a:ext uri="{FF2B5EF4-FFF2-40B4-BE49-F238E27FC236}">
                <a16:creationId xmlns:a16="http://schemas.microsoft.com/office/drawing/2014/main" id="{2F81B13E-D292-4D17-A9F6-5CA73777B940}"/>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86" name="TextBox 85">
            <a:extLst>
              <a:ext uri="{FF2B5EF4-FFF2-40B4-BE49-F238E27FC236}">
                <a16:creationId xmlns:a16="http://schemas.microsoft.com/office/drawing/2014/main" id="{2A5BE422-5CA5-4E45-A20A-A35C9E6E9B45}"/>
              </a:ext>
            </a:extLst>
          </p:cNvPr>
          <p:cNvSpPr txBox="1"/>
          <p:nvPr/>
        </p:nvSpPr>
        <p:spPr>
          <a:xfrm>
            <a:off x="437926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87" name="TextBox 86">
            <a:extLst>
              <a:ext uri="{FF2B5EF4-FFF2-40B4-BE49-F238E27FC236}">
                <a16:creationId xmlns:a16="http://schemas.microsoft.com/office/drawing/2014/main" id="{A408FB12-C23F-4899-AA5C-0C06257304A5}"/>
              </a:ext>
            </a:extLst>
          </p:cNvPr>
          <p:cNvSpPr txBox="1"/>
          <p:nvPr/>
        </p:nvSpPr>
        <p:spPr>
          <a:xfrm>
            <a:off x="4882377"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sp>
        <p:nvSpPr>
          <p:cNvPr id="88" name="TextBox 87">
            <a:extLst>
              <a:ext uri="{FF2B5EF4-FFF2-40B4-BE49-F238E27FC236}">
                <a16:creationId xmlns:a16="http://schemas.microsoft.com/office/drawing/2014/main" id="{E02AF79D-E5E8-4E83-9A47-DAA469C4CC81}"/>
              </a:ext>
            </a:extLst>
          </p:cNvPr>
          <p:cNvSpPr txBox="1"/>
          <p:nvPr/>
        </p:nvSpPr>
        <p:spPr>
          <a:xfrm>
            <a:off x="639171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8</a:t>
            </a:r>
          </a:p>
        </p:txBody>
      </p:sp>
      <p:sp>
        <p:nvSpPr>
          <p:cNvPr id="89" name="TextBox 88">
            <a:extLst>
              <a:ext uri="{FF2B5EF4-FFF2-40B4-BE49-F238E27FC236}">
                <a16:creationId xmlns:a16="http://schemas.microsoft.com/office/drawing/2014/main" id="{3A1C2354-CB97-4539-B2E6-1F48EB6681BC}"/>
              </a:ext>
            </a:extLst>
          </p:cNvPr>
          <p:cNvSpPr txBox="1"/>
          <p:nvPr/>
        </p:nvSpPr>
        <p:spPr>
          <a:xfrm>
            <a:off x="6894829"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C6BC3E5C-7AEC-478A-9C2F-4AE5B70715C9}"/>
              </a:ext>
            </a:extLst>
          </p:cNvPr>
          <p:cNvSpPr txBox="1"/>
          <p:nvPr/>
        </p:nvSpPr>
        <p:spPr>
          <a:xfrm>
            <a:off x="7333822"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0</a:t>
            </a:r>
          </a:p>
        </p:txBody>
      </p:sp>
      <p:sp>
        <p:nvSpPr>
          <p:cNvPr id="91" name="TextBox 90">
            <a:extLst>
              <a:ext uri="{FF2B5EF4-FFF2-40B4-BE49-F238E27FC236}">
                <a16:creationId xmlns:a16="http://schemas.microsoft.com/office/drawing/2014/main" id="{69AFBEEB-9DA9-47C8-870A-4BF72E457C16}"/>
              </a:ext>
            </a:extLst>
          </p:cNvPr>
          <p:cNvSpPr txBox="1"/>
          <p:nvPr/>
        </p:nvSpPr>
        <p:spPr>
          <a:xfrm>
            <a:off x="7845495" y="1954769"/>
            <a:ext cx="42402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1</a:t>
            </a:r>
          </a:p>
        </p:txBody>
      </p:sp>
      <p:sp>
        <p:nvSpPr>
          <p:cNvPr id="92" name="TextBox 91">
            <a:extLst>
              <a:ext uri="{FF2B5EF4-FFF2-40B4-BE49-F238E27FC236}">
                <a16:creationId xmlns:a16="http://schemas.microsoft.com/office/drawing/2014/main" id="{DCD63FD1-D848-4F9B-B53E-883996B4CB7A}"/>
              </a:ext>
            </a:extLst>
          </p:cNvPr>
          <p:cNvSpPr txBox="1"/>
          <p:nvPr/>
        </p:nvSpPr>
        <p:spPr>
          <a:xfrm>
            <a:off x="8340048"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2</a:t>
            </a:r>
          </a:p>
        </p:txBody>
      </p:sp>
      <p:sp>
        <p:nvSpPr>
          <p:cNvPr id="93" name="TextBox 92">
            <a:extLst>
              <a:ext uri="{FF2B5EF4-FFF2-40B4-BE49-F238E27FC236}">
                <a16:creationId xmlns:a16="http://schemas.microsoft.com/office/drawing/2014/main" id="{A46A09FC-8F6E-4351-9439-21C5B0E6C1FE}"/>
              </a:ext>
            </a:extLst>
          </p:cNvPr>
          <p:cNvSpPr txBox="1"/>
          <p:nvPr/>
        </p:nvSpPr>
        <p:spPr>
          <a:xfrm>
            <a:off x="8843161"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3</a:t>
            </a:r>
          </a:p>
        </p:txBody>
      </p:sp>
      <p:sp>
        <p:nvSpPr>
          <p:cNvPr id="94" name="TextBox 93">
            <a:extLst>
              <a:ext uri="{FF2B5EF4-FFF2-40B4-BE49-F238E27FC236}">
                <a16:creationId xmlns:a16="http://schemas.microsoft.com/office/drawing/2014/main" id="{45B413E9-B943-4FA7-8ED2-52FFF6A7BC3C}"/>
              </a:ext>
            </a:extLst>
          </p:cNvPr>
          <p:cNvSpPr txBox="1"/>
          <p:nvPr/>
        </p:nvSpPr>
        <p:spPr>
          <a:xfrm>
            <a:off x="9346274"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4</a:t>
            </a:r>
          </a:p>
        </p:txBody>
      </p:sp>
      <p:sp>
        <p:nvSpPr>
          <p:cNvPr id="95" name="TextBox 94">
            <a:extLst>
              <a:ext uri="{FF2B5EF4-FFF2-40B4-BE49-F238E27FC236}">
                <a16:creationId xmlns:a16="http://schemas.microsoft.com/office/drawing/2014/main" id="{88DD6E14-873E-4FC1-8D29-4684985DF959}"/>
              </a:ext>
            </a:extLst>
          </p:cNvPr>
          <p:cNvSpPr txBox="1"/>
          <p:nvPr/>
        </p:nvSpPr>
        <p:spPr>
          <a:xfrm>
            <a:off x="9849387"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5</a:t>
            </a:r>
          </a:p>
        </p:txBody>
      </p:sp>
      <p:sp>
        <p:nvSpPr>
          <p:cNvPr id="96" name="TextBox 95">
            <a:extLst>
              <a:ext uri="{FF2B5EF4-FFF2-40B4-BE49-F238E27FC236}">
                <a16:creationId xmlns:a16="http://schemas.microsoft.com/office/drawing/2014/main" id="{65B182B4-A532-4856-81B7-BEEE275F2508}"/>
              </a:ext>
            </a:extLst>
          </p:cNvPr>
          <p:cNvSpPr txBox="1"/>
          <p:nvPr/>
        </p:nvSpPr>
        <p:spPr>
          <a:xfrm>
            <a:off x="10352500" y="1954769"/>
            <a:ext cx="44114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6</a:t>
            </a:r>
          </a:p>
        </p:txBody>
      </p:sp>
      <p:sp>
        <p:nvSpPr>
          <p:cNvPr id="99" name="TextBox 98">
            <a:extLst>
              <a:ext uri="{FF2B5EF4-FFF2-40B4-BE49-F238E27FC236}">
                <a16:creationId xmlns:a16="http://schemas.microsoft.com/office/drawing/2014/main" id="{57A54BF0-E63B-4D90-8391-0278D839B39D}"/>
              </a:ext>
            </a:extLst>
          </p:cNvPr>
          <p:cNvSpPr txBox="1"/>
          <p:nvPr/>
        </p:nvSpPr>
        <p:spPr>
          <a:xfrm>
            <a:off x="5427696" y="3334430"/>
            <a:ext cx="736099" cy="646331"/>
          </a:xfrm>
          <a:prstGeom prst="rect">
            <a:avLst/>
          </a:prstGeom>
          <a:noFill/>
        </p:spPr>
        <p:txBody>
          <a:bodyPr wrap="none" rtlCol="0">
            <a:spAutoFit/>
          </a:bodyPr>
          <a:lstStyle/>
          <a:p>
            <a:pPr algn="ctr"/>
            <a:r>
              <a:rPr lang="en-US"/>
              <a:t>GAP</a:t>
            </a:r>
          </a:p>
          <a:p>
            <a:pPr algn="ctr"/>
            <a:r>
              <a:rPr lang="en-US"/>
              <a:t>2 sec</a:t>
            </a:r>
          </a:p>
        </p:txBody>
      </p:sp>
      <p:sp>
        <p:nvSpPr>
          <p:cNvPr id="97" name="TextBox 96">
            <a:extLst>
              <a:ext uri="{FF2B5EF4-FFF2-40B4-BE49-F238E27FC236}">
                <a16:creationId xmlns:a16="http://schemas.microsoft.com/office/drawing/2014/main" id="{CEFFC746-337A-4770-A155-BC72A2353F84}"/>
              </a:ext>
            </a:extLst>
          </p:cNvPr>
          <p:cNvSpPr txBox="1"/>
          <p:nvPr/>
        </p:nvSpPr>
        <p:spPr>
          <a:xfrm>
            <a:off x="3304224" y="5941508"/>
            <a:ext cx="5583581" cy="584775"/>
          </a:xfrm>
          <a:prstGeom prst="rect">
            <a:avLst/>
          </a:prstGeom>
          <a:noFill/>
        </p:spPr>
        <p:txBody>
          <a:bodyPr wrap="none" rtlCol="0">
            <a:spAutoFit/>
          </a:bodyPr>
          <a:lstStyle/>
          <a:p>
            <a:pPr algn="ctr"/>
            <a:r>
              <a:rPr lang="en-US" sz="3200" err="1">
                <a:solidFill>
                  <a:schemeClr val="accent1"/>
                </a:solidFill>
              </a:rPr>
              <a:t>recDuration</a:t>
            </a:r>
            <a:r>
              <a:rPr lang="en-US" sz="3200">
                <a:solidFill>
                  <a:schemeClr val="accent1"/>
                </a:solidFill>
              </a:rPr>
              <a:t> = 20 – 2 = 18 sec</a:t>
            </a:r>
          </a:p>
        </p:txBody>
      </p:sp>
    </p:spTree>
    <p:extLst>
      <p:ext uri="{BB962C8B-B14F-4D97-AF65-F5344CB8AC3E}">
        <p14:creationId xmlns:p14="http://schemas.microsoft.com/office/powerpoint/2010/main" val="96479467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 name="Title 1">
            <a:extLst>
              <a:ext uri="{FF2B5EF4-FFF2-40B4-BE49-F238E27FC236}">
                <a16:creationId xmlns:a16="http://schemas.microsoft.com/office/drawing/2014/main" id="{BB4E3879-0FC6-44D6-9281-34F2B554E57F}"/>
              </a:ext>
            </a:extLst>
          </p:cNvPr>
          <p:cNvSpPr txBox="1">
            <a:spLocks/>
          </p:cNvSpPr>
          <p:nvPr/>
        </p:nvSpPr>
        <p:spPr>
          <a:xfrm>
            <a:off x="838200" y="1"/>
            <a:ext cx="10515600" cy="203092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Arial" panose="020B0604020202020204" pitchFamily="34" charset="0"/>
                <a:ea typeface="+mj-ea"/>
                <a:cs typeface="Arial" panose="020B0604020202020204" pitchFamily="34" charset="0"/>
              </a:defRPr>
            </a:lvl1pPr>
          </a:lstStyle>
          <a:p>
            <a:r>
              <a:rPr lang="en-US" sz="3600" b="1">
                <a:solidFill>
                  <a:srgbClr val="7030A0"/>
                </a:solidFill>
              </a:rPr>
              <a:t>Burst frequency (bf): </a:t>
            </a:r>
            <a:r>
              <a:rPr lang="en-US" sz="3600"/>
              <a:t>The frequency, in Hz, of bursts during the recording. This is the number of bursts divided by the recording duration.</a:t>
            </a:r>
          </a:p>
        </p:txBody>
      </p:sp>
      <p:cxnSp>
        <p:nvCxnSpPr>
          <p:cNvPr id="35" name="Straight Connector 34">
            <a:extLst>
              <a:ext uri="{FF2B5EF4-FFF2-40B4-BE49-F238E27FC236}">
                <a16:creationId xmlns:a16="http://schemas.microsoft.com/office/drawing/2014/main" id="{2814F8E3-4AEA-4BA4-A3D8-EB9F55DB1F02}"/>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748586B8-9830-440E-91B0-F430C21E1AAE}"/>
              </a:ext>
            </a:extLst>
          </p:cNvPr>
          <p:cNvCxnSpPr>
            <a:cxnSpLocks/>
          </p:cNvCxnSpPr>
          <p:nvPr/>
        </p:nvCxnSpPr>
        <p:spPr>
          <a:xfrm>
            <a:off x="3026378"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C45B121B-A3D2-4BC8-AE2A-F676503D0272}"/>
              </a:ext>
            </a:extLst>
          </p:cNvPr>
          <p:cNvCxnSpPr>
            <a:cxnSpLocks/>
          </p:cNvCxnSpPr>
          <p:nvPr/>
        </p:nvCxnSpPr>
        <p:spPr>
          <a:xfrm>
            <a:off x="352949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622BF435-EBBA-4218-96BF-4AFCE9AB182D}"/>
              </a:ext>
            </a:extLst>
          </p:cNvPr>
          <p:cNvCxnSpPr>
            <a:cxnSpLocks/>
          </p:cNvCxnSpPr>
          <p:nvPr/>
        </p:nvCxnSpPr>
        <p:spPr>
          <a:xfrm>
            <a:off x="403260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5F8121D-EAA0-4330-999A-E18CB41CBE16}"/>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4EEB74AE-83EB-4C75-BDF1-FF349CDAE14A}"/>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55BC6AA-6EBD-42D9-B053-D4DCDC89E349}"/>
              </a:ext>
            </a:extLst>
          </p:cNvPr>
          <p:cNvCxnSpPr>
            <a:cxnSpLocks/>
          </p:cNvCxnSpPr>
          <p:nvPr/>
        </p:nvCxnSpPr>
        <p:spPr>
          <a:xfrm>
            <a:off x="856062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55A4474-74EF-48A7-81BB-0D5B373EA381}"/>
              </a:ext>
            </a:extLst>
          </p:cNvPr>
          <p:cNvCxnSpPr>
            <a:cxnSpLocks/>
          </p:cNvCxnSpPr>
          <p:nvPr/>
        </p:nvCxnSpPr>
        <p:spPr>
          <a:xfrm>
            <a:off x="906373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6865C555-B0A1-4DC7-BFB3-159291064D3E}"/>
              </a:ext>
            </a:extLst>
          </p:cNvPr>
          <p:cNvCxnSpPr>
            <a:cxnSpLocks/>
          </p:cNvCxnSpPr>
          <p:nvPr/>
        </p:nvCxnSpPr>
        <p:spPr>
          <a:xfrm>
            <a:off x="9566847"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EAC61716-623A-447C-954B-8DD898D75C07}"/>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56" name="TextBox 55">
            <a:extLst>
              <a:ext uri="{FF2B5EF4-FFF2-40B4-BE49-F238E27FC236}">
                <a16:creationId xmlns:a16="http://schemas.microsoft.com/office/drawing/2014/main" id="{506BA941-9ED2-45B9-AC3F-C8C0B0E5C028}"/>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60" name="TextBox 59">
            <a:extLst>
              <a:ext uri="{FF2B5EF4-FFF2-40B4-BE49-F238E27FC236}">
                <a16:creationId xmlns:a16="http://schemas.microsoft.com/office/drawing/2014/main" id="{D5578323-22C5-48E1-ADEE-17A44D65AA3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1" name="TextBox 60">
            <a:extLst>
              <a:ext uri="{FF2B5EF4-FFF2-40B4-BE49-F238E27FC236}">
                <a16:creationId xmlns:a16="http://schemas.microsoft.com/office/drawing/2014/main" id="{1FFB11D9-B26C-434D-9740-8725EB830EE4}"/>
              </a:ext>
            </a:extLst>
          </p:cNvPr>
          <p:cNvSpPr txBox="1"/>
          <p:nvPr/>
        </p:nvSpPr>
        <p:spPr>
          <a:xfrm>
            <a:off x="3373038"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a:t>
            </a:r>
          </a:p>
        </p:txBody>
      </p:sp>
      <p:sp>
        <p:nvSpPr>
          <p:cNvPr id="62" name="TextBox 61">
            <a:extLst>
              <a:ext uri="{FF2B5EF4-FFF2-40B4-BE49-F238E27FC236}">
                <a16:creationId xmlns:a16="http://schemas.microsoft.com/office/drawing/2014/main" id="{83114AA9-4B59-41B6-ADFE-6C4F2491E6E7}"/>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CA7BFD84-ABBA-4A9A-B2F8-6FC0089400F0}"/>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68" name="TextBox 67">
            <a:extLst>
              <a:ext uri="{FF2B5EF4-FFF2-40B4-BE49-F238E27FC236}">
                <a16:creationId xmlns:a16="http://schemas.microsoft.com/office/drawing/2014/main" id="{CB981839-37F6-4368-8E3F-DF8754634807}"/>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71" name="TextBox 70">
            <a:extLst>
              <a:ext uri="{FF2B5EF4-FFF2-40B4-BE49-F238E27FC236}">
                <a16:creationId xmlns:a16="http://schemas.microsoft.com/office/drawing/2014/main" id="{D45BBE2E-DF92-4219-BC3A-1AF1A2792BF9}"/>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72" name="TextBox 71">
            <a:extLst>
              <a:ext uri="{FF2B5EF4-FFF2-40B4-BE49-F238E27FC236}">
                <a16:creationId xmlns:a16="http://schemas.microsoft.com/office/drawing/2014/main" id="{BD8B3B41-1FE1-4CCC-9168-42A24303DFDC}"/>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73" name="TextBox 72">
            <a:extLst>
              <a:ext uri="{FF2B5EF4-FFF2-40B4-BE49-F238E27FC236}">
                <a16:creationId xmlns:a16="http://schemas.microsoft.com/office/drawing/2014/main" id="{D2BC4F3C-EDCE-490E-ADBC-F65B227FA8F9}"/>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76" name="TextBox 75">
            <a:extLst>
              <a:ext uri="{FF2B5EF4-FFF2-40B4-BE49-F238E27FC236}">
                <a16:creationId xmlns:a16="http://schemas.microsoft.com/office/drawing/2014/main" id="{5FC86196-7C2D-42D7-BE6A-1D096E132698}"/>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80" name="TextBox 79">
            <a:extLst>
              <a:ext uri="{FF2B5EF4-FFF2-40B4-BE49-F238E27FC236}">
                <a16:creationId xmlns:a16="http://schemas.microsoft.com/office/drawing/2014/main" id="{0C900B59-4201-4F1B-B8E7-7340816C4316}"/>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5A66A2F2-34E3-4247-8534-59192890CC22}"/>
              </a:ext>
            </a:extLst>
          </p:cNvPr>
          <p:cNvSpPr txBox="1"/>
          <p:nvPr/>
        </p:nvSpPr>
        <p:spPr>
          <a:xfrm>
            <a:off x="337303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17974CD7-4EB3-4ABE-9BD7-E18031C0821C}"/>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7" name="TextBox 86">
            <a:extLst>
              <a:ext uri="{FF2B5EF4-FFF2-40B4-BE49-F238E27FC236}">
                <a16:creationId xmlns:a16="http://schemas.microsoft.com/office/drawing/2014/main" id="{95024911-2DE9-4D0B-A4B3-4BD19777884F}"/>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90" name="TextBox 89">
            <a:extLst>
              <a:ext uri="{FF2B5EF4-FFF2-40B4-BE49-F238E27FC236}">
                <a16:creationId xmlns:a16="http://schemas.microsoft.com/office/drawing/2014/main" id="{062B7B16-42E2-4076-A421-365223EFD43C}"/>
              </a:ext>
            </a:extLst>
          </p:cNvPr>
          <p:cNvSpPr txBox="1"/>
          <p:nvPr/>
        </p:nvSpPr>
        <p:spPr>
          <a:xfrm>
            <a:off x="6894829"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23" name="TextBox 122">
            <a:extLst>
              <a:ext uri="{FF2B5EF4-FFF2-40B4-BE49-F238E27FC236}">
                <a16:creationId xmlns:a16="http://schemas.microsoft.com/office/drawing/2014/main" id="{F07E911A-EF55-4077-B0DF-D9984A42F982}"/>
              </a:ext>
            </a:extLst>
          </p:cNvPr>
          <p:cNvSpPr txBox="1"/>
          <p:nvPr/>
        </p:nvSpPr>
        <p:spPr>
          <a:xfrm>
            <a:off x="8404168"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24" name="TextBox 123">
            <a:extLst>
              <a:ext uri="{FF2B5EF4-FFF2-40B4-BE49-F238E27FC236}">
                <a16:creationId xmlns:a16="http://schemas.microsoft.com/office/drawing/2014/main" id="{E4DDCEBE-F36D-42F0-91A2-FD89D2A6C8CA}"/>
              </a:ext>
            </a:extLst>
          </p:cNvPr>
          <p:cNvSpPr txBox="1"/>
          <p:nvPr/>
        </p:nvSpPr>
        <p:spPr>
          <a:xfrm>
            <a:off x="8907281"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125" name="TextBox 124">
            <a:extLst>
              <a:ext uri="{FF2B5EF4-FFF2-40B4-BE49-F238E27FC236}">
                <a16:creationId xmlns:a16="http://schemas.microsoft.com/office/drawing/2014/main" id="{51749985-D96F-4694-BCC7-0CCD556B9E04}"/>
              </a:ext>
            </a:extLst>
          </p:cNvPr>
          <p:cNvSpPr txBox="1"/>
          <p:nvPr/>
        </p:nvSpPr>
        <p:spPr>
          <a:xfrm>
            <a:off x="9410394"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sp>
        <p:nvSpPr>
          <p:cNvPr id="128" name="TextBox 127">
            <a:extLst>
              <a:ext uri="{FF2B5EF4-FFF2-40B4-BE49-F238E27FC236}">
                <a16:creationId xmlns:a16="http://schemas.microsoft.com/office/drawing/2014/main" id="{8B5F1059-0ECA-4AA6-AA71-49F6194AB602}"/>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9" name="TextBox 128">
            <a:extLst>
              <a:ext uri="{FF2B5EF4-FFF2-40B4-BE49-F238E27FC236}">
                <a16:creationId xmlns:a16="http://schemas.microsoft.com/office/drawing/2014/main" id="{17105D4D-3475-4F62-8B53-E8A9D9E8CB2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mc:AlternateContent xmlns:mc="http://schemas.openxmlformats.org/markup-compatibility/2006">
        <mc:Choice xmlns:a14="http://schemas.microsoft.com/office/drawing/2010/main" Requires="a14">
          <p:sp>
            <p:nvSpPr>
              <p:cNvPr id="133" name="TextBox 132">
                <a:extLst>
                  <a:ext uri="{FF2B5EF4-FFF2-40B4-BE49-F238E27FC236}">
                    <a16:creationId xmlns:a16="http://schemas.microsoft.com/office/drawing/2014/main" id="{FCBFF678-2D12-4089-BC17-3FF02D8C29CF}"/>
                  </a:ext>
                </a:extLst>
              </p:cNvPr>
              <p:cNvSpPr txBox="1"/>
              <p:nvPr/>
            </p:nvSpPr>
            <p:spPr>
              <a:xfrm>
                <a:off x="2549783" y="5892094"/>
                <a:ext cx="7092454" cy="905312"/>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BF = </a:t>
                </a:r>
                <a14:m>
                  <m:oMath xmlns:m="http://schemas.openxmlformats.org/officeDocument/2006/math">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𝑏𝑛</m:t>
                        </m:r>
                      </m:num>
                      <m:den>
                        <m:r>
                          <a:rPr lang="en-US" sz="3600" b="0" i="1" smtClean="0">
                            <a:solidFill>
                              <a:schemeClr val="accent1"/>
                            </a:solidFill>
                            <a:latin typeface="Cambria Math" panose="02040503050406030204" pitchFamily="18" charset="0"/>
                          </a:rPr>
                          <m:t>𝑟𝑒𝑐</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𝑑𝑢𝑟</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3</m:t>
                        </m:r>
                      </m:num>
                      <m:den>
                        <m:r>
                          <a:rPr lang="en-US" sz="3600" b="0" i="1" smtClean="0">
                            <a:solidFill>
                              <a:schemeClr val="accent1"/>
                            </a:solidFill>
                            <a:latin typeface="Cambria Math" panose="02040503050406030204" pitchFamily="18" charset="0"/>
                          </a:rPr>
                          <m:t>20−2</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3</m:t>
                        </m:r>
                      </m:num>
                      <m:den>
                        <m:r>
                          <a:rPr lang="en-US" sz="3600" b="0" i="1" smtClean="0">
                            <a:solidFill>
                              <a:schemeClr val="accent1"/>
                            </a:solidFill>
                            <a:latin typeface="Cambria Math" panose="02040503050406030204" pitchFamily="18" charset="0"/>
                          </a:rPr>
                          <m:t>18</m:t>
                        </m:r>
                      </m:den>
                    </m:f>
                    <m:r>
                      <a:rPr lang="en-US" sz="3600" b="0" i="1" smtClean="0">
                        <a:solidFill>
                          <a:schemeClr val="accent1"/>
                        </a:solidFill>
                        <a:latin typeface="Cambria Math" panose="02040503050406030204" pitchFamily="18" charset="0"/>
                      </a:rPr>
                      <m:t>=.167 </m:t>
                    </m:r>
                    <m:r>
                      <a:rPr lang="en-US" sz="3600" b="0" i="1" smtClean="0">
                        <a:solidFill>
                          <a:schemeClr val="accent1"/>
                        </a:solidFill>
                        <a:latin typeface="Cambria Math" panose="02040503050406030204" pitchFamily="18" charset="0"/>
                      </a:rPr>
                      <m:t>𝐻𝑧</m:t>
                    </m:r>
                  </m:oMath>
                </a14:m>
                <a:endParaRPr lang="en-US" sz="3600">
                  <a:solidFill>
                    <a:schemeClr val="accent1"/>
                  </a:solidFill>
                </a:endParaRPr>
              </a:p>
            </p:txBody>
          </p:sp>
        </mc:Choice>
        <mc:Fallback>
          <p:sp>
            <p:nvSpPr>
              <p:cNvPr id="133" name="TextBox 132">
                <a:extLst>
                  <a:ext uri="{FF2B5EF4-FFF2-40B4-BE49-F238E27FC236}">
                    <a16:creationId xmlns:a16="http://schemas.microsoft.com/office/drawing/2014/main" id="{FCBFF678-2D12-4089-BC17-3FF02D8C29CF}"/>
                  </a:ext>
                </a:extLst>
              </p:cNvPr>
              <p:cNvSpPr txBox="1">
                <a:spLocks noRot="1" noChangeAspect="1" noMove="1" noResize="1" noEditPoints="1" noAdjustHandles="1" noChangeArrowheads="1" noChangeShapeType="1" noTextEdit="1"/>
              </p:cNvSpPr>
              <p:nvPr/>
            </p:nvSpPr>
            <p:spPr>
              <a:xfrm>
                <a:off x="2549783" y="5892094"/>
                <a:ext cx="7092454" cy="905312"/>
              </a:xfrm>
              <a:prstGeom prst="rect">
                <a:avLst/>
              </a:prstGeom>
              <a:blipFill>
                <a:blip r:embed="rId2"/>
                <a:stretch>
                  <a:fillRect l="-2148" b="-8784"/>
                </a:stretch>
              </a:blipFill>
            </p:spPr>
            <p:txBody>
              <a:bodyPr/>
              <a:lstStyle/>
              <a:p>
                <a:r>
                  <a:rPr lang="en-US">
                    <a:noFill/>
                  </a:rPr>
                  <a:t> </a:t>
                </a:r>
              </a:p>
            </p:txBody>
          </p:sp>
        </mc:Fallback>
      </mc:AlternateContent>
      <p:sp>
        <p:nvSpPr>
          <p:cNvPr id="57" name="Rectangle 56">
            <a:extLst>
              <a:ext uri="{FF2B5EF4-FFF2-40B4-BE49-F238E27FC236}">
                <a16:creationId xmlns:a16="http://schemas.microsoft.com/office/drawing/2014/main" id="{5589FE37-94B4-4F25-A457-A6AB718CBBEB}"/>
              </a:ext>
            </a:extLst>
          </p:cNvPr>
          <p:cNvSpPr/>
          <p:nvPr/>
        </p:nvSpPr>
        <p:spPr>
          <a:xfrm>
            <a:off x="5288353"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TextBox 57">
            <a:extLst>
              <a:ext uri="{FF2B5EF4-FFF2-40B4-BE49-F238E27FC236}">
                <a16:creationId xmlns:a16="http://schemas.microsoft.com/office/drawing/2014/main" id="{3CAF49F3-D477-41C8-A4C9-A7725A461FE2}"/>
              </a:ext>
            </a:extLst>
          </p:cNvPr>
          <p:cNvSpPr txBox="1"/>
          <p:nvPr/>
        </p:nvSpPr>
        <p:spPr>
          <a:xfrm>
            <a:off x="5427696" y="3334430"/>
            <a:ext cx="736099" cy="646331"/>
          </a:xfrm>
          <a:prstGeom prst="rect">
            <a:avLst/>
          </a:prstGeom>
          <a:noFill/>
        </p:spPr>
        <p:txBody>
          <a:bodyPr wrap="none" rtlCol="0">
            <a:spAutoFit/>
          </a:bodyPr>
          <a:lstStyle/>
          <a:p>
            <a:pPr algn="ctr"/>
            <a:r>
              <a:rPr lang="en-US"/>
              <a:t>GAP</a:t>
            </a:r>
          </a:p>
          <a:p>
            <a:pPr algn="ctr"/>
            <a:r>
              <a:rPr lang="en-US"/>
              <a:t>2 sec</a:t>
            </a:r>
          </a:p>
        </p:txBody>
      </p:sp>
    </p:spTree>
    <p:extLst>
      <p:ext uri="{BB962C8B-B14F-4D97-AF65-F5344CB8AC3E}">
        <p14:creationId xmlns:p14="http://schemas.microsoft.com/office/powerpoint/2010/main" val="34062656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EDBFCBC9-3F5A-4F93-8B85-A0A71E5A4DC3}"/>
              </a:ext>
            </a:extLst>
          </p:cNvPr>
          <p:cNvSpPr>
            <a:spLocks noGrp="1"/>
          </p:cNvSpPr>
          <p:nvPr>
            <p:ph type="title"/>
          </p:nvPr>
        </p:nvSpPr>
        <p:spPr>
          <a:xfrm>
            <a:off x="838199" y="0"/>
            <a:ext cx="10515600" cy="1325563"/>
          </a:xfrm>
        </p:spPr>
        <p:txBody>
          <a:bodyPr/>
          <a:lstStyle/>
          <a:p>
            <a:r>
              <a:rPr lang="en-US"/>
              <a:t>Terminology Table of Contents</a:t>
            </a:r>
          </a:p>
        </p:txBody>
      </p:sp>
      <p:sp>
        <p:nvSpPr>
          <p:cNvPr id="4" name="Content Placeholder 3">
            <a:extLst>
              <a:ext uri="{FF2B5EF4-FFF2-40B4-BE49-F238E27FC236}">
                <a16:creationId xmlns:a16="http://schemas.microsoft.com/office/drawing/2014/main" id="{449EDA6B-C05C-4CBC-964D-959BAED3287F}"/>
              </a:ext>
            </a:extLst>
          </p:cNvPr>
          <p:cNvSpPr>
            <a:spLocks noGrp="1"/>
          </p:cNvSpPr>
          <p:nvPr>
            <p:ph idx="1"/>
          </p:nvPr>
        </p:nvSpPr>
        <p:spPr>
          <a:xfrm>
            <a:off x="372291" y="1140431"/>
            <a:ext cx="11447417" cy="5582633"/>
          </a:xfrm>
        </p:spPr>
        <p:txBody>
          <a:bodyPr numCol="3">
            <a:normAutofit fontScale="92500" lnSpcReduction="10000"/>
          </a:bodyPr>
          <a:lstStyle/>
          <a:p>
            <a:r>
              <a:rPr lang="en-US">
                <a:hlinkClick r:id="rId2" action="ppaction://hlinksldjump"/>
              </a:rPr>
              <a:t>Dataset</a:t>
            </a:r>
            <a:endParaRPr lang="en-US"/>
          </a:p>
          <a:p>
            <a:r>
              <a:rPr lang="en-US">
                <a:hlinkClick r:id="rId3" action="ppaction://hlinksldjump"/>
              </a:rPr>
              <a:t>Intervals</a:t>
            </a:r>
            <a:endParaRPr lang="en-US"/>
          </a:p>
          <a:p>
            <a:r>
              <a:rPr lang="en-US">
                <a:hlinkClick r:id="rId4" action="ppaction://hlinksldjump"/>
              </a:rPr>
              <a:t>Burst window</a:t>
            </a:r>
            <a:endParaRPr lang="en-US"/>
          </a:p>
          <a:p>
            <a:r>
              <a:rPr lang="en-US">
                <a:hlinkClick r:id="rId5" action="ppaction://hlinksldjump"/>
              </a:rPr>
              <a:t>Single spike</a:t>
            </a:r>
            <a:endParaRPr lang="en-US"/>
          </a:p>
          <a:p>
            <a:r>
              <a:rPr lang="en-US">
                <a:hlinkClick r:id="rId6" action="ppaction://hlinksldjump"/>
              </a:rPr>
              <a:t>Single spike number</a:t>
            </a:r>
            <a:endParaRPr lang="en-US"/>
          </a:p>
          <a:p>
            <a:r>
              <a:rPr lang="en-US">
                <a:hlinkClick r:id="rId7" action="ppaction://hlinksldjump"/>
              </a:rPr>
              <a:t>Burst</a:t>
            </a:r>
            <a:endParaRPr lang="en-US"/>
          </a:p>
          <a:p>
            <a:r>
              <a:rPr lang="en-US">
                <a:hlinkClick r:id="rId8" action="ppaction://hlinksldjump"/>
              </a:rPr>
              <a:t>Burst number</a:t>
            </a:r>
            <a:endParaRPr lang="en-US"/>
          </a:p>
          <a:p>
            <a:r>
              <a:rPr lang="en-US">
                <a:hlinkClick r:id="rId9" action="ppaction://hlinksldjump"/>
              </a:rPr>
              <a:t>Burst start time</a:t>
            </a:r>
            <a:endParaRPr lang="en-US"/>
          </a:p>
          <a:p>
            <a:r>
              <a:rPr lang="en-US">
                <a:hlinkClick r:id="rId10" action="ppaction://hlinksldjump"/>
              </a:rPr>
              <a:t>Spikes per burst</a:t>
            </a:r>
            <a:endParaRPr lang="en-US"/>
          </a:p>
          <a:p>
            <a:r>
              <a:rPr lang="en-US">
                <a:hlinkClick r:id="rId11" action="ppaction://hlinksldjump"/>
              </a:rPr>
              <a:t>Intra-burst interval</a:t>
            </a:r>
            <a:endParaRPr lang="en-US"/>
          </a:p>
          <a:p>
            <a:r>
              <a:rPr lang="en-US">
                <a:hlinkClick r:id="rId12" action="ppaction://hlinksldjump"/>
              </a:rPr>
              <a:t>Burst duration</a:t>
            </a:r>
            <a:endParaRPr lang="en-US"/>
          </a:p>
          <a:p>
            <a:r>
              <a:rPr lang="en-US">
                <a:hlinkClick r:id="rId13" action="ppaction://hlinksldjump"/>
              </a:rPr>
              <a:t>Event</a:t>
            </a:r>
            <a:endParaRPr lang="en-US"/>
          </a:p>
          <a:p>
            <a:r>
              <a:rPr lang="en-US">
                <a:hlinkClick r:id="rId14" action="ppaction://hlinksldjump"/>
              </a:rPr>
              <a:t>Inter-event interval</a:t>
            </a:r>
            <a:endParaRPr lang="en-US"/>
          </a:p>
          <a:p>
            <a:r>
              <a:rPr lang="en-US">
                <a:hlinkClick r:id="rId15" action="ppaction://hlinksldjump"/>
              </a:rPr>
              <a:t>Gap</a:t>
            </a:r>
            <a:endParaRPr lang="en-US"/>
          </a:p>
          <a:p>
            <a:r>
              <a:rPr lang="en-US">
                <a:hlinkClick r:id="rId16" action="ppaction://hlinksldjump"/>
              </a:rPr>
              <a:t>Total duration</a:t>
            </a:r>
            <a:endParaRPr lang="en-US"/>
          </a:p>
          <a:p>
            <a:r>
              <a:rPr lang="en-US">
                <a:hlinkClick r:id="rId17" action="ppaction://hlinksldjump"/>
              </a:rPr>
              <a:t>Recording duration</a:t>
            </a:r>
            <a:endParaRPr lang="en-US"/>
          </a:p>
          <a:p>
            <a:r>
              <a:rPr lang="en-US">
                <a:hlinkClick r:id="rId18" action="ppaction://hlinksldjump"/>
              </a:rPr>
              <a:t>Burst frequency</a:t>
            </a:r>
            <a:endParaRPr lang="en-US"/>
          </a:p>
          <a:p>
            <a:r>
              <a:rPr lang="en-US">
                <a:hlinkClick r:id="rId19" action="ppaction://hlinksldjump"/>
              </a:rPr>
              <a:t>Single spike frequency</a:t>
            </a:r>
            <a:endParaRPr lang="en-US"/>
          </a:p>
          <a:p>
            <a:r>
              <a:rPr lang="en-US">
                <a:hlinkClick r:id="rId20" action="ppaction://hlinksldjump"/>
              </a:rPr>
              <a:t>Total frequency</a:t>
            </a:r>
            <a:endParaRPr lang="en-US"/>
          </a:p>
          <a:p>
            <a:r>
              <a:rPr lang="en-US">
                <a:hlinkClick r:id="rId21" action="ppaction://hlinksldjump"/>
              </a:rPr>
              <a:t>Gap starts + gap ends</a:t>
            </a:r>
            <a:endParaRPr lang="en-US"/>
          </a:p>
          <a:p>
            <a:r>
              <a:rPr lang="en-US">
                <a:hlinkClick r:id="rId22" action="ppaction://hlinksldjump"/>
              </a:rPr>
              <a:t>Gaps + recording times</a:t>
            </a:r>
            <a:endParaRPr lang="en-US"/>
          </a:p>
          <a:p>
            <a:r>
              <a:rPr lang="en-US">
                <a:hlinkClick r:id="rId23" action="ppaction://hlinksldjump"/>
              </a:rPr>
              <a:t>Backward intervals to gaps</a:t>
            </a:r>
            <a:endParaRPr lang="en-US"/>
          </a:p>
          <a:p>
            <a:r>
              <a:rPr lang="en-US">
                <a:hlinkClick r:id="rId24" action="ppaction://hlinksldjump"/>
              </a:rPr>
              <a:t>Forward intervals to gaps</a:t>
            </a:r>
            <a:endParaRPr lang="en-US"/>
          </a:p>
          <a:p>
            <a:r>
              <a:rPr lang="en-US">
                <a:hlinkClick r:id="rId25" action="ppaction://hlinksldjump"/>
              </a:rPr>
              <a:t>Interval gap flag</a:t>
            </a:r>
            <a:endParaRPr lang="en-US"/>
          </a:p>
          <a:p>
            <a:r>
              <a:rPr lang="en-US">
                <a:hlinkClick r:id="rId26" action="ppaction://hlinksldjump"/>
              </a:rPr>
              <a:t>Mean interevent interval</a:t>
            </a:r>
            <a:endParaRPr lang="en-US"/>
          </a:p>
          <a:p>
            <a:r>
              <a:rPr lang="en-US">
                <a:hlinkClick r:id="rId27" action="ppaction://hlinksldjump"/>
              </a:rPr>
              <a:t>Mean intra-burst interval</a:t>
            </a:r>
            <a:endParaRPr lang="en-US"/>
          </a:p>
          <a:p>
            <a:r>
              <a:rPr lang="en-US">
                <a:hlinkClick r:id="rId28" action="ppaction://hlinksldjump"/>
              </a:rPr>
              <a:t>Single spike doubt flag</a:t>
            </a:r>
            <a:endParaRPr lang="en-US"/>
          </a:p>
          <a:p>
            <a:r>
              <a:rPr lang="en-US">
                <a:hlinkClick r:id="rId29" action="ppaction://hlinksldjump"/>
              </a:rPr>
              <a:t>Burst doubt flag</a:t>
            </a:r>
            <a:endParaRPr lang="en-US"/>
          </a:p>
          <a:p>
            <a:r>
              <a:rPr lang="en-US">
                <a:hlinkClick r:id="rId30" action="ppaction://hlinksldjump"/>
              </a:rPr>
              <a:t>Regions</a:t>
            </a:r>
            <a:endParaRPr lang="en-US"/>
          </a:p>
          <a:p>
            <a:r>
              <a:rPr lang="en-US">
                <a:hlinkClick r:id="rId31" action="ppaction://hlinksldjump"/>
              </a:rPr>
              <a:t>Current region processing</a:t>
            </a:r>
            <a:endParaRPr lang="en-US"/>
          </a:p>
          <a:p>
            <a:r>
              <a:rPr lang="en-US">
                <a:hlinkClick r:id="rId32" action="ppaction://hlinksldjump"/>
              </a:rPr>
              <a:t>“Ideal” region processing</a:t>
            </a:r>
            <a:endParaRPr lang="en-US"/>
          </a:p>
          <a:p>
            <a:endParaRPr lang="en-US"/>
          </a:p>
        </p:txBody>
      </p:sp>
    </p:spTree>
    <p:extLst>
      <p:ext uri="{BB962C8B-B14F-4D97-AF65-F5344CB8AC3E}">
        <p14:creationId xmlns:p14="http://schemas.microsoft.com/office/powerpoint/2010/main" val="392072494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Single spike frequency (</a:t>
            </a:r>
            <a:r>
              <a:rPr lang="en-US" sz="3600" b="1" err="1">
                <a:solidFill>
                  <a:srgbClr val="7030A0"/>
                </a:solidFill>
              </a:rPr>
              <a:t>ssf</a:t>
            </a:r>
            <a:r>
              <a:rPr lang="en-US" sz="3600" b="1">
                <a:solidFill>
                  <a:srgbClr val="7030A0"/>
                </a:solidFill>
              </a:rPr>
              <a:t>): </a:t>
            </a:r>
            <a:r>
              <a:rPr lang="en-US" sz="3600"/>
              <a:t>The frequency, in Hz, of single spikes during the recording. This is the number of single spikes divided by the recording duration.</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9" name="Rectangle 38">
            <a:extLst>
              <a:ext uri="{FF2B5EF4-FFF2-40B4-BE49-F238E27FC236}">
                <a16:creationId xmlns:a16="http://schemas.microsoft.com/office/drawing/2014/main" id="{27D58888-A601-43D8-83DB-2A7A24D06105}"/>
              </a:ext>
            </a:extLst>
          </p:cNvPr>
          <p:cNvSpPr/>
          <p:nvPr/>
        </p:nvSpPr>
        <p:spPr>
          <a:xfrm>
            <a:off x="5288353"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0" name="Straight Connector 39">
            <a:extLst>
              <a:ext uri="{FF2B5EF4-FFF2-40B4-BE49-F238E27FC236}">
                <a16:creationId xmlns:a16="http://schemas.microsoft.com/office/drawing/2014/main" id="{B0C75C54-9777-4355-8ED0-3AE4B6C24E65}"/>
              </a:ext>
            </a:extLst>
          </p:cNvPr>
          <p:cNvCxnSpPr>
            <a:cxnSpLocks/>
          </p:cNvCxnSpPr>
          <p:nvPr/>
        </p:nvCxnSpPr>
        <p:spPr>
          <a:xfrm>
            <a:off x="151703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07A3D001-4343-440F-BC09-7E755AEADA54}"/>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D5E5D010-18E1-4583-B741-EA7A7CBDAB0C}"/>
              </a:ext>
            </a:extLst>
          </p:cNvPr>
          <p:cNvCxnSpPr>
            <a:cxnSpLocks/>
          </p:cNvCxnSpPr>
          <p:nvPr/>
        </p:nvCxnSpPr>
        <p:spPr>
          <a:xfrm>
            <a:off x="503883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1CCEBE3F-5D3F-4DE3-95CA-2B40DB4D4D47}"/>
              </a:ext>
            </a:extLst>
          </p:cNvPr>
          <p:cNvCxnSpPr>
            <a:cxnSpLocks/>
          </p:cNvCxnSpPr>
          <p:nvPr/>
        </p:nvCxnSpPr>
        <p:spPr>
          <a:xfrm>
            <a:off x="805750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2371B90C-54E3-4226-B6E2-0E4170CE025D}"/>
              </a:ext>
            </a:extLst>
          </p:cNvPr>
          <p:cNvCxnSpPr>
            <a:cxnSpLocks/>
          </p:cNvCxnSpPr>
          <p:nvPr/>
        </p:nvCxnSpPr>
        <p:spPr>
          <a:xfrm>
            <a:off x="1006996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TextBox 60">
            <a:extLst>
              <a:ext uri="{FF2B5EF4-FFF2-40B4-BE49-F238E27FC236}">
                <a16:creationId xmlns:a16="http://schemas.microsoft.com/office/drawing/2014/main" id="{E1FD9494-E437-48FB-88EE-289A911AB776}"/>
              </a:ext>
            </a:extLst>
          </p:cNvPr>
          <p:cNvSpPr txBox="1"/>
          <p:nvPr/>
        </p:nvSpPr>
        <p:spPr>
          <a:xfrm>
            <a:off x="1360586"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a:t>
            </a:r>
          </a:p>
        </p:txBody>
      </p:sp>
      <p:sp>
        <p:nvSpPr>
          <p:cNvPr id="64" name="TextBox 63">
            <a:extLst>
              <a:ext uri="{FF2B5EF4-FFF2-40B4-BE49-F238E27FC236}">
                <a16:creationId xmlns:a16="http://schemas.microsoft.com/office/drawing/2014/main" id="{CAD81215-1598-44A5-BCB5-6E1329FC06CB}"/>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8" name="TextBox 67">
            <a:extLst>
              <a:ext uri="{FF2B5EF4-FFF2-40B4-BE49-F238E27FC236}">
                <a16:creationId xmlns:a16="http://schemas.microsoft.com/office/drawing/2014/main" id="{C9FF9BF8-2DBF-49BB-BB74-CBBEB5494177}"/>
              </a:ext>
            </a:extLst>
          </p:cNvPr>
          <p:cNvSpPr txBox="1"/>
          <p:nvPr/>
        </p:nvSpPr>
        <p:spPr>
          <a:xfrm>
            <a:off x="488237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8</a:t>
            </a:r>
          </a:p>
        </p:txBody>
      </p:sp>
      <p:sp>
        <p:nvSpPr>
          <p:cNvPr id="74" name="TextBox 73">
            <a:extLst>
              <a:ext uri="{FF2B5EF4-FFF2-40B4-BE49-F238E27FC236}">
                <a16:creationId xmlns:a16="http://schemas.microsoft.com/office/drawing/2014/main" id="{11AADA4F-09DC-4B0C-B8CE-8E626421B549}"/>
              </a:ext>
            </a:extLst>
          </p:cNvPr>
          <p:cNvSpPr txBox="1"/>
          <p:nvPr/>
        </p:nvSpPr>
        <p:spPr>
          <a:xfrm>
            <a:off x="7836935"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4</a:t>
            </a:r>
          </a:p>
        </p:txBody>
      </p:sp>
      <p:sp>
        <p:nvSpPr>
          <p:cNvPr id="78" name="TextBox 77">
            <a:extLst>
              <a:ext uri="{FF2B5EF4-FFF2-40B4-BE49-F238E27FC236}">
                <a16:creationId xmlns:a16="http://schemas.microsoft.com/office/drawing/2014/main" id="{B8CF1FF0-79B3-483F-9320-EF64775CB397}"/>
              </a:ext>
            </a:extLst>
          </p:cNvPr>
          <p:cNvSpPr txBox="1"/>
          <p:nvPr/>
        </p:nvSpPr>
        <p:spPr>
          <a:xfrm>
            <a:off x="9849387"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8</a:t>
            </a:r>
          </a:p>
        </p:txBody>
      </p:sp>
      <p:sp>
        <p:nvSpPr>
          <p:cNvPr id="80" name="TextBox 79">
            <a:extLst>
              <a:ext uri="{FF2B5EF4-FFF2-40B4-BE49-F238E27FC236}">
                <a16:creationId xmlns:a16="http://schemas.microsoft.com/office/drawing/2014/main" id="{A2F037F8-2EB4-473A-9038-4B493E305455}"/>
              </a:ext>
            </a:extLst>
          </p:cNvPr>
          <p:cNvSpPr txBox="1"/>
          <p:nvPr/>
        </p:nvSpPr>
        <p:spPr>
          <a:xfrm>
            <a:off x="136058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77C95FF9-757E-4031-A501-4E78FD91A8E8}"/>
              </a:ext>
            </a:extLst>
          </p:cNvPr>
          <p:cNvSpPr txBox="1"/>
          <p:nvPr/>
        </p:nvSpPr>
        <p:spPr>
          <a:xfrm>
            <a:off x="286992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3EB1A2A9-F142-481B-BE30-E891504FF6E6}"/>
              </a:ext>
            </a:extLst>
          </p:cNvPr>
          <p:cNvSpPr txBox="1"/>
          <p:nvPr/>
        </p:nvSpPr>
        <p:spPr>
          <a:xfrm>
            <a:off x="488533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3" name="TextBox 82">
            <a:extLst>
              <a:ext uri="{FF2B5EF4-FFF2-40B4-BE49-F238E27FC236}">
                <a16:creationId xmlns:a16="http://schemas.microsoft.com/office/drawing/2014/main" id="{8BD4B837-7EC9-4D46-B106-CAD6EAC86DAF}"/>
              </a:ext>
            </a:extLst>
          </p:cNvPr>
          <p:cNvSpPr txBox="1"/>
          <p:nvPr/>
        </p:nvSpPr>
        <p:spPr>
          <a:xfrm>
            <a:off x="790105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84" name="TextBox 83">
            <a:extLst>
              <a:ext uri="{FF2B5EF4-FFF2-40B4-BE49-F238E27FC236}">
                <a16:creationId xmlns:a16="http://schemas.microsoft.com/office/drawing/2014/main" id="{E3215548-D849-49A7-9A83-98B26F95F25B}"/>
              </a:ext>
            </a:extLst>
          </p:cNvPr>
          <p:cNvSpPr txBox="1"/>
          <p:nvPr/>
        </p:nvSpPr>
        <p:spPr>
          <a:xfrm>
            <a:off x="991350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99" name="TextBox 98">
            <a:extLst>
              <a:ext uri="{FF2B5EF4-FFF2-40B4-BE49-F238E27FC236}">
                <a16:creationId xmlns:a16="http://schemas.microsoft.com/office/drawing/2014/main" id="{57A54BF0-E63B-4D90-8391-0278D839B39D}"/>
              </a:ext>
            </a:extLst>
          </p:cNvPr>
          <p:cNvSpPr txBox="1"/>
          <p:nvPr/>
        </p:nvSpPr>
        <p:spPr>
          <a:xfrm>
            <a:off x="5427696" y="3334430"/>
            <a:ext cx="736099" cy="646331"/>
          </a:xfrm>
          <a:prstGeom prst="rect">
            <a:avLst/>
          </a:prstGeom>
          <a:noFill/>
        </p:spPr>
        <p:txBody>
          <a:bodyPr wrap="none" rtlCol="0">
            <a:spAutoFit/>
          </a:bodyPr>
          <a:lstStyle/>
          <a:p>
            <a:pPr algn="ctr"/>
            <a:r>
              <a:rPr lang="en-US"/>
              <a:t>GAP</a:t>
            </a:r>
          </a:p>
          <a:p>
            <a:pPr algn="ctr"/>
            <a:r>
              <a:rPr lang="en-US"/>
              <a:t>2 sec</a:t>
            </a:r>
          </a:p>
        </p:txBody>
      </p:sp>
      <mc:AlternateContent xmlns:mc="http://schemas.openxmlformats.org/markup-compatibility/2006">
        <mc:Choice xmlns:a14="http://schemas.microsoft.com/office/drawing/2010/main" Requires="a14">
          <p:sp>
            <p:nvSpPr>
              <p:cNvPr id="98" name="TextBox 97">
                <a:extLst>
                  <a:ext uri="{FF2B5EF4-FFF2-40B4-BE49-F238E27FC236}">
                    <a16:creationId xmlns:a16="http://schemas.microsoft.com/office/drawing/2014/main" id="{00D45527-E47C-4639-B2B4-62FA826EA551}"/>
                  </a:ext>
                </a:extLst>
              </p:cNvPr>
              <p:cNvSpPr txBox="1"/>
              <p:nvPr/>
            </p:nvSpPr>
            <p:spPr>
              <a:xfrm>
                <a:off x="2549784" y="5892094"/>
                <a:ext cx="7092454" cy="88755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ssf = </a:t>
                </a:r>
                <a14:m>
                  <m:oMath xmlns:m="http://schemas.openxmlformats.org/officeDocument/2006/math">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𝑠𝑠𝑛</m:t>
                        </m:r>
                      </m:num>
                      <m:den>
                        <m:r>
                          <a:rPr lang="en-US" sz="3600" b="0" i="1" smtClean="0">
                            <a:solidFill>
                              <a:schemeClr val="accent1"/>
                            </a:solidFill>
                            <a:latin typeface="Cambria Math" panose="02040503050406030204" pitchFamily="18" charset="0"/>
                          </a:rPr>
                          <m:t>𝑟𝑒𝑐</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𝑑𝑢𝑟</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5</m:t>
                        </m:r>
                      </m:num>
                      <m:den>
                        <m:r>
                          <a:rPr lang="en-US" sz="3600" b="0" i="1" smtClean="0">
                            <a:solidFill>
                              <a:schemeClr val="accent1"/>
                            </a:solidFill>
                            <a:latin typeface="Cambria Math" panose="02040503050406030204" pitchFamily="18" charset="0"/>
                          </a:rPr>
                          <m:t>20−2</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5</m:t>
                        </m:r>
                      </m:num>
                      <m:den>
                        <m:r>
                          <a:rPr lang="en-US" sz="3600" b="0" i="1" smtClean="0">
                            <a:solidFill>
                              <a:schemeClr val="accent1"/>
                            </a:solidFill>
                            <a:latin typeface="Cambria Math" panose="02040503050406030204" pitchFamily="18" charset="0"/>
                          </a:rPr>
                          <m:t>18</m:t>
                        </m:r>
                      </m:den>
                    </m:f>
                    <m:r>
                      <a:rPr lang="en-US" sz="3600" b="0" i="1" smtClean="0">
                        <a:solidFill>
                          <a:schemeClr val="accent1"/>
                        </a:solidFill>
                        <a:latin typeface="Cambria Math" panose="02040503050406030204" pitchFamily="18" charset="0"/>
                      </a:rPr>
                      <m:t>=.278 </m:t>
                    </m:r>
                    <m:r>
                      <a:rPr lang="en-US" sz="3600" b="0" i="1" smtClean="0">
                        <a:solidFill>
                          <a:schemeClr val="accent1"/>
                        </a:solidFill>
                        <a:latin typeface="Cambria Math" panose="02040503050406030204" pitchFamily="18" charset="0"/>
                      </a:rPr>
                      <m:t>𝐻𝑧</m:t>
                    </m:r>
                  </m:oMath>
                </a14:m>
                <a:endParaRPr lang="en-US" sz="3600">
                  <a:solidFill>
                    <a:schemeClr val="accent1"/>
                  </a:solidFill>
                </a:endParaRPr>
              </a:p>
            </p:txBody>
          </p:sp>
        </mc:Choice>
        <mc:Fallback>
          <p:sp>
            <p:nvSpPr>
              <p:cNvPr id="98" name="TextBox 97">
                <a:extLst>
                  <a:ext uri="{FF2B5EF4-FFF2-40B4-BE49-F238E27FC236}">
                    <a16:creationId xmlns:a16="http://schemas.microsoft.com/office/drawing/2014/main" id="{00D45527-E47C-4639-B2B4-62FA826EA551}"/>
                  </a:ext>
                </a:extLst>
              </p:cNvPr>
              <p:cNvSpPr txBox="1">
                <a:spLocks noRot="1" noChangeAspect="1" noMove="1" noResize="1" noEditPoints="1" noAdjustHandles="1" noChangeArrowheads="1" noChangeShapeType="1" noTextEdit="1"/>
              </p:cNvSpPr>
              <p:nvPr/>
            </p:nvSpPr>
            <p:spPr>
              <a:xfrm>
                <a:off x="2549784" y="5892094"/>
                <a:ext cx="7092454" cy="887551"/>
              </a:xfrm>
              <a:prstGeom prst="rect">
                <a:avLst/>
              </a:prstGeom>
              <a:blipFill>
                <a:blip r:embed="rId2"/>
                <a:stretch>
                  <a:fillRect l="-2148" b="-11034"/>
                </a:stretch>
              </a:blipFill>
            </p:spPr>
            <p:txBody>
              <a:bodyPr/>
              <a:lstStyle/>
              <a:p>
                <a:r>
                  <a:rPr lang="en-US">
                    <a:noFill/>
                  </a:rPr>
                  <a:t> </a:t>
                </a:r>
              </a:p>
            </p:txBody>
          </p:sp>
        </mc:Fallback>
      </mc:AlternateContent>
    </p:spTree>
    <p:extLst>
      <p:ext uri="{BB962C8B-B14F-4D97-AF65-F5344CB8AC3E}">
        <p14:creationId xmlns:p14="http://schemas.microsoft.com/office/powerpoint/2010/main" val="196045744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Total Frequency: </a:t>
            </a:r>
            <a:r>
              <a:rPr lang="en-US" sz="3600"/>
              <a:t>The frequency, in Hz, of total spikes during the recording. This is the number of spikes divided by the recording duration</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5E6CC999-542D-450B-9072-1D8886BE890D}"/>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08F7E712-5429-455C-9EFB-D74CDF210A04}"/>
              </a:ext>
            </a:extLst>
          </p:cNvPr>
          <p:cNvCxnSpPr>
            <a:cxnSpLocks/>
          </p:cNvCxnSpPr>
          <p:nvPr/>
        </p:nvCxnSpPr>
        <p:spPr>
          <a:xfrm>
            <a:off x="5541943"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F9A5C009-1910-496B-A7C1-1822970F0A54}"/>
              </a:ext>
            </a:extLst>
          </p:cNvPr>
          <p:cNvCxnSpPr>
            <a:cxnSpLocks/>
          </p:cNvCxnSpPr>
          <p:nvPr/>
        </p:nvCxnSpPr>
        <p:spPr>
          <a:xfrm>
            <a:off x="6045056"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B66BFC10-08DE-48B5-B23A-6F183F082A13}"/>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743E1477-59EB-44BF-9DB3-3C6A7A8C082D}"/>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11323809-9FDA-4F29-A82C-AA0FBACD5790}"/>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3" name="TextBox 12">
            <a:extLst>
              <a:ext uri="{FF2B5EF4-FFF2-40B4-BE49-F238E27FC236}">
                <a16:creationId xmlns:a16="http://schemas.microsoft.com/office/drawing/2014/main" id="{063F1761-4EAD-40E2-BD14-2EEF411621C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4" name="TextBox 13">
            <a:extLst>
              <a:ext uri="{FF2B5EF4-FFF2-40B4-BE49-F238E27FC236}">
                <a16:creationId xmlns:a16="http://schemas.microsoft.com/office/drawing/2014/main" id="{A5B98651-E29F-4D49-A6FB-A631BA5B4E18}"/>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5" name="TextBox 14">
            <a:extLst>
              <a:ext uri="{FF2B5EF4-FFF2-40B4-BE49-F238E27FC236}">
                <a16:creationId xmlns:a16="http://schemas.microsoft.com/office/drawing/2014/main" id="{57DBFBDB-A607-41CD-A042-30EBF2F22D7C}"/>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16" name="TextBox 15">
            <a:extLst>
              <a:ext uri="{FF2B5EF4-FFF2-40B4-BE49-F238E27FC236}">
                <a16:creationId xmlns:a16="http://schemas.microsoft.com/office/drawing/2014/main" id="{EAFA46F0-1EAD-492B-B17F-9B66C38F660F}"/>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17" name="TextBox 16">
            <a:extLst>
              <a:ext uri="{FF2B5EF4-FFF2-40B4-BE49-F238E27FC236}">
                <a16:creationId xmlns:a16="http://schemas.microsoft.com/office/drawing/2014/main" id="{7F8CDF7A-FDF6-4DE7-B305-464F6C52B7B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8" name="TextBox 17">
            <a:extLst>
              <a:ext uri="{FF2B5EF4-FFF2-40B4-BE49-F238E27FC236}">
                <a16:creationId xmlns:a16="http://schemas.microsoft.com/office/drawing/2014/main" id="{9F1C46BE-7900-4262-90C3-0471B29061A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0" name="TextBox 19">
            <a:extLst>
              <a:ext uri="{FF2B5EF4-FFF2-40B4-BE49-F238E27FC236}">
                <a16:creationId xmlns:a16="http://schemas.microsoft.com/office/drawing/2014/main" id="{9F438B38-4B5B-42F2-BCB7-6941DD03CAF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21" name="TextBox 20">
            <a:extLst>
              <a:ext uri="{FF2B5EF4-FFF2-40B4-BE49-F238E27FC236}">
                <a16:creationId xmlns:a16="http://schemas.microsoft.com/office/drawing/2014/main" id="{71718F80-5BB8-4AEB-8504-9A2D9A1E5D77}"/>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22" name="TextBox 21">
            <a:extLst>
              <a:ext uri="{FF2B5EF4-FFF2-40B4-BE49-F238E27FC236}">
                <a16:creationId xmlns:a16="http://schemas.microsoft.com/office/drawing/2014/main" id="{586FD3E3-E337-4357-B28A-016395D6231A}"/>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23" name="TextBox 22">
            <a:extLst>
              <a:ext uri="{FF2B5EF4-FFF2-40B4-BE49-F238E27FC236}">
                <a16:creationId xmlns:a16="http://schemas.microsoft.com/office/drawing/2014/main" id="{68CC3645-D8F4-4A75-9408-E695E3B04050}"/>
              </a:ext>
            </a:extLst>
          </p:cNvPr>
          <p:cNvSpPr txBox="1"/>
          <p:nvPr/>
        </p:nvSpPr>
        <p:spPr>
          <a:xfrm>
            <a:off x="639171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24" name="TextBox 23">
            <a:extLst>
              <a:ext uri="{FF2B5EF4-FFF2-40B4-BE49-F238E27FC236}">
                <a16:creationId xmlns:a16="http://schemas.microsoft.com/office/drawing/2014/main" id="{EE8F42A6-71D2-4541-9238-A6F22A7FC8B1}"/>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25" name="TextBox 24">
            <a:extLst>
              <a:ext uri="{FF2B5EF4-FFF2-40B4-BE49-F238E27FC236}">
                <a16:creationId xmlns:a16="http://schemas.microsoft.com/office/drawing/2014/main" id="{F07C037D-791F-459D-B32F-24ECE9031F63}"/>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mc:AlternateContent xmlns:mc="http://schemas.openxmlformats.org/markup-compatibility/2006">
        <mc:Choice xmlns:a14="http://schemas.microsoft.com/office/drawing/2010/main" Requires="a14">
          <p:sp>
            <p:nvSpPr>
              <p:cNvPr id="31" name="TextBox 30">
                <a:extLst>
                  <a:ext uri="{FF2B5EF4-FFF2-40B4-BE49-F238E27FC236}">
                    <a16:creationId xmlns:a16="http://schemas.microsoft.com/office/drawing/2014/main" id="{FE4E92DC-8895-4359-A47E-77E4E2C689FB}"/>
                  </a:ext>
                </a:extLst>
              </p:cNvPr>
              <p:cNvSpPr txBox="1"/>
              <p:nvPr/>
            </p:nvSpPr>
            <p:spPr>
              <a:xfrm>
                <a:off x="2427475" y="5892094"/>
                <a:ext cx="7337073" cy="89922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t</a:t>
                </a:r>
                <a:r>
                  <a:rPr lang="en-US" sz="3600" err="1">
                    <a:solidFill>
                      <a:schemeClr val="accent1"/>
                    </a:solidFill>
                    <a:latin typeface="Arial" panose="020B0604020202020204" pitchFamily="34" charset="0"/>
                  </a:rPr>
                  <a:t>f</a:t>
                </a:r>
                <a:r>
                  <a:rPr lang="en-US" sz="3600">
                    <a:solidFill>
                      <a:schemeClr val="accent1"/>
                    </a:solidFill>
                    <a:latin typeface="Arial" panose="020B0604020202020204" pitchFamily="34" charset="0"/>
                  </a:rPr>
                  <a:t> = </a:t>
                </a:r>
                <a14:m>
                  <m:oMath xmlns:m="http://schemas.openxmlformats.org/officeDocument/2006/math">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𝑜𝑓</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𝑠𝑝𝑖𝑘𝑒𝑠</m:t>
                        </m:r>
                      </m:num>
                      <m:den>
                        <m:r>
                          <a:rPr lang="en-US" sz="3600" b="0" i="1" smtClean="0">
                            <a:solidFill>
                              <a:schemeClr val="accent1"/>
                            </a:solidFill>
                            <a:latin typeface="Cambria Math" panose="02040503050406030204" pitchFamily="18" charset="0"/>
                          </a:rPr>
                          <m:t>𝑟𝑒𝑐</m:t>
                        </m:r>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𝑑𝑢𝑟</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6</m:t>
                        </m:r>
                      </m:num>
                      <m:den>
                        <m:r>
                          <a:rPr lang="en-US" sz="3600" b="0" i="1" smtClean="0">
                            <a:solidFill>
                              <a:schemeClr val="accent1"/>
                            </a:solidFill>
                            <a:latin typeface="Cambria Math" panose="02040503050406030204" pitchFamily="18" charset="0"/>
                          </a:rPr>
                          <m:t>20−2</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6</m:t>
                        </m:r>
                      </m:num>
                      <m:den>
                        <m:r>
                          <a:rPr lang="en-US" sz="3600" b="0" i="1" smtClean="0">
                            <a:solidFill>
                              <a:schemeClr val="accent1"/>
                            </a:solidFill>
                            <a:latin typeface="Cambria Math" panose="02040503050406030204" pitchFamily="18" charset="0"/>
                          </a:rPr>
                          <m:t>18</m:t>
                        </m:r>
                      </m:den>
                    </m:f>
                    <m:r>
                      <a:rPr lang="en-US" sz="3600" b="0" i="1" smtClean="0">
                        <a:solidFill>
                          <a:schemeClr val="accent1"/>
                        </a:solidFill>
                        <a:latin typeface="Cambria Math" panose="02040503050406030204" pitchFamily="18" charset="0"/>
                      </a:rPr>
                      <m:t>=.333 </m:t>
                    </m:r>
                    <m:r>
                      <a:rPr lang="en-US" sz="3600" b="0" i="1" smtClean="0">
                        <a:solidFill>
                          <a:schemeClr val="accent1"/>
                        </a:solidFill>
                        <a:latin typeface="Cambria Math" panose="02040503050406030204" pitchFamily="18" charset="0"/>
                      </a:rPr>
                      <m:t>𝐻𝑧</m:t>
                    </m:r>
                  </m:oMath>
                </a14:m>
                <a:endParaRPr lang="en-US" sz="3600">
                  <a:solidFill>
                    <a:schemeClr val="accent1"/>
                  </a:solidFill>
                </a:endParaRPr>
              </a:p>
            </p:txBody>
          </p:sp>
        </mc:Choice>
        <mc:Fallback>
          <p:sp>
            <p:nvSpPr>
              <p:cNvPr id="31" name="TextBox 30">
                <a:extLst>
                  <a:ext uri="{FF2B5EF4-FFF2-40B4-BE49-F238E27FC236}">
                    <a16:creationId xmlns:a16="http://schemas.microsoft.com/office/drawing/2014/main" id="{FE4E92DC-8895-4359-A47E-77E4E2C689FB}"/>
                  </a:ext>
                </a:extLst>
              </p:cNvPr>
              <p:cNvSpPr txBox="1">
                <a:spLocks noRot="1" noChangeAspect="1" noMove="1" noResize="1" noEditPoints="1" noAdjustHandles="1" noChangeArrowheads="1" noChangeShapeType="1" noTextEdit="1"/>
              </p:cNvSpPr>
              <p:nvPr/>
            </p:nvSpPr>
            <p:spPr>
              <a:xfrm>
                <a:off x="2427475" y="5892094"/>
                <a:ext cx="7337073" cy="899221"/>
              </a:xfrm>
              <a:prstGeom prst="rect">
                <a:avLst/>
              </a:prstGeom>
              <a:blipFill>
                <a:blip r:embed="rId2"/>
                <a:stretch>
                  <a:fillRect l="-2076" b="-10884"/>
                </a:stretch>
              </a:blipFill>
            </p:spPr>
            <p:txBody>
              <a:bodyPr/>
              <a:lstStyle/>
              <a:p>
                <a:r>
                  <a:rPr lang="en-US">
                    <a:noFill/>
                  </a:rPr>
                  <a:t> </a:t>
                </a:r>
              </a:p>
            </p:txBody>
          </p:sp>
        </mc:Fallback>
      </mc:AlternateContent>
    </p:spTree>
    <p:extLst>
      <p:ext uri="{BB962C8B-B14F-4D97-AF65-F5344CB8AC3E}">
        <p14:creationId xmlns:p14="http://schemas.microsoft.com/office/powerpoint/2010/main" val="31828662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Gap starts and ends: </a:t>
            </a:r>
            <a:r>
              <a:rPr lang="en-US" sz="3600"/>
              <a:t>A list of the start times and a list of the end time of gaps during the recording</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7" name="TextBox 36">
            <a:extLst>
              <a:ext uri="{FF2B5EF4-FFF2-40B4-BE49-F238E27FC236}">
                <a16:creationId xmlns:a16="http://schemas.microsoft.com/office/drawing/2014/main" id="{11F4F17E-B198-4662-82B9-FD38C6AFD4A0}"/>
              </a:ext>
            </a:extLst>
          </p:cNvPr>
          <p:cNvSpPr txBox="1"/>
          <p:nvPr/>
        </p:nvSpPr>
        <p:spPr>
          <a:xfrm>
            <a:off x="3689746" y="5198006"/>
            <a:ext cx="4812536" cy="1077218"/>
          </a:xfrm>
          <a:prstGeom prst="rect">
            <a:avLst/>
          </a:prstGeom>
          <a:noFill/>
        </p:spPr>
        <p:txBody>
          <a:bodyPr wrap="none" rtlCol="0">
            <a:spAutoFit/>
          </a:bodyPr>
          <a:lstStyle/>
          <a:p>
            <a:pPr algn="ctr"/>
            <a:r>
              <a:rPr lang="en-US" sz="3200" err="1">
                <a:solidFill>
                  <a:srgbClr val="00B050"/>
                </a:solidFill>
              </a:rPr>
              <a:t>gapStarts</a:t>
            </a:r>
            <a:r>
              <a:rPr lang="en-US" sz="3200">
                <a:solidFill>
                  <a:srgbClr val="00B050"/>
                </a:solidFill>
              </a:rPr>
              <a:t> = [2, 9, 15] sec</a:t>
            </a:r>
          </a:p>
          <a:p>
            <a:pPr algn="ctr"/>
            <a:r>
              <a:rPr lang="en-US" sz="3200" err="1">
                <a:solidFill>
                  <a:srgbClr val="00B050"/>
                </a:solidFill>
              </a:rPr>
              <a:t>gapEnds</a:t>
            </a:r>
            <a:r>
              <a:rPr lang="en-US" sz="3200">
                <a:solidFill>
                  <a:srgbClr val="00B050"/>
                </a:solidFill>
              </a:rPr>
              <a:t> = [4, 11, 17] sec</a:t>
            </a:r>
          </a:p>
        </p:txBody>
      </p:sp>
      <p:sp>
        <p:nvSpPr>
          <p:cNvPr id="78" name="TextBox 77">
            <a:extLst>
              <a:ext uri="{FF2B5EF4-FFF2-40B4-BE49-F238E27FC236}">
                <a16:creationId xmlns:a16="http://schemas.microsoft.com/office/drawing/2014/main" id="{0E8A473B-7FA7-41EA-AA50-EEA7AE38B320}"/>
              </a:ext>
            </a:extLst>
          </p:cNvPr>
          <p:cNvSpPr txBox="1"/>
          <p:nvPr/>
        </p:nvSpPr>
        <p:spPr>
          <a:xfrm>
            <a:off x="1863699"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a:t>
            </a:r>
          </a:p>
        </p:txBody>
      </p:sp>
      <p:sp>
        <p:nvSpPr>
          <p:cNvPr id="80" name="TextBox 79">
            <a:extLst>
              <a:ext uri="{FF2B5EF4-FFF2-40B4-BE49-F238E27FC236}">
                <a16:creationId xmlns:a16="http://schemas.microsoft.com/office/drawing/2014/main" id="{D72A0772-79B8-43B2-8FED-CAFDF2A93F8E}"/>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92" name="TextBox 91">
            <a:extLst>
              <a:ext uri="{FF2B5EF4-FFF2-40B4-BE49-F238E27FC236}">
                <a16:creationId xmlns:a16="http://schemas.microsoft.com/office/drawing/2014/main" id="{BEDD4B03-A226-4C42-85D7-72498DE81B2B}"/>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94" name="TextBox 93">
            <a:extLst>
              <a:ext uri="{FF2B5EF4-FFF2-40B4-BE49-F238E27FC236}">
                <a16:creationId xmlns:a16="http://schemas.microsoft.com/office/drawing/2014/main" id="{34D1A363-E768-43A3-95F2-693699E568D9}"/>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98" name="TextBox 97">
            <a:extLst>
              <a:ext uri="{FF2B5EF4-FFF2-40B4-BE49-F238E27FC236}">
                <a16:creationId xmlns:a16="http://schemas.microsoft.com/office/drawing/2014/main" id="{F062F86A-765C-40A4-8D50-37C65FD1C748}"/>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100" name="TextBox 99">
            <a:extLst>
              <a:ext uri="{FF2B5EF4-FFF2-40B4-BE49-F238E27FC236}">
                <a16:creationId xmlns:a16="http://schemas.microsoft.com/office/drawing/2014/main" id="{A6489FAD-13A8-4BD6-86F3-22737223A8BF}"/>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103" name="Rectangle 102">
            <a:extLst>
              <a:ext uri="{FF2B5EF4-FFF2-40B4-BE49-F238E27FC236}">
                <a16:creationId xmlns:a16="http://schemas.microsoft.com/office/drawing/2014/main" id="{D0A17C3F-26E9-4AC4-9957-CCE77D81134C}"/>
              </a:ext>
            </a:extLst>
          </p:cNvPr>
          <p:cNvSpPr/>
          <p:nvPr/>
        </p:nvSpPr>
        <p:spPr>
          <a:xfrm>
            <a:off x="5541560"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Rectangle 103">
            <a:extLst>
              <a:ext uri="{FF2B5EF4-FFF2-40B4-BE49-F238E27FC236}">
                <a16:creationId xmlns:a16="http://schemas.microsoft.com/office/drawing/2014/main" id="{99E6E7B1-C41A-474E-A32C-5C2B168B28FB}"/>
              </a:ext>
            </a:extLst>
          </p:cNvPr>
          <p:cNvSpPr/>
          <p:nvPr/>
        </p:nvSpPr>
        <p:spPr>
          <a:xfrm>
            <a:off x="2015570"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 name="Rectangle 104">
            <a:extLst>
              <a:ext uri="{FF2B5EF4-FFF2-40B4-BE49-F238E27FC236}">
                <a16:creationId xmlns:a16="http://schemas.microsoft.com/office/drawing/2014/main" id="{ACB24AA2-4FE3-4FEA-AED5-53B5530494F6}"/>
              </a:ext>
            </a:extLst>
          </p:cNvPr>
          <p:cNvSpPr/>
          <p:nvPr/>
        </p:nvSpPr>
        <p:spPr>
          <a:xfrm>
            <a:off x="8552060"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68763902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Gap starts plus end: </a:t>
            </a:r>
            <a:r>
              <a:rPr lang="en-US" sz="3600"/>
              <a:t>A list of the start times of gaps plus the end of the recording</a:t>
            </a:r>
            <a:br>
              <a:rPr lang="en-US" sz="3600"/>
            </a:br>
            <a:r>
              <a:rPr lang="en-US" sz="3600" b="1">
                <a:solidFill>
                  <a:srgbClr val="7030A0"/>
                </a:solidFill>
              </a:rPr>
              <a:t>Gap ends plus start: </a:t>
            </a:r>
            <a:r>
              <a:rPr lang="en-US" sz="3600"/>
              <a:t>A list of the end times of gaps during the start of the recording</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7" name="TextBox 36">
            <a:extLst>
              <a:ext uri="{FF2B5EF4-FFF2-40B4-BE49-F238E27FC236}">
                <a16:creationId xmlns:a16="http://schemas.microsoft.com/office/drawing/2014/main" id="{11F4F17E-B198-4662-82B9-FD38C6AFD4A0}"/>
              </a:ext>
            </a:extLst>
          </p:cNvPr>
          <p:cNvSpPr txBox="1"/>
          <p:nvPr/>
        </p:nvSpPr>
        <p:spPr>
          <a:xfrm>
            <a:off x="2614936" y="5198006"/>
            <a:ext cx="6962162" cy="1077218"/>
          </a:xfrm>
          <a:prstGeom prst="rect">
            <a:avLst/>
          </a:prstGeom>
          <a:noFill/>
        </p:spPr>
        <p:txBody>
          <a:bodyPr wrap="none" rtlCol="0">
            <a:spAutoFit/>
          </a:bodyPr>
          <a:lstStyle/>
          <a:p>
            <a:pPr algn="ctr"/>
            <a:r>
              <a:rPr lang="en-US" sz="3200" err="1">
                <a:solidFill>
                  <a:srgbClr val="00B050"/>
                </a:solidFill>
              </a:rPr>
              <a:t>gapStartsPlusEnd</a:t>
            </a:r>
            <a:r>
              <a:rPr lang="en-US" sz="3200">
                <a:solidFill>
                  <a:srgbClr val="00B050"/>
                </a:solidFill>
              </a:rPr>
              <a:t> = [2, 9, 15, 20] sec</a:t>
            </a:r>
          </a:p>
          <a:p>
            <a:pPr algn="ctr"/>
            <a:r>
              <a:rPr lang="en-US" sz="3200" err="1">
                <a:solidFill>
                  <a:srgbClr val="00B050"/>
                </a:solidFill>
              </a:rPr>
              <a:t>gapEndsPlusStart</a:t>
            </a:r>
            <a:r>
              <a:rPr lang="en-US" sz="3200">
                <a:solidFill>
                  <a:srgbClr val="00B050"/>
                </a:solidFill>
              </a:rPr>
              <a:t> = [0, 4, 11, 17] sec</a:t>
            </a:r>
          </a:p>
        </p:txBody>
      </p:sp>
      <p:sp>
        <p:nvSpPr>
          <p:cNvPr id="78" name="TextBox 77">
            <a:extLst>
              <a:ext uri="{FF2B5EF4-FFF2-40B4-BE49-F238E27FC236}">
                <a16:creationId xmlns:a16="http://schemas.microsoft.com/office/drawing/2014/main" id="{0E8A473B-7FA7-41EA-AA50-EEA7AE38B320}"/>
              </a:ext>
            </a:extLst>
          </p:cNvPr>
          <p:cNvSpPr txBox="1"/>
          <p:nvPr/>
        </p:nvSpPr>
        <p:spPr>
          <a:xfrm>
            <a:off x="1863699"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a:t>
            </a:r>
          </a:p>
        </p:txBody>
      </p:sp>
      <p:sp>
        <p:nvSpPr>
          <p:cNvPr id="80" name="TextBox 79">
            <a:extLst>
              <a:ext uri="{FF2B5EF4-FFF2-40B4-BE49-F238E27FC236}">
                <a16:creationId xmlns:a16="http://schemas.microsoft.com/office/drawing/2014/main" id="{D72A0772-79B8-43B2-8FED-CAFDF2A93F8E}"/>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92" name="TextBox 91">
            <a:extLst>
              <a:ext uri="{FF2B5EF4-FFF2-40B4-BE49-F238E27FC236}">
                <a16:creationId xmlns:a16="http://schemas.microsoft.com/office/drawing/2014/main" id="{BEDD4B03-A226-4C42-85D7-72498DE81B2B}"/>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94" name="TextBox 93">
            <a:extLst>
              <a:ext uri="{FF2B5EF4-FFF2-40B4-BE49-F238E27FC236}">
                <a16:creationId xmlns:a16="http://schemas.microsoft.com/office/drawing/2014/main" id="{34D1A363-E768-43A3-95F2-693699E568D9}"/>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98" name="TextBox 97">
            <a:extLst>
              <a:ext uri="{FF2B5EF4-FFF2-40B4-BE49-F238E27FC236}">
                <a16:creationId xmlns:a16="http://schemas.microsoft.com/office/drawing/2014/main" id="{F062F86A-765C-40A4-8D50-37C65FD1C748}"/>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100" name="TextBox 99">
            <a:extLst>
              <a:ext uri="{FF2B5EF4-FFF2-40B4-BE49-F238E27FC236}">
                <a16:creationId xmlns:a16="http://schemas.microsoft.com/office/drawing/2014/main" id="{A6489FAD-13A8-4BD6-86F3-22737223A8BF}"/>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103" name="Rectangle 102">
            <a:extLst>
              <a:ext uri="{FF2B5EF4-FFF2-40B4-BE49-F238E27FC236}">
                <a16:creationId xmlns:a16="http://schemas.microsoft.com/office/drawing/2014/main" id="{D0A17C3F-26E9-4AC4-9957-CCE77D81134C}"/>
              </a:ext>
            </a:extLst>
          </p:cNvPr>
          <p:cNvSpPr/>
          <p:nvPr/>
        </p:nvSpPr>
        <p:spPr>
          <a:xfrm>
            <a:off x="5541560"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Rectangle 103">
            <a:extLst>
              <a:ext uri="{FF2B5EF4-FFF2-40B4-BE49-F238E27FC236}">
                <a16:creationId xmlns:a16="http://schemas.microsoft.com/office/drawing/2014/main" id="{99E6E7B1-C41A-474E-A32C-5C2B168B28FB}"/>
              </a:ext>
            </a:extLst>
          </p:cNvPr>
          <p:cNvSpPr/>
          <p:nvPr/>
        </p:nvSpPr>
        <p:spPr>
          <a:xfrm>
            <a:off x="2015570"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 name="Rectangle 104">
            <a:extLst>
              <a:ext uri="{FF2B5EF4-FFF2-40B4-BE49-F238E27FC236}">
                <a16:creationId xmlns:a16="http://schemas.microsoft.com/office/drawing/2014/main" id="{ACB24AA2-4FE3-4FEA-AED5-53B5530494F6}"/>
              </a:ext>
            </a:extLst>
          </p:cNvPr>
          <p:cNvSpPr/>
          <p:nvPr/>
        </p:nvSpPr>
        <p:spPr>
          <a:xfrm>
            <a:off x="8552060"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17205892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Backward intervals to gaps: </a:t>
            </a:r>
            <a:r>
              <a:rPr lang="en-US" sz="3600"/>
              <a:t>The interval from the end of the previous gap or start of the recording to the time of the spike. Used to add doubt flags if interval is less than burst window</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7" name="TextBox 36">
            <a:extLst>
              <a:ext uri="{FF2B5EF4-FFF2-40B4-BE49-F238E27FC236}">
                <a16:creationId xmlns:a16="http://schemas.microsoft.com/office/drawing/2014/main" id="{11F4F17E-B198-4662-82B9-FD38C6AFD4A0}"/>
              </a:ext>
            </a:extLst>
          </p:cNvPr>
          <p:cNvSpPr txBox="1"/>
          <p:nvPr/>
        </p:nvSpPr>
        <p:spPr>
          <a:xfrm>
            <a:off x="2342704" y="5198006"/>
            <a:ext cx="7506607" cy="584775"/>
          </a:xfrm>
          <a:prstGeom prst="rect">
            <a:avLst/>
          </a:prstGeom>
          <a:noFill/>
        </p:spPr>
        <p:txBody>
          <a:bodyPr wrap="none" rtlCol="0">
            <a:spAutoFit/>
          </a:bodyPr>
          <a:lstStyle/>
          <a:p>
            <a:pPr algn="ctr"/>
            <a:r>
              <a:rPr lang="en-US" sz="3200" err="1">
                <a:solidFill>
                  <a:srgbClr val="00B050"/>
                </a:solidFill>
              </a:rPr>
              <a:t>backIntervalsToGaps</a:t>
            </a:r>
            <a:r>
              <a:rPr lang="en-US" sz="3200">
                <a:solidFill>
                  <a:srgbClr val="00B050"/>
                </a:solidFill>
              </a:rPr>
              <a:t> = [</a:t>
            </a:r>
            <a:r>
              <a:rPr lang="en-US" sz="3200">
                <a:solidFill>
                  <a:srgbClr val="FF0000"/>
                </a:solidFill>
              </a:rPr>
              <a:t>1</a:t>
            </a:r>
            <a:r>
              <a:rPr lang="en-US" sz="3200">
                <a:solidFill>
                  <a:srgbClr val="00B050"/>
                </a:solidFill>
              </a:rPr>
              <a:t>, 4, 8, 5, 9] sec</a:t>
            </a:r>
          </a:p>
        </p:txBody>
      </p:sp>
      <p:sp>
        <p:nvSpPr>
          <p:cNvPr id="48" name="Rectangle 47">
            <a:extLst>
              <a:ext uri="{FF2B5EF4-FFF2-40B4-BE49-F238E27FC236}">
                <a16:creationId xmlns:a16="http://schemas.microsoft.com/office/drawing/2014/main" id="{5BDDB4A8-E648-450E-B96E-F8D4DD553D1E}"/>
              </a:ext>
            </a:extLst>
          </p:cNvPr>
          <p:cNvSpPr/>
          <p:nvPr/>
        </p:nvSpPr>
        <p:spPr>
          <a:xfrm>
            <a:off x="5541560"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3" name="Straight Connector 52">
            <a:extLst>
              <a:ext uri="{FF2B5EF4-FFF2-40B4-BE49-F238E27FC236}">
                <a16:creationId xmlns:a16="http://schemas.microsoft.com/office/drawing/2014/main" id="{DA4046F3-1FF5-4AF0-89FB-2C774766A340}"/>
              </a:ext>
            </a:extLst>
          </p:cNvPr>
          <p:cNvCxnSpPr>
            <a:cxnSpLocks/>
          </p:cNvCxnSpPr>
          <p:nvPr/>
        </p:nvCxnSpPr>
        <p:spPr>
          <a:xfrm>
            <a:off x="151703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4E2FA796-806A-4296-8581-DFC3A22ECA86}"/>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498CE6F1-5676-4D21-911C-31707F403203}"/>
              </a:ext>
            </a:extLst>
          </p:cNvPr>
          <p:cNvCxnSpPr>
            <a:cxnSpLocks/>
          </p:cNvCxnSpPr>
          <p:nvPr/>
        </p:nvCxnSpPr>
        <p:spPr>
          <a:xfrm>
            <a:off x="503883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70430FA3-15C3-4ACC-B736-B019C8C1BE3F}"/>
              </a:ext>
            </a:extLst>
          </p:cNvPr>
          <p:cNvCxnSpPr>
            <a:cxnSpLocks/>
          </p:cNvCxnSpPr>
          <p:nvPr/>
        </p:nvCxnSpPr>
        <p:spPr>
          <a:xfrm>
            <a:off x="805750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568B8FAB-BB61-40DA-8202-6E34571A5B57}"/>
              </a:ext>
            </a:extLst>
          </p:cNvPr>
          <p:cNvCxnSpPr>
            <a:cxnSpLocks/>
          </p:cNvCxnSpPr>
          <p:nvPr/>
        </p:nvCxnSpPr>
        <p:spPr>
          <a:xfrm>
            <a:off x="1006996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9CB26AC9-A803-4139-B999-2F74AEC0D716}"/>
              </a:ext>
            </a:extLst>
          </p:cNvPr>
          <p:cNvSpPr txBox="1"/>
          <p:nvPr/>
        </p:nvSpPr>
        <p:spPr>
          <a:xfrm>
            <a:off x="1360586"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a:t>
            </a:r>
          </a:p>
        </p:txBody>
      </p:sp>
      <p:sp>
        <p:nvSpPr>
          <p:cNvPr id="70" name="TextBox 69">
            <a:extLst>
              <a:ext uri="{FF2B5EF4-FFF2-40B4-BE49-F238E27FC236}">
                <a16:creationId xmlns:a16="http://schemas.microsoft.com/office/drawing/2014/main" id="{B35F54B4-3BF5-4648-BA5F-839B8217BC62}"/>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71" name="TextBox 70">
            <a:extLst>
              <a:ext uri="{FF2B5EF4-FFF2-40B4-BE49-F238E27FC236}">
                <a16:creationId xmlns:a16="http://schemas.microsoft.com/office/drawing/2014/main" id="{089B2115-724F-40EB-9552-97D19D3C03E3}"/>
              </a:ext>
            </a:extLst>
          </p:cNvPr>
          <p:cNvSpPr txBox="1"/>
          <p:nvPr/>
        </p:nvSpPr>
        <p:spPr>
          <a:xfrm>
            <a:off x="488237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8</a:t>
            </a:r>
          </a:p>
        </p:txBody>
      </p:sp>
      <p:sp>
        <p:nvSpPr>
          <p:cNvPr id="72" name="TextBox 71">
            <a:extLst>
              <a:ext uri="{FF2B5EF4-FFF2-40B4-BE49-F238E27FC236}">
                <a16:creationId xmlns:a16="http://schemas.microsoft.com/office/drawing/2014/main" id="{CF8821E0-4EEE-465E-8798-BFB4F5C8DC2D}"/>
              </a:ext>
            </a:extLst>
          </p:cNvPr>
          <p:cNvSpPr txBox="1"/>
          <p:nvPr/>
        </p:nvSpPr>
        <p:spPr>
          <a:xfrm>
            <a:off x="7836935"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4</a:t>
            </a:r>
          </a:p>
        </p:txBody>
      </p:sp>
      <p:sp>
        <p:nvSpPr>
          <p:cNvPr id="82" name="TextBox 81">
            <a:extLst>
              <a:ext uri="{FF2B5EF4-FFF2-40B4-BE49-F238E27FC236}">
                <a16:creationId xmlns:a16="http://schemas.microsoft.com/office/drawing/2014/main" id="{71266F89-E78D-4096-930C-0FE7CCFEE445}"/>
              </a:ext>
            </a:extLst>
          </p:cNvPr>
          <p:cNvSpPr txBox="1"/>
          <p:nvPr/>
        </p:nvSpPr>
        <p:spPr>
          <a:xfrm>
            <a:off x="9849387"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8</a:t>
            </a:r>
          </a:p>
        </p:txBody>
      </p:sp>
      <p:sp>
        <p:nvSpPr>
          <p:cNvPr id="83" name="TextBox 82">
            <a:extLst>
              <a:ext uri="{FF2B5EF4-FFF2-40B4-BE49-F238E27FC236}">
                <a16:creationId xmlns:a16="http://schemas.microsoft.com/office/drawing/2014/main" id="{1944A02E-85F4-4174-BA79-16515F18AE10}"/>
              </a:ext>
            </a:extLst>
          </p:cNvPr>
          <p:cNvSpPr txBox="1"/>
          <p:nvPr/>
        </p:nvSpPr>
        <p:spPr>
          <a:xfrm>
            <a:off x="136058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4" name="TextBox 83">
            <a:extLst>
              <a:ext uri="{FF2B5EF4-FFF2-40B4-BE49-F238E27FC236}">
                <a16:creationId xmlns:a16="http://schemas.microsoft.com/office/drawing/2014/main" id="{22D67E9D-5062-4A87-A030-A820008E3850}"/>
              </a:ext>
            </a:extLst>
          </p:cNvPr>
          <p:cNvSpPr txBox="1"/>
          <p:nvPr/>
        </p:nvSpPr>
        <p:spPr>
          <a:xfrm>
            <a:off x="286992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5" name="TextBox 84">
            <a:extLst>
              <a:ext uri="{FF2B5EF4-FFF2-40B4-BE49-F238E27FC236}">
                <a16:creationId xmlns:a16="http://schemas.microsoft.com/office/drawing/2014/main" id="{359C128B-6D73-42B9-933D-679813012B6B}"/>
              </a:ext>
            </a:extLst>
          </p:cNvPr>
          <p:cNvSpPr txBox="1"/>
          <p:nvPr/>
        </p:nvSpPr>
        <p:spPr>
          <a:xfrm>
            <a:off x="488533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6" name="TextBox 85">
            <a:extLst>
              <a:ext uri="{FF2B5EF4-FFF2-40B4-BE49-F238E27FC236}">
                <a16:creationId xmlns:a16="http://schemas.microsoft.com/office/drawing/2014/main" id="{742A3144-C6B4-46BE-93AE-D1A8B320876D}"/>
              </a:ext>
            </a:extLst>
          </p:cNvPr>
          <p:cNvSpPr txBox="1"/>
          <p:nvPr/>
        </p:nvSpPr>
        <p:spPr>
          <a:xfrm>
            <a:off x="790105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87" name="TextBox 86">
            <a:extLst>
              <a:ext uri="{FF2B5EF4-FFF2-40B4-BE49-F238E27FC236}">
                <a16:creationId xmlns:a16="http://schemas.microsoft.com/office/drawing/2014/main" id="{AF44DBA4-9024-49AF-8F00-134BE9E470C0}"/>
              </a:ext>
            </a:extLst>
          </p:cNvPr>
          <p:cNvSpPr txBox="1"/>
          <p:nvPr/>
        </p:nvSpPr>
        <p:spPr>
          <a:xfrm>
            <a:off x="991350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88" name="TextBox 87">
            <a:extLst>
              <a:ext uri="{FF2B5EF4-FFF2-40B4-BE49-F238E27FC236}">
                <a16:creationId xmlns:a16="http://schemas.microsoft.com/office/drawing/2014/main" id="{3CCD7D92-4DAA-40EA-97F9-DF5BF51CCACC}"/>
              </a:ext>
            </a:extLst>
          </p:cNvPr>
          <p:cNvSpPr txBox="1"/>
          <p:nvPr/>
        </p:nvSpPr>
        <p:spPr>
          <a:xfrm>
            <a:off x="5680903" y="3334430"/>
            <a:ext cx="736099" cy="646331"/>
          </a:xfrm>
          <a:prstGeom prst="rect">
            <a:avLst/>
          </a:prstGeom>
          <a:noFill/>
        </p:spPr>
        <p:txBody>
          <a:bodyPr wrap="none" rtlCol="0">
            <a:spAutoFit/>
          </a:bodyPr>
          <a:lstStyle/>
          <a:p>
            <a:pPr algn="ctr"/>
            <a:r>
              <a:rPr lang="en-US"/>
              <a:t>GAP</a:t>
            </a:r>
          </a:p>
          <a:p>
            <a:pPr algn="ctr"/>
            <a:r>
              <a:rPr lang="en-US"/>
              <a:t>2 sec</a:t>
            </a:r>
          </a:p>
        </p:txBody>
      </p:sp>
      <p:cxnSp>
        <p:nvCxnSpPr>
          <p:cNvPr id="32" name="Straight Connector 31">
            <a:extLst>
              <a:ext uri="{FF2B5EF4-FFF2-40B4-BE49-F238E27FC236}">
                <a16:creationId xmlns:a16="http://schemas.microsoft.com/office/drawing/2014/main" id="{9615E0FF-C953-446C-AB32-AB262B8CDFF7}"/>
              </a:ext>
            </a:extLst>
          </p:cNvPr>
          <p:cNvCxnSpPr>
            <a:cxnSpLocks/>
          </p:cNvCxnSpPr>
          <p:nvPr/>
        </p:nvCxnSpPr>
        <p:spPr>
          <a:xfrm>
            <a:off x="1013926" y="2898059"/>
            <a:ext cx="503113"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85073BB6-ABAF-4902-AAA3-55A0094E4DD4}"/>
              </a:ext>
            </a:extLst>
          </p:cNvPr>
          <p:cNvCxnSpPr>
            <a:cxnSpLocks/>
          </p:cNvCxnSpPr>
          <p:nvPr/>
        </p:nvCxnSpPr>
        <p:spPr>
          <a:xfrm>
            <a:off x="1005089" y="3362262"/>
            <a:ext cx="2021289"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90C87663-491B-4516-AA66-0E82ACAC0ABF}"/>
              </a:ext>
            </a:extLst>
          </p:cNvPr>
          <p:cNvCxnSpPr>
            <a:cxnSpLocks/>
          </p:cNvCxnSpPr>
          <p:nvPr/>
        </p:nvCxnSpPr>
        <p:spPr>
          <a:xfrm>
            <a:off x="1013926" y="3826464"/>
            <a:ext cx="4024904"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DAD3936B-4228-46A3-A38B-5BA45E6C367E}"/>
              </a:ext>
            </a:extLst>
          </p:cNvPr>
          <p:cNvCxnSpPr>
            <a:cxnSpLocks/>
          </p:cNvCxnSpPr>
          <p:nvPr/>
        </p:nvCxnSpPr>
        <p:spPr>
          <a:xfrm>
            <a:off x="5550397" y="2898059"/>
            <a:ext cx="250711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E36C1C09-DD66-466D-8A58-6FE600D21C8E}"/>
              </a:ext>
            </a:extLst>
          </p:cNvPr>
          <p:cNvCxnSpPr>
            <a:cxnSpLocks/>
          </p:cNvCxnSpPr>
          <p:nvPr/>
        </p:nvCxnSpPr>
        <p:spPr>
          <a:xfrm>
            <a:off x="5541560" y="3362262"/>
            <a:ext cx="4528400" cy="0"/>
          </a:xfrm>
          <a:prstGeom prst="line">
            <a:avLst/>
          </a:prstGeom>
        </p:spPr>
        <p:style>
          <a:lnRef idx="1">
            <a:schemeClr val="accent1"/>
          </a:lnRef>
          <a:fillRef idx="0">
            <a:schemeClr val="accent1"/>
          </a:fillRef>
          <a:effectRef idx="0">
            <a:schemeClr val="accent1"/>
          </a:effectRef>
          <a:fontRef idx="minor">
            <a:schemeClr val="tx1"/>
          </a:fontRef>
        </p:style>
      </p:cxnSp>
      <p:sp>
        <p:nvSpPr>
          <p:cNvPr id="47" name="TextBox 46">
            <a:extLst>
              <a:ext uri="{FF2B5EF4-FFF2-40B4-BE49-F238E27FC236}">
                <a16:creationId xmlns:a16="http://schemas.microsoft.com/office/drawing/2014/main" id="{F720D460-AE7D-43B2-8729-4BBC48C288C6}"/>
              </a:ext>
            </a:extLst>
          </p:cNvPr>
          <p:cNvSpPr txBox="1"/>
          <p:nvPr/>
        </p:nvSpPr>
        <p:spPr>
          <a:xfrm>
            <a:off x="1116132" y="2566968"/>
            <a:ext cx="298699" cy="369332"/>
          </a:xfrm>
          <a:prstGeom prst="rect">
            <a:avLst/>
          </a:prstGeom>
          <a:noFill/>
        </p:spPr>
        <p:txBody>
          <a:bodyPr wrap="square" rtlCol="0">
            <a:spAutoFit/>
          </a:bodyPr>
          <a:lstStyle/>
          <a:p>
            <a:pPr algn="ctr"/>
            <a:r>
              <a:rPr lang="en-US">
                <a:solidFill>
                  <a:srgbClr val="FF0000"/>
                </a:solidFill>
              </a:rPr>
              <a:t>1</a:t>
            </a:r>
          </a:p>
        </p:txBody>
      </p:sp>
      <p:sp>
        <p:nvSpPr>
          <p:cNvPr id="49" name="TextBox 48">
            <a:extLst>
              <a:ext uri="{FF2B5EF4-FFF2-40B4-BE49-F238E27FC236}">
                <a16:creationId xmlns:a16="http://schemas.microsoft.com/office/drawing/2014/main" id="{8B6BD669-7569-4BD9-9205-25FEA5B77759}"/>
              </a:ext>
            </a:extLst>
          </p:cNvPr>
          <p:cNvSpPr txBox="1"/>
          <p:nvPr/>
        </p:nvSpPr>
        <p:spPr>
          <a:xfrm>
            <a:off x="1792576" y="2992930"/>
            <a:ext cx="298699" cy="369332"/>
          </a:xfrm>
          <a:prstGeom prst="rect">
            <a:avLst/>
          </a:prstGeom>
          <a:noFill/>
        </p:spPr>
        <p:txBody>
          <a:bodyPr wrap="square" rtlCol="0">
            <a:spAutoFit/>
          </a:bodyPr>
          <a:lstStyle/>
          <a:p>
            <a:pPr algn="ctr"/>
            <a:r>
              <a:rPr lang="en-US"/>
              <a:t>4</a:t>
            </a:r>
          </a:p>
        </p:txBody>
      </p:sp>
      <p:sp>
        <p:nvSpPr>
          <p:cNvPr id="50" name="TextBox 49">
            <a:extLst>
              <a:ext uri="{FF2B5EF4-FFF2-40B4-BE49-F238E27FC236}">
                <a16:creationId xmlns:a16="http://schemas.microsoft.com/office/drawing/2014/main" id="{ECB5972F-3304-4595-A223-398DC9AA3367}"/>
              </a:ext>
            </a:extLst>
          </p:cNvPr>
          <p:cNvSpPr txBox="1"/>
          <p:nvPr/>
        </p:nvSpPr>
        <p:spPr>
          <a:xfrm>
            <a:off x="3196232" y="3472929"/>
            <a:ext cx="298699" cy="369332"/>
          </a:xfrm>
          <a:prstGeom prst="rect">
            <a:avLst/>
          </a:prstGeom>
          <a:noFill/>
        </p:spPr>
        <p:txBody>
          <a:bodyPr wrap="square" rtlCol="0">
            <a:spAutoFit/>
          </a:bodyPr>
          <a:lstStyle/>
          <a:p>
            <a:pPr algn="ctr"/>
            <a:r>
              <a:rPr lang="en-US"/>
              <a:t>8</a:t>
            </a:r>
          </a:p>
        </p:txBody>
      </p:sp>
      <p:sp>
        <p:nvSpPr>
          <p:cNvPr id="51" name="TextBox 50">
            <a:extLst>
              <a:ext uri="{FF2B5EF4-FFF2-40B4-BE49-F238E27FC236}">
                <a16:creationId xmlns:a16="http://schemas.microsoft.com/office/drawing/2014/main" id="{03906754-AEBA-47DB-9CE3-4D36DCC2BE59}"/>
              </a:ext>
            </a:extLst>
          </p:cNvPr>
          <p:cNvSpPr txBox="1"/>
          <p:nvPr/>
        </p:nvSpPr>
        <p:spPr>
          <a:xfrm>
            <a:off x="6650473" y="2566968"/>
            <a:ext cx="298699" cy="369332"/>
          </a:xfrm>
          <a:prstGeom prst="rect">
            <a:avLst/>
          </a:prstGeom>
          <a:noFill/>
        </p:spPr>
        <p:txBody>
          <a:bodyPr wrap="square" rtlCol="0">
            <a:spAutoFit/>
          </a:bodyPr>
          <a:lstStyle/>
          <a:p>
            <a:pPr algn="ctr"/>
            <a:r>
              <a:rPr lang="en-US"/>
              <a:t>5</a:t>
            </a:r>
          </a:p>
        </p:txBody>
      </p:sp>
      <p:sp>
        <p:nvSpPr>
          <p:cNvPr id="52" name="TextBox 51">
            <a:extLst>
              <a:ext uri="{FF2B5EF4-FFF2-40B4-BE49-F238E27FC236}">
                <a16:creationId xmlns:a16="http://schemas.microsoft.com/office/drawing/2014/main" id="{0E7759F6-05FA-4506-AD28-84C2C94859BB}"/>
              </a:ext>
            </a:extLst>
          </p:cNvPr>
          <p:cNvSpPr txBox="1"/>
          <p:nvPr/>
        </p:nvSpPr>
        <p:spPr>
          <a:xfrm>
            <a:off x="8419448" y="2992930"/>
            <a:ext cx="298699" cy="369332"/>
          </a:xfrm>
          <a:prstGeom prst="rect">
            <a:avLst/>
          </a:prstGeom>
          <a:noFill/>
        </p:spPr>
        <p:txBody>
          <a:bodyPr wrap="square" rtlCol="0">
            <a:spAutoFit/>
          </a:bodyPr>
          <a:lstStyle/>
          <a:p>
            <a:pPr algn="ctr"/>
            <a:r>
              <a:rPr lang="en-US"/>
              <a:t>9</a:t>
            </a:r>
          </a:p>
        </p:txBody>
      </p:sp>
      <p:sp>
        <p:nvSpPr>
          <p:cNvPr id="54" name="TextBox 53">
            <a:extLst>
              <a:ext uri="{FF2B5EF4-FFF2-40B4-BE49-F238E27FC236}">
                <a16:creationId xmlns:a16="http://schemas.microsoft.com/office/drawing/2014/main" id="{16DF88A2-65C8-4A9A-95A3-20EF4B345899}"/>
              </a:ext>
            </a:extLst>
          </p:cNvPr>
          <p:cNvSpPr txBox="1"/>
          <p:nvPr/>
        </p:nvSpPr>
        <p:spPr>
          <a:xfrm>
            <a:off x="538510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55" name="Arrow: Down 54">
            <a:extLst>
              <a:ext uri="{FF2B5EF4-FFF2-40B4-BE49-F238E27FC236}">
                <a16:creationId xmlns:a16="http://schemas.microsoft.com/office/drawing/2014/main" id="{767BBC8B-2E0C-441B-8794-1A194F2E8D8C}"/>
              </a:ext>
            </a:extLst>
          </p:cNvPr>
          <p:cNvSpPr/>
          <p:nvPr/>
        </p:nvSpPr>
        <p:spPr>
          <a:xfrm rot="2877750">
            <a:off x="1644963" y="1852702"/>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270" rtlCol="0" anchor="ctr"/>
          <a:lstStyle/>
          <a:p>
            <a:pPr algn="ctr"/>
            <a:r>
              <a:rPr lang="en-US"/>
              <a:t>doubt</a:t>
            </a:r>
          </a:p>
        </p:txBody>
      </p:sp>
    </p:spTree>
    <p:extLst>
      <p:ext uri="{BB962C8B-B14F-4D97-AF65-F5344CB8AC3E}">
        <p14:creationId xmlns:p14="http://schemas.microsoft.com/office/powerpoint/2010/main" val="137813460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Forward intervals to gaps: </a:t>
            </a:r>
            <a:r>
              <a:rPr lang="en-US" sz="3600"/>
              <a:t>The interval from the time of the spike to the start of the next gap or the end of the recording. Used to add doubt flags if interval is less than burst window</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7" name="TextBox 36">
            <a:extLst>
              <a:ext uri="{FF2B5EF4-FFF2-40B4-BE49-F238E27FC236}">
                <a16:creationId xmlns:a16="http://schemas.microsoft.com/office/drawing/2014/main" id="{11F4F17E-B198-4662-82B9-FD38C6AFD4A0}"/>
              </a:ext>
            </a:extLst>
          </p:cNvPr>
          <p:cNvSpPr txBox="1"/>
          <p:nvPr/>
        </p:nvSpPr>
        <p:spPr>
          <a:xfrm>
            <a:off x="2092636" y="5198006"/>
            <a:ext cx="8006744" cy="584775"/>
          </a:xfrm>
          <a:prstGeom prst="rect">
            <a:avLst/>
          </a:prstGeom>
          <a:noFill/>
        </p:spPr>
        <p:txBody>
          <a:bodyPr wrap="none" rtlCol="0">
            <a:spAutoFit/>
          </a:bodyPr>
          <a:lstStyle/>
          <a:p>
            <a:pPr algn="ctr"/>
            <a:r>
              <a:rPr lang="en-US" sz="3200" err="1">
                <a:solidFill>
                  <a:srgbClr val="00B050"/>
                </a:solidFill>
              </a:rPr>
              <a:t>forwardIntervalsToGaps</a:t>
            </a:r>
            <a:r>
              <a:rPr lang="en-US" sz="3200">
                <a:solidFill>
                  <a:srgbClr val="00B050"/>
                </a:solidFill>
              </a:rPr>
              <a:t> = [8, 5, </a:t>
            </a:r>
            <a:r>
              <a:rPr lang="en-US" sz="3200">
                <a:solidFill>
                  <a:srgbClr val="FF0000"/>
                </a:solidFill>
              </a:rPr>
              <a:t>1</a:t>
            </a:r>
            <a:r>
              <a:rPr lang="en-US" sz="3200">
                <a:solidFill>
                  <a:srgbClr val="00B050"/>
                </a:solidFill>
              </a:rPr>
              <a:t>, 6, 2] sec</a:t>
            </a:r>
          </a:p>
        </p:txBody>
      </p:sp>
      <p:sp>
        <p:nvSpPr>
          <p:cNvPr id="48" name="Rectangle 47">
            <a:extLst>
              <a:ext uri="{FF2B5EF4-FFF2-40B4-BE49-F238E27FC236}">
                <a16:creationId xmlns:a16="http://schemas.microsoft.com/office/drawing/2014/main" id="{5BDDB4A8-E648-450E-B96E-F8D4DD553D1E}"/>
              </a:ext>
            </a:extLst>
          </p:cNvPr>
          <p:cNvSpPr/>
          <p:nvPr/>
        </p:nvSpPr>
        <p:spPr>
          <a:xfrm>
            <a:off x="5541560"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3" name="Straight Connector 52">
            <a:extLst>
              <a:ext uri="{FF2B5EF4-FFF2-40B4-BE49-F238E27FC236}">
                <a16:creationId xmlns:a16="http://schemas.microsoft.com/office/drawing/2014/main" id="{DA4046F3-1FF5-4AF0-89FB-2C774766A340}"/>
              </a:ext>
            </a:extLst>
          </p:cNvPr>
          <p:cNvCxnSpPr>
            <a:cxnSpLocks/>
          </p:cNvCxnSpPr>
          <p:nvPr/>
        </p:nvCxnSpPr>
        <p:spPr>
          <a:xfrm>
            <a:off x="151703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4E2FA796-806A-4296-8581-DFC3A22ECA86}"/>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498CE6F1-5676-4D21-911C-31707F403203}"/>
              </a:ext>
            </a:extLst>
          </p:cNvPr>
          <p:cNvCxnSpPr>
            <a:cxnSpLocks/>
          </p:cNvCxnSpPr>
          <p:nvPr/>
        </p:nvCxnSpPr>
        <p:spPr>
          <a:xfrm>
            <a:off x="503883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70430FA3-15C3-4ACC-B736-B019C8C1BE3F}"/>
              </a:ext>
            </a:extLst>
          </p:cNvPr>
          <p:cNvCxnSpPr>
            <a:cxnSpLocks/>
          </p:cNvCxnSpPr>
          <p:nvPr/>
        </p:nvCxnSpPr>
        <p:spPr>
          <a:xfrm>
            <a:off x="805750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568B8FAB-BB61-40DA-8202-6E34571A5B57}"/>
              </a:ext>
            </a:extLst>
          </p:cNvPr>
          <p:cNvCxnSpPr>
            <a:cxnSpLocks/>
          </p:cNvCxnSpPr>
          <p:nvPr/>
        </p:nvCxnSpPr>
        <p:spPr>
          <a:xfrm>
            <a:off x="1006996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9CB26AC9-A803-4139-B999-2F74AEC0D716}"/>
              </a:ext>
            </a:extLst>
          </p:cNvPr>
          <p:cNvSpPr txBox="1"/>
          <p:nvPr/>
        </p:nvSpPr>
        <p:spPr>
          <a:xfrm>
            <a:off x="1360586"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a:t>
            </a:r>
          </a:p>
        </p:txBody>
      </p:sp>
      <p:sp>
        <p:nvSpPr>
          <p:cNvPr id="70" name="TextBox 69">
            <a:extLst>
              <a:ext uri="{FF2B5EF4-FFF2-40B4-BE49-F238E27FC236}">
                <a16:creationId xmlns:a16="http://schemas.microsoft.com/office/drawing/2014/main" id="{B35F54B4-3BF5-4648-BA5F-839B8217BC62}"/>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71" name="TextBox 70">
            <a:extLst>
              <a:ext uri="{FF2B5EF4-FFF2-40B4-BE49-F238E27FC236}">
                <a16:creationId xmlns:a16="http://schemas.microsoft.com/office/drawing/2014/main" id="{089B2115-724F-40EB-9552-97D19D3C03E3}"/>
              </a:ext>
            </a:extLst>
          </p:cNvPr>
          <p:cNvSpPr txBox="1"/>
          <p:nvPr/>
        </p:nvSpPr>
        <p:spPr>
          <a:xfrm>
            <a:off x="488237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8</a:t>
            </a:r>
          </a:p>
        </p:txBody>
      </p:sp>
      <p:sp>
        <p:nvSpPr>
          <p:cNvPr id="72" name="TextBox 71">
            <a:extLst>
              <a:ext uri="{FF2B5EF4-FFF2-40B4-BE49-F238E27FC236}">
                <a16:creationId xmlns:a16="http://schemas.microsoft.com/office/drawing/2014/main" id="{CF8821E0-4EEE-465E-8798-BFB4F5C8DC2D}"/>
              </a:ext>
            </a:extLst>
          </p:cNvPr>
          <p:cNvSpPr txBox="1"/>
          <p:nvPr/>
        </p:nvSpPr>
        <p:spPr>
          <a:xfrm>
            <a:off x="7836935"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4</a:t>
            </a:r>
          </a:p>
        </p:txBody>
      </p:sp>
      <p:sp>
        <p:nvSpPr>
          <p:cNvPr id="82" name="TextBox 81">
            <a:extLst>
              <a:ext uri="{FF2B5EF4-FFF2-40B4-BE49-F238E27FC236}">
                <a16:creationId xmlns:a16="http://schemas.microsoft.com/office/drawing/2014/main" id="{71266F89-E78D-4096-930C-0FE7CCFEE445}"/>
              </a:ext>
            </a:extLst>
          </p:cNvPr>
          <p:cNvSpPr txBox="1"/>
          <p:nvPr/>
        </p:nvSpPr>
        <p:spPr>
          <a:xfrm>
            <a:off x="9849387"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8</a:t>
            </a:r>
          </a:p>
        </p:txBody>
      </p:sp>
      <p:sp>
        <p:nvSpPr>
          <p:cNvPr id="83" name="TextBox 82">
            <a:extLst>
              <a:ext uri="{FF2B5EF4-FFF2-40B4-BE49-F238E27FC236}">
                <a16:creationId xmlns:a16="http://schemas.microsoft.com/office/drawing/2014/main" id="{1944A02E-85F4-4174-BA79-16515F18AE10}"/>
              </a:ext>
            </a:extLst>
          </p:cNvPr>
          <p:cNvSpPr txBox="1"/>
          <p:nvPr/>
        </p:nvSpPr>
        <p:spPr>
          <a:xfrm>
            <a:off x="136058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4" name="TextBox 83">
            <a:extLst>
              <a:ext uri="{FF2B5EF4-FFF2-40B4-BE49-F238E27FC236}">
                <a16:creationId xmlns:a16="http://schemas.microsoft.com/office/drawing/2014/main" id="{22D67E9D-5062-4A87-A030-A820008E3850}"/>
              </a:ext>
            </a:extLst>
          </p:cNvPr>
          <p:cNvSpPr txBox="1"/>
          <p:nvPr/>
        </p:nvSpPr>
        <p:spPr>
          <a:xfrm>
            <a:off x="286992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5" name="TextBox 84">
            <a:extLst>
              <a:ext uri="{FF2B5EF4-FFF2-40B4-BE49-F238E27FC236}">
                <a16:creationId xmlns:a16="http://schemas.microsoft.com/office/drawing/2014/main" id="{359C128B-6D73-42B9-933D-679813012B6B}"/>
              </a:ext>
            </a:extLst>
          </p:cNvPr>
          <p:cNvSpPr txBox="1"/>
          <p:nvPr/>
        </p:nvSpPr>
        <p:spPr>
          <a:xfrm>
            <a:off x="488533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6" name="TextBox 85">
            <a:extLst>
              <a:ext uri="{FF2B5EF4-FFF2-40B4-BE49-F238E27FC236}">
                <a16:creationId xmlns:a16="http://schemas.microsoft.com/office/drawing/2014/main" id="{742A3144-C6B4-46BE-93AE-D1A8B320876D}"/>
              </a:ext>
            </a:extLst>
          </p:cNvPr>
          <p:cNvSpPr txBox="1"/>
          <p:nvPr/>
        </p:nvSpPr>
        <p:spPr>
          <a:xfrm>
            <a:off x="790105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87" name="TextBox 86">
            <a:extLst>
              <a:ext uri="{FF2B5EF4-FFF2-40B4-BE49-F238E27FC236}">
                <a16:creationId xmlns:a16="http://schemas.microsoft.com/office/drawing/2014/main" id="{AF44DBA4-9024-49AF-8F00-134BE9E470C0}"/>
              </a:ext>
            </a:extLst>
          </p:cNvPr>
          <p:cNvSpPr txBox="1"/>
          <p:nvPr/>
        </p:nvSpPr>
        <p:spPr>
          <a:xfrm>
            <a:off x="991350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88" name="TextBox 87">
            <a:extLst>
              <a:ext uri="{FF2B5EF4-FFF2-40B4-BE49-F238E27FC236}">
                <a16:creationId xmlns:a16="http://schemas.microsoft.com/office/drawing/2014/main" id="{3CCD7D92-4DAA-40EA-97F9-DF5BF51CCACC}"/>
              </a:ext>
            </a:extLst>
          </p:cNvPr>
          <p:cNvSpPr txBox="1"/>
          <p:nvPr/>
        </p:nvSpPr>
        <p:spPr>
          <a:xfrm>
            <a:off x="5680903" y="3334430"/>
            <a:ext cx="736099" cy="646331"/>
          </a:xfrm>
          <a:prstGeom prst="rect">
            <a:avLst/>
          </a:prstGeom>
          <a:noFill/>
        </p:spPr>
        <p:txBody>
          <a:bodyPr wrap="none" rtlCol="0">
            <a:spAutoFit/>
          </a:bodyPr>
          <a:lstStyle/>
          <a:p>
            <a:pPr algn="ctr"/>
            <a:r>
              <a:rPr lang="en-US"/>
              <a:t>GAP</a:t>
            </a:r>
          </a:p>
          <a:p>
            <a:pPr algn="ctr"/>
            <a:r>
              <a:rPr lang="en-US"/>
              <a:t>2 sec</a:t>
            </a:r>
          </a:p>
        </p:txBody>
      </p:sp>
      <p:cxnSp>
        <p:nvCxnSpPr>
          <p:cNvPr id="34" name="Straight Connector 33">
            <a:extLst>
              <a:ext uri="{FF2B5EF4-FFF2-40B4-BE49-F238E27FC236}">
                <a16:creationId xmlns:a16="http://schemas.microsoft.com/office/drawing/2014/main" id="{85073BB6-ABAF-4902-AAA3-55A0094E4DD4}"/>
              </a:ext>
            </a:extLst>
          </p:cNvPr>
          <p:cNvCxnSpPr>
            <a:cxnSpLocks/>
          </p:cNvCxnSpPr>
          <p:nvPr/>
        </p:nvCxnSpPr>
        <p:spPr>
          <a:xfrm>
            <a:off x="3026378" y="3362262"/>
            <a:ext cx="2513256"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DAD3936B-4228-46A3-A38B-5BA45E6C367E}"/>
              </a:ext>
            </a:extLst>
          </p:cNvPr>
          <p:cNvCxnSpPr>
            <a:cxnSpLocks/>
          </p:cNvCxnSpPr>
          <p:nvPr/>
        </p:nvCxnSpPr>
        <p:spPr>
          <a:xfrm>
            <a:off x="8057507" y="2898059"/>
            <a:ext cx="3018679"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E36C1C09-DD66-466D-8A58-6FE600D21C8E}"/>
              </a:ext>
            </a:extLst>
          </p:cNvPr>
          <p:cNvCxnSpPr>
            <a:cxnSpLocks/>
          </p:cNvCxnSpPr>
          <p:nvPr/>
        </p:nvCxnSpPr>
        <p:spPr>
          <a:xfrm>
            <a:off x="10069959" y="3362262"/>
            <a:ext cx="1014788" cy="0"/>
          </a:xfrm>
          <a:prstGeom prst="line">
            <a:avLst/>
          </a:prstGeom>
        </p:spPr>
        <p:style>
          <a:lnRef idx="1">
            <a:schemeClr val="accent1"/>
          </a:lnRef>
          <a:fillRef idx="0">
            <a:schemeClr val="accent1"/>
          </a:fillRef>
          <a:effectRef idx="0">
            <a:schemeClr val="accent1"/>
          </a:effectRef>
          <a:fontRef idx="minor">
            <a:schemeClr val="tx1"/>
          </a:fontRef>
        </p:style>
      </p:cxnSp>
      <p:sp>
        <p:nvSpPr>
          <p:cNvPr id="49" name="TextBox 48">
            <a:extLst>
              <a:ext uri="{FF2B5EF4-FFF2-40B4-BE49-F238E27FC236}">
                <a16:creationId xmlns:a16="http://schemas.microsoft.com/office/drawing/2014/main" id="{8B6BD669-7569-4BD9-9205-25FEA5B77759}"/>
              </a:ext>
            </a:extLst>
          </p:cNvPr>
          <p:cNvSpPr txBox="1"/>
          <p:nvPr/>
        </p:nvSpPr>
        <p:spPr>
          <a:xfrm>
            <a:off x="4134715" y="3043966"/>
            <a:ext cx="298699" cy="369332"/>
          </a:xfrm>
          <a:prstGeom prst="rect">
            <a:avLst/>
          </a:prstGeom>
          <a:noFill/>
        </p:spPr>
        <p:txBody>
          <a:bodyPr wrap="square" rtlCol="0">
            <a:spAutoFit/>
          </a:bodyPr>
          <a:lstStyle/>
          <a:p>
            <a:pPr algn="ctr"/>
            <a:r>
              <a:rPr lang="en-US"/>
              <a:t>5</a:t>
            </a:r>
          </a:p>
        </p:txBody>
      </p:sp>
      <p:sp>
        <p:nvSpPr>
          <p:cNvPr id="51" name="TextBox 50">
            <a:extLst>
              <a:ext uri="{FF2B5EF4-FFF2-40B4-BE49-F238E27FC236}">
                <a16:creationId xmlns:a16="http://schemas.microsoft.com/office/drawing/2014/main" id="{03906754-AEBA-47DB-9CE3-4D36DCC2BE59}"/>
              </a:ext>
            </a:extLst>
          </p:cNvPr>
          <p:cNvSpPr txBox="1"/>
          <p:nvPr/>
        </p:nvSpPr>
        <p:spPr>
          <a:xfrm>
            <a:off x="9319445" y="2566968"/>
            <a:ext cx="298699" cy="369332"/>
          </a:xfrm>
          <a:prstGeom prst="rect">
            <a:avLst/>
          </a:prstGeom>
          <a:noFill/>
        </p:spPr>
        <p:txBody>
          <a:bodyPr wrap="square" rtlCol="0">
            <a:spAutoFit/>
          </a:bodyPr>
          <a:lstStyle/>
          <a:p>
            <a:pPr algn="ctr"/>
            <a:r>
              <a:rPr lang="en-US"/>
              <a:t>6</a:t>
            </a:r>
          </a:p>
        </p:txBody>
      </p:sp>
      <p:sp>
        <p:nvSpPr>
          <p:cNvPr id="52" name="TextBox 51">
            <a:extLst>
              <a:ext uri="{FF2B5EF4-FFF2-40B4-BE49-F238E27FC236}">
                <a16:creationId xmlns:a16="http://schemas.microsoft.com/office/drawing/2014/main" id="{0E7759F6-05FA-4506-AD28-84C2C94859BB}"/>
              </a:ext>
            </a:extLst>
          </p:cNvPr>
          <p:cNvSpPr txBox="1"/>
          <p:nvPr/>
        </p:nvSpPr>
        <p:spPr>
          <a:xfrm>
            <a:off x="10428003" y="2992930"/>
            <a:ext cx="298699" cy="369332"/>
          </a:xfrm>
          <a:prstGeom prst="rect">
            <a:avLst/>
          </a:prstGeom>
          <a:noFill/>
        </p:spPr>
        <p:txBody>
          <a:bodyPr wrap="square" rtlCol="0">
            <a:spAutoFit/>
          </a:bodyPr>
          <a:lstStyle/>
          <a:p>
            <a:pPr algn="ctr"/>
            <a:r>
              <a:rPr lang="en-US"/>
              <a:t>2</a:t>
            </a:r>
          </a:p>
        </p:txBody>
      </p:sp>
      <p:sp>
        <p:nvSpPr>
          <p:cNvPr id="54" name="TextBox 53">
            <a:extLst>
              <a:ext uri="{FF2B5EF4-FFF2-40B4-BE49-F238E27FC236}">
                <a16:creationId xmlns:a16="http://schemas.microsoft.com/office/drawing/2014/main" id="{16DF88A2-65C8-4A9A-95A3-20EF4B345899}"/>
              </a:ext>
            </a:extLst>
          </p:cNvPr>
          <p:cNvSpPr txBox="1"/>
          <p:nvPr/>
        </p:nvSpPr>
        <p:spPr>
          <a:xfrm>
            <a:off x="538510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55" name="Arrow: Down 54">
            <a:extLst>
              <a:ext uri="{FF2B5EF4-FFF2-40B4-BE49-F238E27FC236}">
                <a16:creationId xmlns:a16="http://schemas.microsoft.com/office/drawing/2014/main" id="{767BBC8B-2E0C-441B-8794-1A194F2E8D8C}"/>
              </a:ext>
            </a:extLst>
          </p:cNvPr>
          <p:cNvSpPr/>
          <p:nvPr/>
        </p:nvSpPr>
        <p:spPr>
          <a:xfrm rot="13663709">
            <a:off x="4158216" y="3777527"/>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 rtlCol="0" anchor="ctr"/>
          <a:lstStyle/>
          <a:p>
            <a:pPr algn="ctr"/>
            <a:r>
              <a:rPr lang="en-US"/>
              <a:t>doubt</a:t>
            </a:r>
          </a:p>
        </p:txBody>
      </p:sp>
      <p:cxnSp>
        <p:nvCxnSpPr>
          <p:cNvPr id="39" name="Straight Connector 38">
            <a:extLst>
              <a:ext uri="{FF2B5EF4-FFF2-40B4-BE49-F238E27FC236}">
                <a16:creationId xmlns:a16="http://schemas.microsoft.com/office/drawing/2014/main" id="{4F8200E0-1631-42A9-955E-94D7CD170D71}"/>
              </a:ext>
            </a:extLst>
          </p:cNvPr>
          <p:cNvCxnSpPr>
            <a:cxnSpLocks/>
          </p:cNvCxnSpPr>
          <p:nvPr/>
        </p:nvCxnSpPr>
        <p:spPr>
          <a:xfrm>
            <a:off x="5036521" y="3824481"/>
            <a:ext cx="503113" cy="0"/>
          </a:xfrm>
          <a:prstGeom prst="line">
            <a:avLst/>
          </a:prstGeom>
        </p:spPr>
        <p:style>
          <a:lnRef idx="1">
            <a:schemeClr val="accent1"/>
          </a:lnRef>
          <a:fillRef idx="0">
            <a:schemeClr val="accent1"/>
          </a:fillRef>
          <a:effectRef idx="0">
            <a:schemeClr val="accent1"/>
          </a:effectRef>
          <a:fontRef idx="minor">
            <a:schemeClr val="tx1"/>
          </a:fontRef>
        </p:style>
      </p:cxnSp>
      <p:sp>
        <p:nvSpPr>
          <p:cNvPr id="40" name="TextBox 39">
            <a:extLst>
              <a:ext uri="{FF2B5EF4-FFF2-40B4-BE49-F238E27FC236}">
                <a16:creationId xmlns:a16="http://schemas.microsoft.com/office/drawing/2014/main" id="{48240F80-D536-4D67-B0E3-0E01F8975809}"/>
              </a:ext>
            </a:extLst>
          </p:cNvPr>
          <p:cNvSpPr txBox="1"/>
          <p:nvPr/>
        </p:nvSpPr>
        <p:spPr>
          <a:xfrm>
            <a:off x="5138727" y="3493390"/>
            <a:ext cx="298699" cy="369332"/>
          </a:xfrm>
          <a:prstGeom prst="rect">
            <a:avLst/>
          </a:prstGeom>
          <a:noFill/>
        </p:spPr>
        <p:txBody>
          <a:bodyPr wrap="square" rtlCol="0">
            <a:spAutoFit/>
          </a:bodyPr>
          <a:lstStyle/>
          <a:p>
            <a:pPr algn="ctr"/>
            <a:r>
              <a:rPr lang="en-US">
                <a:solidFill>
                  <a:srgbClr val="FF0000"/>
                </a:solidFill>
              </a:rPr>
              <a:t>1</a:t>
            </a:r>
          </a:p>
        </p:txBody>
      </p:sp>
      <p:cxnSp>
        <p:nvCxnSpPr>
          <p:cNvPr id="43" name="Straight Connector 42">
            <a:extLst>
              <a:ext uri="{FF2B5EF4-FFF2-40B4-BE49-F238E27FC236}">
                <a16:creationId xmlns:a16="http://schemas.microsoft.com/office/drawing/2014/main" id="{AF3FF410-EA7D-42D6-BCE5-583BC6BAAB31}"/>
              </a:ext>
            </a:extLst>
          </p:cNvPr>
          <p:cNvCxnSpPr>
            <a:cxnSpLocks/>
          </p:cNvCxnSpPr>
          <p:nvPr/>
        </p:nvCxnSpPr>
        <p:spPr>
          <a:xfrm>
            <a:off x="1506368" y="2898059"/>
            <a:ext cx="4041769" cy="0"/>
          </a:xfrm>
          <a:prstGeom prst="line">
            <a:avLst/>
          </a:prstGeom>
        </p:spPr>
        <p:style>
          <a:lnRef idx="1">
            <a:schemeClr val="accent1"/>
          </a:lnRef>
          <a:fillRef idx="0">
            <a:schemeClr val="accent1"/>
          </a:fillRef>
          <a:effectRef idx="0">
            <a:schemeClr val="accent1"/>
          </a:effectRef>
          <a:fontRef idx="minor">
            <a:schemeClr val="tx1"/>
          </a:fontRef>
        </p:style>
      </p:cxnSp>
      <p:sp>
        <p:nvSpPr>
          <p:cNvPr id="46" name="TextBox 45">
            <a:extLst>
              <a:ext uri="{FF2B5EF4-FFF2-40B4-BE49-F238E27FC236}">
                <a16:creationId xmlns:a16="http://schemas.microsoft.com/office/drawing/2014/main" id="{78403348-608E-4F87-9FF7-90BB016A23C5}"/>
              </a:ext>
            </a:extLst>
          </p:cNvPr>
          <p:cNvSpPr txBox="1"/>
          <p:nvPr/>
        </p:nvSpPr>
        <p:spPr>
          <a:xfrm>
            <a:off x="2204184" y="2566968"/>
            <a:ext cx="298699" cy="369332"/>
          </a:xfrm>
          <a:prstGeom prst="rect">
            <a:avLst/>
          </a:prstGeom>
          <a:noFill/>
        </p:spPr>
        <p:txBody>
          <a:bodyPr wrap="square" rtlCol="0">
            <a:spAutoFit/>
          </a:bodyPr>
          <a:lstStyle/>
          <a:p>
            <a:pPr algn="ctr"/>
            <a:r>
              <a:rPr lang="en-US"/>
              <a:t>8</a:t>
            </a:r>
          </a:p>
        </p:txBody>
      </p:sp>
    </p:spTree>
    <p:extLst>
      <p:ext uri="{BB962C8B-B14F-4D97-AF65-F5344CB8AC3E}">
        <p14:creationId xmlns:p14="http://schemas.microsoft.com/office/powerpoint/2010/main" val="297948796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Interval gap flag: </a:t>
            </a:r>
            <a:r>
              <a:rPr lang="en-US" sz="3600"/>
              <a:t>The duration of any gaps that occur within a backwards interval. </a:t>
            </a:r>
            <a:r>
              <a:rPr lang="en-US" sz="3200"/>
              <a:t>If not 0, interval is not added to </a:t>
            </a:r>
            <a:r>
              <a:rPr lang="en-US" sz="3200" err="1"/>
              <a:t>inter_intervals</a:t>
            </a:r>
            <a:r>
              <a:rPr lang="en-US" sz="3200"/>
              <a:t> / </a:t>
            </a:r>
            <a:r>
              <a:rPr lang="en-US" sz="3200" err="1"/>
              <a:t>intra_intervals</a:t>
            </a:r>
            <a:r>
              <a:rPr lang="en-US" sz="3200"/>
              <a:t>. Used to add burst doubt flags if there’s a gap during a burst</a:t>
            </a:r>
            <a:endParaRPr lang="en-US" sz="3600"/>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7" name="TextBox 36">
            <a:extLst>
              <a:ext uri="{FF2B5EF4-FFF2-40B4-BE49-F238E27FC236}">
                <a16:creationId xmlns:a16="http://schemas.microsoft.com/office/drawing/2014/main" id="{11F4F17E-B198-4662-82B9-FD38C6AFD4A0}"/>
              </a:ext>
            </a:extLst>
          </p:cNvPr>
          <p:cNvSpPr txBox="1"/>
          <p:nvPr/>
        </p:nvSpPr>
        <p:spPr>
          <a:xfrm>
            <a:off x="2752796" y="5198006"/>
            <a:ext cx="6686446" cy="584775"/>
          </a:xfrm>
          <a:prstGeom prst="rect">
            <a:avLst/>
          </a:prstGeom>
          <a:noFill/>
        </p:spPr>
        <p:txBody>
          <a:bodyPr wrap="none" rtlCol="0">
            <a:spAutoFit/>
          </a:bodyPr>
          <a:lstStyle/>
          <a:p>
            <a:pPr algn="ctr"/>
            <a:r>
              <a:rPr lang="en-US" sz="3200" err="1">
                <a:solidFill>
                  <a:srgbClr val="00B050"/>
                </a:solidFill>
              </a:rPr>
              <a:t>intervalGapFlag</a:t>
            </a:r>
            <a:r>
              <a:rPr lang="en-US" sz="3200">
                <a:solidFill>
                  <a:srgbClr val="00B050"/>
                </a:solidFill>
              </a:rPr>
              <a:t> = [0, 0, 0, </a:t>
            </a:r>
            <a:r>
              <a:rPr lang="en-US" sz="3200">
                <a:solidFill>
                  <a:srgbClr val="FF0000"/>
                </a:solidFill>
              </a:rPr>
              <a:t>2</a:t>
            </a:r>
            <a:r>
              <a:rPr lang="en-US" sz="3200">
                <a:solidFill>
                  <a:srgbClr val="00B050"/>
                </a:solidFill>
              </a:rPr>
              <a:t>, 0] sec </a:t>
            </a:r>
          </a:p>
        </p:txBody>
      </p:sp>
      <p:sp>
        <p:nvSpPr>
          <p:cNvPr id="48" name="Rectangle 47">
            <a:extLst>
              <a:ext uri="{FF2B5EF4-FFF2-40B4-BE49-F238E27FC236}">
                <a16:creationId xmlns:a16="http://schemas.microsoft.com/office/drawing/2014/main" id="{5BDDB4A8-E648-450E-B96E-F8D4DD553D1E}"/>
              </a:ext>
            </a:extLst>
          </p:cNvPr>
          <p:cNvSpPr/>
          <p:nvPr/>
        </p:nvSpPr>
        <p:spPr>
          <a:xfrm>
            <a:off x="5541560"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3" name="Straight Connector 52">
            <a:extLst>
              <a:ext uri="{FF2B5EF4-FFF2-40B4-BE49-F238E27FC236}">
                <a16:creationId xmlns:a16="http://schemas.microsoft.com/office/drawing/2014/main" id="{DA4046F3-1FF5-4AF0-89FB-2C774766A340}"/>
              </a:ext>
            </a:extLst>
          </p:cNvPr>
          <p:cNvCxnSpPr>
            <a:cxnSpLocks/>
          </p:cNvCxnSpPr>
          <p:nvPr/>
        </p:nvCxnSpPr>
        <p:spPr>
          <a:xfrm>
            <a:off x="151703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4E2FA796-806A-4296-8581-DFC3A22ECA86}"/>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498CE6F1-5676-4D21-911C-31707F403203}"/>
              </a:ext>
            </a:extLst>
          </p:cNvPr>
          <p:cNvCxnSpPr>
            <a:cxnSpLocks/>
          </p:cNvCxnSpPr>
          <p:nvPr/>
        </p:nvCxnSpPr>
        <p:spPr>
          <a:xfrm>
            <a:off x="503883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70430FA3-15C3-4ACC-B736-B019C8C1BE3F}"/>
              </a:ext>
            </a:extLst>
          </p:cNvPr>
          <p:cNvCxnSpPr>
            <a:cxnSpLocks/>
          </p:cNvCxnSpPr>
          <p:nvPr/>
        </p:nvCxnSpPr>
        <p:spPr>
          <a:xfrm>
            <a:off x="805750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568B8FAB-BB61-40DA-8202-6E34571A5B57}"/>
              </a:ext>
            </a:extLst>
          </p:cNvPr>
          <p:cNvCxnSpPr>
            <a:cxnSpLocks/>
          </p:cNvCxnSpPr>
          <p:nvPr/>
        </p:nvCxnSpPr>
        <p:spPr>
          <a:xfrm>
            <a:off x="1006996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9CB26AC9-A803-4139-B999-2F74AEC0D716}"/>
              </a:ext>
            </a:extLst>
          </p:cNvPr>
          <p:cNvSpPr txBox="1"/>
          <p:nvPr/>
        </p:nvSpPr>
        <p:spPr>
          <a:xfrm>
            <a:off x="1360586"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a:t>
            </a:r>
          </a:p>
        </p:txBody>
      </p:sp>
      <p:sp>
        <p:nvSpPr>
          <p:cNvPr id="70" name="TextBox 69">
            <a:extLst>
              <a:ext uri="{FF2B5EF4-FFF2-40B4-BE49-F238E27FC236}">
                <a16:creationId xmlns:a16="http://schemas.microsoft.com/office/drawing/2014/main" id="{B35F54B4-3BF5-4648-BA5F-839B8217BC62}"/>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71" name="TextBox 70">
            <a:extLst>
              <a:ext uri="{FF2B5EF4-FFF2-40B4-BE49-F238E27FC236}">
                <a16:creationId xmlns:a16="http://schemas.microsoft.com/office/drawing/2014/main" id="{089B2115-724F-40EB-9552-97D19D3C03E3}"/>
              </a:ext>
            </a:extLst>
          </p:cNvPr>
          <p:cNvSpPr txBox="1"/>
          <p:nvPr/>
        </p:nvSpPr>
        <p:spPr>
          <a:xfrm>
            <a:off x="488237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8</a:t>
            </a:r>
          </a:p>
        </p:txBody>
      </p:sp>
      <p:sp>
        <p:nvSpPr>
          <p:cNvPr id="72" name="TextBox 71">
            <a:extLst>
              <a:ext uri="{FF2B5EF4-FFF2-40B4-BE49-F238E27FC236}">
                <a16:creationId xmlns:a16="http://schemas.microsoft.com/office/drawing/2014/main" id="{CF8821E0-4EEE-465E-8798-BFB4F5C8DC2D}"/>
              </a:ext>
            </a:extLst>
          </p:cNvPr>
          <p:cNvSpPr txBox="1"/>
          <p:nvPr/>
        </p:nvSpPr>
        <p:spPr>
          <a:xfrm>
            <a:off x="7836935"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4</a:t>
            </a:r>
          </a:p>
        </p:txBody>
      </p:sp>
      <p:sp>
        <p:nvSpPr>
          <p:cNvPr id="82" name="TextBox 81">
            <a:extLst>
              <a:ext uri="{FF2B5EF4-FFF2-40B4-BE49-F238E27FC236}">
                <a16:creationId xmlns:a16="http://schemas.microsoft.com/office/drawing/2014/main" id="{71266F89-E78D-4096-930C-0FE7CCFEE445}"/>
              </a:ext>
            </a:extLst>
          </p:cNvPr>
          <p:cNvSpPr txBox="1"/>
          <p:nvPr/>
        </p:nvSpPr>
        <p:spPr>
          <a:xfrm>
            <a:off x="9849387"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8</a:t>
            </a:r>
          </a:p>
        </p:txBody>
      </p:sp>
      <p:sp>
        <p:nvSpPr>
          <p:cNvPr id="83" name="TextBox 82">
            <a:extLst>
              <a:ext uri="{FF2B5EF4-FFF2-40B4-BE49-F238E27FC236}">
                <a16:creationId xmlns:a16="http://schemas.microsoft.com/office/drawing/2014/main" id="{1944A02E-85F4-4174-BA79-16515F18AE10}"/>
              </a:ext>
            </a:extLst>
          </p:cNvPr>
          <p:cNvSpPr txBox="1"/>
          <p:nvPr/>
        </p:nvSpPr>
        <p:spPr>
          <a:xfrm>
            <a:off x="136058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4" name="TextBox 83">
            <a:extLst>
              <a:ext uri="{FF2B5EF4-FFF2-40B4-BE49-F238E27FC236}">
                <a16:creationId xmlns:a16="http://schemas.microsoft.com/office/drawing/2014/main" id="{22D67E9D-5062-4A87-A030-A820008E3850}"/>
              </a:ext>
            </a:extLst>
          </p:cNvPr>
          <p:cNvSpPr txBox="1"/>
          <p:nvPr/>
        </p:nvSpPr>
        <p:spPr>
          <a:xfrm>
            <a:off x="286992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5" name="TextBox 84">
            <a:extLst>
              <a:ext uri="{FF2B5EF4-FFF2-40B4-BE49-F238E27FC236}">
                <a16:creationId xmlns:a16="http://schemas.microsoft.com/office/drawing/2014/main" id="{359C128B-6D73-42B9-933D-679813012B6B}"/>
              </a:ext>
            </a:extLst>
          </p:cNvPr>
          <p:cNvSpPr txBox="1"/>
          <p:nvPr/>
        </p:nvSpPr>
        <p:spPr>
          <a:xfrm>
            <a:off x="488533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6" name="TextBox 85">
            <a:extLst>
              <a:ext uri="{FF2B5EF4-FFF2-40B4-BE49-F238E27FC236}">
                <a16:creationId xmlns:a16="http://schemas.microsoft.com/office/drawing/2014/main" id="{742A3144-C6B4-46BE-93AE-D1A8B320876D}"/>
              </a:ext>
            </a:extLst>
          </p:cNvPr>
          <p:cNvSpPr txBox="1"/>
          <p:nvPr/>
        </p:nvSpPr>
        <p:spPr>
          <a:xfrm>
            <a:off x="790105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87" name="TextBox 86">
            <a:extLst>
              <a:ext uri="{FF2B5EF4-FFF2-40B4-BE49-F238E27FC236}">
                <a16:creationId xmlns:a16="http://schemas.microsoft.com/office/drawing/2014/main" id="{AF44DBA4-9024-49AF-8F00-134BE9E470C0}"/>
              </a:ext>
            </a:extLst>
          </p:cNvPr>
          <p:cNvSpPr txBox="1"/>
          <p:nvPr/>
        </p:nvSpPr>
        <p:spPr>
          <a:xfrm>
            <a:off x="991350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88" name="TextBox 87">
            <a:extLst>
              <a:ext uri="{FF2B5EF4-FFF2-40B4-BE49-F238E27FC236}">
                <a16:creationId xmlns:a16="http://schemas.microsoft.com/office/drawing/2014/main" id="{3CCD7D92-4DAA-40EA-97F9-DF5BF51CCACC}"/>
              </a:ext>
            </a:extLst>
          </p:cNvPr>
          <p:cNvSpPr txBox="1"/>
          <p:nvPr/>
        </p:nvSpPr>
        <p:spPr>
          <a:xfrm>
            <a:off x="5680903" y="3334430"/>
            <a:ext cx="736099" cy="646331"/>
          </a:xfrm>
          <a:prstGeom prst="rect">
            <a:avLst/>
          </a:prstGeom>
          <a:noFill/>
        </p:spPr>
        <p:txBody>
          <a:bodyPr wrap="none" rtlCol="0">
            <a:spAutoFit/>
          </a:bodyPr>
          <a:lstStyle/>
          <a:p>
            <a:pPr algn="ctr"/>
            <a:r>
              <a:rPr lang="en-US"/>
              <a:t>GAP</a:t>
            </a:r>
          </a:p>
          <a:p>
            <a:pPr algn="ctr"/>
            <a:r>
              <a:rPr lang="en-US"/>
              <a:t>2 sec</a:t>
            </a:r>
          </a:p>
        </p:txBody>
      </p:sp>
      <p:sp>
        <p:nvSpPr>
          <p:cNvPr id="54" name="TextBox 53">
            <a:extLst>
              <a:ext uri="{FF2B5EF4-FFF2-40B4-BE49-F238E27FC236}">
                <a16:creationId xmlns:a16="http://schemas.microsoft.com/office/drawing/2014/main" id="{16DF88A2-65C8-4A9A-95A3-20EF4B345899}"/>
              </a:ext>
            </a:extLst>
          </p:cNvPr>
          <p:cNvSpPr txBox="1"/>
          <p:nvPr/>
        </p:nvSpPr>
        <p:spPr>
          <a:xfrm>
            <a:off x="538510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44" name="TextBox 43">
            <a:extLst>
              <a:ext uri="{FF2B5EF4-FFF2-40B4-BE49-F238E27FC236}">
                <a16:creationId xmlns:a16="http://schemas.microsoft.com/office/drawing/2014/main" id="{78CD0FC1-06AB-42FD-9785-625F60BB71A2}"/>
              </a:ext>
            </a:extLst>
          </p:cNvPr>
          <p:cNvSpPr txBox="1"/>
          <p:nvPr/>
        </p:nvSpPr>
        <p:spPr>
          <a:xfrm>
            <a:off x="1108838" y="4621759"/>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45" name="TextBox 44">
            <a:extLst>
              <a:ext uri="{FF2B5EF4-FFF2-40B4-BE49-F238E27FC236}">
                <a16:creationId xmlns:a16="http://schemas.microsoft.com/office/drawing/2014/main" id="{92234871-3244-4FF0-805D-EF8D613833C0}"/>
              </a:ext>
            </a:extLst>
          </p:cNvPr>
          <p:cNvSpPr txBox="1"/>
          <p:nvPr/>
        </p:nvSpPr>
        <p:spPr>
          <a:xfrm>
            <a:off x="2115063" y="4621759"/>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47" name="TextBox 46">
            <a:extLst>
              <a:ext uri="{FF2B5EF4-FFF2-40B4-BE49-F238E27FC236}">
                <a16:creationId xmlns:a16="http://schemas.microsoft.com/office/drawing/2014/main" id="{4A851316-A2EF-4C7F-B7F8-CC58BD1D8F2D}"/>
              </a:ext>
            </a:extLst>
          </p:cNvPr>
          <p:cNvSpPr txBox="1"/>
          <p:nvPr/>
        </p:nvSpPr>
        <p:spPr>
          <a:xfrm>
            <a:off x="3876150" y="4621759"/>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50" name="TextBox 49">
            <a:extLst>
              <a:ext uri="{FF2B5EF4-FFF2-40B4-BE49-F238E27FC236}">
                <a16:creationId xmlns:a16="http://schemas.microsoft.com/office/drawing/2014/main" id="{9EBD8EA2-9E07-4A71-B743-9C88F0A86A5B}"/>
              </a:ext>
            </a:extLst>
          </p:cNvPr>
          <p:cNvSpPr txBox="1"/>
          <p:nvPr/>
        </p:nvSpPr>
        <p:spPr>
          <a:xfrm>
            <a:off x="8907281" y="4621759"/>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58" name="TextBox 57">
            <a:extLst>
              <a:ext uri="{FF2B5EF4-FFF2-40B4-BE49-F238E27FC236}">
                <a16:creationId xmlns:a16="http://schemas.microsoft.com/office/drawing/2014/main" id="{638D959D-6F48-45FD-8320-E292F549EC90}"/>
              </a:ext>
            </a:extLst>
          </p:cNvPr>
          <p:cNvSpPr txBox="1"/>
          <p:nvPr/>
        </p:nvSpPr>
        <p:spPr>
          <a:xfrm>
            <a:off x="6539991" y="4621759"/>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a:t>
            </a:r>
          </a:p>
        </p:txBody>
      </p:sp>
      <p:sp>
        <p:nvSpPr>
          <p:cNvPr id="59" name="&quot;Not Allowed&quot; Symbol 58">
            <a:extLst>
              <a:ext uri="{FF2B5EF4-FFF2-40B4-BE49-F238E27FC236}">
                <a16:creationId xmlns:a16="http://schemas.microsoft.com/office/drawing/2014/main" id="{48ADFD6A-FC11-440E-92B4-44B416C62A0B}"/>
              </a:ext>
            </a:extLst>
          </p:cNvPr>
          <p:cNvSpPr/>
          <p:nvPr/>
        </p:nvSpPr>
        <p:spPr>
          <a:xfrm>
            <a:off x="6701582" y="3108211"/>
            <a:ext cx="899045" cy="899045"/>
          </a:xfrm>
          <a:prstGeom prst="noSmoking">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36790050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a:extLst>
              <a:ext uri="{FF2B5EF4-FFF2-40B4-BE49-F238E27FC236}">
                <a16:creationId xmlns:a16="http://schemas.microsoft.com/office/drawing/2014/main" id="{E7F1EF72-DAFB-4736-98C7-915A42B2CB95}"/>
              </a:ext>
            </a:extLst>
          </p:cNvPr>
          <p:cNvSpPr/>
          <p:nvPr/>
        </p:nvSpPr>
        <p:spPr>
          <a:xfrm>
            <a:off x="3492827"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TextBox 39">
            <a:extLst>
              <a:ext uri="{FF2B5EF4-FFF2-40B4-BE49-F238E27FC236}">
                <a16:creationId xmlns:a16="http://schemas.microsoft.com/office/drawing/2014/main" id="{D6BFA371-49D0-4E84-B80E-7BB03447B796}"/>
              </a:ext>
            </a:extLst>
          </p:cNvPr>
          <p:cNvSpPr txBox="1"/>
          <p:nvPr/>
        </p:nvSpPr>
        <p:spPr>
          <a:xfrm>
            <a:off x="3632170" y="3334430"/>
            <a:ext cx="736099" cy="646331"/>
          </a:xfrm>
          <a:prstGeom prst="rect">
            <a:avLst/>
          </a:prstGeom>
          <a:noFill/>
        </p:spPr>
        <p:txBody>
          <a:bodyPr wrap="none" rtlCol="0">
            <a:spAutoFit/>
          </a:bodyPr>
          <a:lstStyle/>
          <a:p>
            <a:pPr algn="ctr"/>
            <a:r>
              <a:rPr lang="en-US"/>
              <a:t>GAP</a:t>
            </a:r>
          </a:p>
          <a:p>
            <a:pPr algn="ctr"/>
            <a:r>
              <a:rPr lang="en-US"/>
              <a:t>2 sec</a:t>
            </a:r>
          </a:p>
        </p:txBody>
      </p:sp>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Mean inter-event interval: </a:t>
            </a:r>
            <a:r>
              <a:rPr lang="en-US" sz="3600"/>
              <a:t>The average of all inter-event intervals that are not interrupted by gaps</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5E6CC999-542D-450B-9072-1D8886BE890D}"/>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08F7E712-5429-455C-9EFB-D74CDF210A04}"/>
              </a:ext>
            </a:extLst>
          </p:cNvPr>
          <p:cNvCxnSpPr>
            <a:cxnSpLocks/>
          </p:cNvCxnSpPr>
          <p:nvPr/>
        </p:nvCxnSpPr>
        <p:spPr>
          <a:xfrm>
            <a:off x="5541943"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743E1477-59EB-44BF-9DB3-3C6A7A8C082D}"/>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11323809-9FDA-4F29-A82C-AA0FBACD5790}"/>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3" name="TextBox 12">
            <a:extLst>
              <a:ext uri="{FF2B5EF4-FFF2-40B4-BE49-F238E27FC236}">
                <a16:creationId xmlns:a16="http://schemas.microsoft.com/office/drawing/2014/main" id="{063F1761-4EAD-40E2-BD14-2EEF411621C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4" name="TextBox 13">
            <a:extLst>
              <a:ext uri="{FF2B5EF4-FFF2-40B4-BE49-F238E27FC236}">
                <a16:creationId xmlns:a16="http://schemas.microsoft.com/office/drawing/2014/main" id="{A5B98651-E29F-4D49-A6FB-A631BA5B4E18}"/>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7" name="TextBox 16">
            <a:extLst>
              <a:ext uri="{FF2B5EF4-FFF2-40B4-BE49-F238E27FC236}">
                <a16:creationId xmlns:a16="http://schemas.microsoft.com/office/drawing/2014/main" id="{7F8CDF7A-FDF6-4DE7-B305-464F6C52B7B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8" name="TextBox 17">
            <a:extLst>
              <a:ext uri="{FF2B5EF4-FFF2-40B4-BE49-F238E27FC236}">
                <a16:creationId xmlns:a16="http://schemas.microsoft.com/office/drawing/2014/main" id="{9F1C46BE-7900-4262-90C3-0471B29061A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0" name="TextBox 19">
            <a:extLst>
              <a:ext uri="{FF2B5EF4-FFF2-40B4-BE49-F238E27FC236}">
                <a16:creationId xmlns:a16="http://schemas.microsoft.com/office/drawing/2014/main" id="{9F438B38-4B5B-42F2-BCB7-6941DD03CAF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21" name="TextBox 20">
            <a:extLst>
              <a:ext uri="{FF2B5EF4-FFF2-40B4-BE49-F238E27FC236}">
                <a16:creationId xmlns:a16="http://schemas.microsoft.com/office/drawing/2014/main" id="{71718F80-5BB8-4AEB-8504-9A2D9A1E5D77}"/>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24" name="TextBox 23">
            <a:extLst>
              <a:ext uri="{FF2B5EF4-FFF2-40B4-BE49-F238E27FC236}">
                <a16:creationId xmlns:a16="http://schemas.microsoft.com/office/drawing/2014/main" id="{EE8F42A6-71D2-4541-9238-A6F22A7FC8B1}"/>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25" name="TextBox 24">
            <a:extLst>
              <a:ext uri="{FF2B5EF4-FFF2-40B4-BE49-F238E27FC236}">
                <a16:creationId xmlns:a16="http://schemas.microsoft.com/office/drawing/2014/main" id="{F07C037D-791F-459D-B32F-24ECE9031F63}"/>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cxnSp>
        <p:nvCxnSpPr>
          <p:cNvPr id="32" name="Straight Connector 31">
            <a:extLst>
              <a:ext uri="{FF2B5EF4-FFF2-40B4-BE49-F238E27FC236}">
                <a16:creationId xmlns:a16="http://schemas.microsoft.com/office/drawing/2014/main" id="{67223FFA-2893-4A49-B60F-60DCAA072D7F}"/>
              </a:ext>
            </a:extLst>
          </p:cNvPr>
          <p:cNvCxnSpPr>
            <a:cxnSpLocks/>
          </p:cNvCxnSpPr>
          <p:nvPr/>
        </p:nvCxnSpPr>
        <p:spPr>
          <a:xfrm>
            <a:off x="3026378" y="3557734"/>
            <a:ext cx="2499923" cy="0"/>
          </a:xfrm>
          <a:prstGeom prst="line">
            <a:avLst/>
          </a:prstGeom>
        </p:spPr>
        <p:style>
          <a:lnRef idx="1">
            <a:schemeClr val="accent1"/>
          </a:lnRef>
          <a:fillRef idx="0">
            <a:schemeClr val="accent1"/>
          </a:fillRef>
          <a:effectRef idx="0">
            <a:schemeClr val="accent1"/>
          </a:effectRef>
          <a:fontRef idx="minor">
            <a:schemeClr val="tx1"/>
          </a:fontRef>
        </p:style>
      </p:cxnSp>
      <p:sp>
        <p:nvSpPr>
          <p:cNvPr id="34" name="TextBox 33">
            <a:extLst>
              <a:ext uri="{FF2B5EF4-FFF2-40B4-BE49-F238E27FC236}">
                <a16:creationId xmlns:a16="http://schemas.microsoft.com/office/drawing/2014/main" id="{877AB1D4-B093-428A-9236-823E7C76BEDE}"/>
              </a:ext>
            </a:extLst>
          </p:cNvPr>
          <p:cNvSpPr txBox="1"/>
          <p:nvPr/>
        </p:nvSpPr>
        <p:spPr>
          <a:xfrm>
            <a:off x="7908159" y="3214713"/>
            <a:ext cx="298699" cy="369332"/>
          </a:xfrm>
          <a:prstGeom prst="rect">
            <a:avLst/>
          </a:prstGeom>
          <a:noFill/>
        </p:spPr>
        <p:txBody>
          <a:bodyPr wrap="square" rtlCol="0">
            <a:spAutoFit/>
          </a:bodyPr>
          <a:lstStyle/>
          <a:p>
            <a:pPr algn="ctr"/>
            <a:r>
              <a:rPr lang="en-US"/>
              <a:t>4</a:t>
            </a:r>
          </a:p>
        </p:txBody>
      </p:sp>
      <p:cxnSp>
        <p:nvCxnSpPr>
          <p:cNvPr id="35" name="Straight Connector 34">
            <a:extLst>
              <a:ext uri="{FF2B5EF4-FFF2-40B4-BE49-F238E27FC236}">
                <a16:creationId xmlns:a16="http://schemas.microsoft.com/office/drawing/2014/main" id="{EAA5785A-76FF-4E58-9AE8-0555230AEDD3}"/>
              </a:ext>
            </a:extLst>
          </p:cNvPr>
          <p:cNvCxnSpPr>
            <a:cxnSpLocks/>
          </p:cNvCxnSpPr>
          <p:nvPr/>
        </p:nvCxnSpPr>
        <p:spPr>
          <a:xfrm>
            <a:off x="7058350" y="3557734"/>
            <a:ext cx="1995407" cy="0"/>
          </a:xfrm>
          <a:prstGeom prst="line">
            <a:avLst/>
          </a:prstGeom>
        </p:spPr>
        <p:style>
          <a:lnRef idx="1">
            <a:schemeClr val="accent1"/>
          </a:lnRef>
          <a:fillRef idx="0">
            <a:schemeClr val="accent1"/>
          </a:fillRef>
          <a:effectRef idx="0">
            <a:schemeClr val="accent1"/>
          </a:effectRef>
          <a:fontRef idx="minor">
            <a:schemeClr val="tx1"/>
          </a:fontRef>
        </p:style>
      </p:cxnSp>
      <p:sp>
        <p:nvSpPr>
          <p:cNvPr id="36" name="Arrow: Down 35">
            <a:extLst>
              <a:ext uri="{FF2B5EF4-FFF2-40B4-BE49-F238E27FC236}">
                <a16:creationId xmlns:a16="http://schemas.microsoft.com/office/drawing/2014/main" id="{FE50D528-7CEF-4ED2-9834-37A1A83283C3}"/>
              </a:ext>
            </a:extLst>
          </p:cNvPr>
          <p:cNvSpPr/>
          <p:nvPr/>
        </p:nvSpPr>
        <p:spPr>
          <a:xfrm rot="10800000">
            <a:off x="7820028" y="3625940"/>
            <a:ext cx="472051" cy="568587"/>
          </a:xfrm>
          <a:prstGeom prst="downArrow">
            <a:avLst/>
          </a:prstGeom>
          <a:solidFill>
            <a:srgbClr val="CC99FF"/>
          </a:solidFill>
          <a:ln>
            <a:solidFill>
              <a:srgbClr val="CC99FF"/>
            </a:solidFill>
          </a:ln>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a:p>
        </p:txBody>
      </p:sp>
      <p:sp>
        <p:nvSpPr>
          <p:cNvPr id="37" name="TextBox 36">
            <a:extLst>
              <a:ext uri="{FF2B5EF4-FFF2-40B4-BE49-F238E27FC236}">
                <a16:creationId xmlns:a16="http://schemas.microsoft.com/office/drawing/2014/main" id="{11F4F17E-B198-4662-82B9-FD38C6AFD4A0}"/>
              </a:ext>
            </a:extLst>
          </p:cNvPr>
          <p:cNvSpPr txBox="1"/>
          <p:nvPr/>
        </p:nvSpPr>
        <p:spPr>
          <a:xfrm>
            <a:off x="3690535" y="4991091"/>
            <a:ext cx="4910320" cy="584775"/>
          </a:xfrm>
          <a:prstGeom prst="rect">
            <a:avLst/>
          </a:prstGeom>
          <a:noFill/>
        </p:spPr>
        <p:txBody>
          <a:bodyPr wrap="none" rtlCol="0">
            <a:spAutoFit/>
          </a:bodyPr>
          <a:lstStyle/>
          <a:p>
            <a:pPr algn="ctr"/>
            <a:r>
              <a:rPr lang="en-US" sz="3200" err="1">
                <a:solidFill>
                  <a:srgbClr val="00B050"/>
                </a:solidFill>
              </a:rPr>
              <a:t>Inter_Intervals</a:t>
            </a:r>
            <a:r>
              <a:rPr lang="en-US" sz="3200">
                <a:solidFill>
                  <a:srgbClr val="00B050"/>
                </a:solidFill>
              </a:rPr>
              <a:t> = [3, 4] sec</a:t>
            </a:r>
          </a:p>
        </p:txBody>
      </p:sp>
      <p:sp>
        <p:nvSpPr>
          <p:cNvPr id="43" name="TextBox 42">
            <a:extLst>
              <a:ext uri="{FF2B5EF4-FFF2-40B4-BE49-F238E27FC236}">
                <a16:creationId xmlns:a16="http://schemas.microsoft.com/office/drawing/2014/main" id="{D8A5192F-AD11-4EE7-9768-886477640848}"/>
              </a:ext>
            </a:extLst>
          </p:cNvPr>
          <p:cNvSpPr txBox="1"/>
          <p:nvPr/>
        </p:nvSpPr>
        <p:spPr>
          <a:xfrm>
            <a:off x="6145695" y="3214713"/>
            <a:ext cx="298699" cy="369332"/>
          </a:xfrm>
          <a:prstGeom prst="rect">
            <a:avLst/>
          </a:prstGeom>
          <a:noFill/>
        </p:spPr>
        <p:txBody>
          <a:bodyPr wrap="square" rtlCol="0">
            <a:spAutoFit/>
          </a:bodyPr>
          <a:lstStyle/>
          <a:p>
            <a:pPr algn="ctr"/>
            <a:r>
              <a:rPr lang="en-US"/>
              <a:t>3</a:t>
            </a:r>
          </a:p>
        </p:txBody>
      </p:sp>
      <p:cxnSp>
        <p:nvCxnSpPr>
          <p:cNvPr id="44" name="Straight Connector 43">
            <a:extLst>
              <a:ext uri="{FF2B5EF4-FFF2-40B4-BE49-F238E27FC236}">
                <a16:creationId xmlns:a16="http://schemas.microsoft.com/office/drawing/2014/main" id="{49F12F1F-A365-4928-97C5-D4B1636F3611}"/>
              </a:ext>
            </a:extLst>
          </p:cNvPr>
          <p:cNvCxnSpPr>
            <a:cxnSpLocks/>
          </p:cNvCxnSpPr>
          <p:nvPr/>
        </p:nvCxnSpPr>
        <p:spPr>
          <a:xfrm>
            <a:off x="5541943" y="3557734"/>
            <a:ext cx="1509339" cy="0"/>
          </a:xfrm>
          <a:prstGeom prst="line">
            <a:avLst/>
          </a:prstGeom>
        </p:spPr>
        <p:style>
          <a:lnRef idx="1">
            <a:schemeClr val="accent1"/>
          </a:lnRef>
          <a:fillRef idx="0">
            <a:schemeClr val="accent1"/>
          </a:fillRef>
          <a:effectRef idx="0">
            <a:schemeClr val="accent1"/>
          </a:effectRef>
          <a:fontRef idx="minor">
            <a:schemeClr val="tx1"/>
          </a:fontRef>
        </p:style>
      </p:cxnSp>
      <p:sp>
        <p:nvSpPr>
          <p:cNvPr id="45" name="Arrow: Down 44">
            <a:extLst>
              <a:ext uri="{FF2B5EF4-FFF2-40B4-BE49-F238E27FC236}">
                <a16:creationId xmlns:a16="http://schemas.microsoft.com/office/drawing/2014/main" id="{8F839C2A-6B20-4896-9318-12A9F8AC6806}"/>
              </a:ext>
            </a:extLst>
          </p:cNvPr>
          <p:cNvSpPr/>
          <p:nvPr/>
        </p:nvSpPr>
        <p:spPr>
          <a:xfrm rot="10800000">
            <a:off x="6057564" y="3625940"/>
            <a:ext cx="472051" cy="568587"/>
          </a:xfrm>
          <a:prstGeom prst="downArrow">
            <a:avLst/>
          </a:prstGeom>
          <a:solidFill>
            <a:srgbClr val="CC99FF"/>
          </a:solidFill>
          <a:ln>
            <a:solidFill>
              <a:srgbClr val="CC99FF"/>
            </a:solidFill>
          </a:ln>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a:p>
        </p:txBody>
      </p:sp>
      <p:sp>
        <p:nvSpPr>
          <p:cNvPr id="30" name="&quot;Not Allowed&quot; Symbol 29">
            <a:extLst>
              <a:ext uri="{FF2B5EF4-FFF2-40B4-BE49-F238E27FC236}">
                <a16:creationId xmlns:a16="http://schemas.microsoft.com/office/drawing/2014/main" id="{A4382A67-DA2E-44AB-A549-32451C6CCEB7}"/>
              </a:ext>
            </a:extLst>
          </p:cNvPr>
          <p:cNvSpPr/>
          <p:nvPr/>
        </p:nvSpPr>
        <p:spPr>
          <a:xfrm>
            <a:off x="4337752" y="3108211"/>
            <a:ext cx="899045" cy="899045"/>
          </a:xfrm>
          <a:prstGeom prst="noSmoking">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1" name="TextBox 30">
            <a:extLst>
              <a:ext uri="{FF2B5EF4-FFF2-40B4-BE49-F238E27FC236}">
                <a16:creationId xmlns:a16="http://schemas.microsoft.com/office/drawing/2014/main" id="{6DA930FB-AD67-4BF5-B2F1-40CB2B19AF1E}"/>
              </a:ext>
            </a:extLst>
          </p:cNvPr>
          <p:cNvSpPr txBox="1"/>
          <p:nvPr/>
        </p:nvSpPr>
        <p:spPr>
          <a:xfrm>
            <a:off x="4629225" y="3373067"/>
            <a:ext cx="301686" cy="369332"/>
          </a:xfrm>
          <a:prstGeom prst="rect">
            <a:avLst/>
          </a:prstGeom>
          <a:noFill/>
        </p:spPr>
        <p:txBody>
          <a:bodyPr wrap="square" rtlCol="0">
            <a:spAutoFit/>
          </a:bodyPr>
          <a:lstStyle/>
          <a:p>
            <a:pPr algn="ctr"/>
            <a:r>
              <a:rPr lang="en-US"/>
              <a:t>5</a:t>
            </a:r>
          </a:p>
        </p:txBody>
      </p:sp>
      <mc:AlternateContent xmlns:mc="http://schemas.openxmlformats.org/markup-compatibility/2006">
        <mc:Choice xmlns:a14="http://schemas.microsoft.com/office/drawing/2010/main" Requires="a14">
          <p:sp>
            <p:nvSpPr>
              <p:cNvPr id="46" name="TextBox 45">
                <a:extLst>
                  <a:ext uri="{FF2B5EF4-FFF2-40B4-BE49-F238E27FC236}">
                    <a16:creationId xmlns:a16="http://schemas.microsoft.com/office/drawing/2014/main" id="{B3FCEA8F-D89A-459A-8EE5-ADB9402A18C5}"/>
                  </a:ext>
                </a:extLst>
              </p:cNvPr>
              <p:cNvSpPr txBox="1"/>
              <p:nvPr/>
            </p:nvSpPr>
            <p:spPr>
              <a:xfrm>
                <a:off x="1412073" y="5892094"/>
                <a:ext cx="9367886" cy="940129"/>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minter = </a:t>
                </a:r>
                <a14:m>
                  <m:oMath xmlns:m="http://schemas.openxmlformats.org/officeDocument/2006/math">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𝑠𝑢𝑚</m:t>
                        </m:r>
                        <m:r>
                          <a:rPr lang="en-US" sz="3600" b="0" i="1" smtClean="0">
                            <a:solidFill>
                              <a:schemeClr val="accent1"/>
                            </a:solidFill>
                            <a:latin typeface="Cambria Math" panose="02040503050406030204" pitchFamily="18" charset="0"/>
                          </a:rPr>
                          <m:t>(</m:t>
                        </m:r>
                        <m:r>
                          <a:rPr lang="en-US" sz="3600" b="0" i="1" smtClean="0">
                            <a:solidFill>
                              <a:schemeClr val="accent1"/>
                            </a:solidFill>
                            <a:latin typeface="Cambria Math" panose="02040503050406030204" pitchFamily="18" charset="0"/>
                          </a:rPr>
                          <m:t>𝑖𝑛𝑡𝑒𝑟</m:t>
                        </m:r>
                        <m:r>
                          <a:rPr lang="en-US" sz="3600" b="0" i="1" smtClean="0">
                            <a:solidFill>
                              <a:schemeClr val="accent1"/>
                            </a:solidFill>
                            <a:latin typeface="Cambria Math" panose="02040503050406030204" pitchFamily="18" charset="0"/>
                          </a:rPr>
                          <m:t>_</m:t>
                        </m:r>
                        <m:r>
                          <a:rPr lang="en-US" sz="3600" b="0" i="1" smtClean="0">
                            <a:solidFill>
                              <a:schemeClr val="accent1"/>
                            </a:solidFill>
                            <a:latin typeface="Cambria Math" panose="02040503050406030204" pitchFamily="18" charset="0"/>
                          </a:rPr>
                          <m:t>𝑖𝑛𝑡𝑒𝑟𝑣𝑎𝑙𝑠</m:t>
                        </m:r>
                      </m:num>
                      <m:den>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𝑖𝑛𝑡𝑒𝑟</m:t>
                        </m:r>
                        <m:r>
                          <a:rPr lang="en-US" sz="3600" b="0" i="1" smtClean="0">
                            <a:solidFill>
                              <a:schemeClr val="accent1"/>
                            </a:solidFill>
                            <a:latin typeface="Cambria Math" panose="02040503050406030204" pitchFamily="18" charset="0"/>
                          </a:rPr>
                          <m:t>_</m:t>
                        </m:r>
                        <m:r>
                          <a:rPr lang="en-US" sz="3600" b="0" i="1" smtClean="0">
                            <a:solidFill>
                              <a:schemeClr val="accent1"/>
                            </a:solidFill>
                            <a:latin typeface="Cambria Math" panose="02040503050406030204" pitchFamily="18" charset="0"/>
                          </a:rPr>
                          <m:t>𝑖𝑛𝑡𝑒𝑟𝑣𝑎𝑙𝑠</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3+4</m:t>
                        </m:r>
                      </m:num>
                      <m:den>
                        <m:r>
                          <a:rPr lang="en-US" sz="3600" b="0" i="1" smtClean="0">
                            <a:solidFill>
                              <a:schemeClr val="accent1"/>
                            </a:solidFill>
                            <a:latin typeface="Cambria Math" panose="02040503050406030204" pitchFamily="18" charset="0"/>
                          </a:rPr>
                          <m:t>2</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7</m:t>
                        </m:r>
                      </m:num>
                      <m:den>
                        <m:r>
                          <a:rPr lang="en-US" sz="3600" b="0" i="1" smtClean="0">
                            <a:solidFill>
                              <a:schemeClr val="accent1"/>
                            </a:solidFill>
                            <a:latin typeface="Cambria Math" panose="02040503050406030204" pitchFamily="18" charset="0"/>
                          </a:rPr>
                          <m:t>2</m:t>
                        </m:r>
                      </m:den>
                    </m:f>
                    <m:r>
                      <a:rPr lang="en-US" sz="3600" b="0" i="1" smtClean="0">
                        <a:solidFill>
                          <a:schemeClr val="accent1"/>
                        </a:solidFill>
                        <a:latin typeface="Cambria Math" panose="02040503050406030204" pitchFamily="18" charset="0"/>
                      </a:rPr>
                      <m:t>=3.5 </m:t>
                    </m:r>
                    <m:r>
                      <a:rPr lang="en-US" sz="3600" b="0" i="1" smtClean="0">
                        <a:solidFill>
                          <a:schemeClr val="accent1"/>
                        </a:solidFill>
                        <a:latin typeface="Cambria Math" panose="02040503050406030204" pitchFamily="18" charset="0"/>
                      </a:rPr>
                      <m:t>𝑠𝑒𝑐</m:t>
                    </m:r>
                  </m:oMath>
                </a14:m>
                <a:endParaRPr lang="en-US" sz="3600">
                  <a:solidFill>
                    <a:schemeClr val="accent1"/>
                  </a:solidFill>
                </a:endParaRPr>
              </a:p>
            </p:txBody>
          </p:sp>
        </mc:Choice>
        <mc:Fallback>
          <p:sp>
            <p:nvSpPr>
              <p:cNvPr id="46" name="TextBox 45">
                <a:extLst>
                  <a:ext uri="{FF2B5EF4-FFF2-40B4-BE49-F238E27FC236}">
                    <a16:creationId xmlns:a16="http://schemas.microsoft.com/office/drawing/2014/main" id="{B3FCEA8F-D89A-459A-8EE5-ADB9402A18C5}"/>
                  </a:ext>
                </a:extLst>
              </p:cNvPr>
              <p:cNvSpPr txBox="1">
                <a:spLocks noRot="1" noChangeAspect="1" noMove="1" noResize="1" noEditPoints="1" noAdjustHandles="1" noChangeArrowheads="1" noChangeShapeType="1" noTextEdit="1"/>
              </p:cNvSpPr>
              <p:nvPr/>
            </p:nvSpPr>
            <p:spPr>
              <a:xfrm>
                <a:off x="1412073" y="5892094"/>
                <a:ext cx="9367886" cy="940129"/>
              </a:xfrm>
              <a:prstGeom prst="rect">
                <a:avLst/>
              </a:prstGeom>
              <a:blipFill>
                <a:blip r:embed="rId2"/>
                <a:stretch>
                  <a:fillRect l="-1563" b="-6494"/>
                </a:stretch>
              </a:blipFill>
            </p:spPr>
            <p:txBody>
              <a:bodyPr/>
              <a:lstStyle/>
              <a:p>
                <a:r>
                  <a:rPr lang="en-US">
                    <a:noFill/>
                  </a:rPr>
                  <a:t> </a:t>
                </a:r>
              </a:p>
            </p:txBody>
          </p:sp>
        </mc:Fallback>
      </mc:AlternateContent>
    </p:spTree>
    <p:extLst>
      <p:ext uri="{BB962C8B-B14F-4D97-AF65-F5344CB8AC3E}">
        <p14:creationId xmlns:p14="http://schemas.microsoft.com/office/powerpoint/2010/main" val="29589325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Mean intra-burst interval: </a:t>
            </a:r>
            <a:r>
              <a:rPr lang="en-US" sz="3600"/>
              <a:t>The average of all </a:t>
            </a:r>
            <a:r>
              <a:rPr lang="en-US" sz="3600" err="1"/>
              <a:t>intraburst</a:t>
            </a:r>
            <a:r>
              <a:rPr lang="en-US" sz="3600"/>
              <a:t> intervals that are not interrupted by gaps</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7" name="TextBox 36">
            <a:extLst>
              <a:ext uri="{FF2B5EF4-FFF2-40B4-BE49-F238E27FC236}">
                <a16:creationId xmlns:a16="http://schemas.microsoft.com/office/drawing/2014/main" id="{11F4F17E-B198-4662-82B9-FD38C6AFD4A0}"/>
              </a:ext>
            </a:extLst>
          </p:cNvPr>
          <p:cNvSpPr txBox="1"/>
          <p:nvPr/>
        </p:nvSpPr>
        <p:spPr>
          <a:xfrm>
            <a:off x="2723126" y="4991091"/>
            <a:ext cx="6845144" cy="584775"/>
          </a:xfrm>
          <a:prstGeom prst="rect">
            <a:avLst/>
          </a:prstGeom>
          <a:noFill/>
        </p:spPr>
        <p:txBody>
          <a:bodyPr wrap="none" rtlCol="0">
            <a:spAutoFit/>
          </a:bodyPr>
          <a:lstStyle/>
          <a:p>
            <a:pPr algn="ctr"/>
            <a:r>
              <a:rPr lang="en-US" sz="3200" err="1">
                <a:solidFill>
                  <a:srgbClr val="00B050"/>
                </a:solidFill>
              </a:rPr>
              <a:t>Intra_Intervals</a:t>
            </a:r>
            <a:r>
              <a:rPr lang="en-US" sz="3200">
                <a:solidFill>
                  <a:srgbClr val="00B050"/>
                </a:solidFill>
              </a:rPr>
              <a:t> = [1.5, 0.5, 0.5, 1] sec</a:t>
            </a:r>
          </a:p>
        </p:txBody>
      </p:sp>
      <mc:AlternateContent xmlns:mc="http://schemas.openxmlformats.org/markup-compatibility/2006">
        <mc:Choice xmlns:a14="http://schemas.microsoft.com/office/drawing/2010/main" Requires="a14">
          <p:sp>
            <p:nvSpPr>
              <p:cNvPr id="46" name="TextBox 45">
                <a:extLst>
                  <a:ext uri="{FF2B5EF4-FFF2-40B4-BE49-F238E27FC236}">
                    <a16:creationId xmlns:a16="http://schemas.microsoft.com/office/drawing/2014/main" id="{B3FCEA8F-D89A-459A-8EE5-ADB9402A18C5}"/>
                  </a:ext>
                </a:extLst>
              </p:cNvPr>
              <p:cNvSpPr txBox="1"/>
              <p:nvPr/>
            </p:nvSpPr>
            <p:spPr>
              <a:xfrm>
                <a:off x="225695" y="5892094"/>
                <a:ext cx="11740650" cy="940129"/>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mintra = </a:t>
                </a:r>
                <a14:m>
                  <m:oMath xmlns:m="http://schemas.openxmlformats.org/officeDocument/2006/math">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𝑠𝑢𝑚</m:t>
                        </m:r>
                        <m:r>
                          <a:rPr lang="en-US" sz="3600" b="0" i="1" smtClean="0">
                            <a:solidFill>
                              <a:schemeClr val="accent1"/>
                            </a:solidFill>
                            <a:latin typeface="Cambria Math" panose="02040503050406030204" pitchFamily="18" charset="0"/>
                          </a:rPr>
                          <m:t>(</m:t>
                        </m:r>
                        <m:r>
                          <a:rPr lang="en-US" sz="3600" b="0" i="1" smtClean="0">
                            <a:solidFill>
                              <a:schemeClr val="accent1"/>
                            </a:solidFill>
                            <a:latin typeface="Cambria Math" panose="02040503050406030204" pitchFamily="18" charset="0"/>
                          </a:rPr>
                          <m:t>𝑖𝑛𝑡𝑟𝑎</m:t>
                        </m:r>
                        <m:r>
                          <a:rPr lang="en-US" sz="3600" b="0" i="1" smtClean="0">
                            <a:solidFill>
                              <a:schemeClr val="accent1"/>
                            </a:solidFill>
                            <a:latin typeface="Cambria Math" panose="02040503050406030204" pitchFamily="18" charset="0"/>
                          </a:rPr>
                          <m:t>_</m:t>
                        </m:r>
                        <m:r>
                          <a:rPr lang="en-US" sz="3600" b="0" i="1" smtClean="0">
                            <a:solidFill>
                              <a:schemeClr val="accent1"/>
                            </a:solidFill>
                            <a:latin typeface="Cambria Math" panose="02040503050406030204" pitchFamily="18" charset="0"/>
                          </a:rPr>
                          <m:t>𝑖𝑛𝑡𝑒𝑟𝑣𝑎𝑙𝑠</m:t>
                        </m:r>
                      </m:num>
                      <m:den>
                        <m:r>
                          <a:rPr lang="en-US" sz="3600" b="0" i="1" smtClean="0">
                            <a:solidFill>
                              <a:schemeClr val="accent1"/>
                            </a:solidFill>
                            <a:latin typeface="Cambria Math" panose="02040503050406030204" pitchFamily="18" charset="0"/>
                          </a:rPr>
                          <m:t># </m:t>
                        </m:r>
                        <m:r>
                          <a:rPr lang="en-US" sz="3600" b="0" i="1" smtClean="0">
                            <a:solidFill>
                              <a:schemeClr val="accent1"/>
                            </a:solidFill>
                            <a:latin typeface="Cambria Math" panose="02040503050406030204" pitchFamily="18" charset="0"/>
                          </a:rPr>
                          <m:t>𝑖𝑛𝑡𝑒𝑟</m:t>
                        </m:r>
                        <m:r>
                          <a:rPr lang="en-US" sz="3600" b="0" i="1" smtClean="0">
                            <a:solidFill>
                              <a:schemeClr val="accent1"/>
                            </a:solidFill>
                            <a:latin typeface="Cambria Math" panose="02040503050406030204" pitchFamily="18" charset="0"/>
                          </a:rPr>
                          <m:t>_</m:t>
                        </m:r>
                        <m:r>
                          <a:rPr lang="en-US" sz="3600" b="0" i="1" smtClean="0">
                            <a:solidFill>
                              <a:schemeClr val="accent1"/>
                            </a:solidFill>
                            <a:latin typeface="Cambria Math" panose="02040503050406030204" pitchFamily="18" charset="0"/>
                          </a:rPr>
                          <m:t>𝑖𝑛𝑡𝑒𝑟𝑣𝑎𝑙𝑠</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1.5+0.5+0.5+1</m:t>
                        </m:r>
                      </m:num>
                      <m:den>
                        <m:r>
                          <a:rPr lang="en-US" sz="3600" b="0" i="1" smtClean="0">
                            <a:solidFill>
                              <a:schemeClr val="accent1"/>
                            </a:solidFill>
                            <a:latin typeface="Cambria Math" panose="02040503050406030204" pitchFamily="18" charset="0"/>
                          </a:rPr>
                          <m:t>4</m:t>
                        </m:r>
                      </m:den>
                    </m:f>
                    <m:r>
                      <a:rPr lang="en-US" sz="3600" b="0" i="1" smtClean="0">
                        <a:solidFill>
                          <a:schemeClr val="accent1"/>
                        </a:solidFill>
                        <a:latin typeface="Cambria Math" panose="02040503050406030204" pitchFamily="18" charset="0"/>
                      </a:rPr>
                      <m:t>=</m:t>
                    </m:r>
                    <m:f>
                      <m:fPr>
                        <m:ctrlPr>
                          <a:rPr lang="en-US" sz="3600" b="0" i="1" smtClean="0">
                            <a:solidFill>
                              <a:schemeClr val="accent1"/>
                            </a:solidFill>
                            <a:latin typeface="Cambria Math" panose="02040503050406030204" pitchFamily="18" charset="0"/>
                          </a:rPr>
                        </m:ctrlPr>
                      </m:fPr>
                      <m:num>
                        <m:r>
                          <a:rPr lang="en-US" sz="3600" b="0" i="1" smtClean="0">
                            <a:solidFill>
                              <a:schemeClr val="accent1"/>
                            </a:solidFill>
                            <a:latin typeface="Cambria Math" panose="02040503050406030204" pitchFamily="18" charset="0"/>
                          </a:rPr>
                          <m:t>3.5</m:t>
                        </m:r>
                      </m:num>
                      <m:den>
                        <m:r>
                          <a:rPr lang="en-US" sz="3600" b="0" i="1" smtClean="0">
                            <a:solidFill>
                              <a:schemeClr val="accent1"/>
                            </a:solidFill>
                            <a:latin typeface="Cambria Math" panose="02040503050406030204" pitchFamily="18" charset="0"/>
                          </a:rPr>
                          <m:t>4</m:t>
                        </m:r>
                      </m:den>
                    </m:f>
                    <m:r>
                      <a:rPr lang="en-US" sz="3600" b="0" i="1" smtClean="0">
                        <a:solidFill>
                          <a:schemeClr val="accent1"/>
                        </a:solidFill>
                        <a:latin typeface="Cambria Math" panose="02040503050406030204" pitchFamily="18" charset="0"/>
                      </a:rPr>
                      <m:t>=0.875 </m:t>
                    </m:r>
                    <m:r>
                      <a:rPr lang="en-US" sz="3600" b="0" i="1" smtClean="0">
                        <a:solidFill>
                          <a:schemeClr val="accent1"/>
                        </a:solidFill>
                        <a:latin typeface="Cambria Math" panose="02040503050406030204" pitchFamily="18" charset="0"/>
                      </a:rPr>
                      <m:t>𝑠𝑒𝑐</m:t>
                    </m:r>
                  </m:oMath>
                </a14:m>
                <a:endParaRPr lang="en-US" sz="3600">
                  <a:solidFill>
                    <a:schemeClr val="accent1"/>
                  </a:solidFill>
                </a:endParaRPr>
              </a:p>
            </p:txBody>
          </p:sp>
        </mc:Choice>
        <mc:Fallback>
          <p:sp>
            <p:nvSpPr>
              <p:cNvPr id="46" name="TextBox 45">
                <a:extLst>
                  <a:ext uri="{FF2B5EF4-FFF2-40B4-BE49-F238E27FC236}">
                    <a16:creationId xmlns:a16="http://schemas.microsoft.com/office/drawing/2014/main" id="{B3FCEA8F-D89A-459A-8EE5-ADB9402A18C5}"/>
                  </a:ext>
                </a:extLst>
              </p:cNvPr>
              <p:cNvSpPr txBox="1">
                <a:spLocks noRot="1" noChangeAspect="1" noMove="1" noResize="1" noEditPoints="1" noAdjustHandles="1" noChangeArrowheads="1" noChangeShapeType="1" noTextEdit="1"/>
              </p:cNvSpPr>
              <p:nvPr/>
            </p:nvSpPr>
            <p:spPr>
              <a:xfrm>
                <a:off x="225695" y="5892094"/>
                <a:ext cx="11740650" cy="940129"/>
              </a:xfrm>
              <a:prstGeom prst="rect">
                <a:avLst/>
              </a:prstGeom>
              <a:blipFill>
                <a:blip r:embed="rId2"/>
                <a:stretch>
                  <a:fillRect l="-1506" b="-6494"/>
                </a:stretch>
              </a:blipFill>
            </p:spPr>
            <p:txBody>
              <a:bodyPr/>
              <a:lstStyle/>
              <a:p>
                <a:r>
                  <a:rPr lang="en-US">
                    <a:noFill/>
                  </a:rPr>
                  <a:t> </a:t>
                </a:r>
              </a:p>
            </p:txBody>
          </p:sp>
        </mc:Fallback>
      </mc:AlternateContent>
      <p:cxnSp>
        <p:nvCxnSpPr>
          <p:cNvPr id="38" name="Straight Connector 37">
            <a:extLst>
              <a:ext uri="{FF2B5EF4-FFF2-40B4-BE49-F238E27FC236}">
                <a16:creationId xmlns:a16="http://schemas.microsoft.com/office/drawing/2014/main" id="{679A1E74-D06F-421B-A2DF-AF555FE4108A}"/>
              </a:ext>
            </a:extLst>
          </p:cNvPr>
          <p:cNvCxnSpPr>
            <a:cxnSpLocks/>
          </p:cNvCxnSpPr>
          <p:nvPr/>
        </p:nvCxnSpPr>
        <p:spPr>
          <a:xfrm>
            <a:off x="3026378"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1CEED8F7-68A8-4964-8C07-3A90094E793E}"/>
              </a:ext>
            </a:extLst>
          </p:cNvPr>
          <p:cNvCxnSpPr>
            <a:cxnSpLocks/>
          </p:cNvCxnSpPr>
          <p:nvPr/>
        </p:nvCxnSpPr>
        <p:spPr>
          <a:xfrm>
            <a:off x="403260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C247D9B3-60F4-49FC-91F7-BB43C135E37B}"/>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5335414E-2F04-4013-AF6D-EF915881D0A5}"/>
              </a:ext>
            </a:extLst>
          </p:cNvPr>
          <p:cNvCxnSpPr>
            <a:cxnSpLocks/>
          </p:cNvCxnSpPr>
          <p:nvPr/>
        </p:nvCxnSpPr>
        <p:spPr>
          <a:xfrm>
            <a:off x="856062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6CABE885-F2EE-4C73-ADB7-F08500CC216A}"/>
              </a:ext>
            </a:extLst>
          </p:cNvPr>
          <p:cNvCxnSpPr>
            <a:cxnSpLocks/>
          </p:cNvCxnSpPr>
          <p:nvPr/>
        </p:nvCxnSpPr>
        <p:spPr>
          <a:xfrm>
            <a:off x="906373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B1738F0B-4B49-43CA-A172-DBE1B5809737}"/>
              </a:ext>
            </a:extLst>
          </p:cNvPr>
          <p:cNvCxnSpPr>
            <a:cxnSpLocks/>
          </p:cNvCxnSpPr>
          <p:nvPr/>
        </p:nvCxnSpPr>
        <p:spPr>
          <a:xfrm>
            <a:off x="9566847"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52" name="TextBox 51">
            <a:extLst>
              <a:ext uri="{FF2B5EF4-FFF2-40B4-BE49-F238E27FC236}">
                <a16:creationId xmlns:a16="http://schemas.microsoft.com/office/drawing/2014/main" id="{FAD7A4B2-A1E3-415D-A665-453154FAB86C}"/>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54" name="TextBox 53">
            <a:extLst>
              <a:ext uri="{FF2B5EF4-FFF2-40B4-BE49-F238E27FC236}">
                <a16:creationId xmlns:a16="http://schemas.microsoft.com/office/drawing/2014/main" id="{7381E3C5-ED8A-4469-BED7-2F5B2886C88D}"/>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55" name="TextBox 54">
            <a:extLst>
              <a:ext uri="{FF2B5EF4-FFF2-40B4-BE49-F238E27FC236}">
                <a16:creationId xmlns:a16="http://schemas.microsoft.com/office/drawing/2014/main" id="{9B8ED585-3C99-48EE-B49C-05996436BA14}"/>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57" name="TextBox 56">
            <a:extLst>
              <a:ext uri="{FF2B5EF4-FFF2-40B4-BE49-F238E27FC236}">
                <a16:creationId xmlns:a16="http://schemas.microsoft.com/office/drawing/2014/main" id="{4D469F44-E72E-45EA-91AC-AC07FD3DE9F3}"/>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58" name="TextBox 57">
            <a:extLst>
              <a:ext uri="{FF2B5EF4-FFF2-40B4-BE49-F238E27FC236}">
                <a16:creationId xmlns:a16="http://schemas.microsoft.com/office/drawing/2014/main" id="{4F2BDE49-EE55-4350-8BF0-F9CE734E60EB}"/>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59" name="TextBox 58">
            <a:extLst>
              <a:ext uri="{FF2B5EF4-FFF2-40B4-BE49-F238E27FC236}">
                <a16:creationId xmlns:a16="http://schemas.microsoft.com/office/drawing/2014/main" id="{75D68392-A52D-4E97-9277-3D76539B1091}"/>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60" name="TextBox 59">
            <a:extLst>
              <a:ext uri="{FF2B5EF4-FFF2-40B4-BE49-F238E27FC236}">
                <a16:creationId xmlns:a16="http://schemas.microsoft.com/office/drawing/2014/main" id="{802B3785-D750-479B-B35D-E8BDF822272B}"/>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62" name="TextBox 61">
            <a:extLst>
              <a:ext uri="{FF2B5EF4-FFF2-40B4-BE49-F238E27FC236}">
                <a16:creationId xmlns:a16="http://schemas.microsoft.com/office/drawing/2014/main" id="{C4B33B01-2ECE-46FF-ADF3-90FB961B320D}"/>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63" name="TextBox 62">
            <a:extLst>
              <a:ext uri="{FF2B5EF4-FFF2-40B4-BE49-F238E27FC236}">
                <a16:creationId xmlns:a16="http://schemas.microsoft.com/office/drawing/2014/main" id="{9E01BDAD-702C-4C2F-88A7-3F34BD58A52B}"/>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65" name="TextBox 64">
            <a:extLst>
              <a:ext uri="{FF2B5EF4-FFF2-40B4-BE49-F238E27FC236}">
                <a16:creationId xmlns:a16="http://schemas.microsoft.com/office/drawing/2014/main" id="{A457C328-3FC8-4F8A-9772-3211116F0778}"/>
              </a:ext>
            </a:extLst>
          </p:cNvPr>
          <p:cNvSpPr txBox="1"/>
          <p:nvPr/>
        </p:nvSpPr>
        <p:spPr>
          <a:xfrm>
            <a:off x="8404168"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66" name="TextBox 65">
            <a:extLst>
              <a:ext uri="{FF2B5EF4-FFF2-40B4-BE49-F238E27FC236}">
                <a16:creationId xmlns:a16="http://schemas.microsoft.com/office/drawing/2014/main" id="{DAFF608D-E1CA-41C9-B58D-5F736CFE46FE}"/>
              </a:ext>
            </a:extLst>
          </p:cNvPr>
          <p:cNvSpPr txBox="1"/>
          <p:nvPr/>
        </p:nvSpPr>
        <p:spPr>
          <a:xfrm>
            <a:off x="8907281"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6E00364D-EB2F-4B86-B713-DE620F3D9B6E}"/>
              </a:ext>
            </a:extLst>
          </p:cNvPr>
          <p:cNvSpPr txBox="1"/>
          <p:nvPr/>
        </p:nvSpPr>
        <p:spPr>
          <a:xfrm>
            <a:off x="9410394"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cxnSp>
        <p:nvCxnSpPr>
          <p:cNvPr id="73" name="Straight Connector 72">
            <a:extLst>
              <a:ext uri="{FF2B5EF4-FFF2-40B4-BE49-F238E27FC236}">
                <a16:creationId xmlns:a16="http://schemas.microsoft.com/office/drawing/2014/main" id="{4FB2743C-BA85-45B8-8E7D-CAD53164FA1B}"/>
              </a:ext>
            </a:extLst>
          </p:cNvPr>
          <p:cNvCxnSpPr>
            <a:cxnSpLocks/>
          </p:cNvCxnSpPr>
          <p:nvPr/>
        </p:nvCxnSpPr>
        <p:spPr>
          <a:xfrm>
            <a:off x="378195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74" name="TextBox 73">
            <a:extLst>
              <a:ext uri="{FF2B5EF4-FFF2-40B4-BE49-F238E27FC236}">
                <a16:creationId xmlns:a16="http://schemas.microsoft.com/office/drawing/2014/main" id="{DD2A9F8B-7937-4D05-936D-132C6E47FA03}"/>
              </a:ext>
            </a:extLst>
          </p:cNvPr>
          <p:cNvSpPr txBox="1"/>
          <p:nvPr/>
        </p:nvSpPr>
        <p:spPr>
          <a:xfrm>
            <a:off x="3529319" y="2324101"/>
            <a:ext cx="505268"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5</a:t>
            </a:r>
          </a:p>
        </p:txBody>
      </p:sp>
      <p:sp>
        <p:nvSpPr>
          <p:cNvPr id="75" name="TextBox 74">
            <a:extLst>
              <a:ext uri="{FF2B5EF4-FFF2-40B4-BE49-F238E27FC236}">
                <a16:creationId xmlns:a16="http://schemas.microsoft.com/office/drawing/2014/main" id="{73393428-69D2-43D2-9DF6-FC52BC91236B}"/>
              </a:ext>
            </a:extLst>
          </p:cNvPr>
          <p:cNvSpPr txBox="1"/>
          <p:nvPr/>
        </p:nvSpPr>
        <p:spPr>
          <a:xfrm>
            <a:off x="3625499"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cxnSp>
        <p:nvCxnSpPr>
          <p:cNvPr id="76" name="Straight Connector 75">
            <a:extLst>
              <a:ext uri="{FF2B5EF4-FFF2-40B4-BE49-F238E27FC236}">
                <a16:creationId xmlns:a16="http://schemas.microsoft.com/office/drawing/2014/main" id="{506F30E3-7638-4C2B-9E3A-1A4209EE9562}"/>
              </a:ext>
            </a:extLst>
          </p:cNvPr>
          <p:cNvCxnSpPr>
            <a:cxnSpLocks/>
          </p:cNvCxnSpPr>
          <p:nvPr/>
        </p:nvCxnSpPr>
        <p:spPr>
          <a:xfrm>
            <a:off x="679864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77" name="TextBox 76">
            <a:extLst>
              <a:ext uri="{FF2B5EF4-FFF2-40B4-BE49-F238E27FC236}">
                <a16:creationId xmlns:a16="http://schemas.microsoft.com/office/drawing/2014/main" id="{F2097A6F-43AA-40BB-B20E-B225DC0625E7}"/>
              </a:ext>
            </a:extLst>
          </p:cNvPr>
          <p:cNvSpPr txBox="1"/>
          <p:nvPr/>
        </p:nvSpPr>
        <p:spPr>
          <a:xfrm>
            <a:off x="6647470" y="2324101"/>
            <a:ext cx="61638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5</a:t>
            </a:r>
          </a:p>
        </p:txBody>
      </p:sp>
      <p:sp>
        <p:nvSpPr>
          <p:cNvPr id="78" name="TextBox 77">
            <a:extLst>
              <a:ext uri="{FF2B5EF4-FFF2-40B4-BE49-F238E27FC236}">
                <a16:creationId xmlns:a16="http://schemas.microsoft.com/office/drawing/2014/main" id="{447876AA-2991-4C82-A13A-048EE46D073F}"/>
              </a:ext>
            </a:extLst>
          </p:cNvPr>
          <p:cNvSpPr txBox="1"/>
          <p:nvPr/>
        </p:nvSpPr>
        <p:spPr>
          <a:xfrm>
            <a:off x="664219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79" name="Rectangle 78">
            <a:extLst>
              <a:ext uri="{FF2B5EF4-FFF2-40B4-BE49-F238E27FC236}">
                <a16:creationId xmlns:a16="http://schemas.microsoft.com/office/drawing/2014/main" id="{1280C149-EE31-4510-941F-CD758B67EBC6}"/>
              </a:ext>
            </a:extLst>
          </p:cNvPr>
          <p:cNvSpPr/>
          <p:nvPr/>
        </p:nvSpPr>
        <p:spPr>
          <a:xfrm>
            <a:off x="8658229" y="2693433"/>
            <a:ext cx="304804"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TextBox 79">
            <a:extLst>
              <a:ext uri="{FF2B5EF4-FFF2-40B4-BE49-F238E27FC236}">
                <a16:creationId xmlns:a16="http://schemas.microsoft.com/office/drawing/2014/main" id="{166392F5-BFC8-43E9-8432-1CE92035C799}"/>
              </a:ext>
            </a:extLst>
          </p:cNvPr>
          <p:cNvSpPr txBox="1"/>
          <p:nvPr/>
        </p:nvSpPr>
        <p:spPr>
          <a:xfrm>
            <a:off x="8701629" y="3132771"/>
            <a:ext cx="221097" cy="923330"/>
          </a:xfrm>
          <a:prstGeom prst="rect">
            <a:avLst/>
          </a:prstGeom>
          <a:noFill/>
        </p:spPr>
        <p:txBody>
          <a:bodyPr wrap="square" rtlCol="0">
            <a:spAutoFit/>
          </a:bodyPr>
          <a:lstStyle/>
          <a:p>
            <a:pPr algn="ctr"/>
            <a:r>
              <a:rPr lang="en-US"/>
              <a:t>GAP</a:t>
            </a:r>
          </a:p>
        </p:txBody>
      </p:sp>
      <p:sp>
        <p:nvSpPr>
          <p:cNvPr id="81" name="&quot;Not Allowed&quot; Symbol 80">
            <a:extLst>
              <a:ext uri="{FF2B5EF4-FFF2-40B4-BE49-F238E27FC236}">
                <a16:creationId xmlns:a16="http://schemas.microsoft.com/office/drawing/2014/main" id="{768D9834-C797-40B0-B5C3-A8A753C2EBA4}"/>
              </a:ext>
            </a:extLst>
          </p:cNvPr>
          <p:cNvSpPr/>
          <p:nvPr/>
        </p:nvSpPr>
        <p:spPr>
          <a:xfrm>
            <a:off x="8627512" y="4029549"/>
            <a:ext cx="369332" cy="369332"/>
          </a:xfrm>
          <a:prstGeom prst="noSmoking">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378636205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Single spike doubt flag: </a:t>
            </a:r>
            <a:r>
              <a:rPr lang="en-US" sz="3600"/>
              <a:t>The doubt flag value for a spike is changed to 1 when it occurs within a burst window from the start/end of recording or a gap. Count the total at end</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7" name="TextBox 36">
            <a:extLst>
              <a:ext uri="{FF2B5EF4-FFF2-40B4-BE49-F238E27FC236}">
                <a16:creationId xmlns:a16="http://schemas.microsoft.com/office/drawing/2014/main" id="{11F4F17E-B198-4662-82B9-FD38C6AFD4A0}"/>
              </a:ext>
            </a:extLst>
          </p:cNvPr>
          <p:cNvSpPr txBox="1"/>
          <p:nvPr/>
        </p:nvSpPr>
        <p:spPr>
          <a:xfrm>
            <a:off x="7146679" y="5034048"/>
            <a:ext cx="4637808" cy="584775"/>
          </a:xfrm>
          <a:prstGeom prst="rect">
            <a:avLst/>
          </a:prstGeom>
          <a:noFill/>
        </p:spPr>
        <p:txBody>
          <a:bodyPr wrap="none" rtlCol="0">
            <a:spAutoFit/>
          </a:bodyPr>
          <a:lstStyle/>
          <a:p>
            <a:pPr algn="ctr"/>
            <a:r>
              <a:rPr lang="en-US" sz="3200" err="1">
                <a:solidFill>
                  <a:srgbClr val="00B050"/>
                </a:solidFill>
              </a:rPr>
              <a:t>ssDoubts</a:t>
            </a:r>
            <a:r>
              <a:rPr lang="en-US" sz="3200">
                <a:solidFill>
                  <a:srgbClr val="00B050"/>
                </a:solidFill>
              </a:rPr>
              <a:t> = [1, 0, 1, 0, 0]</a:t>
            </a:r>
          </a:p>
        </p:txBody>
      </p:sp>
      <mc:AlternateContent xmlns:mc="http://schemas.openxmlformats.org/markup-compatibility/2006">
        <mc:Choice xmlns:a14="http://schemas.microsoft.com/office/drawing/2010/main" Requires="a14">
          <p:sp>
            <p:nvSpPr>
              <p:cNvPr id="46" name="TextBox 45">
                <a:extLst>
                  <a:ext uri="{FF2B5EF4-FFF2-40B4-BE49-F238E27FC236}">
                    <a16:creationId xmlns:a16="http://schemas.microsoft.com/office/drawing/2014/main" id="{B3FCEA8F-D89A-459A-8EE5-ADB9402A18C5}"/>
                  </a:ext>
                </a:extLst>
              </p:cNvPr>
              <p:cNvSpPr txBox="1"/>
              <p:nvPr/>
            </p:nvSpPr>
            <p:spPr>
              <a:xfrm>
                <a:off x="53478" y="5892094"/>
                <a:ext cx="12085103" cy="64633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ssDoubts = </a:t>
                </a:r>
                <a14:m>
                  <m:oMath xmlns:m="http://schemas.openxmlformats.org/officeDocument/2006/math">
                    <m:r>
                      <a:rPr lang="en-US" sz="3600" b="0" i="1" smtClean="0">
                        <a:solidFill>
                          <a:schemeClr val="accent1"/>
                        </a:solidFill>
                        <a:latin typeface="Cambria Math" panose="02040503050406030204" pitchFamily="18" charset="0"/>
                      </a:rPr>
                      <m:t>𝑠𝑢𝑚</m:t>
                    </m:r>
                    <m:d>
                      <m:dPr>
                        <m:ctrlPr>
                          <a:rPr lang="en-US" sz="3600" b="0" i="1" smtClean="0">
                            <a:solidFill>
                              <a:schemeClr val="accent1"/>
                            </a:solidFill>
                            <a:latin typeface="Cambria Math" panose="02040503050406030204" pitchFamily="18" charset="0"/>
                          </a:rPr>
                        </m:ctrlPr>
                      </m:dPr>
                      <m:e>
                        <m:r>
                          <a:rPr lang="en-US" sz="3600" b="0" i="1" smtClean="0">
                            <a:solidFill>
                              <a:schemeClr val="accent1"/>
                            </a:solidFill>
                            <a:latin typeface="Cambria Math" panose="02040503050406030204" pitchFamily="18" charset="0"/>
                          </a:rPr>
                          <m:t>𝑠𝑠𝐷𝑜𝑢𝑏𝑡𝑠</m:t>
                        </m:r>
                      </m:e>
                    </m:d>
                    <m:r>
                      <a:rPr lang="en-US" sz="3600" b="0" i="1" smtClean="0">
                        <a:solidFill>
                          <a:schemeClr val="accent1"/>
                        </a:solidFill>
                        <a:latin typeface="Cambria Math" panose="02040503050406030204" pitchFamily="18" charset="0"/>
                      </a:rPr>
                      <m:t>=</m:t>
                    </m:r>
                    <m:r>
                      <a:rPr lang="en-US" sz="3600" b="0" i="1" smtClean="0">
                        <a:solidFill>
                          <a:schemeClr val="accent1"/>
                        </a:solidFill>
                        <a:latin typeface="Cambria Math" panose="02040503050406030204" pitchFamily="18" charset="0"/>
                      </a:rPr>
                      <m:t>𝑠𝑢𝑚</m:t>
                    </m:r>
                    <m:r>
                      <a:rPr lang="en-US" sz="3600" b="0" i="1" smtClean="0">
                        <a:solidFill>
                          <a:schemeClr val="accent1"/>
                        </a:solidFill>
                        <a:latin typeface="Cambria Math" panose="02040503050406030204" pitchFamily="18" charset="0"/>
                      </a:rPr>
                      <m:t> </m:t>
                    </m:r>
                    <m:d>
                      <m:dPr>
                        <m:ctrlPr>
                          <a:rPr lang="en-US" sz="3600" b="0" i="1" smtClean="0">
                            <a:solidFill>
                              <a:schemeClr val="accent1"/>
                            </a:solidFill>
                            <a:latin typeface="Cambria Math" panose="02040503050406030204" pitchFamily="18" charset="0"/>
                          </a:rPr>
                        </m:ctrlPr>
                      </m:dPr>
                      <m:e>
                        <m:r>
                          <a:rPr lang="en-US" sz="3600" b="0" i="1" smtClean="0">
                            <a:solidFill>
                              <a:schemeClr val="accent1"/>
                            </a:solidFill>
                            <a:latin typeface="Cambria Math" panose="02040503050406030204" pitchFamily="18" charset="0"/>
                          </a:rPr>
                          <m:t>1+0+1+0+0</m:t>
                        </m:r>
                      </m:e>
                    </m:d>
                    <m:r>
                      <a:rPr lang="en-US" sz="3600" b="0" i="1" smtClean="0">
                        <a:solidFill>
                          <a:schemeClr val="accent1"/>
                        </a:solidFill>
                        <a:latin typeface="Cambria Math" panose="02040503050406030204" pitchFamily="18" charset="0"/>
                      </a:rPr>
                      <m:t>=2</m:t>
                    </m:r>
                  </m:oMath>
                </a14:m>
                <a:endParaRPr lang="en-US" sz="3600">
                  <a:solidFill>
                    <a:schemeClr val="accent1"/>
                  </a:solidFill>
                </a:endParaRPr>
              </a:p>
            </p:txBody>
          </p:sp>
        </mc:Choice>
        <mc:Fallback>
          <p:sp>
            <p:nvSpPr>
              <p:cNvPr id="46" name="TextBox 45">
                <a:extLst>
                  <a:ext uri="{FF2B5EF4-FFF2-40B4-BE49-F238E27FC236}">
                    <a16:creationId xmlns:a16="http://schemas.microsoft.com/office/drawing/2014/main" id="{B3FCEA8F-D89A-459A-8EE5-ADB9402A18C5}"/>
                  </a:ext>
                </a:extLst>
              </p:cNvPr>
              <p:cNvSpPr txBox="1">
                <a:spLocks noRot="1" noChangeAspect="1" noMove="1" noResize="1" noEditPoints="1" noAdjustHandles="1" noChangeArrowheads="1" noChangeShapeType="1" noTextEdit="1"/>
              </p:cNvSpPr>
              <p:nvPr/>
            </p:nvSpPr>
            <p:spPr>
              <a:xfrm>
                <a:off x="53478" y="5892094"/>
                <a:ext cx="12085103" cy="646331"/>
              </a:xfrm>
              <a:prstGeom prst="rect">
                <a:avLst/>
              </a:prstGeom>
              <a:blipFill>
                <a:blip r:embed="rId2"/>
                <a:stretch>
                  <a:fillRect l="-1110" t="-15094" b="-34906"/>
                </a:stretch>
              </a:blipFill>
            </p:spPr>
            <p:txBody>
              <a:bodyPr/>
              <a:lstStyle/>
              <a:p>
                <a:r>
                  <a:rPr lang="en-US">
                    <a:noFill/>
                  </a:rPr>
                  <a:t> </a:t>
                </a:r>
              </a:p>
            </p:txBody>
          </p:sp>
        </mc:Fallback>
      </mc:AlternateContent>
      <p:sp>
        <p:nvSpPr>
          <p:cNvPr id="45" name="TextBox 44">
            <a:extLst>
              <a:ext uri="{FF2B5EF4-FFF2-40B4-BE49-F238E27FC236}">
                <a16:creationId xmlns:a16="http://schemas.microsoft.com/office/drawing/2014/main" id="{7FCB340D-76E7-447C-8D26-E4CC509A5A63}"/>
              </a:ext>
            </a:extLst>
          </p:cNvPr>
          <p:cNvSpPr txBox="1"/>
          <p:nvPr/>
        </p:nvSpPr>
        <p:spPr>
          <a:xfrm>
            <a:off x="0" y="4787826"/>
            <a:ext cx="7008211" cy="1077218"/>
          </a:xfrm>
          <a:prstGeom prst="rect">
            <a:avLst/>
          </a:prstGeom>
          <a:noFill/>
        </p:spPr>
        <p:txBody>
          <a:bodyPr wrap="square" rtlCol="0">
            <a:spAutoFit/>
          </a:bodyPr>
          <a:lstStyle/>
          <a:p>
            <a:pPr algn="ctr"/>
            <a:r>
              <a:rPr lang="en-US" sz="3200">
                <a:solidFill>
                  <a:srgbClr val="FF9999"/>
                </a:solidFill>
              </a:rPr>
              <a:t>*single spikes with doubts are still included in other summary variables</a:t>
            </a:r>
          </a:p>
        </p:txBody>
      </p:sp>
      <p:sp>
        <p:nvSpPr>
          <p:cNvPr id="48" name="Rectangle 47">
            <a:extLst>
              <a:ext uri="{FF2B5EF4-FFF2-40B4-BE49-F238E27FC236}">
                <a16:creationId xmlns:a16="http://schemas.microsoft.com/office/drawing/2014/main" id="{5BDDB4A8-E648-450E-B96E-F8D4DD553D1E}"/>
              </a:ext>
            </a:extLst>
          </p:cNvPr>
          <p:cNvSpPr/>
          <p:nvPr/>
        </p:nvSpPr>
        <p:spPr>
          <a:xfrm>
            <a:off x="5288353" y="2693433"/>
            <a:ext cx="1014787"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3" name="Straight Connector 52">
            <a:extLst>
              <a:ext uri="{FF2B5EF4-FFF2-40B4-BE49-F238E27FC236}">
                <a16:creationId xmlns:a16="http://schemas.microsoft.com/office/drawing/2014/main" id="{DA4046F3-1FF5-4AF0-89FB-2C774766A340}"/>
              </a:ext>
            </a:extLst>
          </p:cNvPr>
          <p:cNvCxnSpPr>
            <a:cxnSpLocks/>
          </p:cNvCxnSpPr>
          <p:nvPr/>
        </p:nvCxnSpPr>
        <p:spPr>
          <a:xfrm>
            <a:off x="151703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4E2FA796-806A-4296-8581-DFC3A22ECA86}"/>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498CE6F1-5676-4D21-911C-31707F403203}"/>
              </a:ext>
            </a:extLst>
          </p:cNvPr>
          <p:cNvCxnSpPr>
            <a:cxnSpLocks/>
          </p:cNvCxnSpPr>
          <p:nvPr/>
        </p:nvCxnSpPr>
        <p:spPr>
          <a:xfrm>
            <a:off x="503883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70430FA3-15C3-4ACC-B736-B019C8C1BE3F}"/>
              </a:ext>
            </a:extLst>
          </p:cNvPr>
          <p:cNvCxnSpPr>
            <a:cxnSpLocks/>
          </p:cNvCxnSpPr>
          <p:nvPr/>
        </p:nvCxnSpPr>
        <p:spPr>
          <a:xfrm>
            <a:off x="805750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568B8FAB-BB61-40DA-8202-6E34571A5B57}"/>
              </a:ext>
            </a:extLst>
          </p:cNvPr>
          <p:cNvCxnSpPr>
            <a:cxnSpLocks/>
          </p:cNvCxnSpPr>
          <p:nvPr/>
        </p:nvCxnSpPr>
        <p:spPr>
          <a:xfrm>
            <a:off x="10069960"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9CB26AC9-A803-4139-B999-2F74AEC0D716}"/>
              </a:ext>
            </a:extLst>
          </p:cNvPr>
          <p:cNvSpPr txBox="1"/>
          <p:nvPr/>
        </p:nvSpPr>
        <p:spPr>
          <a:xfrm>
            <a:off x="1360586"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a:t>
            </a:r>
          </a:p>
        </p:txBody>
      </p:sp>
      <p:sp>
        <p:nvSpPr>
          <p:cNvPr id="70" name="TextBox 69">
            <a:extLst>
              <a:ext uri="{FF2B5EF4-FFF2-40B4-BE49-F238E27FC236}">
                <a16:creationId xmlns:a16="http://schemas.microsoft.com/office/drawing/2014/main" id="{B35F54B4-3BF5-4648-BA5F-839B8217BC62}"/>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71" name="TextBox 70">
            <a:extLst>
              <a:ext uri="{FF2B5EF4-FFF2-40B4-BE49-F238E27FC236}">
                <a16:creationId xmlns:a16="http://schemas.microsoft.com/office/drawing/2014/main" id="{089B2115-724F-40EB-9552-97D19D3C03E3}"/>
              </a:ext>
            </a:extLst>
          </p:cNvPr>
          <p:cNvSpPr txBox="1"/>
          <p:nvPr/>
        </p:nvSpPr>
        <p:spPr>
          <a:xfrm>
            <a:off x="4882377"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8</a:t>
            </a:r>
          </a:p>
        </p:txBody>
      </p:sp>
      <p:sp>
        <p:nvSpPr>
          <p:cNvPr id="72" name="TextBox 71">
            <a:extLst>
              <a:ext uri="{FF2B5EF4-FFF2-40B4-BE49-F238E27FC236}">
                <a16:creationId xmlns:a16="http://schemas.microsoft.com/office/drawing/2014/main" id="{CF8821E0-4EEE-465E-8798-BFB4F5C8DC2D}"/>
              </a:ext>
            </a:extLst>
          </p:cNvPr>
          <p:cNvSpPr txBox="1"/>
          <p:nvPr/>
        </p:nvSpPr>
        <p:spPr>
          <a:xfrm>
            <a:off x="7836935"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4</a:t>
            </a:r>
          </a:p>
        </p:txBody>
      </p:sp>
      <p:sp>
        <p:nvSpPr>
          <p:cNvPr id="82" name="TextBox 81">
            <a:extLst>
              <a:ext uri="{FF2B5EF4-FFF2-40B4-BE49-F238E27FC236}">
                <a16:creationId xmlns:a16="http://schemas.microsoft.com/office/drawing/2014/main" id="{71266F89-E78D-4096-930C-0FE7CCFEE445}"/>
              </a:ext>
            </a:extLst>
          </p:cNvPr>
          <p:cNvSpPr txBox="1"/>
          <p:nvPr/>
        </p:nvSpPr>
        <p:spPr>
          <a:xfrm>
            <a:off x="9849387"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8</a:t>
            </a:r>
          </a:p>
        </p:txBody>
      </p:sp>
      <p:sp>
        <p:nvSpPr>
          <p:cNvPr id="83" name="TextBox 82">
            <a:extLst>
              <a:ext uri="{FF2B5EF4-FFF2-40B4-BE49-F238E27FC236}">
                <a16:creationId xmlns:a16="http://schemas.microsoft.com/office/drawing/2014/main" id="{1944A02E-85F4-4174-BA79-16515F18AE10}"/>
              </a:ext>
            </a:extLst>
          </p:cNvPr>
          <p:cNvSpPr txBox="1"/>
          <p:nvPr/>
        </p:nvSpPr>
        <p:spPr>
          <a:xfrm>
            <a:off x="136058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4" name="TextBox 83">
            <a:extLst>
              <a:ext uri="{FF2B5EF4-FFF2-40B4-BE49-F238E27FC236}">
                <a16:creationId xmlns:a16="http://schemas.microsoft.com/office/drawing/2014/main" id="{22D67E9D-5062-4A87-A030-A820008E3850}"/>
              </a:ext>
            </a:extLst>
          </p:cNvPr>
          <p:cNvSpPr txBox="1"/>
          <p:nvPr/>
        </p:nvSpPr>
        <p:spPr>
          <a:xfrm>
            <a:off x="286992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5" name="TextBox 84">
            <a:extLst>
              <a:ext uri="{FF2B5EF4-FFF2-40B4-BE49-F238E27FC236}">
                <a16:creationId xmlns:a16="http://schemas.microsoft.com/office/drawing/2014/main" id="{359C128B-6D73-42B9-933D-679813012B6B}"/>
              </a:ext>
            </a:extLst>
          </p:cNvPr>
          <p:cNvSpPr txBox="1"/>
          <p:nvPr/>
        </p:nvSpPr>
        <p:spPr>
          <a:xfrm>
            <a:off x="488533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6" name="TextBox 85">
            <a:extLst>
              <a:ext uri="{FF2B5EF4-FFF2-40B4-BE49-F238E27FC236}">
                <a16:creationId xmlns:a16="http://schemas.microsoft.com/office/drawing/2014/main" id="{742A3144-C6B4-46BE-93AE-D1A8B320876D}"/>
              </a:ext>
            </a:extLst>
          </p:cNvPr>
          <p:cNvSpPr txBox="1"/>
          <p:nvPr/>
        </p:nvSpPr>
        <p:spPr>
          <a:xfrm>
            <a:off x="7901054"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87" name="TextBox 86">
            <a:extLst>
              <a:ext uri="{FF2B5EF4-FFF2-40B4-BE49-F238E27FC236}">
                <a16:creationId xmlns:a16="http://schemas.microsoft.com/office/drawing/2014/main" id="{AF44DBA4-9024-49AF-8F00-134BE9E470C0}"/>
              </a:ext>
            </a:extLst>
          </p:cNvPr>
          <p:cNvSpPr txBox="1"/>
          <p:nvPr/>
        </p:nvSpPr>
        <p:spPr>
          <a:xfrm>
            <a:off x="9913506"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88" name="TextBox 87">
            <a:extLst>
              <a:ext uri="{FF2B5EF4-FFF2-40B4-BE49-F238E27FC236}">
                <a16:creationId xmlns:a16="http://schemas.microsoft.com/office/drawing/2014/main" id="{3CCD7D92-4DAA-40EA-97F9-DF5BF51CCACC}"/>
              </a:ext>
            </a:extLst>
          </p:cNvPr>
          <p:cNvSpPr txBox="1"/>
          <p:nvPr/>
        </p:nvSpPr>
        <p:spPr>
          <a:xfrm>
            <a:off x="5427696" y="3334430"/>
            <a:ext cx="736099" cy="646331"/>
          </a:xfrm>
          <a:prstGeom prst="rect">
            <a:avLst/>
          </a:prstGeom>
          <a:noFill/>
        </p:spPr>
        <p:txBody>
          <a:bodyPr wrap="none" rtlCol="0">
            <a:spAutoFit/>
          </a:bodyPr>
          <a:lstStyle/>
          <a:p>
            <a:pPr algn="ctr"/>
            <a:r>
              <a:rPr lang="en-US"/>
              <a:t>GAP</a:t>
            </a:r>
          </a:p>
          <a:p>
            <a:pPr algn="ctr"/>
            <a:r>
              <a:rPr lang="en-US"/>
              <a:t>2 sec</a:t>
            </a:r>
          </a:p>
        </p:txBody>
      </p:sp>
      <p:sp>
        <p:nvSpPr>
          <p:cNvPr id="44" name="Arrow: Down 43">
            <a:extLst>
              <a:ext uri="{FF2B5EF4-FFF2-40B4-BE49-F238E27FC236}">
                <a16:creationId xmlns:a16="http://schemas.microsoft.com/office/drawing/2014/main" id="{FF677707-C4CE-4641-8CB6-0D9D16BB2DCA}"/>
              </a:ext>
            </a:extLst>
          </p:cNvPr>
          <p:cNvSpPr/>
          <p:nvPr/>
        </p:nvSpPr>
        <p:spPr>
          <a:xfrm rot="2877750">
            <a:off x="5291149" y="2122086"/>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270" rtlCol="0" anchor="ctr"/>
          <a:lstStyle/>
          <a:p>
            <a:pPr algn="ctr"/>
            <a:r>
              <a:rPr lang="en-US"/>
              <a:t>doubt</a:t>
            </a:r>
          </a:p>
        </p:txBody>
      </p:sp>
      <p:sp>
        <p:nvSpPr>
          <p:cNvPr id="90" name="Arrow: Down 89">
            <a:extLst>
              <a:ext uri="{FF2B5EF4-FFF2-40B4-BE49-F238E27FC236}">
                <a16:creationId xmlns:a16="http://schemas.microsoft.com/office/drawing/2014/main" id="{B6CCA7B9-30AC-4C8A-8D36-B18E51D847FA}"/>
              </a:ext>
            </a:extLst>
          </p:cNvPr>
          <p:cNvSpPr/>
          <p:nvPr/>
        </p:nvSpPr>
        <p:spPr>
          <a:xfrm rot="2877750">
            <a:off x="1683211" y="2122086"/>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270" rtlCol="0" anchor="ctr"/>
          <a:lstStyle/>
          <a:p>
            <a:pPr algn="ctr"/>
            <a:r>
              <a:rPr lang="en-US"/>
              <a:t>doubt</a:t>
            </a:r>
          </a:p>
        </p:txBody>
      </p:sp>
    </p:spTree>
    <p:extLst>
      <p:ext uri="{BB962C8B-B14F-4D97-AF65-F5344CB8AC3E}">
        <p14:creationId xmlns:p14="http://schemas.microsoft.com/office/powerpoint/2010/main" val="5684233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Dataset: </a:t>
            </a:r>
            <a:r>
              <a:rPr lang="en-US" sz="3600"/>
              <a:t>The time at which spikes occur</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5E6CC999-542D-450B-9072-1D8886BE890D}"/>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08F7E712-5429-455C-9EFB-D74CDF210A04}"/>
              </a:ext>
            </a:extLst>
          </p:cNvPr>
          <p:cNvCxnSpPr>
            <a:cxnSpLocks/>
          </p:cNvCxnSpPr>
          <p:nvPr/>
        </p:nvCxnSpPr>
        <p:spPr>
          <a:xfrm>
            <a:off x="5541943"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F9A5C009-1910-496B-A7C1-1822970F0A54}"/>
              </a:ext>
            </a:extLst>
          </p:cNvPr>
          <p:cNvCxnSpPr>
            <a:cxnSpLocks/>
          </p:cNvCxnSpPr>
          <p:nvPr/>
        </p:nvCxnSpPr>
        <p:spPr>
          <a:xfrm>
            <a:off x="6045056"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B66BFC10-08DE-48B5-B23A-6F183F082A13}"/>
              </a:ext>
            </a:extLst>
          </p:cNvPr>
          <p:cNvCxnSpPr>
            <a:cxnSpLocks/>
          </p:cNvCxnSpPr>
          <p:nvPr/>
        </p:nvCxnSpPr>
        <p:spPr>
          <a:xfrm>
            <a:off x="654816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743E1477-59EB-44BF-9DB3-3C6A7A8C082D}"/>
              </a:ext>
            </a:extLst>
          </p:cNvPr>
          <p:cNvCxnSpPr>
            <a:cxnSpLocks/>
          </p:cNvCxnSpPr>
          <p:nvPr/>
        </p:nvCxnSpPr>
        <p:spPr>
          <a:xfrm>
            <a:off x="7051282"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11323809-9FDA-4F29-A82C-AA0FBACD5790}"/>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3" name="TextBox 12">
            <a:extLst>
              <a:ext uri="{FF2B5EF4-FFF2-40B4-BE49-F238E27FC236}">
                <a16:creationId xmlns:a16="http://schemas.microsoft.com/office/drawing/2014/main" id="{063F1761-4EAD-40E2-BD14-2EEF411621C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4" name="TextBox 13">
            <a:extLst>
              <a:ext uri="{FF2B5EF4-FFF2-40B4-BE49-F238E27FC236}">
                <a16:creationId xmlns:a16="http://schemas.microsoft.com/office/drawing/2014/main" id="{A5B98651-E29F-4D49-A6FB-A631BA5B4E18}"/>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5" name="TextBox 14">
            <a:extLst>
              <a:ext uri="{FF2B5EF4-FFF2-40B4-BE49-F238E27FC236}">
                <a16:creationId xmlns:a16="http://schemas.microsoft.com/office/drawing/2014/main" id="{57DBFBDB-A607-41CD-A042-30EBF2F22D7C}"/>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16" name="TextBox 15">
            <a:extLst>
              <a:ext uri="{FF2B5EF4-FFF2-40B4-BE49-F238E27FC236}">
                <a16:creationId xmlns:a16="http://schemas.microsoft.com/office/drawing/2014/main" id="{EAFA46F0-1EAD-492B-B17F-9B66C38F660F}"/>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17" name="TextBox 16">
            <a:extLst>
              <a:ext uri="{FF2B5EF4-FFF2-40B4-BE49-F238E27FC236}">
                <a16:creationId xmlns:a16="http://schemas.microsoft.com/office/drawing/2014/main" id="{7F8CDF7A-FDF6-4DE7-B305-464F6C52B7B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8" name="TextBox 17">
            <a:extLst>
              <a:ext uri="{FF2B5EF4-FFF2-40B4-BE49-F238E27FC236}">
                <a16:creationId xmlns:a16="http://schemas.microsoft.com/office/drawing/2014/main" id="{9F1C46BE-7900-4262-90C3-0471B29061A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0" name="TextBox 19">
            <a:extLst>
              <a:ext uri="{FF2B5EF4-FFF2-40B4-BE49-F238E27FC236}">
                <a16:creationId xmlns:a16="http://schemas.microsoft.com/office/drawing/2014/main" id="{9F438B38-4B5B-42F2-BCB7-6941DD03CAF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21" name="TextBox 20">
            <a:extLst>
              <a:ext uri="{FF2B5EF4-FFF2-40B4-BE49-F238E27FC236}">
                <a16:creationId xmlns:a16="http://schemas.microsoft.com/office/drawing/2014/main" id="{71718F80-5BB8-4AEB-8504-9A2D9A1E5D77}"/>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22" name="TextBox 21">
            <a:extLst>
              <a:ext uri="{FF2B5EF4-FFF2-40B4-BE49-F238E27FC236}">
                <a16:creationId xmlns:a16="http://schemas.microsoft.com/office/drawing/2014/main" id="{586FD3E3-E337-4357-B28A-016395D6231A}"/>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23" name="TextBox 22">
            <a:extLst>
              <a:ext uri="{FF2B5EF4-FFF2-40B4-BE49-F238E27FC236}">
                <a16:creationId xmlns:a16="http://schemas.microsoft.com/office/drawing/2014/main" id="{68CC3645-D8F4-4A75-9408-E695E3B04050}"/>
              </a:ext>
            </a:extLst>
          </p:cNvPr>
          <p:cNvSpPr txBox="1"/>
          <p:nvPr/>
        </p:nvSpPr>
        <p:spPr>
          <a:xfrm>
            <a:off x="639171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24" name="TextBox 23">
            <a:extLst>
              <a:ext uri="{FF2B5EF4-FFF2-40B4-BE49-F238E27FC236}">
                <a16:creationId xmlns:a16="http://schemas.microsoft.com/office/drawing/2014/main" id="{EE8F42A6-71D2-4541-9238-A6F22A7FC8B1}"/>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25" name="TextBox 24">
            <a:extLst>
              <a:ext uri="{FF2B5EF4-FFF2-40B4-BE49-F238E27FC236}">
                <a16:creationId xmlns:a16="http://schemas.microsoft.com/office/drawing/2014/main" id="{F07C037D-791F-459D-B32F-24ECE9031F63}"/>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6" name="TextBox 35">
            <a:extLst>
              <a:ext uri="{FF2B5EF4-FFF2-40B4-BE49-F238E27FC236}">
                <a16:creationId xmlns:a16="http://schemas.microsoft.com/office/drawing/2014/main" id="{BF02E7A9-F5EF-43CA-8B8D-C5D472815F16}"/>
              </a:ext>
            </a:extLst>
          </p:cNvPr>
          <p:cNvSpPr txBox="1"/>
          <p:nvPr/>
        </p:nvSpPr>
        <p:spPr>
          <a:xfrm>
            <a:off x="4125496" y="3214713"/>
            <a:ext cx="301686" cy="369332"/>
          </a:xfrm>
          <a:prstGeom prst="rect">
            <a:avLst/>
          </a:prstGeom>
          <a:noFill/>
        </p:spPr>
        <p:txBody>
          <a:bodyPr wrap="square" rtlCol="0">
            <a:spAutoFit/>
          </a:bodyPr>
          <a:lstStyle/>
          <a:p>
            <a:pPr algn="ctr"/>
            <a:r>
              <a:rPr lang="en-US"/>
              <a:t>5</a:t>
            </a:r>
          </a:p>
        </p:txBody>
      </p:sp>
      <p:cxnSp>
        <p:nvCxnSpPr>
          <p:cNvPr id="37" name="Straight Connector 36">
            <a:extLst>
              <a:ext uri="{FF2B5EF4-FFF2-40B4-BE49-F238E27FC236}">
                <a16:creationId xmlns:a16="http://schemas.microsoft.com/office/drawing/2014/main" id="{F88F0585-0883-4550-B46A-1A419C2238BE}"/>
              </a:ext>
            </a:extLst>
          </p:cNvPr>
          <p:cNvCxnSpPr>
            <a:cxnSpLocks/>
          </p:cNvCxnSpPr>
          <p:nvPr/>
        </p:nvCxnSpPr>
        <p:spPr>
          <a:xfrm>
            <a:off x="3026378" y="3557734"/>
            <a:ext cx="2499923" cy="0"/>
          </a:xfrm>
          <a:prstGeom prst="line">
            <a:avLst/>
          </a:prstGeom>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368D76A5-CAA3-4070-B6C2-875B32207197}"/>
              </a:ext>
            </a:extLst>
          </p:cNvPr>
          <p:cNvSpPr txBox="1"/>
          <p:nvPr/>
        </p:nvSpPr>
        <p:spPr>
          <a:xfrm>
            <a:off x="7906665" y="3214713"/>
            <a:ext cx="301686" cy="369332"/>
          </a:xfrm>
          <a:prstGeom prst="rect">
            <a:avLst/>
          </a:prstGeom>
          <a:noFill/>
        </p:spPr>
        <p:txBody>
          <a:bodyPr wrap="square" rtlCol="0">
            <a:spAutoFit/>
          </a:bodyPr>
          <a:lstStyle/>
          <a:p>
            <a:pPr algn="ctr"/>
            <a:r>
              <a:rPr lang="en-US"/>
              <a:t>4</a:t>
            </a:r>
          </a:p>
        </p:txBody>
      </p:sp>
      <p:cxnSp>
        <p:nvCxnSpPr>
          <p:cNvPr id="39" name="Straight Connector 38">
            <a:extLst>
              <a:ext uri="{FF2B5EF4-FFF2-40B4-BE49-F238E27FC236}">
                <a16:creationId xmlns:a16="http://schemas.microsoft.com/office/drawing/2014/main" id="{E04BD833-3EC8-4C6E-BBE6-EA5808D5B21E}"/>
              </a:ext>
            </a:extLst>
          </p:cNvPr>
          <p:cNvCxnSpPr>
            <a:cxnSpLocks/>
          </p:cNvCxnSpPr>
          <p:nvPr/>
        </p:nvCxnSpPr>
        <p:spPr>
          <a:xfrm>
            <a:off x="7048373" y="3557734"/>
            <a:ext cx="2015361" cy="0"/>
          </a:xfrm>
          <a:prstGeom prst="line">
            <a:avLst/>
          </a:prstGeom>
        </p:spPr>
        <p:style>
          <a:lnRef idx="1">
            <a:schemeClr val="accent1"/>
          </a:lnRef>
          <a:fillRef idx="0">
            <a:schemeClr val="accent1"/>
          </a:fillRef>
          <a:effectRef idx="0">
            <a:schemeClr val="accent1"/>
          </a:effectRef>
          <a:fontRef idx="minor">
            <a:schemeClr val="tx1"/>
          </a:fontRef>
        </p:style>
      </p:cxnSp>
      <p:sp>
        <p:nvSpPr>
          <p:cNvPr id="40" name="TextBox 39">
            <a:extLst>
              <a:ext uri="{FF2B5EF4-FFF2-40B4-BE49-F238E27FC236}">
                <a16:creationId xmlns:a16="http://schemas.microsoft.com/office/drawing/2014/main" id="{0FC3F339-EB43-4A7D-AE11-DDFC200AB678}"/>
              </a:ext>
            </a:extLst>
          </p:cNvPr>
          <p:cNvSpPr txBox="1"/>
          <p:nvPr/>
        </p:nvSpPr>
        <p:spPr>
          <a:xfrm>
            <a:off x="1869309" y="3214713"/>
            <a:ext cx="301686" cy="369332"/>
          </a:xfrm>
          <a:prstGeom prst="rect">
            <a:avLst/>
          </a:prstGeom>
          <a:noFill/>
        </p:spPr>
        <p:txBody>
          <a:bodyPr wrap="square" rtlCol="0">
            <a:spAutoFit/>
          </a:bodyPr>
          <a:lstStyle/>
          <a:p>
            <a:pPr algn="ctr"/>
            <a:r>
              <a:rPr lang="en-US"/>
              <a:t>4</a:t>
            </a:r>
          </a:p>
        </p:txBody>
      </p:sp>
      <p:cxnSp>
        <p:nvCxnSpPr>
          <p:cNvPr id="41" name="Straight Connector 40">
            <a:extLst>
              <a:ext uri="{FF2B5EF4-FFF2-40B4-BE49-F238E27FC236}">
                <a16:creationId xmlns:a16="http://schemas.microsoft.com/office/drawing/2014/main" id="{6D55FB04-5277-49B4-8ADF-CDED89F88B90}"/>
              </a:ext>
            </a:extLst>
          </p:cNvPr>
          <p:cNvCxnSpPr>
            <a:cxnSpLocks/>
          </p:cNvCxnSpPr>
          <p:nvPr/>
        </p:nvCxnSpPr>
        <p:spPr>
          <a:xfrm>
            <a:off x="1011017" y="3557734"/>
            <a:ext cx="2015361" cy="0"/>
          </a:xfrm>
          <a:prstGeom prst="line">
            <a:avLst/>
          </a:prstGeom>
        </p:spPr>
        <p:style>
          <a:lnRef idx="1">
            <a:schemeClr val="accent1"/>
          </a:lnRef>
          <a:fillRef idx="0">
            <a:schemeClr val="accent1"/>
          </a:fillRef>
          <a:effectRef idx="0">
            <a:schemeClr val="accent1"/>
          </a:effectRef>
          <a:fontRef idx="minor">
            <a:schemeClr val="tx1"/>
          </a:fontRef>
        </p:style>
      </p:cxnSp>
      <p:sp>
        <p:nvSpPr>
          <p:cNvPr id="42" name="TextBox 41">
            <a:extLst>
              <a:ext uri="{FF2B5EF4-FFF2-40B4-BE49-F238E27FC236}">
                <a16:creationId xmlns:a16="http://schemas.microsoft.com/office/drawing/2014/main" id="{011BCC47-7C11-477D-A088-66AF1245ED95}"/>
              </a:ext>
            </a:extLst>
          </p:cNvPr>
          <p:cNvSpPr txBox="1"/>
          <p:nvPr/>
        </p:nvSpPr>
        <p:spPr>
          <a:xfrm>
            <a:off x="5645462" y="3214713"/>
            <a:ext cx="301686" cy="369332"/>
          </a:xfrm>
          <a:prstGeom prst="rect">
            <a:avLst/>
          </a:prstGeom>
          <a:noFill/>
        </p:spPr>
        <p:txBody>
          <a:bodyPr wrap="square" rtlCol="0">
            <a:spAutoFit/>
          </a:bodyPr>
          <a:lstStyle/>
          <a:p>
            <a:pPr algn="ctr"/>
            <a:r>
              <a:rPr lang="en-US"/>
              <a:t>1</a:t>
            </a:r>
          </a:p>
        </p:txBody>
      </p:sp>
      <p:cxnSp>
        <p:nvCxnSpPr>
          <p:cNvPr id="43" name="Straight Connector 42">
            <a:extLst>
              <a:ext uri="{FF2B5EF4-FFF2-40B4-BE49-F238E27FC236}">
                <a16:creationId xmlns:a16="http://schemas.microsoft.com/office/drawing/2014/main" id="{4AFE4589-C802-4C9C-8429-111B9A2AD3CF}"/>
              </a:ext>
            </a:extLst>
          </p:cNvPr>
          <p:cNvCxnSpPr>
            <a:cxnSpLocks/>
          </p:cNvCxnSpPr>
          <p:nvPr/>
        </p:nvCxnSpPr>
        <p:spPr>
          <a:xfrm>
            <a:off x="5544644" y="3557734"/>
            <a:ext cx="503322" cy="0"/>
          </a:xfrm>
          <a:prstGeom prst="line">
            <a:avLst/>
          </a:prstGeom>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3BE02717-75A8-467A-971C-F80368F4E2B1}"/>
              </a:ext>
            </a:extLst>
          </p:cNvPr>
          <p:cNvSpPr txBox="1"/>
          <p:nvPr/>
        </p:nvSpPr>
        <p:spPr>
          <a:xfrm>
            <a:off x="6148091" y="3214713"/>
            <a:ext cx="301686" cy="369332"/>
          </a:xfrm>
          <a:prstGeom prst="rect">
            <a:avLst/>
          </a:prstGeom>
          <a:noFill/>
        </p:spPr>
        <p:txBody>
          <a:bodyPr wrap="square" rtlCol="0">
            <a:spAutoFit/>
          </a:bodyPr>
          <a:lstStyle/>
          <a:p>
            <a:pPr algn="ctr"/>
            <a:r>
              <a:rPr lang="en-US"/>
              <a:t>1</a:t>
            </a:r>
          </a:p>
        </p:txBody>
      </p:sp>
      <p:cxnSp>
        <p:nvCxnSpPr>
          <p:cNvPr id="46" name="Straight Connector 45">
            <a:extLst>
              <a:ext uri="{FF2B5EF4-FFF2-40B4-BE49-F238E27FC236}">
                <a16:creationId xmlns:a16="http://schemas.microsoft.com/office/drawing/2014/main" id="{30FD6F98-E783-4192-95D6-23276F500B4C}"/>
              </a:ext>
            </a:extLst>
          </p:cNvPr>
          <p:cNvCxnSpPr>
            <a:cxnSpLocks/>
          </p:cNvCxnSpPr>
          <p:nvPr/>
        </p:nvCxnSpPr>
        <p:spPr>
          <a:xfrm>
            <a:off x="6047273" y="3557734"/>
            <a:ext cx="503322" cy="0"/>
          </a:xfrm>
          <a:prstGeom prst="line">
            <a:avLst/>
          </a:prstGeom>
        </p:spPr>
        <p:style>
          <a:lnRef idx="1">
            <a:schemeClr val="accent1"/>
          </a:lnRef>
          <a:fillRef idx="0">
            <a:schemeClr val="accent1"/>
          </a:fillRef>
          <a:effectRef idx="0">
            <a:schemeClr val="accent1"/>
          </a:effectRef>
          <a:fontRef idx="minor">
            <a:schemeClr val="tx1"/>
          </a:fontRef>
        </p:style>
      </p:cxnSp>
      <p:sp>
        <p:nvSpPr>
          <p:cNvPr id="47" name="TextBox 46">
            <a:extLst>
              <a:ext uri="{FF2B5EF4-FFF2-40B4-BE49-F238E27FC236}">
                <a16:creationId xmlns:a16="http://schemas.microsoft.com/office/drawing/2014/main" id="{E3DEFAEF-72D9-467E-AEF9-8F7D76A261D0}"/>
              </a:ext>
            </a:extLst>
          </p:cNvPr>
          <p:cNvSpPr txBox="1"/>
          <p:nvPr/>
        </p:nvSpPr>
        <p:spPr>
          <a:xfrm>
            <a:off x="6651203" y="3214713"/>
            <a:ext cx="301686" cy="369332"/>
          </a:xfrm>
          <a:prstGeom prst="rect">
            <a:avLst/>
          </a:prstGeom>
          <a:noFill/>
        </p:spPr>
        <p:txBody>
          <a:bodyPr wrap="square" rtlCol="0">
            <a:spAutoFit/>
          </a:bodyPr>
          <a:lstStyle/>
          <a:p>
            <a:pPr algn="ctr"/>
            <a:r>
              <a:rPr lang="en-US"/>
              <a:t>1</a:t>
            </a:r>
          </a:p>
        </p:txBody>
      </p:sp>
      <p:cxnSp>
        <p:nvCxnSpPr>
          <p:cNvPr id="48" name="Straight Connector 47">
            <a:extLst>
              <a:ext uri="{FF2B5EF4-FFF2-40B4-BE49-F238E27FC236}">
                <a16:creationId xmlns:a16="http://schemas.microsoft.com/office/drawing/2014/main" id="{8AEF4F75-BC9D-48AC-9DAC-C63AC7E1450B}"/>
              </a:ext>
            </a:extLst>
          </p:cNvPr>
          <p:cNvCxnSpPr>
            <a:cxnSpLocks/>
          </p:cNvCxnSpPr>
          <p:nvPr/>
        </p:nvCxnSpPr>
        <p:spPr>
          <a:xfrm>
            <a:off x="6550385" y="3557734"/>
            <a:ext cx="503322" cy="0"/>
          </a:xfrm>
          <a:prstGeom prst="line">
            <a:avLst/>
          </a:prstGeom>
        </p:spPr>
        <p:style>
          <a:lnRef idx="1">
            <a:schemeClr val="accent1"/>
          </a:lnRef>
          <a:fillRef idx="0">
            <a:schemeClr val="accent1"/>
          </a:fillRef>
          <a:effectRef idx="0">
            <a:schemeClr val="accent1"/>
          </a:effectRef>
          <a:fontRef idx="minor">
            <a:schemeClr val="tx1"/>
          </a:fontRef>
        </p:style>
      </p:cxnSp>
      <p:sp>
        <p:nvSpPr>
          <p:cNvPr id="49" name="TextBox 48">
            <a:extLst>
              <a:ext uri="{FF2B5EF4-FFF2-40B4-BE49-F238E27FC236}">
                <a16:creationId xmlns:a16="http://schemas.microsoft.com/office/drawing/2014/main" id="{19AFFEFF-5E7C-45FD-AFFA-D5744EDE5B92}"/>
              </a:ext>
            </a:extLst>
          </p:cNvPr>
          <p:cNvSpPr txBox="1"/>
          <p:nvPr/>
        </p:nvSpPr>
        <p:spPr>
          <a:xfrm>
            <a:off x="2987342" y="5486060"/>
            <a:ext cx="6428363" cy="584775"/>
          </a:xfrm>
          <a:prstGeom prst="rect">
            <a:avLst/>
          </a:prstGeom>
          <a:noFill/>
        </p:spPr>
        <p:txBody>
          <a:bodyPr wrap="none" rtlCol="0">
            <a:spAutoFit/>
          </a:bodyPr>
          <a:lstStyle/>
          <a:p>
            <a:pPr algn="ctr"/>
            <a:r>
              <a:rPr lang="en-US" sz="3200">
                <a:solidFill>
                  <a:srgbClr val="00B050"/>
                </a:solidFill>
              </a:rPr>
              <a:t>Dataset = [4, 9, 10, 11, 12, 16] sec</a:t>
            </a:r>
          </a:p>
        </p:txBody>
      </p:sp>
    </p:spTree>
    <p:extLst>
      <p:ext uri="{BB962C8B-B14F-4D97-AF65-F5344CB8AC3E}">
        <p14:creationId xmlns:p14="http://schemas.microsoft.com/office/powerpoint/2010/main" val="190111337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Burst doubt flag: </a:t>
            </a:r>
            <a:r>
              <a:rPr lang="en-US" sz="3600"/>
              <a:t>The doubt flag value for a burst is changed to 1 when a burst occurs within a burst window from the start/end of recording, a gap, or when it contains a gap. Count the total at end</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7" name="TextBox 36">
            <a:extLst>
              <a:ext uri="{FF2B5EF4-FFF2-40B4-BE49-F238E27FC236}">
                <a16:creationId xmlns:a16="http://schemas.microsoft.com/office/drawing/2014/main" id="{11F4F17E-B198-4662-82B9-FD38C6AFD4A0}"/>
              </a:ext>
            </a:extLst>
          </p:cNvPr>
          <p:cNvSpPr txBox="1"/>
          <p:nvPr/>
        </p:nvSpPr>
        <p:spPr>
          <a:xfrm>
            <a:off x="7351859" y="5034048"/>
            <a:ext cx="4227440" cy="584775"/>
          </a:xfrm>
          <a:prstGeom prst="rect">
            <a:avLst/>
          </a:prstGeom>
          <a:noFill/>
        </p:spPr>
        <p:txBody>
          <a:bodyPr wrap="none" rtlCol="0">
            <a:spAutoFit/>
          </a:bodyPr>
          <a:lstStyle/>
          <a:p>
            <a:pPr algn="ctr"/>
            <a:r>
              <a:rPr lang="en-US" sz="3200" err="1">
                <a:solidFill>
                  <a:srgbClr val="00B050"/>
                </a:solidFill>
              </a:rPr>
              <a:t>burstDoubts</a:t>
            </a:r>
            <a:r>
              <a:rPr lang="en-US" sz="3200">
                <a:solidFill>
                  <a:srgbClr val="00B050"/>
                </a:solidFill>
              </a:rPr>
              <a:t> = [0, 1, 1]</a:t>
            </a:r>
          </a:p>
        </p:txBody>
      </p:sp>
      <mc:AlternateContent xmlns:mc="http://schemas.openxmlformats.org/markup-compatibility/2006">
        <mc:Choice xmlns:a14="http://schemas.microsoft.com/office/drawing/2010/main" Requires="a14">
          <p:sp>
            <p:nvSpPr>
              <p:cNvPr id="46" name="TextBox 45">
                <a:extLst>
                  <a:ext uri="{FF2B5EF4-FFF2-40B4-BE49-F238E27FC236}">
                    <a16:creationId xmlns:a16="http://schemas.microsoft.com/office/drawing/2014/main" id="{B3FCEA8F-D89A-459A-8EE5-ADB9402A18C5}"/>
                  </a:ext>
                </a:extLst>
              </p:cNvPr>
              <p:cNvSpPr txBox="1"/>
              <p:nvPr/>
            </p:nvSpPr>
            <p:spPr>
              <a:xfrm>
                <a:off x="609717" y="5892094"/>
                <a:ext cx="10972620" cy="646331"/>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bDoubts = </a:t>
                </a:r>
                <a14:m>
                  <m:oMath xmlns:m="http://schemas.openxmlformats.org/officeDocument/2006/math">
                    <m:r>
                      <a:rPr lang="en-US" sz="3600" b="0" i="1" smtClean="0">
                        <a:solidFill>
                          <a:schemeClr val="accent1"/>
                        </a:solidFill>
                        <a:latin typeface="Cambria Math" panose="02040503050406030204" pitchFamily="18" charset="0"/>
                      </a:rPr>
                      <m:t>𝑠𝑢𝑚</m:t>
                    </m:r>
                    <m:d>
                      <m:dPr>
                        <m:ctrlPr>
                          <a:rPr lang="en-US" sz="3600" b="0" i="1" smtClean="0">
                            <a:solidFill>
                              <a:schemeClr val="accent1"/>
                            </a:solidFill>
                            <a:latin typeface="Cambria Math" panose="02040503050406030204" pitchFamily="18" charset="0"/>
                          </a:rPr>
                        </m:ctrlPr>
                      </m:dPr>
                      <m:e>
                        <m:r>
                          <a:rPr lang="en-US" sz="3600" b="0" i="1" smtClean="0">
                            <a:solidFill>
                              <a:schemeClr val="accent1"/>
                            </a:solidFill>
                            <a:latin typeface="Cambria Math" panose="02040503050406030204" pitchFamily="18" charset="0"/>
                          </a:rPr>
                          <m:t>𝑏𝑢𝑟𝑠𝑡𝐷𝑜𝑢𝑏𝑡𝑠</m:t>
                        </m:r>
                      </m:e>
                    </m:d>
                    <m:r>
                      <a:rPr lang="en-US" sz="3600" b="0" i="1" smtClean="0">
                        <a:solidFill>
                          <a:schemeClr val="accent1"/>
                        </a:solidFill>
                        <a:latin typeface="Cambria Math" panose="02040503050406030204" pitchFamily="18" charset="0"/>
                      </a:rPr>
                      <m:t>=</m:t>
                    </m:r>
                    <m:r>
                      <a:rPr lang="en-US" sz="3600" b="0" i="1" smtClean="0">
                        <a:solidFill>
                          <a:schemeClr val="accent1"/>
                        </a:solidFill>
                        <a:latin typeface="Cambria Math" panose="02040503050406030204" pitchFamily="18" charset="0"/>
                      </a:rPr>
                      <m:t>𝑠𝑢𝑚</m:t>
                    </m:r>
                    <m:r>
                      <a:rPr lang="en-US" sz="3600" b="0" i="1" smtClean="0">
                        <a:solidFill>
                          <a:schemeClr val="accent1"/>
                        </a:solidFill>
                        <a:latin typeface="Cambria Math" panose="02040503050406030204" pitchFamily="18" charset="0"/>
                      </a:rPr>
                      <m:t> </m:t>
                    </m:r>
                    <m:d>
                      <m:dPr>
                        <m:ctrlPr>
                          <a:rPr lang="en-US" sz="3600" b="0" i="1" smtClean="0">
                            <a:solidFill>
                              <a:schemeClr val="accent1"/>
                            </a:solidFill>
                            <a:latin typeface="Cambria Math" panose="02040503050406030204" pitchFamily="18" charset="0"/>
                          </a:rPr>
                        </m:ctrlPr>
                      </m:dPr>
                      <m:e>
                        <m:r>
                          <a:rPr lang="en-US" sz="3600" b="0" i="1" smtClean="0">
                            <a:solidFill>
                              <a:schemeClr val="accent1"/>
                            </a:solidFill>
                            <a:latin typeface="Cambria Math" panose="02040503050406030204" pitchFamily="18" charset="0"/>
                          </a:rPr>
                          <m:t>0+1+1</m:t>
                        </m:r>
                      </m:e>
                    </m:d>
                    <m:r>
                      <a:rPr lang="en-US" sz="3600" b="0" i="1" smtClean="0">
                        <a:solidFill>
                          <a:schemeClr val="accent1"/>
                        </a:solidFill>
                        <a:latin typeface="Cambria Math" panose="02040503050406030204" pitchFamily="18" charset="0"/>
                      </a:rPr>
                      <m:t>=2</m:t>
                    </m:r>
                  </m:oMath>
                </a14:m>
                <a:endParaRPr lang="en-US" sz="3600">
                  <a:solidFill>
                    <a:schemeClr val="accent1"/>
                  </a:solidFill>
                </a:endParaRPr>
              </a:p>
            </p:txBody>
          </p:sp>
        </mc:Choice>
        <mc:Fallback>
          <p:sp>
            <p:nvSpPr>
              <p:cNvPr id="46" name="TextBox 45">
                <a:extLst>
                  <a:ext uri="{FF2B5EF4-FFF2-40B4-BE49-F238E27FC236}">
                    <a16:creationId xmlns:a16="http://schemas.microsoft.com/office/drawing/2014/main" id="{B3FCEA8F-D89A-459A-8EE5-ADB9402A18C5}"/>
                  </a:ext>
                </a:extLst>
              </p:cNvPr>
              <p:cNvSpPr txBox="1">
                <a:spLocks noRot="1" noChangeAspect="1" noMove="1" noResize="1" noEditPoints="1" noAdjustHandles="1" noChangeArrowheads="1" noChangeShapeType="1" noTextEdit="1"/>
              </p:cNvSpPr>
              <p:nvPr/>
            </p:nvSpPr>
            <p:spPr>
              <a:xfrm>
                <a:off x="609717" y="5892094"/>
                <a:ext cx="10972620" cy="646331"/>
              </a:xfrm>
              <a:prstGeom prst="rect">
                <a:avLst/>
              </a:prstGeom>
              <a:blipFill>
                <a:blip r:embed="rId2"/>
                <a:stretch>
                  <a:fillRect l="-1222" t="-15094" b="-34906"/>
                </a:stretch>
              </a:blipFill>
            </p:spPr>
            <p:txBody>
              <a:bodyPr/>
              <a:lstStyle/>
              <a:p>
                <a:r>
                  <a:rPr lang="en-US">
                    <a:noFill/>
                  </a:rPr>
                  <a:t> </a:t>
                </a:r>
              </a:p>
            </p:txBody>
          </p:sp>
        </mc:Fallback>
      </mc:AlternateContent>
      <p:cxnSp>
        <p:nvCxnSpPr>
          <p:cNvPr id="38" name="Straight Connector 37">
            <a:extLst>
              <a:ext uri="{FF2B5EF4-FFF2-40B4-BE49-F238E27FC236}">
                <a16:creationId xmlns:a16="http://schemas.microsoft.com/office/drawing/2014/main" id="{679A1E74-D06F-421B-A2DF-AF555FE4108A}"/>
              </a:ext>
            </a:extLst>
          </p:cNvPr>
          <p:cNvCxnSpPr>
            <a:cxnSpLocks/>
          </p:cNvCxnSpPr>
          <p:nvPr/>
        </p:nvCxnSpPr>
        <p:spPr>
          <a:xfrm>
            <a:off x="3026378"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1CEED8F7-68A8-4964-8C07-3A90094E793E}"/>
              </a:ext>
            </a:extLst>
          </p:cNvPr>
          <p:cNvCxnSpPr>
            <a:cxnSpLocks/>
          </p:cNvCxnSpPr>
          <p:nvPr/>
        </p:nvCxnSpPr>
        <p:spPr>
          <a:xfrm>
            <a:off x="403260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C247D9B3-60F4-49FC-91F7-BB43C135E37B}"/>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5335414E-2F04-4013-AF6D-EF915881D0A5}"/>
              </a:ext>
            </a:extLst>
          </p:cNvPr>
          <p:cNvCxnSpPr>
            <a:cxnSpLocks/>
          </p:cNvCxnSpPr>
          <p:nvPr/>
        </p:nvCxnSpPr>
        <p:spPr>
          <a:xfrm>
            <a:off x="856062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6CABE885-F2EE-4C73-ADB7-F08500CC216A}"/>
              </a:ext>
            </a:extLst>
          </p:cNvPr>
          <p:cNvCxnSpPr>
            <a:cxnSpLocks/>
          </p:cNvCxnSpPr>
          <p:nvPr/>
        </p:nvCxnSpPr>
        <p:spPr>
          <a:xfrm>
            <a:off x="906373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B1738F0B-4B49-43CA-A172-DBE1B5809737}"/>
              </a:ext>
            </a:extLst>
          </p:cNvPr>
          <p:cNvCxnSpPr>
            <a:cxnSpLocks/>
          </p:cNvCxnSpPr>
          <p:nvPr/>
        </p:nvCxnSpPr>
        <p:spPr>
          <a:xfrm>
            <a:off x="9566847"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52" name="TextBox 51">
            <a:extLst>
              <a:ext uri="{FF2B5EF4-FFF2-40B4-BE49-F238E27FC236}">
                <a16:creationId xmlns:a16="http://schemas.microsoft.com/office/drawing/2014/main" id="{FAD7A4B2-A1E3-415D-A665-453154FAB86C}"/>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54" name="TextBox 53">
            <a:extLst>
              <a:ext uri="{FF2B5EF4-FFF2-40B4-BE49-F238E27FC236}">
                <a16:creationId xmlns:a16="http://schemas.microsoft.com/office/drawing/2014/main" id="{7381E3C5-ED8A-4469-BED7-2F5B2886C88D}"/>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55" name="TextBox 54">
            <a:extLst>
              <a:ext uri="{FF2B5EF4-FFF2-40B4-BE49-F238E27FC236}">
                <a16:creationId xmlns:a16="http://schemas.microsoft.com/office/drawing/2014/main" id="{9B8ED585-3C99-48EE-B49C-05996436BA14}"/>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57" name="TextBox 56">
            <a:extLst>
              <a:ext uri="{FF2B5EF4-FFF2-40B4-BE49-F238E27FC236}">
                <a16:creationId xmlns:a16="http://schemas.microsoft.com/office/drawing/2014/main" id="{4D469F44-E72E-45EA-91AC-AC07FD3DE9F3}"/>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58" name="TextBox 57">
            <a:extLst>
              <a:ext uri="{FF2B5EF4-FFF2-40B4-BE49-F238E27FC236}">
                <a16:creationId xmlns:a16="http://schemas.microsoft.com/office/drawing/2014/main" id="{4F2BDE49-EE55-4350-8BF0-F9CE734E60EB}"/>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59" name="TextBox 58">
            <a:extLst>
              <a:ext uri="{FF2B5EF4-FFF2-40B4-BE49-F238E27FC236}">
                <a16:creationId xmlns:a16="http://schemas.microsoft.com/office/drawing/2014/main" id="{75D68392-A52D-4E97-9277-3D76539B1091}"/>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60" name="TextBox 59">
            <a:extLst>
              <a:ext uri="{FF2B5EF4-FFF2-40B4-BE49-F238E27FC236}">
                <a16:creationId xmlns:a16="http://schemas.microsoft.com/office/drawing/2014/main" id="{802B3785-D750-479B-B35D-E8BDF822272B}"/>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62" name="TextBox 61">
            <a:extLst>
              <a:ext uri="{FF2B5EF4-FFF2-40B4-BE49-F238E27FC236}">
                <a16:creationId xmlns:a16="http://schemas.microsoft.com/office/drawing/2014/main" id="{C4B33B01-2ECE-46FF-ADF3-90FB961B320D}"/>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63" name="TextBox 62">
            <a:extLst>
              <a:ext uri="{FF2B5EF4-FFF2-40B4-BE49-F238E27FC236}">
                <a16:creationId xmlns:a16="http://schemas.microsoft.com/office/drawing/2014/main" id="{9E01BDAD-702C-4C2F-88A7-3F34BD58A52B}"/>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65" name="TextBox 64">
            <a:extLst>
              <a:ext uri="{FF2B5EF4-FFF2-40B4-BE49-F238E27FC236}">
                <a16:creationId xmlns:a16="http://schemas.microsoft.com/office/drawing/2014/main" id="{A457C328-3FC8-4F8A-9772-3211116F0778}"/>
              </a:ext>
            </a:extLst>
          </p:cNvPr>
          <p:cNvSpPr txBox="1"/>
          <p:nvPr/>
        </p:nvSpPr>
        <p:spPr>
          <a:xfrm>
            <a:off x="8404168"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66" name="TextBox 65">
            <a:extLst>
              <a:ext uri="{FF2B5EF4-FFF2-40B4-BE49-F238E27FC236}">
                <a16:creationId xmlns:a16="http://schemas.microsoft.com/office/drawing/2014/main" id="{DAFF608D-E1CA-41C9-B58D-5F736CFE46FE}"/>
              </a:ext>
            </a:extLst>
          </p:cNvPr>
          <p:cNvSpPr txBox="1"/>
          <p:nvPr/>
        </p:nvSpPr>
        <p:spPr>
          <a:xfrm>
            <a:off x="8907281"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6E00364D-EB2F-4B86-B713-DE620F3D9B6E}"/>
              </a:ext>
            </a:extLst>
          </p:cNvPr>
          <p:cNvSpPr txBox="1"/>
          <p:nvPr/>
        </p:nvSpPr>
        <p:spPr>
          <a:xfrm>
            <a:off x="9410394"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cxnSp>
        <p:nvCxnSpPr>
          <p:cNvPr id="73" name="Straight Connector 72">
            <a:extLst>
              <a:ext uri="{FF2B5EF4-FFF2-40B4-BE49-F238E27FC236}">
                <a16:creationId xmlns:a16="http://schemas.microsoft.com/office/drawing/2014/main" id="{4FB2743C-BA85-45B8-8E7D-CAD53164FA1B}"/>
              </a:ext>
            </a:extLst>
          </p:cNvPr>
          <p:cNvCxnSpPr>
            <a:cxnSpLocks/>
          </p:cNvCxnSpPr>
          <p:nvPr/>
        </p:nvCxnSpPr>
        <p:spPr>
          <a:xfrm>
            <a:off x="378195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74" name="TextBox 73">
            <a:extLst>
              <a:ext uri="{FF2B5EF4-FFF2-40B4-BE49-F238E27FC236}">
                <a16:creationId xmlns:a16="http://schemas.microsoft.com/office/drawing/2014/main" id="{DD2A9F8B-7937-4D05-936D-132C6E47FA03}"/>
              </a:ext>
            </a:extLst>
          </p:cNvPr>
          <p:cNvSpPr txBox="1"/>
          <p:nvPr/>
        </p:nvSpPr>
        <p:spPr>
          <a:xfrm>
            <a:off x="3529319" y="2324101"/>
            <a:ext cx="505268"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5</a:t>
            </a:r>
          </a:p>
        </p:txBody>
      </p:sp>
      <p:sp>
        <p:nvSpPr>
          <p:cNvPr id="75" name="TextBox 74">
            <a:extLst>
              <a:ext uri="{FF2B5EF4-FFF2-40B4-BE49-F238E27FC236}">
                <a16:creationId xmlns:a16="http://schemas.microsoft.com/office/drawing/2014/main" id="{73393428-69D2-43D2-9DF6-FC52BC91236B}"/>
              </a:ext>
            </a:extLst>
          </p:cNvPr>
          <p:cNvSpPr txBox="1"/>
          <p:nvPr/>
        </p:nvSpPr>
        <p:spPr>
          <a:xfrm>
            <a:off x="3625499"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cxnSp>
        <p:nvCxnSpPr>
          <p:cNvPr id="76" name="Straight Connector 75">
            <a:extLst>
              <a:ext uri="{FF2B5EF4-FFF2-40B4-BE49-F238E27FC236}">
                <a16:creationId xmlns:a16="http://schemas.microsoft.com/office/drawing/2014/main" id="{506F30E3-7638-4C2B-9E3A-1A4209EE9562}"/>
              </a:ext>
            </a:extLst>
          </p:cNvPr>
          <p:cNvCxnSpPr>
            <a:cxnSpLocks/>
          </p:cNvCxnSpPr>
          <p:nvPr/>
        </p:nvCxnSpPr>
        <p:spPr>
          <a:xfrm>
            <a:off x="679864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77" name="TextBox 76">
            <a:extLst>
              <a:ext uri="{FF2B5EF4-FFF2-40B4-BE49-F238E27FC236}">
                <a16:creationId xmlns:a16="http://schemas.microsoft.com/office/drawing/2014/main" id="{F2097A6F-43AA-40BB-B20E-B225DC0625E7}"/>
              </a:ext>
            </a:extLst>
          </p:cNvPr>
          <p:cNvSpPr txBox="1"/>
          <p:nvPr/>
        </p:nvSpPr>
        <p:spPr>
          <a:xfrm>
            <a:off x="6647470" y="2324101"/>
            <a:ext cx="61638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5</a:t>
            </a:r>
          </a:p>
        </p:txBody>
      </p:sp>
      <p:sp>
        <p:nvSpPr>
          <p:cNvPr id="78" name="TextBox 77">
            <a:extLst>
              <a:ext uri="{FF2B5EF4-FFF2-40B4-BE49-F238E27FC236}">
                <a16:creationId xmlns:a16="http://schemas.microsoft.com/office/drawing/2014/main" id="{447876AA-2991-4C82-A13A-048EE46D073F}"/>
              </a:ext>
            </a:extLst>
          </p:cNvPr>
          <p:cNvSpPr txBox="1"/>
          <p:nvPr/>
        </p:nvSpPr>
        <p:spPr>
          <a:xfrm>
            <a:off x="664219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79" name="Rectangle 78">
            <a:extLst>
              <a:ext uri="{FF2B5EF4-FFF2-40B4-BE49-F238E27FC236}">
                <a16:creationId xmlns:a16="http://schemas.microsoft.com/office/drawing/2014/main" id="{1280C149-EE31-4510-941F-CD758B67EBC6}"/>
              </a:ext>
            </a:extLst>
          </p:cNvPr>
          <p:cNvSpPr/>
          <p:nvPr/>
        </p:nvSpPr>
        <p:spPr>
          <a:xfrm>
            <a:off x="8658229" y="2693433"/>
            <a:ext cx="304804"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TextBox 79">
            <a:extLst>
              <a:ext uri="{FF2B5EF4-FFF2-40B4-BE49-F238E27FC236}">
                <a16:creationId xmlns:a16="http://schemas.microsoft.com/office/drawing/2014/main" id="{166392F5-BFC8-43E9-8432-1CE92035C799}"/>
              </a:ext>
            </a:extLst>
          </p:cNvPr>
          <p:cNvSpPr txBox="1"/>
          <p:nvPr/>
        </p:nvSpPr>
        <p:spPr>
          <a:xfrm>
            <a:off x="8701629" y="3132771"/>
            <a:ext cx="221097" cy="923330"/>
          </a:xfrm>
          <a:prstGeom prst="rect">
            <a:avLst/>
          </a:prstGeom>
          <a:noFill/>
        </p:spPr>
        <p:txBody>
          <a:bodyPr wrap="square" rtlCol="0">
            <a:spAutoFit/>
          </a:bodyPr>
          <a:lstStyle/>
          <a:p>
            <a:pPr algn="ctr"/>
            <a:r>
              <a:rPr lang="en-US"/>
              <a:t>GAP</a:t>
            </a:r>
          </a:p>
        </p:txBody>
      </p:sp>
      <p:sp>
        <p:nvSpPr>
          <p:cNvPr id="39" name="Rectangle 38">
            <a:extLst>
              <a:ext uri="{FF2B5EF4-FFF2-40B4-BE49-F238E27FC236}">
                <a16:creationId xmlns:a16="http://schemas.microsoft.com/office/drawing/2014/main" id="{C4DA35AA-78AE-47E4-8AD1-4398A0069D5E}"/>
              </a:ext>
            </a:extLst>
          </p:cNvPr>
          <p:cNvSpPr/>
          <p:nvPr/>
        </p:nvSpPr>
        <p:spPr>
          <a:xfrm>
            <a:off x="5914415" y="2693433"/>
            <a:ext cx="477318" cy="1928326"/>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1" name="Straight Connector 40">
            <a:extLst>
              <a:ext uri="{FF2B5EF4-FFF2-40B4-BE49-F238E27FC236}">
                <a16:creationId xmlns:a16="http://schemas.microsoft.com/office/drawing/2014/main" id="{E739EEF8-DBD4-4E97-BE73-0792D78350B2}"/>
              </a:ext>
            </a:extLst>
          </p:cNvPr>
          <p:cNvCxnSpPr>
            <a:cxnSpLocks/>
          </p:cNvCxnSpPr>
          <p:nvPr/>
        </p:nvCxnSpPr>
        <p:spPr>
          <a:xfrm>
            <a:off x="6153074" y="2693433"/>
            <a:ext cx="0" cy="1928326"/>
          </a:xfrm>
          <a:prstGeom prst="line">
            <a:avLst/>
          </a:prstGeom>
          <a:ln w="19050">
            <a:solidFill>
              <a:schemeClr val="bg2"/>
            </a:solidFill>
          </a:ln>
        </p:spPr>
        <p:style>
          <a:lnRef idx="1">
            <a:schemeClr val="accent1"/>
          </a:lnRef>
          <a:fillRef idx="0">
            <a:schemeClr val="accent1"/>
          </a:fillRef>
          <a:effectRef idx="0">
            <a:schemeClr val="accent1"/>
          </a:effectRef>
          <a:fontRef idx="minor">
            <a:schemeClr val="tx1"/>
          </a:fontRef>
        </p:style>
      </p:cxnSp>
      <p:sp>
        <p:nvSpPr>
          <p:cNvPr id="40" name="TextBox 39">
            <a:extLst>
              <a:ext uri="{FF2B5EF4-FFF2-40B4-BE49-F238E27FC236}">
                <a16:creationId xmlns:a16="http://schemas.microsoft.com/office/drawing/2014/main" id="{494346B1-47CD-47D4-8366-709308B2A4F8}"/>
              </a:ext>
            </a:extLst>
          </p:cNvPr>
          <p:cNvSpPr txBox="1"/>
          <p:nvPr/>
        </p:nvSpPr>
        <p:spPr>
          <a:xfrm>
            <a:off x="5825022" y="3472930"/>
            <a:ext cx="668254" cy="369332"/>
          </a:xfrm>
          <a:prstGeom prst="rect">
            <a:avLst/>
          </a:prstGeom>
          <a:noFill/>
        </p:spPr>
        <p:txBody>
          <a:bodyPr wrap="square" rtlCol="0">
            <a:spAutoFit/>
          </a:bodyPr>
          <a:lstStyle/>
          <a:p>
            <a:pPr algn="ctr"/>
            <a:r>
              <a:rPr lang="en-US"/>
              <a:t>GAP</a:t>
            </a:r>
          </a:p>
        </p:txBody>
      </p:sp>
      <p:sp>
        <p:nvSpPr>
          <p:cNvPr id="43" name="Arrow: Down 42">
            <a:extLst>
              <a:ext uri="{FF2B5EF4-FFF2-40B4-BE49-F238E27FC236}">
                <a16:creationId xmlns:a16="http://schemas.microsoft.com/office/drawing/2014/main" id="{8E0CDEA3-7B1D-45D9-8043-3922FBC5850F}"/>
              </a:ext>
            </a:extLst>
          </p:cNvPr>
          <p:cNvSpPr/>
          <p:nvPr/>
        </p:nvSpPr>
        <p:spPr>
          <a:xfrm rot="2877750">
            <a:off x="7053077" y="2346550"/>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270" rtlCol="0" anchor="ctr"/>
          <a:lstStyle/>
          <a:p>
            <a:pPr algn="ctr"/>
            <a:r>
              <a:rPr lang="en-US"/>
              <a:t>doubt</a:t>
            </a:r>
          </a:p>
        </p:txBody>
      </p:sp>
      <p:sp>
        <p:nvSpPr>
          <p:cNvPr id="44" name="Arrow: Down 43">
            <a:extLst>
              <a:ext uri="{FF2B5EF4-FFF2-40B4-BE49-F238E27FC236}">
                <a16:creationId xmlns:a16="http://schemas.microsoft.com/office/drawing/2014/main" id="{FF677707-C4CE-4641-8CB6-0D9D16BB2DCA}"/>
              </a:ext>
            </a:extLst>
          </p:cNvPr>
          <p:cNvSpPr/>
          <p:nvPr/>
        </p:nvSpPr>
        <p:spPr>
          <a:xfrm rot="2877750">
            <a:off x="9690223" y="2346550"/>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vert="vert270" rtlCol="0" anchor="ctr"/>
          <a:lstStyle/>
          <a:p>
            <a:pPr algn="ctr"/>
            <a:r>
              <a:rPr lang="en-US"/>
              <a:t>doubt</a:t>
            </a:r>
          </a:p>
        </p:txBody>
      </p:sp>
      <p:sp>
        <p:nvSpPr>
          <p:cNvPr id="45" name="TextBox 44">
            <a:extLst>
              <a:ext uri="{FF2B5EF4-FFF2-40B4-BE49-F238E27FC236}">
                <a16:creationId xmlns:a16="http://schemas.microsoft.com/office/drawing/2014/main" id="{7FCB340D-76E7-447C-8D26-E4CC509A5A63}"/>
              </a:ext>
            </a:extLst>
          </p:cNvPr>
          <p:cNvSpPr txBox="1"/>
          <p:nvPr/>
        </p:nvSpPr>
        <p:spPr>
          <a:xfrm>
            <a:off x="0" y="4787826"/>
            <a:ext cx="7008211" cy="1077218"/>
          </a:xfrm>
          <a:prstGeom prst="rect">
            <a:avLst/>
          </a:prstGeom>
          <a:noFill/>
        </p:spPr>
        <p:txBody>
          <a:bodyPr wrap="square" rtlCol="0">
            <a:spAutoFit/>
          </a:bodyPr>
          <a:lstStyle/>
          <a:p>
            <a:pPr algn="ctr"/>
            <a:r>
              <a:rPr lang="en-US" sz="3200">
                <a:solidFill>
                  <a:srgbClr val="FF9999"/>
                </a:solidFill>
              </a:rPr>
              <a:t>*Bursts with doubts are still included in other summary variables</a:t>
            </a:r>
          </a:p>
        </p:txBody>
      </p:sp>
    </p:spTree>
    <p:extLst>
      <p:ext uri="{BB962C8B-B14F-4D97-AF65-F5344CB8AC3E}">
        <p14:creationId xmlns:p14="http://schemas.microsoft.com/office/powerpoint/2010/main" val="406761788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 name="Rectangle 121">
            <a:extLst>
              <a:ext uri="{FF2B5EF4-FFF2-40B4-BE49-F238E27FC236}">
                <a16:creationId xmlns:a16="http://schemas.microsoft.com/office/drawing/2014/main" id="{D1D1982A-B4D6-41F2-B28B-2532BD1E25C7}"/>
              </a:ext>
            </a:extLst>
          </p:cNvPr>
          <p:cNvSpPr/>
          <p:nvPr/>
        </p:nvSpPr>
        <p:spPr>
          <a:xfrm>
            <a:off x="1009646" y="2693433"/>
            <a:ext cx="2583959" cy="1928326"/>
          </a:xfrm>
          <a:prstGeom prst="rect">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a:solidFill>
                  <a:schemeClr val="tx1"/>
                </a:solidFill>
              </a:rPr>
              <a:t>Region 0</a:t>
            </a:r>
          </a:p>
        </p:txBody>
      </p:sp>
      <p:sp>
        <p:nvSpPr>
          <p:cNvPr id="123" name="Rectangle 122">
            <a:extLst>
              <a:ext uri="{FF2B5EF4-FFF2-40B4-BE49-F238E27FC236}">
                <a16:creationId xmlns:a16="http://schemas.microsoft.com/office/drawing/2014/main" id="{500CF3E1-13F2-4B40-96AB-FB4E24757961}"/>
              </a:ext>
            </a:extLst>
          </p:cNvPr>
          <p:cNvSpPr/>
          <p:nvPr/>
        </p:nvSpPr>
        <p:spPr>
          <a:xfrm>
            <a:off x="3593604" y="2693433"/>
            <a:ext cx="2742549" cy="1928326"/>
          </a:xfrm>
          <a:prstGeom prst="rect">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1</a:t>
            </a:r>
          </a:p>
        </p:txBody>
      </p:sp>
      <p:sp>
        <p:nvSpPr>
          <p:cNvPr id="124" name="Rectangle 123">
            <a:extLst>
              <a:ext uri="{FF2B5EF4-FFF2-40B4-BE49-F238E27FC236}">
                <a16:creationId xmlns:a16="http://schemas.microsoft.com/office/drawing/2014/main" id="{BBC82ADC-8DD9-44AF-8692-D301AC7E9A70}"/>
              </a:ext>
            </a:extLst>
          </p:cNvPr>
          <p:cNvSpPr/>
          <p:nvPr/>
        </p:nvSpPr>
        <p:spPr>
          <a:xfrm>
            <a:off x="6348963" y="2693433"/>
            <a:ext cx="2742549" cy="1928326"/>
          </a:xfrm>
          <a:prstGeom prst="rec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2</a:t>
            </a:r>
          </a:p>
        </p:txBody>
      </p:sp>
      <p:sp>
        <p:nvSpPr>
          <p:cNvPr id="125" name="Rectangle 124">
            <a:extLst>
              <a:ext uri="{FF2B5EF4-FFF2-40B4-BE49-F238E27FC236}">
                <a16:creationId xmlns:a16="http://schemas.microsoft.com/office/drawing/2014/main" id="{CE7534F3-0D54-4E2B-9C0D-EEEE055E6B47}"/>
              </a:ext>
            </a:extLst>
          </p:cNvPr>
          <p:cNvSpPr/>
          <p:nvPr/>
        </p:nvSpPr>
        <p:spPr>
          <a:xfrm>
            <a:off x="9091513" y="2693433"/>
            <a:ext cx="1984674" cy="1928326"/>
          </a:xfrm>
          <a:prstGeom prst="rect">
            <a:avLst/>
          </a:prstGeom>
          <a:solidFill>
            <a:srgbClr val="D9F7F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3</a:t>
            </a:r>
          </a:p>
        </p:txBody>
      </p:sp>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Region: </a:t>
            </a:r>
            <a:r>
              <a:rPr lang="en-US" sz="3600"/>
              <a:t>Demarcation of treatments or other experimental features. </a:t>
            </a:r>
          </a:p>
        </p:txBody>
      </p:sp>
      <p:cxnSp>
        <p:nvCxnSpPr>
          <p:cNvPr id="34" name="Straight Connector 33">
            <a:extLst>
              <a:ext uri="{FF2B5EF4-FFF2-40B4-BE49-F238E27FC236}">
                <a16:creationId xmlns:a16="http://schemas.microsoft.com/office/drawing/2014/main" id="{F2A917D8-AA09-4F22-81C1-C259D4B57583}"/>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09B2289E-F02B-428E-B511-DEAB1B34F0F3}"/>
              </a:ext>
            </a:extLst>
          </p:cNvPr>
          <p:cNvCxnSpPr>
            <a:cxnSpLocks/>
          </p:cNvCxnSpPr>
          <p:nvPr/>
        </p:nvCxnSpPr>
        <p:spPr>
          <a:xfrm>
            <a:off x="2523265"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4B7B9466-5977-4660-8DCA-2BFCB21B5A29}"/>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5CB3EE82-0234-4F81-90D0-D87F923EE4AA}"/>
              </a:ext>
            </a:extLst>
          </p:cNvPr>
          <p:cNvCxnSpPr>
            <a:cxnSpLocks/>
          </p:cNvCxnSpPr>
          <p:nvPr/>
        </p:nvCxnSpPr>
        <p:spPr>
          <a:xfrm>
            <a:off x="5541943"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B5E8C635-4938-42A2-BD75-A83BAB84AB40}"/>
              </a:ext>
            </a:extLst>
          </p:cNvPr>
          <p:cNvCxnSpPr>
            <a:cxnSpLocks/>
          </p:cNvCxnSpPr>
          <p:nvPr/>
        </p:nvCxnSpPr>
        <p:spPr>
          <a:xfrm>
            <a:off x="6045056"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BC37F7C-8905-4810-844A-32C81344656D}"/>
              </a:ext>
            </a:extLst>
          </p:cNvPr>
          <p:cNvCxnSpPr>
            <a:cxnSpLocks/>
          </p:cNvCxnSpPr>
          <p:nvPr/>
        </p:nvCxnSpPr>
        <p:spPr>
          <a:xfrm>
            <a:off x="654816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E632A8B1-3649-49A7-B57B-C6D10F953DD8}"/>
              </a:ext>
            </a:extLst>
          </p:cNvPr>
          <p:cNvCxnSpPr>
            <a:cxnSpLocks/>
          </p:cNvCxnSpPr>
          <p:nvPr/>
        </p:nvCxnSpPr>
        <p:spPr>
          <a:xfrm>
            <a:off x="856062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A0325E31-CC59-44F7-94FD-3404F8F56D35}"/>
              </a:ext>
            </a:extLst>
          </p:cNvPr>
          <p:cNvCxnSpPr>
            <a:cxnSpLocks/>
          </p:cNvCxnSpPr>
          <p:nvPr/>
        </p:nvCxnSpPr>
        <p:spPr>
          <a:xfrm>
            <a:off x="10573073"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5714644C-2281-4F4F-92A9-147BE6F41E09}"/>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a16="http://schemas.microsoft.com/office/drawing/2014/main" id="{9574B2BE-913E-4105-B3FD-0D9ABB3860A6}"/>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76" name="TextBox 75">
            <a:extLst>
              <a:ext uri="{FF2B5EF4-FFF2-40B4-BE49-F238E27FC236}">
                <a16:creationId xmlns:a16="http://schemas.microsoft.com/office/drawing/2014/main" id="{982E6383-71FA-477B-BF9A-AD6A3B55EBB3}"/>
              </a:ext>
            </a:extLst>
          </p:cNvPr>
          <p:cNvSpPr txBox="1"/>
          <p:nvPr/>
        </p:nvSpPr>
        <p:spPr>
          <a:xfrm>
            <a:off x="2366812"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3</a:t>
            </a:r>
          </a:p>
        </p:txBody>
      </p:sp>
      <p:sp>
        <p:nvSpPr>
          <p:cNvPr id="77" name="TextBox 76">
            <a:extLst>
              <a:ext uri="{FF2B5EF4-FFF2-40B4-BE49-F238E27FC236}">
                <a16:creationId xmlns:a16="http://schemas.microsoft.com/office/drawing/2014/main" id="{D5045A1D-4042-45DA-8CEF-F7DDBEB918AA}"/>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89" name="TextBox 88">
            <a:extLst>
              <a:ext uri="{FF2B5EF4-FFF2-40B4-BE49-F238E27FC236}">
                <a16:creationId xmlns:a16="http://schemas.microsoft.com/office/drawing/2014/main" id="{F6B6002F-5E81-4BA1-B6D0-ABC65AFFB17D}"/>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5588F674-1BDB-4F23-A205-1952182558C6}"/>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91" name="TextBox 90">
            <a:extLst>
              <a:ext uri="{FF2B5EF4-FFF2-40B4-BE49-F238E27FC236}">
                <a16:creationId xmlns:a16="http://schemas.microsoft.com/office/drawing/2014/main" id="{FB666959-732B-4ED7-89D8-08DADF665B83}"/>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95" name="TextBox 94">
            <a:extLst>
              <a:ext uri="{FF2B5EF4-FFF2-40B4-BE49-F238E27FC236}">
                <a16:creationId xmlns:a16="http://schemas.microsoft.com/office/drawing/2014/main" id="{57842CB3-7F18-4588-957D-89858DA0664B}"/>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99" name="TextBox 98">
            <a:extLst>
              <a:ext uri="{FF2B5EF4-FFF2-40B4-BE49-F238E27FC236}">
                <a16:creationId xmlns:a16="http://schemas.microsoft.com/office/drawing/2014/main" id="{14463CAA-B4D5-4220-A29B-B54081169A57}"/>
              </a:ext>
            </a:extLst>
          </p:cNvPr>
          <p:cNvSpPr txBox="1"/>
          <p:nvPr/>
        </p:nvSpPr>
        <p:spPr>
          <a:xfrm>
            <a:off x="10352500"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9</a:t>
            </a:r>
          </a:p>
        </p:txBody>
      </p:sp>
      <p:sp>
        <p:nvSpPr>
          <p:cNvPr id="100" name="TextBox 99">
            <a:extLst>
              <a:ext uri="{FF2B5EF4-FFF2-40B4-BE49-F238E27FC236}">
                <a16:creationId xmlns:a16="http://schemas.microsoft.com/office/drawing/2014/main" id="{470AB2E8-03D9-4071-8329-8063DB46FD0A}"/>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103" name="TextBox 102">
            <a:extLst>
              <a:ext uri="{FF2B5EF4-FFF2-40B4-BE49-F238E27FC236}">
                <a16:creationId xmlns:a16="http://schemas.microsoft.com/office/drawing/2014/main" id="{F30E38B6-500B-40D2-A227-03FDB888FBA8}"/>
              </a:ext>
            </a:extLst>
          </p:cNvPr>
          <p:cNvSpPr txBox="1"/>
          <p:nvPr/>
        </p:nvSpPr>
        <p:spPr>
          <a:xfrm>
            <a:off x="2366812"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04" name="TextBox 103">
            <a:extLst>
              <a:ext uri="{FF2B5EF4-FFF2-40B4-BE49-F238E27FC236}">
                <a16:creationId xmlns:a16="http://schemas.microsoft.com/office/drawing/2014/main" id="{299F0864-5921-4133-BC22-E152B0427FB1}"/>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09" name="TextBox 108">
            <a:extLst>
              <a:ext uri="{FF2B5EF4-FFF2-40B4-BE49-F238E27FC236}">
                <a16:creationId xmlns:a16="http://schemas.microsoft.com/office/drawing/2014/main" id="{6060DD13-5E8E-40AC-B9F6-ACA988540C0A}"/>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110" name="TextBox 109">
            <a:extLst>
              <a:ext uri="{FF2B5EF4-FFF2-40B4-BE49-F238E27FC236}">
                <a16:creationId xmlns:a16="http://schemas.microsoft.com/office/drawing/2014/main" id="{69B87198-A706-428C-9718-ABFDA3B733F5}"/>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111" name="TextBox 110">
            <a:extLst>
              <a:ext uri="{FF2B5EF4-FFF2-40B4-BE49-F238E27FC236}">
                <a16:creationId xmlns:a16="http://schemas.microsoft.com/office/drawing/2014/main" id="{AAC1C26B-0EF3-409D-98E3-2AD7928E6068}"/>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15" name="TextBox 114">
            <a:extLst>
              <a:ext uri="{FF2B5EF4-FFF2-40B4-BE49-F238E27FC236}">
                <a16:creationId xmlns:a16="http://schemas.microsoft.com/office/drawing/2014/main" id="{8589A5DF-11B7-45C0-A72C-CAE47CFADF09}"/>
              </a:ext>
            </a:extLst>
          </p:cNvPr>
          <p:cNvSpPr txBox="1"/>
          <p:nvPr/>
        </p:nvSpPr>
        <p:spPr>
          <a:xfrm>
            <a:off x="8404167"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19" name="TextBox 118">
            <a:extLst>
              <a:ext uri="{FF2B5EF4-FFF2-40B4-BE49-F238E27FC236}">
                <a16:creationId xmlns:a16="http://schemas.microsoft.com/office/drawing/2014/main" id="{CC2922FC-7BB8-4805-BE54-88F9BDD672D1}"/>
              </a:ext>
            </a:extLst>
          </p:cNvPr>
          <p:cNvSpPr txBox="1"/>
          <p:nvPr/>
        </p:nvSpPr>
        <p:spPr>
          <a:xfrm>
            <a:off x="10416620"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120" name="TextBox 119">
            <a:extLst>
              <a:ext uri="{FF2B5EF4-FFF2-40B4-BE49-F238E27FC236}">
                <a16:creationId xmlns:a16="http://schemas.microsoft.com/office/drawing/2014/main" id="{096F04EA-A040-44A9-AFDB-5F60F01F0B87}"/>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1" name="TextBox 120">
            <a:extLst>
              <a:ext uri="{FF2B5EF4-FFF2-40B4-BE49-F238E27FC236}">
                <a16:creationId xmlns:a16="http://schemas.microsoft.com/office/drawing/2014/main" id="{37041C17-0262-46E7-9A6F-CD6F73B5A23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Tree>
    <p:extLst>
      <p:ext uri="{BB962C8B-B14F-4D97-AF65-F5344CB8AC3E}">
        <p14:creationId xmlns:p14="http://schemas.microsoft.com/office/powerpoint/2010/main" val="234137602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 name="Rectangle 121">
            <a:extLst>
              <a:ext uri="{FF2B5EF4-FFF2-40B4-BE49-F238E27FC236}">
                <a16:creationId xmlns:a16="http://schemas.microsoft.com/office/drawing/2014/main" id="{D1D1982A-B4D6-41F2-B28B-2532BD1E25C7}"/>
              </a:ext>
            </a:extLst>
          </p:cNvPr>
          <p:cNvSpPr/>
          <p:nvPr/>
        </p:nvSpPr>
        <p:spPr>
          <a:xfrm>
            <a:off x="1009646" y="2693433"/>
            <a:ext cx="2583959" cy="1928326"/>
          </a:xfrm>
          <a:prstGeom prst="rect">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a:solidFill>
                  <a:schemeClr val="tx1"/>
                </a:solidFill>
              </a:rPr>
              <a:t>Region 0</a:t>
            </a:r>
          </a:p>
        </p:txBody>
      </p:sp>
      <p:sp>
        <p:nvSpPr>
          <p:cNvPr id="123" name="Rectangle 122">
            <a:extLst>
              <a:ext uri="{FF2B5EF4-FFF2-40B4-BE49-F238E27FC236}">
                <a16:creationId xmlns:a16="http://schemas.microsoft.com/office/drawing/2014/main" id="{500CF3E1-13F2-4B40-96AB-FB4E24757961}"/>
              </a:ext>
            </a:extLst>
          </p:cNvPr>
          <p:cNvSpPr/>
          <p:nvPr/>
        </p:nvSpPr>
        <p:spPr>
          <a:xfrm>
            <a:off x="3593604" y="4774716"/>
            <a:ext cx="2742549" cy="1928326"/>
          </a:xfrm>
          <a:prstGeom prst="rect">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1</a:t>
            </a:r>
          </a:p>
        </p:txBody>
      </p:sp>
      <p:sp>
        <p:nvSpPr>
          <p:cNvPr id="124" name="Rectangle 123">
            <a:extLst>
              <a:ext uri="{FF2B5EF4-FFF2-40B4-BE49-F238E27FC236}">
                <a16:creationId xmlns:a16="http://schemas.microsoft.com/office/drawing/2014/main" id="{BBC82ADC-8DD9-44AF-8692-D301AC7E9A70}"/>
              </a:ext>
            </a:extLst>
          </p:cNvPr>
          <p:cNvSpPr/>
          <p:nvPr/>
        </p:nvSpPr>
        <p:spPr>
          <a:xfrm>
            <a:off x="6348963" y="2693433"/>
            <a:ext cx="2742549" cy="1928326"/>
          </a:xfrm>
          <a:prstGeom prst="rec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2</a:t>
            </a:r>
          </a:p>
        </p:txBody>
      </p:sp>
      <p:sp>
        <p:nvSpPr>
          <p:cNvPr id="125" name="Rectangle 124">
            <a:extLst>
              <a:ext uri="{FF2B5EF4-FFF2-40B4-BE49-F238E27FC236}">
                <a16:creationId xmlns:a16="http://schemas.microsoft.com/office/drawing/2014/main" id="{CE7534F3-0D54-4E2B-9C0D-EEEE055E6B47}"/>
              </a:ext>
            </a:extLst>
          </p:cNvPr>
          <p:cNvSpPr/>
          <p:nvPr/>
        </p:nvSpPr>
        <p:spPr>
          <a:xfrm>
            <a:off x="9091513" y="4774716"/>
            <a:ext cx="1984674" cy="1928326"/>
          </a:xfrm>
          <a:prstGeom prst="rect">
            <a:avLst/>
          </a:prstGeom>
          <a:solidFill>
            <a:srgbClr val="D9F7F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3</a:t>
            </a:r>
          </a:p>
        </p:txBody>
      </p:sp>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Current region processing: </a:t>
            </a:r>
            <a:r>
              <a:rPr lang="en-US" sz="3600"/>
              <a:t>Split the wave file and run burst detection separately</a:t>
            </a:r>
          </a:p>
        </p:txBody>
      </p:sp>
      <p:cxnSp>
        <p:nvCxnSpPr>
          <p:cNvPr id="34" name="Straight Connector 33">
            <a:extLst>
              <a:ext uri="{FF2B5EF4-FFF2-40B4-BE49-F238E27FC236}">
                <a16:creationId xmlns:a16="http://schemas.microsoft.com/office/drawing/2014/main" id="{F2A917D8-AA09-4F22-81C1-C259D4B57583}"/>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09B2289E-F02B-428E-B511-DEAB1B34F0F3}"/>
              </a:ext>
            </a:extLst>
          </p:cNvPr>
          <p:cNvCxnSpPr>
            <a:cxnSpLocks/>
          </p:cNvCxnSpPr>
          <p:nvPr/>
        </p:nvCxnSpPr>
        <p:spPr>
          <a:xfrm>
            <a:off x="2523265"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4B7B9466-5977-4660-8DCA-2BFCB21B5A29}"/>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5CB3EE82-0234-4F81-90D0-D87F923EE4AA}"/>
              </a:ext>
            </a:extLst>
          </p:cNvPr>
          <p:cNvCxnSpPr>
            <a:cxnSpLocks/>
          </p:cNvCxnSpPr>
          <p:nvPr/>
        </p:nvCxnSpPr>
        <p:spPr>
          <a:xfrm>
            <a:off x="5541943" y="4774716"/>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B5E8C635-4938-42A2-BD75-A83BAB84AB40}"/>
              </a:ext>
            </a:extLst>
          </p:cNvPr>
          <p:cNvCxnSpPr>
            <a:cxnSpLocks/>
          </p:cNvCxnSpPr>
          <p:nvPr/>
        </p:nvCxnSpPr>
        <p:spPr>
          <a:xfrm>
            <a:off x="6045056" y="4774716"/>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BC37F7C-8905-4810-844A-32C81344656D}"/>
              </a:ext>
            </a:extLst>
          </p:cNvPr>
          <p:cNvCxnSpPr>
            <a:cxnSpLocks/>
          </p:cNvCxnSpPr>
          <p:nvPr/>
        </p:nvCxnSpPr>
        <p:spPr>
          <a:xfrm>
            <a:off x="654816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E632A8B1-3649-49A7-B57B-C6D10F953DD8}"/>
              </a:ext>
            </a:extLst>
          </p:cNvPr>
          <p:cNvCxnSpPr>
            <a:cxnSpLocks/>
          </p:cNvCxnSpPr>
          <p:nvPr/>
        </p:nvCxnSpPr>
        <p:spPr>
          <a:xfrm>
            <a:off x="856062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A0325E31-CC59-44F7-94FD-3404F8F56D35}"/>
              </a:ext>
            </a:extLst>
          </p:cNvPr>
          <p:cNvCxnSpPr>
            <a:cxnSpLocks/>
          </p:cNvCxnSpPr>
          <p:nvPr/>
        </p:nvCxnSpPr>
        <p:spPr>
          <a:xfrm>
            <a:off x="10573073" y="4774716"/>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5714644C-2281-4F4F-92A9-147BE6F41E09}"/>
              </a:ext>
            </a:extLst>
          </p:cNvPr>
          <p:cNvCxnSpPr>
            <a:cxnSpLocks/>
          </p:cNvCxnSpPr>
          <p:nvPr/>
        </p:nvCxnSpPr>
        <p:spPr>
          <a:xfrm>
            <a:off x="11076186" y="4774716"/>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a16="http://schemas.microsoft.com/office/drawing/2014/main" id="{9574B2BE-913E-4105-B3FD-0D9ABB3860A6}"/>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76" name="TextBox 75">
            <a:extLst>
              <a:ext uri="{FF2B5EF4-FFF2-40B4-BE49-F238E27FC236}">
                <a16:creationId xmlns:a16="http://schemas.microsoft.com/office/drawing/2014/main" id="{982E6383-71FA-477B-BF9A-AD6A3B55EBB3}"/>
              </a:ext>
            </a:extLst>
          </p:cNvPr>
          <p:cNvSpPr txBox="1"/>
          <p:nvPr/>
        </p:nvSpPr>
        <p:spPr>
          <a:xfrm>
            <a:off x="2366812"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3</a:t>
            </a:r>
          </a:p>
        </p:txBody>
      </p:sp>
      <p:sp>
        <p:nvSpPr>
          <p:cNvPr id="77" name="TextBox 76">
            <a:extLst>
              <a:ext uri="{FF2B5EF4-FFF2-40B4-BE49-F238E27FC236}">
                <a16:creationId xmlns:a16="http://schemas.microsoft.com/office/drawing/2014/main" id="{D5045A1D-4042-45DA-8CEF-F7DDBEB918AA}"/>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89" name="TextBox 88">
            <a:extLst>
              <a:ext uri="{FF2B5EF4-FFF2-40B4-BE49-F238E27FC236}">
                <a16:creationId xmlns:a16="http://schemas.microsoft.com/office/drawing/2014/main" id="{F6B6002F-5E81-4BA1-B6D0-ABC65AFFB17D}"/>
              </a:ext>
            </a:extLst>
          </p:cNvPr>
          <p:cNvSpPr txBox="1"/>
          <p:nvPr/>
        </p:nvSpPr>
        <p:spPr>
          <a:xfrm>
            <a:off x="5385490" y="4405384"/>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5588F674-1BDB-4F23-A205-1952182558C6}"/>
              </a:ext>
            </a:extLst>
          </p:cNvPr>
          <p:cNvSpPr txBox="1"/>
          <p:nvPr/>
        </p:nvSpPr>
        <p:spPr>
          <a:xfrm>
            <a:off x="5824483" y="4405384"/>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91" name="TextBox 90">
            <a:extLst>
              <a:ext uri="{FF2B5EF4-FFF2-40B4-BE49-F238E27FC236}">
                <a16:creationId xmlns:a16="http://schemas.microsoft.com/office/drawing/2014/main" id="{FB666959-732B-4ED7-89D8-08DADF665B83}"/>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95" name="TextBox 94">
            <a:extLst>
              <a:ext uri="{FF2B5EF4-FFF2-40B4-BE49-F238E27FC236}">
                <a16:creationId xmlns:a16="http://schemas.microsoft.com/office/drawing/2014/main" id="{57842CB3-7F18-4588-957D-89858DA0664B}"/>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99" name="TextBox 98">
            <a:extLst>
              <a:ext uri="{FF2B5EF4-FFF2-40B4-BE49-F238E27FC236}">
                <a16:creationId xmlns:a16="http://schemas.microsoft.com/office/drawing/2014/main" id="{14463CAA-B4D5-4220-A29B-B54081169A57}"/>
              </a:ext>
            </a:extLst>
          </p:cNvPr>
          <p:cNvSpPr txBox="1"/>
          <p:nvPr/>
        </p:nvSpPr>
        <p:spPr>
          <a:xfrm>
            <a:off x="10352500" y="4405384"/>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9</a:t>
            </a:r>
          </a:p>
        </p:txBody>
      </p:sp>
      <p:sp>
        <p:nvSpPr>
          <p:cNvPr id="103" name="TextBox 102">
            <a:extLst>
              <a:ext uri="{FF2B5EF4-FFF2-40B4-BE49-F238E27FC236}">
                <a16:creationId xmlns:a16="http://schemas.microsoft.com/office/drawing/2014/main" id="{F30E38B6-500B-40D2-A227-03FDB888FBA8}"/>
              </a:ext>
            </a:extLst>
          </p:cNvPr>
          <p:cNvSpPr txBox="1"/>
          <p:nvPr/>
        </p:nvSpPr>
        <p:spPr>
          <a:xfrm>
            <a:off x="2366812"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04" name="TextBox 103">
            <a:extLst>
              <a:ext uri="{FF2B5EF4-FFF2-40B4-BE49-F238E27FC236}">
                <a16:creationId xmlns:a16="http://schemas.microsoft.com/office/drawing/2014/main" id="{299F0864-5921-4133-BC22-E152B0427FB1}"/>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09" name="TextBox 108">
            <a:extLst>
              <a:ext uri="{FF2B5EF4-FFF2-40B4-BE49-F238E27FC236}">
                <a16:creationId xmlns:a16="http://schemas.microsoft.com/office/drawing/2014/main" id="{6060DD13-5E8E-40AC-B9F6-ACA988540C0A}"/>
              </a:ext>
            </a:extLst>
          </p:cNvPr>
          <p:cNvSpPr txBox="1"/>
          <p:nvPr/>
        </p:nvSpPr>
        <p:spPr>
          <a:xfrm>
            <a:off x="5385490" y="4036052"/>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10" name="TextBox 109">
            <a:extLst>
              <a:ext uri="{FF2B5EF4-FFF2-40B4-BE49-F238E27FC236}">
                <a16:creationId xmlns:a16="http://schemas.microsoft.com/office/drawing/2014/main" id="{69B87198-A706-428C-9718-ABFDA3B733F5}"/>
              </a:ext>
            </a:extLst>
          </p:cNvPr>
          <p:cNvSpPr txBox="1"/>
          <p:nvPr/>
        </p:nvSpPr>
        <p:spPr>
          <a:xfrm>
            <a:off x="5888603" y="4036052"/>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11" name="TextBox 110">
            <a:extLst>
              <a:ext uri="{FF2B5EF4-FFF2-40B4-BE49-F238E27FC236}">
                <a16:creationId xmlns:a16="http://schemas.microsoft.com/office/drawing/2014/main" id="{AAC1C26B-0EF3-409D-98E3-2AD7928E6068}"/>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15" name="TextBox 114">
            <a:extLst>
              <a:ext uri="{FF2B5EF4-FFF2-40B4-BE49-F238E27FC236}">
                <a16:creationId xmlns:a16="http://schemas.microsoft.com/office/drawing/2014/main" id="{8589A5DF-11B7-45C0-A72C-CAE47CFADF09}"/>
              </a:ext>
            </a:extLst>
          </p:cNvPr>
          <p:cNvSpPr txBox="1"/>
          <p:nvPr/>
        </p:nvSpPr>
        <p:spPr>
          <a:xfrm>
            <a:off x="8404167"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19" name="TextBox 118">
            <a:extLst>
              <a:ext uri="{FF2B5EF4-FFF2-40B4-BE49-F238E27FC236}">
                <a16:creationId xmlns:a16="http://schemas.microsoft.com/office/drawing/2014/main" id="{CC2922FC-7BB8-4805-BE54-88F9BDD672D1}"/>
              </a:ext>
            </a:extLst>
          </p:cNvPr>
          <p:cNvSpPr txBox="1"/>
          <p:nvPr/>
        </p:nvSpPr>
        <p:spPr>
          <a:xfrm>
            <a:off x="10416620" y="4036052"/>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20" name="TextBox 119">
            <a:extLst>
              <a:ext uri="{FF2B5EF4-FFF2-40B4-BE49-F238E27FC236}">
                <a16:creationId xmlns:a16="http://schemas.microsoft.com/office/drawing/2014/main" id="{096F04EA-A040-44A9-AFDB-5F60F01F0B87}"/>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1" name="TextBox 120">
            <a:extLst>
              <a:ext uri="{FF2B5EF4-FFF2-40B4-BE49-F238E27FC236}">
                <a16:creationId xmlns:a16="http://schemas.microsoft.com/office/drawing/2014/main" id="{37041C17-0262-46E7-9A6F-CD6F73B5A23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cxnSp>
        <p:nvCxnSpPr>
          <p:cNvPr id="36" name="Straight Connector 35">
            <a:extLst>
              <a:ext uri="{FF2B5EF4-FFF2-40B4-BE49-F238E27FC236}">
                <a16:creationId xmlns:a16="http://schemas.microsoft.com/office/drawing/2014/main" id="{4194EDD0-3CE6-46FA-96E6-86A0B52070A5}"/>
              </a:ext>
            </a:extLst>
          </p:cNvPr>
          <p:cNvCxnSpPr>
            <a:cxnSpLocks/>
          </p:cNvCxnSpPr>
          <p:nvPr/>
        </p:nvCxnSpPr>
        <p:spPr>
          <a:xfrm>
            <a:off x="3593604"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F7977A75-1678-42B8-BB1B-FE96AB5B75A7}"/>
              </a:ext>
            </a:extLst>
          </p:cNvPr>
          <p:cNvSpPr txBox="1"/>
          <p:nvPr/>
        </p:nvSpPr>
        <p:spPr>
          <a:xfrm>
            <a:off x="10855613" y="4405384"/>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40" name="TextBox 39">
            <a:extLst>
              <a:ext uri="{FF2B5EF4-FFF2-40B4-BE49-F238E27FC236}">
                <a16:creationId xmlns:a16="http://schemas.microsoft.com/office/drawing/2014/main" id="{96A89F5F-6703-4462-9F46-EDFFE99EF633}"/>
              </a:ext>
            </a:extLst>
          </p:cNvPr>
          <p:cNvSpPr txBox="1"/>
          <p:nvPr/>
        </p:nvSpPr>
        <p:spPr>
          <a:xfrm>
            <a:off x="11307430" y="4405384"/>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41" name="TextBox 40">
            <a:extLst>
              <a:ext uri="{FF2B5EF4-FFF2-40B4-BE49-F238E27FC236}">
                <a16:creationId xmlns:a16="http://schemas.microsoft.com/office/drawing/2014/main" id="{C4C365F6-0C57-49E2-AE6F-8C4E87DE112B}"/>
              </a:ext>
            </a:extLst>
          </p:cNvPr>
          <p:cNvSpPr txBox="1"/>
          <p:nvPr/>
        </p:nvSpPr>
        <p:spPr>
          <a:xfrm>
            <a:off x="11215770" y="4036052"/>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cxnSp>
        <p:nvCxnSpPr>
          <p:cNvPr id="42" name="Straight Connector 41">
            <a:extLst>
              <a:ext uri="{FF2B5EF4-FFF2-40B4-BE49-F238E27FC236}">
                <a16:creationId xmlns:a16="http://schemas.microsoft.com/office/drawing/2014/main" id="{D6915FFD-AB24-4C23-AF2E-0141B4FC1F2C}"/>
              </a:ext>
            </a:extLst>
          </p:cNvPr>
          <p:cNvCxnSpPr>
            <a:cxnSpLocks/>
          </p:cNvCxnSpPr>
          <p:nvPr/>
        </p:nvCxnSpPr>
        <p:spPr>
          <a:xfrm>
            <a:off x="9092540" y="4774716"/>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281CB8DA-C9F2-4F12-87F8-87ABB7DF0E21}"/>
              </a:ext>
            </a:extLst>
          </p:cNvPr>
          <p:cNvCxnSpPr>
            <a:cxnSpLocks/>
          </p:cNvCxnSpPr>
          <p:nvPr/>
        </p:nvCxnSpPr>
        <p:spPr>
          <a:xfrm>
            <a:off x="6336153" y="4774716"/>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FB326302-4F96-40FC-BB1D-63037D61E7A2}"/>
              </a:ext>
            </a:extLst>
          </p:cNvPr>
          <p:cNvCxnSpPr>
            <a:cxnSpLocks/>
          </p:cNvCxnSpPr>
          <p:nvPr/>
        </p:nvCxnSpPr>
        <p:spPr>
          <a:xfrm>
            <a:off x="3593604" y="4774716"/>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9E33AA6D-C126-4EB5-A693-9408FF0193EC}"/>
              </a:ext>
            </a:extLst>
          </p:cNvPr>
          <p:cNvCxnSpPr>
            <a:cxnSpLocks/>
          </p:cNvCxnSpPr>
          <p:nvPr/>
        </p:nvCxnSpPr>
        <p:spPr>
          <a:xfrm>
            <a:off x="6336153"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821F7EE7-3427-4E19-8918-B40DEE561B54}"/>
              </a:ext>
            </a:extLst>
          </p:cNvPr>
          <p:cNvCxnSpPr>
            <a:cxnSpLocks/>
          </p:cNvCxnSpPr>
          <p:nvPr/>
        </p:nvCxnSpPr>
        <p:spPr>
          <a:xfrm>
            <a:off x="9091512"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9204338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 name="Rectangle 121">
            <a:extLst>
              <a:ext uri="{FF2B5EF4-FFF2-40B4-BE49-F238E27FC236}">
                <a16:creationId xmlns:a16="http://schemas.microsoft.com/office/drawing/2014/main" id="{D1D1982A-B4D6-41F2-B28B-2532BD1E25C7}"/>
              </a:ext>
            </a:extLst>
          </p:cNvPr>
          <p:cNvSpPr/>
          <p:nvPr/>
        </p:nvSpPr>
        <p:spPr>
          <a:xfrm>
            <a:off x="1009646" y="2693433"/>
            <a:ext cx="2583959" cy="1928326"/>
          </a:xfrm>
          <a:prstGeom prst="rect">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a:solidFill>
                  <a:schemeClr val="tx1"/>
                </a:solidFill>
              </a:rPr>
              <a:t>Region 0</a:t>
            </a:r>
          </a:p>
        </p:txBody>
      </p:sp>
      <p:sp>
        <p:nvSpPr>
          <p:cNvPr id="123" name="Rectangle 122">
            <a:extLst>
              <a:ext uri="{FF2B5EF4-FFF2-40B4-BE49-F238E27FC236}">
                <a16:creationId xmlns:a16="http://schemas.microsoft.com/office/drawing/2014/main" id="{500CF3E1-13F2-4B40-96AB-FB4E24757961}"/>
              </a:ext>
            </a:extLst>
          </p:cNvPr>
          <p:cNvSpPr/>
          <p:nvPr/>
        </p:nvSpPr>
        <p:spPr>
          <a:xfrm>
            <a:off x="3593604" y="4774716"/>
            <a:ext cx="2742549" cy="1928326"/>
          </a:xfrm>
          <a:prstGeom prst="rect">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1</a:t>
            </a:r>
          </a:p>
        </p:txBody>
      </p:sp>
      <p:sp>
        <p:nvSpPr>
          <p:cNvPr id="124" name="Rectangle 123">
            <a:extLst>
              <a:ext uri="{FF2B5EF4-FFF2-40B4-BE49-F238E27FC236}">
                <a16:creationId xmlns:a16="http://schemas.microsoft.com/office/drawing/2014/main" id="{BBC82ADC-8DD9-44AF-8692-D301AC7E9A70}"/>
              </a:ext>
            </a:extLst>
          </p:cNvPr>
          <p:cNvSpPr/>
          <p:nvPr/>
        </p:nvSpPr>
        <p:spPr>
          <a:xfrm>
            <a:off x="6348963" y="2693433"/>
            <a:ext cx="2742549" cy="1928326"/>
          </a:xfrm>
          <a:prstGeom prst="rec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2</a:t>
            </a:r>
          </a:p>
        </p:txBody>
      </p:sp>
      <p:sp>
        <p:nvSpPr>
          <p:cNvPr id="125" name="Rectangle 124">
            <a:extLst>
              <a:ext uri="{FF2B5EF4-FFF2-40B4-BE49-F238E27FC236}">
                <a16:creationId xmlns:a16="http://schemas.microsoft.com/office/drawing/2014/main" id="{CE7534F3-0D54-4E2B-9C0D-EEEE055E6B47}"/>
              </a:ext>
            </a:extLst>
          </p:cNvPr>
          <p:cNvSpPr/>
          <p:nvPr/>
        </p:nvSpPr>
        <p:spPr>
          <a:xfrm>
            <a:off x="9091513" y="4774716"/>
            <a:ext cx="1984674" cy="1928326"/>
          </a:xfrm>
          <a:prstGeom prst="rect">
            <a:avLst/>
          </a:prstGeom>
          <a:solidFill>
            <a:srgbClr val="D9F7F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3</a:t>
            </a:r>
          </a:p>
        </p:txBody>
      </p:sp>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Current region processing: </a:t>
            </a:r>
            <a:r>
              <a:rPr lang="en-US" sz="3600"/>
              <a:t>Split the wave file and run burst detection separately</a:t>
            </a:r>
          </a:p>
        </p:txBody>
      </p:sp>
      <p:cxnSp>
        <p:nvCxnSpPr>
          <p:cNvPr id="34" name="Straight Connector 33">
            <a:extLst>
              <a:ext uri="{FF2B5EF4-FFF2-40B4-BE49-F238E27FC236}">
                <a16:creationId xmlns:a16="http://schemas.microsoft.com/office/drawing/2014/main" id="{F2A917D8-AA09-4F22-81C1-C259D4B57583}"/>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09B2289E-F02B-428E-B511-DEAB1B34F0F3}"/>
              </a:ext>
            </a:extLst>
          </p:cNvPr>
          <p:cNvCxnSpPr>
            <a:cxnSpLocks/>
          </p:cNvCxnSpPr>
          <p:nvPr/>
        </p:nvCxnSpPr>
        <p:spPr>
          <a:xfrm>
            <a:off x="2523265" y="2693433"/>
            <a:ext cx="0" cy="1928326"/>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4B7B9466-5977-4660-8DCA-2BFCB21B5A29}"/>
              </a:ext>
            </a:extLst>
          </p:cNvPr>
          <p:cNvCxnSpPr>
            <a:cxnSpLocks/>
          </p:cNvCxnSpPr>
          <p:nvPr/>
        </p:nvCxnSpPr>
        <p:spPr>
          <a:xfrm>
            <a:off x="3026378" y="2693433"/>
            <a:ext cx="0" cy="1928326"/>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5CB3EE82-0234-4F81-90D0-D87F923EE4AA}"/>
              </a:ext>
            </a:extLst>
          </p:cNvPr>
          <p:cNvCxnSpPr>
            <a:cxnSpLocks/>
          </p:cNvCxnSpPr>
          <p:nvPr/>
        </p:nvCxnSpPr>
        <p:spPr>
          <a:xfrm>
            <a:off x="5541943" y="4774716"/>
            <a:ext cx="0" cy="1928326"/>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B5E8C635-4938-42A2-BD75-A83BAB84AB40}"/>
              </a:ext>
            </a:extLst>
          </p:cNvPr>
          <p:cNvCxnSpPr>
            <a:cxnSpLocks/>
          </p:cNvCxnSpPr>
          <p:nvPr/>
        </p:nvCxnSpPr>
        <p:spPr>
          <a:xfrm>
            <a:off x="6045056" y="4774716"/>
            <a:ext cx="0" cy="1928326"/>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BC37F7C-8905-4810-844A-32C81344656D}"/>
              </a:ext>
            </a:extLst>
          </p:cNvPr>
          <p:cNvCxnSpPr>
            <a:cxnSpLocks/>
          </p:cNvCxnSpPr>
          <p:nvPr/>
        </p:nvCxnSpPr>
        <p:spPr>
          <a:xfrm>
            <a:off x="6548169" y="2693433"/>
            <a:ext cx="0" cy="1928326"/>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E632A8B1-3649-49A7-B57B-C6D10F953DD8}"/>
              </a:ext>
            </a:extLst>
          </p:cNvPr>
          <p:cNvCxnSpPr>
            <a:cxnSpLocks/>
          </p:cNvCxnSpPr>
          <p:nvPr/>
        </p:nvCxnSpPr>
        <p:spPr>
          <a:xfrm>
            <a:off x="8560621" y="2693433"/>
            <a:ext cx="0" cy="1928326"/>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A0325E31-CC59-44F7-94FD-3404F8F56D35}"/>
              </a:ext>
            </a:extLst>
          </p:cNvPr>
          <p:cNvCxnSpPr>
            <a:cxnSpLocks/>
          </p:cNvCxnSpPr>
          <p:nvPr/>
        </p:nvCxnSpPr>
        <p:spPr>
          <a:xfrm>
            <a:off x="10573073" y="4774716"/>
            <a:ext cx="0" cy="1928326"/>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5714644C-2281-4F4F-92A9-147BE6F41E09}"/>
              </a:ext>
            </a:extLst>
          </p:cNvPr>
          <p:cNvCxnSpPr>
            <a:cxnSpLocks/>
          </p:cNvCxnSpPr>
          <p:nvPr/>
        </p:nvCxnSpPr>
        <p:spPr>
          <a:xfrm>
            <a:off x="11076186" y="4774716"/>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a16="http://schemas.microsoft.com/office/drawing/2014/main" id="{9574B2BE-913E-4105-B3FD-0D9ABB3860A6}"/>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76" name="TextBox 75">
            <a:extLst>
              <a:ext uri="{FF2B5EF4-FFF2-40B4-BE49-F238E27FC236}">
                <a16:creationId xmlns:a16="http://schemas.microsoft.com/office/drawing/2014/main" id="{982E6383-71FA-477B-BF9A-AD6A3B55EBB3}"/>
              </a:ext>
            </a:extLst>
          </p:cNvPr>
          <p:cNvSpPr txBox="1"/>
          <p:nvPr/>
        </p:nvSpPr>
        <p:spPr>
          <a:xfrm>
            <a:off x="2366812"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3</a:t>
            </a:r>
          </a:p>
        </p:txBody>
      </p:sp>
      <p:sp>
        <p:nvSpPr>
          <p:cNvPr id="77" name="TextBox 76">
            <a:extLst>
              <a:ext uri="{FF2B5EF4-FFF2-40B4-BE49-F238E27FC236}">
                <a16:creationId xmlns:a16="http://schemas.microsoft.com/office/drawing/2014/main" id="{D5045A1D-4042-45DA-8CEF-F7DDBEB918AA}"/>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89" name="TextBox 88">
            <a:extLst>
              <a:ext uri="{FF2B5EF4-FFF2-40B4-BE49-F238E27FC236}">
                <a16:creationId xmlns:a16="http://schemas.microsoft.com/office/drawing/2014/main" id="{F6B6002F-5E81-4BA1-B6D0-ABC65AFFB17D}"/>
              </a:ext>
            </a:extLst>
          </p:cNvPr>
          <p:cNvSpPr txBox="1"/>
          <p:nvPr/>
        </p:nvSpPr>
        <p:spPr>
          <a:xfrm>
            <a:off x="5385490" y="4405384"/>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5588F674-1BDB-4F23-A205-1952182558C6}"/>
              </a:ext>
            </a:extLst>
          </p:cNvPr>
          <p:cNvSpPr txBox="1"/>
          <p:nvPr/>
        </p:nvSpPr>
        <p:spPr>
          <a:xfrm>
            <a:off x="5824483" y="4405384"/>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91" name="TextBox 90">
            <a:extLst>
              <a:ext uri="{FF2B5EF4-FFF2-40B4-BE49-F238E27FC236}">
                <a16:creationId xmlns:a16="http://schemas.microsoft.com/office/drawing/2014/main" id="{FB666959-732B-4ED7-89D8-08DADF665B83}"/>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95" name="TextBox 94">
            <a:extLst>
              <a:ext uri="{FF2B5EF4-FFF2-40B4-BE49-F238E27FC236}">
                <a16:creationId xmlns:a16="http://schemas.microsoft.com/office/drawing/2014/main" id="{57842CB3-7F18-4588-957D-89858DA0664B}"/>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99" name="TextBox 98">
            <a:extLst>
              <a:ext uri="{FF2B5EF4-FFF2-40B4-BE49-F238E27FC236}">
                <a16:creationId xmlns:a16="http://schemas.microsoft.com/office/drawing/2014/main" id="{14463CAA-B4D5-4220-A29B-B54081169A57}"/>
              </a:ext>
            </a:extLst>
          </p:cNvPr>
          <p:cNvSpPr txBox="1"/>
          <p:nvPr/>
        </p:nvSpPr>
        <p:spPr>
          <a:xfrm>
            <a:off x="10352500" y="4405384"/>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9</a:t>
            </a:r>
          </a:p>
        </p:txBody>
      </p:sp>
      <p:sp>
        <p:nvSpPr>
          <p:cNvPr id="103" name="TextBox 102">
            <a:extLst>
              <a:ext uri="{FF2B5EF4-FFF2-40B4-BE49-F238E27FC236}">
                <a16:creationId xmlns:a16="http://schemas.microsoft.com/office/drawing/2014/main" id="{F30E38B6-500B-40D2-A227-03FDB888FBA8}"/>
              </a:ext>
            </a:extLst>
          </p:cNvPr>
          <p:cNvSpPr txBox="1"/>
          <p:nvPr/>
        </p:nvSpPr>
        <p:spPr>
          <a:xfrm>
            <a:off x="2366812"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04" name="TextBox 103">
            <a:extLst>
              <a:ext uri="{FF2B5EF4-FFF2-40B4-BE49-F238E27FC236}">
                <a16:creationId xmlns:a16="http://schemas.microsoft.com/office/drawing/2014/main" id="{299F0864-5921-4133-BC22-E152B0427FB1}"/>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09" name="TextBox 108">
            <a:extLst>
              <a:ext uri="{FF2B5EF4-FFF2-40B4-BE49-F238E27FC236}">
                <a16:creationId xmlns:a16="http://schemas.microsoft.com/office/drawing/2014/main" id="{6060DD13-5E8E-40AC-B9F6-ACA988540C0A}"/>
              </a:ext>
            </a:extLst>
          </p:cNvPr>
          <p:cNvSpPr txBox="1"/>
          <p:nvPr/>
        </p:nvSpPr>
        <p:spPr>
          <a:xfrm>
            <a:off x="5385490" y="4036052"/>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10" name="TextBox 109">
            <a:extLst>
              <a:ext uri="{FF2B5EF4-FFF2-40B4-BE49-F238E27FC236}">
                <a16:creationId xmlns:a16="http://schemas.microsoft.com/office/drawing/2014/main" id="{69B87198-A706-428C-9718-ABFDA3B733F5}"/>
              </a:ext>
            </a:extLst>
          </p:cNvPr>
          <p:cNvSpPr txBox="1"/>
          <p:nvPr/>
        </p:nvSpPr>
        <p:spPr>
          <a:xfrm>
            <a:off x="5888603" y="4036052"/>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11" name="TextBox 110">
            <a:extLst>
              <a:ext uri="{FF2B5EF4-FFF2-40B4-BE49-F238E27FC236}">
                <a16:creationId xmlns:a16="http://schemas.microsoft.com/office/drawing/2014/main" id="{AAC1C26B-0EF3-409D-98E3-2AD7928E6068}"/>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15" name="TextBox 114">
            <a:extLst>
              <a:ext uri="{FF2B5EF4-FFF2-40B4-BE49-F238E27FC236}">
                <a16:creationId xmlns:a16="http://schemas.microsoft.com/office/drawing/2014/main" id="{8589A5DF-11B7-45C0-A72C-CAE47CFADF09}"/>
              </a:ext>
            </a:extLst>
          </p:cNvPr>
          <p:cNvSpPr txBox="1"/>
          <p:nvPr/>
        </p:nvSpPr>
        <p:spPr>
          <a:xfrm>
            <a:off x="8404167"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19" name="TextBox 118">
            <a:extLst>
              <a:ext uri="{FF2B5EF4-FFF2-40B4-BE49-F238E27FC236}">
                <a16:creationId xmlns:a16="http://schemas.microsoft.com/office/drawing/2014/main" id="{CC2922FC-7BB8-4805-BE54-88F9BDD672D1}"/>
              </a:ext>
            </a:extLst>
          </p:cNvPr>
          <p:cNvSpPr txBox="1"/>
          <p:nvPr/>
        </p:nvSpPr>
        <p:spPr>
          <a:xfrm>
            <a:off x="10416620" y="4036052"/>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20" name="TextBox 119">
            <a:extLst>
              <a:ext uri="{FF2B5EF4-FFF2-40B4-BE49-F238E27FC236}">
                <a16:creationId xmlns:a16="http://schemas.microsoft.com/office/drawing/2014/main" id="{096F04EA-A040-44A9-AFDB-5F60F01F0B87}"/>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1" name="TextBox 120">
            <a:extLst>
              <a:ext uri="{FF2B5EF4-FFF2-40B4-BE49-F238E27FC236}">
                <a16:creationId xmlns:a16="http://schemas.microsoft.com/office/drawing/2014/main" id="{37041C17-0262-46E7-9A6F-CD6F73B5A23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cxnSp>
        <p:nvCxnSpPr>
          <p:cNvPr id="36" name="Straight Connector 35">
            <a:extLst>
              <a:ext uri="{FF2B5EF4-FFF2-40B4-BE49-F238E27FC236}">
                <a16:creationId xmlns:a16="http://schemas.microsoft.com/office/drawing/2014/main" id="{4194EDD0-3CE6-46FA-96E6-86A0B52070A5}"/>
              </a:ext>
            </a:extLst>
          </p:cNvPr>
          <p:cNvCxnSpPr>
            <a:cxnSpLocks/>
          </p:cNvCxnSpPr>
          <p:nvPr/>
        </p:nvCxnSpPr>
        <p:spPr>
          <a:xfrm>
            <a:off x="3593604"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F7977A75-1678-42B8-BB1B-FE96AB5B75A7}"/>
              </a:ext>
            </a:extLst>
          </p:cNvPr>
          <p:cNvSpPr txBox="1"/>
          <p:nvPr/>
        </p:nvSpPr>
        <p:spPr>
          <a:xfrm>
            <a:off x="10855613" y="4405384"/>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40" name="TextBox 39">
            <a:extLst>
              <a:ext uri="{FF2B5EF4-FFF2-40B4-BE49-F238E27FC236}">
                <a16:creationId xmlns:a16="http://schemas.microsoft.com/office/drawing/2014/main" id="{96A89F5F-6703-4462-9F46-EDFFE99EF633}"/>
              </a:ext>
            </a:extLst>
          </p:cNvPr>
          <p:cNvSpPr txBox="1"/>
          <p:nvPr/>
        </p:nvSpPr>
        <p:spPr>
          <a:xfrm>
            <a:off x="11307430" y="4405384"/>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41" name="TextBox 40">
            <a:extLst>
              <a:ext uri="{FF2B5EF4-FFF2-40B4-BE49-F238E27FC236}">
                <a16:creationId xmlns:a16="http://schemas.microsoft.com/office/drawing/2014/main" id="{C4C365F6-0C57-49E2-AE6F-8C4E87DE112B}"/>
              </a:ext>
            </a:extLst>
          </p:cNvPr>
          <p:cNvSpPr txBox="1"/>
          <p:nvPr/>
        </p:nvSpPr>
        <p:spPr>
          <a:xfrm>
            <a:off x="11215770" y="4036052"/>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cxnSp>
        <p:nvCxnSpPr>
          <p:cNvPr id="42" name="Straight Connector 41">
            <a:extLst>
              <a:ext uri="{FF2B5EF4-FFF2-40B4-BE49-F238E27FC236}">
                <a16:creationId xmlns:a16="http://schemas.microsoft.com/office/drawing/2014/main" id="{D6915FFD-AB24-4C23-AF2E-0141B4FC1F2C}"/>
              </a:ext>
            </a:extLst>
          </p:cNvPr>
          <p:cNvCxnSpPr>
            <a:cxnSpLocks/>
          </p:cNvCxnSpPr>
          <p:nvPr/>
        </p:nvCxnSpPr>
        <p:spPr>
          <a:xfrm>
            <a:off x="9092540" y="4774716"/>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281CB8DA-C9F2-4F12-87F8-87ABB7DF0E21}"/>
              </a:ext>
            </a:extLst>
          </p:cNvPr>
          <p:cNvCxnSpPr>
            <a:cxnSpLocks/>
          </p:cNvCxnSpPr>
          <p:nvPr/>
        </p:nvCxnSpPr>
        <p:spPr>
          <a:xfrm>
            <a:off x="6336153" y="4774716"/>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FB326302-4F96-40FC-BB1D-63037D61E7A2}"/>
              </a:ext>
            </a:extLst>
          </p:cNvPr>
          <p:cNvCxnSpPr>
            <a:cxnSpLocks/>
          </p:cNvCxnSpPr>
          <p:nvPr/>
        </p:nvCxnSpPr>
        <p:spPr>
          <a:xfrm>
            <a:off x="3593604" y="4774716"/>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9E33AA6D-C126-4EB5-A693-9408FF0193EC}"/>
              </a:ext>
            </a:extLst>
          </p:cNvPr>
          <p:cNvCxnSpPr>
            <a:cxnSpLocks/>
          </p:cNvCxnSpPr>
          <p:nvPr/>
        </p:nvCxnSpPr>
        <p:spPr>
          <a:xfrm>
            <a:off x="6336153"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821F7EE7-3427-4E19-8918-B40DEE561B54}"/>
              </a:ext>
            </a:extLst>
          </p:cNvPr>
          <p:cNvCxnSpPr>
            <a:cxnSpLocks/>
          </p:cNvCxnSpPr>
          <p:nvPr/>
        </p:nvCxnSpPr>
        <p:spPr>
          <a:xfrm>
            <a:off x="9091512"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6850763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Long-term Region Goal: </a:t>
            </a:r>
            <a:r>
              <a:rPr lang="en-US" sz="3600"/>
              <a:t>Complete burst detection first, then split output by region. Bursts that start in a region “belong” to that region. Total </a:t>
            </a:r>
            <a:r>
              <a:rPr lang="en-US" sz="3600" err="1"/>
              <a:t>freq</a:t>
            </a:r>
            <a:r>
              <a:rPr lang="en-US" sz="3600"/>
              <a:t> is still number of spikes in a given region </a:t>
            </a:r>
          </a:p>
        </p:txBody>
      </p:sp>
      <p:cxnSp>
        <p:nvCxnSpPr>
          <p:cNvPr id="34" name="Straight Connector 33">
            <a:extLst>
              <a:ext uri="{FF2B5EF4-FFF2-40B4-BE49-F238E27FC236}">
                <a16:creationId xmlns:a16="http://schemas.microsoft.com/office/drawing/2014/main" id="{F2A917D8-AA09-4F22-81C1-C259D4B57583}"/>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09B2289E-F02B-428E-B511-DEAB1B34F0F3}"/>
              </a:ext>
            </a:extLst>
          </p:cNvPr>
          <p:cNvCxnSpPr>
            <a:cxnSpLocks/>
          </p:cNvCxnSpPr>
          <p:nvPr/>
        </p:nvCxnSpPr>
        <p:spPr>
          <a:xfrm>
            <a:off x="2523265"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4B7B9466-5977-4660-8DCA-2BFCB21B5A29}"/>
              </a:ext>
            </a:extLst>
          </p:cNvPr>
          <p:cNvCxnSpPr>
            <a:cxnSpLocks/>
          </p:cNvCxnSpPr>
          <p:nvPr/>
        </p:nvCxnSpPr>
        <p:spPr>
          <a:xfrm>
            <a:off x="3026378"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5CB3EE82-0234-4F81-90D0-D87F923EE4AA}"/>
              </a:ext>
            </a:extLst>
          </p:cNvPr>
          <p:cNvCxnSpPr>
            <a:cxnSpLocks/>
          </p:cNvCxnSpPr>
          <p:nvPr/>
        </p:nvCxnSpPr>
        <p:spPr>
          <a:xfrm>
            <a:off x="5541943"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B5E8C635-4938-42A2-BD75-A83BAB84AB40}"/>
              </a:ext>
            </a:extLst>
          </p:cNvPr>
          <p:cNvCxnSpPr>
            <a:cxnSpLocks/>
          </p:cNvCxnSpPr>
          <p:nvPr/>
        </p:nvCxnSpPr>
        <p:spPr>
          <a:xfrm>
            <a:off x="6045056"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BC37F7C-8905-4810-844A-32C81344656D}"/>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E632A8B1-3649-49A7-B57B-C6D10F953DD8}"/>
              </a:ext>
            </a:extLst>
          </p:cNvPr>
          <p:cNvCxnSpPr>
            <a:cxnSpLocks/>
          </p:cNvCxnSpPr>
          <p:nvPr/>
        </p:nvCxnSpPr>
        <p:spPr>
          <a:xfrm>
            <a:off x="856062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A0325E31-CC59-44F7-94FD-3404F8F56D35}"/>
              </a:ext>
            </a:extLst>
          </p:cNvPr>
          <p:cNvCxnSpPr>
            <a:cxnSpLocks/>
          </p:cNvCxnSpPr>
          <p:nvPr/>
        </p:nvCxnSpPr>
        <p:spPr>
          <a:xfrm>
            <a:off x="10573073" y="2693433"/>
            <a:ext cx="0" cy="1928326"/>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5714644C-2281-4F4F-92A9-147BE6F41E09}"/>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a16="http://schemas.microsoft.com/office/drawing/2014/main" id="{9574B2BE-913E-4105-B3FD-0D9ABB3860A6}"/>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76" name="TextBox 75">
            <a:extLst>
              <a:ext uri="{FF2B5EF4-FFF2-40B4-BE49-F238E27FC236}">
                <a16:creationId xmlns:a16="http://schemas.microsoft.com/office/drawing/2014/main" id="{982E6383-71FA-477B-BF9A-AD6A3B55EBB3}"/>
              </a:ext>
            </a:extLst>
          </p:cNvPr>
          <p:cNvSpPr txBox="1"/>
          <p:nvPr/>
        </p:nvSpPr>
        <p:spPr>
          <a:xfrm>
            <a:off x="2366812"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3</a:t>
            </a:r>
          </a:p>
        </p:txBody>
      </p:sp>
      <p:sp>
        <p:nvSpPr>
          <p:cNvPr id="77" name="TextBox 76">
            <a:extLst>
              <a:ext uri="{FF2B5EF4-FFF2-40B4-BE49-F238E27FC236}">
                <a16:creationId xmlns:a16="http://schemas.microsoft.com/office/drawing/2014/main" id="{D5045A1D-4042-45DA-8CEF-F7DDBEB918AA}"/>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89" name="TextBox 88">
            <a:extLst>
              <a:ext uri="{FF2B5EF4-FFF2-40B4-BE49-F238E27FC236}">
                <a16:creationId xmlns:a16="http://schemas.microsoft.com/office/drawing/2014/main" id="{F6B6002F-5E81-4BA1-B6D0-ABC65AFFB17D}"/>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5588F674-1BDB-4F23-A205-1952182558C6}"/>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91" name="TextBox 90">
            <a:extLst>
              <a:ext uri="{FF2B5EF4-FFF2-40B4-BE49-F238E27FC236}">
                <a16:creationId xmlns:a16="http://schemas.microsoft.com/office/drawing/2014/main" id="{FB666959-732B-4ED7-89D8-08DADF665B83}"/>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95" name="TextBox 94">
            <a:extLst>
              <a:ext uri="{FF2B5EF4-FFF2-40B4-BE49-F238E27FC236}">
                <a16:creationId xmlns:a16="http://schemas.microsoft.com/office/drawing/2014/main" id="{57842CB3-7F18-4588-957D-89858DA0664B}"/>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99" name="TextBox 98">
            <a:extLst>
              <a:ext uri="{FF2B5EF4-FFF2-40B4-BE49-F238E27FC236}">
                <a16:creationId xmlns:a16="http://schemas.microsoft.com/office/drawing/2014/main" id="{14463CAA-B4D5-4220-A29B-B54081169A57}"/>
              </a:ext>
            </a:extLst>
          </p:cNvPr>
          <p:cNvSpPr txBox="1"/>
          <p:nvPr/>
        </p:nvSpPr>
        <p:spPr>
          <a:xfrm>
            <a:off x="10352500"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9</a:t>
            </a:r>
          </a:p>
        </p:txBody>
      </p:sp>
      <p:sp>
        <p:nvSpPr>
          <p:cNvPr id="100" name="TextBox 99">
            <a:extLst>
              <a:ext uri="{FF2B5EF4-FFF2-40B4-BE49-F238E27FC236}">
                <a16:creationId xmlns:a16="http://schemas.microsoft.com/office/drawing/2014/main" id="{470AB2E8-03D9-4071-8329-8063DB46FD0A}"/>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103" name="TextBox 102">
            <a:extLst>
              <a:ext uri="{FF2B5EF4-FFF2-40B4-BE49-F238E27FC236}">
                <a16:creationId xmlns:a16="http://schemas.microsoft.com/office/drawing/2014/main" id="{F30E38B6-500B-40D2-A227-03FDB888FBA8}"/>
              </a:ext>
            </a:extLst>
          </p:cNvPr>
          <p:cNvSpPr txBox="1"/>
          <p:nvPr/>
        </p:nvSpPr>
        <p:spPr>
          <a:xfrm>
            <a:off x="2366812"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04" name="TextBox 103">
            <a:extLst>
              <a:ext uri="{FF2B5EF4-FFF2-40B4-BE49-F238E27FC236}">
                <a16:creationId xmlns:a16="http://schemas.microsoft.com/office/drawing/2014/main" id="{299F0864-5921-4133-BC22-E152B0427FB1}"/>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09" name="TextBox 108">
            <a:extLst>
              <a:ext uri="{FF2B5EF4-FFF2-40B4-BE49-F238E27FC236}">
                <a16:creationId xmlns:a16="http://schemas.microsoft.com/office/drawing/2014/main" id="{6060DD13-5E8E-40AC-B9F6-ACA988540C0A}"/>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110" name="TextBox 109">
            <a:extLst>
              <a:ext uri="{FF2B5EF4-FFF2-40B4-BE49-F238E27FC236}">
                <a16:creationId xmlns:a16="http://schemas.microsoft.com/office/drawing/2014/main" id="{69B87198-A706-428C-9718-ABFDA3B733F5}"/>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111" name="TextBox 110">
            <a:extLst>
              <a:ext uri="{FF2B5EF4-FFF2-40B4-BE49-F238E27FC236}">
                <a16:creationId xmlns:a16="http://schemas.microsoft.com/office/drawing/2014/main" id="{AAC1C26B-0EF3-409D-98E3-2AD7928E6068}"/>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15" name="TextBox 114">
            <a:extLst>
              <a:ext uri="{FF2B5EF4-FFF2-40B4-BE49-F238E27FC236}">
                <a16:creationId xmlns:a16="http://schemas.microsoft.com/office/drawing/2014/main" id="{8589A5DF-11B7-45C0-A72C-CAE47CFADF09}"/>
              </a:ext>
            </a:extLst>
          </p:cNvPr>
          <p:cNvSpPr txBox="1"/>
          <p:nvPr/>
        </p:nvSpPr>
        <p:spPr>
          <a:xfrm>
            <a:off x="8404167"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19" name="TextBox 118">
            <a:extLst>
              <a:ext uri="{FF2B5EF4-FFF2-40B4-BE49-F238E27FC236}">
                <a16:creationId xmlns:a16="http://schemas.microsoft.com/office/drawing/2014/main" id="{CC2922FC-7BB8-4805-BE54-88F9BDD672D1}"/>
              </a:ext>
            </a:extLst>
          </p:cNvPr>
          <p:cNvSpPr txBox="1"/>
          <p:nvPr/>
        </p:nvSpPr>
        <p:spPr>
          <a:xfrm>
            <a:off x="10416620"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120" name="TextBox 119">
            <a:extLst>
              <a:ext uri="{FF2B5EF4-FFF2-40B4-BE49-F238E27FC236}">
                <a16:creationId xmlns:a16="http://schemas.microsoft.com/office/drawing/2014/main" id="{096F04EA-A040-44A9-AFDB-5F60F01F0B87}"/>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1" name="TextBox 120">
            <a:extLst>
              <a:ext uri="{FF2B5EF4-FFF2-40B4-BE49-F238E27FC236}">
                <a16:creationId xmlns:a16="http://schemas.microsoft.com/office/drawing/2014/main" id="{37041C17-0262-46E7-9A6F-CD6F73B5A23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Tree>
    <p:extLst>
      <p:ext uri="{BB962C8B-B14F-4D97-AF65-F5344CB8AC3E}">
        <p14:creationId xmlns:p14="http://schemas.microsoft.com/office/powerpoint/2010/main" val="1737122098"/>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 name="Rectangle 121">
            <a:extLst>
              <a:ext uri="{FF2B5EF4-FFF2-40B4-BE49-F238E27FC236}">
                <a16:creationId xmlns:a16="http://schemas.microsoft.com/office/drawing/2014/main" id="{D1D1982A-B4D6-41F2-B28B-2532BD1E25C7}"/>
              </a:ext>
            </a:extLst>
          </p:cNvPr>
          <p:cNvSpPr/>
          <p:nvPr/>
        </p:nvSpPr>
        <p:spPr>
          <a:xfrm>
            <a:off x="1009646" y="2693433"/>
            <a:ext cx="2583959" cy="1928326"/>
          </a:xfrm>
          <a:prstGeom prst="rect">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a:solidFill>
                  <a:schemeClr val="tx1"/>
                </a:solidFill>
              </a:rPr>
              <a:t>Region 0</a:t>
            </a:r>
          </a:p>
        </p:txBody>
      </p:sp>
      <p:sp>
        <p:nvSpPr>
          <p:cNvPr id="123" name="Rectangle 122">
            <a:extLst>
              <a:ext uri="{FF2B5EF4-FFF2-40B4-BE49-F238E27FC236}">
                <a16:creationId xmlns:a16="http://schemas.microsoft.com/office/drawing/2014/main" id="{500CF3E1-13F2-4B40-96AB-FB4E24757961}"/>
              </a:ext>
            </a:extLst>
          </p:cNvPr>
          <p:cNvSpPr/>
          <p:nvPr/>
        </p:nvSpPr>
        <p:spPr>
          <a:xfrm>
            <a:off x="3593604" y="2693433"/>
            <a:ext cx="2742549" cy="1928326"/>
          </a:xfrm>
          <a:prstGeom prst="rect">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1</a:t>
            </a:r>
          </a:p>
        </p:txBody>
      </p:sp>
      <p:sp>
        <p:nvSpPr>
          <p:cNvPr id="124" name="Rectangle 123">
            <a:extLst>
              <a:ext uri="{FF2B5EF4-FFF2-40B4-BE49-F238E27FC236}">
                <a16:creationId xmlns:a16="http://schemas.microsoft.com/office/drawing/2014/main" id="{BBC82ADC-8DD9-44AF-8692-D301AC7E9A70}"/>
              </a:ext>
            </a:extLst>
          </p:cNvPr>
          <p:cNvSpPr/>
          <p:nvPr/>
        </p:nvSpPr>
        <p:spPr>
          <a:xfrm>
            <a:off x="6348963" y="2693433"/>
            <a:ext cx="2742549" cy="1928326"/>
          </a:xfrm>
          <a:prstGeom prst="rec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2</a:t>
            </a:r>
          </a:p>
        </p:txBody>
      </p:sp>
      <p:sp>
        <p:nvSpPr>
          <p:cNvPr id="125" name="Rectangle 124">
            <a:extLst>
              <a:ext uri="{FF2B5EF4-FFF2-40B4-BE49-F238E27FC236}">
                <a16:creationId xmlns:a16="http://schemas.microsoft.com/office/drawing/2014/main" id="{CE7534F3-0D54-4E2B-9C0D-EEEE055E6B47}"/>
              </a:ext>
            </a:extLst>
          </p:cNvPr>
          <p:cNvSpPr/>
          <p:nvPr/>
        </p:nvSpPr>
        <p:spPr>
          <a:xfrm>
            <a:off x="9091513" y="2693433"/>
            <a:ext cx="1984674" cy="1928326"/>
          </a:xfrm>
          <a:prstGeom prst="rect">
            <a:avLst/>
          </a:prstGeom>
          <a:solidFill>
            <a:srgbClr val="D9F7F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a:ln>
                  <a:noFill/>
                </a:ln>
                <a:solidFill>
                  <a:prstClr val="black"/>
                </a:solidFill>
                <a:effectLst/>
                <a:uLnTx/>
                <a:uFillTx/>
                <a:latin typeface="Arial" panose="020B0604020202020204"/>
                <a:ea typeface="+mn-ea"/>
                <a:cs typeface="+mn-cs"/>
              </a:rPr>
              <a:t>Region 3</a:t>
            </a:r>
          </a:p>
        </p:txBody>
      </p:sp>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Long-term Region Goal: </a:t>
            </a:r>
            <a:r>
              <a:rPr lang="en-US" sz="3600"/>
              <a:t>Complete burst detection first, then split output by region. Bursts that start in a region “belong” to that region. Total </a:t>
            </a:r>
            <a:r>
              <a:rPr lang="en-US" sz="3600" err="1"/>
              <a:t>freq</a:t>
            </a:r>
            <a:r>
              <a:rPr lang="en-US" sz="3600"/>
              <a:t> is still number of spikes in a given region </a:t>
            </a:r>
          </a:p>
        </p:txBody>
      </p:sp>
      <p:cxnSp>
        <p:nvCxnSpPr>
          <p:cNvPr id="34" name="Straight Connector 33">
            <a:extLst>
              <a:ext uri="{FF2B5EF4-FFF2-40B4-BE49-F238E27FC236}">
                <a16:creationId xmlns:a16="http://schemas.microsoft.com/office/drawing/2014/main" id="{F2A917D8-AA09-4F22-81C1-C259D4B57583}"/>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09B2289E-F02B-428E-B511-DEAB1B34F0F3}"/>
              </a:ext>
            </a:extLst>
          </p:cNvPr>
          <p:cNvCxnSpPr>
            <a:cxnSpLocks/>
          </p:cNvCxnSpPr>
          <p:nvPr/>
        </p:nvCxnSpPr>
        <p:spPr>
          <a:xfrm>
            <a:off x="2523265"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4B7B9466-5977-4660-8DCA-2BFCB21B5A29}"/>
              </a:ext>
            </a:extLst>
          </p:cNvPr>
          <p:cNvCxnSpPr>
            <a:cxnSpLocks/>
          </p:cNvCxnSpPr>
          <p:nvPr/>
        </p:nvCxnSpPr>
        <p:spPr>
          <a:xfrm>
            <a:off x="3026378"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5CB3EE82-0234-4F81-90D0-D87F923EE4AA}"/>
              </a:ext>
            </a:extLst>
          </p:cNvPr>
          <p:cNvCxnSpPr>
            <a:cxnSpLocks/>
          </p:cNvCxnSpPr>
          <p:nvPr/>
        </p:nvCxnSpPr>
        <p:spPr>
          <a:xfrm>
            <a:off x="5541943"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B5E8C635-4938-42A2-BD75-A83BAB84AB40}"/>
              </a:ext>
            </a:extLst>
          </p:cNvPr>
          <p:cNvCxnSpPr>
            <a:cxnSpLocks/>
          </p:cNvCxnSpPr>
          <p:nvPr/>
        </p:nvCxnSpPr>
        <p:spPr>
          <a:xfrm>
            <a:off x="6045056"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BC37F7C-8905-4810-844A-32C81344656D}"/>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E632A8B1-3649-49A7-B57B-C6D10F953DD8}"/>
              </a:ext>
            </a:extLst>
          </p:cNvPr>
          <p:cNvCxnSpPr>
            <a:cxnSpLocks/>
          </p:cNvCxnSpPr>
          <p:nvPr/>
        </p:nvCxnSpPr>
        <p:spPr>
          <a:xfrm>
            <a:off x="8560621"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A0325E31-CC59-44F7-94FD-3404F8F56D35}"/>
              </a:ext>
            </a:extLst>
          </p:cNvPr>
          <p:cNvCxnSpPr>
            <a:cxnSpLocks/>
          </p:cNvCxnSpPr>
          <p:nvPr/>
        </p:nvCxnSpPr>
        <p:spPr>
          <a:xfrm>
            <a:off x="10573073" y="2693433"/>
            <a:ext cx="0" cy="1928326"/>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5714644C-2281-4F4F-92A9-147BE6F41E09}"/>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a16="http://schemas.microsoft.com/office/drawing/2014/main" id="{9574B2BE-913E-4105-B3FD-0D9ABB3860A6}"/>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76" name="TextBox 75">
            <a:extLst>
              <a:ext uri="{FF2B5EF4-FFF2-40B4-BE49-F238E27FC236}">
                <a16:creationId xmlns:a16="http://schemas.microsoft.com/office/drawing/2014/main" id="{982E6383-71FA-477B-BF9A-AD6A3B55EBB3}"/>
              </a:ext>
            </a:extLst>
          </p:cNvPr>
          <p:cNvSpPr txBox="1"/>
          <p:nvPr/>
        </p:nvSpPr>
        <p:spPr>
          <a:xfrm>
            <a:off x="2366812"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3</a:t>
            </a:r>
          </a:p>
        </p:txBody>
      </p:sp>
      <p:sp>
        <p:nvSpPr>
          <p:cNvPr id="77" name="TextBox 76">
            <a:extLst>
              <a:ext uri="{FF2B5EF4-FFF2-40B4-BE49-F238E27FC236}">
                <a16:creationId xmlns:a16="http://schemas.microsoft.com/office/drawing/2014/main" id="{D5045A1D-4042-45DA-8CEF-F7DDBEB918AA}"/>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89" name="TextBox 88">
            <a:extLst>
              <a:ext uri="{FF2B5EF4-FFF2-40B4-BE49-F238E27FC236}">
                <a16:creationId xmlns:a16="http://schemas.microsoft.com/office/drawing/2014/main" id="{F6B6002F-5E81-4BA1-B6D0-ABC65AFFB17D}"/>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5588F674-1BDB-4F23-A205-1952182558C6}"/>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91" name="TextBox 90">
            <a:extLst>
              <a:ext uri="{FF2B5EF4-FFF2-40B4-BE49-F238E27FC236}">
                <a16:creationId xmlns:a16="http://schemas.microsoft.com/office/drawing/2014/main" id="{FB666959-732B-4ED7-89D8-08DADF665B83}"/>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95" name="TextBox 94">
            <a:extLst>
              <a:ext uri="{FF2B5EF4-FFF2-40B4-BE49-F238E27FC236}">
                <a16:creationId xmlns:a16="http://schemas.microsoft.com/office/drawing/2014/main" id="{57842CB3-7F18-4588-957D-89858DA0664B}"/>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99" name="TextBox 98">
            <a:extLst>
              <a:ext uri="{FF2B5EF4-FFF2-40B4-BE49-F238E27FC236}">
                <a16:creationId xmlns:a16="http://schemas.microsoft.com/office/drawing/2014/main" id="{14463CAA-B4D5-4220-A29B-B54081169A57}"/>
              </a:ext>
            </a:extLst>
          </p:cNvPr>
          <p:cNvSpPr txBox="1"/>
          <p:nvPr/>
        </p:nvSpPr>
        <p:spPr>
          <a:xfrm>
            <a:off x="10352500"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9</a:t>
            </a:r>
          </a:p>
        </p:txBody>
      </p:sp>
      <p:sp>
        <p:nvSpPr>
          <p:cNvPr id="100" name="TextBox 99">
            <a:extLst>
              <a:ext uri="{FF2B5EF4-FFF2-40B4-BE49-F238E27FC236}">
                <a16:creationId xmlns:a16="http://schemas.microsoft.com/office/drawing/2014/main" id="{470AB2E8-03D9-4071-8329-8063DB46FD0A}"/>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103" name="TextBox 102">
            <a:extLst>
              <a:ext uri="{FF2B5EF4-FFF2-40B4-BE49-F238E27FC236}">
                <a16:creationId xmlns:a16="http://schemas.microsoft.com/office/drawing/2014/main" id="{F30E38B6-500B-40D2-A227-03FDB888FBA8}"/>
              </a:ext>
            </a:extLst>
          </p:cNvPr>
          <p:cNvSpPr txBox="1"/>
          <p:nvPr/>
        </p:nvSpPr>
        <p:spPr>
          <a:xfrm>
            <a:off x="2366812"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04" name="TextBox 103">
            <a:extLst>
              <a:ext uri="{FF2B5EF4-FFF2-40B4-BE49-F238E27FC236}">
                <a16:creationId xmlns:a16="http://schemas.microsoft.com/office/drawing/2014/main" id="{299F0864-5921-4133-BC22-E152B0427FB1}"/>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09" name="TextBox 108">
            <a:extLst>
              <a:ext uri="{FF2B5EF4-FFF2-40B4-BE49-F238E27FC236}">
                <a16:creationId xmlns:a16="http://schemas.microsoft.com/office/drawing/2014/main" id="{6060DD13-5E8E-40AC-B9F6-ACA988540C0A}"/>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110" name="TextBox 109">
            <a:extLst>
              <a:ext uri="{FF2B5EF4-FFF2-40B4-BE49-F238E27FC236}">
                <a16:creationId xmlns:a16="http://schemas.microsoft.com/office/drawing/2014/main" id="{69B87198-A706-428C-9718-ABFDA3B733F5}"/>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111" name="TextBox 110">
            <a:extLst>
              <a:ext uri="{FF2B5EF4-FFF2-40B4-BE49-F238E27FC236}">
                <a16:creationId xmlns:a16="http://schemas.microsoft.com/office/drawing/2014/main" id="{AAC1C26B-0EF3-409D-98E3-2AD7928E6068}"/>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15" name="TextBox 114">
            <a:extLst>
              <a:ext uri="{FF2B5EF4-FFF2-40B4-BE49-F238E27FC236}">
                <a16:creationId xmlns:a16="http://schemas.microsoft.com/office/drawing/2014/main" id="{8589A5DF-11B7-45C0-A72C-CAE47CFADF09}"/>
              </a:ext>
            </a:extLst>
          </p:cNvPr>
          <p:cNvSpPr txBox="1"/>
          <p:nvPr/>
        </p:nvSpPr>
        <p:spPr>
          <a:xfrm>
            <a:off x="8404167"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19" name="TextBox 118">
            <a:extLst>
              <a:ext uri="{FF2B5EF4-FFF2-40B4-BE49-F238E27FC236}">
                <a16:creationId xmlns:a16="http://schemas.microsoft.com/office/drawing/2014/main" id="{CC2922FC-7BB8-4805-BE54-88F9BDD672D1}"/>
              </a:ext>
            </a:extLst>
          </p:cNvPr>
          <p:cNvSpPr txBox="1"/>
          <p:nvPr/>
        </p:nvSpPr>
        <p:spPr>
          <a:xfrm>
            <a:off x="10416620"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120" name="TextBox 119">
            <a:extLst>
              <a:ext uri="{FF2B5EF4-FFF2-40B4-BE49-F238E27FC236}">
                <a16:creationId xmlns:a16="http://schemas.microsoft.com/office/drawing/2014/main" id="{096F04EA-A040-44A9-AFDB-5F60F01F0B87}"/>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1" name="TextBox 120">
            <a:extLst>
              <a:ext uri="{FF2B5EF4-FFF2-40B4-BE49-F238E27FC236}">
                <a16:creationId xmlns:a16="http://schemas.microsoft.com/office/drawing/2014/main" id="{37041C17-0262-46E7-9A6F-CD6F73B5A23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Tree>
    <p:extLst>
      <p:ext uri="{BB962C8B-B14F-4D97-AF65-F5344CB8AC3E}">
        <p14:creationId xmlns:p14="http://schemas.microsoft.com/office/powerpoint/2010/main" val="26988037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Intervals: </a:t>
            </a:r>
            <a:r>
              <a:rPr lang="en-US" sz="3600"/>
              <a:t>The backwards interval of time from an event to the prior event, or to the beginning of the recording for the first event.</a:t>
            </a:r>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5E6CC999-542D-450B-9072-1D8886BE890D}"/>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08F7E712-5429-455C-9EFB-D74CDF210A04}"/>
              </a:ext>
            </a:extLst>
          </p:cNvPr>
          <p:cNvCxnSpPr>
            <a:cxnSpLocks/>
          </p:cNvCxnSpPr>
          <p:nvPr/>
        </p:nvCxnSpPr>
        <p:spPr>
          <a:xfrm>
            <a:off x="5541943"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F9A5C009-1910-496B-A7C1-1822970F0A54}"/>
              </a:ext>
            </a:extLst>
          </p:cNvPr>
          <p:cNvCxnSpPr>
            <a:cxnSpLocks/>
          </p:cNvCxnSpPr>
          <p:nvPr/>
        </p:nvCxnSpPr>
        <p:spPr>
          <a:xfrm>
            <a:off x="6045056"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B66BFC10-08DE-48B5-B23A-6F183F082A13}"/>
              </a:ext>
            </a:extLst>
          </p:cNvPr>
          <p:cNvCxnSpPr>
            <a:cxnSpLocks/>
          </p:cNvCxnSpPr>
          <p:nvPr/>
        </p:nvCxnSpPr>
        <p:spPr>
          <a:xfrm>
            <a:off x="654816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743E1477-59EB-44BF-9DB3-3C6A7A8C082D}"/>
              </a:ext>
            </a:extLst>
          </p:cNvPr>
          <p:cNvCxnSpPr>
            <a:cxnSpLocks/>
          </p:cNvCxnSpPr>
          <p:nvPr/>
        </p:nvCxnSpPr>
        <p:spPr>
          <a:xfrm>
            <a:off x="7051282"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11323809-9FDA-4F29-A82C-AA0FBACD5790}"/>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3" name="TextBox 12">
            <a:extLst>
              <a:ext uri="{FF2B5EF4-FFF2-40B4-BE49-F238E27FC236}">
                <a16:creationId xmlns:a16="http://schemas.microsoft.com/office/drawing/2014/main" id="{063F1761-4EAD-40E2-BD14-2EEF411621C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4" name="TextBox 13">
            <a:extLst>
              <a:ext uri="{FF2B5EF4-FFF2-40B4-BE49-F238E27FC236}">
                <a16:creationId xmlns:a16="http://schemas.microsoft.com/office/drawing/2014/main" id="{A5B98651-E29F-4D49-A6FB-A631BA5B4E18}"/>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5" name="TextBox 14">
            <a:extLst>
              <a:ext uri="{FF2B5EF4-FFF2-40B4-BE49-F238E27FC236}">
                <a16:creationId xmlns:a16="http://schemas.microsoft.com/office/drawing/2014/main" id="{57DBFBDB-A607-41CD-A042-30EBF2F22D7C}"/>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16" name="TextBox 15">
            <a:extLst>
              <a:ext uri="{FF2B5EF4-FFF2-40B4-BE49-F238E27FC236}">
                <a16:creationId xmlns:a16="http://schemas.microsoft.com/office/drawing/2014/main" id="{EAFA46F0-1EAD-492B-B17F-9B66C38F660F}"/>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17" name="TextBox 16">
            <a:extLst>
              <a:ext uri="{FF2B5EF4-FFF2-40B4-BE49-F238E27FC236}">
                <a16:creationId xmlns:a16="http://schemas.microsoft.com/office/drawing/2014/main" id="{7F8CDF7A-FDF6-4DE7-B305-464F6C52B7B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8" name="TextBox 17">
            <a:extLst>
              <a:ext uri="{FF2B5EF4-FFF2-40B4-BE49-F238E27FC236}">
                <a16:creationId xmlns:a16="http://schemas.microsoft.com/office/drawing/2014/main" id="{9F1C46BE-7900-4262-90C3-0471B29061A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0" name="TextBox 19">
            <a:extLst>
              <a:ext uri="{FF2B5EF4-FFF2-40B4-BE49-F238E27FC236}">
                <a16:creationId xmlns:a16="http://schemas.microsoft.com/office/drawing/2014/main" id="{9F438B38-4B5B-42F2-BCB7-6941DD03CAF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21" name="TextBox 20">
            <a:extLst>
              <a:ext uri="{FF2B5EF4-FFF2-40B4-BE49-F238E27FC236}">
                <a16:creationId xmlns:a16="http://schemas.microsoft.com/office/drawing/2014/main" id="{71718F80-5BB8-4AEB-8504-9A2D9A1E5D77}"/>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22" name="TextBox 21">
            <a:extLst>
              <a:ext uri="{FF2B5EF4-FFF2-40B4-BE49-F238E27FC236}">
                <a16:creationId xmlns:a16="http://schemas.microsoft.com/office/drawing/2014/main" id="{586FD3E3-E337-4357-B28A-016395D6231A}"/>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23" name="TextBox 22">
            <a:extLst>
              <a:ext uri="{FF2B5EF4-FFF2-40B4-BE49-F238E27FC236}">
                <a16:creationId xmlns:a16="http://schemas.microsoft.com/office/drawing/2014/main" id="{68CC3645-D8F4-4A75-9408-E695E3B04050}"/>
              </a:ext>
            </a:extLst>
          </p:cNvPr>
          <p:cNvSpPr txBox="1"/>
          <p:nvPr/>
        </p:nvSpPr>
        <p:spPr>
          <a:xfrm>
            <a:off x="639171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24" name="TextBox 23">
            <a:extLst>
              <a:ext uri="{FF2B5EF4-FFF2-40B4-BE49-F238E27FC236}">
                <a16:creationId xmlns:a16="http://schemas.microsoft.com/office/drawing/2014/main" id="{EE8F42A6-71D2-4541-9238-A6F22A7FC8B1}"/>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25" name="TextBox 24">
            <a:extLst>
              <a:ext uri="{FF2B5EF4-FFF2-40B4-BE49-F238E27FC236}">
                <a16:creationId xmlns:a16="http://schemas.microsoft.com/office/drawing/2014/main" id="{F07C037D-791F-459D-B32F-24ECE9031F63}"/>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36" name="TextBox 35">
            <a:extLst>
              <a:ext uri="{FF2B5EF4-FFF2-40B4-BE49-F238E27FC236}">
                <a16:creationId xmlns:a16="http://schemas.microsoft.com/office/drawing/2014/main" id="{BF02E7A9-F5EF-43CA-8B8D-C5D472815F16}"/>
              </a:ext>
            </a:extLst>
          </p:cNvPr>
          <p:cNvSpPr txBox="1"/>
          <p:nvPr/>
        </p:nvSpPr>
        <p:spPr>
          <a:xfrm>
            <a:off x="4125496" y="3214713"/>
            <a:ext cx="301686" cy="369332"/>
          </a:xfrm>
          <a:prstGeom prst="rect">
            <a:avLst/>
          </a:prstGeom>
          <a:noFill/>
        </p:spPr>
        <p:txBody>
          <a:bodyPr wrap="square" rtlCol="0">
            <a:spAutoFit/>
          </a:bodyPr>
          <a:lstStyle/>
          <a:p>
            <a:pPr algn="ctr"/>
            <a:r>
              <a:rPr lang="en-US"/>
              <a:t>5</a:t>
            </a:r>
          </a:p>
        </p:txBody>
      </p:sp>
      <p:cxnSp>
        <p:nvCxnSpPr>
          <p:cNvPr id="37" name="Straight Connector 36">
            <a:extLst>
              <a:ext uri="{FF2B5EF4-FFF2-40B4-BE49-F238E27FC236}">
                <a16:creationId xmlns:a16="http://schemas.microsoft.com/office/drawing/2014/main" id="{F88F0585-0883-4550-B46A-1A419C2238BE}"/>
              </a:ext>
            </a:extLst>
          </p:cNvPr>
          <p:cNvCxnSpPr>
            <a:cxnSpLocks/>
          </p:cNvCxnSpPr>
          <p:nvPr/>
        </p:nvCxnSpPr>
        <p:spPr>
          <a:xfrm>
            <a:off x="3026378" y="3557734"/>
            <a:ext cx="2499923" cy="0"/>
          </a:xfrm>
          <a:prstGeom prst="line">
            <a:avLst/>
          </a:prstGeom>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368D76A5-CAA3-4070-B6C2-875B32207197}"/>
              </a:ext>
            </a:extLst>
          </p:cNvPr>
          <p:cNvSpPr txBox="1"/>
          <p:nvPr/>
        </p:nvSpPr>
        <p:spPr>
          <a:xfrm>
            <a:off x="7906665" y="3214713"/>
            <a:ext cx="301686" cy="369332"/>
          </a:xfrm>
          <a:prstGeom prst="rect">
            <a:avLst/>
          </a:prstGeom>
          <a:noFill/>
        </p:spPr>
        <p:txBody>
          <a:bodyPr wrap="square" rtlCol="0">
            <a:spAutoFit/>
          </a:bodyPr>
          <a:lstStyle/>
          <a:p>
            <a:pPr algn="ctr"/>
            <a:r>
              <a:rPr lang="en-US"/>
              <a:t>4</a:t>
            </a:r>
          </a:p>
        </p:txBody>
      </p:sp>
      <p:cxnSp>
        <p:nvCxnSpPr>
          <p:cNvPr id="39" name="Straight Connector 38">
            <a:extLst>
              <a:ext uri="{FF2B5EF4-FFF2-40B4-BE49-F238E27FC236}">
                <a16:creationId xmlns:a16="http://schemas.microsoft.com/office/drawing/2014/main" id="{E04BD833-3EC8-4C6E-BBE6-EA5808D5B21E}"/>
              </a:ext>
            </a:extLst>
          </p:cNvPr>
          <p:cNvCxnSpPr>
            <a:cxnSpLocks/>
          </p:cNvCxnSpPr>
          <p:nvPr/>
        </p:nvCxnSpPr>
        <p:spPr>
          <a:xfrm>
            <a:off x="7048373" y="3557734"/>
            <a:ext cx="2015361" cy="0"/>
          </a:xfrm>
          <a:prstGeom prst="line">
            <a:avLst/>
          </a:prstGeom>
        </p:spPr>
        <p:style>
          <a:lnRef idx="1">
            <a:schemeClr val="accent1"/>
          </a:lnRef>
          <a:fillRef idx="0">
            <a:schemeClr val="accent1"/>
          </a:fillRef>
          <a:effectRef idx="0">
            <a:schemeClr val="accent1"/>
          </a:effectRef>
          <a:fontRef idx="minor">
            <a:schemeClr val="tx1"/>
          </a:fontRef>
        </p:style>
      </p:cxnSp>
      <p:sp>
        <p:nvSpPr>
          <p:cNvPr id="40" name="TextBox 39">
            <a:extLst>
              <a:ext uri="{FF2B5EF4-FFF2-40B4-BE49-F238E27FC236}">
                <a16:creationId xmlns:a16="http://schemas.microsoft.com/office/drawing/2014/main" id="{0FC3F339-EB43-4A7D-AE11-DDFC200AB678}"/>
              </a:ext>
            </a:extLst>
          </p:cNvPr>
          <p:cNvSpPr txBox="1"/>
          <p:nvPr/>
        </p:nvSpPr>
        <p:spPr>
          <a:xfrm>
            <a:off x="1869309" y="3214713"/>
            <a:ext cx="301686" cy="369332"/>
          </a:xfrm>
          <a:prstGeom prst="rect">
            <a:avLst/>
          </a:prstGeom>
          <a:noFill/>
        </p:spPr>
        <p:txBody>
          <a:bodyPr wrap="square" rtlCol="0">
            <a:spAutoFit/>
          </a:bodyPr>
          <a:lstStyle/>
          <a:p>
            <a:pPr algn="ctr"/>
            <a:r>
              <a:rPr lang="en-US"/>
              <a:t>4</a:t>
            </a:r>
          </a:p>
        </p:txBody>
      </p:sp>
      <p:cxnSp>
        <p:nvCxnSpPr>
          <p:cNvPr id="41" name="Straight Connector 40">
            <a:extLst>
              <a:ext uri="{FF2B5EF4-FFF2-40B4-BE49-F238E27FC236}">
                <a16:creationId xmlns:a16="http://schemas.microsoft.com/office/drawing/2014/main" id="{6D55FB04-5277-49B4-8ADF-CDED89F88B90}"/>
              </a:ext>
            </a:extLst>
          </p:cNvPr>
          <p:cNvCxnSpPr>
            <a:cxnSpLocks/>
          </p:cNvCxnSpPr>
          <p:nvPr/>
        </p:nvCxnSpPr>
        <p:spPr>
          <a:xfrm>
            <a:off x="1011017" y="3557734"/>
            <a:ext cx="2015361" cy="0"/>
          </a:xfrm>
          <a:prstGeom prst="line">
            <a:avLst/>
          </a:prstGeom>
        </p:spPr>
        <p:style>
          <a:lnRef idx="1">
            <a:schemeClr val="accent1"/>
          </a:lnRef>
          <a:fillRef idx="0">
            <a:schemeClr val="accent1"/>
          </a:fillRef>
          <a:effectRef idx="0">
            <a:schemeClr val="accent1"/>
          </a:effectRef>
          <a:fontRef idx="minor">
            <a:schemeClr val="tx1"/>
          </a:fontRef>
        </p:style>
      </p:cxnSp>
      <p:sp>
        <p:nvSpPr>
          <p:cNvPr id="42" name="TextBox 41">
            <a:extLst>
              <a:ext uri="{FF2B5EF4-FFF2-40B4-BE49-F238E27FC236}">
                <a16:creationId xmlns:a16="http://schemas.microsoft.com/office/drawing/2014/main" id="{011BCC47-7C11-477D-A088-66AF1245ED95}"/>
              </a:ext>
            </a:extLst>
          </p:cNvPr>
          <p:cNvSpPr txBox="1"/>
          <p:nvPr/>
        </p:nvSpPr>
        <p:spPr>
          <a:xfrm>
            <a:off x="5645462" y="3214713"/>
            <a:ext cx="301686" cy="369332"/>
          </a:xfrm>
          <a:prstGeom prst="rect">
            <a:avLst/>
          </a:prstGeom>
          <a:noFill/>
        </p:spPr>
        <p:txBody>
          <a:bodyPr wrap="square" rtlCol="0">
            <a:spAutoFit/>
          </a:bodyPr>
          <a:lstStyle/>
          <a:p>
            <a:pPr algn="ctr"/>
            <a:r>
              <a:rPr lang="en-US"/>
              <a:t>1</a:t>
            </a:r>
          </a:p>
        </p:txBody>
      </p:sp>
      <p:cxnSp>
        <p:nvCxnSpPr>
          <p:cNvPr id="43" name="Straight Connector 42">
            <a:extLst>
              <a:ext uri="{FF2B5EF4-FFF2-40B4-BE49-F238E27FC236}">
                <a16:creationId xmlns:a16="http://schemas.microsoft.com/office/drawing/2014/main" id="{4AFE4589-C802-4C9C-8429-111B9A2AD3CF}"/>
              </a:ext>
            </a:extLst>
          </p:cNvPr>
          <p:cNvCxnSpPr>
            <a:cxnSpLocks/>
          </p:cNvCxnSpPr>
          <p:nvPr/>
        </p:nvCxnSpPr>
        <p:spPr>
          <a:xfrm>
            <a:off x="5544644" y="3557734"/>
            <a:ext cx="503322" cy="0"/>
          </a:xfrm>
          <a:prstGeom prst="line">
            <a:avLst/>
          </a:prstGeom>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3BE02717-75A8-467A-971C-F80368F4E2B1}"/>
              </a:ext>
            </a:extLst>
          </p:cNvPr>
          <p:cNvSpPr txBox="1"/>
          <p:nvPr/>
        </p:nvSpPr>
        <p:spPr>
          <a:xfrm>
            <a:off x="6148091" y="3214713"/>
            <a:ext cx="301686" cy="369332"/>
          </a:xfrm>
          <a:prstGeom prst="rect">
            <a:avLst/>
          </a:prstGeom>
          <a:noFill/>
        </p:spPr>
        <p:txBody>
          <a:bodyPr wrap="square" rtlCol="0">
            <a:spAutoFit/>
          </a:bodyPr>
          <a:lstStyle/>
          <a:p>
            <a:pPr algn="ctr"/>
            <a:r>
              <a:rPr lang="en-US"/>
              <a:t>1</a:t>
            </a:r>
          </a:p>
        </p:txBody>
      </p:sp>
      <p:cxnSp>
        <p:nvCxnSpPr>
          <p:cNvPr id="46" name="Straight Connector 45">
            <a:extLst>
              <a:ext uri="{FF2B5EF4-FFF2-40B4-BE49-F238E27FC236}">
                <a16:creationId xmlns:a16="http://schemas.microsoft.com/office/drawing/2014/main" id="{30FD6F98-E783-4192-95D6-23276F500B4C}"/>
              </a:ext>
            </a:extLst>
          </p:cNvPr>
          <p:cNvCxnSpPr>
            <a:cxnSpLocks/>
          </p:cNvCxnSpPr>
          <p:nvPr/>
        </p:nvCxnSpPr>
        <p:spPr>
          <a:xfrm>
            <a:off x="6047273" y="3557734"/>
            <a:ext cx="503322" cy="0"/>
          </a:xfrm>
          <a:prstGeom prst="line">
            <a:avLst/>
          </a:prstGeom>
        </p:spPr>
        <p:style>
          <a:lnRef idx="1">
            <a:schemeClr val="accent1"/>
          </a:lnRef>
          <a:fillRef idx="0">
            <a:schemeClr val="accent1"/>
          </a:fillRef>
          <a:effectRef idx="0">
            <a:schemeClr val="accent1"/>
          </a:effectRef>
          <a:fontRef idx="minor">
            <a:schemeClr val="tx1"/>
          </a:fontRef>
        </p:style>
      </p:cxnSp>
      <p:sp>
        <p:nvSpPr>
          <p:cNvPr id="47" name="TextBox 46">
            <a:extLst>
              <a:ext uri="{FF2B5EF4-FFF2-40B4-BE49-F238E27FC236}">
                <a16:creationId xmlns:a16="http://schemas.microsoft.com/office/drawing/2014/main" id="{E3DEFAEF-72D9-467E-AEF9-8F7D76A261D0}"/>
              </a:ext>
            </a:extLst>
          </p:cNvPr>
          <p:cNvSpPr txBox="1"/>
          <p:nvPr/>
        </p:nvSpPr>
        <p:spPr>
          <a:xfrm>
            <a:off x="6651203" y="3214713"/>
            <a:ext cx="301686" cy="369332"/>
          </a:xfrm>
          <a:prstGeom prst="rect">
            <a:avLst/>
          </a:prstGeom>
          <a:noFill/>
        </p:spPr>
        <p:txBody>
          <a:bodyPr wrap="square" rtlCol="0">
            <a:spAutoFit/>
          </a:bodyPr>
          <a:lstStyle/>
          <a:p>
            <a:pPr algn="ctr"/>
            <a:r>
              <a:rPr lang="en-US"/>
              <a:t>1</a:t>
            </a:r>
          </a:p>
        </p:txBody>
      </p:sp>
      <p:cxnSp>
        <p:nvCxnSpPr>
          <p:cNvPr id="48" name="Straight Connector 47">
            <a:extLst>
              <a:ext uri="{FF2B5EF4-FFF2-40B4-BE49-F238E27FC236}">
                <a16:creationId xmlns:a16="http://schemas.microsoft.com/office/drawing/2014/main" id="{8AEF4F75-BC9D-48AC-9DAC-C63AC7E1450B}"/>
              </a:ext>
            </a:extLst>
          </p:cNvPr>
          <p:cNvCxnSpPr>
            <a:cxnSpLocks/>
          </p:cNvCxnSpPr>
          <p:nvPr/>
        </p:nvCxnSpPr>
        <p:spPr>
          <a:xfrm>
            <a:off x="6550385" y="3557734"/>
            <a:ext cx="503322" cy="0"/>
          </a:xfrm>
          <a:prstGeom prst="line">
            <a:avLst/>
          </a:prstGeom>
        </p:spPr>
        <p:style>
          <a:lnRef idx="1">
            <a:schemeClr val="accent1"/>
          </a:lnRef>
          <a:fillRef idx="0">
            <a:schemeClr val="accent1"/>
          </a:fillRef>
          <a:effectRef idx="0">
            <a:schemeClr val="accent1"/>
          </a:effectRef>
          <a:fontRef idx="minor">
            <a:schemeClr val="tx1"/>
          </a:fontRef>
        </p:style>
      </p:cxnSp>
      <p:sp>
        <p:nvSpPr>
          <p:cNvPr id="49" name="TextBox 48">
            <a:extLst>
              <a:ext uri="{FF2B5EF4-FFF2-40B4-BE49-F238E27FC236}">
                <a16:creationId xmlns:a16="http://schemas.microsoft.com/office/drawing/2014/main" id="{19AFFEFF-5E7C-45FD-AFFA-D5744EDE5B92}"/>
              </a:ext>
            </a:extLst>
          </p:cNvPr>
          <p:cNvSpPr txBox="1"/>
          <p:nvPr/>
        </p:nvSpPr>
        <p:spPr>
          <a:xfrm>
            <a:off x="3359234" y="5486060"/>
            <a:ext cx="5684569" cy="584775"/>
          </a:xfrm>
          <a:prstGeom prst="rect">
            <a:avLst/>
          </a:prstGeom>
          <a:noFill/>
        </p:spPr>
        <p:txBody>
          <a:bodyPr wrap="none" rtlCol="0">
            <a:spAutoFit/>
          </a:bodyPr>
          <a:lstStyle/>
          <a:p>
            <a:pPr algn="ctr"/>
            <a:r>
              <a:rPr lang="en-US" sz="3200">
                <a:solidFill>
                  <a:srgbClr val="00B050"/>
                </a:solidFill>
              </a:rPr>
              <a:t>Intervals = [4, 5, 1, 1, 1, 4] sec</a:t>
            </a:r>
          </a:p>
        </p:txBody>
      </p:sp>
    </p:spTree>
    <p:extLst>
      <p:ext uri="{BB962C8B-B14F-4D97-AF65-F5344CB8AC3E}">
        <p14:creationId xmlns:p14="http://schemas.microsoft.com/office/powerpoint/2010/main" val="27209304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08DB6-BD44-4401-A786-2D06627D7C16}"/>
              </a:ext>
            </a:extLst>
          </p:cNvPr>
          <p:cNvSpPr>
            <a:spLocks noGrp="1"/>
          </p:cNvSpPr>
          <p:nvPr>
            <p:ph type="title"/>
          </p:nvPr>
        </p:nvSpPr>
        <p:spPr>
          <a:xfrm>
            <a:off x="838200" y="1"/>
            <a:ext cx="10515600" cy="2030922"/>
          </a:xfrm>
        </p:spPr>
        <p:txBody>
          <a:bodyPr>
            <a:noAutofit/>
          </a:bodyPr>
          <a:lstStyle/>
          <a:p>
            <a:r>
              <a:rPr lang="en-US" sz="3600" b="1">
                <a:solidFill>
                  <a:srgbClr val="7030A0"/>
                </a:solidFill>
              </a:rPr>
              <a:t>Burst Window (BW): </a:t>
            </a:r>
            <a:r>
              <a:rPr lang="en-US" sz="3600"/>
              <a:t>An interval of time used to determine if adjacent spikes belong to a burst. To be part of a burst, interval between spikes must be </a:t>
            </a:r>
            <a:r>
              <a:rPr lang="en-US" sz="3600" i="1"/>
              <a:t>less than the burst window</a:t>
            </a:r>
            <a:endParaRPr lang="en-US" sz="3600"/>
          </a:p>
        </p:txBody>
      </p:sp>
      <p:cxnSp>
        <p:nvCxnSpPr>
          <p:cNvPr id="4" name="Straight Connector 3">
            <a:extLst>
              <a:ext uri="{FF2B5EF4-FFF2-40B4-BE49-F238E27FC236}">
                <a16:creationId xmlns:a16="http://schemas.microsoft.com/office/drawing/2014/main" id="{BBA85397-CC20-4B9B-9F65-005390E6F737}"/>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5E6CC999-542D-450B-9072-1D8886BE890D}"/>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08F7E712-5429-455C-9EFB-D74CDF210A04}"/>
              </a:ext>
            </a:extLst>
          </p:cNvPr>
          <p:cNvCxnSpPr>
            <a:cxnSpLocks/>
          </p:cNvCxnSpPr>
          <p:nvPr/>
        </p:nvCxnSpPr>
        <p:spPr>
          <a:xfrm>
            <a:off x="5541943"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F9A5C009-1910-496B-A7C1-1822970F0A54}"/>
              </a:ext>
            </a:extLst>
          </p:cNvPr>
          <p:cNvCxnSpPr>
            <a:cxnSpLocks/>
          </p:cNvCxnSpPr>
          <p:nvPr/>
        </p:nvCxnSpPr>
        <p:spPr>
          <a:xfrm>
            <a:off x="6045056"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B66BFC10-08DE-48B5-B23A-6F183F082A13}"/>
              </a:ext>
            </a:extLst>
          </p:cNvPr>
          <p:cNvCxnSpPr>
            <a:cxnSpLocks/>
          </p:cNvCxnSpPr>
          <p:nvPr/>
        </p:nvCxnSpPr>
        <p:spPr>
          <a:xfrm>
            <a:off x="6548169"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743E1477-59EB-44BF-9DB3-3C6A7A8C082D}"/>
              </a:ext>
            </a:extLst>
          </p:cNvPr>
          <p:cNvCxnSpPr>
            <a:cxnSpLocks/>
          </p:cNvCxnSpPr>
          <p:nvPr/>
        </p:nvCxnSpPr>
        <p:spPr>
          <a:xfrm>
            <a:off x="7051282"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11323809-9FDA-4F29-A82C-AA0FBACD5790}"/>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D5399204-A56F-4E35-BB37-F8A94BFDACEF}"/>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73C8D4CF-6D74-4517-B89F-A634F8F06F8C}"/>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3" name="TextBox 12">
            <a:extLst>
              <a:ext uri="{FF2B5EF4-FFF2-40B4-BE49-F238E27FC236}">
                <a16:creationId xmlns:a16="http://schemas.microsoft.com/office/drawing/2014/main" id="{063F1761-4EAD-40E2-BD14-2EEF411621C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4" name="TextBox 13">
            <a:extLst>
              <a:ext uri="{FF2B5EF4-FFF2-40B4-BE49-F238E27FC236}">
                <a16:creationId xmlns:a16="http://schemas.microsoft.com/office/drawing/2014/main" id="{A5B98651-E29F-4D49-A6FB-A631BA5B4E18}"/>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5" name="TextBox 14">
            <a:extLst>
              <a:ext uri="{FF2B5EF4-FFF2-40B4-BE49-F238E27FC236}">
                <a16:creationId xmlns:a16="http://schemas.microsoft.com/office/drawing/2014/main" id="{57DBFBDB-A607-41CD-A042-30EBF2F22D7C}"/>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16" name="TextBox 15">
            <a:extLst>
              <a:ext uri="{FF2B5EF4-FFF2-40B4-BE49-F238E27FC236}">
                <a16:creationId xmlns:a16="http://schemas.microsoft.com/office/drawing/2014/main" id="{EAFA46F0-1EAD-492B-B17F-9B66C38F660F}"/>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17" name="TextBox 16">
            <a:extLst>
              <a:ext uri="{FF2B5EF4-FFF2-40B4-BE49-F238E27FC236}">
                <a16:creationId xmlns:a16="http://schemas.microsoft.com/office/drawing/2014/main" id="{7F8CDF7A-FDF6-4DE7-B305-464F6C52B7B9}"/>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8" name="TextBox 17">
            <a:extLst>
              <a:ext uri="{FF2B5EF4-FFF2-40B4-BE49-F238E27FC236}">
                <a16:creationId xmlns:a16="http://schemas.microsoft.com/office/drawing/2014/main" id="{9F1C46BE-7900-4262-90C3-0471B29061A4}"/>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9" name="TextBox 18">
            <a:extLst>
              <a:ext uri="{FF2B5EF4-FFF2-40B4-BE49-F238E27FC236}">
                <a16:creationId xmlns:a16="http://schemas.microsoft.com/office/drawing/2014/main" id="{B99D2179-B280-439D-A35B-B12D4C34FF11}"/>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20" name="TextBox 19">
            <a:extLst>
              <a:ext uri="{FF2B5EF4-FFF2-40B4-BE49-F238E27FC236}">
                <a16:creationId xmlns:a16="http://schemas.microsoft.com/office/drawing/2014/main" id="{9F438B38-4B5B-42F2-BCB7-6941DD03CAFF}"/>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21" name="TextBox 20">
            <a:extLst>
              <a:ext uri="{FF2B5EF4-FFF2-40B4-BE49-F238E27FC236}">
                <a16:creationId xmlns:a16="http://schemas.microsoft.com/office/drawing/2014/main" id="{71718F80-5BB8-4AEB-8504-9A2D9A1E5D77}"/>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22" name="TextBox 21">
            <a:extLst>
              <a:ext uri="{FF2B5EF4-FFF2-40B4-BE49-F238E27FC236}">
                <a16:creationId xmlns:a16="http://schemas.microsoft.com/office/drawing/2014/main" id="{586FD3E3-E337-4357-B28A-016395D6231A}"/>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23" name="TextBox 22">
            <a:extLst>
              <a:ext uri="{FF2B5EF4-FFF2-40B4-BE49-F238E27FC236}">
                <a16:creationId xmlns:a16="http://schemas.microsoft.com/office/drawing/2014/main" id="{68CC3645-D8F4-4A75-9408-E695E3B04050}"/>
              </a:ext>
            </a:extLst>
          </p:cNvPr>
          <p:cNvSpPr txBox="1"/>
          <p:nvPr/>
        </p:nvSpPr>
        <p:spPr>
          <a:xfrm>
            <a:off x="639171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24" name="TextBox 23">
            <a:extLst>
              <a:ext uri="{FF2B5EF4-FFF2-40B4-BE49-F238E27FC236}">
                <a16:creationId xmlns:a16="http://schemas.microsoft.com/office/drawing/2014/main" id="{EE8F42A6-71D2-4541-9238-A6F22A7FC8B1}"/>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25" name="TextBox 24">
            <a:extLst>
              <a:ext uri="{FF2B5EF4-FFF2-40B4-BE49-F238E27FC236}">
                <a16:creationId xmlns:a16="http://schemas.microsoft.com/office/drawing/2014/main" id="{F07C037D-791F-459D-B32F-24ECE9031F63}"/>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26" name="TextBox 25">
            <a:extLst>
              <a:ext uri="{FF2B5EF4-FFF2-40B4-BE49-F238E27FC236}">
                <a16:creationId xmlns:a16="http://schemas.microsoft.com/office/drawing/2014/main" id="{3BA4ED5A-514F-48A9-9EF8-6AA68AF802A4}"/>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27" name="TextBox 26">
            <a:extLst>
              <a:ext uri="{FF2B5EF4-FFF2-40B4-BE49-F238E27FC236}">
                <a16:creationId xmlns:a16="http://schemas.microsoft.com/office/drawing/2014/main" id="{F8458700-1DEE-45E7-8814-E563D7CB3D9A}"/>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29" name="Left Bracket 28">
            <a:extLst>
              <a:ext uri="{FF2B5EF4-FFF2-40B4-BE49-F238E27FC236}">
                <a16:creationId xmlns:a16="http://schemas.microsoft.com/office/drawing/2014/main" id="{460264DC-D798-4A2C-AFEE-E3EAC89381C0}"/>
              </a:ext>
            </a:extLst>
          </p:cNvPr>
          <p:cNvSpPr/>
          <p:nvPr/>
        </p:nvSpPr>
        <p:spPr>
          <a:xfrm rot="16200000">
            <a:off x="2353149" y="4487977"/>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30" name="Left Bracket 29">
            <a:extLst>
              <a:ext uri="{FF2B5EF4-FFF2-40B4-BE49-F238E27FC236}">
                <a16:creationId xmlns:a16="http://schemas.microsoft.com/office/drawing/2014/main" id="{5F69EB05-D6FB-49F7-9D4F-2321ED99160C}"/>
              </a:ext>
            </a:extLst>
          </p:cNvPr>
          <p:cNvSpPr/>
          <p:nvPr/>
        </p:nvSpPr>
        <p:spPr>
          <a:xfrm rot="16200000">
            <a:off x="4868714" y="4487976"/>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31" name="Left Bracket 30">
            <a:extLst>
              <a:ext uri="{FF2B5EF4-FFF2-40B4-BE49-F238E27FC236}">
                <a16:creationId xmlns:a16="http://schemas.microsoft.com/office/drawing/2014/main" id="{62926CC4-7085-4A05-A78E-4E92A3FEC177}"/>
              </a:ext>
            </a:extLst>
          </p:cNvPr>
          <p:cNvSpPr/>
          <p:nvPr/>
        </p:nvSpPr>
        <p:spPr>
          <a:xfrm rot="16200000">
            <a:off x="5371827" y="4951272"/>
            <a:ext cx="340231" cy="1006227"/>
          </a:xfrm>
          <a:prstGeom prst="leftBracket">
            <a:avLst/>
          </a:prstGeom>
          <a:ln w="28575">
            <a:solidFill>
              <a:schemeClr val="accent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32" name="Left Bracket 31">
            <a:extLst>
              <a:ext uri="{FF2B5EF4-FFF2-40B4-BE49-F238E27FC236}">
                <a16:creationId xmlns:a16="http://schemas.microsoft.com/office/drawing/2014/main" id="{6F6AAB42-47DD-4055-A07F-E14D264F1462}"/>
              </a:ext>
            </a:extLst>
          </p:cNvPr>
          <p:cNvSpPr/>
          <p:nvPr/>
        </p:nvSpPr>
        <p:spPr>
          <a:xfrm rot="16200000">
            <a:off x="5874939" y="5418779"/>
            <a:ext cx="340231" cy="1006227"/>
          </a:xfrm>
          <a:prstGeom prst="leftBracket">
            <a:avLst/>
          </a:prstGeom>
          <a:ln w="28575">
            <a:solidFill>
              <a:schemeClr val="accent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33" name="Left Bracket 32">
            <a:extLst>
              <a:ext uri="{FF2B5EF4-FFF2-40B4-BE49-F238E27FC236}">
                <a16:creationId xmlns:a16="http://schemas.microsoft.com/office/drawing/2014/main" id="{EC002835-4BE6-41E5-9F95-6A4615E6F746}"/>
              </a:ext>
            </a:extLst>
          </p:cNvPr>
          <p:cNvSpPr/>
          <p:nvPr/>
        </p:nvSpPr>
        <p:spPr>
          <a:xfrm rot="16200000">
            <a:off x="6378052" y="5886285"/>
            <a:ext cx="340231" cy="1006227"/>
          </a:xfrm>
          <a:prstGeom prst="leftBracket">
            <a:avLst/>
          </a:prstGeom>
          <a:ln w="28575">
            <a:solidFill>
              <a:schemeClr val="accent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34" name="Left Bracket 33">
            <a:extLst>
              <a:ext uri="{FF2B5EF4-FFF2-40B4-BE49-F238E27FC236}">
                <a16:creationId xmlns:a16="http://schemas.microsoft.com/office/drawing/2014/main" id="{85F64347-BE6B-4136-8D58-30B1BC5DCA5B}"/>
              </a:ext>
            </a:extLst>
          </p:cNvPr>
          <p:cNvSpPr/>
          <p:nvPr/>
        </p:nvSpPr>
        <p:spPr>
          <a:xfrm rot="16200000">
            <a:off x="8390504" y="4487976"/>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35" name="Left Bracket 34">
            <a:extLst>
              <a:ext uri="{FF2B5EF4-FFF2-40B4-BE49-F238E27FC236}">
                <a16:creationId xmlns:a16="http://schemas.microsoft.com/office/drawing/2014/main" id="{E102B067-510D-489C-B457-AB574C74135A}"/>
              </a:ext>
            </a:extLst>
          </p:cNvPr>
          <p:cNvSpPr/>
          <p:nvPr/>
        </p:nvSpPr>
        <p:spPr>
          <a:xfrm rot="16200000">
            <a:off x="9396731" y="4487975"/>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Tree>
    <p:extLst>
      <p:ext uri="{BB962C8B-B14F-4D97-AF65-F5344CB8AC3E}">
        <p14:creationId xmlns:p14="http://schemas.microsoft.com/office/powerpoint/2010/main" val="32910219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 name="Title 1">
            <a:extLst>
              <a:ext uri="{FF2B5EF4-FFF2-40B4-BE49-F238E27FC236}">
                <a16:creationId xmlns:a16="http://schemas.microsoft.com/office/drawing/2014/main" id="{BB4E3879-0FC6-44D6-9281-34F2B554E57F}"/>
              </a:ext>
            </a:extLst>
          </p:cNvPr>
          <p:cNvSpPr txBox="1">
            <a:spLocks/>
          </p:cNvSpPr>
          <p:nvPr/>
        </p:nvSpPr>
        <p:spPr>
          <a:xfrm>
            <a:off x="838200" y="1"/>
            <a:ext cx="10515600" cy="203092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Arial" panose="020B0604020202020204" pitchFamily="34" charset="0"/>
                <a:ea typeface="+mj-ea"/>
                <a:cs typeface="Arial" panose="020B0604020202020204" pitchFamily="34" charset="0"/>
              </a:defRPr>
            </a:lvl1pPr>
          </a:lstStyle>
          <a:p>
            <a:r>
              <a:rPr lang="en-US" sz="3600" b="1">
                <a:solidFill>
                  <a:srgbClr val="7030A0"/>
                </a:solidFill>
              </a:rPr>
              <a:t>Single Spike (SS): </a:t>
            </a:r>
            <a:r>
              <a:rPr lang="en-US" sz="3600"/>
              <a:t>a spike that occurs greater than or equal to one burst window away from other spikes</a:t>
            </a:r>
          </a:p>
        </p:txBody>
      </p:sp>
      <p:cxnSp>
        <p:nvCxnSpPr>
          <p:cNvPr id="89" name="Straight Connector 88">
            <a:extLst>
              <a:ext uri="{FF2B5EF4-FFF2-40B4-BE49-F238E27FC236}">
                <a16:creationId xmlns:a16="http://schemas.microsoft.com/office/drawing/2014/main" id="{F1CA1F62-9CC0-446B-8CFA-7D4ABA749315}"/>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93" name="Straight Connector 92">
            <a:extLst>
              <a:ext uri="{FF2B5EF4-FFF2-40B4-BE49-F238E27FC236}">
                <a16:creationId xmlns:a16="http://schemas.microsoft.com/office/drawing/2014/main" id="{D0B54FC7-EEBA-40BC-804C-3CA5B445C848}"/>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Straight Connector 93">
            <a:extLst>
              <a:ext uri="{FF2B5EF4-FFF2-40B4-BE49-F238E27FC236}">
                <a16:creationId xmlns:a16="http://schemas.microsoft.com/office/drawing/2014/main" id="{E77D42AC-20F1-469E-BF14-08C409B3958B}"/>
              </a:ext>
            </a:extLst>
          </p:cNvPr>
          <p:cNvCxnSpPr>
            <a:cxnSpLocks/>
          </p:cNvCxnSpPr>
          <p:nvPr/>
        </p:nvCxnSpPr>
        <p:spPr>
          <a:xfrm>
            <a:off x="5541943"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a:extLst>
              <a:ext uri="{FF2B5EF4-FFF2-40B4-BE49-F238E27FC236}">
                <a16:creationId xmlns:a16="http://schemas.microsoft.com/office/drawing/2014/main" id="{2EE8C43C-ACC0-4AC9-9ED9-B510BE28325F}"/>
              </a:ext>
            </a:extLst>
          </p:cNvPr>
          <p:cNvCxnSpPr>
            <a:cxnSpLocks/>
          </p:cNvCxnSpPr>
          <p:nvPr/>
        </p:nvCxnSpPr>
        <p:spPr>
          <a:xfrm>
            <a:off x="6045056"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6" name="Straight Connector 95">
            <a:extLst>
              <a:ext uri="{FF2B5EF4-FFF2-40B4-BE49-F238E27FC236}">
                <a16:creationId xmlns:a16="http://schemas.microsoft.com/office/drawing/2014/main" id="{1511E6E6-1801-4540-A3F1-087A8977783B}"/>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E2B71858-9999-4525-8339-40A11A9813DD}"/>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BAB6D309-C79A-49D0-86ED-3F10DFC4914D}"/>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79DF21AE-5A0B-465F-A269-5F63902B25B1}"/>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00" name="TextBox 99">
            <a:extLst>
              <a:ext uri="{FF2B5EF4-FFF2-40B4-BE49-F238E27FC236}">
                <a16:creationId xmlns:a16="http://schemas.microsoft.com/office/drawing/2014/main" id="{F7C63CFD-6F3C-4497-A161-C8C2A35BEAB6}"/>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01" name="TextBox 100">
            <a:extLst>
              <a:ext uri="{FF2B5EF4-FFF2-40B4-BE49-F238E27FC236}">
                <a16:creationId xmlns:a16="http://schemas.microsoft.com/office/drawing/2014/main" id="{8533531F-E707-414E-9F62-0D42DD0AE196}"/>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02" name="TextBox 101">
            <a:extLst>
              <a:ext uri="{FF2B5EF4-FFF2-40B4-BE49-F238E27FC236}">
                <a16:creationId xmlns:a16="http://schemas.microsoft.com/office/drawing/2014/main" id="{17D3EE3D-30F2-4F4E-9479-B7B07613D0DD}"/>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03" name="TextBox 102">
            <a:extLst>
              <a:ext uri="{FF2B5EF4-FFF2-40B4-BE49-F238E27FC236}">
                <a16:creationId xmlns:a16="http://schemas.microsoft.com/office/drawing/2014/main" id="{ECAB6853-190F-40D0-B12A-3ED6E2B842D1}"/>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104" name="TextBox 103">
            <a:extLst>
              <a:ext uri="{FF2B5EF4-FFF2-40B4-BE49-F238E27FC236}">
                <a16:creationId xmlns:a16="http://schemas.microsoft.com/office/drawing/2014/main" id="{F96DFD88-3C62-484D-ABC5-278AAAEB2120}"/>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105" name="TextBox 104">
            <a:extLst>
              <a:ext uri="{FF2B5EF4-FFF2-40B4-BE49-F238E27FC236}">
                <a16:creationId xmlns:a16="http://schemas.microsoft.com/office/drawing/2014/main" id="{55312436-4C84-4285-BD83-B4549DC5011C}"/>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06" name="TextBox 105">
            <a:extLst>
              <a:ext uri="{FF2B5EF4-FFF2-40B4-BE49-F238E27FC236}">
                <a16:creationId xmlns:a16="http://schemas.microsoft.com/office/drawing/2014/main" id="{E1D59F61-E777-4556-8C3B-554F17BBE2F7}"/>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07" name="TextBox 106">
            <a:extLst>
              <a:ext uri="{FF2B5EF4-FFF2-40B4-BE49-F238E27FC236}">
                <a16:creationId xmlns:a16="http://schemas.microsoft.com/office/drawing/2014/main" id="{C2AF3D33-AE29-4500-BCF9-23E8B35AEF86}"/>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108" name="TextBox 107">
            <a:extLst>
              <a:ext uri="{FF2B5EF4-FFF2-40B4-BE49-F238E27FC236}">
                <a16:creationId xmlns:a16="http://schemas.microsoft.com/office/drawing/2014/main" id="{C3FFF894-B0EE-44CA-9812-23F19D0CADCD}"/>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09" name="TextBox 108">
            <a:extLst>
              <a:ext uri="{FF2B5EF4-FFF2-40B4-BE49-F238E27FC236}">
                <a16:creationId xmlns:a16="http://schemas.microsoft.com/office/drawing/2014/main" id="{F2133619-6BC7-4D14-BBF6-9C527225449B}"/>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10" name="TextBox 109">
            <a:extLst>
              <a:ext uri="{FF2B5EF4-FFF2-40B4-BE49-F238E27FC236}">
                <a16:creationId xmlns:a16="http://schemas.microsoft.com/office/drawing/2014/main" id="{D1E209EC-6E4B-4F53-B157-9812C8112C59}"/>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111" name="TextBox 110">
            <a:extLst>
              <a:ext uri="{FF2B5EF4-FFF2-40B4-BE49-F238E27FC236}">
                <a16:creationId xmlns:a16="http://schemas.microsoft.com/office/drawing/2014/main" id="{85C0B8E8-3301-4EA9-A9E1-44D6F7DBB0A7}"/>
              </a:ext>
            </a:extLst>
          </p:cNvPr>
          <p:cNvSpPr txBox="1"/>
          <p:nvPr/>
        </p:nvSpPr>
        <p:spPr>
          <a:xfrm>
            <a:off x="639171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112" name="TextBox 111">
            <a:extLst>
              <a:ext uri="{FF2B5EF4-FFF2-40B4-BE49-F238E27FC236}">
                <a16:creationId xmlns:a16="http://schemas.microsoft.com/office/drawing/2014/main" id="{29DE2990-787E-4AFB-A377-F7DABC033D8A}"/>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13" name="TextBox 112">
            <a:extLst>
              <a:ext uri="{FF2B5EF4-FFF2-40B4-BE49-F238E27FC236}">
                <a16:creationId xmlns:a16="http://schemas.microsoft.com/office/drawing/2014/main" id="{5CFC9CB7-DBEF-4F3B-8C4E-DEF1845D67CA}"/>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14" name="TextBox 113">
            <a:extLst>
              <a:ext uri="{FF2B5EF4-FFF2-40B4-BE49-F238E27FC236}">
                <a16:creationId xmlns:a16="http://schemas.microsoft.com/office/drawing/2014/main" id="{527CC835-E821-417A-ADAD-4F4CEC88143D}"/>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15" name="TextBox 114">
            <a:extLst>
              <a:ext uri="{FF2B5EF4-FFF2-40B4-BE49-F238E27FC236}">
                <a16:creationId xmlns:a16="http://schemas.microsoft.com/office/drawing/2014/main" id="{CEE92A8F-9132-42B8-AC29-2575C1FA4ADD}"/>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116" name="Left Bracket 115">
            <a:extLst>
              <a:ext uri="{FF2B5EF4-FFF2-40B4-BE49-F238E27FC236}">
                <a16:creationId xmlns:a16="http://schemas.microsoft.com/office/drawing/2014/main" id="{31DB79EB-3534-454B-BA2C-FAE2AED5E1B8}"/>
              </a:ext>
            </a:extLst>
          </p:cNvPr>
          <p:cNvSpPr/>
          <p:nvPr/>
        </p:nvSpPr>
        <p:spPr>
          <a:xfrm rot="16200000">
            <a:off x="2353149" y="4487977"/>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17" name="Left Bracket 116">
            <a:extLst>
              <a:ext uri="{FF2B5EF4-FFF2-40B4-BE49-F238E27FC236}">
                <a16:creationId xmlns:a16="http://schemas.microsoft.com/office/drawing/2014/main" id="{C6B844AB-FBB7-489A-8B03-02C124CC1765}"/>
              </a:ext>
            </a:extLst>
          </p:cNvPr>
          <p:cNvSpPr/>
          <p:nvPr/>
        </p:nvSpPr>
        <p:spPr>
          <a:xfrm rot="16200000">
            <a:off x="4868714" y="4487976"/>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18" name="Left Bracket 117">
            <a:extLst>
              <a:ext uri="{FF2B5EF4-FFF2-40B4-BE49-F238E27FC236}">
                <a16:creationId xmlns:a16="http://schemas.microsoft.com/office/drawing/2014/main" id="{C65B8420-30E0-45E9-8D23-956814159FF4}"/>
              </a:ext>
            </a:extLst>
          </p:cNvPr>
          <p:cNvSpPr/>
          <p:nvPr/>
        </p:nvSpPr>
        <p:spPr>
          <a:xfrm rot="16200000">
            <a:off x="5371827" y="4951272"/>
            <a:ext cx="340231" cy="1006227"/>
          </a:xfrm>
          <a:prstGeom prst="leftBracket">
            <a:avLst/>
          </a:prstGeom>
          <a:ln w="28575">
            <a:solidFill>
              <a:schemeClr val="accent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19" name="Left Bracket 118">
            <a:extLst>
              <a:ext uri="{FF2B5EF4-FFF2-40B4-BE49-F238E27FC236}">
                <a16:creationId xmlns:a16="http://schemas.microsoft.com/office/drawing/2014/main" id="{F2667505-5EB7-4642-926E-B9FC998944DE}"/>
              </a:ext>
            </a:extLst>
          </p:cNvPr>
          <p:cNvSpPr/>
          <p:nvPr/>
        </p:nvSpPr>
        <p:spPr>
          <a:xfrm rot="16200000">
            <a:off x="5874939" y="5418779"/>
            <a:ext cx="340231" cy="1006227"/>
          </a:xfrm>
          <a:prstGeom prst="leftBracket">
            <a:avLst/>
          </a:prstGeom>
          <a:ln w="28575">
            <a:solidFill>
              <a:schemeClr val="accent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20" name="Left Bracket 119">
            <a:extLst>
              <a:ext uri="{FF2B5EF4-FFF2-40B4-BE49-F238E27FC236}">
                <a16:creationId xmlns:a16="http://schemas.microsoft.com/office/drawing/2014/main" id="{19AEEE25-FAE6-4E72-A2BC-C8D742A68B6C}"/>
              </a:ext>
            </a:extLst>
          </p:cNvPr>
          <p:cNvSpPr/>
          <p:nvPr/>
        </p:nvSpPr>
        <p:spPr>
          <a:xfrm rot="16200000">
            <a:off x="6378052" y="5886285"/>
            <a:ext cx="340231" cy="1006227"/>
          </a:xfrm>
          <a:prstGeom prst="leftBracket">
            <a:avLst/>
          </a:prstGeom>
          <a:ln w="28575">
            <a:solidFill>
              <a:schemeClr val="accent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21" name="Left Bracket 120">
            <a:extLst>
              <a:ext uri="{FF2B5EF4-FFF2-40B4-BE49-F238E27FC236}">
                <a16:creationId xmlns:a16="http://schemas.microsoft.com/office/drawing/2014/main" id="{D04C7047-8E8D-4B59-B8B6-0ED2580A818F}"/>
              </a:ext>
            </a:extLst>
          </p:cNvPr>
          <p:cNvSpPr/>
          <p:nvPr/>
        </p:nvSpPr>
        <p:spPr>
          <a:xfrm rot="16200000">
            <a:off x="8390504" y="4487976"/>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22" name="Left Bracket 121">
            <a:extLst>
              <a:ext uri="{FF2B5EF4-FFF2-40B4-BE49-F238E27FC236}">
                <a16:creationId xmlns:a16="http://schemas.microsoft.com/office/drawing/2014/main" id="{D8CC3A37-A5FB-4715-821A-F865EA56399F}"/>
              </a:ext>
            </a:extLst>
          </p:cNvPr>
          <p:cNvSpPr/>
          <p:nvPr/>
        </p:nvSpPr>
        <p:spPr>
          <a:xfrm rot="16200000">
            <a:off x="9396731" y="4487975"/>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grpSp>
        <p:nvGrpSpPr>
          <p:cNvPr id="9" name="Group 8">
            <a:extLst>
              <a:ext uri="{FF2B5EF4-FFF2-40B4-BE49-F238E27FC236}">
                <a16:creationId xmlns:a16="http://schemas.microsoft.com/office/drawing/2014/main" id="{1E610176-15DC-4139-B4D1-72536F927CF7}"/>
              </a:ext>
            </a:extLst>
          </p:cNvPr>
          <p:cNvGrpSpPr/>
          <p:nvPr/>
        </p:nvGrpSpPr>
        <p:grpSpPr>
          <a:xfrm>
            <a:off x="3155254" y="2214233"/>
            <a:ext cx="1045029" cy="786467"/>
            <a:chOff x="3155254" y="2214233"/>
            <a:chExt cx="1045029" cy="786467"/>
          </a:xfrm>
        </p:grpSpPr>
        <p:sp>
          <p:nvSpPr>
            <p:cNvPr id="7" name="Arrow: Down 6">
              <a:extLst>
                <a:ext uri="{FF2B5EF4-FFF2-40B4-BE49-F238E27FC236}">
                  <a16:creationId xmlns:a16="http://schemas.microsoft.com/office/drawing/2014/main" id="{6EA9918E-D204-455B-B1B5-AD8BE5C7F94E}"/>
                </a:ext>
              </a:extLst>
            </p:cNvPr>
            <p:cNvSpPr/>
            <p:nvPr/>
          </p:nvSpPr>
          <p:spPr>
            <a:xfrm rot="2877750">
              <a:off x="3284535" y="2084952"/>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08F40768-4464-4E6A-A57A-29BC241192B0}"/>
                </a:ext>
              </a:extLst>
            </p:cNvPr>
            <p:cNvSpPr txBox="1"/>
            <p:nvPr/>
          </p:nvSpPr>
          <p:spPr>
            <a:xfrm>
              <a:off x="3572523" y="2324101"/>
              <a:ext cx="396262" cy="369332"/>
            </a:xfrm>
            <a:prstGeom prst="rect">
              <a:avLst/>
            </a:prstGeom>
            <a:noFill/>
          </p:spPr>
          <p:txBody>
            <a:bodyPr wrap="none" rtlCol="0">
              <a:spAutoFit/>
            </a:bodyPr>
            <a:lstStyle/>
            <a:p>
              <a:r>
                <a:rPr lang="en-US">
                  <a:solidFill>
                    <a:schemeClr val="bg1"/>
                  </a:solidFill>
                </a:rPr>
                <a:t>SS</a:t>
              </a:r>
            </a:p>
          </p:txBody>
        </p:sp>
      </p:grpSp>
      <p:grpSp>
        <p:nvGrpSpPr>
          <p:cNvPr id="126" name="Group 125">
            <a:extLst>
              <a:ext uri="{FF2B5EF4-FFF2-40B4-BE49-F238E27FC236}">
                <a16:creationId xmlns:a16="http://schemas.microsoft.com/office/drawing/2014/main" id="{152BD2F9-00D8-474A-8FA0-2023699D1DAA}"/>
              </a:ext>
            </a:extLst>
          </p:cNvPr>
          <p:cNvGrpSpPr/>
          <p:nvPr/>
        </p:nvGrpSpPr>
        <p:grpSpPr>
          <a:xfrm>
            <a:off x="9217627" y="2214233"/>
            <a:ext cx="1045029" cy="786467"/>
            <a:chOff x="3155254" y="2214233"/>
            <a:chExt cx="1045029" cy="786467"/>
          </a:xfrm>
        </p:grpSpPr>
        <p:sp>
          <p:nvSpPr>
            <p:cNvPr id="127" name="Arrow: Down 126">
              <a:extLst>
                <a:ext uri="{FF2B5EF4-FFF2-40B4-BE49-F238E27FC236}">
                  <a16:creationId xmlns:a16="http://schemas.microsoft.com/office/drawing/2014/main" id="{2A372FE2-FB1F-4F22-8107-BEB596885820}"/>
                </a:ext>
              </a:extLst>
            </p:cNvPr>
            <p:cNvSpPr/>
            <p:nvPr/>
          </p:nvSpPr>
          <p:spPr>
            <a:xfrm rot="2877750">
              <a:off x="3284535" y="2084952"/>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28" name="TextBox 127">
              <a:extLst>
                <a:ext uri="{FF2B5EF4-FFF2-40B4-BE49-F238E27FC236}">
                  <a16:creationId xmlns:a16="http://schemas.microsoft.com/office/drawing/2014/main" id="{7BA8DCD1-79E8-4A82-9F8D-2A00437324FD}"/>
                </a:ext>
              </a:extLst>
            </p:cNvPr>
            <p:cNvSpPr txBox="1"/>
            <p:nvPr/>
          </p:nvSpPr>
          <p:spPr>
            <a:xfrm>
              <a:off x="3572523" y="2324101"/>
              <a:ext cx="396262" cy="369332"/>
            </a:xfrm>
            <a:prstGeom prst="rect">
              <a:avLst/>
            </a:prstGeom>
            <a:noFill/>
          </p:spPr>
          <p:txBody>
            <a:bodyPr wrap="none" rtlCol="0">
              <a:spAutoFit/>
            </a:bodyPr>
            <a:lstStyle/>
            <a:p>
              <a:r>
                <a:rPr lang="en-US">
                  <a:solidFill>
                    <a:schemeClr val="bg1"/>
                  </a:solidFill>
                </a:rPr>
                <a:t>SS</a:t>
              </a:r>
            </a:p>
          </p:txBody>
        </p:sp>
      </p:grpSp>
      <p:sp>
        <p:nvSpPr>
          <p:cNvPr id="129" name="TextBox 128">
            <a:extLst>
              <a:ext uri="{FF2B5EF4-FFF2-40B4-BE49-F238E27FC236}">
                <a16:creationId xmlns:a16="http://schemas.microsoft.com/office/drawing/2014/main" id="{782A5252-365E-462A-8DD6-182C096E374F}"/>
              </a:ext>
            </a:extLst>
          </p:cNvPr>
          <p:cNvSpPr txBox="1"/>
          <p:nvPr/>
        </p:nvSpPr>
        <p:spPr>
          <a:xfrm>
            <a:off x="7319519" y="6165381"/>
            <a:ext cx="4053482" cy="584775"/>
          </a:xfrm>
          <a:prstGeom prst="rect">
            <a:avLst/>
          </a:prstGeom>
          <a:noFill/>
        </p:spPr>
        <p:txBody>
          <a:bodyPr wrap="none" rtlCol="0">
            <a:spAutoFit/>
          </a:bodyPr>
          <a:lstStyle/>
          <a:p>
            <a:pPr algn="ctr"/>
            <a:r>
              <a:rPr lang="en-US" sz="3200" err="1">
                <a:solidFill>
                  <a:srgbClr val="00B050"/>
                </a:solidFill>
              </a:rPr>
              <a:t>ssTimes</a:t>
            </a:r>
            <a:r>
              <a:rPr lang="en-US" sz="3200">
                <a:solidFill>
                  <a:srgbClr val="00B050"/>
                </a:solidFill>
              </a:rPr>
              <a:t> = [4, 16] sec</a:t>
            </a:r>
          </a:p>
        </p:txBody>
      </p:sp>
      <p:sp>
        <p:nvSpPr>
          <p:cNvPr id="130" name="TextBox 129">
            <a:extLst>
              <a:ext uri="{FF2B5EF4-FFF2-40B4-BE49-F238E27FC236}">
                <a16:creationId xmlns:a16="http://schemas.microsoft.com/office/drawing/2014/main" id="{2F185FD7-5138-4E13-B72C-0213714C5EE0}"/>
              </a:ext>
            </a:extLst>
          </p:cNvPr>
          <p:cNvSpPr txBox="1"/>
          <p:nvPr/>
        </p:nvSpPr>
        <p:spPr>
          <a:xfrm>
            <a:off x="2269578" y="6164524"/>
            <a:ext cx="3113353" cy="584775"/>
          </a:xfrm>
          <a:prstGeom prst="rect">
            <a:avLst/>
          </a:prstGeom>
          <a:noFill/>
        </p:spPr>
        <p:txBody>
          <a:bodyPr wrap="none" rtlCol="0">
            <a:spAutoFit/>
          </a:bodyPr>
          <a:lstStyle/>
          <a:p>
            <a:pPr algn="ctr"/>
            <a:r>
              <a:rPr lang="en-US" sz="3200" err="1">
                <a:solidFill>
                  <a:srgbClr val="00B050"/>
                </a:solidFill>
              </a:rPr>
              <a:t>ssPoints</a:t>
            </a:r>
            <a:r>
              <a:rPr lang="en-US" sz="3200">
                <a:solidFill>
                  <a:srgbClr val="00B050"/>
                </a:solidFill>
              </a:rPr>
              <a:t> = [0, 5]</a:t>
            </a:r>
          </a:p>
        </p:txBody>
      </p:sp>
    </p:spTree>
    <p:extLst>
      <p:ext uri="{BB962C8B-B14F-4D97-AF65-F5344CB8AC3E}">
        <p14:creationId xmlns:p14="http://schemas.microsoft.com/office/powerpoint/2010/main" val="43945453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 name="Title 1">
            <a:extLst>
              <a:ext uri="{FF2B5EF4-FFF2-40B4-BE49-F238E27FC236}">
                <a16:creationId xmlns:a16="http://schemas.microsoft.com/office/drawing/2014/main" id="{BB4E3879-0FC6-44D6-9281-34F2B554E57F}"/>
              </a:ext>
            </a:extLst>
          </p:cNvPr>
          <p:cNvSpPr txBox="1">
            <a:spLocks/>
          </p:cNvSpPr>
          <p:nvPr/>
        </p:nvSpPr>
        <p:spPr>
          <a:xfrm>
            <a:off x="838200" y="1"/>
            <a:ext cx="10515600" cy="203092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Arial" panose="020B0604020202020204" pitchFamily="34" charset="0"/>
                <a:ea typeface="+mj-ea"/>
                <a:cs typeface="Arial" panose="020B0604020202020204" pitchFamily="34" charset="0"/>
              </a:defRPr>
            </a:lvl1pPr>
          </a:lstStyle>
          <a:p>
            <a:r>
              <a:rPr lang="en-US" sz="3600" b="1">
                <a:solidFill>
                  <a:srgbClr val="7030A0"/>
                </a:solidFill>
              </a:rPr>
              <a:t>Number of single spikes (</a:t>
            </a:r>
            <a:r>
              <a:rPr lang="en-US" sz="3600" b="1" err="1">
                <a:solidFill>
                  <a:srgbClr val="7030A0"/>
                </a:solidFill>
              </a:rPr>
              <a:t>nss</a:t>
            </a:r>
            <a:r>
              <a:rPr lang="en-US" sz="3600" b="1">
                <a:solidFill>
                  <a:srgbClr val="7030A0"/>
                </a:solidFill>
              </a:rPr>
              <a:t>/</a:t>
            </a:r>
            <a:r>
              <a:rPr lang="en-US" sz="3600" b="1" err="1">
                <a:solidFill>
                  <a:srgbClr val="7030A0"/>
                </a:solidFill>
              </a:rPr>
              <a:t>ssn</a:t>
            </a:r>
            <a:r>
              <a:rPr lang="en-US" sz="3600" b="1">
                <a:solidFill>
                  <a:srgbClr val="7030A0"/>
                </a:solidFill>
              </a:rPr>
              <a:t>): </a:t>
            </a:r>
            <a:r>
              <a:rPr lang="en-US" sz="3600"/>
              <a:t>The number of single spikes over the course of the recording</a:t>
            </a:r>
          </a:p>
        </p:txBody>
      </p:sp>
      <p:cxnSp>
        <p:nvCxnSpPr>
          <p:cNvPr id="89" name="Straight Connector 88">
            <a:extLst>
              <a:ext uri="{FF2B5EF4-FFF2-40B4-BE49-F238E27FC236}">
                <a16:creationId xmlns:a16="http://schemas.microsoft.com/office/drawing/2014/main" id="{F1CA1F62-9CC0-446B-8CFA-7D4ABA749315}"/>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93" name="Straight Connector 92">
            <a:extLst>
              <a:ext uri="{FF2B5EF4-FFF2-40B4-BE49-F238E27FC236}">
                <a16:creationId xmlns:a16="http://schemas.microsoft.com/office/drawing/2014/main" id="{D0B54FC7-EEBA-40BC-804C-3CA5B445C848}"/>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Straight Connector 93">
            <a:extLst>
              <a:ext uri="{FF2B5EF4-FFF2-40B4-BE49-F238E27FC236}">
                <a16:creationId xmlns:a16="http://schemas.microsoft.com/office/drawing/2014/main" id="{E77D42AC-20F1-469E-BF14-08C409B3958B}"/>
              </a:ext>
            </a:extLst>
          </p:cNvPr>
          <p:cNvCxnSpPr>
            <a:cxnSpLocks/>
          </p:cNvCxnSpPr>
          <p:nvPr/>
        </p:nvCxnSpPr>
        <p:spPr>
          <a:xfrm>
            <a:off x="5541943"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a:extLst>
              <a:ext uri="{FF2B5EF4-FFF2-40B4-BE49-F238E27FC236}">
                <a16:creationId xmlns:a16="http://schemas.microsoft.com/office/drawing/2014/main" id="{2EE8C43C-ACC0-4AC9-9ED9-B510BE28325F}"/>
              </a:ext>
            </a:extLst>
          </p:cNvPr>
          <p:cNvCxnSpPr>
            <a:cxnSpLocks/>
          </p:cNvCxnSpPr>
          <p:nvPr/>
        </p:nvCxnSpPr>
        <p:spPr>
          <a:xfrm>
            <a:off x="6045056"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6" name="Straight Connector 95">
            <a:extLst>
              <a:ext uri="{FF2B5EF4-FFF2-40B4-BE49-F238E27FC236}">
                <a16:creationId xmlns:a16="http://schemas.microsoft.com/office/drawing/2014/main" id="{1511E6E6-1801-4540-A3F1-087A8977783B}"/>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E2B71858-9999-4525-8339-40A11A9813DD}"/>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BAB6D309-C79A-49D0-86ED-3F10DFC4914D}"/>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79DF21AE-5A0B-465F-A269-5F63902B25B1}"/>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00" name="TextBox 99">
            <a:extLst>
              <a:ext uri="{FF2B5EF4-FFF2-40B4-BE49-F238E27FC236}">
                <a16:creationId xmlns:a16="http://schemas.microsoft.com/office/drawing/2014/main" id="{F7C63CFD-6F3C-4497-A161-C8C2A35BEAB6}"/>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01" name="TextBox 100">
            <a:extLst>
              <a:ext uri="{FF2B5EF4-FFF2-40B4-BE49-F238E27FC236}">
                <a16:creationId xmlns:a16="http://schemas.microsoft.com/office/drawing/2014/main" id="{8533531F-E707-414E-9F62-0D42DD0AE196}"/>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02" name="TextBox 101">
            <a:extLst>
              <a:ext uri="{FF2B5EF4-FFF2-40B4-BE49-F238E27FC236}">
                <a16:creationId xmlns:a16="http://schemas.microsoft.com/office/drawing/2014/main" id="{17D3EE3D-30F2-4F4E-9479-B7B07613D0DD}"/>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03" name="TextBox 102">
            <a:extLst>
              <a:ext uri="{FF2B5EF4-FFF2-40B4-BE49-F238E27FC236}">
                <a16:creationId xmlns:a16="http://schemas.microsoft.com/office/drawing/2014/main" id="{ECAB6853-190F-40D0-B12A-3ED6E2B842D1}"/>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104" name="TextBox 103">
            <a:extLst>
              <a:ext uri="{FF2B5EF4-FFF2-40B4-BE49-F238E27FC236}">
                <a16:creationId xmlns:a16="http://schemas.microsoft.com/office/drawing/2014/main" id="{F96DFD88-3C62-484D-ABC5-278AAAEB2120}"/>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105" name="TextBox 104">
            <a:extLst>
              <a:ext uri="{FF2B5EF4-FFF2-40B4-BE49-F238E27FC236}">
                <a16:creationId xmlns:a16="http://schemas.microsoft.com/office/drawing/2014/main" id="{55312436-4C84-4285-BD83-B4549DC5011C}"/>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06" name="TextBox 105">
            <a:extLst>
              <a:ext uri="{FF2B5EF4-FFF2-40B4-BE49-F238E27FC236}">
                <a16:creationId xmlns:a16="http://schemas.microsoft.com/office/drawing/2014/main" id="{E1D59F61-E777-4556-8C3B-554F17BBE2F7}"/>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07" name="TextBox 106">
            <a:extLst>
              <a:ext uri="{FF2B5EF4-FFF2-40B4-BE49-F238E27FC236}">
                <a16:creationId xmlns:a16="http://schemas.microsoft.com/office/drawing/2014/main" id="{C2AF3D33-AE29-4500-BCF9-23E8B35AEF86}"/>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108" name="TextBox 107">
            <a:extLst>
              <a:ext uri="{FF2B5EF4-FFF2-40B4-BE49-F238E27FC236}">
                <a16:creationId xmlns:a16="http://schemas.microsoft.com/office/drawing/2014/main" id="{C3FFF894-B0EE-44CA-9812-23F19D0CADCD}"/>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09" name="TextBox 108">
            <a:extLst>
              <a:ext uri="{FF2B5EF4-FFF2-40B4-BE49-F238E27FC236}">
                <a16:creationId xmlns:a16="http://schemas.microsoft.com/office/drawing/2014/main" id="{F2133619-6BC7-4D14-BBF6-9C527225449B}"/>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10" name="TextBox 109">
            <a:extLst>
              <a:ext uri="{FF2B5EF4-FFF2-40B4-BE49-F238E27FC236}">
                <a16:creationId xmlns:a16="http://schemas.microsoft.com/office/drawing/2014/main" id="{D1E209EC-6E4B-4F53-B157-9812C8112C59}"/>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111" name="TextBox 110">
            <a:extLst>
              <a:ext uri="{FF2B5EF4-FFF2-40B4-BE49-F238E27FC236}">
                <a16:creationId xmlns:a16="http://schemas.microsoft.com/office/drawing/2014/main" id="{85C0B8E8-3301-4EA9-A9E1-44D6F7DBB0A7}"/>
              </a:ext>
            </a:extLst>
          </p:cNvPr>
          <p:cNvSpPr txBox="1"/>
          <p:nvPr/>
        </p:nvSpPr>
        <p:spPr>
          <a:xfrm>
            <a:off x="639171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112" name="TextBox 111">
            <a:extLst>
              <a:ext uri="{FF2B5EF4-FFF2-40B4-BE49-F238E27FC236}">
                <a16:creationId xmlns:a16="http://schemas.microsoft.com/office/drawing/2014/main" id="{29DE2990-787E-4AFB-A377-F7DABC033D8A}"/>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13" name="TextBox 112">
            <a:extLst>
              <a:ext uri="{FF2B5EF4-FFF2-40B4-BE49-F238E27FC236}">
                <a16:creationId xmlns:a16="http://schemas.microsoft.com/office/drawing/2014/main" id="{5CFC9CB7-DBEF-4F3B-8C4E-DEF1845D67CA}"/>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14" name="TextBox 113">
            <a:extLst>
              <a:ext uri="{FF2B5EF4-FFF2-40B4-BE49-F238E27FC236}">
                <a16:creationId xmlns:a16="http://schemas.microsoft.com/office/drawing/2014/main" id="{527CC835-E821-417A-ADAD-4F4CEC88143D}"/>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15" name="TextBox 114">
            <a:extLst>
              <a:ext uri="{FF2B5EF4-FFF2-40B4-BE49-F238E27FC236}">
                <a16:creationId xmlns:a16="http://schemas.microsoft.com/office/drawing/2014/main" id="{CEE92A8F-9132-42B8-AC29-2575C1FA4ADD}"/>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grpSp>
        <p:nvGrpSpPr>
          <p:cNvPr id="9" name="Group 8">
            <a:extLst>
              <a:ext uri="{FF2B5EF4-FFF2-40B4-BE49-F238E27FC236}">
                <a16:creationId xmlns:a16="http://schemas.microsoft.com/office/drawing/2014/main" id="{1E610176-15DC-4139-B4D1-72536F927CF7}"/>
              </a:ext>
            </a:extLst>
          </p:cNvPr>
          <p:cNvGrpSpPr/>
          <p:nvPr/>
        </p:nvGrpSpPr>
        <p:grpSpPr>
          <a:xfrm>
            <a:off x="3155254" y="2214233"/>
            <a:ext cx="1045029" cy="786467"/>
            <a:chOff x="3155254" y="2214233"/>
            <a:chExt cx="1045029" cy="786467"/>
          </a:xfrm>
        </p:grpSpPr>
        <p:sp>
          <p:nvSpPr>
            <p:cNvPr id="7" name="Arrow: Down 6">
              <a:extLst>
                <a:ext uri="{FF2B5EF4-FFF2-40B4-BE49-F238E27FC236}">
                  <a16:creationId xmlns:a16="http://schemas.microsoft.com/office/drawing/2014/main" id="{6EA9918E-D204-455B-B1B5-AD8BE5C7F94E}"/>
                </a:ext>
              </a:extLst>
            </p:cNvPr>
            <p:cNvSpPr/>
            <p:nvPr/>
          </p:nvSpPr>
          <p:spPr>
            <a:xfrm rot="2877750">
              <a:off x="3284535" y="2084952"/>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08F40768-4464-4E6A-A57A-29BC241192B0}"/>
                </a:ext>
              </a:extLst>
            </p:cNvPr>
            <p:cNvSpPr txBox="1"/>
            <p:nvPr/>
          </p:nvSpPr>
          <p:spPr>
            <a:xfrm>
              <a:off x="3572523" y="2324101"/>
              <a:ext cx="396262" cy="369332"/>
            </a:xfrm>
            <a:prstGeom prst="rect">
              <a:avLst/>
            </a:prstGeom>
            <a:noFill/>
          </p:spPr>
          <p:txBody>
            <a:bodyPr wrap="none" rtlCol="0">
              <a:spAutoFit/>
            </a:bodyPr>
            <a:lstStyle/>
            <a:p>
              <a:r>
                <a:rPr lang="en-US">
                  <a:solidFill>
                    <a:schemeClr val="bg1"/>
                  </a:solidFill>
                </a:rPr>
                <a:t>SS</a:t>
              </a:r>
            </a:p>
          </p:txBody>
        </p:sp>
      </p:grpSp>
      <p:grpSp>
        <p:nvGrpSpPr>
          <p:cNvPr id="126" name="Group 125">
            <a:extLst>
              <a:ext uri="{FF2B5EF4-FFF2-40B4-BE49-F238E27FC236}">
                <a16:creationId xmlns:a16="http://schemas.microsoft.com/office/drawing/2014/main" id="{152BD2F9-00D8-474A-8FA0-2023699D1DAA}"/>
              </a:ext>
            </a:extLst>
          </p:cNvPr>
          <p:cNvGrpSpPr/>
          <p:nvPr/>
        </p:nvGrpSpPr>
        <p:grpSpPr>
          <a:xfrm>
            <a:off x="9217627" y="2214233"/>
            <a:ext cx="1045029" cy="786467"/>
            <a:chOff x="3155254" y="2214233"/>
            <a:chExt cx="1045029" cy="786467"/>
          </a:xfrm>
        </p:grpSpPr>
        <p:sp>
          <p:nvSpPr>
            <p:cNvPr id="127" name="Arrow: Down 126">
              <a:extLst>
                <a:ext uri="{FF2B5EF4-FFF2-40B4-BE49-F238E27FC236}">
                  <a16:creationId xmlns:a16="http://schemas.microsoft.com/office/drawing/2014/main" id="{2A372FE2-FB1F-4F22-8107-BEB596885820}"/>
                </a:ext>
              </a:extLst>
            </p:cNvPr>
            <p:cNvSpPr/>
            <p:nvPr/>
          </p:nvSpPr>
          <p:spPr>
            <a:xfrm rot="2877750">
              <a:off x="3284535" y="2084952"/>
              <a:ext cx="786467" cy="1045029"/>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28" name="TextBox 127">
              <a:extLst>
                <a:ext uri="{FF2B5EF4-FFF2-40B4-BE49-F238E27FC236}">
                  <a16:creationId xmlns:a16="http://schemas.microsoft.com/office/drawing/2014/main" id="{7BA8DCD1-79E8-4A82-9F8D-2A00437324FD}"/>
                </a:ext>
              </a:extLst>
            </p:cNvPr>
            <p:cNvSpPr txBox="1"/>
            <p:nvPr/>
          </p:nvSpPr>
          <p:spPr>
            <a:xfrm>
              <a:off x="3572523" y="2324101"/>
              <a:ext cx="396262" cy="369332"/>
            </a:xfrm>
            <a:prstGeom prst="rect">
              <a:avLst/>
            </a:prstGeom>
            <a:noFill/>
          </p:spPr>
          <p:txBody>
            <a:bodyPr wrap="none" rtlCol="0">
              <a:spAutoFit/>
            </a:bodyPr>
            <a:lstStyle/>
            <a:p>
              <a:r>
                <a:rPr lang="en-US">
                  <a:solidFill>
                    <a:schemeClr val="bg1"/>
                  </a:solidFill>
                </a:rPr>
                <a:t>SS</a:t>
              </a:r>
            </a:p>
          </p:txBody>
        </p:sp>
      </p:grpSp>
      <p:sp>
        <p:nvSpPr>
          <p:cNvPr id="129" name="TextBox 128">
            <a:extLst>
              <a:ext uri="{FF2B5EF4-FFF2-40B4-BE49-F238E27FC236}">
                <a16:creationId xmlns:a16="http://schemas.microsoft.com/office/drawing/2014/main" id="{782A5252-365E-462A-8DD6-182C096E374F}"/>
              </a:ext>
            </a:extLst>
          </p:cNvPr>
          <p:cNvSpPr txBox="1"/>
          <p:nvPr/>
        </p:nvSpPr>
        <p:spPr>
          <a:xfrm>
            <a:off x="6463463" y="4950538"/>
            <a:ext cx="4053482" cy="584775"/>
          </a:xfrm>
          <a:prstGeom prst="rect">
            <a:avLst/>
          </a:prstGeom>
          <a:noFill/>
        </p:spPr>
        <p:txBody>
          <a:bodyPr wrap="none" rtlCol="0">
            <a:spAutoFit/>
          </a:bodyPr>
          <a:lstStyle/>
          <a:p>
            <a:pPr algn="ctr"/>
            <a:r>
              <a:rPr lang="en-US" sz="3200" err="1">
                <a:solidFill>
                  <a:srgbClr val="00B050"/>
                </a:solidFill>
              </a:rPr>
              <a:t>ssTimes</a:t>
            </a:r>
            <a:r>
              <a:rPr lang="en-US" sz="3200">
                <a:solidFill>
                  <a:srgbClr val="00B050"/>
                </a:solidFill>
              </a:rPr>
              <a:t> = [4, 16] sec</a:t>
            </a:r>
          </a:p>
        </p:txBody>
      </p:sp>
      <p:sp>
        <p:nvSpPr>
          <p:cNvPr id="130" name="TextBox 129">
            <a:extLst>
              <a:ext uri="{FF2B5EF4-FFF2-40B4-BE49-F238E27FC236}">
                <a16:creationId xmlns:a16="http://schemas.microsoft.com/office/drawing/2014/main" id="{2F185FD7-5138-4E13-B72C-0213714C5EE0}"/>
              </a:ext>
            </a:extLst>
          </p:cNvPr>
          <p:cNvSpPr txBox="1"/>
          <p:nvPr/>
        </p:nvSpPr>
        <p:spPr>
          <a:xfrm>
            <a:off x="1675055" y="4922544"/>
            <a:ext cx="3113353" cy="584775"/>
          </a:xfrm>
          <a:prstGeom prst="rect">
            <a:avLst/>
          </a:prstGeom>
          <a:noFill/>
        </p:spPr>
        <p:txBody>
          <a:bodyPr wrap="none" rtlCol="0">
            <a:spAutoFit/>
          </a:bodyPr>
          <a:lstStyle/>
          <a:p>
            <a:pPr algn="ctr"/>
            <a:r>
              <a:rPr lang="en-US" sz="3200" err="1">
                <a:solidFill>
                  <a:srgbClr val="00B050"/>
                </a:solidFill>
              </a:rPr>
              <a:t>ssPoints</a:t>
            </a:r>
            <a:r>
              <a:rPr lang="en-US" sz="3200">
                <a:solidFill>
                  <a:srgbClr val="00B050"/>
                </a:solidFill>
              </a:rPr>
              <a:t> = [0, 5]</a:t>
            </a:r>
          </a:p>
        </p:txBody>
      </p:sp>
      <p:sp>
        <p:nvSpPr>
          <p:cNvPr id="42" name="TextBox 41">
            <a:extLst>
              <a:ext uri="{FF2B5EF4-FFF2-40B4-BE49-F238E27FC236}">
                <a16:creationId xmlns:a16="http://schemas.microsoft.com/office/drawing/2014/main" id="{2C29DA18-96F9-4C66-A22D-D89D1E05AFDE}"/>
              </a:ext>
            </a:extLst>
          </p:cNvPr>
          <p:cNvSpPr txBox="1"/>
          <p:nvPr/>
        </p:nvSpPr>
        <p:spPr>
          <a:xfrm>
            <a:off x="4702028" y="6067044"/>
            <a:ext cx="2787943" cy="646331"/>
          </a:xfrm>
          <a:prstGeom prst="rect">
            <a:avLst/>
          </a:prstGeom>
          <a:noFill/>
        </p:spPr>
        <p:txBody>
          <a:bodyPr wrap="none" rtlCol="0">
            <a:spAutoFit/>
          </a:bodyPr>
          <a:lstStyle/>
          <a:p>
            <a:pPr algn="ctr"/>
            <a:r>
              <a:rPr lang="en-US" sz="3600" err="1">
                <a:solidFill>
                  <a:schemeClr val="accent1"/>
                </a:solidFill>
                <a:latin typeface="Arial" panose="020B0604020202020204" pitchFamily="34" charset="0"/>
              </a:rPr>
              <a:t>nss</a:t>
            </a:r>
            <a:r>
              <a:rPr lang="en-US" sz="3600">
                <a:solidFill>
                  <a:schemeClr val="accent1"/>
                </a:solidFill>
                <a:latin typeface="Arial" panose="020B0604020202020204" pitchFamily="34" charset="0"/>
              </a:rPr>
              <a:t> / </a:t>
            </a:r>
            <a:r>
              <a:rPr lang="en-US" sz="3600" err="1">
                <a:solidFill>
                  <a:schemeClr val="accent1"/>
                </a:solidFill>
                <a:latin typeface="Arial" panose="020B0604020202020204" pitchFamily="34" charset="0"/>
              </a:rPr>
              <a:t>ssn</a:t>
            </a:r>
            <a:r>
              <a:rPr lang="en-US" sz="3600">
                <a:solidFill>
                  <a:schemeClr val="accent1"/>
                </a:solidFill>
                <a:latin typeface="Arial" panose="020B0604020202020204" pitchFamily="34" charset="0"/>
              </a:rPr>
              <a:t> = 2</a:t>
            </a:r>
            <a:endParaRPr lang="en-US" sz="3600">
              <a:solidFill>
                <a:schemeClr val="accent1"/>
              </a:solidFill>
            </a:endParaRPr>
          </a:p>
        </p:txBody>
      </p:sp>
    </p:spTree>
    <p:extLst>
      <p:ext uri="{BB962C8B-B14F-4D97-AF65-F5344CB8AC3E}">
        <p14:creationId xmlns:p14="http://schemas.microsoft.com/office/powerpoint/2010/main" val="35888466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 name="Title 1">
            <a:extLst>
              <a:ext uri="{FF2B5EF4-FFF2-40B4-BE49-F238E27FC236}">
                <a16:creationId xmlns:a16="http://schemas.microsoft.com/office/drawing/2014/main" id="{BB4E3879-0FC6-44D6-9281-34F2B554E57F}"/>
              </a:ext>
            </a:extLst>
          </p:cNvPr>
          <p:cNvSpPr txBox="1">
            <a:spLocks/>
          </p:cNvSpPr>
          <p:nvPr/>
        </p:nvSpPr>
        <p:spPr>
          <a:xfrm>
            <a:off x="838200" y="1"/>
            <a:ext cx="10515600" cy="203092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Arial" panose="020B0604020202020204" pitchFamily="34" charset="0"/>
                <a:ea typeface="+mj-ea"/>
                <a:cs typeface="Arial" panose="020B0604020202020204" pitchFamily="34" charset="0"/>
              </a:defRPr>
            </a:lvl1pPr>
          </a:lstStyle>
          <a:p>
            <a:r>
              <a:rPr lang="en-US" sz="3600" b="1">
                <a:solidFill>
                  <a:srgbClr val="7030A0"/>
                </a:solidFill>
              </a:rPr>
              <a:t>Burst: </a:t>
            </a:r>
            <a:r>
              <a:rPr lang="en-US" sz="3600"/>
              <a:t>2 or more spikes the occur within one burst window of each other</a:t>
            </a:r>
          </a:p>
        </p:txBody>
      </p:sp>
      <p:cxnSp>
        <p:nvCxnSpPr>
          <p:cNvPr id="89" name="Straight Connector 88">
            <a:extLst>
              <a:ext uri="{FF2B5EF4-FFF2-40B4-BE49-F238E27FC236}">
                <a16:creationId xmlns:a16="http://schemas.microsoft.com/office/drawing/2014/main" id="{F1CA1F62-9CC0-446B-8CFA-7D4ABA749315}"/>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93" name="Straight Connector 92">
            <a:extLst>
              <a:ext uri="{FF2B5EF4-FFF2-40B4-BE49-F238E27FC236}">
                <a16:creationId xmlns:a16="http://schemas.microsoft.com/office/drawing/2014/main" id="{D0B54FC7-EEBA-40BC-804C-3CA5B445C848}"/>
              </a:ext>
            </a:extLst>
          </p:cNvPr>
          <p:cNvCxnSpPr>
            <a:cxnSpLocks/>
          </p:cNvCxnSpPr>
          <p:nvPr/>
        </p:nvCxnSpPr>
        <p:spPr>
          <a:xfrm>
            <a:off x="3026378"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Straight Connector 93">
            <a:extLst>
              <a:ext uri="{FF2B5EF4-FFF2-40B4-BE49-F238E27FC236}">
                <a16:creationId xmlns:a16="http://schemas.microsoft.com/office/drawing/2014/main" id="{E77D42AC-20F1-469E-BF14-08C409B3958B}"/>
              </a:ext>
            </a:extLst>
          </p:cNvPr>
          <p:cNvCxnSpPr>
            <a:cxnSpLocks/>
          </p:cNvCxnSpPr>
          <p:nvPr/>
        </p:nvCxnSpPr>
        <p:spPr>
          <a:xfrm>
            <a:off x="5541943"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a:extLst>
              <a:ext uri="{FF2B5EF4-FFF2-40B4-BE49-F238E27FC236}">
                <a16:creationId xmlns:a16="http://schemas.microsoft.com/office/drawing/2014/main" id="{2EE8C43C-ACC0-4AC9-9ED9-B510BE28325F}"/>
              </a:ext>
            </a:extLst>
          </p:cNvPr>
          <p:cNvCxnSpPr>
            <a:cxnSpLocks/>
          </p:cNvCxnSpPr>
          <p:nvPr/>
        </p:nvCxnSpPr>
        <p:spPr>
          <a:xfrm>
            <a:off x="6045056"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6" name="Straight Connector 95">
            <a:extLst>
              <a:ext uri="{FF2B5EF4-FFF2-40B4-BE49-F238E27FC236}">
                <a16:creationId xmlns:a16="http://schemas.microsoft.com/office/drawing/2014/main" id="{1511E6E6-1801-4540-A3F1-087A8977783B}"/>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E2B71858-9999-4525-8339-40A11A9813DD}"/>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BAB6D309-C79A-49D0-86ED-3F10DFC4914D}"/>
              </a:ext>
            </a:extLst>
          </p:cNvPr>
          <p:cNvCxnSpPr>
            <a:cxnSpLocks/>
          </p:cNvCxnSpPr>
          <p:nvPr/>
        </p:nvCxnSpPr>
        <p:spPr>
          <a:xfrm>
            <a:off x="9063734" y="2693433"/>
            <a:ext cx="0" cy="1928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79DF21AE-5A0B-465F-A269-5F63902B25B1}"/>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00" name="TextBox 99">
            <a:extLst>
              <a:ext uri="{FF2B5EF4-FFF2-40B4-BE49-F238E27FC236}">
                <a16:creationId xmlns:a16="http://schemas.microsoft.com/office/drawing/2014/main" id="{F7C63CFD-6F3C-4497-A161-C8C2A35BEAB6}"/>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101" name="TextBox 100">
            <a:extLst>
              <a:ext uri="{FF2B5EF4-FFF2-40B4-BE49-F238E27FC236}">
                <a16:creationId xmlns:a16="http://schemas.microsoft.com/office/drawing/2014/main" id="{8533531F-E707-414E-9F62-0D42DD0AE196}"/>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102" name="TextBox 101">
            <a:extLst>
              <a:ext uri="{FF2B5EF4-FFF2-40B4-BE49-F238E27FC236}">
                <a16:creationId xmlns:a16="http://schemas.microsoft.com/office/drawing/2014/main" id="{17D3EE3D-30F2-4F4E-9479-B7B07613D0DD}"/>
              </a:ext>
            </a:extLst>
          </p:cNvPr>
          <p:cNvSpPr txBox="1"/>
          <p:nvPr/>
        </p:nvSpPr>
        <p:spPr>
          <a:xfrm>
            <a:off x="5385490"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9</a:t>
            </a:r>
          </a:p>
        </p:txBody>
      </p:sp>
      <p:sp>
        <p:nvSpPr>
          <p:cNvPr id="103" name="TextBox 102">
            <a:extLst>
              <a:ext uri="{FF2B5EF4-FFF2-40B4-BE49-F238E27FC236}">
                <a16:creationId xmlns:a16="http://schemas.microsoft.com/office/drawing/2014/main" id="{ECAB6853-190F-40D0-B12A-3ED6E2B842D1}"/>
              </a:ext>
            </a:extLst>
          </p:cNvPr>
          <p:cNvSpPr txBox="1"/>
          <p:nvPr/>
        </p:nvSpPr>
        <p:spPr>
          <a:xfrm>
            <a:off x="582448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0</a:t>
            </a:r>
          </a:p>
        </p:txBody>
      </p:sp>
      <p:sp>
        <p:nvSpPr>
          <p:cNvPr id="104" name="TextBox 103">
            <a:extLst>
              <a:ext uri="{FF2B5EF4-FFF2-40B4-BE49-F238E27FC236}">
                <a16:creationId xmlns:a16="http://schemas.microsoft.com/office/drawing/2014/main" id="{F96DFD88-3C62-484D-ABC5-278AAAEB2120}"/>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105" name="TextBox 104">
            <a:extLst>
              <a:ext uri="{FF2B5EF4-FFF2-40B4-BE49-F238E27FC236}">
                <a16:creationId xmlns:a16="http://schemas.microsoft.com/office/drawing/2014/main" id="{55312436-4C84-4285-BD83-B4549DC5011C}"/>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106" name="TextBox 105">
            <a:extLst>
              <a:ext uri="{FF2B5EF4-FFF2-40B4-BE49-F238E27FC236}">
                <a16:creationId xmlns:a16="http://schemas.microsoft.com/office/drawing/2014/main" id="{E1D59F61-E777-4556-8C3B-554F17BBE2F7}"/>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107" name="TextBox 106">
            <a:extLst>
              <a:ext uri="{FF2B5EF4-FFF2-40B4-BE49-F238E27FC236}">
                <a16:creationId xmlns:a16="http://schemas.microsoft.com/office/drawing/2014/main" id="{C2AF3D33-AE29-4500-BCF9-23E8B35AEF86}"/>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108" name="TextBox 107">
            <a:extLst>
              <a:ext uri="{FF2B5EF4-FFF2-40B4-BE49-F238E27FC236}">
                <a16:creationId xmlns:a16="http://schemas.microsoft.com/office/drawing/2014/main" id="{C3FFF894-B0EE-44CA-9812-23F19D0CADCD}"/>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109" name="TextBox 108">
            <a:extLst>
              <a:ext uri="{FF2B5EF4-FFF2-40B4-BE49-F238E27FC236}">
                <a16:creationId xmlns:a16="http://schemas.microsoft.com/office/drawing/2014/main" id="{F2133619-6BC7-4D14-BBF6-9C527225449B}"/>
              </a:ext>
            </a:extLst>
          </p:cNvPr>
          <p:cNvSpPr txBox="1"/>
          <p:nvPr/>
        </p:nvSpPr>
        <p:spPr>
          <a:xfrm>
            <a:off x="538549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110" name="TextBox 109">
            <a:extLst>
              <a:ext uri="{FF2B5EF4-FFF2-40B4-BE49-F238E27FC236}">
                <a16:creationId xmlns:a16="http://schemas.microsoft.com/office/drawing/2014/main" id="{D1E209EC-6E4B-4F53-B157-9812C8112C59}"/>
              </a:ext>
            </a:extLst>
          </p:cNvPr>
          <p:cNvSpPr txBox="1"/>
          <p:nvPr/>
        </p:nvSpPr>
        <p:spPr>
          <a:xfrm>
            <a:off x="5888603"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111" name="TextBox 110">
            <a:extLst>
              <a:ext uri="{FF2B5EF4-FFF2-40B4-BE49-F238E27FC236}">
                <a16:creationId xmlns:a16="http://schemas.microsoft.com/office/drawing/2014/main" id="{85C0B8E8-3301-4EA9-A9E1-44D6F7DBB0A7}"/>
              </a:ext>
            </a:extLst>
          </p:cNvPr>
          <p:cNvSpPr txBox="1"/>
          <p:nvPr/>
        </p:nvSpPr>
        <p:spPr>
          <a:xfrm>
            <a:off x="639171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112" name="TextBox 111">
            <a:extLst>
              <a:ext uri="{FF2B5EF4-FFF2-40B4-BE49-F238E27FC236}">
                <a16:creationId xmlns:a16="http://schemas.microsoft.com/office/drawing/2014/main" id="{29DE2990-787E-4AFB-A377-F7DABC033D8A}"/>
              </a:ext>
            </a:extLst>
          </p:cNvPr>
          <p:cNvSpPr txBox="1"/>
          <p:nvPr/>
        </p:nvSpPr>
        <p:spPr>
          <a:xfrm>
            <a:off x="689482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13" name="TextBox 112">
            <a:extLst>
              <a:ext uri="{FF2B5EF4-FFF2-40B4-BE49-F238E27FC236}">
                <a16:creationId xmlns:a16="http://schemas.microsoft.com/office/drawing/2014/main" id="{5CFC9CB7-DBEF-4F3B-8C4E-DEF1845D67CA}"/>
              </a:ext>
            </a:extLst>
          </p:cNvPr>
          <p:cNvSpPr txBox="1"/>
          <p:nvPr/>
        </p:nvSpPr>
        <p:spPr>
          <a:xfrm>
            <a:off x="8907280"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14" name="TextBox 113">
            <a:extLst>
              <a:ext uri="{FF2B5EF4-FFF2-40B4-BE49-F238E27FC236}">
                <a16:creationId xmlns:a16="http://schemas.microsoft.com/office/drawing/2014/main" id="{527CC835-E821-417A-ADAD-4F4CEC88143D}"/>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15" name="TextBox 114">
            <a:extLst>
              <a:ext uri="{FF2B5EF4-FFF2-40B4-BE49-F238E27FC236}">
                <a16:creationId xmlns:a16="http://schemas.microsoft.com/office/drawing/2014/main" id="{CEE92A8F-9132-42B8-AC29-2575C1FA4ADD}"/>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116" name="Left Bracket 115">
            <a:extLst>
              <a:ext uri="{FF2B5EF4-FFF2-40B4-BE49-F238E27FC236}">
                <a16:creationId xmlns:a16="http://schemas.microsoft.com/office/drawing/2014/main" id="{31DB79EB-3534-454B-BA2C-FAE2AED5E1B8}"/>
              </a:ext>
            </a:extLst>
          </p:cNvPr>
          <p:cNvSpPr/>
          <p:nvPr/>
        </p:nvSpPr>
        <p:spPr>
          <a:xfrm rot="16200000">
            <a:off x="2353149" y="4487977"/>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17" name="Left Bracket 116">
            <a:extLst>
              <a:ext uri="{FF2B5EF4-FFF2-40B4-BE49-F238E27FC236}">
                <a16:creationId xmlns:a16="http://schemas.microsoft.com/office/drawing/2014/main" id="{C6B844AB-FBB7-489A-8B03-02C124CC1765}"/>
              </a:ext>
            </a:extLst>
          </p:cNvPr>
          <p:cNvSpPr/>
          <p:nvPr/>
        </p:nvSpPr>
        <p:spPr>
          <a:xfrm rot="16200000">
            <a:off x="4868714" y="4487976"/>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18" name="Left Bracket 117">
            <a:extLst>
              <a:ext uri="{FF2B5EF4-FFF2-40B4-BE49-F238E27FC236}">
                <a16:creationId xmlns:a16="http://schemas.microsoft.com/office/drawing/2014/main" id="{C65B8420-30E0-45E9-8D23-956814159FF4}"/>
              </a:ext>
            </a:extLst>
          </p:cNvPr>
          <p:cNvSpPr/>
          <p:nvPr/>
        </p:nvSpPr>
        <p:spPr>
          <a:xfrm rot="16200000">
            <a:off x="5371827" y="4951272"/>
            <a:ext cx="340231" cy="1006227"/>
          </a:xfrm>
          <a:prstGeom prst="leftBracket">
            <a:avLst/>
          </a:prstGeom>
          <a:ln w="28575">
            <a:solidFill>
              <a:schemeClr val="accent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19" name="Left Bracket 118">
            <a:extLst>
              <a:ext uri="{FF2B5EF4-FFF2-40B4-BE49-F238E27FC236}">
                <a16:creationId xmlns:a16="http://schemas.microsoft.com/office/drawing/2014/main" id="{F2667505-5EB7-4642-926E-B9FC998944DE}"/>
              </a:ext>
            </a:extLst>
          </p:cNvPr>
          <p:cNvSpPr/>
          <p:nvPr/>
        </p:nvSpPr>
        <p:spPr>
          <a:xfrm rot="16200000">
            <a:off x="5874939" y="5418779"/>
            <a:ext cx="340231" cy="1006227"/>
          </a:xfrm>
          <a:prstGeom prst="leftBracket">
            <a:avLst/>
          </a:prstGeom>
          <a:ln w="28575">
            <a:solidFill>
              <a:schemeClr val="accent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20" name="Left Bracket 119">
            <a:extLst>
              <a:ext uri="{FF2B5EF4-FFF2-40B4-BE49-F238E27FC236}">
                <a16:creationId xmlns:a16="http://schemas.microsoft.com/office/drawing/2014/main" id="{19AEEE25-FAE6-4E72-A2BC-C8D742A68B6C}"/>
              </a:ext>
            </a:extLst>
          </p:cNvPr>
          <p:cNvSpPr/>
          <p:nvPr/>
        </p:nvSpPr>
        <p:spPr>
          <a:xfrm rot="16200000">
            <a:off x="6378052" y="5886285"/>
            <a:ext cx="340231" cy="1006227"/>
          </a:xfrm>
          <a:prstGeom prst="leftBracket">
            <a:avLst/>
          </a:prstGeom>
          <a:ln w="28575">
            <a:solidFill>
              <a:schemeClr val="accent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21" name="Left Bracket 120">
            <a:extLst>
              <a:ext uri="{FF2B5EF4-FFF2-40B4-BE49-F238E27FC236}">
                <a16:creationId xmlns:a16="http://schemas.microsoft.com/office/drawing/2014/main" id="{D04C7047-8E8D-4B59-B8B6-0ED2580A818F}"/>
              </a:ext>
            </a:extLst>
          </p:cNvPr>
          <p:cNvSpPr/>
          <p:nvPr/>
        </p:nvSpPr>
        <p:spPr>
          <a:xfrm rot="16200000">
            <a:off x="8390504" y="4487976"/>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122" name="Left Bracket 121">
            <a:extLst>
              <a:ext uri="{FF2B5EF4-FFF2-40B4-BE49-F238E27FC236}">
                <a16:creationId xmlns:a16="http://schemas.microsoft.com/office/drawing/2014/main" id="{D8CC3A37-A5FB-4715-821A-F865EA56399F}"/>
              </a:ext>
            </a:extLst>
          </p:cNvPr>
          <p:cNvSpPr/>
          <p:nvPr/>
        </p:nvSpPr>
        <p:spPr>
          <a:xfrm rot="16200000">
            <a:off x="9396731" y="4487975"/>
            <a:ext cx="340231" cy="1006227"/>
          </a:xfrm>
          <a:prstGeom prst="leftBracket">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vert="vert" rtlCol="0" anchor="ctr"/>
          <a:lstStyle/>
          <a:p>
            <a:pPr algn="ctr"/>
            <a:r>
              <a:rPr lang="en-US">
                <a:latin typeface="Arial" panose="020B0604020202020204" pitchFamily="34" charset="0"/>
                <a:cs typeface="Arial" panose="020B0604020202020204" pitchFamily="34" charset="0"/>
              </a:rPr>
              <a:t>2 sec</a:t>
            </a:r>
          </a:p>
        </p:txBody>
      </p:sp>
      <p:sp>
        <p:nvSpPr>
          <p:cNvPr id="4" name="TextBox 3">
            <a:extLst>
              <a:ext uri="{FF2B5EF4-FFF2-40B4-BE49-F238E27FC236}">
                <a16:creationId xmlns:a16="http://schemas.microsoft.com/office/drawing/2014/main" id="{E2789CC5-0930-42E9-A34D-9E766BDCA0FF}"/>
              </a:ext>
            </a:extLst>
          </p:cNvPr>
          <p:cNvSpPr txBox="1"/>
          <p:nvPr/>
        </p:nvSpPr>
        <p:spPr>
          <a:xfrm>
            <a:off x="5402724" y="1435927"/>
            <a:ext cx="1877437" cy="646331"/>
          </a:xfrm>
          <a:prstGeom prst="rect">
            <a:avLst/>
          </a:prstGeom>
          <a:noFill/>
        </p:spPr>
        <p:txBody>
          <a:bodyPr wrap="none" rtlCol="0">
            <a:spAutoFit/>
          </a:bodyPr>
          <a:lstStyle/>
          <a:p>
            <a:r>
              <a:rPr lang="en-US" sz="3600">
                <a:solidFill>
                  <a:schemeClr val="accent1"/>
                </a:solidFill>
                <a:latin typeface="Arial" panose="020B0604020202020204" pitchFamily="34" charset="0"/>
              </a:rPr>
              <a:t>BURST</a:t>
            </a:r>
            <a:r>
              <a:rPr lang="en-US" sz="3600">
                <a:solidFill>
                  <a:schemeClr val="accent1"/>
                </a:solidFill>
              </a:rPr>
              <a:t>!</a:t>
            </a:r>
          </a:p>
        </p:txBody>
      </p:sp>
    </p:spTree>
    <p:extLst>
      <p:ext uri="{BB962C8B-B14F-4D97-AF65-F5344CB8AC3E}">
        <p14:creationId xmlns:p14="http://schemas.microsoft.com/office/powerpoint/2010/main" val="35457004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 name="Title 1">
            <a:extLst>
              <a:ext uri="{FF2B5EF4-FFF2-40B4-BE49-F238E27FC236}">
                <a16:creationId xmlns:a16="http://schemas.microsoft.com/office/drawing/2014/main" id="{BB4E3879-0FC6-44D6-9281-34F2B554E57F}"/>
              </a:ext>
            </a:extLst>
          </p:cNvPr>
          <p:cNvSpPr txBox="1">
            <a:spLocks/>
          </p:cNvSpPr>
          <p:nvPr/>
        </p:nvSpPr>
        <p:spPr>
          <a:xfrm>
            <a:off x="838200" y="1"/>
            <a:ext cx="10515600" cy="203092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Arial" panose="020B0604020202020204" pitchFamily="34" charset="0"/>
                <a:ea typeface="+mj-ea"/>
                <a:cs typeface="Arial" panose="020B0604020202020204" pitchFamily="34" charset="0"/>
              </a:defRPr>
            </a:lvl1pPr>
          </a:lstStyle>
          <a:p>
            <a:r>
              <a:rPr lang="en-US" sz="3600" b="1">
                <a:solidFill>
                  <a:srgbClr val="7030A0"/>
                </a:solidFill>
              </a:rPr>
              <a:t>Burst number: </a:t>
            </a:r>
            <a:r>
              <a:rPr lang="en-US" sz="3600"/>
              <a:t>The number of bursts in a recording</a:t>
            </a:r>
          </a:p>
        </p:txBody>
      </p:sp>
      <p:cxnSp>
        <p:nvCxnSpPr>
          <p:cNvPr id="35" name="Straight Connector 34">
            <a:extLst>
              <a:ext uri="{FF2B5EF4-FFF2-40B4-BE49-F238E27FC236}">
                <a16:creationId xmlns:a16="http://schemas.microsoft.com/office/drawing/2014/main" id="{2814F8E3-4AEA-4BA4-A3D8-EB9F55DB1F02}"/>
              </a:ext>
            </a:extLst>
          </p:cNvPr>
          <p:cNvCxnSpPr>
            <a:cxnSpLocks/>
          </p:cNvCxnSpPr>
          <p:nvPr/>
        </p:nvCxnSpPr>
        <p:spPr>
          <a:xfrm>
            <a:off x="101392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748586B8-9830-440E-91B0-F430C21E1AAE}"/>
              </a:ext>
            </a:extLst>
          </p:cNvPr>
          <p:cNvCxnSpPr>
            <a:cxnSpLocks/>
          </p:cNvCxnSpPr>
          <p:nvPr/>
        </p:nvCxnSpPr>
        <p:spPr>
          <a:xfrm>
            <a:off x="3026378"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C45B121B-A3D2-4BC8-AE2A-F676503D0272}"/>
              </a:ext>
            </a:extLst>
          </p:cNvPr>
          <p:cNvCxnSpPr>
            <a:cxnSpLocks/>
          </p:cNvCxnSpPr>
          <p:nvPr/>
        </p:nvCxnSpPr>
        <p:spPr>
          <a:xfrm>
            <a:off x="352949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622BF435-EBBA-4218-96BF-4AFCE9AB182D}"/>
              </a:ext>
            </a:extLst>
          </p:cNvPr>
          <p:cNvCxnSpPr>
            <a:cxnSpLocks/>
          </p:cNvCxnSpPr>
          <p:nvPr/>
        </p:nvCxnSpPr>
        <p:spPr>
          <a:xfrm>
            <a:off x="403260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5F8121D-EAA0-4330-999A-E18CB41CBE16}"/>
              </a:ext>
            </a:extLst>
          </p:cNvPr>
          <p:cNvCxnSpPr>
            <a:cxnSpLocks/>
          </p:cNvCxnSpPr>
          <p:nvPr/>
        </p:nvCxnSpPr>
        <p:spPr>
          <a:xfrm>
            <a:off x="6548169"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4EEB74AE-83EB-4C75-BDF1-FF349CDAE14A}"/>
              </a:ext>
            </a:extLst>
          </p:cNvPr>
          <p:cNvCxnSpPr>
            <a:cxnSpLocks/>
          </p:cNvCxnSpPr>
          <p:nvPr/>
        </p:nvCxnSpPr>
        <p:spPr>
          <a:xfrm>
            <a:off x="7051282"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55BC6AA-6EBD-42D9-B053-D4DCDC89E349}"/>
              </a:ext>
            </a:extLst>
          </p:cNvPr>
          <p:cNvCxnSpPr>
            <a:cxnSpLocks/>
          </p:cNvCxnSpPr>
          <p:nvPr/>
        </p:nvCxnSpPr>
        <p:spPr>
          <a:xfrm>
            <a:off x="8560621"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55A4474-74EF-48A7-81BB-0D5B373EA381}"/>
              </a:ext>
            </a:extLst>
          </p:cNvPr>
          <p:cNvCxnSpPr>
            <a:cxnSpLocks/>
          </p:cNvCxnSpPr>
          <p:nvPr/>
        </p:nvCxnSpPr>
        <p:spPr>
          <a:xfrm>
            <a:off x="9063734"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6865C555-B0A1-4DC7-BFB3-159291064D3E}"/>
              </a:ext>
            </a:extLst>
          </p:cNvPr>
          <p:cNvCxnSpPr>
            <a:cxnSpLocks/>
          </p:cNvCxnSpPr>
          <p:nvPr/>
        </p:nvCxnSpPr>
        <p:spPr>
          <a:xfrm>
            <a:off x="9566847" y="2693433"/>
            <a:ext cx="0" cy="1928326"/>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EAC61716-623A-447C-954B-8DD898D75C07}"/>
              </a:ext>
            </a:extLst>
          </p:cNvPr>
          <p:cNvCxnSpPr>
            <a:cxnSpLocks/>
          </p:cNvCxnSpPr>
          <p:nvPr/>
        </p:nvCxnSpPr>
        <p:spPr>
          <a:xfrm>
            <a:off x="11076186" y="2693433"/>
            <a:ext cx="0" cy="19283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56" name="TextBox 55">
            <a:extLst>
              <a:ext uri="{FF2B5EF4-FFF2-40B4-BE49-F238E27FC236}">
                <a16:creationId xmlns:a16="http://schemas.microsoft.com/office/drawing/2014/main" id="{506BA941-9ED2-45B9-AC3F-C8C0B0E5C028}"/>
              </a:ext>
            </a:extLst>
          </p:cNvPr>
          <p:cNvSpPr txBox="1"/>
          <p:nvPr/>
        </p:nvSpPr>
        <p:spPr>
          <a:xfrm>
            <a:off x="857473"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0</a:t>
            </a:r>
          </a:p>
        </p:txBody>
      </p:sp>
      <p:sp>
        <p:nvSpPr>
          <p:cNvPr id="60" name="TextBox 59">
            <a:extLst>
              <a:ext uri="{FF2B5EF4-FFF2-40B4-BE49-F238E27FC236}">
                <a16:creationId xmlns:a16="http://schemas.microsoft.com/office/drawing/2014/main" id="{D5578323-22C5-48E1-ADEE-17A44D65AA39}"/>
              </a:ext>
            </a:extLst>
          </p:cNvPr>
          <p:cNvSpPr txBox="1"/>
          <p:nvPr/>
        </p:nvSpPr>
        <p:spPr>
          <a:xfrm>
            <a:off x="2869925"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4</a:t>
            </a:r>
          </a:p>
        </p:txBody>
      </p:sp>
      <p:sp>
        <p:nvSpPr>
          <p:cNvPr id="61" name="TextBox 60">
            <a:extLst>
              <a:ext uri="{FF2B5EF4-FFF2-40B4-BE49-F238E27FC236}">
                <a16:creationId xmlns:a16="http://schemas.microsoft.com/office/drawing/2014/main" id="{1FFB11D9-B26C-434D-9740-8725EB830EE4}"/>
              </a:ext>
            </a:extLst>
          </p:cNvPr>
          <p:cNvSpPr txBox="1"/>
          <p:nvPr/>
        </p:nvSpPr>
        <p:spPr>
          <a:xfrm>
            <a:off x="3373038"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5</a:t>
            </a:r>
          </a:p>
        </p:txBody>
      </p:sp>
      <p:sp>
        <p:nvSpPr>
          <p:cNvPr id="62" name="TextBox 61">
            <a:extLst>
              <a:ext uri="{FF2B5EF4-FFF2-40B4-BE49-F238E27FC236}">
                <a16:creationId xmlns:a16="http://schemas.microsoft.com/office/drawing/2014/main" id="{83114AA9-4B59-41B6-ADFE-6C4F2491E6E7}"/>
              </a:ext>
            </a:extLst>
          </p:cNvPr>
          <p:cNvSpPr txBox="1"/>
          <p:nvPr/>
        </p:nvSpPr>
        <p:spPr>
          <a:xfrm>
            <a:off x="3876151" y="2324101"/>
            <a:ext cx="31290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6</a:t>
            </a:r>
          </a:p>
        </p:txBody>
      </p:sp>
      <p:sp>
        <p:nvSpPr>
          <p:cNvPr id="67" name="TextBox 66">
            <a:extLst>
              <a:ext uri="{FF2B5EF4-FFF2-40B4-BE49-F238E27FC236}">
                <a16:creationId xmlns:a16="http://schemas.microsoft.com/office/drawing/2014/main" id="{CA7BFD84-ABBA-4A9A-B2F8-6FC0089400F0}"/>
              </a:ext>
            </a:extLst>
          </p:cNvPr>
          <p:cNvSpPr txBox="1"/>
          <p:nvPr/>
        </p:nvSpPr>
        <p:spPr>
          <a:xfrm>
            <a:off x="6336156" y="2324101"/>
            <a:ext cx="424027"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1</a:t>
            </a:r>
          </a:p>
        </p:txBody>
      </p:sp>
      <p:sp>
        <p:nvSpPr>
          <p:cNvPr id="68" name="TextBox 67">
            <a:extLst>
              <a:ext uri="{FF2B5EF4-FFF2-40B4-BE49-F238E27FC236}">
                <a16:creationId xmlns:a16="http://schemas.microsoft.com/office/drawing/2014/main" id="{CB981839-37F6-4368-8E3F-DF8754634807}"/>
              </a:ext>
            </a:extLst>
          </p:cNvPr>
          <p:cNvSpPr txBox="1"/>
          <p:nvPr/>
        </p:nvSpPr>
        <p:spPr>
          <a:xfrm>
            <a:off x="6830709"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2</a:t>
            </a:r>
          </a:p>
        </p:txBody>
      </p:sp>
      <p:sp>
        <p:nvSpPr>
          <p:cNvPr id="71" name="TextBox 70">
            <a:extLst>
              <a:ext uri="{FF2B5EF4-FFF2-40B4-BE49-F238E27FC236}">
                <a16:creationId xmlns:a16="http://schemas.microsoft.com/office/drawing/2014/main" id="{D45BBE2E-DF92-4219-BC3A-1AF1A2792BF9}"/>
              </a:ext>
            </a:extLst>
          </p:cNvPr>
          <p:cNvSpPr txBox="1"/>
          <p:nvPr/>
        </p:nvSpPr>
        <p:spPr>
          <a:xfrm>
            <a:off x="8340048"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5</a:t>
            </a:r>
          </a:p>
        </p:txBody>
      </p:sp>
      <p:sp>
        <p:nvSpPr>
          <p:cNvPr id="72" name="TextBox 71">
            <a:extLst>
              <a:ext uri="{FF2B5EF4-FFF2-40B4-BE49-F238E27FC236}">
                <a16:creationId xmlns:a16="http://schemas.microsoft.com/office/drawing/2014/main" id="{BD8B3B41-1FE1-4CCC-9168-42A24303DFDC}"/>
              </a:ext>
            </a:extLst>
          </p:cNvPr>
          <p:cNvSpPr txBox="1"/>
          <p:nvPr/>
        </p:nvSpPr>
        <p:spPr>
          <a:xfrm>
            <a:off x="8843161"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6</a:t>
            </a:r>
          </a:p>
        </p:txBody>
      </p:sp>
      <p:sp>
        <p:nvSpPr>
          <p:cNvPr id="73" name="TextBox 72">
            <a:extLst>
              <a:ext uri="{FF2B5EF4-FFF2-40B4-BE49-F238E27FC236}">
                <a16:creationId xmlns:a16="http://schemas.microsoft.com/office/drawing/2014/main" id="{D2BC4F3C-EDCE-490E-ADBC-F65B227FA8F9}"/>
              </a:ext>
            </a:extLst>
          </p:cNvPr>
          <p:cNvSpPr txBox="1"/>
          <p:nvPr/>
        </p:nvSpPr>
        <p:spPr>
          <a:xfrm>
            <a:off x="9346274"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17</a:t>
            </a:r>
          </a:p>
        </p:txBody>
      </p:sp>
      <p:sp>
        <p:nvSpPr>
          <p:cNvPr id="76" name="TextBox 75">
            <a:extLst>
              <a:ext uri="{FF2B5EF4-FFF2-40B4-BE49-F238E27FC236}">
                <a16:creationId xmlns:a16="http://schemas.microsoft.com/office/drawing/2014/main" id="{5FC86196-7C2D-42D7-BE6A-1D096E132698}"/>
              </a:ext>
            </a:extLst>
          </p:cNvPr>
          <p:cNvSpPr txBox="1"/>
          <p:nvPr/>
        </p:nvSpPr>
        <p:spPr>
          <a:xfrm>
            <a:off x="10855613" y="2324101"/>
            <a:ext cx="441146"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0</a:t>
            </a:r>
          </a:p>
        </p:txBody>
      </p:sp>
      <p:sp>
        <p:nvSpPr>
          <p:cNvPr id="80" name="TextBox 79">
            <a:extLst>
              <a:ext uri="{FF2B5EF4-FFF2-40B4-BE49-F238E27FC236}">
                <a16:creationId xmlns:a16="http://schemas.microsoft.com/office/drawing/2014/main" id="{0C900B59-4201-4F1B-B8E7-7340816C4316}"/>
              </a:ext>
            </a:extLst>
          </p:cNvPr>
          <p:cNvSpPr txBox="1"/>
          <p:nvPr/>
        </p:nvSpPr>
        <p:spPr>
          <a:xfrm>
            <a:off x="2869925"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5A66A2F2-34E3-4247-8534-59192890CC22}"/>
              </a:ext>
            </a:extLst>
          </p:cNvPr>
          <p:cNvSpPr txBox="1"/>
          <p:nvPr/>
        </p:nvSpPr>
        <p:spPr>
          <a:xfrm>
            <a:off x="3373038"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1</a:t>
            </a:r>
          </a:p>
        </p:txBody>
      </p:sp>
      <p:sp>
        <p:nvSpPr>
          <p:cNvPr id="82" name="TextBox 81">
            <a:extLst>
              <a:ext uri="{FF2B5EF4-FFF2-40B4-BE49-F238E27FC236}">
                <a16:creationId xmlns:a16="http://schemas.microsoft.com/office/drawing/2014/main" id="{17974CD7-4EB3-4ABE-9BD7-E18031C0821C}"/>
              </a:ext>
            </a:extLst>
          </p:cNvPr>
          <p:cNvSpPr txBox="1"/>
          <p:nvPr/>
        </p:nvSpPr>
        <p:spPr>
          <a:xfrm>
            <a:off x="3876151" y="1954769"/>
            <a:ext cx="312907"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2</a:t>
            </a:r>
          </a:p>
        </p:txBody>
      </p:sp>
      <p:sp>
        <p:nvSpPr>
          <p:cNvPr id="87" name="TextBox 86">
            <a:extLst>
              <a:ext uri="{FF2B5EF4-FFF2-40B4-BE49-F238E27FC236}">
                <a16:creationId xmlns:a16="http://schemas.microsoft.com/office/drawing/2014/main" id="{95024911-2DE9-4D0B-A4B3-4BD19777884F}"/>
              </a:ext>
            </a:extLst>
          </p:cNvPr>
          <p:cNvSpPr txBox="1"/>
          <p:nvPr/>
        </p:nvSpPr>
        <p:spPr>
          <a:xfrm>
            <a:off x="6391716"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3</a:t>
            </a:r>
          </a:p>
        </p:txBody>
      </p:sp>
      <p:sp>
        <p:nvSpPr>
          <p:cNvPr id="90" name="TextBox 89">
            <a:extLst>
              <a:ext uri="{FF2B5EF4-FFF2-40B4-BE49-F238E27FC236}">
                <a16:creationId xmlns:a16="http://schemas.microsoft.com/office/drawing/2014/main" id="{062B7B16-42E2-4076-A421-365223EFD43C}"/>
              </a:ext>
            </a:extLst>
          </p:cNvPr>
          <p:cNvSpPr txBox="1"/>
          <p:nvPr/>
        </p:nvSpPr>
        <p:spPr>
          <a:xfrm>
            <a:off x="6894829"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4</a:t>
            </a:r>
          </a:p>
        </p:txBody>
      </p:sp>
      <p:sp>
        <p:nvSpPr>
          <p:cNvPr id="123" name="TextBox 122">
            <a:extLst>
              <a:ext uri="{FF2B5EF4-FFF2-40B4-BE49-F238E27FC236}">
                <a16:creationId xmlns:a16="http://schemas.microsoft.com/office/drawing/2014/main" id="{F07E911A-EF55-4077-B0DF-D9984A42F982}"/>
              </a:ext>
            </a:extLst>
          </p:cNvPr>
          <p:cNvSpPr txBox="1"/>
          <p:nvPr/>
        </p:nvSpPr>
        <p:spPr>
          <a:xfrm>
            <a:off x="8404168"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5</a:t>
            </a:r>
          </a:p>
        </p:txBody>
      </p:sp>
      <p:sp>
        <p:nvSpPr>
          <p:cNvPr id="124" name="TextBox 123">
            <a:extLst>
              <a:ext uri="{FF2B5EF4-FFF2-40B4-BE49-F238E27FC236}">
                <a16:creationId xmlns:a16="http://schemas.microsoft.com/office/drawing/2014/main" id="{E4DDCEBE-F36D-42F0-91A2-FD89D2A6C8CA}"/>
              </a:ext>
            </a:extLst>
          </p:cNvPr>
          <p:cNvSpPr txBox="1"/>
          <p:nvPr/>
        </p:nvSpPr>
        <p:spPr>
          <a:xfrm>
            <a:off x="8907281"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6</a:t>
            </a:r>
          </a:p>
        </p:txBody>
      </p:sp>
      <p:sp>
        <p:nvSpPr>
          <p:cNvPr id="125" name="TextBox 124">
            <a:extLst>
              <a:ext uri="{FF2B5EF4-FFF2-40B4-BE49-F238E27FC236}">
                <a16:creationId xmlns:a16="http://schemas.microsoft.com/office/drawing/2014/main" id="{51749985-D96F-4694-BCC7-0CCD556B9E04}"/>
              </a:ext>
            </a:extLst>
          </p:cNvPr>
          <p:cNvSpPr txBox="1"/>
          <p:nvPr/>
        </p:nvSpPr>
        <p:spPr>
          <a:xfrm>
            <a:off x="9410394" y="1954769"/>
            <a:ext cx="312906"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7</a:t>
            </a:r>
          </a:p>
        </p:txBody>
      </p:sp>
      <p:sp>
        <p:nvSpPr>
          <p:cNvPr id="128" name="TextBox 127">
            <a:extLst>
              <a:ext uri="{FF2B5EF4-FFF2-40B4-BE49-F238E27FC236}">
                <a16:creationId xmlns:a16="http://schemas.microsoft.com/office/drawing/2014/main" id="{8B5F1059-0ECA-4AA6-AA71-49F6194AB602}"/>
              </a:ext>
            </a:extLst>
          </p:cNvPr>
          <p:cNvSpPr txBox="1"/>
          <p:nvPr/>
        </p:nvSpPr>
        <p:spPr>
          <a:xfrm>
            <a:off x="11307430" y="2324101"/>
            <a:ext cx="543739"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sec</a:t>
            </a:r>
          </a:p>
        </p:txBody>
      </p:sp>
      <p:sp>
        <p:nvSpPr>
          <p:cNvPr id="129" name="TextBox 128">
            <a:extLst>
              <a:ext uri="{FF2B5EF4-FFF2-40B4-BE49-F238E27FC236}">
                <a16:creationId xmlns:a16="http://schemas.microsoft.com/office/drawing/2014/main" id="{17105D4D-3475-4F62-8B53-E8A9D9E8CB2B}"/>
              </a:ext>
            </a:extLst>
          </p:cNvPr>
          <p:cNvSpPr txBox="1"/>
          <p:nvPr/>
        </p:nvSpPr>
        <p:spPr>
          <a:xfrm>
            <a:off x="11215770" y="1954769"/>
            <a:ext cx="736100" cy="369332"/>
          </a:xfrm>
          <a:prstGeom prst="rect">
            <a:avLst/>
          </a:prstGeom>
          <a:noFill/>
        </p:spPr>
        <p:txBody>
          <a:bodyPr wrap="none" rtlCol="0">
            <a:spAutoFit/>
          </a:bodyPr>
          <a:lstStyle/>
          <a:p>
            <a:pPr algn="ctr"/>
            <a:r>
              <a:rPr lang="en-US">
                <a:solidFill>
                  <a:srgbClr val="FF0000"/>
                </a:solidFill>
                <a:latin typeface="Arial" panose="020B0604020202020204" pitchFamily="34" charset="0"/>
                <a:cs typeface="Arial" panose="020B0604020202020204" pitchFamily="34" charset="0"/>
              </a:rPr>
              <a:t>index</a:t>
            </a:r>
          </a:p>
        </p:txBody>
      </p:sp>
      <p:sp>
        <p:nvSpPr>
          <p:cNvPr id="130" name="TextBox 129">
            <a:extLst>
              <a:ext uri="{FF2B5EF4-FFF2-40B4-BE49-F238E27FC236}">
                <a16:creationId xmlns:a16="http://schemas.microsoft.com/office/drawing/2014/main" id="{E1961E32-E05C-4074-9202-D26E7C008F2F}"/>
              </a:ext>
            </a:extLst>
          </p:cNvPr>
          <p:cNvSpPr txBox="1"/>
          <p:nvPr/>
        </p:nvSpPr>
        <p:spPr>
          <a:xfrm>
            <a:off x="2674133" y="4667925"/>
            <a:ext cx="1710726" cy="1200329"/>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Burst 1</a:t>
            </a:r>
          </a:p>
          <a:p>
            <a:pPr algn="ctr"/>
            <a:r>
              <a:rPr lang="en-US" sz="3600" err="1">
                <a:solidFill>
                  <a:srgbClr val="FF0000"/>
                </a:solidFill>
                <a:latin typeface="Arial" panose="020B0604020202020204" pitchFamily="34" charset="0"/>
              </a:rPr>
              <a:t>iburst</a:t>
            </a:r>
            <a:r>
              <a:rPr lang="en-US" sz="3600">
                <a:solidFill>
                  <a:srgbClr val="FF0000"/>
                </a:solidFill>
                <a:latin typeface="Arial" panose="020B0604020202020204" pitchFamily="34" charset="0"/>
              </a:rPr>
              <a:t> 0</a:t>
            </a:r>
            <a:endParaRPr lang="en-US" sz="3600">
              <a:solidFill>
                <a:srgbClr val="FF0000"/>
              </a:solidFill>
            </a:endParaRPr>
          </a:p>
        </p:txBody>
      </p:sp>
      <p:sp>
        <p:nvSpPr>
          <p:cNvPr id="132" name="TextBox 131">
            <a:extLst>
              <a:ext uri="{FF2B5EF4-FFF2-40B4-BE49-F238E27FC236}">
                <a16:creationId xmlns:a16="http://schemas.microsoft.com/office/drawing/2014/main" id="{7056583F-8F74-4665-93C0-E9BE7FAB6F79}"/>
              </a:ext>
            </a:extLst>
          </p:cNvPr>
          <p:cNvSpPr txBox="1"/>
          <p:nvPr/>
        </p:nvSpPr>
        <p:spPr>
          <a:xfrm>
            <a:off x="8214785" y="4667925"/>
            <a:ext cx="1697902" cy="1200329"/>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Burst 3</a:t>
            </a:r>
          </a:p>
          <a:p>
            <a:pPr algn="ctr"/>
            <a:r>
              <a:rPr lang="en-US" sz="3600" err="1">
                <a:solidFill>
                  <a:srgbClr val="FF0000"/>
                </a:solidFill>
                <a:latin typeface="Arial" panose="020B0604020202020204" pitchFamily="34" charset="0"/>
              </a:rPr>
              <a:t>iburst</a:t>
            </a:r>
            <a:r>
              <a:rPr lang="en-US" sz="3600">
                <a:solidFill>
                  <a:srgbClr val="FF0000"/>
                </a:solidFill>
                <a:latin typeface="Arial" panose="020B0604020202020204" pitchFamily="34" charset="0"/>
              </a:rPr>
              <a:t> 2</a:t>
            </a:r>
            <a:endParaRPr lang="en-US" sz="3600">
              <a:solidFill>
                <a:srgbClr val="FF0000"/>
              </a:solidFill>
            </a:endParaRPr>
          </a:p>
        </p:txBody>
      </p:sp>
      <p:sp>
        <p:nvSpPr>
          <p:cNvPr id="37" name="TextBox 36">
            <a:extLst>
              <a:ext uri="{FF2B5EF4-FFF2-40B4-BE49-F238E27FC236}">
                <a16:creationId xmlns:a16="http://schemas.microsoft.com/office/drawing/2014/main" id="{EF171323-BBDD-4A0B-94E6-778C2BFCF228}"/>
              </a:ext>
            </a:extLst>
          </p:cNvPr>
          <p:cNvSpPr txBox="1"/>
          <p:nvPr/>
        </p:nvSpPr>
        <p:spPr>
          <a:xfrm>
            <a:off x="5975346" y="4661746"/>
            <a:ext cx="1710726" cy="1200329"/>
          </a:xfrm>
          <a:prstGeom prst="rect">
            <a:avLst/>
          </a:prstGeom>
          <a:noFill/>
        </p:spPr>
        <p:txBody>
          <a:bodyPr wrap="none" rtlCol="0">
            <a:spAutoFit/>
          </a:bodyPr>
          <a:lstStyle/>
          <a:p>
            <a:pPr algn="ctr"/>
            <a:r>
              <a:rPr lang="en-US" sz="3600">
                <a:solidFill>
                  <a:schemeClr val="accent1"/>
                </a:solidFill>
                <a:latin typeface="Arial" panose="020B0604020202020204" pitchFamily="34" charset="0"/>
              </a:rPr>
              <a:t>Burst 2</a:t>
            </a:r>
          </a:p>
          <a:p>
            <a:pPr algn="ctr"/>
            <a:r>
              <a:rPr lang="en-US" sz="3600" err="1">
                <a:solidFill>
                  <a:srgbClr val="FF0000"/>
                </a:solidFill>
                <a:latin typeface="Arial" panose="020B0604020202020204" pitchFamily="34" charset="0"/>
              </a:rPr>
              <a:t>iburst</a:t>
            </a:r>
            <a:r>
              <a:rPr lang="en-US" sz="3600">
                <a:solidFill>
                  <a:srgbClr val="FF0000"/>
                </a:solidFill>
                <a:latin typeface="Arial" panose="020B0604020202020204" pitchFamily="34" charset="0"/>
              </a:rPr>
              <a:t> 1</a:t>
            </a:r>
            <a:endParaRPr lang="en-US" sz="3600">
              <a:solidFill>
                <a:srgbClr val="FF0000"/>
              </a:solidFill>
            </a:endParaRPr>
          </a:p>
        </p:txBody>
      </p:sp>
    </p:spTree>
    <p:extLst>
      <p:ext uri="{BB962C8B-B14F-4D97-AF65-F5344CB8AC3E}">
        <p14:creationId xmlns:p14="http://schemas.microsoft.com/office/powerpoint/2010/main" val="26928973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Application>Microsoft Office PowerPoint</Application>
  <PresentationFormat>Widescreen</PresentationFormat>
  <Slides>35</Slides>
  <Notes>0</Notes>
  <HiddenSlides>0</HiddenSlides>
  <ScaleCrop>false</ScaleCrop>
  <HeadingPairs>
    <vt:vector size="4" baseType="variant">
      <vt:variant>
        <vt:lpstr>Theme</vt:lpstr>
      </vt:variant>
      <vt:variant>
        <vt:i4>1</vt:i4>
      </vt:variant>
      <vt:variant>
        <vt:lpstr>Slide Titles</vt:lpstr>
      </vt:variant>
      <vt:variant>
        <vt:i4>35</vt:i4>
      </vt:variant>
    </vt:vector>
  </HeadingPairs>
  <TitlesOfParts>
    <vt:vector size="36" baseType="lpstr">
      <vt:lpstr>Office Theme</vt:lpstr>
      <vt:lpstr>Vary Burst Window Analysis</vt:lpstr>
      <vt:lpstr>Terminology Table of Contents</vt:lpstr>
      <vt:lpstr>Dataset: The time at which spikes occur</vt:lpstr>
      <vt:lpstr>Intervals: The backwards interval of time from an event to the prior event, or to the beginning of the recording for the first event.</vt:lpstr>
      <vt:lpstr>Burst Window (BW): An interval of time used to determine if adjacent spikes belong to a burst. To be part of a burst, interval between spikes must be less than the burst window</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Event: Either a single spike or a burst. All of the spikes in one burst are part of one “event”</vt:lpstr>
      <vt:lpstr>Inter-event interval: The interval of time between events. By definition, an interval greater than burst window. Could be time between two single spikes, two bursts, or a single spike and a burst. </vt:lpstr>
      <vt:lpstr>Gap: A break in the recording. No data exists during this time period. For extracellular recordings, this is typically between series</vt:lpstr>
      <vt:lpstr>Total Duration: The absolute length of time (“clock time”) from the start of the recording to the end of the recording. This includes any gaps</vt:lpstr>
      <vt:lpstr>Recording Duration: The length of time during which data collection/recording occurred. This is the total duration minus any gaps.</vt:lpstr>
      <vt:lpstr>PowerPoint Presentation</vt:lpstr>
      <vt:lpstr>Single spike frequency (ssf): The frequency, in Hz, of single spikes during the recording. This is the number of single spikes divided by the recording duration.</vt:lpstr>
      <vt:lpstr>Total Frequency: The frequency, in Hz, of total spikes during the recording. This is the number of spikes divided by the recording duration</vt:lpstr>
      <vt:lpstr>Gap starts and ends: A list of the start times and a list of the end time of gaps during the recording</vt:lpstr>
      <vt:lpstr>Gap starts plus end: A list of the start times of gaps plus the end of the recording Gap ends plus start: A list of the end times of gaps during the start of the recording</vt:lpstr>
      <vt:lpstr>Backward intervals to gaps: The interval from the end of the previous gap or start of the recording to the time of the spike. Used to add doubt flags if interval is less than burst window</vt:lpstr>
      <vt:lpstr>Forward intervals to gaps: The interval from the time of the spike to the start of the next gap or the end of the recording. Used to add doubt flags if interval is less than burst window</vt:lpstr>
      <vt:lpstr>Interval gap flag: The duration of any gaps that occur within a backwards interval. If not 0, interval is not added to inter_intervals / intra_intervals. Used to add burst doubt flags if there’s a gap during a burst</vt:lpstr>
      <vt:lpstr>Mean inter-event interval: The average of all inter-event intervals that are not interrupted by gaps</vt:lpstr>
      <vt:lpstr>Mean intra-burst interval: The average of all intraburst intervals that are not interrupted by gaps</vt:lpstr>
      <vt:lpstr>Single spike doubt flag: The doubt flag value for a spike is changed to 1 when it occurs within a burst window from the start/end of recording or a gap. Count the total at end</vt:lpstr>
      <vt:lpstr>Burst doubt flag: The doubt flag value for a burst is changed to 1 when a burst occurs within a burst window from the start/end of recording, a gap, or when it contains a gap. Count the total at end</vt:lpstr>
      <vt:lpstr>Region: Demarcation of treatments or other experimental features. </vt:lpstr>
      <vt:lpstr>Current region processing: Split the wave file and run burst detection separately</vt:lpstr>
      <vt:lpstr>Current region processing: Split the wave file and run burst detection separately</vt:lpstr>
      <vt:lpstr>Long-term Region Goal: Complete burst detection first, then split output by region. Bursts that start in a region “belong” to that region. Total freq is still number of spikes in a given region </vt:lpstr>
      <vt:lpstr>Long-term Region Goal: Complete burst detection first, then split output by region. Bursts that start in a region “belong” to that region. Total freq is still number of spikes in a given region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ary Burst Window Analysis</dc:title>
  <dc:creator>Amanda Gibson</dc:creator>
  <cp:revision>1</cp:revision>
  <dcterms:created xsi:type="dcterms:W3CDTF">2021-02-07T20:21:06Z</dcterms:created>
  <dcterms:modified xsi:type="dcterms:W3CDTF">2021-02-08T01:43:43Z</dcterms:modified>
</cp:coreProperties>
</file>